
<file path=[Content_Types].xml><?xml version="1.0" encoding="utf-8"?>
<Types xmlns="http://schemas.openxmlformats.org/package/2006/content-types">
  <Default Extension="gif" ContentType="image/gi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53"/>
  </p:notesMasterIdLst>
  <p:sldIdLst>
    <p:sldId id="256" r:id="rId2"/>
    <p:sldId id="391" r:id="rId3"/>
    <p:sldId id="401" r:id="rId4"/>
    <p:sldId id="402" r:id="rId5"/>
    <p:sldId id="403" r:id="rId6"/>
    <p:sldId id="404" r:id="rId7"/>
    <p:sldId id="257" r:id="rId8"/>
    <p:sldId id="368" r:id="rId9"/>
    <p:sldId id="396" r:id="rId10"/>
    <p:sldId id="288" r:id="rId11"/>
    <p:sldId id="289" r:id="rId12"/>
    <p:sldId id="290" r:id="rId13"/>
    <p:sldId id="395" r:id="rId14"/>
    <p:sldId id="258" r:id="rId15"/>
    <p:sldId id="351" r:id="rId16"/>
    <p:sldId id="367" r:id="rId17"/>
    <p:sldId id="363" r:id="rId18"/>
    <p:sldId id="352" r:id="rId19"/>
    <p:sldId id="357" r:id="rId20"/>
    <p:sldId id="358" r:id="rId21"/>
    <p:sldId id="364" r:id="rId22"/>
    <p:sldId id="354" r:id="rId23"/>
    <p:sldId id="291" r:id="rId24"/>
    <p:sldId id="292" r:id="rId25"/>
    <p:sldId id="405" r:id="rId26"/>
    <p:sldId id="370" r:id="rId27"/>
    <p:sldId id="392" r:id="rId28"/>
    <p:sldId id="355" r:id="rId29"/>
    <p:sldId id="398" r:id="rId30"/>
    <p:sldId id="362" r:id="rId31"/>
    <p:sldId id="365" r:id="rId32"/>
    <p:sldId id="360" r:id="rId33"/>
    <p:sldId id="361" r:id="rId34"/>
    <p:sldId id="366" r:id="rId35"/>
    <p:sldId id="399" r:id="rId36"/>
    <p:sldId id="373" r:id="rId37"/>
    <p:sldId id="294" r:id="rId38"/>
    <p:sldId id="380" r:id="rId39"/>
    <p:sldId id="383" r:id="rId40"/>
    <p:sldId id="400" r:id="rId41"/>
    <p:sldId id="378" r:id="rId42"/>
    <p:sldId id="381" r:id="rId43"/>
    <p:sldId id="377" r:id="rId44"/>
    <p:sldId id="385" r:id="rId45"/>
    <p:sldId id="386" r:id="rId46"/>
    <p:sldId id="387" r:id="rId47"/>
    <p:sldId id="388" r:id="rId48"/>
    <p:sldId id="390" r:id="rId49"/>
    <p:sldId id="389" r:id="rId50"/>
    <p:sldId id="379" r:id="rId51"/>
    <p:sldId id="393" r:id="rId5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slideViewPr>
    <p:cSldViewPr snapToGrid="0">
      <p:cViewPr>
        <p:scale>
          <a:sx n="1" d="2"/>
          <a:sy n="1" d="2"/>
        </p:scale>
        <p:origin x="0" y="0"/>
      </p:cViewPr>
      <p:guideLst/>
    </p:cSldViewPr>
  </p:slide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slide" Target="slides/slide46.xml"/><Relationship Id="rId50" Type="http://schemas.openxmlformats.org/officeDocument/2006/relationships/slide" Target="slides/slide49.xml"/><Relationship Id="rId55" Type="http://schemas.openxmlformats.org/officeDocument/2006/relationships/viewProps" Target="viewProp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notesMaster" Target="notesMasters/notesMaster1.xml"/><Relationship Id="rId58" Type="http://schemas.microsoft.com/office/2016/11/relationships/changesInfo" Target="changesInfos/changesInfo1.xml"/><Relationship Id="rId5" Type="http://schemas.openxmlformats.org/officeDocument/2006/relationships/slide" Target="slides/slide4.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56" Type="http://schemas.openxmlformats.org/officeDocument/2006/relationships/theme" Target="theme/theme1.xml"/><Relationship Id="rId8" Type="http://schemas.openxmlformats.org/officeDocument/2006/relationships/slide" Target="slides/slide7.xml"/><Relationship Id="rId51" Type="http://schemas.openxmlformats.org/officeDocument/2006/relationships/slide" Target="slides/slide50.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20" Type="http://schemas.openxmlformats.org/officeDocument/2006/relationships/slide" Target="slides/slide19.xml"/><Relationship Id="rId41" Type="http://schemas.openxmlformats.org/officeDocument/2006/relationships/slide" Target="slides/slide40.xml"/><Relationship Id="rId54"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57" Type="http://schemas.openxmlformats.org/officeDocument/2006/relationships/tableStyles" Target="tableStyles.xml"/><Relationship Id="rId10" Type="http://schemas.openxmlformats.org/officeDocument/2006/relationships/slide" Target="slides/slide9.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slide" Target="slides/slide5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Belaid, Sirine" userId="S::belaids@upmc.edu::5dcb4cf5-c058-49ea-93f8-4f4e6c877fcd" providerId="AD" clId="Web-{F57F2013-AD89-1F6B-D692-D4ABBCB53CC7}"/>
    <pc:docChg chg="delSld modSld">
      <pc:chgData name="Belaid, Sirine" userId="S::belaids@upmc.edu::5dcb4cf5-c058-49ea-93f8-4f4e6c877fcd" providerId="AD" clId="Web-{F57F2013-AD89-1F6B-D692-D4ABBCB53CC7}" dt="2024-12-12T16:02:31.722" v="98"/>
      <pc:docMkLst>
        <pc:docMk/>
      </pc:docMkLst>
      <pc:sldChg chg="addSp delSp modSp mod setBg">
        <pc:chgData name="Belaid, Sirine" userId="S::belaids@upmc.edu::5dcb4cf5-c058-49ea-93f8-4f4e6c877fcd" providerId="AD" clId="Web-{F57F2013-AD89-1F6B-D692-D4ABBCB53CC7}" dt="2024-12-12T16:02:31.722" v="98"/>
        <pc:sldMkLst>
          <pc:docMk/>
          <pc:sldMk cId="931904134" sldId="287"/>
        </pc:sldMkLst>
        <pc:spChg chg="mod">
          <ac:chgData name="Belaid, Sirine" userId="S::belaids@upmc.edu::5dcb4cf5-c058-49ea-93f8-4f4e6c877fcd" providerId="AD" clId="Web-{F57F2013-AD89-1F6B-D692-D4ABBCB53CC7}" dt="2024-12-12T16:02:31.722" v="98"/>
          <ac:spMkLst>
            <pc:docMk/>
            <pc:sldMk cId="931904134" sldId="287"/>
            <ac:spMk id="2" creationId="{3913824F-ECD1-10CA-7CE8-EE77DB7B4E4C}"/>
          </ac:spMkLst>
        </pc:spChg>
        <pc:spChg chg="add del">
          <ac:chgData name="Belaid, Sirine" userId="S::belaids@upmc.edu::5dcb4cf5-c058-49ea-93f8-4f4e6c877fcd" providerId="AD" clId="Web-{F57F2013-AD89-1F6B-D692-D4ABBCB53CC7}" dt="2024-12-12T16:02:31.722" v="98"/>
          <ac:spMkLst>
            <pc:docMk/>
            <pc:sldMk cId="931904134" sldId="287"/>
            <ac:spMk id="3" creationId="{3DB2B855-1F64-5184-A62B-BB64F2950C59}"/>
          </ac:spMkLst>
        </pc:spChg>
        <pc:spChg chg="add">
          <ac:chgData name="Belaid, Sirine" userId="S::belaids@upmc.edu::5dcb4cf5-c058-49ea-93f8-4f4e6c877fcd" providerId="AD" clId="Web-{F57F2013-AD89-1F6B-D692-D4ABBCB53CC7}" dt="2024-12-12T16:02:31.722" v="98"/>
          <ac:spMkLst>
            <pc:docMk/>
            <pc:sldMk cId="931904134" sldId="287"/>
            <ac:spMk id="7" creationId="{3DB2B855-1F64-5184-A62B-BB64F2950C59}"/>
          </ac:spMkLst>
        </pc:spChg>
        <pc:spChg chg="add">
          <ac:chgData name="Belaid, Sirine" userId="S::belaids@upmc.edu::5dcb4cf5-c058-49ea-93f8-4f4e6c877fcd" providerId="AD" clId="Web-{F57F2013-AD89-1F6B-D692-D4ABBCB53CC7}" dt="2024-12-12T16:02:31.722" v="98"/>
          <ac:spMkLst>
            <pc:docMk/>
            <pc:sldMk cId="931904134" sldId="287"/>
            <ac:spMk id="8" creationId="{18873D23-2DCF-4B31-A009-95721C06E8E1}"/>
          </ac:spMkLst>
        </pc:spChg>
        <pc:spChg chg="add">
          <ac:chgData name="Belaid, Sirine" userId="S::belaids@upmc.edu::5dcb4cf5-c058-49ea-93f8-4f4e6c877fcd" providerId="AD" clId="Web-{F57F2013-AD89-1F6B-D692-D4ABBCB53CC7}" dt="2024-12-12T16:02:31.722" v="98"/>
          <ac:spMkLst>
            <pc:docMk/>
            <pc:sldMk cId="931904134" sldId="287"/>
            <ac:spMk id="10" creationId="{C13EF075-D4EF-4929-ADBC-91B27DA19955}"/>
          </ac:spMkLst>
        </pc:spChg>
        <pc:grpChg chg="add">
          <ac:chgData name="Belaid, Sirine" userId="S::belaids@upmc.edu::5dcb4cf5-c058-49ea-93f8-4f4e6c877fcd" providerId="AD" clId="Web-{F57F2013-AD89-1F6B-D692-D4ABBCB53CC7}" dt="2024-12-12T16:02:31.722" v="98"/>
          <ac:grpSpMkLst>
            <pc:docMk/>
            <pc:sldMk cId="931904134" sldId="287"/>
            <ac:grpSpMk id="12" creationId="{DAA26DFA-AAB2-4973-9C17-16D587C7B198}"/>
          </ac:grpSpMkLst>
        </pc:grpChg>
        <pc:graphicFrameChg chg="add del">
          <ac:chgData name="Belaid, Sirine" userId="S::belaids@upmc.edu::5dcb4cf5-c058-49ea-93f8-4f4e6c877fcd" providerId="AD" clId="Web-{F57F2013-AD89-1F6B-D692-D4ABBCB53CC7}" dt="2024-12-12T16:02:31.706" v="97"/>
          <ac:graphicFrameMkLst>
            <pc:docMk/>
            <pc:sldMk cId="931904134" sldId="287"/>
            <ac:graphicFrameMk id="5" creationId="{85E57E08-12B0-ADF5-14FC-DDC28CF96D02}"/>
          </ac:graphicFrameMkLst>
        </pc:graphicFrameChg>
      </pc:sldChg>
      <pc:sldChg chg="addSp modSp">
        <pc:chgData name="Belaid, Sirine" userId="S::belaids@upmc.edu::5dcb4cf5-c058-49ea-93f8-4f4e6c877fcd" providerId="AD" clId="Web-{F57F2013-AD89-1F6B-D692-D4ABBCB53CC7}" dt="2024-12-12T14:55:50.997" v="18" actId="1076"/>
        <pc:sldMkLst>
          <pc:docMk/>
          <pc:sldMk cId="1022786307" sldId="355"/>
        </pc:sldMkLst>
        <pc:spChg chg="mod">
          <ac:chgData name="Belaid, Sirine" userId="S::belaids@upmc.edu::5dcb4cf5-c058-49ea-93f8-4f4e6c877fcd" providerId="AD" clId="Web-{F57F2013-AD89-1F6B-D692-D4ABBCB53CC7}" dt="2024-12-12T14:55:50.997" v="18" actId="1076"/>
          <ac:spMkLst>
            <pc:docMk/>
            <pc:sldMk cId="1022786307" sldId="355"/>
            <ac:spMk id="3" creationId="{1C74E49B-EF04-8C3D-7D26-98DBD002E7B7}"/>
          </ac:spMkLst>
        </pc:spChg>
        <pc:picChg chg="add mod">
          <ac:chgData name="Belaid, Sirine" userId="S::belaids@upmc.edu::5dcb4cf5-c058-49ea-93f8-4f4e6c877fcd" providerId="AD" clId="Web-{F57F2013-AD89-1F6B-D692-D4ABBCB53CC7}" dt="2024-12-12T14:55:40.450" v="17" actId="14100"/>
          <ac:picMkLst>
            <pc:docMk/>
            <pc:sldMk cId="1022786307" sldId="355"/>
            <ac:picMk id="4" creationId="{6CEBC467-148F-4F34-2DCF-5CB061C2F9E8}"/>
          </ac:picMkLst>
        </pc:picChg>
      </pc:sldChg>
      <pc:sldChg chg="modSp modNotes">
        <pc:chgData name="Belaid, Sirine" userId="S::belaids@upmc.edu::5dcb4cf5-c058-49ea-93f8-4f4e6c877fcd" providerId="AD" clId="Web-{F57F2013-AD89-1F6B-D692-D4ABBCB53CC7}" dt="2024-12-12T15:37:17.102" v="78" actId="20577"/>
        <pc:sldMkLst>
          <pc:docMk/>
          <pc:sldMk cId="1919480477" sldId="360"/>
        </pc:sldMkLst>
        <pc:spChg chg="mod">
          <ac:chgData name="Belaid, Sirine" userId="S::belaids@upmc.edu::5dcb4cf5-c058-49ea-93f8-4f4e6c877fcd" providerId="AD" clId="Web-{F57F2013-AD89-1F6B-D692-D4ABBCB53CC7}" dt="2024-12-12T15:37:17.102" v="78" actId="20577"/>
          <ac:spMkLst>
            <pc:docMk/>
            <pc:sldMk cId="1919480477" sldId="360"/>
            <ac:spMk id="4" creationId="{BC1764D5-760C-CB8E-B008-E46689C2012F}"/>
          </ac:spMkLst>
        </pc:spChg>
      </pc:sldChg>
      <pc:sldChg chg="modSp mod modShow modNotes">
        <pc:chgData name="Belaid, Sirine" userId="S::belaids@upmc.edu::5dcb4cf5-c058-49ea-93f8-4f4e6c877fcd" providerId="AD" clId="Web-{F57F2013-AD89-1F6B-D692-D4ABBCB53CC7}" dt="2024-12-12T15:44:46.451" v="95" actId="20577"/>
        <pc:sldMkLst>
          <pc:docMk/>
          <pc:sldMk cId="2817742152" sldId="361"/>
        </pc:sldMkLst>
        <pc:spChg chg="mod">
          <ac:chgData name="Belaid, Sirine" userId="S::belaids@upmc.edu::5dcb4cf5-c058-49ea-93f8-4f4e6c877fcd" providerId="AD" clId="Web-{F57F2013-AD89-1F6B-D692-D4ABBCB53CC7}" dt="2024-12-12T15:44:46.451" v="95" actId="20577"/>
          <ac:spMkLst>
            <pc:docMk/>
            <pc:sldMk cId="2817742152" sldId="361"/>
            <ac:spMk id="3" creationId="{B6FB2075-FE59-DFEA-3EE2-6A1D6EAFE127}"/>
          </ac:spMkLst>
        </pc:spChg>
      </pc:sldChg>
      <pc:sldChg chg="addSp delSp modSp">
        <pc:chgData name="Belaid, Sirine" userId="S::belaids@upmc.edu::5dcb4cf5-c058-49ea-93f8-4f4e6c877fcd" providerId="AD" clId="Web-{F57F2013-AD89-1F6B-D692-D4ABBCB53CC7}" dt="2024-12-12T15:03:18.353" v="66" actId="1076"/>
        <pc:sldMkLst>
          <pc:docMk/>
          <pc:sldMk cId="2090633080" sldId="362"/>
        </pc:sldMkLst>
        <pc:spChg chg="mod">
          <ac:chgData name="Belaid, Sirine" userId="S::belaids@upmc.edu::5dcb4cf5-c058-49ea-93f8-4f4e6c877fcd" providerId="AD" clId="Web-{F57F2013-AD89-1F6B-D692-D4ABBCB53CC7}" dt="2024-12-12T15:03:18.353" v="66" actId="1076"/>
          <ac:spMkLst>
            <pc:docMk/>
            <pc:sldMk cId="2090633080" sldId="362"/>
            <ac:spMk id="2" creationId="{C48941FB-E149-0D2C-B85E-E5D47986915D}"/>
          </ac:spMkLst>
        </pc:spChg>
        <pc:spChg chg="mod">
          <ac:chgData name="Belaid, Sirine" userId="S::belaids@upmc.edu::5dcb4cf5-c058-49ea-93f8-4f4e6c877fcd" providerId="AD" clId="Web-{F57F2013-AD89-1F6B-D692-D4ABBCB53CC7}" dt="2024-12-12T15:01:29.444" v="56" actId="1076"/>
          <ac:spMkLst>
            <pc:docMk/>
            <pc:sldMk cId="2090633080" sldId="362"/>
            <ac:spMk id="3" creationId="{7639CC8F-08C3-8406-49DC-53CA41C3EDD0}"/>
          </ac:spMkLst>
        </pc:spChg>
        <pc:picChg chg="del mod">
          <ac:chgData name="Belaid, Sirine" userId="S::belaids@upmc.edu::5dcb4cf5-c058-49ea-93f8-4f4e6c877fcd" providerId="AD" clId="Web-{F57F2013-AD89-1F6B-D692-D4ABBCB53CC7}" dt="2024-12-12T14:54:52.152" v="7"/>
          <ac:picMkLst>
            <pc:docMk/>
            <pc:sldMk cId="2090633080" sldId="362"/>
            <ac:picMk id="5" creationId="{CDB56A19-B131-8567-B59B-78FF0F2B1E3F}"/>
          </ac:picMkLst>
        </pc:picChg>
        <pc:picChg chg="add mod">
          <ac:chgData name="Belaid, Sirine" userId="S::belaids@upmc.edu::5dcb4cf5-c058-49ea-93f8-4f4e6c877fcd" providerId="AD" clId="Web-{F57F2013-AD89-1F6B-D692-D4ABBCB53CC7}" dt="2024-12-12T14:57:39.860" v="28" actId="14100"/>
          <ac:picMkLst>
            <pc:docMk/>
            <pc:sldMk cId="2090633080" sldId="362"/>
            <ac:picMk id="6" creationId="{4BFA40AF-853D-CFF9-DF8A-410FE0CFD66E}"/>
          </ac:picMkLst>
        </pc:picChg>
        <pc:picChg chg="add mod">
          <ac:chgData name="Belaid, Sirine" userId="S::belaids@upmc.edu::5dcb4cf5-c058-49ea-93f8-4f4e6c877fcd" providerId="AD" clId="Web-{F57F2013-AD89-1F6B-D692-D4ABBCB53CC7}" dt="2024-12-12T15:03:08.915" v="65" actId="1076"/>
          <ac:picMkLst>
            <pc:docMk/>
            <pc:sldMk cId="2090633080" sldId="362"/>
            <ac:picMk id="8" creationId="{22CB9261-5166-8F4B-4E5C-424F7C469E83}"/>
          </ac:picMkLst>
        </pc:picChg>
      </pc:sldChg>
      <pc:sldChg chg="modSp">
        <pc:chgData name="Belaid, Sirine" userId="S::belaids@upmc.edu::5dcb4cf5-c058-49ea-93f8-4f4e6c877fcd" providerId="AD" clId="Web-{F57F2013-AD89-1F6B-D692-D4ABBCB53CC7}" dt="2024-12-12T15:44:38.467" v="91" actId="20577"/>
        <pc:sldMkLst>
          <pc:docMk/>
          <pc:sldMk cId="2208660293" sldId="366"/>
        </pc:sldMkLst>
        <pc:spChg chg="mod">
          <ac:chgData name="Belaid, Sirine" userId="S::belaids@upmc.edu::5dcb4cf5-c058-49ea-93f8-4f4e6c877fcd" providerId="AD" clId="Web-{F57F2013-AD89-1F6B-D692-D4ABBCB53CC7}" dt="2024-12-12T15:44:38.467" v="91" actId="20577"/>
          <ac:spMkLst>
            <pc:docMk/>
            <pc:sldMk cId="2208660293" sldId="366"/>
            <ac:spMk id="3" creationId="{FC73AACB-7825-85D8-03D0-48CD572599F9}"/>
          </ac:spMkLst>
        </pc:spChg>
      </pc:sldChg>
      <pc:sldChg chg="del">
        <pc:chgData name="Belaid, Sirine" userId="S::belaids@upmc.edu::5dcb4cf5-c058-49ea-93f8-4f4e6c877fcd" providerId="AD" clId="Web-{F57F2013-AD89-1F6B-D692-D4ABBCB53CC7}" dt="2024-12-12T15:04:33.995" v="67"/>
        <pc:sldMkLst>
          <pc:docMk/>
          <pc:sldMk cId="2086705072" sldId="394"/>
        </pc:sldMkLst>
      </pc:sldChg>
    </pc:docChg>
  </pc:docChgLst>
  <pc:docChgLst>
    <pc:chgData name="Belaid, Sirine" userId="S::belaids@upmc.edu::5dcb4cf5-c058-49ea-93f8-4f4e6c877fcd" providerId="AD" clId="Web-{2D044EF4-C2C0-8FB6-8099-448B465F582D}"/>
    <pc:docChg chg="mod addSld modSld">
      <pc:chgData name="Belaid, Sirine" userId="S::belaids@upmc.edu::5dcb4cf5-c058-49ea-93f8-4f4e6c877fcd" providerId="AD" clId="Web-{2D044EF4-C2C0-8FB6-8099-448B465F582D}" dt="2024-12-04T04:36:03.398" v="246"/>
      <pc:docMkLst>
        <pc:docMk/>
      </pc:docMkLst>
      <pc:sldChg chg="addSp delSp modSp">
        <pc:chgData name="Belaid, Sirine" userId="S::belaids@upmc.edu::5dcb4cf5-c058-49ea-93f8-4f4e6c877fcd" providerId="AD" clId="Web-{2D044EF4-C2C0-8FB6-8099-448B465F582D}" dt="2024-12-04T04:05:17.469" v="36"/>
        <pc:sldMkLst>
          <pc:docMk/>
          <pc:sldMk cId="1471262162" sldId="377"/>
        </pc:sldMkLst>
        <pc:spChg chg="mod">
          <ac:chgData name="Belaid, Sirine" userId="S::belaids@upmc.edu::5dcb4cf5-c058-49ea-93f8-4f4e6c877fcd" providerId="AD" clId="Web-{2D044EF4-C2C0-8FB6-8099-448B465F582D}" dt="2024-12-04T04:00:48.037" v="34" actId="1076"/>
          <ac:spMkLst>
            <pc:docMk/>
            <pc:sldMk cId="1471262162" sldId="377"/>
            <ac:spMk id="14" creationId="{35C15FFC-6CEB-2F98-52A9-42581F2BEE14}"/>
          </ac:spMkLst>
        </pc:spChg>
        <pc:picChg chg="add del mod">
          <ac:chgData name="Belaid, Sirine" userId="S::belaids@upmc.edu::5dcb4cf5-c058-49ea-93f8-4f4e6c877fcd" providerId="AD" clId="Web-{2D044EF4-C2C0-8FB6-8099-448B465F582D}" dt="2024-12-04T04:05:17.469" v="36"/>
          <ac:picMkLst>
            <pc:docMk/>
            <pc:sldMk cId="1471262162" sldId="377"/>
            <ac:picMk id="2" creationId="{1EF4D62E-2BCA-D8D3-C396-A346DB6914BB}"/>
          </ac:picMkLst>
        </pc:picChg>
      </pc:sldChg>
      <pc:sldChg chg="addSp delSp modSp">
        <pc:chgData name="Belaid, Sirine" userId="S::belaids@upmc.edu::5dcb4cf5-c058-49ea-93f8-4f4e6c877fcd" providerId="AD" clId="Web-{2D044EF4-C2C0-8FB6-8099-448B465F582D}" dt="2024-12-04T04:05:57.674" v="48" actId="1076"/>
        <pc:sldMkLst>
          <pc:docMk/>
          <pc:sldMk cId="249774899" sldId="385"/>
        </pc:sldMkLst>
        <pc:spChg chg="add del mod">
          <ac:chgData name="Belaid, Sirine" userId="S::belaids@upmc.edu::5dcb4cf5-c058-49ea-93f8-4f4e6c877fcd" providerId="AD" clId="Web-{2D044EF4-C2C0-8FB6-8099-448B465F582D}" dt="2024-12-04T04:05:28.767" v="40"/>
          <ac:spMkLst>
            <pc:docMk/>
            <pc:sldMk cId="249774899" sldId="385"/>
            <ac:spMk id="5" creationId="{4CB57A87-6D23-1F89-8344-5C56ACF0A737}"/>
          </ac:spMkLst>
        </pc:spChg>
        <pc:picChg chg="add mod">
          <ac:chgData name="Belaid, Sirine" userId="S::belaids@upmc.edu::5dcb4cf5-c058-49ea-93f8-4f4e6c877fcd" providerId="AD" clId="Web-{2D044EF4-C2C0-8FB6-8099-448B465F582D}" dt="2024-12-04T04:05:57.674" v="48" actId="1076"/>
          <ac:picMkLst>
            <pc:docMk/>
            <pc:sldMk cId="249774899" sldId="385"/>
            <ac:picMk id="2" creationId="{BDF0E3A3-B93B-6105-6BE4-19F4454DDFB6}"/>
          </ac:picMkLst>
        </pc:picChg>
        <pc:picChg chg="del">
          <ac:chgData name="Belaid, Sirine" userId="S::belaids@upmc.edu::5dcb4cf5-c058-49ea-93f8-4f4e6c877fcd" providerId="AD" clId="Web-{2D044EF4-C2C0-8FB6-8099-448B465F582D}" dt="2024-12-04T04:05:22.579" v="38"/>
          <ac:picMkLst>
            <pc:docMk/>
            <pc:sldMk cId="249774899" sldId="385"/>
            <ac:picMk id="4" creationId="{F9669FBE-FB50-92B0-432E-5AC30BFAC3CF}"/>
          </ac:picMkLst>
        </pc:picChg>
        <pc:cxnChg chg="mod">
          <ac:chgData name="Belaid, Sirine" userId="S::belaids@upmc.edu::5dcb4cf5-c058-49ea-93f8-4f4e6c877fcd" providerId="AD" clId="Web-{2D044EF4-C2C0-8FB6-8099-448B465F582D}" dt="2024-12-04T04:05:55.018" v="47" actId="1076"/>
          <ac:cxnSpMkLst>
            <pc:docMk/>
            <pc:sldMk cId="249774899" sldId="385"/>
            <ac:cxnSpMk id="8" creationId="{EAA7AACC-D540-CB9D-262B-3F3B8FF060A4}"/>
          </ac:cxnSpMkLst>
        </pc:cxnChg>
      </pc:sldChg>
      <pc:sldChg chg="modSp">
        <pc:chgData name="Belaid, Sirine" userId="S::belaids@upmc.edu::5dcb4cf5-c058-49ea-93f8-4f4e6c877fcd" providerId="AD" clId="Web-{2D044EF4-C2C0-8FB6-8099-448B465F582D}" dt="2024-12-04T04:09:37.558" v="90" actId="20577"/>
        <pc:sldMkLst>
          <pc:docMk/>
          <pc:sldMk cId="3743057861" sldId="386"/>
        </pc:sldMkLst>
        <pc:spChg chg="mod">
          <ac:chgData name="Belaid, Sirine" userId="S::belaids@upmc.edu::5dcb4cf5-c058-49ea-93f8-4f4e6c877fcd" providerId="AD" clId="Web-{2D044EF4-C2C0-8FB6-8099-448B465F582D}" dt="2024-12-04T04:09:37.558" v="90" actId="20577"/>
          <ac:spMkLst>
            <pc:docMk/>
            <pc:sldMk cId="3743057861" sldId="386"/>
            <ac:spMk id="3" creationId="{6B57145F-A3D4-5C8F-5BBE-CC4E7BC1E90B}"/>
          </ac:spMkLst>
        </pc:spChg>
      </pc:sldChg>
      <pc:sldChg chg="addSp delSp modSp">
        <pc:chgData name="Belaid, Sirine" userId="S::belaids@upmc.edu::5dcb4cf5-c058-49ea-93f8-4f4e6c877fcd" providerId="AD" clId="Web-{2D044EF4-C2C0-8FB6-8099-448B465F582D}" dt="2024-12-04T04:09:57.824" v="101" actId="20577"/>
        <pc:sldMkLst>
          <pc:docMk/>
          <pc:sldMk cId="2301887968" sldId="387"/>
        </pc:sldMkLst>
        <pc:spChg chg="mod">
          <ac:chgData name="Belaid, Sirine" userId="S::belaids@upmc.edu::5dcb4cf5-c058-49ea-93f8-4f4e6c877fcd" providerId="AD" clId="Web-{2D044EF4-C2C0-8FB6-8099-448B465F582D}" dt="2024-12-04T04:09:57.824" v="101" actId="20577"/>
          <ac:spMkLst>
            <pc:docMk/>
            <pc:sldMk cId="2301887968" sldId="387"/>
            <ac:spMk id="2" creationId="{146ABACD-E5FC-771D-118F-2B844414B97D}"/>
          </ac:spMkLst>
        </pc:spChg>
        <pc:spChg chg="del">
          <ac:chgData name="Belaid, Sirine" userId="S::belaids@upmc.edu::5dcb4cf5-c058-49ea-93f8-4f4e6c877fcd" providerId="AD" clId="Web-{2D044EF4-C2C0-8FB6-8099-448B465F582D}" dt="2024-12-03T19:24:13.590" v="1"/>
          <ac:spMkLst>
            <pc:docMk/>
            <pc:sldMk cId="2301887968" sldId="387"/>
            <ac:spMk id="3" creationId="{E741DE41-57B0-F79C-5265-0E358924F034}"/>
          </ac:spMkLst>
        </pc:spChg>
        <pc:picChg chg="add mod">
          <ac:chgData name="Belaid, Sirine" userId="S::belaids@upmc.edu::5dcb4cf5-c058-49ea-93f8-4f4e6c877fcd" providerId="AD" clId="Web-{2D044EF4-C2C0-8FB6-8099-448B465F582D}" dt="2024-12-03T19:40:44.498" v="3" actId="1076"/>
          <ac:picMkLst>
            <pc:docMk/>
            <pc:sldMk cId="2301887968" sldId="387"/>
            <ac:picMk id="3" creationId="{810541E0-8A79-01D8-C40B-C1CE60AC7C95}"/>
          </ac:picMkLst>
        </pc:picChg>
        <pc:picChg chg="add mod ord">
          <ac:chgData name="Belaid, Sirine" userId="S::belaids@upmc.edu::5dcb4cf5-c058-49ea-93f8-4f4e6c877fcd" providerId="AD" clId="Web-{2D044EF4-C2C0-8FB6-8099-448B465F582D}" dt="2024-12-03T20:29:52.921" v="8" actId="1076"/>
          <ac:picMkLst>
            <pc:docMk/>
            <pc:sldMk cId="2301887968" sldId="387"/>
            <ac:picMk id="4" creationId="{66407B73-10FA-BB48-FFD3-1D37778569DD}"/>
          </ac:picMkLst>
        </pc:picChg>
        <pc:picChg chg="add mod">
          <ac:chgData name="Belaid, Sirine" userId="S::belaids@upmc.edu::5dcb4cf5-c058-49ea-93f8-4f4e6c877fcd" providerId="AD" clId="Web-{2D044EF4-C2C0-8FB6-8099-448B465F582D}" dt="2024-12-03T20:29:12.872" v="5"/>
          <ac:picMkLst>
            <pc:docMk/>
            <pc:sldMk cId="2301887968" sldId="387"/>
            <ac:picMk id="5" creationId="{006D3BE1-39D9-E3A1-5396-C3E8E929D575}"/>
          </ac:picMkLst>
        </pc:picChg>
        <pc:picChg chg="add mod">
          <ac:chgData name="Belaid, Sirine" userId="S::belaids@upmc.edu::5dcb4cf5-c058-49ea-93f8-4f4e6c877fcd" providerId="AD" clId="Web-{2D044EF4-C2C0-8FB6-8099-448B465F582D}" dt="2024-12-03T20:29:54.296" v="9" actId="1076"/>
          <ac:picMkLst>
            <pc:docMk/>
            <pc:sldMk cId="2301887968" sldId="387"/>
            <ac:picMk id="6" creationId="{B8357494-6C64-CE7D-8E84-E3B3B91ABADD}"/>
          </ac:picMkLst>
        </pc:picChg>
      </pc:sldChg>
      <pc:sldChg chg="modSp new modNotes">
        <pc:chgData name="Belaid, Sirine" userId="S::belaids@upmc.edu::5dcb4cf5-c058-49ea-93f8-4f4e6c877fcd" providerId="AD" clId="Web-{2D044EF4-C2C0-8FB6-8099-448B465F582D}" dt="2024-12-04T04:36:03.398" v="246"/>
        <pc:sldMkLst>
          <pc:docMk/>
          <pc:sldMk cId="3342538804" sldId="388"/>
        </pc:sldMkLst>
        <pc:spChg chg="mod">
          <ac:chgData name="Belaid, Sirine" userId="S::belaids@upmc.edu::5dcb4cf5-c058-49ea-93f8-4f4e6c877fcd" providerId="AD" clId="Web-{2D044EF4-C2C0-8FB6-8099-448B465F582D}" dt="2024-12-04T04:33:02.345" v="117" actId="20577"/>
          <ac:spMkLst>
            <pc:docMk/>
            <pc:sldMk cId="3342538804" sldId="388"/>
            <ac:spMk id="2" creationId="{F15E40A9-1ADA-D72F-B394-AE4EAAF52A32}"/>
          </ac:spMkLst>
        </pc:spChg>
        <pc:spChg chg="mod">
          <ac:chgData name="Belaid, Sirine" userId="S::belaids@upmc.edu::5dcb4cf5-c058-49ea-93f8-4f4e6c877fcd" providerId="AD" clId="Web-{2D044EF4-C2C0-8FB6-8099-448B465F582D}" dt="2024-12-04T04:35:33.490" v="229" actId="20577"/>
          <ac:spMkLst>
            <pc:docMk/>
            <pc:sldMk cId="3342538804" sldId="388"/>
            <ac:spMk id="3" creationId="{19813B5D-F53D-0C33-97ED-29C6246EA762}"/>
          </ac:spMkLst>
        </pc:spChg>
      </pc:sldChg>
      <pc:sldChg chg="add replId">
        <pc:chgData name="Belaid, Sirine" userId="S::belaids@upmc.edu::5dcb4cf5-c058-49ea-93f8-4f4e6c877fcd" providerId="AD" clId="Web-{2D044EF4-C2C0-8FB6-8099-448B465F582D}" dt="2024-12-04T04:27:23.755" v="103"/>
        <pc:sldMkLst>
          <pc:docMk/>
          <pc:sldMk cId="200882343" sldId="389"/>
        </pc:sldMkLst>
      </pc:sldChg>
    </pc:docChg>
  </pc:docChgLst>
  <pc:docChgLst>
    <pc:chgData name="Belaid, Sirine" userId="S::belaids@upmc.edu::5dcb4cf5-c058-49ea-93f8-4f4e6c877fcd" providerId="AD" clId="Web-{2C87839C-64AF-094E-EC63-8DCBC42D96AF}"/>
    <pc:docChg chg="modSld">
      <pc:chgData name="Belaid, Sirine" userId="S::belaids@upmc.edu::5dcb4cf5-c058-49ea-93f8-4f4e6c877fcd" providerId="AD" clId="Web-{2C87839C-64AF-094E-EC63-8DCBC42D96AF}" dt="2025-01-13T04:04:28.209" v="68" actId="1076"/>
      <pc:docMkLst>
        <pc:docMk/>
      </pc:docMkLst>
      <pc:sldChg chg="modNotes">
        <pc:chgData name="Belaid, Sirine" userId="S::belaids@upmc.edu::5dcb4cf5-c058-49ea-93f8-4f4e6c877fcd" providerId="AD" clId="Web-{2C87839C-64AF-094E-EC63-8DCBC42D96AF}" dt="2025-01-13T03:07:44.198" v="5"/>
        <pc:sldMkLst>
          <pc:docMk/>
          <pc:sldMk cId="2064663832" sldId="288"/>
        </pc:sldMkLst>
      </pc:sldChg>
      <pc:sldChg chg="modNotes">
        <pc:chgData name="Belaid, Sirine" userId="S::belaids@upmc.edu::5dcb4cf5-c058-49ea-93f8-4f4e6c877fcd" providerId="AD" clId="Web-{2C87839C-64AF-094E-EC63-8DCBC42D96AF}" dt="2025-01-13T03:10:43.408" v="42"/>
        <pc:sldMkLst>
          <pc:docMk/>
          <pc:sldMk cId="1575805153" sldId="291"/>
        </pc:sldMkLst>
      </pc:sldChg>
      <pc:sldChg chg="modNotes">
        <pc:chgData name="Belaid, Sirine" userId="S::belaids@upmc.edu::5dcb4cf5-c058-49ea-93f8-4f4e6c877fcd" providerId="AD" clId="Web-{2C87839C-64AF-094E-EC63-8DCBC42D96AF}" dt="2025-01-13T03:09:28.765" v="30"/>
        <pc:sldMkLst>
          <pc:docMk/>
          <pc:sldMk cId="3765036932" sldId="351"/>
        </pc:sldMkLst>
      </pc:sldChg>
      <pc:sldChg chg="modNotes">
        <pc:chgData name="Belaid, Sirine" userId="S::belaids@upmc.edu::5dcb4cf5-c058-49ea-93f8-4f4e6c877fcd" providerId="AD" clId="Web-{2C87839C-64AF-094E-EC63-8DCBC42D96AF}" dt="2025-01-13T03:14:16.557" v="43"/>
        <pc:sldMkLst>
          <pc:docMk/>
          <pc:sldMk cId="1022786307" sldId="355"/>
        </pc:sldMkLst>
      </pc:sldChg>
      <pc:sldChg chg="modSp modNotes">
        <pc:chgData name="Belaid, Sirine" userId="S::belaids@upmc.edu::5dcb4cf5-c058-49ea-93f8-4f4e6c877fcd" providerId="AD" clId="Web-{2C87839C-64AF-094E-EC63-8DCBC42D96AF}" dt="2025-01-13T03:16:08.780" v="57"/>
        <pc:sldMkLst>
          <pc:docMk/>
          <pc:sldMk cId="1919480477" sldId="360"/>
        </pc:sldMkLst>
        <pc:spChg chg="mod">
          <ac:chgData name="Belaid, Sirine" userId="S::belaids@upmc.edu::5dcb4cf5-c058-49ea-93f8-4f4e6c877fcd" providerId="AD" clId="Web-{2C87839C-64AF-094E-EC63-8DCBC42D96AF}" dt="2025-01-13T03:15:12.168" v="48" actId="20577"/>
          <ac:spMkLst>
            <pc:docMk/>
            <pc:sldMk cId="1919480477" sldId="360"/>
            <ac:spMk id="2" creationId="{F6D64424-A927-6867-0632-D218B464FCAA}"/>
          </ac:spMkLst>
        </pc:spChg>
      </pc:sldChg>
      <pc:sldChg chg="modSp mod modShow">
        <pc:chgData name="Belaid, Sirine" userId="S::belaids@upmc.edu::5dcb4cf5-c058-49ea-93f8-4f4e6c877fcd" providerId="AD" clId="Web-{2C87839C-64AF-094E-EC63-8DCBC42D96AF}" dt="2025-01-13T03:16:30.515" v="58" actId="20577"/>
        <pc:sldMkLst>
          <pc:docMk/>
          <pc:sldMk cId="2817742152" sldId="361"/>
        </pc:sldMkLst>
        <pc:spChg chg="mod">
          <ac:chgData name="Belaid, Sirine" userId="S::belaids@upmc.edu::5dcb4cf5-c058-49ea-93f8-4f4e6c877fcd" providerId="AD" clId="Web-{2C87839C-64AF-094E-EC63-8DCBC42D96AF}" dt="2025-01-13T03:16:30.515" v="58" actId="20577"/>
          <ac:spMkLst>
            <pc:docMk/>
            <pc:sldMk cId="2817742152" sldId="361"/>
            <ac:spMk id="3" creationId="{B6FB2075-FE59-DFEA-3EE2-6A1D6EAFE127}"/>
          </ac:spMkLst>
        </pc:spChg>
      </pc:sldChg>
      <pc:sldChg chg="mod modShow">
        <pc:chgData name="Belaid, Sirine" userId="S::belaids@upmc.edu::5dcb4cf5-c058-49ea-93f8-4f4e6c877fcd" providerId="AD" clId="Web-{2C87839C-64AF-094E-EC63-8DCBC42D96AF}" dt="2025-01-13T03:05:12.990" v="1"/>
        <pc:sldMkLst>
          <pc:docMk/>
          <pc:sldMk cId="2208660293" sldId="366"/>
        </pc:sldMkLst>
      </pc:sldChg>
      <pc:sldChg chg="mod modShow">
        <pc:chgData name="Belaid, Sirine" userId="S::belaids@upmc.edu::5dcb4cf5-c058-49ea-93f8-4f4e6c877fcd" providerId="AD" clId="Web-{2C87839C-64AF-094E-EC63-8DCBC42D96AF}" dt="2025-01-13T03:05:22.881" v="2"/>
        <pc:sldMkLst>
          <pc:docMk/>
          <pc:sldMk cId="3004633114" sldId="367"/>
        </pc:sldMkLst>
      </pc:sldChg>
      <pc:sldChg chg="modSp modNotes">
        <pc:chgData name="Belaid, Sirine" userId="S::belaids@upmc.edu::5dcb4cf5-c058-49ea-93f8-4f4e6c877fcd" providerId="AD" clId="Web-{2C87839C-64AF-094E-EC63-8DCBC42D96AF}" dt="2025-01-13T04:04:10.442" v="67" actId="20577"/>
        <pc:sldMkLst>
          <pc:docMk/>
          <pc:sldMk cId="3434993078" sldId="379"/>
        </pc:sldMkLst>
        <pc:spChg chg="mod">
          <ac:chgData name="Belaid, Sirine" userId="S::belaids@upmc.edu::5dcb4cf5-c058-49ea-93f8-4f4e6c877fcd" providerId="AD" clId="Web-{2C87839C-64AF-094E-EC63-8DCBC42D96AF}" dt="2025-01-13T04:04:10.442" v="67" actId="20577"/>
          <ac:spMkLst>
            <pc:docMk/>
            <pc:sldMk cId="3434993078" sldId="379"/>
            <ac:spMk id="2" creationId="{16195E82-86AE-AB44-06FF-1A93F02750DC}"/>
          </ac:spMkLst>
        </pc:spChg>
      </pc:sldChg>
      <pc:sldChg chg="modSp">
        <pc:chgData name="Belaid, Sirine" userId="S::belaids@upmc.edu::5dcb4cf5-c058-49ea-93f8-4f4e6c877fcd" providerId="AD" clId="Web-{2C87839C-64AF-094E-EC63-8DCBC42D96AF}" dt="2025-01-13T04:04:28.209" v="68" actId="1076"/>
        <pc:sldMkLst>
          <pc:docMk/>
          <pc:sldMk cId="1731714019" sldId="393"/>
        </pc:sldMkLst>
        <pc:spChg chg="mod">
          <ac:chgData name="Belaid, Sirine" userId="S::belaids@upmc.edu::5dcb4cf5-c058-49ea-93f8-4f4e6c877fcd" providerId="AD" clId="Web-{2C87839C-64AF-094E-EC63-8DCBC42D96AF}" dt="2025-01-13T04:04:28.209" v="68" actId="1076"/>
          <ac:spMkLst>
            <pc:docMk/>
            <pc:sldMk cId="1731714019" sldId="393"/>
            <ac:spMk id="3" creationId="{4A01C084-E4E4-6950-077A-5C215D5C06BE}"/>
          </ac:spMkLst>
        </pc:spChg>
      </pc:sldChg>
      <pc:sldChg chg="modNotes">
        <pc:chgData name="Belaid, Sirine" userId="S::belaids@upmc.edu::5dcb4cf5-c058-49ea-93f8-4f4e6c877fcd" providerId="AD" clId="Web-{2C87839C-64AF-094E-EC63-8DCBC42D96AF}" dt="2025-01-13T03:09:05.014" v="11"/>
        <pc:sldMkLst>
          <pc:docMk/>
          <pc:sldMk cId="1625999220" sldId="395"/>
        </pc:sldMkLst>
      </pc:sldChg>
      <pc:sldChg chg="mod modShow">
        <pc:chgData name="Belaid, Sirine" userId="S::belaids@upmc.edu::5dcb4cf5-c058-49ea-93f8-4f4e6c877fcd" providerId="AD" clId="Web-{2C87839C-64AF-094E-EC63-8DCBC42D96AF}" dt="2025-01-13T03:05:28.068" v="3"/>
        <pc:sldMkLst>
          <pc:docMk/>
          <pc:sldMk cId="2372464141" sldId="404"/>
        </pc:sldMkLst>
      </pc:sldChg>
    </pc:docChg>
  </pc:docChgLst>
  <pc:docChgLst>
    <pc:chgData name="Belaid, Sirine" userId="S::belaids@upmc.edu::5dcb4cf5-c058-49ea-93f8-4f4e6c877fcd" providerId="AD" clId="Web-{F0D27E88-6F57-F7B0-7709-EFA96C609C1C}"/>
    <pc:docChg chg="modSld">
      <pc:chgData name="Belaid, Sirine" userId="S::belaids@upmc.edu::5dcb4cf5-c058-49ea-93f8-4f4e6c877fcd" providerId="AD" clId="Web-{F0D27E88-6F57-F7B0-7709-EFA96C609C1C}" dt="2024-12-24T03:29:39.867" v="1" actId="1076"/>
      <pc:docMkLst>
        <pc:docMk/>
      </pc:docMkLst>
      <pc:sldChg chg="modSp">
        <pc:chgData name="Belaid, Sirine" userId="S::belaids@upmc.edu::5dcb4cf5-c058-49ea-93f8-4f4e6c877fcd" providerId="AD" clId="Web-{F0D27E88-6F57-F7B0-7709-EFA96C609C1C}" dt="2024-12-24T03:29:39.867" v="1" actId="1076"/>
        <pc:sldMkLst>
          <pc:docMk/>
          <pc:sldMk cId="412412650" sldId="391"/>
        </pc:sldMkLst>
        <pc:spChg chg="mod">
          <ac:chgData name="Belaid, Sirine" userId="S::belaids@upmc.edu::5dcb4cf5-c058-49ea-93f8-4f4e6c877fcd" providerId="AD" clId="Web-{F0D27E88-6F57-F7B0-7709-EFA96C609C1C}" dt="2024-12-24T03:29:39.867" v="1" actId="1076"/>
          <ac:spMkLst>
            <pc:docMk/>
            <pc:sldMk cId="412412650" sldId="391"/>
            <ac:spMk id="4" creationId="{0C4DFA9F-D5D8-418D-6708-4B57D7393503}"/>
          </ac:spMkLst>
        </pc:spChg>
      </pc:sldChg>
    </pc:docChg>
  </pc:docChgLst>
  <pc:docChgLst>
    <pc:chgData name="Belaid, Sirine" userId="S::belaids@upmc.edu::5dcb4cf5-c058-49ea-93f8-4f4e6c877fcd" providerId="AD" clId="Web-{CA0C33D0-C09E-583B-D4CE-01D9F9A06D6E}"/>
    <pc:docChg chg="addSld delSld modSld sldOrd">
      <pc:chgData name="Belaid, Sirine" userId="S::belaids@upmc.edu::5dcb4cf5-c058-49ea-93f8-4f4e6c877fcd" providerId="AD" clId="Web-{CA0C33D0-C09E-583B-D4CE-01D9F9A06D6E}" dt="2024-11-21T04:39:25.610" v="829" actId="20577"/>
      <pc:docMkLst>
        <pc:docMk/>
      </pc:docMkLst>
      <pc:sldChg chg="modSp">
        <pc:chgData name="Belaid, Sirine" userId="S::belaids@upmc.edu::5dcb4cf5-c058-49ea-93f8-4f4e6c877fcd" providerId="AD" clId="Web-{CA0C33D0-C09E-583B-D4CE-01D9F9A06D6E}" dt="2024-11-21T04:04:54.380" v="478" actId="20577"/>
        <pc:sldMkLst>
          <pc:docMk/>
          <pc:sldMk cId="109857222" sldId="256"/>
        </pc:sldMkLst>
        <pc:spChg chg="mod">
          <ac:chgData name="Belaid, Sirine" userId="S::belaids@upmc.edu::5dcb4cf5-c058-49ea-93f8-4f4e6c877fcd" providerId="AD" clId="Web-{CA0C33D0-C09E-583B-D4CE-01D9F9A06D6E}" dt="2024-11-21T04:04:54.380" v="478" actId="20577"/>
          <ac:spMkLst>
            <pc:docMk/>
            <pc:sldMk cId="109857222" sldId="256"/>
            <ac:spMk id="2" creationId="{00000000-0000-0000-0000-000000000000}"/>
          </ac:spMkLst>
        </pc:spChg>
        <pc:spChg chg="mod">
          <ac:chgData name="Belaid, Sirine" userId="S::belaids@upmc.edu::5dcb4cf5-c058-49ea-93f8-4f4e6c877fcd" providerId="AD" clId="Web-{CA0C33D0-C09E-583B-D4CE-01D9F9A06D6E}" dt="2024-11-21T04:04:50.646" v="476" actId="20577"/>
          <ac:spMkLst>
            <pc:docMk/>
            <pc:sldMk cId="109857222" sldId="256"/>
            <ac:spMk id="3" creationId="{00000000-0000-0000-0000-000000000000}"/>
          </ac:spMkLst>
        </pc:spChg>
      </pc:sldChg>
      <pc:sldChg chg="addSp modSp">
        <pc:chgData name="Belaid, Sirine" userId="S::belaids@upmc.edu::5dcb4cf5-c058-49ea-93f8-4f4e6c877fcd" providerId="AD" clId="Web-{CA0C33D0-C09E-583B-D4CE-01D9F9A06D6E}" dt="2024-11-21T04:09:42.932" v="515" actId="14100"/>
        <pc:sldMkLst>
          <pc:docMk/>
          <pc:sldMk cId="344766927" sldId="259"/>
        </pc:sldMkLst>
        <pc:spChg chg="add mod">
          <ac:chgData name="Belaid, Sirine" userId="S::belaids@upmc.edu::5dcb4cf5-c058-49ea-93f8-4f4e6c877fcd" providerId="AD" clId="Web-{CA0C33D0-C09E-583B-D4CE-01D9F9A06D6E}" dt="2024-11-21T04:07:59.753" v="503" actId="1076"/>
          <ac:spMkLst>
            <pc:docMk/>
            <pc:sldMk cId="344766927" sldId="259"/>
            <ac:spMk id="5" creationId="{C3283941-314B-E5AE-FFFD-61566629F0CD}"/>
          </ac:spMkLst>
        </pc:spChg>
        <pc:spChg chg="add mod">
          <ac:chgData name="Belaid, Sirine" userId="S::belaids@upmc.edu::5dcb4cf5-c058-49ea-93f8-4f4e6c877fcd" providerId="AD" clId="Web-{CA0C33D0-C09E-583B-D4CE-01D9F9A06D6E}" dt="2024-11-21T04:09:42.932" v="515" actId="14100"/>
          <ac:spMkLst>
            <pc:docMk/>
            <pc:sldMk cId="344766927" sldId="259"/>
            <ac:spMk id="7" creationId="{FD96D3BB-86B3-AE7F-C26B-7FEFA0B328FE}"/>
          </ac:spMkLst>
        </pc:spChg>
      </pc:sldChg>
      <pc:sldChg chg="addSp modSp">
        <pc:chgData name="Belaid, Sirine" userId="S::belaids@upmc.edu::5dcb4cf5-c058-49ea-93f8-4f4e6c877fcd" providerId="AD" clId="Web-{CA0C33D0-C09E-583B-D4CE-01D9F9A06D6E}" dt="2024-11-21T04:09:19.508" v="511" actId="14100"/>
        <pc:sldMkLst>
          <pc:docMk/>
          <pc:sldMk cId="3651327643" sldId="260"/>
        </pc:sldMkLst>
        <pc:spChg chg="add mod">
          <ac:chgData name="Belaid, Sirine" userId="S::belaids@upmc.edu::5dcb4cf5-c058-49ea-93f8-4f4e6c877fcd" providerId="AD" clId="Web-{CA0C33D0-C09E-583B-D4CE-01D9F9A06D6E}" dt="2024-11-21T04:08:57.648" v="508" actId="14100"/>
          <ac:spMkLst>
            <pc:docMk/>
            <pc:sldMk cId="3651327643" sldId="260"/>
            <ac:spMk id="6" creationId="{4C8DCD83-E78E-ED43-17BD-373448DE628C}"/>
          </ac:spMkLst>
        </pc:spChg>
        <pc:spChg chg="add mod">
          <ac:chgData name="Belaid, Sirine" userId="S::belaids@upmc.edu::5dcb4cf5-c058-49ea-93f8-4f4e6c877fcd" providerId="AD" clId="Web-{CA0C33D0-C09E-583B-D4CE-01D9F9A06D6E}" dt="2024-11-21T04:09:19.508" v="511" actId="14100"/>
          <ac:spMkLst>
            <pc:docMk/>
            <pc:sldMk cId="3651327643" sldId="260"/>
            <ac:spMk id="7" creationId="{C98DE49E-9BCF-F9F1-67AD-9CD0D3826DEC}"/>
          </ac:spMkLst>
        </pc:spChg>
      </pc:sldChg>
      <pc:sldChg chg="addSp modSp">
        <pc:chgData name="Belaid, Sirine" userId="S::belaids@upmc.edu::5dcb4cf5-c058-49ea-93f8-4f4e6c877fcd" providerId="AD" clId="Web-{CA0C33D0-C09E-583B-D4CE-01D9F9A06D6E}" dt="2024-11-21T04:30:14.165" v="697" actId="14100"/>
        <pc:sldMkLst>
          <pc:docMk/>
          <pc:sldMk cId="2302766718" sldId="261"/>
        </pc:sldMkLst>
        <pc:spChg chg="add mod">
          <ac:chgData name="Belaid, Sirine" userId="S::belaids@upmc.edu::5dcb4cf5-c058-49ea-93f8-4f4e6c877fcd" providerId="AD" clId="Web-{CA0C33D0-C09E-583B-D4CE-01D9F9A06D6E}" dt="2024-11-21T04:11:33.801" v="537" actId="1076"/>
          <ac:spMkLst>
            <pc:docMk/>
            <pc:sldMk cId="2302766718" sldId="261"/>
            <ac:spMk id="6" creationId="{59AB9A91-6868-9208-0C3C-E2B77CD802B3}"/>
          </ac:spMkLst>
        </pc:spChg>
        <pc:spChg chg="add mod">
          <ac:chgData name="Belaid, Sirine" userId="S::belaids@upmc.edu::5dcb4cf5-c058-49ea-93f8-4f4e6c877fcd" providerId="AD" clId="Web-{CA0C33D0-C09E-583B-D4CE-01D9F9A06D6E}" dt="2024-11-21T04:11:37.660" v="539" actId="1076"/>
          <ac:spMkLst>
            <pc:docMk/>
            <pc:sldMk cId="2302766718" sldId="261"/>
            <ac:spMk id="8" creationId="{C7A73E15-61A5-E4B3-0F7A-EF3D7FBF84C6}"/>
          </ac:spMkLst>
        </pc:spChg>
        <pc:spChg chg="add mod">
          <ac:chgData name="Belaid, Sirine" userId="S::belaids@upmc.edu::5dcb4cf5-c058-49ea-93f8-4f4e6c877fcd" providerId="AD" clId="Web-{CA0C33D0-C09E-583B-D4CE-01D9F9A06D6E}" dt="2024-11-21T04:11:41.536" v="541" actId="1076"/>
          <ac:spMkLst>
            <pc:docMk/>
            <pc:sldMk cId="2302766718" sldId="261"/>
            <ac:spMk id="10" creationId="{19D5FEC9-A227-5FDD-332A-0C29A3C4D3D7}"/>
          </ac:spMkLst>
        </pc:spChg>
        <pc:spChg chg="add mod">
          <ac:chgData name="Belaid, Sirine" userId="S::belaids@upmc.edu::5dcb4cf5-c058-49ea-93f8-4f4e6c877fcd" providerId="AD" clId="Web-{CA0C33D0-C09E-583B-D4CE-01D9F9A06D6E}" dt="2024-11-21T04:27:48.639" v="672" actId="14100"/>
          <ac:spMkLst>
            <pc:docMk/>
            <pc:sldMk cId="2302766718" sldId="261"/>
            <ac:spMk id="12" creationId="{AF3D8C70-3150-27C0-2D43-04BB4B781995}"/>
          </ac:spMkLst>
        </pc:spChg>
        <pc:spChg chg="add mod">
          <ac:chgData name="Belaid, Sirine" userId="S::belaids@upmc.edu::5dcb4cf5-c058-49ea-93f8-4f4e6c877fcd" providerId="AD" clId="Web-{CA0C33D0-C09E-583B-D4CE-01D9F9A06D6E}" dt="2024-11-21T04:28:16.235" v="678" actId="14100"/>
          <ac:spMkLst>
            <pc:docMk/>
            <pc:sldMk cId="2302766718" sldId="261"/>
            <ac:spMk id="14" creationId="{30DDA2BD-58CC-3571-0D62-CB72B2E12291}"/>
          </ac:spMkLst>
        </pc:spChg>
        <pc:spChg chg="add mod">
          <ac:chgData name="Belaid, Sirine" userId="S::belaids@upmc.edu::5dcb4cf5-c058-49ea-93f8-4f4e6c877fcd" providerId="AD" clId="Web-{CA0C33D0-C09E-583B-D4CE-01D9F9A06D6E}" dt="2024-11-21T04:28:41.127" v="683" actId="14100"/>
          <ac:spMkLst>
            <pc:docMk/>
            <pc:sldMk cId="2302766718" sldId="261"/>
            <ac:spMk id="16" creationId="{4ABC1E52-6A91-D66B-231E-2CAA638C3A65}"/>
          </ac:spMkLst>
        </pc:spChg>
        <pc:spChg chg="add mod">
          <ac:chgData name="Belaid, Sirine" userId="S::belaids@upmc.edu::5dcb4cf5-c058-49ea-93f8-4f4e6c877fcd" providerId="AD" clId="Web-{CA0C33D0-C09E-583B-D4CE-01D9F9A06D6E}" dt="2024-11-21T04:29:03.379" v="686" actId="14100"/>
          <ac:spMkLst>
            <pc:docMk/>
            <pc:sldMk cId="2302766718" sldId="261"/>
            <ac:spMk id="18" creationId="{A1D21C41-5547-97D6-4988-D99D75AFBB3A}"/>
          </ac:spMkLst>
        </pc:spChg>
        <pc:spChg chg="add mod">
          <ac:chgData name="Belaid, Sirine" userId="S::belaids@upmc.edu::5dcb4cf5-c058-49ea-93f8-4f4e6c877fcd" providerId="AD" clId="Web-{CA0C33D0-C09E-583B-D4CE-01D9F9A06D6E}" dt="2024-11-21T04:29:31.678" v="692" actId="1076"/>
          <ac:spMkLst>
            <pc:docMk/>
            <pc:sldMk cId="2302766718" sldId="261"/>
            <ac:spMk id="20" creationId="{B650BEB8-BEA3-49C3-2C18-960CB9661CA0}"/>
          </ac:spMkLst>
        </pc:spChg>
        <pc:spChg chg="add mod">
          <ac:chgData name="Belaid, Sirine" userId="S::belaids@upmc.edu::5dcb4cf5-c058-49ea-93f8-4f4e6c877fcd" providerId="AD" clId="Web-{CA0C33D0-C09E-583B-D4CE-01D9F9A06D6E}" dt="2024-11-21T04:30:14.165" v="697" actId="14100"/>
          <ac:spMkLst>
            <pc:docMk/>
            <pc:sldMk cId="2302766718" sldId="261"/>
            <ac:spMk id="22" creationId="{FCA5C757-B61D-A4B2-07BE-B36196757BBE}"/>
          </ac:spMkLst>
        </pc:spChg>
      </pc:sldChg>
      <pc:sldChg chg="addSp delSp modSp">
        <pc:chgData name="Belaid, Sirine" userId="S::belaids@upmc.edu::5dcb4cf5-c058-49ea-93f8-4f4e6c877fcd" providerId="AD" clId="Web-{CA0C33D0-C09E-583B-D4CE-01D9F9A06D6E}" dt="2024-11-21T04:31:36.749" v="706" actId="1076"/>
        <pc:sldMkLst>
          <pc:docMk/>
          <pc:sldMk cId="576414548" sldId="262"/>
        </pc:sldMkLst>
        <pc:spChg chg="add del">
          <ac:chgData name="Belaid, Sirine" userId="S::belaids@upmc.edu::5dcb4cf5-c058-49ea-93f8-4f4e6c877fcd" providerId="AD" clId="Web-{CA0C33D0-C09E-583B-D4CE-01D9F9A06D6E}" dt="2024-11-21T04:31:18.748" v="704"/>
          <ac:spMkLst>
            <pc:docMk/>
            <pc:sldMk cId="576414548" sldId="262"/>
            <ac:spMk id="7" creationId="{3CB9C7D5-4DBA-6576-9128-366C3E7F7E60}"/>
          </ac:spMkLst>
        </pc:spChg>
        <pc:spChg chg="add mod">
          <ac:chgData name="Belaid, Sirine" userId="S::belaids@upmc.edu::5dcb4cf5-c058-49ea-93f8-4f4e6c877fcd" providerId="AD" clId="Web-{CA0C33D0-C09E-583B-D4CE-01D9F9A06D6E}" dt="2024-11-21T04:31:36.749" v="706" actId="1076"/>
          <ac:spMkLst>
            <pc:docMk/>
            <pc:sldMk cId="576414548" sldId="262"/>
            <ac:spMk id="9" creationId="{F182FC2C-ABCE-D16D-70B2-F71259526D8E}"/>
          </ac:spMkLst>
        </pc:spChg>
      </pc:sldChg>
      <pc:sldChg chg="addSp modSp">
        <pc:chgData name="Belaid, Sirine" userId="S::belaids@upmc.edu::5dcb4cf5-c058-49ea-93f8-4f4e6c877fcd" providerId="AD" clId="Web-{CA0C33D0-C09E-583B-D4CE-01D9F9A06D6E}" dt="2024-11-21T04:17:34.721" v="590" actId="14100"/>
        <pc:sldMkLst>
          <pc:docMk/>
          <pc:sldMk cId="2595590755" sldId="264"/>
        </pc:sldMkLst>
        <pc:spChg chg="add mod">
          <ac:chgData name="Belaid, Sirine" userId="S::belaids@upmc.edu::5dcb4cf5-c058-49ea-93f8-4f4e6c877fcd" providerId="AD" clId="Web-{CA0C33D0-C09E-583B-D4CE-01D9F9A06D6E}" dt="2024-11-21T04:10:12.184" v="518"/>
          <ac:spMkLst>
            <pc:docMk/>
            <pc:sldMk cId="2595590755" sldId="264"/>
            <ac:spMk id="4" creationId="{2990DE21-E26E-9308-8E5C-D7F669956FA6}"/>
          </ac:spMkLst>
        </pc:spChg>
        <pc:spChg chg="add mod">
          <ac:chgData name="Belaid, Sirine" userId="S::belaids@upmc.edu::5dcb4cf5-c058-49ea-93f8-4f4e6c877fcd" providerId="AD" clId="Web-{CA0C33D0-C09E-583B-D4CE-01D9F9A06D6E}" dt="2024-11-21T04:10:27.466" v="521" actId="14100"/>
          <ac:spMkLst>
            <pc:docMk/>
            <pc:sldMk cId="2595590755" sldId="264"/>
            <ac:spMk id="5" creationId="{F3A5027F-06CB-CD00-DB5B-5448BD354F44}"/>
          </ac:spMkLst>
        </pc:spChg>
        <pc:spChg chg="add mod">
          <ac:chgData name="Belaid, Sirine" userId="S::belaids@upmc.edu::5dcb4cf5-c058-49ea-93f8-4f4e6c877fcd" providerId="AD" clId="Web-{CA0C33D0-C09E-583B-D4CE-01D9F9A06D6E}" dt="2024-11-21T04:10:34.281" v="523" actId="1076"/>
          <ac:spMkLst>
            <pc:docMk/>
            <pc:sldMk cId="2595590755" sldId="264"/>
            <ac:spMk id="6" creationId="{7AD2551D-AA2D-6AB2-550A-2B359EC2A3E1}"/>
          </ac:spMkLst>
        </pc:spChg>
        <pc:spChg chg="add mod">
          <ac:chgData name="Belaid, Sirine" userId="S::belaids@upmc.edu::5dcb4cf5-c058-49ea-93f8-4f4e6c877fcd" providerId="AD" clId="Web-{CA0C33D0-C09E-583B-D4CE-01D9F9A06D6E}" dt="2024-11-21T04:17:34.721" v="590" actId="14100"/>
          <ac:spMkLst>
            <pc:docMk/>
            <pc:sldMk cId="2595590755" sldId="264"/>
            <ac:spMk id="8" creationId="{D1ADD205-DCAF-C98D-7976-61B0BA44D8EC}"/>
          </ac:spMkLst>
        </pc:spChg>
        <pc:spChg chg="add mod">
          <ac:chgData name="Belaid, Sirine" userId="S::belaids@upmc.edu::5dcb4cf5-c058-49ea-93f8-4f4e6c877fcd" providerId="AD" clId="Web-{CA0C33D0-C09E-583B-D4CE-01D9F9A06D6E}" dt="2024-11-21T04:13:38.376" v="556" actId="14100"/>
          <ac:spMkLst>
            <pc:docMk/>
            <pc:sldMk cId="2595590755" sldId="264"/>
            <ac:spMk id="10" creationId="{F0219CCC-D8B3-C646-6F2B-C47AF331C1CC}"/>
          </ac:spMkLst>
        </pc:spChg>
        <pc:spChg chg="add mod">
          <ac:chgData name="Belaid, Sirine" userId="S::belaids@upmc.edu::5dcb4cf5-c058-49ea-93f8-4f4e6c877fcd" providerId="AD" clId="Web-{CA0C33D0-C09E-583B-D4CE-01D9F9A06D6E}" dt="2024-11-21T04:17:21.298" v="588" actId="14100"/>
          <ac:spMkLst>
            <pc:docMk/>
            <pc:sldMk cId="2595590755" sldId="264"/>
            <ac:spMk id="11" creationId="{A1A26B26-8830-DD62-6351-1C0383C065FC}"/>
          </ac:spMkLst>
        </pc:spChg>
        <pc:spChg chg="add mod">
          <ac:chgData name="Belaid, Sirine" userId="S::belaids@upmc.edu::5dcb4cf5-c058-49ea-93f8-4f4e6c877fcd" providerId="AD" clId="Web-{CA0C33D0-C09E-583B-D4CE-01D9F9A06D6E}" dt="2024-11-21T04:14:44.803" v="570" actId="14100"/>
          <ac:spMkLst>
            <pc:docMk/>
            <pc:sldMk cId="2595590755" sldId="264"/>
            <ac:spMk id="12" creationId="{2EB5C46A-7260-BE61-8902-13E19AD03B99}"/>
          </ac:spMkLst>
        </pc:spChg>
        <pc:spChg chg="add mod">
          <ac:chgData name="Belaid, Sirine" userId="S::belaids@upmc.edu::5dcb4cf5-c058-49ea-93f8-4f4e6c877fcd" providerId="AD" clId="Web-{CA0C33D0-C09E-583B-D4CE-01D9F9A06D6E}" dt="2024-11-21T04:15:00.023" v="574" actId="14100"/>
          <ac:spMkLst>
            <pc:docMk/>
            <pc:sldMk cId="2595590755" sldId="264"/>
            <ac:spMk id="13" creationId="{52209403-C1A1-FE25-C873-1911C98C7A5B}"/>
          </ac:spMkLst>
        </pc:spChg>
        <pc:spChg chg="add mod">
          <ac:chgData name="Belaid, Sirine" userId="S::belaids@upmc.edu::5dcb4cf5-c058-49ea-93f8-4f4e6c877fcd" providerId="AD" clId="Web-{CA0C33D0-C09E-583B-D4CE-01D9F9A06D6E}" dt="2024-11-21T04:15:18.149" v="577" actId="14100"/>
          <ac:spMkLst>
            <pc:docMk/>
            <pc:sldMk cId="2595590755" sldId="264"/>
            <ac:spMk id="14" creationId="{1C36D20E-F80A-8414-282C-E5E3FF4BEC18}"/>
          </ac:spMkLst>
        </pc:spChg>
        <pc:spChg chg="add mod">
          <ac:chgData name="Belaid, Sirine" userId="S::belaids@upmc.edu::5dcb4cf5-c058-49ea-93f8-4f4e6c877fcd" providerId="AD" clId="Web-{CA0C33D0-C09E-583B-D4CE-01D9F9A06D6E}" dt="2024-11-21T04:17:27.002" v="589" actId="14100"/>
          <ac:spMkLst>
            <pc:docMk/>
            <pc:sldMk cId="2595590755" sldId="264"/>
            <ac:spMk id="15" creationId="{5A53B1D6-7D41-6587-8D34-F372DEA33DDF}"/>
          </ac:spMkLst>
        </pc:spChg>
        <pc:spChg chg="add mod">
          <ac:chgData name="Belaid, Sirine" userId="S::belaids@upmc.edu::5dcb4cf5-c058-49ea-93f8-4f4e6c877fcd" providerId="AD" clId="Web-{CA0C33D0-C09E-583B-D4CE-01D9F9A06D6E}" dt="2024-11-21T04:16:47.499" v="587" actId="14100"/>
          <ac:spMkLst>
            <pc:docMk/>
            <pc:sldMk cId="2595590755" sldId="264"/>
            <ac:spMk id="16" creationId="{F7CDFB00-0165-3009-F75E-4F1C6C605198}"/>
          </ac:spMkLst>
        </pc:spChg>
        <pc:picChg chg="mod">
          <ac:chgData name="Belaid, Sirine" userId="S::belaids@upmc.edu::5dcb4cf5-c058-49ea-93f8-4f4e6c877fcd" providerId="AD" clId="Web-{CA0C33D0-C09E-583B-D4CE-01D9F9A06D6E}" dt="2024-11-21T04:15:52.495" v="581" actId="1076"/>
          <ac:picMkLst>
            <pc:docMk/>
            <pc:sldMk cId="2595590755" sldId="264"/>
            <ac:picMk id="2" creationId="{08F67302-9B4E-8524-CA03-A31DE7C76674}"/>
          </ac:picMkLst>
        </pc:picChg>
      </pc:sldChg>
      <pc:sldChg chg="addSp modSp">
        <pc:chgData name="Belaid, Sirine" userId="S::belaids@upmc.edu::5dcb4cf5-c058-49ea-93f8-4f4e6c877fcd" providerId="AD" clId="Web-{CA0C33D0-C09E-583B-D4CE-01D9F9A06D6E}" dt="2024-11-21T04:17:58.035" v="592" actId="1076"/>
        <pc:sldMkLst>
          <pc:docMk/>
          <pc:sldMk cId="571547126" sldId="265"/>
        </pc:sldMkLst>
        <pc:spChg chg="add mod">
          <ac:chgData name="Belaid, Sirine" userId="S::belaids@upmc.edu::5dcb4cf5-c058-49ea-93f8-4f4e6c877fcd" providerId="AD" clId="Web-{CA0C33D0-C09E-583B-D4CE-01D9F9A06D6E}" dt="2024-11-21T04:17:58.035" v="592" actId="1076"/>
          <ac:spMkLst>
            <pc:docMk/>
            <pc:sldMk cId="571547126" sldId="265"/>
            <ac:spMk id="4" creationId="{0BB309F9-0D3E-DAFD-8B04-D0775F9C5816}"/>
          </ac:spMkLst>
        </pc:spChg>
      </pc:sldChg>
      <pc:sldChg chg="addSp delSp modSp">
        <pc:chgData name="Belaid, Sirine" userId="S::belaids@upmc.edu::5dcb4cf5-c058-49ea-93f8-4f4e6c877fcd" providerId="AD" clId="Web-{CA0C33D0-C09E-583B-D4CE-01D9F9A06D6E}" dt="2024-11-21T04:12:02.521" v="546" actId="1076"/>
        <pc:sldMkLst>
          <pc:docMk/>
          <pc:sldMk cId="3955110762" sldId="266"/>
        </pc:sldMkLst>
        <pc:spChg chg="add mod">
          <ac:chgData name="Belaid, Sirine" userId="S::belaids@upmc.edu::5dcb4cf5-c058-49ea-93f8-4f4e6c877fcd" providerId="AD" clId="Web-{CA0C33D0-C09E-583B-D4CE-01D9F9A06D6E}" dt="2024-11-21T04:11:52.677" v="542" actId="1076"/>
          <ac:spMkLst>
            <pc:docMk/>
            <pc:sldMk cId="3955110762" sldId="266"/>
            <ac:spMk id="5" creationId="{8D05FE3C-E449-BDCA-51CC-1A4B1DCBAB32}"/>
          </ac:spMkLst>
        </pc:spChg>
        <pc:spChg chg="add del">
          <ac:chgData name="Belaid, Sirine" userId="S::belaids@upmc.edu::5dcb4cf5-c058-49ea-93f8-4f4e6c877fcd" providerId="AD" clId="Web-{CA0C33D0-C09E-583B-D4CE-01D9F9A06D6E}" dt="2024-11-21T04:10:53.220" v="527"/>
          <ac:spMkLst>
            <pc:docMk/>
            <pc:sldMk cId="3955110762" sldId="266"/>
            <ac:spMk id="7" creationId="{AC6A287D-51B4-EB78-BBA4-9D58582C5522}"/>
          </ac:spMkLst>
        </pc:spChg>
        <pc:spChg chg="add mod">
          <ac:chgData name="Belaid, Sirine" userId="S::belaids@upmc.edu::5dcb4cf5-c058-49ea-93f8-4f4e6c877fcd" providerId="AD" clId="Web-{CA0C33D0-C09E-583B-D4CE-01D9F9A06D6E}" dt="2024-11-21T04:11:58.724" v="544" actId="1076"/>
          <ac:spMkLst>
            <pc:docMk/>
            <pc:sldMk cId="3955110762" sldId="266"/>
            <ac:spMk id="9" creationId="{DDC8DC3E-0663-78DE-F81B-30646D07375E}"/>
          </ac:spMkLst>
        </pc:spChg>
        <pc:spChg chg="add mod">
          <ac:chgData name="Belaid, Sirine" userId="S::belaids@upmc.edu::5dcb4cf5-c058-49ea-93f8-4f4e6c877fcd" providerId="AD" clId="Web-{CA0C33D0-C09E-583B-D4CE-01D9F9A06D6E}" dt="2024-11-21T04:12:02.521" v="546" actId="1076"/>
          <ac:spMkLst>
            <pc:docMk/>
            <pc:sldMk cId="3955110762" sldId="266"/>
            <ac:spMk id="11" creationId="{8ACBF35E-6D03-1CE9-D8B7-961370C360BB}"/>
          </ac:spMkLst>
        </pc:spChg>
      </pc:sldChg>
      <pc:sldChg chg="addSp delSp modSp">
        <pc:chgData name="Belaid, Sirine" userId="S::belaids@upmc.edu::5dcb4cf5-c058-49ea-93f8-4f4e6c877fcd" providerId="AD" clId="Web-{CA0C33D0-C09E-583B-D4CE-01D9F9A06D6E}" dt="2024-11-21T04:18:58.961" v="600" actId="14100"/>
        <pc:sldMkLst>
          <pc:docMk/>
          <pc:sldMk cId="2923304690" sldId="267"/>
        </pc:sldMkLst>
        <pc:spChg chg="add del mod">
          <ac:chgData name="Belaid, Sirine" userId="S::belaids@upmc.edu::5dcb4cf5-c058-49ea-93f8-4f4e6c877fcd" providerId="AD" clId="Web-{CA0C33D0-C09E-583B-D4CE-01D9F9A06D6E}" dt="2024-11-21T04:18:29.413" v="595"/>
          <ac:spMkLst>
            <pc:docMk/>
            <pc:sldMk cId="2923304690" sldId="267"/>
            <ac:spMk id="4" creationId="{408C8F73-7273-2B3C-608A-13E213AFAC49}"/>
          </ac:spMkLst>
        </pc:spChg>
        <pc:spChg chg="add mod">
          <ac:chgData name="Belaid, Sirine" userId="S::belaids@upmc.edu::5dcb4cf5-c058-49ea-93f8-4f4e6c877fcd" providerId="AD" clId="Web-{CA0C33D0-C09E-583B-D4CE-01D9F9A06D6E}" dt="2024-11-21T04:18:58.961" v="600" actId="14100"/>
          <ac:spMkLst>
            <pc:docMk/>
            <pc:sldMk cId="2923304690" sldId="267"/>
            <ac:spMk id="6" creationId="{1B8F986C-D20D-2C34-FA4E-6FCF528EAE8B}"/>
          </ac:spMkLst>
        </pc:spChg>
      </pc:sldChg>
      <pc:sldChg chg="addSp modSp">
        <pc:chgData name="Belaid, Sirine" userId="S::belaids@upmc.edu::5dcb4cf5-c058-49ea-93f8-4f4e6c877fcd" providerId="AD" clId="Web-{CA0C33D0-C09E-583B-D4CE-01D9F9A06D6E}" dt="2024-11-21T04:19:54.575" v="605" actId="14100"/>
        <pc:sldMkLst>
          <pc:docMk/>
          <pc:sldMk cId="3489943564" sldId="270"/>
        </pc:sldMkLst>
        <pc:spChg chg="add mod">
          <ac:chgData name="Belaid, Sirine" userId="S::belaids@upmc.edu::5dcb4cf5-c058-49ea-93f8-4f4e6c877fcd" providerId="AD" clId="Web-{CA0C33D0-C09E-583B-D4CE-01D9F9A06D6E}" dt="2024-11-21T04:19:54.575" v="605" actId="14100"/>
          <ac:spMkLst>
            <pc:docMk/>
            <pc:sldMk cId="3489943564" sldId="270"/>
            <ac:spMk id="4" creationId="{CD39DF3C-48CA-1D04-F69B-80A55457EC9D}"/>
          </ac:spMkLst>
        </pc:spChg>
      </pc:sldChg>
      <pc:sldChg chg="addSp delSp modSp">
        <pc:chgData name="Belaid, Sirine" userId="S::belaids@upmc.edu::5dcb4cf5-c058-49ea-93f8-4f4e6c877fcd" providerId="AD" clId="Web-{CA0C33D0-C09E-583B-D4CE-01D9F9A06D6E}" dt="2024-11-21T04:21:59.193" v="624"/>
        <pc:sldMkLst>
          <pc:docMk/>
          <pc:sldMk cId="4163017298" sldId="271"/>
        </pc:sldMkLst>
        <pc:spChg chg="add mod">
          <ac:chgData name="Belaid, Sirine" userId="S::belaids@upmc.edu::5dcb4cf5-c058-49ea-93f8-4f4e6c877fcd" providerId="AD" clId="Web-{CA0C33D0-C09E-583B-D4CE-01D9F9A06D6E}" dt="2024-11-21T04:20:16.483" v="608" actId="14100"/>
          <ac:spMkLst>
            <pc:docMk/>
            <pc:sldMk cId="4163017298" sldId="271"/>
            <ac:spMk id="4" creationId="{78CD1E7D-0379-EFA8-8800-1E96386F0F9E}"/>
          </ac:spMkLst>
        </pc:spChg>
        <pc:spChg chg="add mod">
          <ac:chgData name="Belaid, Sirine" userId="S::belaids@upmc.edu::5dcb4cf5-c058-49ea-93f8-4f4e6c877fcd" providerId="AD" clId="Web-{CA0C33D0-C09E-583B-D4CE-01D9F9A06D6E}" dt="2024-11-21T04:21:09.986" v="616" actId="14100"/>
          <ac:spMkLst>
            <pc:docMk/>
            <pc:sldMk cId="4163017298" sldId="271"/>
            <ac:spMk id="5" creationId="{BB68E6D0-D34C-777C-060A-88BD13B8E5D4}"/>
          </ac:spMkLst>
        </pc:spChg>
        <pc:spChg chg="add del mod">
          <ac:chgData name="Belaid, Sirine" userId="S::belaids@upmc.edu::5dcb4cf5-c058-49ea-93f8-4f4e6c877fcd" providerId="AD" clId="Web-{CA0C33D0-C09E-583B-D4CE-01D9F9A06D6E}" dt="2024-11-21T04:21:59.193" v="624"/>
          <ac:spMkLst>
            <pc:docMk/>
            <pc:sldMk cId="4163017298" sldId="271"/>
            <ac:spMk id="6" creationId="{AEE9AC63-952D-F366-B0F7-9D249E1B3F01}"/>
          </ac:spMkLst>
        </pc:spChg>
      </pc:sldChg>
      <pc:sldChg chg="addSp modSp">
        <pc:chgData name="Belaid, Sirine" userId="S::belaids@upmc.edu::5dcb4cf5-c058-49ea-93f8-4f4e6c877fcd" providerId="AD" clId="Web-{CA0C33D0-C09E-583B-D4CE-01D9F9A06D6E}" dt="2024-11-21T04:23:10.807" v="637" actId="14100"/>
        <pc:sldMkLst>
          <pc:docMk/>
          <pc:sldMk cId="138475673" sldId="272"/>
        </pc:sldMkLst>
        <pc:spChg chg="add mod">
          <ac:chgData name="Belaid, Sirine" userId="S::belaids@upmc.edu::5dcb4cf5-c058-49ea-93f8-4f4e6c877fcd" providerId="AD" clId="Web-{CA0C33D0-C09E-583B-D4CE-01D9F9A06D6E}" dt="2024-11-21T04:23:10.807" v="637" actId="14100"/>
          <ac:spMkLst>
            <pc:docMk/>
            <pc:sldMk cId="138475673" sldId="272"/>
            <ac:spMk id="5" creationId="{34BC02AE-5590-32FE-3F7D-A71DBFD4767C}"/>
          </ac:spMkLst>
        </pc:spChg>
        <pc:picChg chg="mod">
          <ac:chgData name="Belaid, Sirine" userId="S::belaids@upmc.edu::5dcb4cf5-c058-49ea-93f8-4f4e6c877fcd" providerId="AD" clId="Web-{CA0C33D0-C09E-583B-D4CE-01D9F9A06D6E}" dt="2024-11-21T04:22:39.336" v="630" actId="14100"/>
          <ac:picMkLst>
            <pc:docMk/>
            <pc:sldMk cId="138475673" sldId="272"/>
            <ac:picMk id="2" creationId="{031F6F2D-15CB-C5FE-64DD-76E4EBEF0726}"/>
          </ac:picMkLst>
        </pc:picChg>
        <pc:picChg chg="mod">
          <ac:chgData name="Belaid, Sirine" userId="S::belaids@upmc.edu::5dcb4cf5-c058-49ea-93f8-4f4e6c877fcd" providerId="AD" clId="Web-{CA0C33D0-C09E-583B-D4CE-01D9F9A06D6E}" dt="2024-11-21T04:22:51.884" v="633" actId="14100"/>
          <ac:picMkLst>
            <pc:docMk/>
            <pc:sldMk cId="138475673" sldId="272"/>
            <ac:picMk id="3" creationId="{8A13BC03-44D4-0458-BA9C-98228A9AD56B}"/>
          </ac:picMkLst>
        </pc:picChg>
      </pc:sldChg>
      <pc:sldChg chg="addSp modSp">
        <pc:chgData name="Belaid, Sirine" userId="S::belaids@upmc.edu::5dcb4cf5-c058-49ea-93f8-4f4e6c877fcd" providerId="AD" clId="Web-{CA0C33D0-C09E-583B-D4CE-01D9F9A06D6E}" dt="2024-11-21T04:22:26.570" v="628" actId="14100"/>
        <pc:sldMkLst>
          <pc:docMk/>
          <pc:sldMk cId="2876258149" sldId="273"/>
        </pc:sldMkLst>
        <pc:spChg chg="add mod">
          <ac:chgData name="Belaid, Sirine" userId="S::belaids@upmc.edu::5dcb4cf5-c058-49ea-93f8-4f4e6c877fcd" providerId="AD" clId="Web-{CA0C33D0-C09E-583B-D4CE-01D9F9A06D6E}" dt="2024-11-21T04:22:26.570" v="628" actId="14100"/>
          <ac:spMkLst>
            <pc:docMk/>
            <pc:sldMk cId="2876258149" sldId="273"/>
            <ac:spMk id="2" creationId="{AEE9AC63-952D-F366-B0F7-9D249E1B3F01}"/>
          </ac:spMkLst>
        </pc:spChg>
      </pc:sldChg>
      <pc:sldChg chg="addSp modSp">
        <pc:chgData name="Belaid, Sirine" userId="S::belaids@upmc.edu::5dcb4cf5-c058-49ea-93f8-4f4e6c877fcd" providerId="AD" clId="Web-{CA0C33D0-C09E-583B-D4CE-01D9F9A06D6E}" dt="2024-11-21T04:24:02.717" v="645" actId="1076"/>
        <pc:sldMkLst>
          <pc:docMk/>
          <pc:sldMk cId="1037168473" sldId="274"/>
        </pc:sldMkLst>
        <pc:spChg chg="add mod">
          <ac:chgData name="Belaid, Sirine" userId="S::belaids@upmc.edu::5dcb4cf5-c058-49ea-93f8-4f4e6c877fcd" providerId="AD" clId="Web-{CA0C33D0-C09E-583B-D4CE-01D9F9A06D6E}" dt="2024-11-21T04:23:49.357" v="643" actId="14100"/>
          <ac:spMkLst>
            <pc:docMk/>
            <pc:sldMk cId="1037168473" sldId="274"/>
            <ac:spMk id="4" creationId="{CA7DD2B3-30A0-A3E4-BA9E-7844C3FD1FAA}"/>
          </ac:spMkLst>
        </pc:spChg>
        <pc:spChg chg="add mod">
          <ac:chgData name="Belaid, Sirine" userId="S::belaids@upmc.edu::5dcb4cf5-c058-49ea-93f8-4f4e6c877fcd" providerId="AD" clId="Web-{CA0C33D0-C09E-583B-D4CE-01D9F9A06D6E}" dt="2024-11-21T04:24:02.717" v="645" actId="1076"/>
          <ac:spMkLst>
            <pc:docMk/>
            <pc:sldMk cId="1037168473" sldId="274"/>
            <ac:spMk id="5" creationId="{77234ED6-0442-DB89-56F4-BCB0248887EF}"/>
          </ac:spMkLst>
        </pc:spChg>
      </pc:sldChg>
      <pc:sldChg chg="addSp modSp">
        <pc:chgData name="Belaid, Sirine" userId="S::belaids@upmc.edu::5dcb4cf5-c058-49ea-93f8-4f4e6c877fcd" providerId="AD" clId="Web-{CA0C33D0-C09E-583B-D4CE-01D9F9A06D6E}" dt="2024-11-21T04:26:08.023" v="662" actId="1076"/>
        <pc:sldMkLst>
          <pc:docMk/>
          <pc:sldMk cId="460022324" sldId="275"/>
        </pc:sldMkLst>
        <pc:spChg chg="add mod">
          <ac:chgData name="Belaid, Sirine" userId="S::belaids@upmc.edu::5dcb4cf5-c058-49ea-93f8-4f4e6c877fcd" providerId="AD" clId="Web-{CA0C33D0-C09E-583B-D4CE-01D9F9A06D6E}" dt="2024-11-21T04:25:10.191" v="652" actId="14100"/>
          <ac:spMkLst>
            <pc:docMk/>
            <pc:sldMk cId="460022324" sldId="275"/>
            <ac:spMk id="7" creationId="{BDBA37F0-C05B-C612-7BBC-677D817BBDEC}"/>
          </ac:spMkLst>
        </pc:spChg>
        <pc:spChg chg="add mod">
          <ac:chgData name="Belaid, Sirine" userId="S::belaids@upmc.edu::5dcb4cf5-c058-49ea-93f8-4f4e6c877fcd" providerId="AD" clId="Web-{CA0C33D0-C09E-583B-D4CE-01D9F9A06D6E}" dt="2024-11-21T04:25:26.207" v="655" actId="14100"/>
          <ac:spMkLst>
            <pc:docMk/>
            <pc:sldMk cId="460022324" sldId="275"/>
            <ac:spMk id="9" creationId="{622AC965-8D71-CCBD-E839-502951156F24}"/>
          </ac:spMkLst>
        </pc:spChg>
        <pc:spChg chg="add mod">
          <ac:chgData name="Belaid, Sirine" userId="S::belaids@upmc.edu::5dcb4cf5-c058-49ea-93f8-4f4e6c877fcd" providerId="AD" clId="Web-{CA0C33D0-C09E-583B-D4CE-01D9F9A06D6E}" dt="2024-11-21T04:25:49.506" v="658" actId="14100"/>
          <ac:spMkLst>
            <pc:docMk/>
            <pc:sldMk cId="460022324" sldId="275"/>
            <ac:spMk id="11" creationId="{B53EBF3C-41B4-4216-F114-66A91415C91C}"/>
          </ac:spMkLst>
        </pc:spChg>
        <pc:spChg chg="add mod">
          <ac:chgData name="Belaid, Sirine" userId="S::belaids@upmc.edu::5dcb4cf5-c058-49ea-93f8-4f4e6c877fcd" providerId="AD" clId="Web-{CA0C33D0-C09E-583B-D4CE-01D9F9A06D6E}" dt="2024-11-21T04:25:57.475" v="660" actId="1076"/>
          <ac:spMkLst>
            <pc:docMk/>
            <pc:sldMk cId="460022324" sldId="275"/>
            <ac:spMk id="13" creationId="{A96E9AD8-572F-C963-522A-826169E2B2ED}"/>
          </ac:spMkLst>
        </pc:spChg>
        <pc:spChg chg="add mod">
          <ac:chgData name="Belaid, Sirine" userId="S::belaids@upmc.edu::5dcb4cf5-c058-49ea-93f8-4f4e6c877fcd" providerId="AD" clId="Web-{CA0C33D0-C09E-583B-D4CE-01D9F9A06D6E}" dt="2024-11-21T04:26:08.023" v="662" actId="1076"/>
          <ac:spMkLst>
            <pc:docMk/>
            <pc:sldMk cId="460022324" sldId="275"/>
            <ac:spMk id="15" creationId="{58A84396-DC60-9114-B31C-4A25ACB00665}"/>
          </ac:spMkLst>
        </pc:spChg>
        <pc:picChg chg="mod">
          <ac:chgData name="Belaid, Sirine" userId="S::belaids@upmc.edu::5dcb4cf5-c058-49ea-93f8-4f4e6c877fcd" providerId="AD" clId="Web-{CA0C33D0-C09E-583B-D4CE-01D9F9A06D6E}" dt="2024-11-21T04:24:33.266" v="647" actId="14100"/>
          <ac:picMkLst>
            <pc:docMk/>
            <pc:sldMk cId="460022324" sldId="275"/>
            <ac:picMk id="3" creationId="{A7D018EA-1425-8A40-131E-D968305371A2}"/>
          </ac:picMkLst>
        </pc:picChg>
      </pc:sldChg>
      <pc:sldChg chg="modSp">
        <pc:chgData name="Belaid, Sirine" userId="S::belaids@upmc.edu::5dcb4cf5-c058-49ea-93f8-4f4e6c877fcd" providerId="AD" clId="Web-{CA0C33D0-C09E-583B-D4CE-01D9F9A06D6E}" dt="2024-11-21T04:24:10.608" v="646" actId="1076"/>
        <pc:sldMkLst>
          <pc:docMk/>
          <pc:sldMk cId="890179914" sldId="276"/>
        </pc:sldMkLst>
        <pc:spChg chg="mod">
          <ac:chgData name="Belaid, Sirine" userId="S::belaids@upmc.edu::5dcb4cf5-c058-49ea-93f8-4f4e6c877fcd" providerId="AD" clId="Web-{CA0C33D0-C09E-583B-D4CE-01D9F9A06D6E}" dt="2024-11-21T04:24:10.608" v="646" actId="1076"/>
          <ac:spMkLst>
            <pc:docMk/>
            <pc:sldMk cId="890179914" sldId="276"/>
            <ac:spMk id="2" creationId="{4111335E-0275-7F85-1A60-B2E9C5BFCB5E}"/>
          </ac:spMkLst>
        </pc:spChg>
      </pc:sldChg>
      <pc:sldChg chg="addSp modSp">
        <pc:chgData name="Belaid, Sirine" userId="S::belaids@upmc.edu::5dcb4cf5-c058-49ea-93f8-4f4e6c877fcd" providerId="AD" clId="Web-{CA0C33D0-C09E-583B-D4CE-01D9F9A06D6E}" dt="2024-11-21T04:27:19.106" v="669" actId="14100"/>
        <pc:sldMkLst>
          <pc:docMk/>
          <pc:sldMk cId="3040203494" sldId="278"/>
        </pc:sldMkLst>
        <pc:spChg chg="add mod">
          <ac:chgData name="Belaid, Sirine" userId="S::belaids@upmc.edu::5dcb4cf5-c058-49ea-93f8-4f4e6c877fcd" providerId="AD" clId="Web-{CA0C33D0-C09E-583B-D4CE-01D9F9A06D6E}" dt="2024-11-21T04:26:55.995" v="666" actId="14100"/>
          <ac:spMkLst>
            <pc:docMk/>
            <pc:sldMk cId="3040203494" sldId="278"/>
            <ac:spMk id="7" creationId="{8A7B1E0F-CFB0-DFF9-80E9-168D43CF19E7}"/>
          </ac:spMkLst>
        </pc:spChg>
        <pc:spChg chg="add mod">
          <ac:chgData name="Belaid, Sirine" userId="S::belaids@upmc.edu::5dcb4cf5-c058-49ea-93f8-4f4e6c877fcd" providerId="AD" clId="Web-{CA0C33D0-C09E-583B-D4CE-01D9F9A06D6E}" dt="2024-11-21T04:27:19.106" v="669" actId="14100"/>
          <ac:spMkLst>
            <pc:docMk/>
            <pc:sldMk cId="3040203494" sldId="278"/>
            <ac:spMk id="9" creationId="{44520E45-38F9-1C14-504C-EF35711E769E}"/>
          </ac:spMkLst>
        </pc:spChg>
      </pc:sldChg>
      <pc:sldChg chg="addSp modSp">
        <pc:chgData name="Belaid, Sirine" userId="S::belaids@upmc.edu::5dcb4cf5-c058-49ea-93f8-4f4e6c877fcd" providerId="AD" clId="Web-{CA0C33D0-C09E-583B-D4CE-01D9F9A06D6E}" dt="2024-11-21T04:30:41.386" v="699" actId="20577"/>
        <pc:sldMkLst>
          <pc:docMk/>
          <pc:sldMk cId="1691135755" sldId="279"/>
        </pc:sldMkLst>
        <pc:spChg chg="mod">
          <ac:chgData name="Belaid, Sirine" userId="S::belaids@upmc.edu::5dcb4cf5-c058-49ea-93f8-4f4e6c877fcd" providerId="AD" clId="Web-{CA0C33D0-C09E-583B-D4CE-01D9F9A06D6E}" dt="2024-11-21T04:30:41.386" v="699" actId="20577"/>
          <ac:spMkLst>
            <pc:docMk/>
            <pc:sldMk cId="1691135755" sldId="279"/>
            <ac:spMk id="3" creationId="{40154E4A-504B-F285-191C-FC2B0F11F3E3}"/>
          </ac:spMkLst>
        </pc:spChg>
        <pc:spChg chg="add mod">
          <ac:chgData name="Belaid, Sirine" userId="S::belaids@upmc.edu::5dcb4cf5-c058-49ea-93f8-4f4e6c877fcd" providerId="AD" clId="Web-{CA0C33D0-C09E-583B-D4CE-01D9F9A06D6E}" dt="2024-11-21T04:11:14.206" v="530" actId="1076"/>
          <ac:spMkLst>
            <pc:docMk/>
            <pc:sldMk cId="1691135755" sldId="279"/>
            <ac:spMk id="5" creationId="{8B453B78-8D0F-35EB-2A95-E41CE867A315}"/>
          </ac:spMkLst>
        </pc:spChg>
        <pc:spChg chg="add mod">
          <ac:chgData name="Belaid, Sirine" userId="S::belaids@upmc.edu::5dcb4cf5-c058-49ea-93f8-4f4e6c877fcd" providerId="AD" clId="Web-{CA0C33D0-C09E-583B-D4CE-01D9F9A06D6E}" dt="2024-11-21T04:11:24.222" v="535" actId="1076"/>
          <ac:spMkLst>
            <pc:docMk/>
            <pc:sldMk cId="1691135755" sldId="279"/>
            <ac:spMk id="8" creationId="{4154C069-3066-A58E-282A-AA608DBD0C9A}"/>
          </ac:spMkLst>
        </pc:spChg>
        <pc:spChg chg="add mod">
          <ac:chgData name="Belaid, Sirine" userId="S::belaids@upmc.edu::5dcb4cf5-c058-49ea-93f8-4f4e6c877fcd" providerId="AD" clId="Web-{CA0C33D0-C09E-583B-D4CE-01D9F9A06D6E}" dt="2024-11-21T04:11:22.034" v="534" actId="1076"/>
          <ac:spMkLst>
            <pc:docMk/>
            <pc:sldMk cId="1691135755" sldId="279"/>
            <ac:spMk id="10" creationId="{83D74C53-AD22-CFA3-C6B1-BAA310FD1C03}"/>
          </ac:spMkLst>
        </pc:spChg>
      </pc:sldChg>
      <pc:sldChg chg="modSp">
        <pc:chgData name="Belaid, Sirine" userId="S::belaids@upmc.edu::5dcb4cf5-c058-49ea-93f8-4f4e6c877fcd" providerId="AD" clId="Web-{CA0C33D0-C09E-583B-D4CE-01D9F9A06D6E}" dt="2024-11-21T04:30:54.981" v="702" actId="20577"/>
        <pc:sldMkLst>
          <pc:docMk/>
          <pc:sldMk cId="2334828839" sldId="280"/>
        </pc:sldMkLst>
        <pc:spChg chg="mod">
          <ac:chgData name="Belaid, Sirine" userId="S::belaids@upmc.edu::5dcb4cf5-c058-49ea-93f8-4f4e6c877fcd" providerId="AD" clId="Web-{CA0C33D0-C09E-583B-D4CE-01D9F9A06D6E}" dt="2024-11-21T04:30:54.981" v="702" actId="20577"/>
          <ac:spMkLst>
            <pc:docMk/>
            <pc:sldMk cId="2334828839" sldId="280"/>
            <ac:spMk id="4" creationId="{D1BCFB39-CF04-FACC-1188-03C1357FB1F6}"/>
          </ac:spMkLst>
        </pc:spChg>
      </pc:sldChg>
      <pc:sldChg chg="addSp modSp">
        <pc:chgData name="Belaid, Sirine" userId="S::belaids@upmc.edu::5dcb4cf5-c058-49ea-93f8-4f4e6c877fcd" providerId="AD" clId="Web-{CA0C33D0-C09E-583B-D4CE-01D9F9A06D6E}" dt="2024-11-21T04:12:21.960" v="549" actId="14100"/>
        <pc:sldMkLst>
          <pc:docMk/>
          <pc:sldMk cId="534894233" sldId="282"/>
        </pc:sldMkLst>
        <pc:spChg chg="add mod">
          <ac:chgData name="Belaid, Sirine" userId="S::belaids@upmc.edu::5dcb4cf5-c058-49ea-93f8-4f4e6c877fcd" providerId="AD" clId="Web-{CA0C33D0-C09E-583B-D4CE-01D9F9A06D6E}" dt="2024-11-21T04:12:21.960" v="549" actId="14100"/>
          <ac:spMkLst>
            <pc:docMk/>
            <pc:sldMk cId="534894233" sldId="282"/>
            <ac:spMk id="5" creationId="{190BDE7B-1907-C434-9171-AC3C3EE9BD0D}"/>
          </ac:spMkLst>
        </pc:spChg>
      </pc:sldChg>
      <pc:sldChg chg="addSp modSp">
        <pc:chgData name="Belaid, Sirine" userId="S::belaids@upmc.edu::5dcb4cf5-c058-49ea-93f8-4f4e6c877fcd" providerId="AD" clId="Web-{CA0C33D0-C09E-583B-D4CE-01D9F9A06D6E}" dt="2024-11-21T04:35:00.420" v="726" actId="14100"/>
        <pc:sldMkLst>
          <pc:docMk/>
          <pc:sldMk cId="3128388144" sldId="283"/>
        </pc:sldMkLst>
        <pc:spChg chg="add mod">
          <ac:chgData name="Belaid, Sirine" userId="S::belaids@upmc.edu::5dcb4cf5-c058-49ea-93f8-4f4e6c877fcd" providerId="AD" clId="Web-{CA0C33D0-C09E-583B-D4CE-01D9F9A06D6E}" dt="2024-11-21T04:34:16.838" v="717" actId="14100"/>
          <ac:spMkLst>
            <pc:docMk/>
            <pc:sldMk cId="3128388144" sldId="283"/>
            <ac:spMk id="4" creationId="{773D9104-86D0-5079-8CCE-021D0095FF27}"/>
          </ac:spMkLst>
        </pc:spChg>
        <pc:spChg chg="add mod">
          <ac:chgData name="Belaid, Sirine" userId="S::belaids@upmc.edu::5dcb4cf5-c058-49ea-93f8-4f4e6c877fcd" providerId="AD" clId="Web-{CA0C33D0-C09E-583B-D4CE-01D9F9A06D6E}" dt="2024-11-21T04:34:41.653" v="722" actId="14100"/>
          <ac:spMkLst>
            <pc:docMk/>
            <pc:sldMk cId="3128388144" sldId="283"/>
            <ac:spMk id="10" creationId="{409F5C52-DAA9-5C2A-BA24-122C7701CAC3}"/>
          </ac:spMkLst>
        </pc:spChg>
        <pc:spChg chg="add mod">
          <ac:chgData name="Belaid, Sirine" userId="S::belaids@upmc.edu::5dcb4cf5-c058-49ea-93f8-4f4e6c877fcd" providerId="AD" clId="Web-{CA0C33D0-C09E-583B-D4CE-01D9F9A06D6E}" dt="2024-11-21T04:35:00.420" v="726" actId="14100"/>
          <ac:spMkLst>
            <pc:docMk/>
            <pc:sldMk cId="3128388144" sldId="283"/>
            <ac:spMk id="12" creationId="{272E3F9C-2CBB-6416-669A-0D7DADB32BED}"/>
          </ac:spMkLst>
        </pc:spChg>
      </pc:sldChg>
      <pc:sldChg chg="addSp modSp">
        <pc:chgData name="Belaid, Sirine" userId="S::belaids@upmc.edu::5dcb4cf5-c058-49ea-93f8-4f4e6c877fcd" providerId="AD" clId="Web-{CA0C33D0-C09E-583B-D4CE-01D9F9A06D6E}" dt="2024-11-21T04:33:53.431" v="714" actId="14100"/>
        <pc:sldMkLst>
          <pc:docMk/>
          <pc:sldMk cId="117287384" sldId="285"/>
        </pc:sldMkLst>
        <pc:spChg chg="add mod">
          <ac:chgData name="Belaid, Sirine" userId="S::belaids@upmc.edu::5dcb4cf5-c058-49ea-93f8-4f4e6c877fcd" providerId="AD" clId="Web-{CA0C33D0-C09E-583B-D4CE-01D9F9A06D6E}" dt="2024-11-21T04:33:53.431" v="714" actId="14100"/>
          <ac:spMkLst>
            <pc:docMk/>
            <pc:sldMk cId="117287384" sldId="285"/>
            <ac:spMk id="5" creationId="{3F97B4E1-10EB-5805-EC45-FD4A73E9D517}"/>
          </ac:spMkLst>
        </pc:spChg>
        <pc:spChg chg="add mod">
          <ac:chgData name="Belaid, Sirine" userId="S::belaids@upmc.edu::5dcb4cf5-c058-49ea-93f8-4f4e6c877fcd" providerId="AD" clId="Web-{CA0C33D0-C09E-583B-D4CE-01D9F9A06D6E}" dt="2024-11-21T04:33:48.165" v="713" actId="14100"/>
          <ac:spMkLst>
            <pc:docMk/>
            <pc:sldMk cId="117287384" sldId="285"/>
            <ac:spMk id="7" creationId="{CE559FB9-FCE7-1D86-5F0B-5983BE95DB33}"/>
          </ac:spMkLst>
        </pc:spChg>
      </pc:sldChg>
      <pc:sldChg chg="modSp">
        <pc:chgData name="Belaid, Sirine" userId="S::belaids@upmc.edu::5dcb4cf5-c058-49ea-93f8-4f4e6c877fcd" providerId="AD" clId="Web-{CA0C33D0-C09E-583B-D4CE-01D9F9A06D6E}" dt="2024-11-21T04:06:10.980" v="490" actId="20577"/>
        <pc:sldMkLst>
          <pc:docMk/>
          <pc:sldMk cId="4094227945" sldId="352"/>
        </pc:sldMkLst>
        <pc:spChg chg="mod">
          <ac:chgData name="Belaid, Sirine" userId="S::belaids@upmc.edu::5dcb4cf5-c058-49ea-93f8-4f4e6c877fcd" providerId="AD" clId="Web-{CA0C33D0-C09E-583B-D4CE-01D9F9A06D6E}" dt="2024-11-21T04:06:10.980" v="490" actId="20577"/>
          <ac:spMkLst>
            <pc:docMk/>
            <pc:sldMk cId="4094227945" sldId="352"/>
            <ac:spMk id="3" creationId="{54D52FF0-F483-CAD8-917A-930506D4F12A}"/>
          </ac:spMkLst>
        </pc:spChg>
      </pc:sldChg>
      <pc:sldChg chg="modSp">
        <pc:chgData name="Belaid, Sirine" userId="S::belaids@upmc.edu::5dcb4cf5-c058-49ea-93f8-4f4e6c877fcd" providerId="AD" clId="Web-{CA0C33D0-C09E-583B-D4CE-01D9F9A06D6E}" dt="2024-11-21T04:05:48.541" v="483" actId="20577"/>
        <pc:sldMkLst>
          <pc:docMk/>
          <pc:sldMk cId="449566489" sldId="354"/>
        </pc:sldMkLst>
        <pc:spChg chg="mod">
          <ac:chgData name="Belaid, Sirine" userId="S::belaids@upmc.edu::5dcb4cf5-c058-49ea-93f8-4f4e6c877fcd" providerId="AD" clId="Web-{CA0C33D0-C09E-583B-D4CE-01D9F9A06D6E}" dt="2024-11-21T04:05:48.541" v="483" actId="20577"/>
          <ac:spMkLst>
            <pc:docMk/>
            <pc:sldMk cId="449566489" sldId="354"/>
            <ac:spMk id="3" creationId="{777F2FD0-93E3-360A-DED8-59A3E5728BA8}"/>
          </ac:spMkLst>
        </pc:spChg>
      </pc:sldChg>
      <pc:sldChg chg="modSp">
        <pc:chgData name="Belaid, Sirine" userId="S::belaids@upmc.edu::5dcb4cf5-c058-49ea-93f8-4f4e6c877fcd" providerId="AD" clId="Web-{CA0C33D0-C09E-583B-D4CE-01D9F9A06D6E}" dt="2024-11-21T04:07:00.686" v="493" actId="20577"/>
        <pc:sldMkLst>
          <pc:docMk/>
          <pc:sldMk cId="2208660293" sldId="366"/>
        </pc:sldMkLst>
        <pc:spChg chg="mod">
          <ac:chgData name="Belaid, Sirine" userId="S::belaids@upmc.edu::5dcb4cf5-c058-49ea-93f8-4f4e6c877fcd" providerId="AD" clId="Web-{CA0C33D0-C09E-583B-D4CE-01D9F9A06D6E}" dt="2024-11-21T04:07:00.686" v="493" actId="20577"/>
          <ac:spMkLst>
            <pc:docMk/>
            <pc:sldMk cId="2208660293" sldId="366"/>
            <ac:spMk id="3" creationId="{FC73AACB-7825-85D8-03D0-48CD572599F9}"/>
          </ac:spMkLst>
        </pc:spChg>
      </pc:sldChg>
      <pc:sldChg chg="del">
        <pc:chgData name="Belaid, Sirine" userId="S::belaids@upmc.edu::5dcb4cf5-c058-49ea-93f8-4f4e6c877fcd" providerId="AD" clId="Web-{CA0C33D0-C09E-583B-D4CE-01D9F9A06D6E}" dt="2024-11-21T04:06:41.216" v="491"/>
        <pc:sldMkLst>
          <pc:docMk/>
          <pc:sldMk cId="2684994436" sldId="371"/>
        </pc:sldMkLst>
      </pc:sldChg>
      <pc:sldChg chg="modSp">
        <pc:chgData name="Belaid, Sirine" userId="S::belaids@upmc.edu::5dcb4cf5-c058-49ea-93f8-4f4e6c877fcd" providerId="AD" clId="Web-{CA0C33D0-C09E-583B-D4CE-01D9F9A06D6E}" dt="2024-11-21T02:29:54.661" v="475" actId="20577"/>
        <pc:sldMkLst>
          <pc:docMk/>
          <pc:sldMk cId="983141598" sldId="372"/>
        </pc:sldMkLst>
        <pc:spChg chg="mod">
          <ac:chgData name="Belaid, Sirine" userId="S::belaids@upmc.edu::5dcb4cf5-c058-49ea-93f8-4f4e6c877fcd" providerId="AD" clId="Web-{CA0C33D0-C09E-583B-D4CE-01D9F9A06D6E}" dt="2024-11-21T02:29:54.661" v="475" actId="20577"/>
          <ac:spMkLst>
            <pc:docMk/>
            <pc:sldMk cId="983141598" sldId="372"/>
            <ac:spMk id="3" creationId="{6B57145F-A3D4-5C8F-5BBE-CC4E7BC1E90B}"/>
          </ac:spMkLst>
        </pc:spChg>
      </pc:sldChg>
      <pc:sldChg chg="addSp delSp modSp modNotes">
        <pc:chgData name="Belaid, Sirine" userId="S::belaids@upmc.edu::5dcb4cf5-c058-49ea-93f8-4f4e6c877fcd" providerId="AD" clId="Web-{CA0C33D0-C09E-583B-D4CE-01D9F9A06D6E}" dt="2024-11-21T01:40:50.478" v="149"/>
        <pc:sldMkLst>
          <pc:docMk/>
          <pc:sldMk cId="1471262162" sldId="377"/>
        </pc:sldMkLst>
        <pc:spChg chg="add mod">
          <ac:chgData name="Belaid, Sirine" userId="S::belaids@upmc.edu::5dcb4cf5-c058-49ea-93f8-4f4e6c877fcd" providerId="AD" clId="Web-{CA0C33D0-C09E-583B-D4CE-01D9F9A06D6E}" dt="2024-11-21T01:21:31.945" v="13" actId="20577"/>
          <ac:spMkLst>
            <pc:docMk/>
            <pc:sldMk cId="1471262162" sldId="377"/>
            <ac:spMk id="3" creationId="{BCF6060F-1BCA-851E-0406-1CB6ECDB46F1}"/>
          </ac:spMkLst>
        </pc:spChg>
        <pc:spChg chg="add mod">
          <ac:chgData name="Belaid, Sirine" userId="S::belaids@upmc.edu::5dcb4cf5-c058-49ea-93f8-4f4e6c877fcd" providerId="AD" clId="Web-{CA0C33D0-C09E-583B-D4CE-01D9F9A06D6E}" dt="2024-11-21T01:38:12.782" v="102" actId="1076"/>
          <ac:spMkLst>
            <pc:docMk/>
            <pc:sldMk cId="1471262162" sldId="377"/>
            <ac:spMk id="9" creationId="{6E492868-0D7A-BE71-60BA-5CD8384D4BD3}"/>
          </ac:spMkLst>
        </pc:spChg>
        <pc:spChg chg="add mod">
          <ac:chgData name="Belaid, Sirine" userId="S::belaids@upmc.edu::5dcb4cf5-c058-49ea-93f8-4f4e6c877fcd" providerId="AD" clId="Web-{CA0C33D0-C09E-583B-D4CE-01D9F9A06D6E}" dt="2024-11-21T01:39:31.067" v="125" actId="1076"/>
          <ac:spMkLst>
            <pc:docMk/>
            <pc:sldMk cId="1471262162" sldId="377"/>
            <ac:spMk id="13" creationId="{C7150244-FC12-D4F4-40CF-B6C441D3D7F1}"/>
          </ac:spMkLst>
        </pc:spChg>
        <pc:spChg chg="add mod">
          <ac:chgData name="Belaid, Sirine" userId="S::belaids@upmc.edu::5dcb4cf5-c058-49ea-93f8-4f4e6c877fcd" providerId="AD" clId="Web-{CA0C33D0-C09E-583B-D4CE-01D9F9A06D6E}" dt="2024-11-21T01:40:09.287" v="142" actId="1076"/>
          <ac:spMkLst>
            <pc:docMk/>
            <pc:sldMk cId="1471262162" sldId="377"/>
            <ac:spMk id="14" creationId="{35C15FFC-6CEB-2F98-52A9-42581F2BEE14}"/>
          </ac:spMkLst>
        </pc:spChg>
        <pc:picChg chg="mod">
          <ac:chgData name="Belaid, Sirine" userId="S::belaids@upmc.edu::5dcb4cf5-c058-49ea-93f8-4f4e6c877fcd" providerId="AD" clId="Web-{CA0C33D0-C09E-583B-D4CE-01D9F9A06D6E}" dt="2024-11-21T01:34:48.382" v="75" actId="1076"/>
          <ac:picMkLst>
            <pc:docMk/>
            <pc:sldMk cId="1471262162" sldId="377"/>
            <ac:picMk id="4" creationId="{8D6C8133-998B-F8FB-11E1-1C9829935611}"/>
          </ac:picMkLst>
        </pc:picChg>
        <pc:picChg chg="add del mod">
          <ac:chgData name="Belaid, Sirine" userId="S::belaids@upmc.edu::5dcb4cf5-c058-49ea-93f8-4f4e6c877fcd" providerId="AD" clId="Web-{CA0C33D0-C09E-583B-D4CE-01D9F9A06D6E}" dt="2024-11-21T01:24:07.780" v="42"/>
          <ac:picMkLst>
            <pc:docMk/>
            <pc:sldMk cId="1471262162" sldId="377"/>
            <ac:picMk id="5" creationId="{0F15BE1C-D40F-105D-5C2A-A134ACB0B5EE}"/>
          </ac:picMkLst>
        </pc:picChg>
        <pc:picChg chg="add mod">
          <ac:chgData name="Belaid, Sirine" userId="S::belaids@upmc.edu::5dcb4cf5-c058-49ea-93f8-4f4e6c877fcd" providerId="AD" clId="Web-{CA0C33D0-C09E-583B-D4CE-01D9F9A06D6E}" dt="2024-11-21T01:38:09.641" v="101" actId="1076"/>
          <ac:picMkLst>
            <pc:docMk/>
            <pc:sldMk cId="1471262162" sldId="377"/>
            <ac:picMk id="6" creationId="{F5FED341-E4B4-5B24-CA37-0E733557F2D7}"/>
          </ac:picMkLst>
        </pc:picChg>
        <pc:picChg chg="add del mod">
          <ac:chgData name="Belaid, Sirine" userId="S::belaids@upmc.edu::5dcb4cf5-c058-49ea-93f8-4f4e6c877fcd" providerId="AD" clId="Web-{CA0C33D0-C09E-583B-D4CE-01D9F9A06D6E}" dt="2024-11-21T01:37:49.062" v="95"/>
          <ac:picMkLst>
            <pc:docMk/>
            <pc:sldMk cId="1471262162" sldId="377"/>
            <ac:picMk id="10" creationId="{7C9BC52D-B23C-62CF-2180-8D62CCC58BA5}"/>
          </ac:picMkLst>
        </pc:picChg>
        <pc:picChg chg="add mod">
          <ac:chgData name="Belaid, Sirine" userId="S::belaids@upmc.edu::5dcb4cf5-c058-49ea-93f8-4f4e6c877fcd" providerId="AD" clId="Web-{CA0C33D0-C09E-583B-D4CE-01D9F9A06D6E}" dt="2024-11-21T01:38:21.845" v="105" actId="1076"/>
          <ac:picMkLst>
            <pc:docMk/>
            <pc:sldMk cId="1471262162" sldId="377"/>
            <ac:picMk id="11" creationId="{065FC989-3AE5-B6C0-2ED1-B129D70B5BBE}"/>
          </ac:picMkLst>
        </pc:picChg>
        <pc:cxnChg chg="add mod">
          <ac:chgData name="Belaid, Sirine" userId="S::belaids@upmc.edu::5dcb4cf5-c058-49ea-93f8-4f4e6c877fcd" providerId="AD" clId="Web-{CA0C33D0-C09E-583B-D4CE-01D9F9A06D6E}" dt="2024-11-21T01:38:07.579" v="100" actId="1076"/>
          <ac:cxnSpMkLst>
            <pc:docMk/>
            <pc:sldMk cId="1471262162" sldId="377"/>
            <ac:cxnSpMk id="8" creationId="{842FFB86-F8E8-256F-486E-664F2F319835}"/>
          </ac:cxnSpMkLst>
        </pc:cxnChg>
        <pc:cxnChg chg="add mod">
          <ac:chgData name="Belaid, Sirine" userId="S::belaids@upmc.edu::5dcb4cf5-c058-49ea-93f8-4f4e6c877fcd" providerId="AD" clId="Web-{CA0C33D0-C09E-583B-D4CE-01D9F9A06D6E}" dt="2024-11-21T01:38:53.628" v="109" actId="1076"/>
          <ac:cxnSpMkLst>
            <pc:docMk/>
            <pc:sldMk cId="1471262162" sldId="377"/>
            <ac:cxnSpMk id="12" creationId="{50E549DF-4254-6CC4-71B0-EEB5C726A482}"/>
          </ac:cxnSpMkLst>
        </pc:cxnChg>
      </pc:sldChg>
      <pc:sldChg chg="addSp delSp modSp ord">
        <pc:chgData name="Belaid, Sirine" userId="S::belaids@upmc.edu::5dcb4cf5-c058-49ea-93f8-4f4e6c877fcd" providerId="AD" clId="Web-{CA0C33D0-C09E-583B-D4CE-01D9F9A06D6E}" dt="2024-11-21T02:10:05.262" v="327" actId="1076"/>
        <pc:sldMkLst>
          <pc:docMk/>
          <pc:sldMk cId="3222833950" sldId="378"/>
        </pc:sldMkLst>
        <pc:spChg chg="del">
          <ac:chgData name="Belaid, Sirine" userId="S::belaids@upmc.edu::5dcb4cf5-c058-49ea-93f8-4f4e6c877fcd" providerId="AD" clId="Web-{CA0C33D0-C09E-583B-D4CE-01D9F9A06D6E}" dt="2024-11-21T01:48:59.235" v="151"/>
          <ac:spMkLst>
            <pc:docMk/>
            <pc:sldMk cId="3222833950" sldId="378"/>
            <ac:spMk id="2" creationId="{F40152F2-70F2-248D-4FEB-85D4EB6B9239}"/>
          </ac:spMkLst>
        </pc:spChg>
        <pc:spChg chg="del">
          <ac:chgData name="Belaid, Sirine" userId="S::belaids@upmc.edu::5dcb4cf5-c058-49ea-93f8-4f4e6c877fcd" providerId="AD" clId="Web-{CA0C33D0-C09E-583B-D4CE-01D9F9A06D6E}" dt="2024-11-21T01:48:55.688" v="150"/>
          <ac:spMkLst>
            <pc:docMk/>
            <pc:sldMk cId="3222833950" sldId="378"/>
            <ac:spMk id="3" creationId="{EBB1259D-3D6D-3A66-580A-E68DF670E5F5}"/>
          </ac:spMkLst>
        </pc:spChg>
        <pc:spChg chg="add mod">
          <ac:chgData name="Belaid, Sirine" userId="S::belaids@upmc.edu::5dcb4cf5-c058-49ea-93f8-4f4e6c877fcd" providerId="AD" clId="Web-{CA0C33D0-C09E-583B-D4CE-01D9F9A06D6E}" dt="2024-11-21T01:49:41.222" v="167" actId="1076"/>
          <ac:spMkLst>
            <pc:docMk/>
            <pc:sldMk cId="3222833950" sldId="378"/>
            <ac:spMk id="6" creationId="{765F1A7F-A9C9-0257-81D2-1906954EC116}"/>
          </ac:spMkLst>
        </pc:spChg>
        <pc:spChg chg="add mod">
          <ac:chgData name="Belaid, Sirine" userId="S::belaids@upmc.edu::5dcb4cf5-c058-49ea-93f8-4f4e6c877fcd" providerId="AD" clId="Web-{CA0C33D0-C09E-583B-D4CE-01D9F9A06D6E}" dt="2024-11-21T01:55:54.374" v="269" actId="20577"/>
          <ac:spMkLst>
            <pc:docMk/>
            <pc:sldMk cId="3222833950" sldId="378"/>
            <ac:spMk id="7" creationId="{CDAC4230-0784-FAED-EEAC-40D97D39373D}"/>
          </ac:spMkLst>
        </pc:spChg>
        <pc:spChg chg="add mod">
          <ac:chgData name="Belaid, Sirine" userId="S::belaids@upmc.edu::5dcb4cf5-c058-49ea-93f8-4f4e6c877fcd" providerId="AD" clId="Web-{CA0C33D0-C09E-583B-D4CE-01D9F9A06D6E}" dt="2024-11-21T02:10:05.262" v="327" actId="1076"/>
          <ac:spMkLst>
            <pc:docMk/>
            <pc:sldMk cId="3222833950" sldId="378"/>
            <ac:spMk id="10" creationId="{0B6E8676-D265-34C8-6143-A3C67029C003}"/>
          </ac:spMkLst>
        </pc:spChg>
        <pc:picChg chg="add mod ord">
          <ac:chgData name="Belaid, Sirine" userId="S::belaids@upmc.edu::5dcb4cf5-c058-49ea-93f8-4f4e6c877fcd" providerId="AD" clId="Web-{CA0C33D0-C09E-583B-D4CE-01D9F9A06D6E}" dt="2024-11-21T01:50:13.504" v="170" actId="1076"/>
          <ac:picMkLst>
            <pc:docMk/>
            <pc:sldMk cId="3222833950" sldId="378"/>
            <ac:picMk id="4" creationId="{4348ED40-ECCD-02CF-DC54-D4A548C8952E}"/>
          </ac:picMkLst>
        </pc:picChg>
        <pc:cxnChg chg="add mod">
          <ac:chgData name="Belaid, Sirine" userId="S::belaids@upmc.edu::5dcb4cf5-c058-49ea-93f8-4f4e6c877fcd" providerId="AD" clId="Web-{CA0C33D0-C09E-583B-D4CE-01D9F9A06D6E}" dt="2024-11-21T01:54:06.343" v="247" actId="1076"/>
          <ac:cxnSpMkLst>
            <pc:docMk/>
            <pc:sldMk cId="3222833950" sldId="378"/>
            <ac:cxnSpMk id="9" creationId="{12B2A1A5-93D9-1D67-D518-B0FBF1E4A067}"/>
          </ac:cxnSpMkLst>
        </pc:cxnChg>
      </pc:sldChg>
      <pc:sldChg chg="addSp modSp">
        <pc:chgData name="Belaid, Sirine" userId="S::belaids@upmc.edu::5dcb4cf5-c058-49ea-93f8-4f4e6c877fcd" providerId="AD" clId="Web-{CA0C33D0-C09E-583B-D4CE-01D9F9A06D6E}" dt="2024-11-21T01:34:40.366" v="74" actId="1076"/>
        <pc:sldMkLst>
          <pc:docMk/>
          <pc:sldMk cId="3179549796" sldId="381"/>
        </pc:sldMkLst>
        <pc:spChg chg="mod">
          <ac:chgData name="Belaid, Sirine" userId="S::belaids@upmc.edu::5dcb4cf5-c058-49ea-93f8-4f4e6c877fcd" providerId="AD" clId="Web-{CA0C33D0-C09E-583B-D4CE-01D9F9A06D6E}" dt="2024-11-21T01:34:20.818" v="67" actId="1076"/>
          <ac:spMkLst>
            <pc:docMk/>
            <pc:sldMk cId="3179549796" sldId="381"/>
            <ac:spMk id="6" creationId="{1C507F15-900F-8029-EB18-200808C829EE}"/>
          </ac:spMkLst>
        </pc:spChg>
        <pc:picChg chg="mod">
          <ac:chgData name="Belaid, Sirine" userId="S::belaids@upmc.edu::5dcb4cf5-c058-49ea-93f8-4f4e6c877fcd" providerId="AD" clId="Web-{CA0C33D0-C09E-583B-D4CE-01D9F9A06D6E}" dt="2024-11-21T01:34:25.115" v="69" actId="1076"/>
          <ac:picMkLst>
            <pc:docMk/>
            <pc:sldMk cId="3179549796" sldId="381"/>
            <ac:picMk id="3" creationId="{DA2A71F0-6417-A7F9-E493-739108DE3A4E}"/>
          </ac:picMkLst>
        </pc:picChg>
        <pc:picChg chg="mod">
          <ac:chgData name="Belaid, Sirine" userId="S::belaids@upmc.edu::5dcb4cf5-c058-49ea-93f8-4f4e6c877fcd" providerId="AD" clId="Web-{CA0C33D0-C09E-583B-D4CE-01D9F9A06D6E}" dt="2024-11-21T01:34:27.740" v="70" actId="1076"/>
          <ac:picMkLst>
            <pc:docMk/>
            <pc:sldMk cId="3179549796" sldId="381"/>
            <ac:picMk id="4" creationId="{87600A3E-4DE0-EED9-7AFD-89317515726A}"/>
          </ac:picMkLst>
        </pc:picChg>
        <pc:picChg chg="mod">
          <ac:chgData name="Belaid, Sirine" userId="S::belaids@upmc.edu::5dcb4cf5-c058-49ea-93f8-4f4e6c877fcd" providerId="AD" clId="Web-{CA0C33D0-C09E-583B-D4CE-01D9F9A06D6E}" dt="2024-11-21T01:34:23.146" v="68" actId="1076"/>
          <ac:picMkLst>
            <pc:docMk/>
            <pc:sldMk cId="3179549796" sldId="381"/>
            <ac:picMk id="5" creationId="{A5D062DA-85D1-4F86-95D5-6388AB67CA96}"/>
          </ac:picMkLst>
        </pc:picChg>
        <pc:cxnChg chg="add mod">
          <ac:chgData name="Belaid, Sirine" userId="S::belaids@upmc.edu::5dcb4cf5-c058-49ea-93f8-4f4e6c877fcd" providerId="AD" clId="Web-{CA0C33D0-C09E-583B-D4CE-01D9F9A06D6E}" dt="2024-11-21T01:34:40.366" v="74" actId="1076"/>
          <ac:cxnSpMkLst>
            <pc:docMk/>
            <pc:sldMk cId="3179549796" sldId="381"/>
            <ac:cxnSpMk id="7" creationId="{B6A4A913-B49D-FAAC-0CC7-78EE24A30037}"/>
          </ac:cxnSpMkLst>
        </pc:cxnChg>
      </pc:sldChg>
      <pc:sldChg chg="addSp delSp modSp">
        <pc:chgData name="Belaid, Sirine" userId="S::belaids@upmc.edu::5dcb4cf5-c058-49ea-93f8-4f4e6c877fcd" providerId="AD" clId="Web-{CA0C33D0-C09E-583B-D4CE-01D9F9A06D6E}" dt="2024-11-21T01:53:38.404" v="243" actId="1076"/>
        <pc:sldMkLst>
          <pc:docMk/>
          <pc:sldMk cId="1990103092" sldId="383"/>
        </pc:sldMkLst>
        <pc:spChg chg="add del mod">
          <ac:chgData name="Belaid, Sirine" userId="S::belaids@upmc.edu::5dcb4cf5-c058-49ea-93f8-4f4e6c877fcd" providerId="AD" clId="Web-{CA0C33D0-C09E-583B-D4CE-01D9F9A06D6E}" dt="2024-11-21T01:25:36.691" v="54"/>
          <ac:spMkLst>
            <pc:docMk/>
            <pc:sldMk cId="1990103092" sldId="383"/>
            <ac:spMk id="6" creationId="{542D0131-47D1-8202-2562-479988C3C53C}"/>
          </ac:spMkLst>
        </pc:spChg>
        <pc:picChg chg="mod">
          <ac:chgData name="Belaid, Sirine" userId="S::belaids@upmc.edu::5dcb4cf5-c058-49ea-93f8-4f4e6c877fcd" providerId="AD" clId="Web-{CA0C33D0-C09E-583B-D4CE-01D9F9A06D6E}" dt="2024-11-21T01:53:38.404" v="243" actId="1076"/>
          <ac:picMkLst>
            <pc:docMk/>
            <pc:sldMk cId="1990103092" sldId="383"/>
            <ac:picMk id="4" creationId="{23E5559A-91FB-189D-C2C3-43EF5910F9A1}"/>
          </ac:picMkLst>
        </pc:picChg>
        <pc:picChg chg="mod">
          <ac:chgData name="Belaid, Sirine" userId="S::belaids@upmc.edu::5dcb4cf5-c058-49ea-93f8-4f4e6c877fcd" providerId="AD" clId="Web-{CA0C33D0-C09E-583B-D4CE-01D9F9A06D6E}" dt="2024-11-21T01:24:31.703" v="49" actId="1076"/>
          <ac:picMkLst>
            <pc:docMk/>
            <pc:sldMk cId="1990103092" sldId="383"/>
            <ac:picMk id="7" creationId="{2B92E915-A43B-6795-FC93-BEA6249C106B}"/>
          </ac:picMkLst>
        </pc:picChg>
        <pc:picChg chg="mod">
          <ac:chgData name="Belaid, Sirine" userId="S::belaids@upmc.edu::5dcb4cf5-c058-49ea-93f8-4f4e6c877fcd" providerId="AD" clId="Web-{CA0C33D0-C09E-583B-D4CE-01D9F9A06D6E}" dt="2024-11-21T01:24:35.328" v="51" actId="1076"/>
          <ac:picMkLst>
            <pc:docMk/>
            <pc:sldMk cId="1990103092" sldId="383"/>
            <ac:picMk id="8" creationId="{43C49ADC-0AC6-29EF-2562-4A52BA117222}"/>
          </ac:picMkLst>
        </pc:picChg>
        <pc:cxnChg chg="add del mod">
          <ac:chgData name="Belaid, Sirine" userId="S::belaids@upmc.edu::5dcb4cf5-c058-49ea-93f8-4f4e6c877fcd" providerId="AD" clId="Web-{CA0C33D0-C09E-583B-D4CE-01D9F9A06D6E}" dt="2024-11-21T01:26:21.302" v="61"/>
          <ac:cxnSpMkLst>
            <pc:docMk/>
            <pc:sldMk cId="1990103092" sldId="383"/>
            <ac:cxnSpMk id="9" creationId="{8125620C-5F86-A875-1B90-2624FAB5A2E0}"/>
          </ac:cxnSpMkLst>
        </pc:cxnChg>
        <pc:cxnChg chg="add mod">
          <ac:chgData name="Belaid, Sirine" userId="S::belaids@upmc.edu::5dcb4cf5-c058-49ea-93f8-4f4e6c877fcd" providerId="AD" clId="Web-{CA0C33D0-C09E-583B-D4CE-01D9F9A06D6E}" dt="2024-11-21T01:34:07.286" v="65" actId="1076"/>
          <ac:cxnSpMkLst>
            <pc:docMk/>
            <pc:sldMk cId="1990103092" sldId="383"/>
            <ac:cxnSpMk id="10" creationId="{CDF0C96B-FFED-F26D-9152-38C3A53E2FAF}"/>
          </ac:cxnSpMkLst>
        </pc:cxnChg>
      </pc:sldChg>
      <pc:sldChg chg="addSp delSp modSp add del">
        <pc:chgData name="Belaid, Sirine" userId="S::belaids@upmc.edu::5dcb4cf5-c058-49ea-93f8-4f4e6c877fcd" providerId="AD" clId="Web-{CA0C33D0-C09E-583B-D4CE-01D9F9A06D6E}" dt="2024-11-21T02:27:43.905" v="418"/>
        <pc:sldMkLst>
          <pc:docMk/>
          <pc:sldMk cId="2617481529" sldId="384"/>
        </pc:sldMkLst>
        <pc:picChg chg="add del mod">
          <ac:chgData name="Belaid, Sirine" userId="S::belaids@upmc.edu::5dcb4cf5-c058-49ea-93f8-4f4e6c877fcd" providerId="AD" clId="Web-{CA0C33D0-C09E-583B-D4CE-01D9F9A06D6E}" dt="2024-11-21T02:19:55.852" v="330"/>
          <ac:picMkLst>
            <pc:docMk/>
            <pc:sldMk cId="2617481529" sldId="384"/>
            <ac:picMk id="3" creationId="{EEB6598D-9A89-95A4-F6F8-787F0099A37B}"/>
          </ac:picMkLst>
        </pc:picChg>
      </pc:sldChg>
      <pc:sldChg chg="addSp delSp modSp new">
        <pc:chgData name="Belaid, Sirine" userId="S::belaids@upmc.edu::5dcb4cf5-c058-49ea-93f8-4f4e6c877fcd" providerId="AD" clId="Web-{CA0C33D0-C09E-583B-D4CE-01D9F9A06D6E}" dt="2024-11-21T02:27:35.045" v="417" actId="14100"/>
        <pc:sldMkLst>
          <pc:docMk/>
          <pc:sldMk cId="249774899" sldId="385"/>
        </pc:sldMkLst>
        <pc:spChg chg="del">
          <ac:chgData name="Belaid, Sirine" userId="S::belaids@upmc.edu::5dcb4cf5-c058-49ea-93f8-4f4e6c877fcd" providerId="AD" clId="Web-{CA0C33D0-C09E-583B-D4CE-01D9F9A06D6E}" dt="2024-11-21T02:20:01.368" v="332"/>
          <ac:spMkLst>
            <pc:docMk/>
            <pc:sldMk cId="249774899" sldId="385"/>
            <ac:spMk id="2" creationId="{3B6DDBDF-EFAA-E287-BEFF-5ED1DB6E3A1E}"/>
          </ac:spMkLst>
        </pc:spChg>
        <pc:spChg chg="del">
          <ac:chgData name="Belaid, Sirine" userId="S::belaids@upmc.edu::5dcb4cf5-c058-49ea-93f8-4f4e6c877fcd" providerId="AD" clId="Web-{CA0C33D0-C09E-583B-D4CE-01D9F9A06D6E}" dt="2024-11-21T02:19:59.056" v="331"/>
          <ac:spMkLst>
            <pc:docMk/>
            <pc:sldMk cId="249774899" sldId="385"/>
            <ac:spMk id="3" creationId="{78579A88-ACE1-5C9E-1AFE-0237AD420AED}"/>
          </ac:spMkLst>
        </pc:spChg>
        <pc:spChg chg="add mod">
          <ac:chgData name="Belaid, Sirine" userId="S::belaids@upmc.edu::5dcb4cf5-c058-49ea-93f8-4f4e6c877fcd" providerId="AD" clId="Web-{CA0C33D0-C09E-583B-D4CE-01D9F9A06D6E}" dt="2024-11-21T02:20:41.089" v="351" actId="20577"/>
          <ac:spMkLst>
            <pc:docMk/>
            <pc:sldMk cId="249774899" sldId="385"/>
            <ac:spMk id="6" creationId="{5DD31F45-CA27-23E9-95FA-EBCBA8AB9498}"/>
          </ac:spMkLst>
        </pc:spChg>
        <pc:spChg chg="add mod">
          <ac:chgData name="Belaid, Sirine" userId="S::belaids@upmc.edu::5dcb4cf5-c058-49ea-93f8-4f4e6c877fcd" providerId="AD" clId="Web-{CA0C33D0-C09E-583B-D4CE-01D9F9A06D6E}" dt="2024-11-21T02:25:51.212" v="400" actId="1076"/>
          <ac:spMkLst>
            <pc:docMk/>
            <pc:sldMk cId="249774899" sldId="385"/>
            <ac:spMk id="12" creationId="{E3CA9471-186A-F2D9-ED01-284CA0C66021}"/>
          </ac:spMkLst>
        </pc:spChg>
        <pc:spChg chg="add mod">
          <ac:chgData name="Belaid, Sirine" userId="S::belaids@upmc.edu::5dcb4cf5-c058-49ea-93f8-4f4e6c877fcd" providerId="AD" clId="Web-{CA0C33D0-C09E-583B-D4CE-01D9F9A06D6E}" dt="2024-11-21T02:26:11.698" v="406" actId="1076"/>
          <ac:spMkLst>
            <pc:docMk/>
            <pc:sldMk cId="249774899" sldId="385"/>
            <ac:spMk id="13" creationId="{A04924F5-6DEA-C352-C915-BDD3F8F0E116}"/>
          </ac:spMkLst>
        </pc:spChg>
        <pc:spChg chg="add mod">
          <ac:chgData name="Belaid, Sirine" userId="S::belaids@upmc.edu::5dcb4cf5-c058-49ea-93f8-4f4e6c877fcd" providerId="AD" clId="Web-{CA0C33D0-C09E-583B-D4CE-01D9F9A06D6E}" dt="2024-11-21T02:26:44.152" v="412" actId="1076"/>
          <ac:spMkLst>
            <pc:docMk/>
            <pc:sldMk cId="249774899" sldId="385"/>
            <ac:spMk id="14" creationId="{DB0E8D10-0009-0D13-8B59-E42B4EA49004}"/>
          </ac:spMkLst>
        </pc:spChg>
        <pc:spChg chg="add del mod">
          <ac:chgData name="Belaid, Sirine" userId="S::belaids@upmc.edu::5dcb4cf5-c058-49ea-93f8-4f4e6c877fcd" providerId="AD" clId="Web-{CA0C33D0-C09E-583B-D4CE-01D9F9A06D6E}" dt="2024-11-21T02:26:39.793" v="411"/>
          <ac:spMkLst>
            <pc:docMk/>
            <pc:sldMk cId="249774899" sldId="385"/>
            <ac:spMk id="15" creationId="{E54D8C8B-B9D0-4579-A37B-506E55895454}"/>
          </ac:spMkLst>
        </pc:spChg>
        <pc:spChg chg="add del">
          <ac:chgData name="Belaid, Sirine" userId="S::belaids@upmc.edu::5dcb4cf5-c058-49ea-93f8-4f4e6c877fcd" providerId="AD" clId="Web-{CA0C33D0-C09E-583B-D4CE-01D9F9A06D6E}" dt="2024-11-21T02:26:57.012" v="414"/>
          <ac:spMkLst>
            <pc:docMk/>
            <pc:sldMk cId="249774899" sldId="385"/>
            <ac:spMk id="16" creationId="{2D42AB8F-970E-4B91-849A-3C3A695B9C40}"/>
          </ac:spMkLst>
        </pc:spChg>
        <pc:spChg chg="add mod">
          <ac:chgData name="Belaid, Sirine" userId="S::belaids@upmc.edu::5dcb4cf5-c058-49ea-93f8-4f4e6c877fcd" providerId="AD" clId="Web-{CA0C33D0-C09E-583B-D4CE-01D9F9A06D6E}" dt="2024-11-21T02:27:35.045" v="417" actId="14100"/>
          <ac:spMkLst>
            <pc:docMk/>
            <pc:sldMk cId="249774899" sldId="385"/>
            <ac:spMk id="17" creationId="{C89BA6D0-66B5-3F46-8208-6E3995C7BD5A}"/>
          </ac:spMkLst>
        </pc:spChg>
        <pc:picChg chg="add mod ord">
          <ac:chgData name="Belaid, Sirine" userId="S::belaids@upmc.edu::5dcb4cf5-c058-49ea-93f8-4f4e6c877fcd" providerId="AD" clId="Web-{CA0C33D0-C09E-583B-D4CE-01D9F9A06D6E}" dt="2024-11-21T02:20:20.213" v="338" actId="1076"/>
          <ac:picMkLst>
            <pc:docMk/>
            <pc:sldMk cId="249774899" sldId="385"/>
            <ac:picMk id="4" creationId="{F9669FBE-FB50-92B0-432E-5AC30BFAC3CF}"/>
          </ac:picMkLst>
        </pc:picChg>
        <pc:picChg chg="add mod">
          <ac:chgData name="Belaid, Sirine" userId="S::belaids@upmc.edu::5dcb4cf5-c058-49ea-93f8-4f4e6c877fcd" providerId="AD" clId="Web-{CA0C33D0-C09E-583B-D4CE-01D9F9A06D6E}" dt="2024-11-21T02:26:13.276" v="407" actId="1076"/>
          <ac:picMkLst>
            <pc:docMk/>
            <pc:sldMk cId="249774899" sldId="385"/>
            <ac:picMk id="9" creationId="{C383A974-CCF3-0F5E-CF08-436CEEBB9E70}"/>
          </ac:picMkLst>
        </pc:picChg>
        <pc:picChg chg="add mod">
          <ac:chgData name="Belaid, Sirine" userId="S::belaids@upmc.edu::5dcb4cf5-c058-49ea-93f8-4f4e6c877fcd" providerId="AD" clId="Web-{CA0C33D0-C09E-583B-D4CE-01D9F9A06D6E}" dt="2024-11-21T02:25:46.118" v="399" actId="1076"/>
          <ac:picMkLst>
            <pc:docMk/>
            <pc:sldMk cId="249774899" sldId="385"/>
            <ac:picMk id="11" creationId="{EC7810C9-0AD5-7CC1-30FC-2B740F75AB85}"/>
          </ac:picMkLst>
        </pc:picChg>
        <pc:cxnChg chg="add mod">
          <ac:chgData name="Belaid, Sirine" userId="S::belaids@upmc.edu::5dcb4cf5-c058-49ea-93f8-4f4e6c877fcd" providerId="AD" clId="Web-{CA0C33D0-C09E-583B-D4CE-01D9F9A06D6E}" dt="2024-11-21T02:24:03.864" v="364" actId="14100"/>
          <ac:cxnSpMkLst>
            <pc:docMk/>
            <pc:sldMk cId="249774899" sldId="385"/>
            <ac:cxnSpMk id="8" creationId="{EAA7AACC-D540-CB9D-262B-3F3B8FF060A4}"/>
          </ac:cxnSpMkLst>
        </pc:cxnChg>
      </pc:sldChg>
      <pc:sldChg chg="modSp add replId">
        <pc:chgData name="Belaid, Sirine" userId="S::belaids@upmc.edu::5dcb4cf5-c058-49ea-93f8-4f4e6c877fcd" providerId="AD" clId="Web-{CA0C33D0-C09E-583B-D4CE-01D9F9A06D6E}" dt="2024-11-21T04:38:50.951" v="820" actId="20577"/>
        <pc:sldMkLst>
          <pc:docMk/>
          <pc:sldMk cId="3743057861" sldId="386"/>
        </pc:sldMkLst>
        <pc:spChg chg="mod">
          <ac:chgData name="Belaid, Sirine" userId="S::belaids@upmc.edu::5dcb4cf5-c058-49ea-93f8-4f4e6c877fcd" providerId="AD" clId="Web-{CA0C33D0-C09E-583B-D4CE-01D9F9A06D6E}" dt="2024-11-21T04:35:55.330" v="730" actId="20577"/>
          <ac:spMkLst>
            <pc:docMk/>
            <pc:sldMk cId="3743057861" sldId="386"/>
            <ac:spMk id="2" creationId="{1E63AA7C-D8CC-24E2-1927-C63C14BF6FAB}"/>
          </ac:spMkLst>
        </pc:spChg>
        <pc:spChg chg="mod">
          <ac:chgData name="Belaid, Sirine" userId="S::belaids@upmc.edu::5dcb4cf5-c058-49ea-93f8-4f4e6c877fcd" providerId="AD" clId="Web-{CA0C33D0-C09E-583B-D4CE-01D9F9A06D6E}" dt="2024-11-21T04:38:50.951" v="820" actId="20577"/>
          <ac:spMkLst>
            <pc:docMk/>
            <pc:sldMk cId="3743057861" sldId="386"/>
            <ac:spMk id="3" creationId="{6B57145F-A3D4-5C8F-5BBE-CC4E7BC1E90B}"/>
          </ac:spMkLst>
        </pc:spChg>
      </pc:sldChg>
      <pc:sldChg chg="modSp new">
        <pc:chgData name="Belaid, Sirine" userId="S::belaids@upmc.edu::5dcb4cf5-c058-49ea-93f8-4f4e6c877fcd" providerId="AD" clId="Web-{CA0C33D0-C09E-583B-D4CE-01D9F9A06D6E}" dt="2024-11-21T04:39:25.610" v="829" actId="20577"/>
        <pc:sldMkLst>
          <pc:docMk/>
          <pc:sldMk cId="2301887968" sldId="387"/>
        </pc:sldMkLst>
        <pc:spChg chg="mod">
          <ac:chgData name="Belaid, Sirine" userId="S::belaids@upmc.edu::5dcb4cf5-c058-49ea-93f8-4f4e6c877fcd" providerId="AD" clId="Web-{CA0C33D0-C09E-583B-D4CE-01D9F9A06D6E}" dt="2024-11-21T04:39:25.610" v="829" actId="20577"/>
          <ac:spMkLst>
            <pc:docMk/>
            <pc:sldMk cId="2301887968" sldId="387"/>
            <ac:spMk id="2" creationId="{146ABACD-E5FC-771D-118F-2B844414B97D}"/>
          </ac:spMkLst>
        </pc:spChg>
      </pc:sldChg>
      <pc:sldChg chg="new del">
        <pc:chgData name="Belaid, Sirine" userId="S::belaids@upmc.edu::5dcb4cf5-c058-49ea-93f8-4f4e6c877fcd" providerId="AD" clId="Web-{CA0C33D0-C09E-583B-D4CE-01D9F9A06D6E}" dt="2024-11-21T04:39:04.546" v="822"/>
        <pc:sldMkLst>
          <pc:docMk/>
          <pc:sldMk cId="2745956728" sldId="387"/>
        </pc:sldMkLst>
      </pc:sldChg>
    </pc:docChg>
  </pc:docChgLst>
  <pc:docChgLst>
    <pc:chgData name="Belaid, Sirine" userId="S::belaids@upmc.edu::5dcb4cf5-c058-49ea-93f8-4f4e6c877fcd" providerId="AD" clId="Web-{EEB82D42-9C40-368B-46DB-B7B7573FF0AD}"/>
    <pc:docChg chg="modSld sldOrd">
      <pc:chgData name="Belaid, Sirine" userId="S::belaids@upmc.edu::5dcb4cf5-c058-49ea-93f8-4f4e6c877fcd" providerId="AD" clId="Web-{EEB82D42-9C40-368B-46DB-B7B7573FF0AD}" dt="2024-12-13T14:17:19.026" v="243" actId="20577"/>
      <pc:docMkLst>
        <pc:docMk/>
      </pc:docMkLst>
      <pc:sldChg chg="modSp">
        <pc:chgData name="Belaid, Sirine" userId="S::belaids@upmc.edu::5dcb4cf5-c058-49ea-93f8-4f4e6c877fcd" providerId="AD" clId="Web-{EEB82D42-9C40-368B-46DB-B7B7573FF0AD}" dt="2024-12-13T14:13:21.550" v="171" actId="20577"/>
        <pc:sldMkLst>
          <pc:docMk/>
          <pc:sldMk cId="1500721348" sldId="258"/>
        </pc:sldMkLst>
        <pc:spChg chg="mod">
          <ac:chgData name="Belaid, Sirine" userId="S::belaids@upmc.edu::5dcb4cf5-c058-49ea-93f8-4f4e6c877fcd" providerId="AD" clId="Web-{EEB82D42-9C40-368B-46DB-B7B7573FF0AD}" dt="2024-12-13T14:13:21.550" v="171" actId="20577"/>
          <ac:spMkLst>
            <pc:docMk/>
            <pc:sldMk cId="1500721348" sldId="258"/>
            <ac:spMk id="3" creationId="{76CE0DDB-F694-7507-CAB6-43B4259BD94F}"/>
          </ac:spMkLst>
        </pc:spChg>
      </pc:sldChg>
      <pc:sldChg chg="modSp">
        <pc:chgData name="Belaid, Sirine" userId="S::belaids@upmc.edu::5dcb4cf5-c058-49ea-93f8-4f4e6c877fcd" providerId="AD" clId="Web-{EEB82D42-9C40-368B-46DB-B7B7573FF0AD}" dt="2024-12-13T14:16:04.680" v="225" actId="20577"/>
        <pc:sldMkLst>
          <pc:docMk/>
          <pc:sldMk cId="1403967867" sldId="289"/>
        </pc:sldMkLst>
        <pc:spChg chg="mod">
          <ac:chgData name="Belaid, Sirine" userId="S::belaids@upmc.edu::5dcb4cf5-c058-49ea-93f8-4f4e6c877fcd" providerId="AD" clId="Web-{EEB82D42-9C40-368B-46DB-B7B7573FF0AD}" dt="2024-12-13T14:16:04.680" v="225" actId="20577"/>
          <ac:spMkLst>
            <pc:docMk/>
            <pc:sldMk cId="1403967867" sldId="289"/>
            <ac:spMk id="6" creationId="{68292658-3663-6BA4-20A7-448B238A1793}"/>
          </ac:spMkLst>
        </pc:spChg>
      </pc:sldChg>
      <pc:sldChg chg="addSp modSp">
        <pc:chgData name="Belaid, Sirine" userId="S::belaids@upmc.edu::5dcb4cf5-c058-49ea-93f8-4f4e6c877fcd" providerId="AD" clId="Web-{EEB82D42-9C40-368B-46DB-B7B7573FF0AD}" dt="2024-12-13T03:55:13.712" v="12"/>
        <pc:sldMkLst>
          <pc:docMk/>
          <pc:sldMk cId="1575805153" sldId="291"/>
        </pc:sldMkLst>
        <pc:spChg chg="add mod">
          <ac:chgData name="Belaid, Sirine" userId="S::belaids@upmc.edu::5dcb4cf5-c058-49ea-93f8-4f4e6c877fcd" providerId="AD" clId="Web-{EEB82D42-9C40-368B-46DB-B7B7573FF0AD}" dt="2024-12-13T03:55:13.712" v="12"/>
          <ac:spMkLst>
            <pc:docMk/>
            <pc:sldMk cId="1575805153" sldId="291"/>
            <ac:spMk id="5" creationId="{074554DC-F2C1-2E85-E789-E023EAC35183}"/>
          </ac:spMkLst>
        </pc:spChg>
      </pc:sldChg>
      <pc:sldChg chg="modSp">
        <pc:chgData name="Belaid, Sirine" userId="S::belaids@upmc.edu::5dcb4cf5-c058-49ea-93f8-4f4e6c877fcd" providerId="AD" clId="Web-{EEB82D42-9C40-368B-46DB-B7B7573FF0AD}" dt="2024-12-13T14:13:30.566" v="173" actId="20577"/>
        <pc:sldMkLst>
          <pc:docMk/>
          <pc:sldMk cId="4094227945" sldId="352"/>
        </pc:sldMkLst>
        <pc:spChg chg="mod">
          <ac:chgData name="Belaid, Sirine" userId="S::belaids@upmc.edu::5dcb4cf5-c058-49ea-93f8-4f4e6c877fcd" providerId="AD" clId="Web-{EEB82D42-9C40-368B-46DB-B7B7573FF0AD}" dt="2024-12-13T14:13:30.566" v="173" actId="20577"/>
          <ac:spMkLst>
            <pc:docMk/>
            <pc:sldMk cId="4094227945" sldId="352"/>
            <ac:spMk id="3" creationId="{54D52FF0-F483-CAD8-917A-930506D4F12A}"/>
          </ac:spMkLst>
        </pc:spChg>
      </pc:sldChg>
      <pc:sldChg chg="modSp">
        <pc:chgData name="Belaid, Sirine" userId="S::belaids@upmc.edu::5dcb4cf5-c058-49ea-93f8-4f4e6c877fcd" providerId="AD" clId="Web-{EEB82D42-9C40-368B-46DB-B7B7573FF0AD}" dt="2024-12-13T14:15:41.804" v="220" actId="20577"/>
        <pc:sldMkLst>
          <pc:docMk/>
          <pc:sldMk cId="1022786307" sldId="355"/>
        </pc:sldMkLst>
        <pc:spChg chg="mod">
          <ac:chgData name="Belaid, Sirine" userId="S::belaids@upmc.edu::5dcb4cf5-c058-49ea-93f8-4f4e6c877fcd" providerId="AD" clId="Web-{EEB82D42-9C40-368B-46DB-B7B7573FF0AD}" dt="2024-12-13T14:15:41.804" v="220" actId="20577"/>
          <ac:spMkLst>
            <pc:docMk/>
            <pc:sldMk cId="1022786307" sldId="355"/>
            <ac:spMk id="3" creationId="{1C74E49B-EF04-8C3D-7D26-98DBD002E7B7}"/>
          </ac:spMkLst>
        </pc:spChg>
      </pc:sldChg>
      <pc:sldChg chg="modSp">
        <pc:chgData name="Belaid, Sirine" userId="S::belaids@upmc.edu::5dcb4cf5-c058-49ea-93f8-4f4e6c877fcd" providerId="AD" clId="Web-{EEB82D42-9C40-368B-46DB-B7B7573FF0AD}" dt="2024-12-13T14:12:59.221" v="158" actId="20577"/>
        <pc:sldMkLst>
          <pc:docMk/>
          <pc:sldMk cId="3868067760" sldId="357"/>
        </pc:sldMkLst>
        <pc:spChg chg="mod">
          <ac:chgData name="Belaid, Sirine" userId="S::belaids@upmc.edu::5dcb4cf5-c058-49ea-93f8-4f4e6c877fcd" providerId="AD" clId="Web-{EEB82D42-9C40-368B-46DB-B7B7573FF0AD}" dt="2024-12-13T14:12:59.221" v="158" actId="20577"/>
          <ac:spMkLst>
            <pc:docMk/>
            <pc:sldMk cId="3868067760" sldId="357"/>
            <ac:spMk id="3" creationId="{C6C10584-5F60-48A3-BCF3-AF01322CF6C3}"/>
          </ac:spMkLst>
        </pc:spChg>
      </pc:sldChg>
      <pc:sldChg chg="modSp">
        <pc:chgData name="Belaid, Sirine" userId="S::belaids@upmc.edu::5dcb4cf5-c058-49ea-93f8-4f4e6c877fcd" providerId="AD" clId="Web-{EEB82D42-9C40-368B-46DB-B7B7573FF0AD}" dt="2024-12-13T14:14:25.021" v="189" actId="20577"/>
        <pc:sldMkLst>
          <pc:docMk/>
          <pc:sldMk cId="3825394227" sldId="358"/>
        </pc:sldMkLst>
        <pc:spChg chg="mod">
          <ac:chgData name="Belaid, Sirine" userId="S::belaids@upmc.edu::5dcb4cf5-c058-49ea-93f8-4f4e6c877fcd" providerId="AD" clId="Web-{EEB82D42-9C40-368B-46DB-B7B7573FF0AD}" dt="2024-12-13T14:14:25.021" v="189" actId="20577"/>
          <ac:spMkLst>
            <pc:docMk/>
            <pc:sldMk cId="3825394227" sldId="358"/>
            <ac:spMk id="3" creationId="{4974952F-AF49-DE12-B0DE-612B936EDA11}"/>
          </ac:spMkLst>
        </pc:spChg>
      </pc:sldChg>
      <pc:sldChg chg="modSp addAnim delAnim">
        <pc:chgData name="Belaid, Sirine" userId="S::belaids@upmc.edu::5dcb4cf5-c058-49ea-93f8-4f4e6c877fcd" providerId="AD" clId="Web-{EEB82D42-9C40-368B-46DB-B7B7573FF0AD}" dt="2024-12-13T14:17:19.026" v="243" actId="20577"/>
        <pc:sldMkLst>
          <pc:docMk/>
          <pc:sldMk cId="1919480477" sldId="360"/>
        </pc:sldMkLst>
        <pc:spChg chg="mod">
          <ac:chgData name="Belaid, Sirine" userId="S::belaids@upmc.edu::5dcb4cf5-c058-49ea-93f8-4f4e6c877fcd" providerId="AD" clId="Web-{EEB82D42-9C40-368B-46DB-B7B7573FF0AD}" dt="2024-12-13T14:17:19.026" v="243" actId="20577"/>
          <ac:spMkLst>
            <pc:docMk/>
            <pc:sldMk cId="1919480477" sldId="360"/>
            <ac:spMk id="3" creationId="{6CCD5ABF-F289-6DF4-D01E-776F3BB7441A}"/>
          </ac:spMkLst>
        </pc:spChg>
      </pc:sldChg>
      <pc:sldChg chg="ord">
        <pc:chgData name="Belaid, Sirine" userId="S::belaids@upmc.edu::5dcb4cf5-c058-49ea-93f8-4f4e6c877fcd" providerId="AD" clId="Web-{EEB82D42-9C40-368B-46DB-B7B7573FF0AD}" dt="2024-12-13T04:01:36.384" v="13"/>
        <pc:sldMkLst>
          <pc:docMk/>
          <pc:sldMk cId="2090633080" sldId="362"/>
        </pc:sldMkLst>
      </pc:sldChg>
      <pc:sldChg chg="delSp modSp">
        <pc:chgData name="Belaid, Sirine" userId="S::belaids@upmc.edu::5dcb4cf5-c058-49ea-93f8-4f4e6c877fcd" providerId="AD" clId="Web-{EEB82D42-9C40-368B-46DB-B7B7573FF0AD}" dt="2024-12-13T14:11:44.703" v="84" actId="1076"/>
        <pc:sldMkLst>
          <pc:docMk/>
          <pc:sldMk cId="3004633114" sldId="367"/>
        </pc:sldMkLst>
        <pc:spChg chg="mod">
          <ac:chgData name="Belaid, Sirine" userId="S::belaids@upmc.edu::5dcb4cf5-c058-49ea-93f8-4f4e6c877fcd" providerId="AD" clId="Web-{EEB82D42-9C40-368B-46DB-B7B7573FF0AD}" dt="2024-12-13T14:11:40.766" v="82" actId="20577"/>
          <ac:spMkLst>
            <pc:docMk/>
            <pc:sldMk cId="3004633114" sldId="367"/>
            <ac:spMk id="3" creationId="{9AE938D2-B05F-4829-BA51-1B2B9A25680E}"/>
          </ac:spMkLst>
        </pc:spChg>
        <pc:picChg chg="mod">
          <ac:chgData name="Belaid, Sirine" userId="S::belaids@upmc.edu::5dcb4cf5-c058-49ea-93f8-4f4e6c877fcd" providerId="AD" clId="Web-{EEB82D42-9C40-368B-46DB-B7B7573FF0AD}" dt="2024-12-13T14:11:44.703" v="84" actId="1076"/>
          <ac:picMkLst>
            <pc:docMk/>
            <pc:sldMk cId="3004633114" sldId="367"/>
            <ac:picMk id="5" creationId="{D9102F3E-D968-C1EC-3C84-215E0AAEE767}"/>
          </ac:picMkLst>
        </pc:picChg>
        <pc:picChg chg="del">
          <ac:chgData name="Belaid, Sirine" userId="S::belaids@upmc.edu::5dcb4cf5-c058-49ea-93f8-4f4e6c877fcd" providerId="AD" clId="Web-{EEB82D42-9C40-368B-46DB-B7B7573FF0AD}" dt="2024-12-13T14:11:41.125" v="83"/>
          <ac:picMkLst>
            <pc:docMk/>
            <pc:sldMk cId="3004633114" sldId="367"/>
            <ac:picMk id="6" creationId="{230E52E8-AF0E-CED2-AB11-377EE30E9C99}"/>
          </ac:picMkLst>
        </pc:picChg>
      </pc:sldChg>
      <pc:sldChg chg="modSp">
        <pc:chgData name="Belaid, Sirine" userId="S::belaids@upmc.edu::5dcb4cf5-c058-49ea-93f8-4f4e6c877fcd" providerId="AD" clId="Web-{EEB82D42-9C40-368B-46DB-B7B7573FF0AD}" dt="2024-12-13T14:15:23.616" v="215" actId="20577"/>
        <pc:sldMkLst>
          <pc:docMk/>
          <pc:sldMk cId="13225285" sldId="370"/>
        </pc:sldMkLst>
        <pc:spChg chg="mod">
          <ac:chgData name="Belaid, Sirine" userId="S::belaids@upmc.edu::5dcb4cf5-c058-49ea-93f8-4f4e6c877fcd" providerId="AD" clId="Web-{EEB82D42-9C40-368B-46DB-B7B7573FF0AD}" dt="2024-12-13T14:15:03.194" v="204" actId="20577"/>
          <ac:spMkLst>
            <pc:docMk/>
            <pc:sldMk cId="13225285" sldId="370"/>
            <ac:spMk id="2" creationId="{390210F8-63D0-95C3-DEF9-3C8314A55FAA}"/>
          </ac:spMkLst>
        </pc:spChg>
        <pc:spChg chg="mod">
          <ac:chgData name="Belaid, Sirine" userId="S::belaids@upmc.edu::5dcb4cf5-c058-49ea-93f8-4f4e6c877fcd" providerId="AD" clId="Web-{EEB82D42-9C40-368B-46DB-B7B7573FF0AD}" dt="2024-12-13T14:15:23.616" v="215" actId="20577"/>
          <ac:spMkLst>
            <pc:docMk/>
            <pc:sldMk cId="13225285" sldId="370"/>
            <ac:spMk id="3" creationId="{5F301AD2-63C3-E004-C0F9-E2CADF494E6A}"/>
          </ac:spMkLst>
        </pc:spChg>
      </pc:sldChg>
      <pc:sldChg chg="modNotes">
        <pc:chgData name="Belaid, Sirine" userId="S::belaids@upmc.edu::5dcb4cf5-c058-49ea-93f8-4f4e6c877fcd" providerId="AD" clId="Web-{EEB82D42-9C40-368B-46DB-B7B7573FF0AD}" dt="2024-12-13T12:56:18.593" v="34"/>
        <pc:sldMkLst>
          <pc:docMk/>
          <pc:sldMk cId="1585369059" sldId="373"/>
        </pc:sldMkLst>
      </pc:sldChg>
      <pc:sldChg chg="modNotes">
        <pc:chgData name="Belaid, Sirine" userId="S::belaids@upmc.edu::5dcb4cf5-c058-49ea-93f8-4f4e6c877fcd" providerId="AD" clId="Web-{EEB82D42-9C40-368B-46DB-B7B7573FF0AD}" dt="2024-12-13T12:56:12.858" v="33"/>
        <pc:sldMkLst>
          <pc:docMk/>
          <pc:sldMk cId="3743057861" sldId="386"/>
        </pc:sldMkLst>
      </pc:sldChg>
      <pc:sldChg chg="modSp">
        <pc:chgData name="Belaid, Sirine" userId="S::belaids@upmc.edu::5dcb4cf5-c058-49ea-93f8-4f4e6c877fcd" providerId="AD" clId="Web-{EEB82D42-9C40-368B-46DB-B7B7573FF0AD}" dt="2024-12-13T04:30:55.577" v="26" actId="1076"/>
        <pc:sldMkLst>
          <pc:docMk/>
          <pc:sldMk cId="3342538804" sldId="388"/>
        </pc:sldMkLst>
        <pc:spChg chg="mod">
          <ac:chgData name="Belaid, Sirine" userId="S::belaids@upmc.edu::5dcb4cf5-c058-49ea-93f8-4f4e6c877fcd" providerId="AD" clId="Web-{EEB82D42-9C40-368B-46DB-B7B7573FF0AD}" dt="2024-12-13T04:30:43.531" v="22" actId="14100"/>
          <ac:spMkLst>
            <pc:docMk/>
            <pc:sldMk cId="3342538804" sldId="388"/>
            <ac:spMk id="3" creationId="{19813B5D-F53D-0C33-97ED-29C6246EA762}"/>
          </ac:spMkLst>
        </pc:spChg>
        <pc:picChg chg="mod">
          <ac:chgData name="Belaid, Sirine" userId="S::belaids@upmc.edu::5dcb4cf5-c058-49ea-93f8-4f4e6c877fcd" providerId="AD" clId="Web-{EEB82D42-9C40-368B-46DB-B7B7573FF0AD}" dt="2024-12-13T04:30:55.577" v="26" actId="1076"/>
          <ac:picMkLst>
            <pc:docMk/>
            <pc:sldMk cId="3342538804" sldId="388"/>
            <ac:picMk id="5" creationId="{42271115-8C23-EBF5-D216-7762795949E7}"/>
          </ac:picMkLst>
        </pc:picChg>
      </pc:sldChg>
      <pc:sldChg chg="modSp">
        <pc:chgData name="Belaid, Sirine" userId="S::belaids@upmc.edu::5dcb4cf5-c058-49ea-93f8-4f4e6c877fcd" providerId="AD" clId="Web-{EEB82D42-9C40-368B-46DB-B7B7573FF0AD}" dt="2024-12-13T14:16:14.821" v="233"/>
        <pc:sldMkLst>
          <pc:docMk/>
          <pc:sldMk cId="1625999220" sldId="395"/>
        </pc:sldMkLst>
        <pc:graphicFrameChg chg="mod modGraphic">
          <ac:chgData name="Belaid, Sirine" userId="S::belaids@upmc.edu::5dcb4cf5-c058-49ea-93f8-4f4e6c877fcd" providerId="AD" clId="Web-{EEB82D42-9C40-368B-46DB-B7B7573FF0AD}" dt="2024-12-13T14:16:14.821" v="233"/>
          <ac:graphicFrameMkLst>
            <pc:docMk/>
            <pc:sldMk cId="1625999220" sldId="395"/>
            <ac:graphicFrameMk id="2" creationId="{5AF5F66F-7F30-C7FD-12D8-EE5A388FDE96}"/>
          </ac:graphicFrameMkLst>
        </pc:graphicFrameChg>
      </pc:sldChg>
      <pc:sldChg chg="addSp modSp addAnim">
        <pc:chgData name="Belaid, Sirine" userId="S::belaids@upmc.edu::5dcb4cf5-c058-49ea-93f8-4f4e6c877fcd" providerId="AD" clId="Web-{EEB82D42-9C40-368B-46DB-B7B7573FF0AD}" dt="2024-12-13T12:42:25.848" v="31"/>
        <pc:sldMkLst>
          <pc:docMk/>
          <pc:sldMk cId="1037649623" sldId="396"/>
        </pc:sldMkLst>
        <pc:spChg chg="add mod">
          <ac:chgData name="Belaid, Sirine" userId="S::belaids@upmc.edu::5dcb4cf5-c058-49ea-93f8-4f4e6c877fcd" providerId="AD" clId="Web-{EEB82D42-9C40-368B-46DB-B7B7573FF0AD}" dt="2024-12-13T12:42:19.754" v="30" actId="1076"/>
          <ac:spMkLst>
            <pc:docMk/>
            <pc:sldMk cId="1037649623" sldId="396"/>
            <ac:spMk id="6" creationId="{45F1A969-F05C-EBC3-E804-917C968F09CB}"/>
          </ac:spMkLst>
        </pc:spChg>
      </pc:sldChg>
      <pc:sldChg chg="delSp">
        <pc:chgData name="Belaid, Sirine" userId="S::belaids@upmc.edu::5dcb4cf5-c058-49ea-93f8-4f4e6c877fcd" providerId="AD" clId="Web-{EEB82D42-9C40-368B-46DB-B7B7573FF0AD}" dt="2024-12-13T12:50:41.145" v="32"/>
        <pc:sldMkLst>
          <pc:docMk/>
          <pc:sldMk cId="565133894" sldId="398"/>
        </pc:sldMkLst>
        <pc:picChg chg="del">
          <ac:chgData name="Belaid, Sirine" userId="S::belaids@upmc.edu::5dcb4cf5-c058-49ea-93f8-4f4e6c877fcd" providerId="AD" clId="Web-{EEB82D42-9C40-368B-46DB-B7B7573FF0AD}" dt="2024-12-13T12:50:41.145" v="32"/>
          <ac:picMkLst>
            <pc:docMk/>
            <pc:sldMk cId="565133894" sldId="398"/>
            <ac:picMk id="4" creationId="{FCF9EBDC-9067-3296-021C-172BEBC20B85}"/>
          </ac:picMkLst>
        </pc:picChg>
      </pc:sldChg>
      <pc:sldChg chg="addSp modSp modNotes">
        <pc:chgData name="Belaid, Sirine" userId="S::belaids@upmc.edu::5dcb4cf5-c058-49ea-93f8-4f4e6c877fcd" providerId="AD" clId="Web-{EEB82D42-9C40-368B-46DB-B7B7573FF0AD}" dt="2024-12-13T14:11:12.812" v="78"/>
        <pc:sldMkLst>
          <pc:docMk/>
          <pc:sldMk cId="3969654780" sldId="403"/>
        </pc:sldMkLst>
        <pc:spChg chg="add mod">
          <ac:chgData name="Belaid, Sirine" userId="S::belaids@upmc.edu::5dcb4cf5-c058-49ea-93f8-4f4e6c877fcd" providerId="AD" clId="Web-{EEB82D42-9C40-368B-46DB-B7B7573FF0AD}" dt="2024-12-13T14:06:11.646" v="61" actId="1076"/>
          <ac:spMkLst>
            <pc:docMk/>
            <pc:sldMk cId="3969654780" sldId="403"/>
            <ac:spMk id="3" creationId="{413D458D-0166-F4A0-0D32-6DC38DB896D9}"/>
          </ac:spMkLst>
        </pc:spChg>
      </pc:sldChg>
    </pc:docChg>
  </pc:docChgLst>
  <pc:docChgLst>
    <pc:chgData name="Belaid, Sirine" userId="S::belaids@upmc.edu::5dcb4cf5-c058-49ea-93f8-4f4e6c877fcd" providerId="AD" clId="Web-{C2EB1329-3B0C-57E1-993C-C445A498EDDF}"/>
    <pc:docChg chg="modSld">
      <pc:chgData name="Belaid, Sirine" userId="S::belaids@upmc.edu::5dcb4cf5-c058-49ea-93f8-4f4e6c877fcd" providerId="AD" clId="Web-{C2EB1329-3B0C-57E1-993C-C445A498EDDF}" dt="2025-01-02T12:26:52.815" v="0"/>
      <pc:docMkLst>
        <pc:docMk/>
      </pc:docMkLst>
      <pc:sldChg chg="mod modShow">
        <pc:chgData name="Belaid, Sirine" userId="S::belaids@upmc.edu::5dcb4cf5-c058-49ea-93f8-4f4e6c877fcd" providerId="AD" clId="Web-{C2EB1329-3B0C-57E1-993C-C445A498EDDF}" dt="2025-01-02T12:26:52.815" v="0"/>
        <pc:sldMkLst>
          <pc:docMk/>
          <pc:sldMk cId="2372464141" sldId="404"/>
        </pc:sldMkLst>
      </pc:sldChg>
    </pc:docChg>
  </pc:docChgLst>
  <pc:docChgLst>
    <pc:chgData name="Belaid, Sirine" userId="S::belaids@upmc.edu::5dcb4cf5-c058-49ea-93f8-4f4e6c877fcd" providerId="AD" clId="Web-{1FC96684-9F6B-BEB0-4270-98C226A46F3F}"/>
    <pc:docChg chg="addSld modSld">
      <pc:chgData name="Belaid, Sirine" userId="S::belaids@upmc.edu::5dcb4cf5-c058-49ea-93f8-4f4e6c877fcd" providerId="AD" clId="Web-{1FC96684-9F6B-BEB0-4270-98C226A46F3F}" dt="2024-11-20T23:43:35.436" v="7" actId="20577"/>
      <pc:docMkLst>
        <pc:docMk/>
      </pc:docMkLst>
      <pc:sldChg chg="addSp delSp modSp new">
        <pc:chgData name="Belaid, Sirine" userId="S::belaids@upmc.edu::5dcb4cf5-c058-49ea-93f8-4f4e6c877fcd" providerId="AD" clId="Web-{1FC96684-9F6B-BEB0-4270-98C226A46F3F}" dt="2024-11-20T23:43:35.436" v="7" actId="20577"/>
        <pc:sldMkLst>
          <pc:docMk/>
          <pc:sldMk cId="2684994436" sldId="371"/>
        </pc:sldMkLst>
        <pc:spChg chg="del">
          <ac:chgData name="Belaid, Sirine" userId="S::belaids@upmc.edu::5dcb4cf5-c058-49ea-93f8-4f4e6c877fcd" providerId="AD" clId="Web-{1FC96684-9F6B-BEB0-4270-98C226A46F3F}" dt="2024-11-20T23:42:53.965" v="1"/>
          <ac:spMkLst>
            <pc:docMk/>
            <pc:sldMk cId="2684994436" sldId="371"/>
            <ac:spMk id="3" creationId="{C38062AB-5F5C-8B91-D956-017044F99F90}"/>
          </ac:spMkLst>
        </pc:spChg>
        <pc:spChg chg="add mod">
          <ac:chgData name="Belaid, Sirine" userId="S::belaids@upmc.edu::5dcb4cf5-c058-49ea-93f8-4f4e6c877fcd" providerId="AD" clId="Web-{1FC96684-9F6B-BEB0-4270-98C226A46F3F}" dt="2024-11-20T23:43:35.436" v="7" actId="20577"/>
          <ac:spMkLst>
            <pc:docMk/>
            <pc:sldMk cId="2684994436" sldId="371"/>
            <ac:spMk id="6" creationId="{C78CA2CC-86D2-060F-868C-9F116C227D9B}"/>
          </ac:spMkLst>
        </pc:spChg>
        <pc:picChg chg="add del mod ord">
          <ac:chgData name="Belaid, Sirine" userId="S::belaids@upmc.edu::5dcb4cf5-c058-49ea-93f8-4f4e6c877fcd" providerId="AD" clId="Web-{1FC96684-9F6B-BEB0-4270-98C226A46F3F}" dt="2024-11-20T23:42:56.512" v="2"/>
          <ac:picMkLst>
            <pc:docMk/>
            <pc:sldMk cId="2684994436" sldId="371"/>
            <ac:picMk id="4" creationId="{5FBCB6D9-0ECB-AE57-B8D8-10A095100799}"/>
          </ac:picMkLst>
        </pc:picChg>
      </pc:sldChg>
    </pc:docChg>
  </pc:docChgLst>
  <pc:docChgLst>
    <pc:chgData name="Belaid, Sirine" userId="S::belaids@upmc.edu::5dcb4cf5-c058-49ea-93f8-4f4e6c877fcd" providerId="AD" clId="Web-{CC719679-0353-1A45-E175-85B512CCE0FA}"/>
    <pc:docChg chg="addSld modSld sldOrd">
      <pc:chgData name="Belaid, Sirine" userId="S::belaids@upmc.edu::5dcb4cf5-c058-49ea-93f8-4f4e6c877fcd" providerId="AD" clId="Web-{CC719679-0353-1A45-E175-85B512CCE0FA}" dt="2024-12-12T21:11:13.609" v="478"/>
      <pc:docMkLst>
        <pc:docMk/>
      </pc:docMkLst>
      <pc:sldChg chg="modSp">
        <pc:chgData name="Belaid, Sirine" userId="S::belaids@upmc.edu::5dcb4cf5-c058-49ea-93f8-4f4e6c877fcd" providerId="AD" clId="Web-{CC719679-0353-1A45-E175-85B512CCE0FA}" dt="2024-12-12T20:28:17.379" v="313" actId="20577"/>
        <pc:sldMkLst>
          <pc:docMk/>
          <pc:sldMk cId="3743057861" sldId="386"/>
        </pc:sldMkLst>
        <pc:spChg chg="mod">
          <ac:chgData name="Belaid, Sirine" userId="S::belaids@upmc.edu::5dcb4cf5-c058-49ea-93f8-4f4e6c877fcd" providerId="AD" clId="Web-{CC719679-0353-1A45-E175-85B512CCE0FA}" dt="2024-12-12T20:28:17.379" v="313" actId="20577"/>
          <ac:spMkLst>
            <pc:docMk/>
            <pc:sldMk cId="3743057861" sldId="386"/>
            <ac:spMk id="3" creationId="{6B57145F-A3D4-5C8F-5BBE-CC4E7BC1E90B}"/>
          </ac:spMkLst>
        </pc:spChg>
      </pc:sldChg>
      <pc:sldChg chg="modSp">
        <pc:chgData name="Belaid, Sirine" userId="S::belaids@upmc.edu::5dcb4cf5-c058-49ea-93f8-4f4e6c877fcd" providerId="AD" clId="Web-{CC719679-0353-1A45-E175-85B512CCE0FA}" dt="2024-12-12T16:50:17.192" v="59" actId="1076"/>
        <pc:sldMkLst>
          <pc:docMk/>
          <pc:sldMk cId="3342538804" sldId="388"/>
        </pc:sldMkLst>
        <pc:picChg chg="mod">
          <ac:chgData name="Belaid, Sirine" userId="S::belaids@upmc.edu::5dcb4cf5-c058-49ea-93f8-4f4e6c877fcd" providerId="AD" clId="Web-{CC719679-0353-1A45-E175-85B512CCE0FA}" dt="2024-12-12T16:50:17.192" v="59" actId="1076"/>
          <ac:picMkLst>
            <pc:docMk/>
            <pc:sldMk cId="3342538804" sldId="388"/>
            <ac:picMk id="5" creationId="{42271115-8C23-EBF5-D216-7762795949E7}"/>
          </ac:picMkLst>
        </pc:picChg>
      </pc:sldChg>
      <pc:sldChg chg="modSp">
        <pc:chgData name="Belaid, Sirine" userId="S::belaids@upmc.edu::5dcb4cf5-c058-49ea-93f8-4f4e6c877fcd" providerId="AD" clId="Web-{CC719679-0353-1A45-E175-85B512CCE0FA}" dt="2024-12-12T16:53:41.404" v="81" actId="20577"/>
        <pc:sldMkLst>
          <pc:docMk/>
          <pc:sldMk cId="200882343" sldId="389"/>
        </pc:sldMkLst>
        <pc:spChg chg="mod">
          <ac:chgData name="Belaid, Sirine" userId="S::belaids@upmc.edu::5dcb4cf5-c058-49ea-93f8-4f4e6c877fcd" providerId="AD" clId="Web-{CC719679-0353-1A45-E175-85B512CCE0FA}" dt="2024-12-12T16:53:41.404" v="81" actId="20577"/>
          <ac:spMkLst>
            <pc:docMk/>
            <pc:sldMk cId="200882343" sldId="389"/>
            <ac:spMk id="20" creationId="{54F9B086-14EA-1CB9-B537-BE83DDEBDC33}"/>
          </ac:spMkLst>
        </pc:spChg>
      </pc:sldChg>
      <pc:sldChg chg="modSp">
        <pc:chgData name="Belaid, Sirine" userId="S::belaids@upmc.edu::5dcb4cf5-c058-49ea-93f8-4f4e6c877fcd" providerId="AD" clId="Web-{CC719679-0353-1A45-E175-85B512CCE0FA}" dt="2024-12-12T20:25:38.655" v="288" actId="20577"/>
        <pc:sldMkLst>
          <pc:docMk/>
          <pc:sldMk cId="412412650" sldId="391"/>
        </pc:sldMkLst>
        <pc:spChg chg="mod">
          <ac:chgData name="Belaid, Sirine" userId="S::belaids@upmc.edu::5dcb4cf5-c058-49ea-93f8-4f4e6c877fcd" providerId="AD" clId="Web-{CC719679-0353-1A45-E175-85B512CCE0FA}" dt="2024-12-12T20:25:38.655" v="288" actId="20577"/>
          <ac:spMkLst>
            <pc:docMk/>
            <pc:sldMk cId="412412650" sldId="391"/>
            <ac:spMk id="3" creationId="{58D555CA-A0A4-BD5A-C7A5-51D39BF63446}"/>
          </ac:spMkLst>
        </pc:spChg>
        <pc:spChg chg="mod">
          <ac:chgData name="Belaid, Sirine" userId="S::belaids@upmc.edu::5dcb4cf5-c058-49ea-93f8-4f4e6c877fcd" providerId="AD" clId="Web-{CC719679-0353-1A45-E175-85B512CCE0FA}" dt="2024-12-12T18:55:05.956" v="181" actId="1076"/>
          <ac:spMkLst>
            <pc:docMk/>
            <pc:sldMk cId="412412650" sldId="391"/>
            <ac:spMk id="4" creationId="{0C4DFA9F-D5D8-418D-6708-4B57D7393503}"/>
          </ac:spMkLst>
        </pc:spChg>
        <pc:spChg chg="mod">
          <ac:chgData name="Belaid, Sirine" userId="S::belaids@upmc.edu::5dcb4cf5-c058-49ea-93f8-4f4e6c877fcd" providerId="AD" clId="Web-{CC719679-0353-1A45-E175-85B512CCE0FA}" dt="2024-12-12T18:55:17.909" v="184" actId="1076"/>
          <ac:spMkLst>
            <pc:docMk/>
            <pc:sldMk cId="412412650" sldId="391"/>
            <ac:spMk id="5" creationId="{D812EF7D-4702-057B-A538-96ABF815087F}"/>
          </ac:spMkLst>
        </pc:spChg>
      </pc:sldChg>
      <pc:sldChg chg="modSp">
        <pc:chgData name="Belaid, Sirine" userId="S::belaids@upmc.edu::5dcb4cf5-c058-49ea-93f8-4f4e6c877fcd" providerId="AD" clId="Web-{CC719679-0353-1A45-E175-85B512CCE0FA}" dt="2024-12-12T20:59:16.678" v="449" actId="20577"/>
        <pc:sldMkLst>
          <pc:docMk/>
          <pc:sldMk cId="1731714019" sldId="393"/>
        </pc:sldMkLst>
        <pc:spChg chg="mod">
          <ac:chgData name="Belaid, Sirine" userId="S::belaids@upmc.edu::5dcb4cf5-c058-49ea-93f8-4f4e6c877fcd" providerId="AD" clId="Web-{CC719679-0353-1A45-E175-85B512CCE0FA}" dt="2024-12-12T20:59:16.678" v="449" actId="20577"/>
          <ac:spMkLst>
            <pc:docMk/>
            <pc:sldMk cId="1731714019" sldId="393"/>
            <ac:spMk id="3" creationId="{4A01C084-E4E4-6950-077A-5C215D5C06BE}"/>
          </ac:spMkLst>
        </pc:spChg>
      </pc:sldChg>
      <pc:sldChg chg="addSp delSp modSp add replId">
        <pc:chgData name="Belaid, Sirine" userId="S::belaids@upmc.edu::5dcb4cf5-c058-49ea-93f8-4f4e6c877fcd" providerId="AD" clId="Web-{CC719679-0353-1A45-E175-85B512CCE0FA}" dt="2024-12-12T16:40:23.135" v="16" actId="1076"/>
        <pc:sldMkLst>
          <pc:docMk/>
          <pc:sldMk cId="1807703115" sldId="400"/>
        </pc:sldMkLst>
        <pc:spChg chg="mod">
          <ac:chgData name="Belaid, Sirine" userId="S::belaids@upmc.edu::5dcb4cf5-c058-49ea-93f8-4f4e6c877fcd" providerId="AD" clId="Web-{CC719679-0353-1A45-E175-85B512CCE0FA}" dt="2024-12-12T16:40:23.135" v="16" actId="1076"/>
          <ac:spMkLst>
            <pc:docMk/>
            <pc:sldMk cId="1807703115" sldId="400"/>
            <ac:spMk id="2" creationId="{1E63AA7C-D8CC-24E2-1927-C63C14BF6FAB}"/>
          </ac:spMkLst>
        </pc:spChg>
        <pc:spChg chg="del">
          <ac:chgData name="Belaid, Sirine" userId="S::belaids@upmc.edu::5dcb4cf5-c058-49ea-93f8-4f4e6c877fcd" providerId="AD" clId="Web-{CC719679-0353-1A45-E175-85B512CCE0FA}" dt="2024-12-12T16:40:07.431" v="12"/>
          <ac:spMkLst>
            <pc:docMk/>
            <pc:sldMk cId="1807703115" sldId="400"/>
            <ac:spMk id="3" creationId="{6B57145F-A3D4-5C8F-5BBE-CC4E7BC1E90B}"/>
          </ac:spMkLst>
        </pc:spChg>
        <pc:spChg chg="add del mod">
          <ac:chgData name="Belaid, Sirine" userId="S::belaids@upmc.edu::5dcb4cf5-c058-49ea-93f8-4f4e6c877fcd" providerId="AD" clId="Web-{CC719679-0353-1A45-E175-85B512CCE0FA}" dt="2024-12-12T16:40:11.853" v="14"/>
          <ac:spMkLst>
            <pc:docMk/>
            <pc:sldMk cId="1807703115" sldId="400"/>
            <ac:spMk id="5" creationId="{FD47110A-07C7-8DEF-AFDC-6279C774F282}"/>
          </ac:spMkLst>
        </pc:spChg>
      </pc:sldChg>
      <pc:sldChg chg="modSp new">
        <pc:chgData name="Belaid, Sirine" userId="S::belaids@upmc.edu::5dcb4cf5-c058-49ea-93f8-4f4e6c877fcd" providerId="AD" clId="Web-{CC719679-0353-1A45-E175-85B512CCE0FA}" dt="2024-12-12T19:00:10.286" v="210" actId="20577"/>
        <pc:sldMkLst>
          <pc:docMk/>
          <pc:sldMk cId="1711055037" sldId="401"/>
        </pc:sldMkLst>
        <pc:spChg chg="mod">
          <ac:chgData name="Belaid, Sirine" userId="S::belaids@upmc.edu::5dcb4cf5-c058-49ea-93f8-4f4e6c877fcd" providerId="AD" clId="Web-{CC719679-0353-1A45-E175-85B512CCE0FA}" dt="2024-12-12T18:55:32.629" v="192" actId="20577"/>
          <ac:spMkLst>
            <pc:docMk/>
            <pc:sldMk cId="1711055037" sldId="401"/>
            <ac:spMk id="2" creationId="{D6611131-E80D-221F-0518-F063E22D7C00}"/>
          </ac:spMkLst>
        </pc:spChg>
        <pc:spChg chg="mod">
          <ac:chgData name="Belaid, Sirine" userId="S::belaids@upmc.edu::5dcb4cf5-c058-49ea-93f8-4f4e6c877fcd" providerId="AD" clId="Web-{CC719679-0353-1A45-E175-85B512CCE0FA}" dt="2024-12-12T19:00:10.286" v="210" actId="20577"/>
          <ac:spMkLst>
            <pc:docMk/>
            <pc:sldMk cId="1711055037" sldId="401"/>
            <ac:spMk id="3" creationId="{A954158A-E692-9D38-448A-CBA2603BCC28}"/>
          </ac:spMkLst>
        </pc:spChg>
      </pc:sldChg>
      <pc:sldChg chg="addSp delSp modSp new ord modNotes">
        <pc:chgData name="Belaid, Sirine" userId="S::belaids@upmc.edu::5dcb4cf5-c058-49ea-93f8-4f4e6c877fcd" providerId="AD" clId="Web-{CC719679-0353-1A45-E175-85B512CCE0FA}" dt="2024-12-12T20:44:33.241" v="370"/>
        <pc:sldMkLst>
          <pc:docMk/>
          <pc:sldMk cId="4125576382" sldId="402"/>
        </pc:sldMkLst>
        <pc:spChg chg="mod">
          <ac:chgData name="Belaid, Sirine" userId="S::belaids@upmc.edu::5dcb4cf5-c058-49ea-93f8-4f4e6c877fcd" providerId="AD" clId="Web-{CC719679-0353-1A45-E175-85B512CCE0FA}" dt="2024-12-12T19:50:54.508" v="248" actId="1076"/>
          <ac:spMkLst>
            <pc:docMk/>
            <pc:sldMk cId="4125576382" sldId="402"/>
            <ac:spMk id="2" creationId="{31925F4E-5E30-00A5-9B04-38C836E65924}"/>
          </ac:spMkLst>
        </pc:spChg>
        <pc:spChg chg="del mod">
          <ac:chgData name="Belaid, Sirine" userId="S::belaids@upmc.edu::5dcb4cf5-c058-49ea-93f8-4f4e6c877fcd" providerId="AD" clId="Web-{CC719679-0353-1A45-E175-85B512CCE0FA}" dt="2024-12-12T19:50:41.039" v="243"/>
          <ac:spMkLst>
            <pc:docMk/>
            <pc:sldMk cId="4125576382" sldId="402"/>
            <ac:spMk id="3" creationId="{52103BFE-51D2-A3AD-1E9F-E67A3ABF7785}"/>
          </ac:spMkLst>
        </pc:spChg>
        <pc:spChg chg="add del mod">
          <ac:chgData name="Belaid, Sirine" userId="S::belaids@upmc.edu::5dcb4cf5-c058-49ea-93f8-4f4e6c877fcd" providerId="AD" clId="Web-{CC719679-0353-1A45-E175-85B512CCE0FA}" dt="2024-12-12T19:50:43.398" v="244"/>
          <ac:spMkLst>
            <pc:docMk/>
            <pc:sldMk cId="4125576382" sldId="402"/>
            <ac:spMk id="6" creationId="{5333FC84-63E8-3437-7FE1-386EC0FA66CC}"/>
          </ac:spMkLst>
        </pc:spChg>
        <pc:picChg chg="add mod">
          <ac:chgData name="Belaid, Sirine" userId="S::belaids@upmc.edu::5dcb4cf5-c058-49ea-93f8-4f4e6c877fcd" providerId="AD" clId="Web-{CC719679-0353-1A45-E175-85B512CCE0FA}" dt="2024-12-12T19:50:50.586" v="247" actId="1076"/>
          <ac:picMkLst>
            <pc:docMk/>
            <pc:sldMk cId="4125576382" sldId="402"/>
            <ac:picMk id="4" creationId="{095C874A-45CB-3C70-46DB-FAC03429737C}"/>
          </ac:picMkLst>
        </pc:picChg>
      </pc:sldChg>
      <pc:sldChg chg="addSp delSp modSp new mod ord setBg modNotes">
        <pc:chgData name="Belaid, Sirine" userId="S::belaids@upmc.edu::5dcb4cf5-c058-49ea-93f8-4f4e6c877fcd" providerId="AD" clId="Web-{CC719679-0353-1A45-E175-85B512CCE0FA}" dt="2024-12-12T20:54:06.339" v="440" actId="1076"/>
        <pc:sldMkLst>
          <pc:docMk/>
          <pc:sldMk cId="3969654780" sldId="403"/>
        </pc:sldMkLst>
        <pc:spChg chg="add mod">
          <ac:chgData name="Belaid, Sirine" userId="S::belaids@upmc.edu::5dcb4cf5-c058-49ea-93f8-4f4e6c877fcd" providerId="AD" clId="Web-{CC719679-0353-1A45-E175-85B512CCE0FA}" dt="2024-12-12T20:51:48.334" v="423" actId="14100"/>
          <ac:spMkLst>
            <pc:docMk/>
            <pc:sldMk cId="3969654780" sldId="403"/>
            <ac:spMk id="4" creationId="{5EAD482C-EFF1-44CF-B54A-758B79606F3D}"/>
          </ac:spMkLst>
        </pc:spChg>
        <pc:spChg chg="add mod">
          <ac:chgData name="Belaid, Sirine" userId="S::belaids@upmc.edu::5dcb4cf5-c058-49ea-93f8-4f4e6c877fcd" providerId="AD" clId="Web-{CC719679-0353-1A45-E175-85B512CCE0FA}" dt="2024-12-12T20:53:19.994" v="432" actId="14100"/>
          <ac:spMkLst>
            <pc:docMk/>
            <pc:sldMk cId="3969654780" sldId="403"/>
            <ac:spMk id="5" creationId="{8D4F7496-950C-05BB-173A-4A3A5F9FA2C7}"/>
          </ac:spMkLst>
        </pc:spChg>
        <pc:spChg chg="add mod">
          <ac:chgData name="Belaid, Sirine" userId="S::belaids@upmc.edu::5dcb4cf5-c058-49ea-93f8-4f4e6c877fcd" providerId="AD" clId="Web-{CC719679-0353-1A45-E175-85B512CCE0FA}" dt="2024-12-12T20:51:13.099" v="417" actId="14100"/>
          <ac:spMkLst>
            <pc:docMk/>
            <pc:sldMk cId="3969654780" sldId="403"/>
            <ac:spMk id="6" creationId="{5057A5BE-BD8B-C01A-153D-C0F08300E901}"/>
          </ac:spMkLst>
        </pc:spChg>
        <pc:spChg chg="add mod">
          <ac:chgData name="Belaid, Sirine" userId="S::belaids@upmc.edu::5dcb4cf5-c058-49ea-93f8-4f4e6c877fcd" providerId="AD" clId="Web-{CC719679-0353-1A45-E175-85B512CCE0FA}" dt="2024-12-12T20:52:36.617" v="428" actId="14100"/>
          <ac:spMkLst>
            <pc:docMk/>
            <pc:sldMk cId="3969654780" sldId="403"/>
            <ac:spMk id="7" creationId="{26615FD8-CA50-94EA-8204-2318FD048A44}"/>
          </ac:spMkLst>
        </pc:spChg>
        <pc:spChg chg="add mod">
          <ac:chgData name="Belaid, Sirine" userId="S::belaids@upmc.edu::5dcb4cf5-c058-49ea-93f8-4f4e6c877fcd" providerId="AD" clId="Web-{CC719679-0353-1A45-E175-85B512CCE0FA}" dt="2024-12-12T20:54:06.339" v="440" actId="1076"/>
          <ac:spMkLst>
            <pc:docMk/>
            <pc:sldMk cId="3969654780" sldId="403"/>
            <ac:spMk id="8" creationId="{3F10592F-F6BB-225D-4660-61DB248C111B}"/>
          </ac:spMkLst>
        </pc:spChg>
        <pc:picChg chg="add mod">
          <ac:chgData name="Belaid, Sirine" userId="S::belaids@upmc.edu::5dcb4cf5-c058-49ea-93f8-4f4e6c877fcd" providerId="AD" clId="Web-{CC719679-0353-1A45-E175-85B512CCE0FA}" dt="2024-12-12T20:54:00.761" v="439" actId="1076"/>
          <ac:picMkLst>
            <pc:docMk/>
            <pc:sldMk cId="3969654780" sldId="403"/>
            <ac:picMk id="2" creationId="{A39918D0-1548-2AC8-502B-16B34FC8317D}"/>
          </ac:picMkLst>
        </pc:picChg>
        <pc:picChg chg="add del mod">
          <ac:chgData name="Belaid, Sirine" userId="S::belaids@upmc.edu::5dcb4cf5-c058-49ea-93f8-4f4e6c877fcd" providerId="AD" clId="Web-{CC719679-0353-1A45-E175-85B512CCE0FA}" dt="2024-12-12T20:42:03.220" v="346"/>
          <ac:picMkLst>
            <pc:docMk/>
            <pc:sldMk cId="3969654780" sldId="403"/>
            <ac:picMk id="3" creationId="{7A332E93-E033-B922-1F2E-5FE5DCD9A9A1}"/>
          </ac:picMkLst>
        </pc:picChg>
      </pc:sldChg>
      <pc:sldChg chg="addSp delSp modSp new mod setBg">
        <pc:chgData name="Belaid, Sirine" userId="S::belaids@upmc.edu::5dcb4cf5-c058-49ea-93f8-4f4e6c877fcd" providerId="AD" clId="Web-{CC719679-0353-1A45-E175-85B512CCE0FA}" dt="2024-12-12T20:59:36.507" v="451" actId="14100"/>
        <pc:sldMkLst>
          <pc:docMk/>
          <pc:sldMk cId="2372464141" sldId="404"/>
        </pc:sldMkLst>
        <pc:spChg chg="add mod">
          <ac:chgData name="Belaid, Sirine" userId="S::belaids@upmc.edu::5dcb4cf5-c058-49ea-93f8-4f4e6c877fcd" providerId="AD" clId="Web-{CC719679-0353-1A45-E175-85B512CCE0FA}" dt="2024-12-12T20:59:27.647" v="450" actId="1076"/>
          <ac:spMkLst>
            <pc:docMk/>
            <pc:sldMk cId="2372464141" sldId="404"/>
            <ac:spMk id="3" creationId="{4DC55ADC-1479-2E5C-058A-BAFDD97A0881}"/>
          </ac:spMkLst>
        </pc:spChg>
        <pc:spChg chg="add mod">
          <ac:chgData name="Belaid, Sirine" userId="S::belaids@upmc.edu::5dcb4cf5-c058-49ea-93f8-4f4e6c877fcd" providerId="AD" clId="Web-{CC719679-0353-1A45-E175-85B512CCE0FA}" dt="2024-12-12T20:59:36.507" v="451" actId="14100"/>
          <ac:spMkLst>
            <pc:docMk/>
            <pc:sldMk cId="2372464141" sldId="404"/>
            <ac:spMk id="4" creationId="{9A0FB527-D21C-7270-2B49-D54936E79F4C}"/>
          </ac:spMkLst>
        </pc:spChg>
        <pc:spChg chg="add mod">
          <ac:chgData name="Belaid, Sirine" userId="S::belaids@upmc.edu::5dcb4cf5-c058-49ea-93f8-4f4e6c877fcd" providerId="AD" clId="Web-{CC719679-0353-1A45-E175-85B512CCE0FA}" dt="2024-12-12T20:45:24.540" v="374" actId="14100"/>
          <ac:spMkLst>
            <pc:docMk/>
            <pc:sldMk cId="2372464141" sldId="404"/>
            <ac:spMk id="5" creationId="{447BDD9D-1C0A-27C1-3C5E-632E14C64BD1}"/>
          </ac:spMkLst>
        </pc:spChg>
        <pc:spChg chg="add mod">
          <ac:chgData name="Belaid, Sirine" userId="S::belaids@upmc.edu::5dcb4cf5-c058-49ea-93f8-4f4e6c877fcd" providerId="AD" clId="Web-{CC719679-0353-1A45-E175-85B512CCE0FA}" dt="2024-12-12T20:45:37.181" v="377" actId="14100"/>
          <ac:spMkLst>
            <pc:docMk/>
            <pc:sldMk cId="2372464141" sldId="404"/>
            <ac:spMk id="6" creationId="{80FD8CA4-8927-C765-1A84-CD94410A8ABF}"/>
          </ac:spMkLst>
        </pc:spChg>
        <pc:spChg chg="add del">
          <ac:chgData name="Belaid, Sirine" userId="S::belaids@upmc.edu::5dcb4cf5-c058-49ea-93f8-4f4e6c877fcd" providerId="AD" clId="Web-{CC719679-0353-1A45-E175-85B512CCE0FA}" dt="2024-12-12T20:42:25.752" v="351"/>
          <ac:spMkLst>
            <pc:docMk/>
            <pc:sldMk cId="2372464141" sldId="404"/>
            <ac:spMk id="7" creationId="{42A4FC2C-047E-45A5-965D-8E1E3BF09BC6}"/>
          </ac:spMkLst>
        </pc:spChg>
        <pc:spChg chg="add del">
          <ac:chgData name="Belaid, Sirine" userId="S::belaids@upmc.edu::5dcb4cf5-c058-49ea-93f8-4f4e6c877fcd" providerId="AD" clId="Web-{CC719679-0353-1A45-E175-85B512CCE0FA}" dt="2024-12-12T20:42:28.065" v="353"/>
          <ac:spMkLst>
            <pc:docMk/>
            <pc:sldMk cId="2372464141" sldId="404"/>
            <ac:spMk id="9" creationId="{83C98ABE-055B-441F-B07E-44F97F083C39}"/>
          </ac:spMkLst>
        </pc:spChg>
        <pc:spChg chg="add del">
          <ac:chgData name="Belaid, Sirine" userId="S::belaids@upmc.edu::5dcb4cf5-c058-49ea-93f8-4f4e6c877fcd" providerId="AD" clId="Web-{CC719679-0353-1A45-E175-85B512CCE0FA}" dt="2024-12-12T20:42:28.065" v="353"/>
          <ac:spMkLst>
            <pc:docMk/>
            <pc:sldMk cId="2372464141" sldId="404"/>
            <ac:spMk id="10" creationId="{F3060C83-F051-4F0E-ABAD-AA0DFC48B218}"/>
          </ac:spMkLst>
        </pc:spChg>
        <pc:spChg chg="add del">
          <ac:chgData name="Belaid, Sirine" userId="S::belaids@upmc.edu::5dcb4cf5-c058-49ea-93f8-4f4e6c877fcd" providerId="AD" clId="Web-{CC719679-0353-1A45-E175-85B512CCE0FA}" dt="2024-12-12T20:42:28.065" v="353"/>
          <ac:spMkLst>
            <pc:docMk/>
            <pc:sldMk cId="2372464141" sldId="404"/>
            <ac:spMk id="11" creationId="{29FDB030-9B49-4CED-8CCD-4D99382388AC}"/>
          </ac:spMkLst>
        </pc:spChg>
        <pc:spChg chg="add del">
          <ac:chgData name="Belaid, Sirine" userId="S::belaids@upmc.edu::5dcb4cf5-c058-49ea-93f8-4f4e6c877fcd" providerId="AD" clId="Web-{CC719679-0353-1A45-E175-85B512CCE0FA}" dt="2024-12-12T20:42:28.065" v="353"/>
          <ac:spMkLst>
            <pc:docMk/>
            <pc:sldMk cId="2372464141" sldId="404"/>
            <ac:spMk id="13" creationId="{3783CA14-24A1-485C-8B30-D6A5D87987AD}"/>
          </ac:spMkLst>
        </pc:spChg>
        <pc:spChg chg="add del">
          <ac:chgData name="Belaid, Sirine" userId="S::belaids@upmc.edu::5dcb4cf5-c058-49ea-93f8-4f4e6c877fcd" providerId="AD" clId="Web-{CC719679-0353-1A45-E175-85B512CCE0FA}" dt="2024-12-12T20:42:28.065" v="353"/>
          <ac:spMkLst>
            <pc:docMk/>
            <pc:sldMk cId="2372464141" sldId="404"/>
            <ac:spMk id="15" creationId="{9A97C86A-04D6-40F7-AE84-31AB43E6A846}"/>
          </ac:spMkLst>
        </pc:spChg>
        <pc:spChg chg="add del">
          <ac:chgData name="Belaid, Sirine" userId="S::belaids@upmc.edu::5dcb4cf5-c058-49ea-93f8-4f4e6c877fcd" providerId="AD" clId="Web-{CC719679-0353-1A45-E175-85B512CCE0FA}" dt="2024-12-12T20:42:28.065" v="353"/>
          <ac:spMkLst>
            <pc:docMk/>
            <pc:sldMk cId="2372464141" sldId="404"/>
            <ac:spMk id="17" creationId="{FF9F2414-84E8-453E-B1F3-389FDE8192D9}"/>
          </ac:spMkLst>
        </pc:spChg>
        <pc:spChg chg="add del">
          <ac:chgData name="Belaid, Sirine" userId="S::belaids@upmc.edu::5dcb4cf5-c058-49ea-93f8-4f4e6c877fcd" providerId="AD" clId="Web-{CC719679-0353-1A45-E175-85B512CCE0FA}" dt="2024-12-12T20:42:28.065" v="353"/>
          <ac:spMkLst>
            <pc:docMk/>
            <pc:sldMk cId="2372464141" sldId="404"/>
            <ac:spMk id="19" creationId="{3ECA69A1-7536-43AC-85EF-C7106179F5ED}"/>
          </ac:spMkLst>
        </pc:spChg>
        <pc:picChg chg="add mod">
          <ac:chgData name="Belaid, Sirine" userId="S::belaids@upmc.edu::5dcb4cf5-c058-49ea-93f8-4f4e6c877fcd" providerId="AD" clId="Web-{CC719679-0353-1A45-E175-85B512CCE0FA}" dt="2024-12-12T20:55:39.608" v="441" actId="14100"/>
          <ac:picMkLst>
            <pc:docMk/>
            <pc:sldMk cId="2372464141" sldId="404"/>
            <ac:picMk id="2" creationId="{877DECD5-9B38-55E8-C4CA-3DA907C0CDCB}"/>
          </ac:picMkLst>
        </pc:picChg>
      </pc:sldChg>
      <pc:sldChg chg="addSp modSp new">
        <pc:chgData name="Belaid, Sirine" userId="S::belaids@upmc.edu::5dcb4cf5-c058-49ea-93f8-4f4e6c877fcd" providerId="AD" clId="Web-{CC719679-0353-1A45-E175-85B512CCE0FA}" dt="2024-12-12T21:10:14.154" v="477" actId="1076"/>
        <pc:sldMkLst>
          <pc:docMk/>
          <pc:sldMk cId="1389029600" sldId="405"/>
        </pc:sldMkLst>
        <pc:spChg chg="add mod">
          <ac:chgData name="Belaid, Sirine" userId="S::belaids@upmc.edu::5dcb4cf5-c058-49ea-93f8-4f4e6c877fcd" providerId="AD" clId="Web-{CC719679-0353-1A45-E175-85B512CCE0FA}" dt="2024-12-12T21:10:14.154" v="477" actId="1076"/>
          <ac:spMkLst>
            <pc:docMk/>
            <pc:sldMk cId="1389029600" sldId="405"/>
            <ac:spMk id="4" creationId="{97881B49-F9A6-7533-A2CD-64DD2A7C8445}"/>
          </ac:spMkLst>
        </pc:spChg>
        <pc:picChg chg="add mod">
          <ac:chgData name="Belaid, Sirine" userId="S::belaids@upmc.edu::5dcb4cf5-c058-49ea-93f8-4f4e6c877fcd" providerId="AD" clId="Web-{CC719679-0353-1A45-E175-85B512CCE0FA}" dt="2024-12-12T21:10:04.263" v="474" actId="1076"/>
          <ac:picMkLst>
            <pc:docMk/>
            <pc:sldMk cId="1389029600" sldId="405"/>
            <ac:picMk id="3" creationId="{40D24A7C-18C6-A7BE-190E-6FA7C07D8351}"/>
          </ac:picMkLst>
        </pc:picChg>
      </pc:sldChg>
      <pc:sldChg chg="add replId">
        <pc:chgData name="Belaid, Sirine" userId="S::belaids@upmc.edu::5dcb4cf5-c058-49ea-93f8-4f4e6c877fcd" providerId="AD" clId="Web-{CC719679-0353-1A45-E175-85B512CCE0FA}" dt="2024-12-12T21:11:13.609" v="478"/>
        <pc:sldMkLst>
          <pc:docMk/>
          <pc:sldMk cId="4257167352" sldId="406"/>
        </pc:sldMkLst>
      </pc:sldChg>
    </pc:docChg>
  </pc:docChgLst>
  <pc:docChgLst>
    <pc:chgData name="Belaid, Sirine" userId="S::belaids@upmc.edu::5dcb4cf5-c058-49ea-93f8-4f4e6c877fcd" providerId="AD" clId="Web-{0B02AF87-38A3-0D39-8FB3-31B36863DE92}"/>
    <pc:docChg chg="addSld modSld sldOrd">
      <pc:chgData name="Belaid, Sirine" userId="S::belaids@upmc.edu::5dcb4cf5-c058-49ea-93f8-4f4e6c877fcd" providerId="AD" clId="Web-{0B02AF87-38A3-0D39-8FB3-31B36863DE92}" dt="2024-12-11T18:41:47.909" v="2161"/>
      <pc:docMkLst>
        <pc:docMk/>
      </pc:docMkLst>
      <pc:sldChg chg="modSp">
        <pc:chgData name="Belaid, Sirine" userId="S::belaids@upmc.edu::5dcb4cf5-c058-49ea-93f8-4f4e6c877fcd" providerId="AD" clId="Web-{0B02AF87-38A3-0D39-8FB3-31B36863DE92}" dt="2024-12-11T14:32:49.758" v="1513" actId="20577"/>
        <pc:sldMkLst>
          <pc:docMk/>
          <pc:sldMk cId="109857222" sldId="256"/>
        </pc:sldMkLst>
        <pc:spChg chg="mod">
          <ac:chgData name="Belaid, Sirine" userId="S::belaids@upmc.edu::5dcb4cf5-c058-49ea-93f8-4f4e6c877fcd" providerId="AD" clId="Web-{0B02AF87-38A3-0D39-8FB3-31B36863DE92}" dt="2024-12-11T14:32:24.741" v="1493" actId="20577"/>
          <ac:spMkLst>
            <pc:docMk/>
            <pc:sldMk cId="109857222" sldId="256"/>
            <ac:spMk id="2" creationId="{00000000-0000-0000-0000-000000000000}"/>
          </ac:spMkLst>
        </pc:spChg>
        <pc:spChg chg="mod">
          <ac:chgData name="Belaid, Sirine" userId="S::belaids@upmc.edu::5dcb4cf5-c058-49ea-93f8-4f4e6c877fcd" providerId="AD" clId="Web-{0B02AF87-38A3-0D39-8FB3-31B36863DE92}" dt="2024-12-11T14:32:49.758" v="1513" actId="20577"/>
          <ac:spMkLst>
            <pc:docMk/>
            <pc:sldMk cId="109857222" sldId="256"/>
            <ac:spMk id="3" creationId="{00000000-0000-0000-0000-000000000000}"/>
          </ac:spMkLst>
        </pc:spChg>
      </pc:sldChg>
      <pc:sldChg chg="modSp">
        <pc:chgData name="Belaid, Sirine" userId="S::belaids@upmc.edu::5dcb4cf5-c058-49ea-93f8-4f4e6c877fcd" providerId="AD" clId="Web-{0B02AF87-38A3-0D39-8FB3-31B36863DE92}" dt="2024-12-11T14:50:39.969" v="1600" actId="20577"/>
        <pc:sldMkLst>
          <pc:docMk/>
          <pc:sldMk cId="1491156070" sldId="257"/>
        </pc:sldMkLst>
        <pc:spChg chg="mod">
          <ac:chgData name="Belaid, Sirine" userId="S::belaids@upmc.edu::5dcb4cf5-c058-49ea-93f8-4f4e6c877fcd" providerId="AD" clId="Web-{0B02AF87-38A3-0D39-8FB3-31B36863DE92}" dt="2024-12-11T14:50:39.969" v="1600" actId="20577"/>
          <ac:spMkLst>
            <pc:docMk/>
            <pc:sldMk cId="1491156070" sldId="257"/>
            <ac:spMk id="3" creationId="{283F0732-6ED3-A107-57EE-B45417AADBF0}"/>
          </ac:spMkLst>
        </pc:spChg>
      </pc:sldChg>
      <pc:sldChg chg="modSp modNotes">
        <pc:chgData name="Belaid, Sirine" userId="S::belaids@upmc.edu::5dcb4cf5-c058-49ea-93f8-4f4e6c877fcd" providerId="AD" clId="Web-{0B02AF87-38A3-0D39-8FB3-31B36863DE92}" dt="2024-12-11T17:00:40.975" v="1908"/>
        <pc:sldMkLst>
          <pc:docMk/>
          <pc:sldMk cId="1500721348" sldId="258"/>
        </pc:sldMkLst>
        <pc:spChg chg="mod">
          <ac:chgData name="Belaid, Sirine" userId="S::belaids@upmc.edu::5dcb4cf5-c058-49ea-93f8-4f4e6c877fcd" providerId="AD" clId="Web-{0B02AF87-38A3-0D39-8FB3-31B36863DE92}" dt="2024-12-11T16:57:50.940" v="1893" actId="20577"/>
          <ac:spMkLst>
            <pc:docMk/>
            <pc:sldMk cId="1500721348" sldId="258"/>
            <ac:spMk id="3" creationId="{76CE0DDB-F694-7507-CAB6-43B4259BD94F}"/>
          </ac:spMkLst>
        </pc:spChg>
        <pc:spChg chg="mod">
          <ac:chgData name="Belaid, Sirine" userId="S::belaids@upmc.edu::5dcb4cf5-c058-49ea-93f8-4f4e6c877fcd" providerId="AD" clId="Web-{0B02AF87-38A3-0D39-8FB3-31B36863DE92}" dt="2024-12-10T02:38:52.340" v="103" actId="1076"/>
          <ac:spMkLst>
            <pc:docMk/>
            <pc:sldMk cId="1500721348" sldId="258"/>
            <ac:spMk id="4" creationId="{DD10D27F-5D79-A7D9-F80A-6BEDF78417AC}"/>
          </ac:spMkLst>
        </pc:spChg>
      </pc:sldChg>
      <pc:sldChg chg="modSp">
        <pc:chgData name="Belaid, Sirine" userId="S::belaids@upmc.edu::5dcb4cf5-c058-49ea-93f8-4f4e6c877fcd" providerId="AD" clId="Web-{0B02AF87-38A3-0D39-8FB3-31B36863DE92}" dt="2024-12-10T03:40:29.002" v="1134" actId="1076"/>
        <pc:sldMkLst>
          <pc:docMk/>
          <pc:sldMk cId="2334828839" sldId="280"/>
        </pc:sldMkLst>
        <pc:spChg chg="mod">
          <ac:chgData name="Belaid, Sirine" userId="S::belaids@upmc.edu::5dcb4cf5-c058-49ea-93f8-4f4e6c877fcd" providerId="AD" clId="Web-{0B02AF87-38A3-0D39-8FB3-31B36863DE92}" dt="2024-12-10T03:40:13.220" v="1132" actId="1076"/>
          <ac:spMkLst>
            <pc:docMk/>
            <pc:sldMk cId="2334828839" sldId="280"/>
            <ac:spMk id="2" creationId="{7B0CDAA9-25AE-B069-7EC7-77A005C3B358}"/>
          </ac:spMkLst>
        </pc:spChg>
        <pc:spChg chg="mod">
          <ac:chgData name="Belaid, Sirine" userId="S::belaids@upmc.edu::5dcb4cf5-c058-49ea-93f8-4f4e6c877fcd" providerId="AD" clId="Web-{0B02AF87-38A3-0D39-8FB3-31B36863DE92}" dt="2024-12-10T03:40:19.877" v="1133" actId="1076"/>
          <ac:spMkLst>
            <pc:docMk/>
            <pc:sldMk cId="2334828839" sldId="280"/>
            <ac:spMk id="4" creationId="{D1BCFB39-CF04-FACC-1188-03C1357FB1F6}"/>
          </ac:spMkLst>
        </pc:spChg>
        <pc:spChg chg="mod">
          <ac:chgData name="Belaid, Sirine" userId="S::belaids@upmc.edu::5dcb4cf5-c058-49ea-93f8-4f4e6c877fcd" providerId="AD" clId="Web-{0B02AF87-38A3-0D39-8FB3-31B36863DE92}" dt="2024-12-10T03:40:29.002" v="1134" actId="1076"/>
          <ac:spMkLst>
            <pc:docMk/>
            <pc:sldMk cId="2334828839" sldId="280"/>
            <ac:spMk id="8" creationId="{BB0D772D-D99B-C49D-9E5F-43EFC2F0F2CB}"/>
          </ac:spMkLst>
        </pc:spChg>
      </pc:sldChg>
      <pc:sldChg chg="modSp">
        <pc:chgData name="Belaid, Sirine" userId="S::belaids@upmc.edu::5dcb4cf5-c058-49ea-93f8-4f4e6c877fcd" providerId="AD" clId="Web-{0B02AF87-38A3-0D39-8FB3-31B36863DE92}" dt="2024-12-10T03:44:18.543" v="1208" actId="20577"/>
        <pc:sldMkLst>
          <pc:docMk/>
          <pc:sldMk cId="1811786192" sldId="281"/>
        </pc:sldMkLst>
        <pc:spChg chg="mod">
          <ac:chgData name="Belaid, Sirine" userId="S::belaids@upmc.edu::5dcb4cf5-c058-49ea-93f8-4f4e6c877fcd" providerId="AD" clId="Web-{0B02AF87-38A3-0D39-8FB3-31B36863DE92}" dt="2024-12-10T03:44:18.543" v="1208" actId="20577"/>
          <ac:spMkLst>
            <pc:docMk/>
            <pc:sldMk cId="1811786192" sldId="281"/>
            <ac:spMk id="3" creationId="{D68BC3AB-8ABB-9334-4030-19543AF9FAAE}"/>
          </ac:spMkLst>
        </pc:spChg>
      </pc:sldChg>
      <pc:sldChg chg="modSp">
        <pc:chgData name="Belaid, Sirine" userId="S::belaids@upmc.edu::5dcb4cf5-c058-49ea-93f8-4f4e6c877fcd" providerId="AD" clId="Web-{0B02AF87-38A3-0D39-8FB3-31B36863DE92}" dt="2024-12-10T03:27:47.113" v="996" actId="20577"/>
        <pc:sldMkLst>
          <pc:docMk/>
          <pc:sldMk cId="931904134" sldId="287"/>
        </pc:sldMkLst>
        <pc:spChg chg="mod">
          <ac:chgData name="Belaid, Sirine" userId="S::belaids@upmc.edu::5dcb4cf5-c058-49ea-93f8-4f4e6c877fcd" providerId="AD" clId="Web-{0B02AF87-38A3-0D39-8FB3-31B36863DE92}" dt="2024-12-10T03:27:47.113" v="996" actId="20577"/>
          <ac:spMkLst>
            <pc:docMk/>
            <pc:sldMk cId="931904134" sldId="287"/>
            <ac:spMk id="3" creationId="{3DB2B855-1F64-5184-A62B-BB64F2950C59}"/>
          </ac:spMkLst>
        </pc:spChg>
      </pc:sldChg>
      <pc:sldChg chg="modSp modNotes">
        <pc:chgData name="Belaid, Sirine" userId="S::belaids@upmc.edu::5dcb4cf5-c058-49ea-93f8-4f4e6c877fcd" providerId="AD" clId="Web-{0B02AF87-38A3-0D39-8FB3-31B36863DE92}" dt="2024-12-11T16:40:54.979" v="1845" actId="20577"/>
        <pc:sldMkLst>
          <pc:docMk/>
          <pc:sldMk cId="2064663832" sldId="288"/>
        </pc:sldMkLst>
        <pc:spChg chg="mod">
          <ac:chgData name="Belaid, Sirine" userId="S::belaids@upmc.edu::5dcb4cf5-c058-49ea-93f8-4f4e6c877fcd" providerId="AD" clId="Web-{0B02AF87-38A3-0D39-8FB3-31B36863DE92}" dt="2024-12-11T16:40:54.979" v="1845" actId="20577"/>
          <ac:spMkLst>
            <pc:docMk/>
            <pc:sldMk cId="2064663832" sldId="288"/>
            <ac:spMk id="4" creationId="{9FEA30E3-677C-4B49-0CA0-68676A816BFF}"/>
          </ac:spMkLst>
        </pc:spChg>
        <pc:picChg chg="mod">
          <ac:chgData name="Belaid, Sirine" userId="S::belaids@upmc.edu::5dcb4cf5-c058-49ea-93f8-4f4e6c877fcd" providerId="AD" clId="Web-{0B02AF87-38A3-0D39-8FB3-31B36863DE92}" dt="2024-12-11T16:30:26.590" v="1710" actId="1076"/>
          <ac:picMkLst>
            <pc:docMk/>
            <pc:sldMk cId="2064663832" sldId="288"/>
            <ac:picMk id="2" creationId="{D29F9914-125C-47D2-415A-9432AD406734}"/>
          </ac:picMkLst>
        </pc:picChg>
      </pc:sldChg>
      <pc:sldChg chg="modSp modNotes">
        <pc:chgData name="Belaid, Sirine" userId="S::belaids@upmc.edu::5dcb4cf5-c058-49ea-93f8-4f4e6c877fcd" providerId="AD" clId="Web-{0B02AF87-38A3-0D39-8FB3-31B36863DE92}" dt="2024-12-11T18:27:16.349" v="2086" actId="20577"/>
        <pc:sldMkLst>
          <pc:docMk/>
          <pc:sldMk cId="1403967867" sldId="289"/>
        </pc:sldMkLst>
        <pc:spChg chg="mod">
          <ac:chgData name="Belaid, Sirine" userId="S::belaids@upmc.edu::5dcb4cf5-c058-49ea-93f8-4f4e6c877fcd" providerId="AD" clId="Web-{0B02AF87-38A3-0D39-8FB3-31B36863DE92}" dt="2024-12-11T18:27:16.349" v="2086" actId="20577"/>
          <ac:spMkLst>
            <pc:docMk/>
            <pc:sldMk cId="1403967867" sldId="289"/>
            <ac:spMk id="6" creationId="{68292658-3663-6BA4-20A7-448B238A1793}"/>
          </ac:spMkLst>
        </pc:spChg>
      </pc:sldChg>
      <pc:sldChg chg="modSp">
        <pc:chgData name="Belaid, Sirine" userId="S::belaids@upmc.edu::5dcb4cf5-c058-49ea-93f8-4f4e6c877fcd" providerId="AD" clId="Web-{0B02AF87-38A3-0D39-8FB3-31B36863DE92}" dt="2024-12-11T16:44:07.984" v="1887" actId="20577"/>
        <pc:sldMkLst>
          <pc:docMk/>
          <pc:sldMk cId="1981928479" sldId="290"/>
        </pc:sldMkLst>
        <pc:spChg chg="mod">
          <ac:chgData name="Belaid, Sirine" userId="S::belaids@upmc.edu::5dcb4cf5-c058-49ea-93f8-4f4e6c877fcd" providerId="AD" clId="Web-{0B02AF87-38A3-0D39-8FB3-31B36863DE92}" dt="2024-12-11T16:44:07.984" v="1887" actId="20577"/>
          <ac:spMkLst>
            <pc:docMk/>
            <pc:sldMk cId="1981928479" sldId="290"/>
            <ac:spMk id="6" creationId="{C63AC20E-7038-E80A-DE5C-D04C25D8B883}"/>
          </ac:spMkLst>
        </pc:spChg>
      </pc:sldChg>
      <pc:sldChg chg="modNotes">
        <pc:chgData name="Belaid, Sirine" userId="S::belaids@upmc.edu::5dcb4cf5-c058-49ea-93f8-4f4e6c877fcd" providerId="AD" clId="Web-{0B02AF87-38A3-0D39-8FB3-31B36863DE92}" dt="2024-12-11T17:41:23.130" v="2080"/>
        <pc:sldMkLst>
          <pc:docMk/>
          <pc:sldMk cId="1575805153" sldId="291"/>
        </pc:sldMkLst>
      </pc:sldChg>
      <pc:sldChg chg="addSp delSp modSp">
        <pc:chgData name="Belaid, Sirine" userId="S::belaids@upmc.edu::5dcb4cf5-c058-49ea-93f8-4f4e6c877fcd" providerId="AD" clId="Web-{0B02AF87-38A3-0D39-8FB3-31B36863DE92}" dt="2024-12-10T03:05:05.684" v="730" actId="1076"/>
        <pc:sldMkLst>
          <pc:docMk/>
          <pc:sldMk cId="707447650" sldId="292"/>
        </pc:sldMkLst>
        <pc:spChg chg="mod">
          <ac:chgData name="Belaid, Sirine" userId="S::belaids@upmc.edu::5dcb4cf5-c058-49ea-93f8-4f4e6c877fcd" providerId="AD" clId="Web-{0B02AF87-38A3-0D39-8FB3-31B36863DE92}" dt="2024-12-10T03:04:59.824" v="729" actId="20577"/>
          <ac:spMkLst>
            <pc:docMk/>
            <pc:sldMk cId="707447650" sldId="292"/>
            <ac:spMk id="4" creationId="{16D5F698-1466-B30B-5CE7-AC93819EA30B}"/>
          </ac:spMkLst>
        </pc:spChg>
        <pc:picChg chg="del">
          <ac:chgData name="Belaid, Sirine" userId="S::belaids@upmc.edu::5dcb4cf5-c058-49ea-93f8-4f4e6c877fcd" providerId="AD" clId="Web-{0B02AF87-38A3-0D39-8FB3-31B36863DE92}" dt="2024-12-10T03:04:47.121" v="725"/>
          <ac:picMkLst>
            <pc:docMk/>
            <pc:sldMk cId="707447650" sldId="292"/>
            <ac:picMk id="2" creationId="{F5CD9B15-460F-21E8-6979-30102A6F2EA1}"/>
          </ac:picMkLst>
        </pc:picChg>
        <pc:picChg chg="del">
          <ac:chgData name="Belaid, Sirine" userId="S::belaids@upmc.edu::5dcb4cf5-c058-49ea-93f8-4f4e6c877fcd" providerId="AD" clId="Web-{0B02AF87-38A3-0D39-8FB3-31B36863DE92}" dt="2024-12-10T03:04:49.527" v="726"/>
          <ac:picMkLst>
            <pc:docMk/>
            <pc:sldMk cId="707447650" sldId="292"/>
            <ac:picMk id="3" creationId="{595D8CA0-EC01-5C10-7C2F-1674E932BC2B}"/>
          </ac:picMkLst>
        </pc:picChg>
        <pc:picChg chg="add mod">
          <ac:chgData name="Belaid, Sirine" userId="S::belaids@upmc.edu::5dcb4cf5-c058-49ea-93f8-4f4e6c877fcd" providerId="AD" clId="Web-{0B02AF87-38A3-0D39-8FB3-31B36863DE92}" dt="2024-12-10T03:05:05.684" v="730" actId="1076"/>
          <ac:picMkLst>
            <pc:docMk/>
            <pc:sldMk cId="707447650" sldId="292"/>
            <ac:picMk id="5" creationId="{79BFA588-BAB5-8037-DCDC-77CE5DF30BF9}"/>
          </ac:picMkLst>
        </pc:picChg>
      </pc:sldChg>
      <pc:sldChg chg="modSp modNotes">
        <pc:chgData name="Belaid, Sirine" userId="S::belaids@upmc.edu::5dcb4cf5-c058-49ea-93f8-4f4e6c877fcd" providerId="AD" clId="Web-{0B02AF87-38A3-0D39-8FB3-31B36863DE92}" dt="2024-12-10T03:08:07.847" v="781"/>
        <pc:sldMkLst>
          <pc:docMk/>
          <pc:sldMk cId="3765036932" sldId="351"/>
        </pc:sldMkLst>
        <pc:spChg chg="mod">
          <ac:chgData name="Belaid, Sirine" userId="S::belaids@upmc.edu::5dcb4cf5-c058-49ea-93f8-4f4e6c877fcd" providerId="AD" clId="Web-{0B02AF87-38A3-0D39-8FB3-31B36863DE92}" dt="2024-12-10T03:07:15.720" v="771" actId="20577"/>
          <ac:spMkLst>
            <pc:docMk/>
            <pc:sldMk cId="3765036932" sldId="351"/>
            <ac:spMk id="5" creationId="{A92B86F5-FF6F-56F7-A149-E75340027B3E}"/>
          </ac:spMkLst>
        </pc:spChg>
      </pc:sldChg>
      <pc:sldChg chg="modSp">
        <pc:chgData name="Belaid, Sirine" userId="S::belaids@upmc.edu::5dcb4cf5-c058-49ea-93f8-4f4e6c877fcd" providerId="AD" clId="Web-{0B02AF87-38A3-0D39-8FB3-31B36863DE92}" dt="2024-12-11T17:10:42.628" v="1956" actId="20577"/>
        <pc:sldMkLst>
          <pc:docMk/>
          <pc:sldMk cId="4094227945" sldId="352"/>
        </pc:sldMkLst>
        <pc:spChg chg="mod">
          <ac:chgData name="Belaid, Sirine" userId="S::belaids@upmc.edu::5dcb4cf5-c058-49ea-93f8-4f4e6c877fcd" providerId="AD" clId="Web-{0B02AF87-38A3-0D39-8FB3-31B36863DE92}" dt="2024-12-11T17:10:42.628" v="1956" actId="20577"/>
          <ac:spMkLst>
            <pc:docMk/>
            <pc:sldMk cId="4094227945" sldId="352"/>
            <ac:spMk id="3" creationId="{54D52FF0-F483-CAD8-917A-930506D4F12A}"/>
          </ac:spMkLst>
        </pc:spChg>
      </pc:sldChg>
      <pc:sldChg chg="modNotes">
        <pc:chgData name="Belaid, Sirine" userId="S::belaids@upmc.edu::5dcb4cf5-c058-49ea-93f8-4f4e6c877fcd" providerId="AD" clId="Web-{0B02AF87-38A3-0D39-8FB3-31B36863DE92}" dt="2024-12-11T17:41:30.755" v="2081"/>
        <pc:sldMkLst>
          <pc:docMk/>
          <pc:sldMk cId="449566489" sldId="354"/>
        </pc:sldMkLst>
      </pc:sldChg>
      <pc:sldChg chg="addSp delSp modSp">
        <pc:chgData name="Belaid, Sirine" userId="S::belaids@upmc.edu::5dcb4cf5-c058-49ea-93f8-4f4e6c877fcd" providerId="AD" clId="Web-{0B02AF87-38A3-0D39-8FB3-31B36863DE92}" dt="2024-12-11T18:30:25.292" v="2099" actId="20577"/>
        <pc:sldMkLst>
          <pc:docMk/>
          <pc:sldMk cId="1022786307" sldId="355"/>
        </pc:sldMkLst>
        <pc:spChg chg="mod">
          <ac:chgData name="Belaid, Sirine" userId="S::belaids@upmc.edu::5dcb4cf5-c058-49ea-93f8-4f4e6c877fcd" providerId="AD" clId="Web-{0B02AF87-38A3-0D39-8FB3-31B36863DE92}" dt="2024-12-10T17:47:05.243" v="1411" actId="1076"/>
          <ac:spMkLst>
            <pc:docMk/>
            <pc:sldMk cId="1022786307" sldId="355"/>
            <ac:spMk id="2" creationId="{0EDE86FA-127C-32B5-5E79-B776E06C8F1C}"/>
          </ac:spMkLst>
        </pc:spChg>
        <pc:spChg chg="mod">
          <ac:chgData name="Belaid, Sirine" userId="S::belaids@upmc.edu::5dcb4cf5-c058-49ea-93f8-4f4e6c877fcd" providerId="AD" clId="Web-{0B02AF87-38A3-0D39-8FB3-31B36863DE92}" dt="2024-12-11T18:30:25.292" v="2099" actId="20577"/>
          <ac:spMkLst>
            <pc:docMk/>
            <pc:sldMk cId="1022786307" sldId="355"/>
            <ac:spMk id="3" creationId="{1C74E49B-EF04-8C3D-7D26-98DBD002E7B7}"/>
          </ac:spMkLst>
        </pc:spChg>
        <pc:spChg chg="add del mod">
          <ac:chgData name="Belaid, Sirine" userId="S::belaids@upmc.edu::5dcb4cf5-c058-49ea-93f8-4f4e6c877fcd" providerId="AD" clId="Web-{0B02AF87-38A3-0D39-8FB3-31B36863DE92}" dt="2024-12-10T17:39:47.830" v="1376"/>
          <ac:spMkLst>
            <pc:docMk/>
            <pc:sldMk cId="1022786307" sldId="355"/>
            <ac:spMk id="4" creationId="{4F54D313-5C86-5F01-8A6C-79535B653BE2}"/>
          </ac:spMkLst>
        </pc:spChg>
        <pc:picChg chg="add del mod">
          <ac:chgData name="Belaid, Sirine" userId="S::belaids@upmc.edu::5dcb4cf5-c058-49ea-93f8-4f4e6c877fcd" providerId="AD" clId="Web-{0B02AF87-38A3-0D39-8FB3-31B36863DE92}" dt="2024-12-10T17:42:11.395" v="1403"/>
          <ac:picMkLst>
            <pc:docMk/>
            <pc:sldMk cId="1022786307" sldId="355"/>
            <ac:picMk id="5" creationId="{40F6F45F-286C-9670-F525-C774C91C8A79}"/>
          </ac:picMkLst>
        </pc:picChg>
        <pc:picChg chg="add del mod">
          <ac:chgData name="Belaid, Sirine" userId="S::belaids@upmc.edu::5dcb4cf5-c058-49ea-93f8-4f4e6c877fcd" providerId="AD" clId="Web-{0B02AF87-38A3-0D39-8FB3-31B36863DE92}" dt="2024-12-10T17:46:08.773" v="1406"/>
          <ac:picMkLst>
            <pc:docMk/>
            <pc:sldMk cId="1022786307" sldId="355"/>
            <ac:picMk id="6" creationId="{FDD57693-1E79-B6A0-F939-5DF3F840544F}"/>
          </ac:picMkLst>
        </pc:picChg>
      </pc:sldChg>
      <pc:sldChg chg="modSp">
        <pc:chgData name="Belaid, Sirine" userId="S::belaids@upmc.edu::5dcb4cf5-c058-49ea-93f8-4f4e6c877fcd" providerId="AD" clId="Web-{0B02AF87-38A3-0D39-8FB3-31B36863DE92}" dt="2024-12-10T03:10:35.822" v="848" actId="20577"/>
        <pc:sldMkLst>
          <pc:docMk/>
          <pc:sldMk cId="3868067760" sldId="357"/>
        </pc:sldMkLst>
        <pc:spChg chg="mod">
          <ac:chgData name="Belaid, Sirine" userId="S::belaids@upmc.edu::5dcb4cf5-c058-49ea-93f8-4f4e6c877fcd" providerId="AD" clId="Web-{0B02AF87-38A3-0D39-8FB3-31B36863DE92}" dt="2024-12-10T03:10:35.822" v="848" actId="20577"/>
          <ac:spMkLst>
            <pc:docMk/>
            <pc:sldMk cId="3868067760" sldId="357"/>
            <ac:spMk id="3" creationId="{C6C10584-5F60-48A3-BCF3-AF01322CF6C3}"/>
          </ac:spMkLst>
        </pc:spChg>
      </pc:sldChg>
      <pc:sldChg chg="modSp modNotes">
        <pc:chgData name="Belaid, Sirine" userId="S::belaids@upmc.edu::5dcb4cf5-c058-49ea-93f8-4f4e6c877fcd" providerId="AD" clId="Web-{0B02AF87-38A3-0D39-8FB3-31B36863DE92}" dt="2024-12-11T17:20:16.579" v="2059"/>
        <pc:sldMkLst>
          <pc:docMk/>
          <pc:sldMk cId="3825394227" sldId="358"/>
        </pc:sldMkLst>
        <pc:spChg chg="mod">
          <ac:chgData name="Belaid, Sirine" userId="S::belaids@upmc.edu::5dcb4cf5-c058-49ea-93f8-4f4e6c877fcd" providerId="AD" clId="Web-{0B02AF87-38A3-0D39-8FB3-31B36863DE92}" dt="2024-12-11T17:20:13.016" v="2058" actId="20577"/>
          <ac:spMkLst>
            <pc:docMk/>
            <pc:sldMk cId="3825394227" sldId="358"/>
            <ac:spMk id="3" creationId="{4974952F-AF49-DE12-B0DE-612B936EDA11}"/>
          </ac:spMkLst>
        </pc:spChg>
      </pc:sldChg>
      <pc:sldChg chg="modSp">
        <pc:chgData name="Belaid, Sirine" userId="S::belaids@upmc.edu::5dcb4cf5-c058-49ea-93f8-4f4e6c877fcd" providerId="AD" clId="Web-{0B02AF87-38A3-0D39-8FB3-31B36863DE92}" dt="2024-12-10T03:45:18.654" v="1210" actId="14100"/>
        <pc:sldMkLst>
          <pc:docMk/>
          <pc:sldMk cId="1919480477" sldId="360"/>
        </pc:sldMkLst>
        <pc:spChg chg="mod">
          <ac:chgData name="Belaid, Sirine" userId="S::belaids@upmc.edu::5dcb4cf5-c058-49ea-93f8-4f4e6c877fcd" providerId="AD" clId="Web-{0B02AF87-38A3-0D39-8FB3-31B36863DE92}" dt="2024-12-10T03:24:09.167" v="937" actId="1076"/>
          <ac:spMkLst>
            <pc:docMk/>
            <pc:sldMk cId="1919480477" sldId="360"/>
            <ac:spMk id="3" creationId="{6CCD5ABF-F289-6DF4-D01E-776F3BB7441A}"/>
          </ac:spMkLst>
        </pc:spChg>
        <pc:spChg chg="mod">
          <ac:chgData name="Belaid, Sirine" userId="S::belaids@upmc.edu::5dcb4cf5-c058-49ea-93f8-4f4e6c877fcd" providerId="AD" clId="Web-{0B02AF87-38A3-0D39-8FB3-31B36863DE92}" dt="2024-12-10T03:23:43.603" v="934" actId="1076"/>
          <ac:spMkLst>
            <pc:docMk/>
            <pc:sldMk cId="1919480477" sldId="360"/>
            <ac:spMk id="4" creationId="{BC1764D5-760C-CB8E-B008-E46689C2012F}"/>
          </ac:spMkLst>
        </pc:spChg>
        <pc:spChg chg="mod">
          <ac:chgData name="Belaid, Sirine" userId="S::belaids@upmc.edu::5dcb4cf5-c058-49ea-93f8-4f4e6c877fcd" providerId="AD" clId="Web-{0B02AF87-38A3-0D39-8FB3-31B36863DE92}" dt="2024-12-10T03:45:18.654" v="1210" actId="14100"/>
          <ac:spMkLst>
            <pc:docMk/>
            <pc:sldMk cId="1919480477" sldId="360"/>
            <ac:spMk id="6" creationId="{C33B9BD3-ECFC-E1EF-D683-0E97D7FA1078}"/>
          </ac:spMkLst>
        </pc:spChg>
      </pc:sldChg>
      <pc:sldChg chg="modSp">
        <pc:chgData name="Belaid, Sirine" userId="S::belaids@upmc.edu::5dcb4cf5-c058-49ea-93f8-4f4e6c877fcd" providerId="AD" clId="Web-{0B02AF87-38A3-0D39-8FB3-31B36863DE92}" dt="2024-12-10T03:47:54.614" v="1250" actId="20577"/>
        <pc:sldMkLst>
          <pc:docMk/>
          <pc:sldMk cId="2817742152" sldId="361"/>
        </pc:sldMkLst>
        <pc:spChg chg="mod">
          <ac:chgData name="Belaid, Sirine" userId="S::belaids@upmc.edu::5dcb4cf5-c058-49ea-93f8-4f4e6c877fcd" providerId="AD" clId="Web-{0B02AF87-38A3-0D39-8FB3-31B36863DE92}" dt="2024-12-10T03:47:54.614" v="1250" actId="20577"/>
          <ac:spMkLst>
            <pc:docMk/>
            <pc:sldMk cId="2817742152" sldId="361"/>
            <ac:spMk id="3" creationId="{B6FB2075-FE59-DFEA-3EE2-6A1D6EAFE127}"/>
          </ac:spMkLst>
        </pc:spChg>
      </pc:sldChg>
      <pc:sldChg chg="modSp modNotes">
        <pc:chgData name="Belaid, Sirine" userId="S::belaids@upmc.edu::5dcb4cf5-c058-49ea-93f8-4f4e6c877fcd" providerId="AD" clId="Web-{0B02AF87-38A3-0D39-8FB3-31B36863DE92}" dt="2024-12-11T18:41:47.909" v="2161"/>
        <pc:sldMkLst>
          <pc:docMk/>
          <pc:sldMk cId="2090633080" sldId="362"/>
        </pc:sldMkLst>
        <pc:spChg chg="mod">
          <ac:chgData name="Belaid, Sirine" userId="S::belaids@upmc.edu::5dcb4cf5-c058-49ea-93f8-4f4e6c877fcd" providerId="AD" clId="Web-{0B02AF87-38A3-0D39-8FB3-31B36863DE92}" dt="2024-12-10T03:22:18.787" v="905" actId="20577"/>
          <ac:spMkLst>
            <pc:docMk/>
            <pc:sldMk cId="2090633080" sldId="362"/>
            <ac:spMk id="3" creationId="{7639CC8F-08C3-8406-49DC-53CA41C3EDD0}"/>
          </ac:spMkLst>
        </pc:spChg>
      </pc:sldChg>
      <pc:sldChg chg="modSp">
        <pc:chgData name="Belaid, Sirine" userId="S::belaids@upmc.edu::5dcb4cf5-c058-49ea-93f8-4f4e6c877fcd" providerId="AD" clId="Web-{0B02AF87-38A3-0D39-8FB3-31B36863DE92}" dt="2024-12-11T17:09:45.033" v="1939" actId="20577"/>
        <pc:sldMkLst>
          <pc:docMk/>
          <pc:sldMk cId="3864006159" sldId="363"/>
        </pc:sldMkLst>
        <pc:spChg chg="mod">
          <ac:chgData name="Belaid, Sirine" userId="S::belaids@upmc.edu::5dcb4cf5-c058-49ea-93f8-4f4e6c877fcd" providerId="AD" clId="Web-{0B02AF87-38A3-0D39-8FB3-31B36863DE92}" dt="2024-12-11T17:09:45.033" v="1939" actId="20577"/>
          <ac:spMkLst>
            <pc:docMk/>
            <pc:sldMk cId="3864006159" sldId="363"/>
            <ac:spMk id="3" creationId="{6B57145F-A3D4-5C8F-5BBE-CC4E7BC1E90B}"/>
          </ac:spMkLst>
        </pc:spChg>
      </pc:sldChg>
      <pc:sldChg chg="modSp">
        <pc:chgData name="Belaid, Sirine" userId="S::belaids@upmc.edu::5dcb4cf5-c058-49ea-93f8-4f4e6c877fcd" providerId="AD" clId="Web-{0B02AF87-38A3-0D39-8FB3-31B36863DE92}" dt="2024-12-11T17:21:13.470" v="2065" actId="20577"/>
        <pc:sldMkLst>
          <pc:docMk/>
          <pc:sldMk cId="2414223819" sldId="364"/>
        </pc:sldMkLst>
        <pc:spChg chg="mod">
          <ac:chgData name="Belaid, Sirine" userId="S::belaids@upmc.edu::5dcb4cf5-c058-49ea-93f8-4f4e6c877fcd" providerId="AD" clId="Web-{0B02AF87-38A3-0D39-8FB3-31B36863DE92}" dt="2024-12-11T17:21:13.470" v="2065" actId="20577"/>
          <ac:spMkLst>
            <pc:docMk/>
            <pc:sldMk cId="2414223819" sldId="364"/>
            <ac:spMk id="3" creationId="{6B57145F-A3D4-5C8F-5BBE-CC4E7BC1E90B}"/>
          </ac:spMkLst>
        </pc:spChg>
      </pc:sldChg>
      <pc:sldChg chg="modSp">
        <pc:chgData name="Belaid, Sirine" userId="S::belaids@upmc.edu::5dcb4cf5-c058-49ea-93f8-4f4e6c877fcd" providerId="AD" clId="Web-{0B02AF87-38A3-0D39-8FB3-31B36863DE92}" dt="2024-12-10T03:53:30.892" v="1361" actId="20577"/>
        <pc:sldMkLst>
          <pc:docMk/>
          <pc:sldMk cId="2208660293" sldId="366"/>
        </pc:sldMkLst>
        <pc:spChg chg="mod">
          <ac:chgData name="Belaid, Sirine" userId="S::belaids@upmc.edu::5dcb4cf5-c058-49ea-93f8-4f4e6c877fcd" providerId="AD" clId="Web-{0B02AF87-38A3-0D39-8FB3-31B36863DE92}" dt="2024-12-10T03:53:30.892" v="1361" actId="20577"/>
          <ac:spMkLst>
            <pc:docMk/>
            <pc:sldMk cId="2208660293" sldId="366"/>
            <ac:spMk id="3" creationId="{FC73AACB-7825-85D8-03D0-48CD572599F9}"/>
          </ac:spMkLst>
        </pc:spChg>
      </pc:sldChg>
      <pc:sldChg chg="addSp modSp">
        <pc:chgData name="Belaid, Sirine" userId="S::belaids@upmc.edu::5dcb4cf5-c058-49ea-93f8-4f4e6c877fcd" providerId="AD" clId="Web-{0B02AF87-38A3-0D39-8FB3-31B36863DE92}" dt="2024-12-11T17:08:58.564" v="1928" actId="20577"/>
        <pc:sldMkLst>
          <pc:docMk/>
          <pc:sldMk cId="3004633114" sldId="367"/>
        </pc:sldMkLst>
        <pc:spChg chg="mod">
          <ac:chgData name="Belaid, Sirine" userId="S::belaids@upmc.edu::5dcb4cf5-c058-49ea-93f8-4f4e6c877fcd" providerId="AD" clId="Web-{0B02AF87-38A3-0D39-8FB3-31B36863DE92}" dt="2024-12-11T17:08:58.564" v="1928" actId="20577"/>
          <ac:spMkLst>
            <pc:docMk/>
            <pc:sldMk cId="3004633114" sldId="367"/>
            <ac:spMk id="3" creationId="{9AE938D2-B05F-4829-BA51-1B2B9A25680E}"/>
          </ac:spMkLst>
        </pc:spChg>
        <pc:picChg chg="add mod">
          <ac:chgData name="Belaid, Sirine" userId="S::belaids@upmc.edu::5dcb4cf5-c058-49ea-93f8-4f4e6c877fcd" providerId="AD" clId="Web-{0B02AF87-38A3-0D39-8FB3-31B36863DE92}" dt="2024-12-11T17:05:34.231" v="1917" actId="1076"/>
          <ac:picMkLst>
            <pc:docMk/>
            <pc:sldMk cId="3004633114" sldId="367"/>
            <ac:picMk id="4" creationId="{F0C4D6B0-31BC-CC15-D9C8-1BDAC7F533F3}"/>
          </ac:picMkLst>
        </pc:picChg>
        <pc:picChg chg="add mod">
          <ac:chgData name="Belaid, Sirine" userId="S::belaids@upmc.edu::5dcb4cf5-c058-49ea-93f8-4f4e6c877fcd" providerId="AD" clId="Web-{0B02AF87-38A3-0D39-8FB3-31B36863DE92}" dt="2024-12-11T17:05:44.419" v="1919" actId="1076"/>
          <ac:picMkLst>
            <pc:docMk/>
            <pc:sldMk cId="3004633114" sldId="367"/>
            <ac:picMk id="5" creationId="{D9102F3E-D968-C1EC-3C84-215E0AAEE767}"/>
          </ac:picMkLst>
        </pc:picChg>
        <pc:picChg chg="add mod">
          <ac:chgData name="Belaid, Sirine" userId="S::belaids@upmc.edu::5dcb4cf5-c058-49ea-93f8-4f4e6c877fcd" providerId="AD" clId="Web-{0B02AF87-38A3-0D39-8FB3-31B36863DE92}" dt="2024-12-11T17:08:36.751" v="1924" actId="1076"/>
          <ac:picMkLst>
            <pc:docMk/>
            <pc:sldMk cId="3004633114" sldId="367"/>
            <ac:picMk id="6" creationId="{230E52E8-AF0E-CED2-AB11-377EE30E9C99}"/>
          </ac:picMkLst>
        </pc:picChg>
      </pc:sldChg>
      <pc:sldChg chg="addSp modSp modNotes">
        <pc:chgData name="Belaid, Sirine" userId="S::belaids@upmc.edu::5dcb4cf5-c058-49ea-93f8-4f4e6c877fcd" providerId="AD" clId="Web-{0B02AF87-38A3-0D39-8FB3-31B36863DE92}" dt="2024-12-11T14:53:07.479" v="1605"/>
        <pc:sldMkLst>
          <pc:docMk/>
          <pc:sldMk cId="1204613590" sldId="368"/>
        </pc:sldMkLst>
        <pc:spChg chg="mod">
          <ac:chgData name="Belaid, Sirine" userId="S::belaids@upmc.edu::5dcb4cf5-c058-49ea-93f8-4f4e6c877fcd" providerId="AD" clId="Web-{0B02AF87-38A3-0D39-8FB3-31B36863DE92}" dt="2024-12-10T02:32:54.451" v="18" actId="1076"/>
          <ac:spMkLst>
            <pc:docMk/>
            <pc:sldMk cId="1204613590" sldId="368"/>
            <ac:spMk id="2" creationId="{F6B1AE23-4599-CB1C-CDE6-F87BBDEA55D1}"/>
          </ac:spMkLst>
        </pc:spChg>
        <pc:graphicFrameChg chg="mod">
          <ac:chgData name="Belaid, Sirine" userId="S::belaids@upmc.edu::5dcb4cf5-c058-49ea-93f8-4f4e6c877fcd" providerId="AD" clId="Web-{0B02AF87-38A3-0D39-8FB3-31B36863DE92}" dt="2024-12-11T14:51:59.896" v="1603" actId="1076"/>
          <ac:graphicFrameMkLst>
            <pc:docMk/>
            <pc:sldMk cId="1204613590" sldId="368"/>
            <ac:graphicFrameMk id="5" creationId="{23AF7966-5238-A790-88D7-3E2B2D408459}"/>
          </ac:graphicFrameMkLst>
        </pc:graphicFrameChg>
        <pc:picChg chg="add mod">
          <ac:chgData name="Belaid, Sirine" userId="S::belaids@upmc.edu::5dcb4cf5-c058-49ea-93f8-4f4e6c877fcd" providerId="AD" clId="Web-{0B02AF87-38A3-0D39-8FB3-31B36863DE92}" dt="2024-12-10T02:34:14.892" v="35" actId="1076"/>
          <ac:picMkLst>
            <pc:docMk/>
            <pc:sldMk cId="1204613590" sldId="368"/>
            <ac:picMk id="33" creationId="{700D547C-7836-8933-D13F-34F8334EF821}"/>
          </ac:picMkLst>
        </pc:picChg>
        <pc:picChg chg="add mod">
          <ac:chgData name="Belaid, Sirine" userId="S::belaids@upmc.edu::5dcb4cf5-c058-49ea-93f8-4f4e6c877fcd" providerId="AD" clId="Web-{0B02AF87-38A3-0D39-8FB3-31B36863DE92}" dt="2024-12-10T02:34:44.643" v="40" actId="1076"/>
          <ac:picMkLst>
            <pc:docMk/>
            <pc:sldMk cId="1204613590" sldId="368"/>
            <ac:picMk id="49" creationId="{578B8691-7512-1E34-84EA-DA518854C44C}"/>
          </ac:picMkLst>
        </pc:picChg>
        <pc:picChg chg="add mod">
          <ac:chgData name="Belaid, Sirine" userId="S::belaids@upmc.edu::5dcb4cf5-c058-49ea-93f8-4f4e6c877fcd" providerId="AD" clId="Web-{0B02AF87-38A3-0D39-8FB3-31B36863DE92}" dt="2024-12-10T02:34:25.752" v="39" actId="1076"/>
          <ac:picMkLst>
            <pc:docMk/>
            <pc:sldMk cId="1204613590" sldId="368"/>
            <ac:picMk id="51" creationId="{4CD103BC-B576-76EB-69C0-888FFED54ED1}"/>
          </ac:picMkLst>
        </pc:picChg>
      </pc:sldChg>
      <pc:sldChg chg="modSp">
        <pc:chgData name="Belaid, Sirine" userId="S::belaids@upmc.edu::5dcb4cf5-c058-49ea-93f8-4f4e6c877fcd" providerId="AD" clId="Web-{0B02AF87-38A3-0D39-8FB3-31B36863DE92}" dt="2024-12-11T18:28:41.133" v="2096" actId="20577"/>
        <pc:sldMkLst>
          <pc:docMk/>
          <pc:sldMk cId="13225285" sldId="370"/>
        </pc:sldMkLst>
        <pc:spChg chg="mod">
          <ac:chgData name="Belaid, Sirine" userId="S::belaids@upmc.edu::5dcb4cf5-c058-49ea-93f8-4f4e6c877fcd" providerId="AD" clId="Web-{0B02AF87-38A3-0D39-8FB3-31B36863DE92}" dt="2024-12-11T18:28:41.133" v="2096" actId="20577"/>
          <ac:spMkLst>
            <pc:docMk/>
            <pc:sldMk cId="13225285" sldId="370"/>
            <ac:spMk id="3" creationId="{5F301AD2-63C3-E004-C0F9-E2CADF494E6A}"/>
          </ac:spMkLst>
        </pc:spChg>
      </pc:sldChg>
      <pc:sldChg chg="modSp modNotes">
        <pc:chgData name="Belaid, Sirine" userId="S::belaids@upmc.edu::5dcb4cf5-c058-49ea-93f8-4f4e6c877fcd" providerId="AD" clId="Web-{0B02AF87-38A3-0D39-8FB3-31B36863DE92}" dt="2024-12-10T03:48:39.569" v="1297" actId="14100"/>
        <pc:sldMkLst>
          <pc:docMk/>
          <pc:sldMk cId="3434993078" sldId="379"/>
        </pc:sldMkLst>
        <pc:spChg chg="mod">
          <ac:chgData name="Belaid, Sirine" userId="S::belaids@upmc.edu::5dcb4cf5-c058-49ea-93f8-4f4e6c877fcd" providerId="AD" clId="Web-{0B02AF87-38A3-0D39-8FB3-31B36863DE92}" dt="2024-12-10T03:48:39.569" v="1297" actId="14100"/>
          <ac:spMkLst>
            <pc:docMk/>
            <pc:sldMk cId="3434993078" sldId="379"/>
            <ac:spMk id="2" creationId="{16195E82-86AE-AB44-06FF-1A93F02750DC}"/>
          </ac:spMkLst>
        </pc:spChg>
      </pc:sldChg>
      <pc:sldChg chg="addSp modSp">
        <pc:chgData name="Belaid, Sirine" userId="S::belaids@upmc.edu::5dcb4cf5-c058-49ea-93f8-4f4e6c877fcd" providerId="AD" clId="Web-{0B02AF87-38A3-0D39-8FB3-31B36863DE92}" dt="2024-12-11T14:50:00.185" v="1587" actId="20577"/>
        <pc:sldMkLst>
          <pc:docMk/>
          <pc:sldMk cId="412412650" sldId="391"/>
        </pc:sldMkLst>
        <pc:spChg chg="mod">
          <ac:chgData name="Belaid, Sirine" userId="S::belaids@upmc.edu::5dcb4cf5-c058-49ea-93f8-4f4e6c877fcd" providerId="AD" clId="Web-{0B02AF87-38A3-0D39-8FB3-31B36863DE92}" dt="2024-12-11T14:32:11.256" v="1486" actId="20577"/>
          <ac:spMkLst>
            <pc:docMk/>
            <pc:sldMk cId="412412650" sldId="391"/>
            <ac:spMk id="2" creationId="{1771AC68-97E2-9045-5BCF-44AA08915141}"/>
          </ac:spMkLst>
        </pc:spChg>
        <pc:spChg chg="mod">
          <ac:chgData name="Belaid, Sirine" userId="S::belaids@upmc.edu::5dcb4cf5-c058-49ea-93f8-4f4e6c877fcd" providerId="AD" clId="Web-{0B02AF87-38A3-0D39-8FB3-31B36863DE92}" dt="2024-12-11T14:50:00.185" v="1587" actId="20577"/>
          <ac:spMkLst>
            <pc:docMk/>
            <pc:sldMk cId="412412650" sldId="391"/>
            <ac:spMk id="3" creationId="{58D555CA-A0A4-BD5A-C7A5-51D39BF63446}"/>
          </ac:spMkLst>
        </pc:spChg>
        <pc:spChg chg="add mod">
          <ac:chgData name="Belaid, Sirine" userId="S::belaids@upmc.edu::5dcb4cf5-c058-49ea-93f8-4f4e6c877fcd" providerId="AD" clId="Web-{0B02AF87-38A3-0D39-8FB3-31B36863DE92}" dt="2024-12-11T14:48:45.649" v="1556" actId="1076"/>
          <ac:spMkLst>
            <pc:docMk/>
            <pc:sldMk cId="412412650" sldId="391"/>
            <ac:spMk id="4" creationId="{0C4DFA9F-D5D8-418D-6708-4B57D7393503}"/>
          </ac:spMkLst>
        </pc:spChg>
        <pc:spChg chg="add mod">
          <ac:chgData name="Belaid, Sirine" userId="S::belaids@upmc.edu::5dcb4cf5-c058-49ea-93f8-4f4e6c877fcd" providerId="AD" clId="Web-{0B02AF87-38A3-0D39-8FB3-31B36863DE92}" dt="2024-12-11T14:49:22.448" v="1578" actId="20577"/>
          <ac:spMkLst>
            <pc:docMk/>
            <pc:sldMk cId="412412650" sldId="391"/>
            <ac:spMk id="5" creationId="{D812EF7D-4702-057B-A538-96ABF815087F}"/>
          </ac:spMkLst>
        </pc:spChg>
      </pc:sldChg>
      <pc:sldChg chg="modSp">
        <pc:chgData name="Belaid, Sirine" userId="S::belaids@upmc.edu::5dcb4cf5-c058-49ea-93f8-4f4e6c877fcd" providerId="AD" clId="Web-{0B02AF87-38A3-0D39-8FB3-31B36863DE92}" dt="2024-12-11T16:56:07.250" v="1892" actId="20577"/>
        <pc:sldMkLst>
          <pc:docMk/>
          <pc:sldMk cId="1731714019" sldId="393"/>
        </pc:sldMkLst>
        <pc:spChg chg="mod">
          <ac:chgData name="Belaid, Sirine" userId="S::belaids@upmc.edu::5dcb4cf5-c058-49ea-93f8-4f4e6c877fcd" providerId="AD" clId="Web-{0B02AF87-38A3-0D39-8FB3-31B36863DE92}" dt="2024-12-11T16:56:07.250" v="1892" actId="20577"/>
          <ac:spMkLst>
            <pc:docMk/>
            <pc:sldMk cId="1731714019" sldId="393"/>
            <ac:spMk id="3" creationId="{4A01C084-E4E4-6950-077A-5C215D5C06BE}"/>
          </ac:spMkLst>
        </pc:spChg>
      </pc:sldChg>
      <pc:sldChg chg="modSp ord modNotes">
        <pc:chgData name="Belaid, Sirine" userId="S::belaids@upmc.edu::5dcb4cf5-c058-49ea-93f8-4f4e6c877fcd" providerId="AD" clId="Web-{0B02AF87-38A3-0D39-8FB3-31B36863DE92}" dt="2024-12-11T16:42:45.638" v="1865"/>
        <pc:sldMkLst>
          <pc:docMk/>
          <pc:sldMk cId="1625999220" sldId="395"/>
        </pc:sldMkLst>
        <pc:graphicFrameChg chg="mod modGraphic">
          <ac:chgData name="Belaid, Sirine" userId="S::belaids@upmc.edu::5dcb4cf5-c058-49ea-93f8-4f4e6c877fcd" providerId="AD" clId="Web-{0B02AF87-38A3-0D39-8FB3-31B36863DE92}" dt="2024-12-11T16:42:45.638" v="1865"/>
          <ac:graphicFrameMkLst>
            <pc:docMk/>
            <pc:sldMk cId="1625999220" sldId="395"/>
            <ac:graphicFrameMk id="2" creationId="{5AF5F66F-7F30-C7FD-12D8-EE5A388FDE96}"/>
          </ac:graphicFrameMkLst>
        </pc:graphicFrameChg>
      </pc:sldChg>
      <pc:sldChg chg="addSp modSp new modNotes">
        <pc:chgData name="Belaid, Sirine" userId="S::belaids@upmc.edu::5dcb4cf5-c058-49ea-93f8-4f4e6c877fcd" providerId="AD" clId="Web-{0B02AF87-38A3-0D39-8FB3-31B36863DE92}" dt="2024-12-11T16:19:38.794" v="1647"/>
        <pc:sldMkLst>
          <pc:docMk/>
          <pc:sldMk cId="1037649623" sldId="396"/>
        </pc:sldMkLst>
        <pc:spChg chg="add mod">
          <ac:chgData name="Belaid, Sirine" userId="S::belaids@upmc.edu::5dcb4cf5-c058-49ea-93f8-4f4e6c877fcd" providerId="AD" clId="Web-{0B02AF87-38A3-0D39-8FB3-31B36863DE92}" dt="2024-12-10T03:01:26.534" v="608" actId="1076"/>
          <ac:spMkLst>
            <pc:docMk/>
            <pc:sldMk cId="1037649623" sldId="396"/>
            <ac:spMk id="4" creationId="{4D596B5E-5157-3C7E-BFB0-A26CF590A99E}"/>
          </ac:spMkLst>
        </pc:spChg>
        <pc:spChg chg="add mod">
          <ac:chgData name="Belaid, Sirine" userId="S::belaids@upmc.edu::5dcb4cf5-c058-49ea-93f8-4f4e6c877fcd" providerId="AD" clId="Web-{0B02AF87-38A3-0D39-8FB3-31B36863DE92}" dt="2024-12-10T03:01:36.644" v="609" actId="1076"/>
          <ac:spMkLst>
            <pc:docMk/>
            <pc:sldMk cId="1037649623" sldId="396"/>
            <ac:spMk id="5" creationId="{87E8A27D-4779-14D8-7486-8B184D703BBB}"/>
          </ac:spMkLst>
        </pc:spChg>
        <pc:picChg chg="add mod">
          <ac:chgData name="Belaid, Sirine" userId="S::belaids@upmc.edu::5dcb4cf5-c058-49ea-93f8-4f4e6c877fcd" providerId="AD" clId="Web-{0B02AF87-38A3-0D39-8FB3-31B36863DE92}" dt="2024-12-10T02:54:49.800" v="502" actId="14100"/>
          <ac:picMkLst>
            <pc:docMk/>
            <pc:sldMk cId="1037649623" sldId="396"/>
            <ac:picMk id="2" creationId="{FAEB5427-0668-C432-7EB1-63D66F80DE54}"/>
          </ac:picMkLst>
        </pc:picChg>
        <pc:picChg chg="add mod">
          <ac:chgData name="Belaid, Sirine" userId="S::belaids@upmc.edu::5dcb4cf5-c058-49ea-93f8-4f4e6c877fcd" providerId="AD" clId="Web-{0B02AF87-38A3-0D39-8FB3-31B36863DE92}" dt="2024-12-10T03:00:34.782" v="592" actId="1076"/>
          <ac:picMkLst>
            <pc:docMk/>
            <pc:sldMk cId="1037649623" sldId="396"/>
            <ac:picMk id="3" creationId="{4492925C-A5A5-A3F6-B6B9-9CD544E53238}"/>
          </ac:picMkLst>
        </pc:picChg>
      </pc:sldChg>
      <pc:sldChg chg="modSp new">
        <pc:chgData name="Belaid, Sirine" userId="S::belaids@upmc.edu::5dcb4cf5-c058-49ea-93f8-4f4e6c877fcd" providerId="AD" clId="Web-{0B02AF87-38A3-0D39-8FB3-31B36863DE92}" dt="2024-12-10T03:29:19.913" v="1022" actId="1076"/>
        <pc:sldMkLst>
          <pc:docMk/>
          <pc:sldMk cId="1670317384" sldId="397"/>
        </pc:sldMkLst>
        <pc:spChg chg="mod">
          <ac:chgData name="Belaid, Sirine" userId="S::belaids@upmc.edu::5dcb4cf5-c058-49ea-93f8-4f4e6c877fcd" providerId="AD" clId="Web-{0B02AF87-38A3-0D39-8FB3-31B36863DE92}" dt="2024-12-10T03:29:19.913" v="1022" actId="1076"/>
          <ac:spMkLst>
            <pc:docMk/>
            <pc:sldMk cId="1670317384" sldId="397"/>
            <ac:spMk id="2" creationId="{85806286-C44F-D904-6766-051335CE5001}"/>
          </ac:spMkLst>
        </pc:spChg>
      </pc:sldChg>
      <pc:sldChg chg="addSp modSp new modNotes">
        <pc:chgData name="Belaid, Sirine" userId="S::belaids@upmc.edu::5dcb4cf5-c058-49ea-93f8-4f4e6c877fcd" providerId="AD" clId="Web-{0B02AF87-38A3-0D39-8FB3-31B36863DE92}" dt="2024-12-11T18:41:13.377" v="2159"/>
        <pc:sldMkLst>
          <pc:docMk/>
          <pc:sldMk cId="565133894" sldId="398"/>
        </pc:sldMkLst>
        <pc:spChg chg="mod">
          <ac:chgData name="Belaid, Sirine" userId="S::belaids@upmc.edu::5dcb4cf5-c058-49ea-93f8-4f4e6c877fcd" providerId="AD" clId="Web-{0B02AF87-38A3-0D39-8FB3-31B36863DE92}" dt="2024-12-10T17:39:36.408" v="1372" actId="20577"/>
          <ac:spMkLst>
            <pc:docMk/>
            <pc:sldMk cId="565133894" sldId="398"/>
            <ac:spMk id="2" creationId="{6ABA23EE-C15F-B75B-E6B0-94DC56DAFC1D}"/>
          </ac:spMkLst>
        </pc:spChg>
        <pc:spChg chg="mod">
          <ac:chgData name="Belaid, Sirine" userId="S::belaids@upmc.edu::5dcb4cf5-c058-49ea-93f8-4f4e6c877fcd" providerId="AD" clId="Web-{0B02AF87-38A3-0D39-8FB3-31B36863DE92}" dt="2024-12-11T18:36:19.679" v="2105" actId="20577"/>
          <ac:spMkLst>
            <pc:docMk/>
            <pc:sldMk cId="565133894" sldId="398"/>
            <ac:spMk id="3" creationId="{6E0CC8E0-6974-A9C5-368B-AA1D2079188B}"/>
          </ac:spMkLst>
        </pc:spChg>
        <pc:picChg chg="add mod">
          <ac:chgData name="Belaid, Sirine" userId="S::belaids@upmc.edu::5dcb4cf5-c058-49ea-93f8-4f4e6c877fcd" providerId="AD" clId="Web-{0B02AF87-38A3-0D39-8FB3-31B36863DE92}" dt="2024-12-10T17:48:07.994" v="1416" actId="1076"/>
          <ac:picMkLst>
            <pc:docMk/>
            <pc:sldMk cId="565133894" sldId="398"/>
            <ac:picMk id="4" creationId="{FCF9EBDC-9067-3296-021C-172BEBC20B85}"/>
          </ac:picMkLst>
        </pc:picChg>
      </pc:sldChg>
    </pc:docChg>
  </pc:docChgLst>
  <pc:docChgLst>
    <pc:chgData name="Belaid, Sirine" userId="S::belaids@upmc.edu::5dcb4cf5-c058-49ea-93f8-4f4e6c877fcd" providerId="AD" clId="Web-{D93E0161-80AC-7C56-6200-80C72E39C791}"/>
    <pc:docChg chg="addSld delSld modSld">
      <pc:chgData name="Belaid, Sirine" userId="S::belaids@upmc.edu::5dcb4cf5-c058-49ea-93f8-4f4e6c877fcd" providerId="AD" clId="Web-{D93E0161-80AC-7C56-6200-80C72E39C791}" dt="2024-12-12T16:36:35.500" v="132"/>
      <pc:docMkLst>
        <pc:docMk/>
      </pc:docMkLst>
      <pc:sldChg chg="del">
        <pc:chgData name="Belaid, Sirine" userId="S::belaids@upmc.edu::5dcb4cf5-c058-49ea-93f8-4f4e6c877fcd" providerId="AD" clId="Web-{D93E0161-80AC-7C56-6200-80C72E39C791}" dt="2024-12-12T16:29:38.674" v="8"/>
        <pc:sldMkLst>
          <pc:docMk/>
          <pc:sldMk cId="344766927" sldId="259"/>
        </pc:sldMkLst>
      </pc:sldChg>
      <pc:sldChg chg="del">
        <pc:chgData name="Belaid, Sirine" userId="S::belaids@upmc.edu::5dcb4cf5-c058-49ea-93f8-4f4e6c877fcd" providerId="AD" clId="Web-{D93E0161-80AC-7C56-6200-80C72E39C791}" dt="2024-12-12T16:29:38.658" v="6"/>
        <pc:sldMkLst>
          <pc:docMk/>
          <pc:sldMk cId="3651327643" sldId="260"/>
        </pc:sldMkLst>
      </pc:sldChg>
      <pc:sldChg chg="del">
        <pc:chgData name="Belaid, Sirine" userId="S::belaids@upmc.edu::5dcb4cf5-c058-49ea-93f8-4f4e6c877fcd" providerId="AD" clId="Web-{D93E0161-80AC-7C56-6200-80C72E39C791}" dt="2024-12-12T16:30:27.894" v="33"/>
        <pc:sldMkLst>
          <pc:docMk/>
          <pc:sldMk cId="2302766718" sldId="261"/>
        </pc:sldMkLst>
      </pc:sldChg>
      <pc:sldChg chg="del">
        <pc:chgData name="Belaid, Sirine" userId="S::belaids@upmc.edu::5dcb4cf5-c058-49ea-93f8-4f4e6c877fcd" providerId="AD" clId="Web-{D93E0161-80AC-7C56-6200-80C72E39C791}" dt="2024-12-12T16:30:23.488" v="31"/>
        <pc:sldMkLst>
          <pc:docMk/>
          <pc:sldMk cId="576414548" sldId="262"/>
        </pc:sldMkLst>
      </pc:sldChg>
      <pc:sldChg chg="del">
        <pc:chgData name="Belaid, Sirine" userId="S::belaids@upmc.edu::5dcb4cf5-c058-49ea-93f8-4f4e6c877fcd" providerId="AD" clId="Web-{D93E0161-80AC-7C56-6200-80C72E39C791}" dt="2024-12-12T16:30:23.488" v="30"/>
        <pc:sldMkLst>
          <pc:docMk/>
          <pc:sldMk cId="339090689" sldId="263"/>
        </pc:sldMkLst>
      </pc:sldChg>
      <pc:sldChg chg="del">
        <pc:chgData name="Belaid, Sirine" userId="S::belaids@upmc.edu::5dcb4cf5-c058-49ea-93f8-4f4e6c877fcd" providerId="AD" clId="Web-{D93E0161-80AC-7C56-6200-80C72E39C791}" dt="2024-12-12T16:29:38.674" v="7"/>
        <pc:sldMkLst>
          <pc:docMk/>
          <pc:sldMk cId="2595590755" sldId="264"/>
        </pc:sldMkLst>
      </pc:sldChg>
      <pc:sldChg chg="del">
        <pc:chgData name="Belaid, Sirine" userId="S::belaids@upmc.edu::5dcb4cf5-c058-49ea-93f8-4f4e6c877fcd" providerId="AD" clId="Web-{D93E0161-80AC-7C56-6200-80C72E39C791}" dt="2024-12-12T16:29:38.658" v="5"/>
        <pc:sldMkLst>
          <pc:docMk/>
          <pc:sldMk cId="571547126" sldId="265"/>
        </pc:sldMkLst>
      </pc:sldChg>
      <pc:sldChg chg="del">
        <pc:chgData name="Belaid, Sirine" userId="S::belaids@upmc.edu::5dcb4cf5-c058-49ea-93f8-4f4e6c877fcd" providerId="AD" clId="Web-{D93E0161-80AC-7C56-6200-80C72E39C791}" dt="2024-12-12T16:29:44.596" v="14"/>
        <pc:sldMkLst>
          <pc:docMk/>
          <pc:sldMk cId="3955110762" sldId="266"/>
        </pc:sldMkLst>
      </pc:sldChg>
      <pc:sldChg chg="del">
        <pc:chgData name="Belaid, Sirine" userId="S::belaids@upmc.edu::5dcb4cf5-c058-49ea-93f8-4f4e6c877fcd" providerId="AD" clId="Web-{D93E0161-80AC-7C56-6200-80C72E39C791}" dt="2024-12-12T16:29:29.205" v="4"/>
        <pc:sldMkLst>
          <pc:docMk/>
          <pc:sldMk cId="2923304690" sldId="267"/>
        </pc:sldMkLst>
      </pc:sldChg>
      <pc:sldChg chg="del">
        <pc:chgData name="Belaid, Sirine" userId="S::belaids@upmc.edu::5dcb4cf5-c058-49ea-93f8-4f4e6c877fcd" providerId="AD" clId="Web-{D93E0161-80AC-7C56-6200-80C72E39C791}" dt="2024-12-12T16:29:29.189" v="3"/>
        <pc:sldMkLst>
          <pc:docMk/>
          <pc:sldMk cId="280177216" sldId="268"/>
        </pc:sldMkLst>
      </pc:sldChg>
      <pc:sldChg chg="del">
        <pc:chgData name="Belaid, Sirine" userId="S::belaids@upmc.edu::5dcb4cf5-c058-49ea-93f8-4f4e6c877fcd" providerId="AD" clId="Web-{D93E0161-80AC-7C56-6200-80C72E39C791}" dt="2024-12-12T16:29:29.189" v="2"/>
        <pc:sldMkLst>
          <pc:docMk/>
          <pc:sldMk cId="666331701" sldId="269"/>
        </pc:sldMkLst>
      </pc:sldChg>
      <pc:sldChg chg="del">
        <pc:chgData name="Belaid, Sirine" userId="S::belaids@upmc.edu::5dcb4cf5-c058-49ea-93f8-4f4e6c877fcd" providerId="AD" clId="Web-{D93E0161-80AC-7C56-6200-80C72E39C791}" dt="2024-12-12T16:29:29.189" v="1"/>
        <pc:sldMkLst>
          <pc:docMk/>
          <pc:sldMk cId="3489943564" sldId="270"/>
        </pc:sldMkLst>
      </pc:sldChg>
      <pc:sldChg chg="del">
        <pc:chgData name="Belaid, Sirine" userId="S::belaids@upmc.edu::5dcb4cf5-c058-49ea-93f8-4f4e6c877fcd" providerId="AD" clId="Web-{D93E0161-80AC-7C56-6200-80C72E39C791}" dt="2024-12-12T16:29:44.596" v="13"/>
        <pc:sldMkLst>
          <pc:docMk/>
          <pc:sldMk cId="4163017298" sldId="271"/>
        </pc:sldMkLst>
      </pc:sldChg>
      <pc:sldChg chg="del">
        <pc:chgData name="Belaid, Sirine" userId="S::belaids@upmc.edu::5dcb4cf5-c058-49ea-93f8-4f4e6c877fcd" providerId="AD" clId="Web-{D93E0161-80AC-7C56-6200-80C72E39C791}" dt="2024-12-12T16:29:44.596" v="12"/>
        <pc:sldMkLst>
          <pc:docMk/>
          <pc:sldMk cId="138475673" sldId="272"/>
        </pc:sldMkLst>
      </pc:sldChg>
      <pc:sldChg chg="del">
        <pc:chgData name="Belaid, Sirine" userId="S::belaids@upmc.edu::5dcb4cf5-c058-49ea-93f8-4f4e6c877fcd" providerId="AD" clId="Web-{D93E0161-80AC-7C56-6200-80C72E39C791}" dt="2024-12-12T16:29:44.596" v="11"/>
        <pc:sldMkLst>
          <pc:docMk/>
          <pc:sldMk cId="2876258149" sldId="273"/>
        </pc:sldMkLst>
      </pc:sldChg>
      <pc:sldChg chg="del">
        <pc:chgData name="Belaid, Sirine" userId="S::belaids@upmc.edu::5dcb4cf5-c058-49ea-93f8-4f4e6c877fcd" providerId="AD" clId="Web-{D93E0161-80AC-7C56-6200-80C72E39C791}" dt="2024-12-12T16:29:44.580" v="10"/>
        <pc:sldMkLst>
          <pc:docMk/>
          <pc:sldMk cId="1037168473" sldId="274"/>
        </pc:sldMkLst>
      </pc:sldChg>
      <pc:sldChg chg="del">
        <pc:chgData name="Belaid, Sirine" userId="S::belaids@upmc.edu::5dcb4cf5-c058-49ea-93f8-4f4e6c877fcd" providerId="AD" clId="Web-{D93E0161-80AC-7C56-6200-80C72E39C791}" dt="2024-12-12T16:29:58.612" v="19"/>
        <pc:sldMkLst>
          <pc:docMk/>
          <pc:sldMk cId="460022324" sldId="275"/>
        </pc:sldMkLst>
      </pc:sldChg>
      <pc:sldChg chg="del">
        <pc:chgData name="Belaid, Sirine" userId="S::belaids@upmc.edu::5dcb4cf5-c058-49ea-93f8-4f4e6c877fcd" providerId="AD" clId="Web-{D93E0161-80AC-7C56-6200-80C72E39C791}" dt="2024-12-12T16:29:58.612" v="20"/>
        <pc:sldMkLst>
          <pc:docMk/>
          <pc:sldMk cId="890179914" sldId="276"/>
        </pc:sldMkLst>
      </pc:sldChg>
      <pc:sldChg chg="del">
        <pc:chgData name="Belaid, Sirine" userId="S::belaids@upmc.edu::5dcb4cf5-c058-49ea-93f8-4f4e6c877fcd" providerId="AD" clId="Web-{D93E0161-80AC-7C56-6200-80C72E39C791}" dt="2024-12-12T16:29:58.612" v="18"/>
        <pc:sldMkLst>
          <pc:docMk/>
          <pc:sldMk cId="2737701447" sldId="277"/>
        </pc:sldMkLst>
      </pc:sldChg>
      <pc:sldChg chg="del">
        <pc:chgData name="Belaid, Sirine" userId="S::belaids@upmc.edu::5dcb4cf5-c058-49ea-93f8-4f4e6c877fcd" providerId="AD" clId="Web-{D93E0161-80AC-7C56-6200-80C72E39C791}" dt="2024-12-12T16:29:53.221" v="16"/>
        <pc:sldMkLst>
          <pc:docMk/>
          <pc:sldMk cId="3040203494" sldId="278"/>
        </pc:sldMkLst>
      </pc:sldChg>
      <pc:sldChg chg="del">
        <pc:chgData name="Belaid, Sirine" userId="S::belaids@upmc.edu::5dcb4cf5-c058-49ea-93f8-4f4e6c877fcd" providerId="AD" clId="Web-{D93E0161-80AC-7C56-6200-80C72E39C791}" dt="2024-12-12T16:30:09.300" v="24"/>
        <pc:sldMkLst>
          <pc:docMk/>
          <pc:sldMk cId="1691135755" sldId="279"/>
        </pc:sldMkLst>
      </pc:sldChg>
      <pc:sldChg chg="del">
        <pc:chgData name="Belaid, Sirine" userId="S::belaids@upmc.edu::5dcb4cf5-c058-49ea-93f8-4f4e6c877fcd" providerId="AD" clId="Web-{D93E0161-80AC-7C56-6200-80C72E39C791}" dt="2024-12-12T16:30:09.300" v="23"/>
        <pc:sldMkLst>
          <pc:docMk/>
          <pc:sldMk cId="2334828839" sldId="280"/>
        </pc:sldMkLst>
      </pc:sldChg>
      <pc:sldChg chg="del">
        <pc:chgData name="Belaid, Sirine" userId="S::belaids@upmc.edu::5dcb4cf5-c058-49ea-93f8-4f4e6c877fcd" providerId="AD" clId="Web-{D93E0161-80AC-7C56-6200-80C72E39C791}" dt="2024-12-12T16:30:09.300" v="22"/>
        <pc:sldMkLst>
          <pc:docMk/>
          <pc:sldMk cId="1811786192" sldId="281"/>
        </pc:sldMkLst>
      </pc:sldChg>
      <pc:sldChg chg="del">
        <pc:chgData name="Belaid, Sirine" userId="S::belaids@upmc.edu::5dcb4cf5-c058-49ea-93f8-4f4e6c877fcd" providerId="AD" clId="Web-{D93E0161-80AC-7C56-6200-80C72E39C791}" dt="2024-12-12T16:30:09.284" v="21"/>
        <pc:sldMkLst>
          <pc:docMk/>
          <pc:sldMk cId="534894233" sldId="282"/>
        </pc:sldMkLst>
      </pc:sldChg>
      <pc:sldChg chg="del">
        <pc:chgData name="Belaid, Sirine" userId="S::belaids@upmc.edu::5dcb4cf5-c058-49ea-93f8-4f4e6c877fcd" providerId="AD" clId="Web-{D93E0161-80AC-7C56-6200-80C72E39C791}" dt="2024-12-12T16:30:23.488" v="28"/>
        <pc:sldMkLst>
          <pc:docMk/>
          <pc:sldMk cId="3128388144" sldId="283"/>
        </pc:sldMkLst>
      </pc:sldChg>
      <pc:sldChg chg="del">
        <pc:chgData name="Belaid, Sirine" userId="S::belaids@upmc.edu::5dcb4cf5-c058-49ea-93f8-4f4e6c877fcd" providerId="AD" clId="Web-{D93E0161-80AC-7C56-6200-80C72E39C791}" dt="2024-12-12T16:30:23.488" v="26"/>
        <pc:sldMkLst>
          <pc:docMk/>
          <pc:sldMk cId="1929808205" sldId="284"/>
        </pc:sldMkLst>
      </pc:sldChg>
      <pc:sldChg chg="del">
        <pc:chgData name="Belaid, Sirine" userId="S::belaids@upmc.edu::5dcb4cf5-c058-49ea-93f8-4f4e6c877fcd" providerId="AD" clId="Web-{D93E0161-80AC-7C56-6200-80C72E39C791}" dt="2024-12-12T16:30:23.488" v="29"/>
        <pc:sldMkLst>
          <pc:docMk/>
          <pc:sldMk cId="117287384" sldId="285"/>
        </pc:sldMkLst>
      </pc:sldChg>
      <pc:sldChg chg="del">
        <pc:chgData name="Belaid, Sirine" userId="S::belaids@upmc.edu::5dcb4cf5-c058-49ea-93f8-4f4e6c877fcd" providerId="AD" clId="Web-{D93E0161-80AC-7C56-6200-80C72E39C791}" dt="2024-12-12T16:29:53.206" v="15"/>
        <pc:sldMkLst>
          <pc:docMk/>
          <pc:sldMk cId="1161013520" sldId="286"/>
        </pc:sldMkLst>
      </pc:sldChg>
      <pc:sldChg chg="addSp delSp modSp del">
        <pc:chgData name="Belaid, Sirine" userId="S::belaids@upmc.edu::5dcb4cf5-c058-49ea-93f8-4f4e6c877fcd" providerId="AD" clId="Web-{D93E0161-80AC-7C56-6200-80C72E39C791}" dt="2024-12-12T16:29:58.612" v="17"/>
        <pc:sldMkLst>
          <pc:docMk/>
          <pc:sldMk cId="931904134" sldId="287"/>
        </pc:sldMkLst>
        <pc:spChg chg="mod">
          <ac:chgData name="Belaid, Sirine" userId="S::belaids@upmc.edu::5dcb4cf5-c058-49ea-93f8-4f4e6c877fcd" providerId="AD" clId="Web-{D93E0161-80AC-7C56-6200-80C72E39C791}" dt="2024-12-12T16:04:11.663" v="0"/>
          <ac:spMkLst>
            <pc:docMk/>
            <pc:sldMk cId="931904134" sldId="287"/>
            <ac:spMk id="2" creationId="{3913824F-ECD1-10CA-7CE8-EE77DB7B4E4C}"/>
          </ac:spMkLst>
        </pc:spChg>
        <pc:spChg chg="del">
          <ac:chgData name="Belaid, Sirine" userId="S::belaids@upmc.edu::5dcb4cf5-c058-49ea-93f8-4f4e6c877fcd" providerId="AD" clId="Web-{D93E0161-80AC-7C56-6200-80C72E39C791}" dt="2024-12-12T16:04:11.663" v="0"/>
          <ac:spMkLst>
            <pc:docMk/>
            <pc:sldMk cId="931904134" sldId="287"/>
            <ac:spMk id="7" creationId="{3DB2B855-1F64-5184-A62B-BB64F2950C59}"/>
          </ac:spMkLst>
        </pc:spChg>
        <pc:spChg chg="del">
          <ac:chgData name="Belaid, Sirine" userId="S::belaids@upmc.edu::5dcb4cf5-c058-49ea-93f8-4f4e6c877fcd" providerId="AD" clId="Web-{D93E0161-80AC-7C56-6200-80C72E39C791}" dt="2024-12-12T16:04:11.663" v="0"/>
          <ac:spMkLst>
            <pc:docMk/>
            <pc:sldMk cId="931904134" sldId="287"/>
            <ac:spMk id="8" creationId="{18873D23-2DCF-4B31-A009-95721C06E8E1}"/>
          </ac:spMkLst>
        </pc:spChg>
        <pc:spChg chg="del">
          <ac:chgData name="Belaid, Sirine" userId="S::belaids@upmc.edu::5dcb4cf5-c058-49ea-93f8-4f4e6c877fcd" providerId="AD" clId="Web-{D93E0161-80AC-7C56-6200-80C72E39C791}" dt="2024-12-12T16:04:11.663" v="0"/>
          <ac:spMkLst>
            <pc:docMk/>
            <pc:sldMk cId="931904134" sldId="287"/>
            <ac:spMk id="10" creationId="{C13EF075-D4EF-4929-ADBC-91B27DA19955}"/>
          </ac:spMkLst>
        </pc:spChg>
        <pc:spChg chg="add">
          <ac:chgData name="Belaid, Sirine" userId="S::belaids@upmc.edu::5dcb4cf5-c058-49ea-93f8-4f4e6c877fcd" providerId="AD" clId="Web-{D93E0161-80AC-7C56-6200-80C72E39C791}" dt="2024-12-12T16:04:11.663" v="0"/>
          <ac:spMkLst>
            <pc:docMk/>
            <pc:sldMk cId="931904134" sldId="287"/>
            <ac:spMk id="22" creationId="{35DB3719-6FDC-4E5D-891D-FF40B7300F64}"/>
          </ac:spMkLst>
        </pc:spChg>
        <pc:spChg chg="add">
          <ac:chgData name="Belaid, Sirine" userId="S::belaids@upmc.edu::5dcb4cf5-c058-49ea-93f8-4f4e6c877fcd" providerId="AD" clId="Web-{D93E0161-80AC-7C56-6200-80C72E39C791}" dt="2024-12-12T16:04:11.663" v="0"/>
          <ac:spMkLst>
            <pc:docMk/>
            <pc:sldMk cId="931904134" sldId="287"/>
            <ac:spMk id="24" creationId="{E0CBAC23-2E3F-4A90-BA59-F8299F6A5439}"/>
          </ac:spMkLst>
        </pc:spChg>
        <pc:grpChg chg="del">
          <ac:chgData name="Belaid, Sirine" userId="S::belaids@upmc.edu::5dcb4cf5-c058-49ea-93f8-4f4e6c877fcd" providerId="AD" clId="Web-{D93E0161-80AC-7C56-6200-80C72E39C791}" dt="2024-12-12T16:04:11.663" v="0"/>
          <ac:grpSpMkLst>
            <pc:docMk/>
            <pc:sldMk cId="931904134" sldId="287"/>
            <ac:grpSpMk id="12" creationId="{DAA26DFA-AAB2-4973-9C17-16D587C7B198}"/>
          </ac:grpSpMkLst>
        </pc:grpChg>
        <pc:graphicFrameChg chg="add">
          <ac:chgData name="Belaid, Sirine" userId="S::belaids@upmc.edu::5dcb4cf5-c058-49ea-93f8-4f4e6c877fcd" providerId="AD" clId="Web-{D93E0161-80AC-7C56-6200-80C72E39C791}" dt="2024-12-12T16:04:11.663" v="0"/>
          <ac:graphicFrameMkLst>
            <pc:docMk/>
            <pc:sldMk cId="931904134" sldId="287"/>
            <ac:graphicFrameMk id="18" creationId="{F4A10D47-5A5C-6403-E09B-7C4037E1435B}"/>
          </ac:graphicFrameMkLst>
        </pc:graphicFrameChg>
      </pc:sldChg>
      <pc:sldChg chg="mod modShow">
        <pc:chgData name="Belaid, Sirine" userId="S::belaids@upmc.edu::5dcb4cf5-c058-49ea-93f8-4f4e6c877fcd" providerId="AD" clId="Web-{D93E0161-80AC-7C56-6200-80C72E39C791}" dt="2024-12-12T16:36:35.500" v="132"/>
        <pc:sldMkLst>
          <pc:docMk/>
          <pc:sldMk cId="3594639168" sldId="294"/>
        </pc:sldMkLst>
      </pc:sldChg>
      <pc:sldChg chg="del">
        <pc:chgData name="Belaid, Sirine" userId="S::belaids@upmc.edu::5dcb4cf5-c058-49ea-93f8-4f4e6c877fcd" providerId="AD" clId="Web-{D93E0161-80AC-7C56-6200-80C72E39C791}" dt="2024-12-12T16:30:23.472" v="25"/>
        <pc:sldMkLst>
          <pc:docMk/>
          <pc:sldMk cId="0" sldId="349"/>
        </pc:sldMkLst>
      </pc:sldChg>
      <pc:sldChg chg="del">
        <pc:chgData name="Belaid, Sirine" userId="S::belaids@upmc.edu::5dcb4cf5-c058-49ea-93f8-4f4e6c877fcd" providerId="AD" clId="Web-{D93E0161-80AC-7C56-6200-80C72E39C791}" dt="2024-12-12T16:29:38.674" v="9"/>
        <pc:sldMkLst>
          <pc:docMk/>
          <pc:sldMk cId="481006994" sldId="353"/>
        </pc:sldMkLst>
      </pc:sldChg>
      <pc:sldChg chg="del">
        <pc:chgData name="Belaid, Sirine" userId="S::belaids@upmc.edu::5dcb4cf5-c058-49ea-93f8-4f4e6c877fcd" providerId="AD" clId="Web-{D93E0161-80AC-7C56-6200-80C72E39C791}" dt="2024-12-12T16:30:27.894" v="32"/>
        <pc:sldMkLst>
          <pc:docMk/>
          <pc:sldMk cId="983141598" sldId="372"/>
        </pc:sldMkLst>
      </pc:sldChg>
      <pc:sldChg chg="modSp">
        <pc:chgData name="Belaid, Sirine" userId="S::belaids@upmc.edu::5dcb4cf5-c058-49ea-93f8-4f4e6c877fcd" providerId="AD" clId="Web-{D93E0161-80AC-7C56-6200-80C72E39C791}" dt="2024-12-12T16:35:09.044" v="131" actId="1076"/>
        <pc:sldMkLst>
          <pc:docMk/>
          <pc:sldMk cId="1585369059" sldId="373"/>
        </pc:sldMkLst>
        <pc:spChg chg="mod">
          <ac:chgData name="Belaid, Sirine" userId="S::belaids@upmc.edu::5dcb4cf5-c058-49ea-93f8-4f4e6c877fcd" providerId="AD" clId="Web-{D93E0161-80AC-7C56-6200-80C72E39C791}" dt="2024-12-12T16:34:58.762" v="130" actId="1076"/>
          <ac:spMkLst>
            <pc:docMk/>
            <pc:sldMk cId="1585369059" sldId="373"/>
            <ac:spMk id="2" creationId="{FB724AC0-21F1-4947-B039-8B916AD90503}"/>
          </ac:spMkLst>
        </pc:spChg>
        <pc:spChg chg="mod">
          <ac:chgData name="Belaid, Sirine" userId="S::belaids@upmc.edu::5dcb4cf5-c058-49ea-93f8-4f4e6c877fcd" providerId="AD" clId="Web-{D93E0161-80AC-7C56-6200-80C72E39C791}" dt="2024-12-12T16:34:24.949" v="126" actId="1076"/>
          <ac:spMkLst>
            <pc:docMk/>
            <pc:sldMk cId="1585369059" sldId="373"/>
            <ac:spMk id="5" creationId="{9F58DC41-9621-4087-B8B6-EE4695F2E993}"/>
          </ac:spMkLst>
        </pc:spChg>
        <pc:spChg chg="mod">
          <ac:chgData name="Belaid, Sirine" userId="S::belaids@upmc.edu::5dcb4cf5-c058-49ea-93f8-4f4e6c877fcd" providerId="AD" clId="Web-{D93E0161-80AC-7C56-6200-80C72E39C791}" dt="2024-12-12T16:33:34.088" v="115" actId="1076"/>
          <ac:spMkLst>
            <pc:docMk/>
            <pc:sldMk cId="1585369059" sldId="373"/>
            <ac:spMk id="7" creationId="{9D47461E-0BB7-AAC9-5DA2-D49CDDA91C13}"/>
          </ac:spMkLst>
        </pc:spChg>
        <pc:spChg chg="mod">
          <ac:chgData name="Belaid, Sirine" userId="S::belaids@upmc.edu::5dcb4cf5-c058-49ea-93f8-4f4e6c877fcd" providerId="AD" clId="Web-{D93E0161-80AC-7C56-6200-80C72E39C791}" dt="2024-12-12T16:34:15.136" v="123" actId="1076"/>
          <ac:spMkLst>
            <pc:docMk/>
            <pc:sldMk cId="1585369059" sldId="373"/>
            <ac:spMk id="12" creationId="{782AAF26-D644-5F01-EDCE-1FD6496CC9B0}"/>
          </ac:spMkLst>
        </pc:spChg>
        <pc:spChg chg="mod">
          <ac:chgData name="Belaid, Sirine" userId="S::belaids@upmc.edu::5dcb4cf5-c058-49ea-93f8-4f4e6c877fcd" providerId="AD" clId="Web-{D93E0161-80AC-7C56-6200-80C72E39C791}" dt="2024-12-12T16:34:39.168" v="128" actId="1076"/>
          <ac:spMkLst>
            <pc:docMk/>
            <pc:sldMk cId="1585369059" sldId="373"/>
            <ac:spMk id="14" creationId="{EE865E3E-5B67-AF73-D7E3-344A997681D8}"/>
          </ac:spMkLst>
        </pc:spChg>
        <pc:picChg chg="mod">
          <ac:chgData name="Belaid, Sirine" userId="S::belaids@upmc.edu::5dcb4cf5-c058-49ea-93f8-4f4e6c877fcd" providerId="AD" clId="Web-{D93E0161-80AC-7C56-6200-80C72E39C791}" dt="2024-12-12T16:34:20.058" v="125" actId="1076"/>
          <ac:picMkLst>
            <pc:docMk/>
            <pc:sldMk cId="1585369059" sldId="373"/>
            <ac:picMk id="16" creationId="{52B19BB3-93DE-EACA-F901-197D9A1D6DA5}"/>
          </ac:picMkLst>
        </pc:picChg>
        <pc:picChg chg="mod">
          <ac:chgData name="Belaid, Sirine" userId="S::belaids@upmc.edu::5dcb4cf5-c058-49ea-93f8-4f4e6c877fcd" providerId="AD" clId="Web-{D93E0161-80AC-7C56-6200-80C72E39C791}" dt="2024-12-12T16:34:29.043" v="127" actId="1076"/>
          <ac:picMkLst>
            <pc:docMk/>
            <pc:sldMk cId="1585369059" sldId="373"/>
            <ac:picMk id="17" creationId="{F472A4CB-E883-4C2B-81DA-6562322C25FA}"/>
          </ac:picMkLst>
        </pc:picChg>
        <pc:picChg chg="mod">
          <ac:chgData name="Belaid, Sirine" userId="S::belaids@upmc.edu::5dcb4cf5-c058-49ea-93f8-4f4e6c877fcd" providerId="AD" clId="Web-{D93E0161-80AC-7C56-6200-80C72E39C791}" dt="2024-12-12T16:35:09.044" v="131" actId="1076"/>
          <ac:picMkLst>
            <pc:docMk/>
            <pc:sldMk cId="1585369059" sldId="373"/>
            <ac:picMk id="18" creationId="{710D269B-2DED-A3C6-53D4-BDDE8ACC3173}"/>
          </ac:picMkLst>
        </pc:picChg>
      </pc:sldChg>
      <pc:sldChg chg="del">
        <pc:chgData name="Belaid, Sirine" userId="S::belaids@upmc.edu::5dcb4cf5-c058-49ea-93f8-4f4e6c877fcd" providerId="AD" clId="Web-{D93E0161-80AC-7C56-6200-80C72E39C791}" dt="2024-12-12T16:30:23.488" v="27"/>
        <pc:sldMkLst>
          <pc:docMk/>
          <pc:sldMk cId="1670317384" sldId="397"/>
        </pc:sldMkLst>
      </pc:sldChg>
      <pc:sldChg chg="modSp add replId">
        <pc:chgData name="Belaid, Sirine" userId="S::belaids@upmc.edu::5dcb4cf5-c058-49ea-93f8-4f4e6c877fcd" providerId="AD" clId="Web-{D93E0161-80AC-7C56-6200-80C72E39C791}" dt="2024-12-12T16:32:45.680" v="113" actId="20577"/>
        <pc:sldMkLst>
          <pc:docMk/>
          <pc:sldMk cId="1117081788" sldId="399"/>
        </pc:sldMkLst>
        <pc:spChg chg="mod">
          <ac:chgData name="Belaid, Sirine" userId="S::belaids@upmc.edu::5dcb4cf5-c058-49ea-93f8-4f4e6c877fcd" providerId="AD" clId="Web-{D93E0161-80AC-7C56-6200-80C72E39C791}" dt="2024-12-12T16:31:14.099" v="36" actId="20577"/>
          <ac:spMkLst>
            <pc:docMk/>
            <pc:sldMk cId="1117081788" sldId="399"/>
            <ac:spMk id="2" creationId="{1E63AA7C-D8CC-24E2-1927-C63C14BF6FAB}"/>
          </ac:spMkLst>
        </pc:spChg>
        <pc:spChg chg="mod">
          <ac:chgData name="Belaid, Sirine" userId="S::belaids@upmc.edu::5dcb4cf5-c058-49ea-93f8-4f4e6c877fcd" providerId="AD" clId="Web-{D93E0161-80AC-7C56-6200-80C72E39C791}" dt="2024-12-12T16:32:45.680" v="113" actId="20577"/>
          <ac:spMkLst>
            <pc:docMk/>
            <pc:sldMk cId="1117081788" sldId="399"/>
            <ac:spMk id="3" creationId="{6B57145F-A3D4-5C8F-5BBE-CC4E7BC1E90B}"/>
          </ac:spMkLst>
        </pc:spChg>
      </pc:sldChg>
    </pc:docChg>
  </pc:docChgLst>
  <pc:docChgLst>
    <pc:chgData name="Belaid, Sirine" userId="S::belaids@upmc.edu::5dcb4cf5-c058-49ea-93f8-4f4e6c877fcd" providerId="AD" clId="Web-{C7A7A18F-85C4-4C01-9C3A-9C4567A637CC}"/>
    <pc:docChg chg="modSld">
      <pc:chgData name="Belaid, Sirine" userId="S::belaids@upmc.edu::5dcb4cf5-c058-49ea-93f8-4f4e6c877fcd" providerId="AD" clId="Web-{C7A7A18F-85C4-4C01-9C3A-9C4567A637CC}" dt="2024-11-22T01:04:47.654" v="11" actId="20577"/>
      <pc:docMkLst>
        <pc:docMk/>
      </pc:docMkLst>
      <pc:sldChg chg="modSp">
        <pc:chgData name="Belaid, Sirine" userId="S::belaids@upmc.edu::5dcb4cf5-c058-49ea-93f8-4f4e6c877fcd" providerId="AD" clId="Web-{C7A7A18F-85C4-4C01-9C3A-9C4567A637CC}" dt="2024-11-22T01:04:47.654" v="11" actId="20577"/>
        <pc:sldMkLst>
          <pc:docMk/>
          <pc:sldMk cId="1022786307" sldId="355"/>
        </pc:sldMkLst>
        <pc:spChg chg="mod">
          <ac:chgData name="Belaid, Sirine" userId="S::belaids@upmc.edu::5dcb4cf5-c058-49ea-93f8-4f4e6c877fcd" providerId="AD" clId="Web-{C7A7A18F-85C4-4C01-9C3A-9C4567A637CC}" dt="2024-11-22T01:04:47.654" v="11" actId="20577"/>
          <ac:spMkLst>
            <pc:docMk/>
            <pc:sldMk cId="1022786307" sldId="355"/>
            <ac:spMk id="2" creationId="{0EDE86FA-127C-32B5-5E79-B776E06C8F1C}"/>
          </ac:spMkLst>
        </pc:spChg>
      </pc:sldChg>
      <pc:sldChg chg="modNotes">
        <pc:chgData name="Belaid, Sirine" userId="S::belaids@upmc.edu::5dcb4cf5-c058-49ea-93f8-4f4e6c877fcd" providerId="AD" clId="Web-{C7A7A18F-85C4-4C01-9C3A-9C4567A637CC}" dt="2024-11-22T01:04:31.716" v="10"/>
        <pc:sldMkLst>
          <pc:docMk/>
          <pc:sldMk cId="1990103092" sldId="383"/>
        </pc:sldMkLst>
      </pc:sldChg>
    </pc:docChg>
  </pc:docChgLst>
  <pc:docChgLst>
    <pc:chgData name="Belaid, Sirine" userId="S::belaids@upmc.edu::5dcb4cf5-c058-49ea-93f8-4f4e6c877fcd" providerId="AD" clId="Web-{5E05E048-1A86-115E-5614-74E76CA65F15}"/>
    <pc:docChg chg="addSld modSld">
      <pc:chgData name="Belaid, Sirine" userId="S::belaids@upmc.edu::5dcb4cf5-c058-49ea-93f8-4f4e6c877fcd" providerId="AD" clId="Web-{5E05E048-1A86-115E-5614-74E76CA65F15}" dt="2024-11-12T15:18:26.412" v="70" actId="20577"/>
      <pc:docMkLst>
        <pc:docMk/>
      </pc:docMkLst>
      <pc:sldChg chg="modSp new">
        <pc:chgData name="Belaid, Sirine" userId="S::belaids@upmc.edu::5dcb4cf5-c058-49ea-93f8-4f4e6c877fcd" providerId="AD" clId="Web-{5E05E048-1A86-115E-5614-74E76CA65F15}" dt="2024-11-12T15:18:17.693" v="54" actId="20577"/>
        <pc:sldMkLst>
          <pc:docMk/>
          <pc:sldMk cId="1491156070" sldId="257"/>
        </pc:sldMkLst>
        <pc:spChg chg="mod">
          <ac:chgData name="Belaid, Sirine" userId="S::belaids@upmc.edu::5dcb4cf5-c058-49ea-93f8-4f4e6c877fcd" providerId="AD" clId="Web-{5E05E048-1A86-115E-5614-74E76CA65F15}" dt="2024-11-12T15:05:39.068" v="9" actId="20577"/>
          <ac:spMkLst>
            <pc:docMk/>
            <pc:sldMk cId="1491156070" sldId="257"/>
            <ac:spMk id="2" creationId="{06E2AEE0-4A9B-F0FC-0EC4-7B9EB29E7B34}"/>
          </ac:spMkLst>
        </pc:spChg>
        <pc:spChg chg="mod">
          <ac:chgData name="Belaid, Sirine" userId="S::belaids@upmc.edu::5dcb4cf5-c058-49ea-93f8-4f4e6c877fcd" providerId="AD" clId="Web-{5E05E048-1A86-115E-5614-74E76CA65F15}" dt="2024-11-12T15:18:17.693" v="54" actId="20577"/>
          <ac:spMkLst>
            <pc:docMk/>
            <pc:sldMk cId="1491156070" sldId="257"/>
            <ac:spMk id="3" creationId="{283F0732-6ED3-A107-57EE-B45417AADBF0}"/>
          </ac:spMkLst>
        </pc:spChg>
      </pc:sldChg>
      <pc:sldChg chg="modSp new">
        <pc:chgData name="Belaid, Sirine" userId="S::belaids@upmc.edu::5dcb4cf5-c058-49ea-93f8-4f4e6c877fcd" providerId="AD" clId="Web-{5E05E048-1A86-115E-5614-74E76CA65F15}" dt="2024-11-12T15:18:26.412" v="70" actId="20577"/>
        <pc:sldMkLst>
          <pc:docMk/>
          <pc:sldMk cId="1500721348" sldId="258"/>
        </pc:sldMkLst>
        <pc:spChg chg="mod">
          <ac:chgData name="Belaid, Sirine" userId="S::belaids@upmc.edu::5dcb4cf5-c058-49ea-93f8-4f4e6c877fcd" providerId="AD" clId="Web-{5E05E048-1A86-115E-5614-74E76CA65F15}" dt="2024-11-12T15:18:26.412" v="70" actId="20577"/>
          <ac:spMkLst>
            <pc:docMk/>
            <pc:sldMk cId="1500721348" sldId="258"/>
            <ac:spMk id="2" creationId="{D92E322D-5432-20CD-FED8-415687922947}"/>
          </ac:spMkLst>
        </pc:spChg>
      </pc:sldChg>
      <pc:sldChg chg="new">
        <pc:chgData name="Belaid, Sirine" userId="S::belaids@upmc.edu::5dcb4cf5-c058-49ea-93f8-4f4e6c877fcd" providerId="AD" clId="Web-{5E05E048-1A86-115E-5614-74E76CA65F15}" dt="2024-11-12T15:05:21.724" v="2"/>
        <pc:sldMkLst>
          <pc:docMk/>
          <pc:sldMk cId="344766927" sldId="259"/>
        </pc:sldMkLst>
      </pc:sldChg>
      <pc:sldChg chg="new">
        <pc:chgData name="Belaid, Sirine" userId="S::belaids@upmc.edu::5dcb4cf5-c058-49ea-93f8-4f4e6c877fcd" providerId="AD" clId="Web-{5E05E048-1A86-115E-5614-74E76CA65F15}" dt="2024-11-12T15:05:23.224" v="3"/>
        <pc:sldMkLst>
          <pc:docMk/>
          <pc:sldMk cId="3651327643" sldId="260"/>
        </pc:sldMkLst>
      </pc:sldChg>
      <pc:sldChg chg="new">
        <pc:chgData name="Belaid, Sirine" userId="S::belaids@upmc.edu::5dcb4cf5-c058-49ea-93f8-4f4e6c877fcd" providerId="AD" clId="Web-{5E05E048-1A86-115E-5614-74E76CA65F15}" dt="2024-11-12T15:05:24.833" v="4"/>
        <pc:sldMkLst>
          <pc:docMk/>
          <pc:sldMk cId="2302766718" sldId="261"/>
        </pc:sldMkLst>
      </pc:sldChg>
      <pc:sldChg chg="new">
        <pc:chgData name="Belaid, Sirine" userId="S::belaids@upmc.edu::5dcb4cf5-c058-49ea-93f8-4f4e6c877fcd" providerId="AD" clId="Web-{5E05E048-1A86-115E-5614-74E76CA65F15}" dt="2024-11-12T15:05:26.599" v="5"/>
        <pc:sldMkLst>
          <pc:docMk/>
          <pc:sldMk cId="576414548" sldId="262"/>
        </pc:sldMkLst>
      </pc:sldChg>
      <pc:sldChg chg="new">
        <pc:chgData name="Belaid, Sirine" userId="S::belaids@upmc.edu::5dcb4cf5-c058-49ea-93f8-4f4e6c877fcd" providerId="AD" clId="Web-{5E05E048-1A86-115E-5614-74E76CA65F15}" dt="2024-11-12T15:05:28.036" v="6"/>
        <pc:sldMkLst>
          <pc:docMk/>
          <pc:sldMk cId="339090689" sldId="263"/>
        </pc:sldMkLst>
      </pc:sldChg>
    </pc:docChg>
  </pc:docChgLst>
  <pc:docChgLst>
    <pc:chgData name="Belaid, Sirine" userId="S::belaids@upmc.edu::5dcb4cf5-c058-49ea-93f8-4f4e6c877fcd" providerId="AD" clId="Web-{C6E71903-7883-6B8F-75F3-0E729A5B177E}"/>
    <pc:docChg chg="addSld">
      <pc:chgData name="Belaid, Sirine" userId="S::belaids@upmc.edu::5dcb4cf5-c058-49ea-93f8-4f4e6c877fcd" providerId="AD" clId="Web-{C6E71903-7883-6B8F-75F3-0E729A5B177E}" dt="2024-11-19T14:20:04.181" v="0"/>
      <pc:docMkLst>
        <pc:docMk/>
      </pc:docMkLst>
      <pc:sldChg chg="new">
        <pc:chgData name="Belaid, Sirine" userId="S::belaids@upmc.edu::5dcb4cf5-c058-49ea-93f8-4f4e6c877fcd" providerId="AD" clId="Web-{C6E71903-7883-6B8F-75F3-0E729A5B177E}" dt="2024-11-19T14:20:04.181" v="0"/>
        <pc:sldMkLst>
          <pc:docMk/>
          <pc:sldMk cId="2595590755" sldId="264"/>
        </pc:sldMkLst>
      </pc:sldChg>
    </pc:docChg>
  </pc:docChgLst>
  <pc:docChgLst>
    <pc:chgData name="Belaid, Sirine" userId="S::belaids@upmc.edu::5dcb4cf5-c058-49ea-93f8-4f4e6c877fcd" providerId="AD" clId="Web-{DB16CD52-E380-E1AE-46F2-FC40BAFDB119}"/>
    <pc:docChg chg="addSld delSld modSld">
      <pc:chgData name="Belaid, Sirine" userId="S::belaids@upmc.edu::5dcb4cf5-c058-49ea-93f8-4f4e6c877fcd" providerId="AD" clId="Web-{DB16CD52-E380-E1AE-46F2-FC40BAFDB119}" dt="2024-11-21T01:20:02.267" v="754"/>
      <pc:docMkLst>
        <pc:docMk/>
      </pc:docMkLst>
      <pc:sldChg chg="del modNotes">
        <pc:chgData name="Belaid, Sirine" userId="S::belaids@upmc.edu::5dcb4cf5-c058-49ea-93f8-4f4e6c877fcd" providerId="AD" clId="Web-{DB16CD52-E380-E1AE-46F2-FC40BAFDB119}" dt="2024-11-21T00:21:10.383" v="266"/>
        <pc:sldMkLst>
          <pc:docMk/>
          <pc:sldMk cId="2531899748" sldId="293"/>
        </pc:sldMkLst>
      </pc:sldChg>
      <pc:sldChg chg="addSp delSp modSp mod modShow">
        <pc:chgData name="Belaid, Sirine" userId="S::belaids@upmc.edu::5dcb4cf5-c058-49ea-93f8-4f4e6c877fcd" providerId="AD" clId="Web-{DB16CD52-E380-E1AE-46F2-FC40BAFDB119}" dt="2024-11-21T00:38:23.991" v="418"/>
        <pc:sldMkLst>
          <pc:docMk/>
          <pc:sldMk cId="3594639168" sldId="294"/>
        </pc:sldMkLst>
        <pc:spChg chg="del">
          <ac:chgData name="Belaid, Sirine" userId="S::belaids@upmc.edu::5dcb4cf5-c058-49ea-93f8-4f4e6c877fcd" providerId="AD" clId="Web-{DB16CD52-E380-E1AE-46F2-FC40BAFDB119}" dt="2024-11-21T00:38:06.225" v="412"/>
          <ac:spMkLst>
            <pc:docMk/>
            <pc:sldMk cId="3594639168" sldId="294"/>
            <ac:spMk id="2" creationId="{258360A0-C121-F080-9B84-7C5F873CF389}"/>
          </ac:spMkLst>
        </pc:spChg>
        <pc:spChg chg="del">
          <ac:chgData name="Belaid, Sirine" userId="S::belaids@upmc.edu::5dcb4cf5-c058-49ea-93f8-4f4e6c877fcd" providerId="AD" clId="Web-{DB16CD52-E380-E1AE-46F2-FC40BAFDB119}" dt="2024-11-21T00:37:51.802" v="409"/>
          <ac:spMkLst>
            <pc:docMk/>
            <pc:sldMk cId="3594639168" sldId="294"/>
            <ac:spMk id="3" creationId="{A53CB8EC-3ECD-46FF-2459-E3E90E30F5B3}"/>
          </ac:spMkLst>
        </pc:spChg>
        <pc:picChg chg="add mod ord">
          <ac:chgData name="Belaid, Sirine" userId="S::belaids@upmc.edu::5dcb4cf5-c058-49ea-93f8-4f4e6c877fcd" providerId="AD" clId="Web-{DB16CD52-E380-E1AE-46F2-FC40BAFDB119}" dt="2024-11-21T00:38:18.147" v="417" actId="14100"/>
          <ac:picMkLst>
            <pc:docMk/>
            <pc:sldMk cId="3594639168" sldId="294"/>
            <ac:picMk id="4" creationId="{15754B00-BE5C-ACB5-D817-0B03BBCC147B}"/>
          </ac:picMkLst>
        </pc:picChg>
      </pc:sldChg>
      <pc:sldChg chg="modSp">
        <pc:chgData name="Belaid, Sirine" userId="S::belaids@upmc.edu::5dcb4cf5-c058-49ea-93f8-4f4e6c877fcd" providerId="AD" clId="Web-{DB16CD52-E380-E1AE-46F2-FC40BAFDB119}" dt="2024-11-21T00:03:44.226" v="191" actId="1076"/>
        <pc:sldMkLst>
          <pc:docMk/>
          <pc:sldMk cId="4094227945" sldId="352"/>
        </pc:sldMkLst>
        <pc:spChg chg="mod">
          <ac:chgData name="Belaid, Sirine" userId="S::belaids@upmc.edu::5dcb4cf5-c058-49ea-93f8-4f4e6c877fcd" providerId="AD" clId="Web-{DB16CD52-E380-E1AE-46F2-FC40BAFDB119}" dt="2024-11-21T00:03:44.226" v="191" actId="1076"/>
          <ac:spMkLst>
            <pc:docMk/>
            <pc:sldMk cId="4094227945" sldId="352"/>
            <ac:spMk id="3" creationId="{54D52FF0-F483-CAD8-917A-930506D4F12A}"/>
          </ac:spMkLst>
        </pc:spChg>
      </pc:sldChg>
      <pc:sldChg chg="modSp">
        <pc:chgData name="Belaid, Sirine" userId="S::belaids@upmc.edu::5dcb4cf5-c058-49ea-93f8-4f4e6c877fcd" providerId="AD" clId="Web-{DB16CD52-E380-E1AE-46F2-FC40BAFDB119}" dt="2024-11-20T23:49:51.879" v="50" actId="14100"/>
        <pc:sldMkLst>
          <pc:docMk/>
          <pc:sldMk cId="1022786307" sldId="355"/>
        </pc:sldMkLst>
        <pc:spChg chg="mod">
          <ac:chgData name="Belaid, Sirine" userId="S::belaids@upmc.edu::5dcb4cf5-c058-49ea-93f8-4f4e6c877fcd" providerId="AD" clId="Web-{DB16CD52-E380-E1AE-46F2-FC40BAFDB119}" dt="2024-11-20T23:49:51.879" v="50" actId="14100"/>
          <ac:spMkLst>
            <pc:docMk/>
            <pc:sldMk cId="1022786307" sldId="355"/>
            <ac:spMk id="3" creationId="{1C74E49B-EF04-8C3D-7D26-98DBD002E7B7}"/>
          </ac:spMkLst>
        </pc:spChg>
      </pc:sldChg>
      <pc:sldChg chg="modSp modNotes">
        <pc:chgData name="Belaid, Sirine" userId="S::belaids@upmc.edu::5dcb4cf5-c058-49ea-93f8-4f4e6c877fcd" providerId="AD" clId="Web-{DB16CD52-E380-E1AE-46F2-FC40BAFDB119}" dt="2024-11-21T00:02:37.050" v="150" actId="20577"/>
        <pc:sldMkLst>
          <pc:docMk/>
          <pc:sldMk cId="3868067760" sldId="357"/>
        </pc:sldMkLst>
        <pc:spChg chg="mod">
          <ac:chgData name="Belaid, Sirine" userId="S::belaids@upmc.edu::5dcb4cf5-c058-49ea-93f8-4f4e6c877fcd" providerId="AD" clId="Web-{DB16CD52-E380-E1AE-46F2-FC40BAFDB119}" dt="2024-11-21T00:02:37.050" v="150" actId="20577"/>
          <ac:spMkLst>
            <pc:docMk/>
            <pc:sldMk cId="3868067760" sldId="357"/>
            <ac:spMk id="3" creationId="{C6C10584-5F60-48A3-BCF3-AF01322CF6C3}"/>
          </ac:spMkLst>
        </pc:spChg>
      </pc:sldChg>
      <pc:sldChg chg="addSp modSp">
        <pc:chgData name="Belaid, Sirine" userId="S::belaids@upmc.edu::5dcb4cf5-c058-49ea-93f8-4f4e6c877fcd" providerId="AD" clId="Web-{DB16CD52-E380-E1AE-46F2-FC40BAFDB119}" dt="2024-11-20T23:48:52.579" v="49" actId="1076"/>
        <pc:sldMkLst>
          <pc:docMk/>
          <pc:sldMk cId="1919480477" sldId="360"/>
        </pc:sldMkLst>
        <pc:spChg chg="mod">
          <ac:chgData name="Belaid, Sirine" userId="S::belaids@upmc.edu::5dcb4cf5-c058-49ea-93f8-4f4e6c877fcd" providerId="AD" clId="Web-{DB16CD52-E380-E1AE-46F2-FC40BAFDB119}" dt="2024-11-20T23:46:43.743" v="26" actId="1076"/>
          <ac:spMkLst>
            <pc:docMk/>
            <pc:sldMk cId="1919480477" sldId="360"/>
            <ac:spMk id="3" creationId="{6CCD5ABF-F289-6DF4-D01E-776F3BB7441A}"/>
          </ac:spMkLst>
        </pc:spChg>
        <pc:spChg chg="add mod">
          <ac:chgData name="Belaid, Sirine" userId="S::belaids@upmc.edu::5dcb4cf5-c058-49ea-93f8-4f4e6c877fcd" providerId="AD" clId="Web-{DB16CD52-E380-E1AE-46F2-FC40BAFDB119}" dt="2024-11-20T23:47:53.825" v="44" actId="20577"/>
          <ac:spMkLst>
            <pc:docMk/>
            <pc:sldMk cId="1919480477" sldId="360"/>
            <ac:spMk id="4" creationId="{BC1764D5-760C-CB8E-B008-E46689C2012F}"/>
          </ac:spMkLst>
        </pc:spChg>
        <pc:spChg chg="add mod">
          <ac:chgData name="Belaid, Sirine" userId="S::belaids@upmc.edu::5dcb4cf5-c058-49ea-93f8-4f4e6c877fcd" providerId="AD" clId="Web-{DB16CD52-E380-E1AE-46F2-FC40BAFDB119}" dt="2024-11-20T23:48:52.579" v="49" actId="1076"/>
          <ac:spMkLst>
            <pc:docMk/>
            <pc:sldMk cId="1919480477" sldId="360"/>
            <ac:spMk id="6" creationId="{C33B9BD3-ECFC-E1EF-D683-0E97D7FA1078}"/>
          </ac:spMkLst>
        </pc:spChg>
      </pc:sldChg>
      <pc:sldChg chg="addSp delSp modSp">
        <pc:chgData name="Belaid, Sirine" userId="S::belaids@upmc.edu::5dcb4cf5-c058-49ea-93f8-4f4e6c877fcd" providerId="AD" clId="Web-{DB16CD52-E380-E1AE-46F2-FC40BAFDB119}" dt="2024-11-20T23:52:04.293" v="57" actId="1076"/>
        <pc:sldMkLst>
          <pc:docMk/>
          <pc:sldMk cId="2090633080" sldId="362"/>
        </pc:sldMkLst>
        <pc:spChg chg="mod">
          <ac:chgData name="Belaid, Sirine" userId="S::belaids@upmc.edu::5dcb4cf5-c058-49ea-93f8-4f4e6c877fcd" providerId="AD" clId="Web-{DB16CD52-E380-E1AE-46F2-FC40BAFDB119}" dt="2024-11-20T23:52:01.090" v="56" actId="1076"/>
          <ac:spMkLst>
            <pc:docMk/>
            <pc:sldMk cId="2090633080" sldId="362"/>
            <ac:spMk id="3" creationId="{7639CC8F-08C3-8406-49DC-53CA41C3EDD0}"/>
          </ac:spMkLst>
        </pc:spChg>
        <pc:spChg chg="add del">
          <ac:chgData name="Belaid, Sirine" userId="S::belaids@upmc.edu::5dcb4cf5-c058-49ea-93f8-4f4e6c877fcd" providerId="AD" clId="Web-{DB16CD52-E380-E1AE-46F2-FC40BAFDB119}" dt="2024-11-20T23:51:42.589" v="52"/>
          <ac:spMkLst>
            <pc:docMk/>
            <pc:sldMk cId="2090633080" sldId="362"/>
            <ac:spMk id="4" creationId="{04357C93-F0CB-4A1C-8F77-4E9063789819}"/>
          </ac:spMkLst>
        </pc:spChg>
        <pc:picChg chg="add mod">
          <ac:chgData name="Belaid, Sirine" userId="S::belaids@upmc.edu::5dcb4cf5-c058-49ea-93f8-4f4e6c877fcd" providerId="AD" clId="Web-{DB16CD52-E380-E1AE-46F2-FC40BAFDB119}" dt="2024-11-20T23:52:04.293" v="57" actId="1076"/>
          <ac:picMkLst>
            <pc:docMk/>
            <pc:sldMk cId="2090633080" sldId="362"/>
            <ac:picMk id="5" creationId="{CDB56A19-B131-8567-B59B-78FF0F2B1E3F}"/>
          </ac:picMkLst>
        </pc:picChg>
      </pc:sldChg>
      <pc:sldChg chg="modSp">
        <pc:chgData name="Belaid, Sirine" userId="S::belaids@upmc.edu::5dcb4cf5-c058-49ea-93f8-4f4e6c877fcd" providerId="AD" clId="Web-{DB16CD52-E380-E1AE-46F2-FC40BAFDB119}" dt="2024-11-20T23:43:54.498" v="0" actId="20577"/>
        <pc:sldMkLst>
          <pc:docMk/>
          <pc:sldMk cId="2684994436" sldId="371"/>
        </pc:sldMkLst>
        <pc:spChg chg="mod">
          <ac:chgData name="Belaid, Sirine" userId="S::belaids@upmc.edu::5dcb4cf5-c058-49ea-93f8-4f4e6c877fcd" providerId="AD" clId="Web-{DB16CD52-E380-E1AE-46F2-FC40BAFDB119}" dt="2024-11-20T23:43:54.498" v="0" actId="20577"/>
          <ac:spMkLst>
            <pc:docMk/>
            <pc:sldMk cId="2684994436" sldId="371"/>
            <ac:spMk id="6" creationId="{C78CA2CC-86D2-060F-868C-9F116C227D9B}"/>
          </ac:spMkLst>
        </pc:spChg>
      </pc:sldChg>
      <pc:sldChg chg="modSp add replId modNotes">
        <pc:chgData name="Belaid, Sirine" userId="S::belaids@upmc.edu::5dcb4cf5-c058-49ea-93f8-4f4e6c877fcd" providerId="AD" clId="Web-{DB16CD52-E380-E1AE-46F2-FC40BAFDB119}" dt="2024-11-21T00:24:29.848" v="294"/>
        <pc:sldMkLst>
          <pc:docMk/>
          <pc:sldMk cId="983141598" sldId="372"/>
        </pc:sldMkLst>
        <pc:spChg chg="mod">
          <ac:chgData name="Belaid, Sirine" userId="S::belaids@upmc.edu::5dcb4cf5-c058-49ea-93f8-4f4e6c877fcd" providerId="AD" clId="Web-{DB16CD52-E380-E1AE-46F2-FC40BAFDB119}" dt="2024-11-21T00:18:43.343" v="197" actId="20577"/>
          <ac:spMkLst>
            <pc:docMk/>
            <pc:sldMk cId="983141598" sldId="372"/>
            <ac:spMk id="2" creationId="{1E63AA7C-D8CC-24E2-1927-C63C14BF6FAB}"/>
          </ac:spMkLst>
        </pc:spChg>
        <pc:spChg chg="mod">
          <ac:chgData name="Belaid, Sirine" userId="S::belaids@upmc.edu::5dcb4cf5-c058-49ea-93f8-4f4e6c877fcd" providerId="AD" clId="Web-{DB16CD52-E380-E1AE-46F2-FC40BAFDB119}" dt="2024-11-21T00:19:27.767" v="218" actId="20577"/>
          <ac:spMkLst>
            <pc:docMk/>
            <pc:sldMk cId="983141598" sldId="372"/>
            <ac:spMk id="3" creationId="{6B57145F-A3D4-5C8F-5BBE-CC4E7BC1E90B}"/>
          </ac:spMkLst>
        </pc:spChg>
      </pc:sldChg>
      <pc:sldChg chg="new del">
        <pc:chgData name="Belaid, Sirine" userId="S::belaids@upmc.edu::5dcb4cf5-c058-49ea-93f8-4f4e6c877fcd" providerId="AD" clId="Web-{DB16CD52-E380-E1AE-46F2-FC40BAFDB119}" dt="2024-11-21T00:18:00.715" v="193"/>
        <pc:sldMkLst>
          <pc:docMk/>
          <pc:sldMk cId="1567485361" sldId="372"/>
        </pc:sldMkLst>
      </pc:sldChg>
      <pc:sldChg chg="addSp delSp modSp add">
        <pc:chgData name="Belaid, Sirine" userId="S::belaids@upmc.edu::5dcb4cf5-c058-49ea-93f8-4f4e6c877fcd" providerId="AD" clId="Web-{DB16CD52-E380-E1AE-46F2-FC40BAFDB119}" dt="2024-11-21T00:35:21.402" v="408" actId="1076"/>
        <pc:sldMkLst>
          <pc:docMk/>
          <pc:sldMk cId="1585369059" sldId="373"/>
        </pc:sldMkLst>
        <pc:spChg chg="mod">
          <ac:chgData name="Belaid, Sirine" userId="S::belaids@upmc.edu::5dcb4cf5-c058-49ea-93f8-4f4e6c877fcd" providerId="AD" clId="Web-{DB16CD52-E380-E1AE-46F2-FC40BAFDB119}" dt="2024-11-21T00:31:56.359" v="396" actId="1076"/>
          <ac:spMkLst>
            <pc:docMk/>
            <pc:sldMk cId="1585369059" sldId="373"/>
            <ac:spMk id="2" creationId="{FB724AC0-21F1-4947-B039-8B916AD90503}"/>
          </ac:spMkLst>
        </pc:spChg>
        <pc:spChg chg="add del mod">
          <ac:chgData name="Belaid, Sirine" userId="S::belaids@upmc.edu::5dcb4cf5-c058-49ea-93f8-4f4e6c877fcd" providerId="AD" clId="Web-{DB16CD52-E380-E1AE-46F2-FC40BAFDB119}" dt="2024-11-21T00:28:36.081" v="353"/>
          <ac:spMkLst>
            <pc:docMk/>
            <pc:sldMk cId="1585369059" sldId="373"/>
            <ac:spMk id="4" creationId="{9BA359BB-9ACC-5A77-BDCC-96D3AB6F7570}"/>
          </ac:spMkLst>
        </pc:spChg>
        <pc:spChg chg="mod">
          <ac:chgData name="Belaid, Sirine" userId="S::belaids@upmc.edu::5dcb4cf5-c058-49ea-93f8-4f4e6c877fcd" providerId="AD" clId="Web-{DB16CD52-E380-E1AE-46F2-FC40BAFDB119}" dt="2024-11-21T00:29:53.898" v="369" actId="1076"/>
          <ac:spMkLst>
            <pc:docMk/>
            <pc:sldMk cId="1585369059" sldId="373"/>
            <ac:spMk id="5" creationId="{9F58DC41-9621-4087-B8B6-EE4695F2E993}"/>
          </ac:spMkLst>
        </pc:spChg>
        <pc:spChg chg="add mod">
          <ac:chgData name="Belaid, Sirine" userId="S::belaids@upmc.edu::5dcb4cf5-c058-49ea-93f8-4f4e6c877fcd" providerId="AD" clId="Web-{DB16CD52-E380-E1AE-46F2-FC40BAFDB119}" dt="2024-11-21T00:30:12.181" v="375" actId="1076"/>
          <ac:spMkLst>
            <pc:docMk/>
            <pc:sldMk cId="1585369059" sldId="373"/>
            <ac:spMk id="7" creationId="{9D47461E-0BB7-AAC9-5DA2-D49CDDA91C13}"/>
          </ac:spMkLst>
        </pc:spChg>
        <pc:spChg chg="add mod">
          <ac:chgData name="Belaid, Sirine" userId="S::belaids@upmc.edu::5dcb4cf5-c058-49ea-93f8-4f4e6c877fcd" providerId="AD" clId="Web-{DB16CD52-E380-E1AE-46F2-FC40BAFDB119}" dt="2024-11-21T00:30:49.042" v="385" actId="20577"/>
          <ac:spMkLst>
            <pc:docMk/>
            <pc:sldMk cId="1585369059" sldId="373"/>
            <ac:spMk id="12" creationId="{782AAF26-D644-5F01-EDCE-1FD6496CC9B0}"/>
          </ac:spMkLst>
        </pc:spChg>
        <pc:spChg chg="add mod">
          <ac:chgData name="Belaid, Sirine" userId="S::belaids@upmc.edu::5dcb4cf5-c058-49ea-93f8-4f4e6c877fcd" providerId="AD" clId="Web-{DB16CD52-E380-E1AE-46F2-FC40BAFDB119}" dt="2024-11-21T00:32:00.968" v="397" actId="1076"/>
          <ac:spMkLst>
            <pc:docMk/>
            <pc:sldMk cId="1585369059" sldId="373"/>
            <ac:spMk id="14" creationId="{EE865E3E-5B67-AF73-D7E3-344A997681D8}"/>
          </ac:spMkLst>
        </pc:spChg>
        <pc:spChg chg="add del mod">
          <ac:chgData name="Belaid, Sirine" userId="S::belaids@upmc.edu::5dcb4cf5-c058-49ea-93f8-4f4e6c877fcd" providerId="AD" clId="Web-{DB16CD52-E380-E1AE-46F2-FC40BAFDB119}" dt="2024-11-21T00:35:18.340" v="407"/>
          <ac:spMkLst>
            <pc:docMk/>
            <pc:sldMk cId="1585369059" sldId="373"/>
            <ac:spMk id="20" creationId="{BF462876-F9BE-EDB5-A831-4120B5643B58}"/>
          </ac:spMkLst>
        </pc:spChg>
        <pc:picChg chg="add del mod">
          <ac:chgData name="Belaid, Sirine" userId="S::belaids@upmc.edu::5dcb4cf5-c058-49ea-93f8-4f4e6c877fcd" providerId="AD" clId="Web-{DB16CD52-E380-E1AE-46F2-FC40BAFDB119}" dt="2024-11-21T00:34:56.948" v="404"/>
          <ac:picMkLst>
            <pc:docMk/>
            <pc:sldMk cId="1585369059" sldId="373"/>
            <ac:picMk id="9" creationId="{7FC37908-F77F-90DF-F8AC-0D574E969D48}"/>
          </ac:picMkLst>
        </pc:picChg>
        <pc:picChg chg="add del">
          <ac:chgData name="Belaid, Sirine" userId="S::belaids@upmc.edu::5dcb4cf5-c058-49ea-93f8-4f4e6c877fcd" providerId="AD" clId="Web-{DB16CD52-E380-E1AE-46F2-FC40BAFDB119}" dt="2024-11-21T00:30:38.807" v="380"/>
          <ac:picMkLst>
            <pc:docMk/>
            <pc:sldMk cId="1585369059" sldId="373"/>
            <ac:picMk id="11" creationId="{3A2062D9-00AC-A6C0-9811-F6D9BCEADF2E}"/>
          </ac:picMkLst>
        </pc:picChg>
        <pc:picChg chg="add mod">
          <ac:chgData name="Belaid, Sirine" userId="S::belaids@upmc.edu::5dcb4cf5-c058-49ea-93f8-4f4e6c877fcd" providerId="AD" clId="Web-{DB16CD52-E380-E1AE-46F2-FC40BAFDB119}" dt="2024-11-21T00:31:38.905" v="394" actId="1076"/>
          <ac:picMkLst>
            <pc:docMk/>
            <pc:sldMk cId="1585369059" sldId="373"/>
            <ac:picMk id="16" creationId="{52B19BB3-93DE-EACA-F901-197D9A1D6DA5}"/>
          </ac:picMkLst>
        </pc:picChg>
        <pc:picChg chg="add mod">
          <ac:chgData name="Belaid, Sirine" userId="S::belaids@upmc.edu::5dcb4cf5-c058-49ea-93f8-4f4e6c877fcd" providerId="AD" clId="Web-{DB16CD52-E380-E1AE-46F2-FC40BAFDB119}" dt="2024-11-21T00:33:50.522" v="401" actId="1076"/>
          <ac:picMkLst>
            <pc:docMk/>
            <pc:sldMk cId="1585369059" sldId="373"/>
            <ac:picMk id="17" creationId="{F472A4CB-E883-4C2B-81DA-6562322C25FA}"/>
          </ac:picMkLst>
        </pc:picChg>
        <pc:picChg chg="add mod">
          <ac:chgData name="Belaid, Sirine" userId="S::belaids@upmc.edu::5dcb4cf5-c058-49ea-93f8-4f4e6c877fcd" providerId="AD" clId="Web-{DB16CD52-E380-E1AE-46F2-FC40BAFDB119}" dt="2024-11-21T00:35:21.402" v="408" actId="1076"/>
          <ac:picMkLst>
            <pc:docMk/>
            <pc:sldMk cId="1585369059" sldId="373"/>
            <ac:picMk id="18" creationId="{710D269B-2DED-A3C6-53D4-BDDE8ACC3173}"/>
          </ac:picMkLst>
        </pc:picChg>
        <pc:picChg chg="del">
          <ac:chgData name="Belaid, Sirine" userId="S::belaids@upmc.edu::5dcb4cf5-c058-49ea-93f8-4f4e6c877fcd" providerId="AD" clId="Web-{DB16CD52-E380-E1AE-46F2-FC40BAFDB119}" dt="2024-11-21T00:28:26.409" v="352"/>
          <ac:picMkLst>
            <pc:docMk/>
            <pc:sldMk cId="1585369059" sldId="373"/>
            <ac:picMk id="2050" creationId="{851A54D3-43AA-409A-8523-B2FD6A24ACCC}"/>
          </ac:picMkLst>
        </pc:picChg>
        <pc:picChg chg="del mod">
          <ac:chgData name="Belaid, Sirine" userId="S::belaids@upmc.edu::5dcb4cf5-c058-49ea-93f8-4f4e6c877fcd" providerId="AD" clId="Web-{DB16CD52-E380-E1AE-46F2-FC40BAFDB119}" dt="2024-11-21T00:32:53.393" v="398"/>
          <ac:picMkLst>
            <pc:docMk/>
            <pc:sldMk cId="1585369059" sldId="373"/>
            <ac:picMk id="2052" creationId="{61DE33C6-C278-4BC5-82DD-BDD462AC73FB}"/>
          </ac:picMkLst>
        </pc:picChg>
      </pc:sldChg>
      <pc:sldChg chg="add del replId">
        <pc:chgData name="Belaid, Sirine" userId="S::belaids@upmc.edu::5dcb4cf5-c058-49ea-93f8-4f4e6c877fcd" providerId="AD" clId="Web-{DB16CD52-E380-E1AE-46F2-FC40BAFDB119}" dt="2024-11-21T00:20:54.163" v="264"/>
        <pc:sldMkLst>
          <pc:docMk/>
          <pc:sldMk cId="2112067454" sldId="373"/>
        </pc:sldMkLst>
      </pc:sldChg>
      <pc:sldChg chg="modSp add del">
        <pc:chgData name="Belaid, Sirine" userId="S::belaids@upmc.edu::5dcb4cf5-c058-49ea-93f8-4f4e6c877fcd" providerId="AD" clId="Web-{DB16CD52-E380-E1AE-46F2-FC40BAFDB119}" dt="2024-11-21T00:38:01.834" v="411"/>
        <pc:sldMkLst>
          <pc:docMk/>
          <pc:sldMk cId="2150412935" sldId="374"/>
        </pc:sldMkLst>
        <pc:spChg chg="mod">
          <ac:chgData name="Belaid, Sirine" userId="S::belaids@upmc.edu::5dcb4cf5-c058-49ea-93f8-4f4e6c877fcd" providerId="AD" clId="Web-{DB16CD52-E380-E1AE-46F2-FC40BAFDB119}" dt="2024-11-21T00:28:52.488" v="356" actId="14100"/>
          <ac:spMkLst>
            <pc:docMk/>
            <pc:sldMk cId="2150412935" sldId="374"/>
            <ac:spMk id="2" creationId="{AE4BF168-4EF8-4E1D-AD2E-A44561535F1A}"/>
          </ac:spMkLst>
        </pc:spChg>
        <pc:spChg chg="mod">
          <ac:chgData name="Belaid, Sirine" userId="S::belaids@upmc.edu::5dcb4cf5-c058-49ea-93f8-4f4e6c877fcd" providerId="AD" clId="Web-{DB16CD52-E380-E1AE-46F2-FC40BAFDB119}" dt="2024-11-21T00:30:32.463" v="378" actId="14100"/>
          <ac:spMkLst>
            <pc:docMk/>
            <pc:sldMk cId="2150412935" sldId="374"/>
            <ac:spMk id="4" creationId="{E38C6282-1F34-45B8-9518-AAACA74DA7D0}"/>
          </ac:spMkLst>
        </pc:spChg>
      </pc:sldChg>
      <pc:sldChg chg="modSp add del">
        <pc:chgData name="Belaid, Sirine" userId="S::belaids@upmc.edu::5dcb4cf5-c058-49ea-93f8-4f4e6c877fcd" providerId="AD" clId="Web-{DB16CD52-E380-E1AE-46F2-FC40BAFDB119}" dt="2024-11-21T00:37:57.209" v="410"/>
        <pc:sldMkLst>
          <pc:docMk/>
          <pc:sldMk cId="3794118593" sldId="375"/>
        </pc:sldMkLst>
        <pc:spChg chg="mod">
          <ac:chgData name="Belaid, Sirine" userId="S::belaids@upmc.edu::5dcb4cf5-c058-49ea-93f8-4f4e6c877fcd" providerId="AD" clId="Web-{DB16CD52-E380-E1AE-46F2-FC40BAFDB119}" dt="2024-11-21T00:31:09.825" v="388" actId="20577"/>
          <ac:spMkLst>
            <pc:docMk/>
            <pc:sldMk cId="3794118593" sldId="375"/>
            <ac:spMk id="2" creationId="{A4631A03-FB9A-4826-92E4-A38779F357B9}"/>
          </ac:spMkLst>
        </pc:spChg>
      </pc:sldChg>
      <pc:sldChg chg="addSp delSp modSp new del">
        <pc:chgData name="Belaid, Sirine" userId="S::belaids@upmc.edu::5dcb4cf5-c058-49ea-93f8-4f4e6c877fcd" providerId="AD" clId="Web-{DB16CD52-E380-E1AE-46F2-FC40BAFDB119}" dt="2024-11-21T00:42:15.958" v="431"/>
        <pc:sldMkLst>
          <pc:docMk/>
          <pc:sldMk cId="1008573961" sldId="376"/>
        </pc:sldMkLst>
        <pc:spChg chg="add del mod">
          <ac:chgData name="Belaid, Sirine" userId="S::belaids@upmc.edu::5dcb4cf5-c058-49ea-93f8-4f4e6c877fcd" providerId="AD" clId="Web-{DB16CD52-E380-E1AE-46F2-FC40BAFDB119}" dt="2024-11-21T00:39:08.900" v="421"/>
          <ac:spMkLst>
            <pc:docMk/>
            <pc:sldMk cId="1008573961" sldId="376"/>
            <ac:spMk id="4" creationId="{DAF6C83E-331E-910E-380E-5255B5EAC742}"/>
          </ac:spMkLst>
        </pc:spChg>
      </pc:sldChg>
      <pc:sldChg chg="addSp delSp modSp new">
        <pc:chgData name="Belaid, Sirine" userId="S::belaids@upmc.edu::5dcb4cf5-c058-49ea-93f8-4f4e6c877fcd" providerId="AD" clId="Web-{DB16CD52-E380-E1AE-46F2-FC40BAFDB119}" dt="2024-11-21T01:20:02.267" v="754"/>
        <pc:sldMkLst>
          <pc:docMk/>
          <pc:sldMk cId="1471262162" sldId="377"/>
        </pc:sldMkLst>
        <pc:spChg chg="del">
          <ac:chgData name="Belaid, Sirine" userId="S::belaids@upmc.edu::5dcb4cf5-c058-49ea-93f8-4f4e6c877fcd" providerId="AD" clId="Web-{DB16CD52-E380-E1AE-46F2-FC40BAFDB119}" dt="2024-11-21T01:20:02.267" v="754"/>
          <ac:spMkLst>
            <pc:docMk/>
            <pc:sldMk cId="1471262162" sldId="377"/>
            <ac:spMk id="2" creationId="{24272892-8889-8DF5-60D7-BC45597E8998}"/>
          </ac:spMkLst>
        </pc:spChg>
        <pc:spChg chg="del">
          <ac:chgData name="Belaid, Sirine" userId="S::belaids@upmc.edu::5dcb4cf5-c058-49ea-93f8-4f4e6c877fcd" providerId="AD" clId="Web-{DB16CD52-E380-E1AE-46F2-FC40BAFDB119}" dt="2024-11-21T01:19:58.189" v="753"/>
          <ac:spMkLst>
            <pc:docMk/>
            <pc:sldMk cId="1471262162" sldId="377"/>
            <ac:spMk id="3" creationId="{BAB1DB4F-2D09-2D42-4771-1873C4A87E18}"/>
          </ac:spMkLst>
        </pc:spChg>
        <pc:picChg chg="add mod ord">
          <ac:chgData name="Belaid, Sirine" userId="S::belaids@upmc.edu::5dcb4cf5-c058-49ea-93f8-4f4e6c877fcd" providerId="AD" clId="Web-{DB16CD52-E380-E1AE-46F2-FC40BAFDB119}" dt="2024-11-21T01:19:58.189" v="753"/>
          <ac:picMkLst>
            <pc:docMk/>
            <pc:sldMk cId="1471262162" sldId="377"/>
            <ac:picMk id="4" creationId="{8D6C8133-998B-F8FB-11E1-1C9829935611}"/>
          </ac:picMkLst>
        </pc:picChg>
      </pc:sldChg>
      <pc:sldChg chg="new">
        <pc:chgData name="Belaid, Sirine" userId="S::belaids@upmc.edu::5dcb4cf5-c058-49ea-93f8-4f4e6c877fcd" providerId="AD" clId="Web-{DB16CD52-E380-E1AE-46F2-FC40BAFDB119}" dt="2024-11-21T00:24:33.364" v="297"/>
        <pc:sldMkLst>
          <pc:docMk/>
          <pc:sldMk cId="3222833950" sldId="378"/>
        </pc:sldMkLst>
      </pc:sldChg>
      <pc:sldChg chg="modSp new">
        <pc:chgData name="Belaid, Sirine" userId="S::belaids@upmc.edu::5dcb4cf5-c058-49ea-93f8-4f4e6c877fcd" providerId="AD" clId="Web-{DB16CD52-E380-E1AE-46F2-FC40BAFDB119}" dt="2024-11-21T00:26:22.683" v="349" actId="20577"/>
        <pc:sldMkLst>
          <pc:docMk/>
          <pc:sldMk cId="3434993078" sldId="379"/>
        </pc:sldMkLst>
        <pc:spChg chg="mod">
          <ac:chgData name="Belaid, Sirine" userId="S::belaids@upmc.edu::5dcb4cf5-c058-49ea-93f8-4f4e6c877fcd" providerId="AD" clId="Web-{DB16CD52-E380-E1AE-46F2-FC40BAFDB119}" dt="2024-11-21T00:26:22.683" v="349" actId="20577"/>
          <ac:spMkLst>
            <pc:docMk/>
            <pc:sldMk cId="3434993078" sldId="379"/>
            <ac:spMk id="2" creationId="{16195E82-86AE-AB44-06FF-1A93F02750DC}"/>
          </ac:spMkLst>
        </pc:spChg>
        <pc:spChg chg="mod">
          <ac:chgData name="Belaid, Sirine" userId="S::belaids@upmc.edu::5dcb4cf5-c058-49ea-93f8-4f4e6c877fcd" providerId="AD" clId="Web-{DB16CD52-E380-E1AE-46F2-FC40BAFDB119}" dt="2024-11-21T00:25:39.008" v="343" actId="1076"/>
          <ac:spMkLst>
            <pc:docMk/>
            <pc:sldMk cId="3434993078" sldId="379"/>
            <ac:spMk id="3" creationId="{0DD947CF-FC6B-318D-FE2A-A5727C629A3D}"/>
          </ac:spMkLst>
        </pc:spChg>
      </pc:sldChg>
      <pc:sldChg chg="add del">
        <pc:chgData name="Belaid, Sirine" userId="S::belaids@upmc.edu::5dcb4cf5-c058-49ea-93f8-4f4e6c877fcd" providerId="AD" clId="Web-{DB16CD52-E380-E1AE-46F2-FC40BAFDB119}" dt="2024-11-21T00:29:11.958" v="361"/>
        <pc:sldMkLst>
          <pc:docMk/>
          <pc:sldMk cId="1668179323" sldId="380"/>
        </pc:sldMkLst>
      </pc:sldChg>
      <pc:sldChg chg="modSp add modNotes">
        <pc:chgData name="Belaid, Sirine" userId="S::belaids@upmc.edu::5dcb4cf5-c058-49ea-93f8-4f4e6c877fcd" providerId="AD" clId="Web-{DB16CD52-E380-E1AE-46F2-FC40BAFDB119}" dt="2024-11-21T00:50:21.911" v="453"/>
        <pc:sldMkLst>
          <pc:docMk/>
          <pc:sldMk cId="3575352840" sldId="380"/>
        </pc:sldMkLst>
        <pc:spChg chg="mod">
          <ac:chgData name="Belaid, Sirine" userId="S::belaids@upmc.edu::5dcb4cf5-c058-49ea-93f8-4f4e6c877fcd" providerId="AD" clId="Web-{DB16CD52-E380-E1AE-46F2-FC40BAFDB119}" dt="2024-11-21T00:40:21.842" v="430" actId="14100"/>
          <ac:spMkLst>
            <pc:docMk/>
            <pc:sldMk cId="3575352840" sldId="380"/>
            <ac:spMk id="6" creationId="{ED9C0DF9-D82E-4405-8519-FC4A50EDC839}"/>
          </ac:spMkLst>
        </pc:spChg>
        <pc:graphicFrameChg chg="mod">
          <ac:chgData name="Belaid, Sirine" userId="S::belaids@upmc.edu::5dcb4cf5-c058-49ea-93f8-4f4e6c877fcd" providerId="AD" clId="Web-{DB16CD52-E380-E1AE-46F2-FC40BAFDB119}" dt="2024-11-21T00:40:07.998" v="428" actId="1076"/>
          <ac:graphicFrameMkLst>
            <pc:docMk/>
            <pc:sldMk cId="3575352840" sldId="380"/>
            <ac:graphicFrameMk id="4" creationId="{05D739F9-2718-402C-89C7-6EA977CB517F}"/>
          </ac:graphicFrameMkLst>
        </pc:graphicFrameChg>
      </pc:sldChg>
      <pc:sldChg chg="addSp delSp modSp new modNotes">
        <pc:chgData name="Belaid, Sirine" userId="S::belaids@upmc.edu::5dcb4cf5-c058-49ea-93f8-4f4e6c877fcd" providerId="AD" clId="Web-{DB16CD52-E380-E1AE-46F2-FC40BAFDB119}" dt="2024-11-21T01:15:34.836" v="752"/>
        <pc:sldMkLst>
          <pc:docMk/>
          <pc:sldMk cId="3179549796" sldId="381"/>
        </pc:sldMkLst>
        <pc:spChg chg="add mod">
          <ac:chgData name="Belaid, Sirine" userId="S::belaids@upmc.edu::5dcb4cf5-c058-49ea-93f8-4f4e6c877fcd" providerId="AD" clId="Web-{DB16CD52-E380-E1AE-46F2-FC40BAFDB119}" dt="2024-11-21T01:12:11.516" v="665" actId="1076"/>
          <ac:spMkLst>
            <pc:docMk/>
            <pc:sldMk cId="3179549796" sldId="381"/>
            <ac:spMk id="6" creationId="{1C507F15-900F-8029-EB18-200808C829EE}"/>
          </ac:spMkLst>
        </pc:spChg>
        <pc:spChg chg="add mod">
          <ac:chgData name="Belaid, Sirine" userId="S::belaids@upmc.edu::5dcb4cf5-c058-49ea-93f8-4f4e6c877fcd" providerId="AD" clId="Web-{DB16CD52-E380-E1AE-46F2-FC40BAFDB119}" dt="2024-11-21T01:01:47.817" v="547" actId="20577"/>
          <ac:spMkLst>
            <pc:docMk/>
            <pc:sldMk cId="3179549796" sldId="381"/>
            <ac:spMk id="9" creationId="{AD8C5142-AE2B-D2E6-6500-8B460B6BA993}"/>
          </ac:spMkLst>
        </pc:spChg>
        <pc:picChg chg="add del mod">
          <ac:chgData name="Belaid, Sirine" userId="S::belaids@upmc.edu::5dcb4cf5-c058-49ea-93f8-4f4e6c877fcd" providerId="AD" clId="Web-{DB16CD52-E380-E1AE-46F2-FC40BAFDB119}" dt="2024-11-21T00:52:53.810" v="462"/>
          <ac:picMkLst>
            <pc:docMk/>
            <pc:sldMk cId="3179549796" sldId="381"/>
            <ac:picMk id="2" creationId="{25D74405-5C9B-4A45-688A-F2B5E7E8A1A2}"/>
          </ac:picMkLst>
        </pc:picChg>
        <pc:picChg chg="add mod">
          <ac:chgData name="Belaid, Sirine" userId="S::belaids@upmc.edu::5dcb4cf5-c058-49ea-93f8-4f4e6c877fcd" providerId="AD" clId="Web-{DB16CD52-E380-E1AE-46F2-FC40BAFDB119}" dt="2024-11-21T01:13:01.862" v="670" actId="1076"/>
          <ac:picMkLst>
            <pc:docMk/>
            <pc:sldMk cId="3179549796" sldId="381"/>
            <ac:picMk id="3" creationId="{DA2A71F0-6417-A7F9-E493-739108DE3A4E}"/>
          </ac:picMkLst>
        </pc:picChg>
        <pc:picChg chg="add mod">
          <ac:chgData name="Belaid, Sirine" userId="S::belaids@upmc.edu::5dcb4cf5-c058-49ea-93f8-4f4e6c877fcd" providerId="AD" clId="Web-{DB16CD52-E380-E1AE-46F2-FC40BAFDB119}" dt="2024-11-21T01:12:55.018" v="668" actId="1076"/>
          <ac:picMkLst>
            <pc:docMk/>
            <pc:sldMk cId="3179549796" sldId="381"/>
            <ac:picMk id="4" creationId="{87600A3E-4DE0-EED9-7AFD-89317515726A}"/>
          </ac:picMkLst>
        </pc:picChg>
        <pc:picChg chg="add mod">
          <ac:chgData name="Belaid, Sirine" userId="S::belaids@upmc.edu::5dcb4cf5-c058-49ea-93f8-4f4e6c877fcd" providerId="AD" clId="Web-{DB16CD52-E380-E1AE-46F2-FC40BAFDB119}" dt="2024-11-21T00:58:08.235" v="504" actId="1076"/>
          <ac:picMkLst>
            <pc:docMk/>
            <pc:sldMk cId="3179549796" sldId="381"/>
            <ac:picMk id="5" creationId="{A5D062DA-85D1-4F86-95D5-6388AB67CA96}"/>
          </ac:picMkLst>
        </pc:picChg>
        <pc:picChg chg="add mod">
          <ac:chgData name="Belaid, Sirine" userId="S::belaids@upmc.edu::5dcb4cf5-c058-49ea-93f8-4f4e6c877fcd" providerId="AD" clId="Web-{DB16CD52-E380-E1AE-46F2-FC40BAFDB119}" dt="2024-11-21T00:57:51.516" v="499" actId="1076"/>
          <ac:picMkLst>
            <pc:docMk/>
            <pc:sldMk cId="3179549796" sldId="381"/>
            <ac:picMk id="8" creationId="{0D7723B9-EEFD-E885-4CCB-D0781E15D12F}"/>
          </ac:picMkLst>
        </pc:picChg>
      </pc:sldChg>
      <pc:sldChg chg="add del">
        <pc:chgData name="Belaid, Sirine" userId="S::belaids@upmc.edu::5dcb4cf5-c058-49ea-93f8-4f4e6c877fcd" providerId="AD" clId="Web-{DB16CD52-E380-E1AE-46F2-FC40BAFDB119}" dt="2024-11-21T00:58:53.722" v="519"/>
        <pc:sldMkLst>
          <pc:docMk/>
          <pc:sldMk cId="943869258" sldId="382"/>
        </pc:sldMkLst>
      </pc:sldChg>
      <pc:sldChg chg="add del">
        <pc:chgData name="Belaid, Sirine" userId="S::belaids@upmc.edu::5dcb4cf5-c058-49ea-93f8-4f4e6c877fcd" providerId="AD" clId="Web-{DB16CD52-E380-E1AE-46F2-FC40BAFDB119}" dt="2024-11-21T01:06:19.795" v="603"/>
        <pc:sldMkLst>
          <pc:docMk/>
          <pc:sldMk cId="4029488217" sldId="382"/>
        </pc:sldMkLst>
      </pc:sldChg>
      <pc:sldChg chg="addSp modSp new modNotes">
        <pc:chgData name="Belaid, Sirine" userId="S::belaids@upmc.edu::5dcb4cf5-c058-49ea-93f8-4f4e6c877fcd" providerId="AD" clId="Web-{DB16CD52-E380-E1AE-46F2-FC40BAFDB119}" dt="2024-11-21T01:09:14.333" v="626"/>
        <pc:sldMkLst>
          <pc:docMk/>
          <pc:sldMk cId="1990103092" sldId="383"/>
        </pc:sldMkLst>
        <pc:spChg chg="add mod">
          <ac:chgData name="Belaid, Sirine" userId="S::belaids@upmc.edu::5dcb4cf5-c058-49ea-93f8-4f4e6c877fcd" providerId="AD" clId="Web-{DB16CD52-E380-E1AE-46F2-FC40BAFDB119}" dt="2024-11-21T01:06:10.092" v="602" actId="1076"/>
          <ac:spMkLst>
            <pc:docMk/>
            <pc:sldMk cId="1990103092" sldId="383"/>
            <ac:spMk id="2" creationId="{EFD2B7A6-04ED-F6EA-4A80-A8A55A074112}"/>
          </ac:spMkLst>
        </pc:spChg>
        <pc:spChg chg="add mod">
          <ac:chgData name="Belaid, Sirine" userId="S::belaids@upmc.edu::5dcb4cf5-c058-49ea-93f8-4f4e6c877fcd" providerId="AD" clId="Web-{DB16CD52-E380-E1AE-46F2-FC40BAFDB119}" dt="2024-11-21T01:00:32.915" v="543" actId="1076"/>
          <ac:spMkLst>
            <pc:docMk/>
            <pc:sldMk cId="1990103092" sldId="383"/>
            <ac:spMk id="3" creationId="{264DE756-E4BD-CE65-DF99-0597DCD47AA5}"/>
          </ac:spMkLst>
        </pc:spChg>
        <pc:spChg chg="add">
          <ac:chgData name="Belaid, Sirine" userId="S::belaids@upmc.edu::5dcb4cf5-c058-49ea-93f8-4f4e6c877fcd" providerId="AD" clId="Web-{DB16CD52-E380-E1AE-46F2-FC40BAFDB119}" dt="2024-11-21T01:01:12.183" v="544"/>
          <ac:spMkLst>
            <pc:docMk/>
            <pc:sldMk cId="1990103092" sldId="383"/>
            <ac:spMk id="6" creationId="{34780BE4-850B-02FE-95DD-93D8B11667D5}"/>
          </ac:spMkLst>
        </pc:spChg>
        <pc:picChg chg="add mod">
          <ac:chgData name="Belaid, Sirine" userId="S::belaids@upmc.edu::5dcb4cf5-c058-49ea-93f8-4f4e6c877fcd" providerId="AD" clId="Web-{DB16CD52-E380-E1AE-46F2-FC40BAFDB119}" dt="2024-11-21T01:05:44.309" v="596" actId="1076"/>
          <ac:picMkLst>
            <pc:docMk/>
            <pc:sldMk cId="1990103092" sldId="383"/>
            <ac:picMk id="4" creationId="{23E5559A-91FB-189D-C2C3-43EF5910F9A1}"/>
          </ac:picMkLst>
        </pc:picChg>
        <pc:picChg chg="add mod">
          <ac:chgData name="Belaid, Sirine" userId="S::belaids@upmc.edu::5dcb4cf5-c058-49ea-93f8-4f4e6c877fcd" providerId="AD" clId="Web-{DB16CD52-E380-E1AE-46F2-FC40BAFDB119}" dt="2024-11-21T01:00:09.382" v="526" actId="1076"/>
          <ac:picMkLst>
            <pc:docMk/>
            <pc:sldMk cId="1990103092" sldId="383"/>
            <ac:picMk id="5" creationId="{5E1BA499-E711-9FE7-0FBC-EC5EF72903E5}"/>
          </ac:picMkLst>
        </pc:picChg>
        <pc:picChg chg="add mod">
          <ac:chgData name="Belaid, Sirine" userId="S::belaids@upmc.edu::5dcb4cf5-c058-49ea-93f8-4f4e6c877fcd" providerId="AD" clId="Web-{DB16CD52-E380-E1AE-46F2-FC40BAFDB119}" dt="2024-11-21T01:05:39.341" v="594" actId="1076"/>
          <ac:picMkLst>
            <pc:docMk/>
            <pc:sldMk cId="1990103092" sldId="383"/>
            <ac:picMk id="7" creationId="{2B92E915-A43B-6795-FC93-BEA6249C106B}"/>
          </ac:picMkLst>
        </pc:picChg>
        <pc:picChg chg="add mod">
          <ac:chgData name="Belaid, Sirine" userId="S::belaids@upmc.edu::5dcb4cf5-c058-49ea-93f8-4f4e6c877fcd" providerId="AD" clId="Web-{DB16CD52-E380-E1AE-46F2-FC40BAFDB119}" dt="2024-11-21T01:05:37.669" v="593" actId="1076"/>
          <ac:picMkLst>
            <pc:docMk/>
            <pc:sldMk cId="1990103092" sldId="383"/>
            <ac:picMk id="8" creationId="{43C49ADC-0AC6-29EF-2562-4A52BA117222}"/>
          </ac:picMkLst>
        </pc:picChg>
      </pc:sldChg>
    </pc:docChg>
  </pc:docChgLst>
  <pc:docChgLst>
    <pc:chgData name="Belaid, Sirine" userId="S::belaids@upmc.edu::5dcb4cf5-c058-49ea-93f8-4f4e6c877fcd" providerId="AD" clId="Web-{C194EF7C-1560-E765-E430-CFB5A4E93E27}"/>
    <pc:docChg chg="modSld">
      <pc:chgData name="Belaid, Sirine" userId="S::belaids@upmc.edu::5dcb4cf5-c058-49ea-93f8-4f4e6c877fcd" providerId="AD" clId="Web-{C194EF7C-1560-E765-E430-CFB5A4E93E27}" dt="2024-12-13T15:16:51.382" v="15" actId="20577"/>
      <pc:docMkLst>
        <pc:docMk/>
      </pc:docMkLst>
      <pc:sldChg chg="modSp">
        <pc:chgData name="Belaid, Sirine" userId="S::belaids@upmc.edu::5dcb4cf5-c058-49ea-93f8-4f4e6c877fcd" providerId="AD" clId="Web-{C194EF7C-1560-E765-E430-CFB5A4E93E27}" dt="2024-12-13T15:16:51.382" v="15" actId="20577"/>
        <pc:sldMkLst>
          <pc:docMk/>
          <pc:sldMk cId="4094227945" sldId="352"/>
        </pc:sldMkLst>
        <pc:spChg chg="mod">
          <ac:chgData name="Belaid, Sirine" userId="S::belaids@upmc.edu::5dcb4cf5-c058-49ea-93f8-4f4e6c877fcd" providerId="AD" clId="Web-{C194EF7C-1560-E765-E430-CFB5A4E93E27}" dt="2024-12-13T15:16:51.382" v="15" actId="20577"/>
          <ac:spMkLst>
            <pc:docMk/>
            <pc:sldMk cId="4094227945" sldId="352"/>
            <ac:spMk id="3" creationId="{54D52FF0-F483-CAD8-917A-930506D4F12A}"/>
          </ac:spMkLst>
        </pc:spChg>
      </pc:sldChg>
    </pc:docChg>
  </pc:docChgLst>
  <pc:docChgLst>
    <pc:chgData name="Belaid, Sirine" userId="S::belaids@upmc.edu::5dcb4cf5-c058-49ea-93f8-4f4e6c877fcd" providerId="AD" clId="Web-{6D884D18-B658-B0C8-E745-046C8C950825}"/>
    <pc:docChg chg="modSld">
      <pc:chgData name="Belaid, Sirine" userId="S::belaids@upmc.edu::5dcb4cf5-c058-49ea-93f8-4f4e6c877fcd" providerId="AD" clId="Web-{6D884D18-B658-B0C8-E745-046C8C950825}" dt="2025-04-24T15:33:50.762" v="1"/>
      <pc:docMkLst>
        <pc:docMk/>
      </pc:docMkLst>
      <pc:sldChg chg="modNotes">
        <pc:chgData name="Belaid, Sirine" userId="S::belaids@upmc.edu::5dcb4cf5-c058-49ea-93f8-4f4e6c877fcd" providerId="AD" clId="Web-{6D884D18-B658-B0C8-E745-046C8C950825}" dt="2025-04-24T15:33:50.762" v="1"/>
        <pc:sldMkLst>
          <pc:docMk/>
          <pc:sldMk cId="3825394227" sldId="358"/>
        </pc:sldMkLst>
      </pc:sldChg>
    </pc:docChg>
  </pc:docChgLst>
  <pc:docChgLst>
    <pc:chgData name="Belaid, Sirine" userId="S::belaids@upmc.edu::5dcb4cf5-c058-49ea-93f8-4f4e6c877fcd" providerId="AD" clId="Web-{063A331D-F9CF-3389-F915-DE4D8F5EEB28}"/>
    <pc:docChg chg="addSld delSld modSld">
      <pc:chgData name="Belaid, Sirine" userId="S::belaids@upmc.edu::5dcb4cf5-c058-49ea-93f8-4f4e6c877fcd" providerId="AD" clId="Web-{063A331D-F9CF-3389-F915-DE4D8F5EEB28}" dt="2024-12-04T20:58:57.307" v="756"/>
      <pc:docMkLst>
        <pc:docMk/>
      </pc:docMkLst>
      <pc:sldChg chg="addSp modSp">
        <pc:chgData name="Belaid, Sirine" userId="S::belaids@upmc.edu::5dcb4cf5-c058-49ea-93f8-4f4e6c877fcd" providerId="AD" clId="Web-{063A331D-F9CF-3389-F915-DE4D8F5EEB28}" dt="2024-12-04T20:34:02.484" v="704" actId="1076"/>
        <pc:sldMkLst>
          <pc:docMk/>
          <pc:sldMk cId="1575805153" sldId="291"/>
        </pc:sldMkLst>
        <pc:spChg chg="add mod">
          <ac:chgData name="Belaid, Sirine" userId="S::belaids@upmc.edu::5dcb4cf5-c058-49ea-93f8-4f4e6c877fcd" providerId="AD" clId="Web-{063A331D-F9CF-3389-F915-DE4D8F5EEB28}" dt="2024-12-04T20:34:02.484" v="704" actId="1076"/>
          <ac:spMkLst>
            <pc:docMk/>
            <pc:sldMk cId="1575805153" sldId="291"/>
            <ac:spMk id="4" creationId="{E97BA42B-3905-D7AD-EE5E-69978AE92026}"/>
          </ac:spMkLst>
        </pc:spChg>
        <pc:picChg chg="mod">
          <ac:chgData name="Belaid, Sirine" userId="S::belaids@upmc.edu::5dcb4cf5-c058-49ea-93f8-4f4e6c877fcd" providerId="AD" clId="Web-{063A331D-F9CF-3389-F915-DE4D8F5EEB28}" dt="2024-12-04T20:33:43.374" v="699" actId="1076"/>
          <ac:picMkLst>
            <pc:docMk/>
            <pc:sldMk cId="1575805153" sldId="291"/>
            <ac:picMk id="2" creationId="{5A5AF7B2-F832-D154-7A42-A41BF70830E9}"/>
          </ac:picMkLst>
        </pc:picChg>
        <pc:picChg chg="add mod">
          <ac:chgData name="Belaid, Sirine" userId="S::belaids@upmc.edu::5dcb4cf5-c058-49ea-93f8-4f4e6c877fcd" providerId="AD" clId="Web-{063A331D-F9CF-3389-F915-DE4D8F5EEB28}" dt="2024-12-04T20:33:47.468" v="701" actId="1076"/>
          <ac:picMkLst>
            <pc:docMk/>
            <pc:sldMk cId="1575805153" sldId="291"/>
            <ac:picMk id="3" creationId="{0A24DA9C-91D8-D8C5-28ED-0B9A089B35DA}"/>
          </ac:picMkLst>
        </pc:picChg>
      </pc:sldChg>
      <pc:sldChg chg="modSp">
        <pc:chgData name="Belaid, Sirine" userId="S::belaids@upmc.edu::5dcb4cf5-c058-49ea-93f8-4f4e6c877fcd" providerId="AD" clId="Web-{063A331D-F9CF-3389-F915-DE4D8F5EEB28}" dt="2024-12-04T20:37:22.647" v="714" actId="20577"/>
        <pc:sldMkLst>
          <pc:docMk/>
          <pc:sldMk cId="707447650" sldId="292"/>
        </pc:sldMkLst>
        <pc:spChg chg="mod">
          <ac:chgData name="Belaid, Sirine" userId="S::belaids@upmc.edu::5dcb4cf5-c058-49ea-93f8-4f4e6c877fcd" providerId="AD" clId="Web-{063A331D-F9CF-3389-F915-DE4D8F5EEB28}" dt="2024-12-04T20:37:22.647" v="714" actId="20577"/>
          <ac:spMkLst>
            <pc:docMk/>
            <pc:sldMk cId="707447650" sldId="292"/>
            <ac:spMk id="4" creationId="{16D5F698-1466-B30B-5CE7-AC93819EA30B}"/>
          </ac:spMkLst>
        </pc:spChg>
      </pc:sldChg>
      <pc:sldChg chg="modSp modNotes">
        <pc:chgData name="Belaid, Sirine" userId="S::belaids@upmc.edu::5dcb4cf5-c058-49ea-93f8-4f4e6c877fcd" providerId="AD" clId="Web-{063A331D-F9CF-3389-F915-DE4D8F5EEB28}" dt="2024-12-04T19:34:05.749" v="609"/>
        <pc:sldMkLst>
          <pc:docMk/>
          <pc:sldMk cId="4094227945" sldId="352"/>
        </pc:sldMkLst>
        <pc:spChg chg="mod">
          <ac:chgData name="Belaid, Sirine" userId="S::belaids@upmc.edu::5dcb4cf5-c058-49ea-93f8-4f4e6c877fcd" providerId="AD" clId="Web-{063A331D-F9CF-3389-F915-DE4D8F5EEB28}" dt="2024-12-04T19:33:41.951" v="585" actId="20577"/>
          <ac:spMkLst>
            <pc:docMk/>
            <pc:sldMk cId="4094227945" sldId="352"/>
            <ac:spMk id="3" creationId="{54D52FF0-F483-CAD8-917A-930506D4F12A}"/>
          </ac:spMkLst>
        </pc:spChg>
      </pc:sldChg>
      <pc:sldChg chg="addSp delSp modSp modNotes">
        <pc:chgData name="Belaid, Sirine" userId="S::belaids@upmc.edu::5dcb4cf5-c058-49ea-93f8-4f4e6c877fcd" providerId="AD" clId="Web-{063A331D-F9CF-3389-F915-DE4D8F5EEB28}" dt="2024-12-04T20:33:53.937" v="702"/>
        <pc:sldMkLst>
          <pc:docMk/>
          <pc:sldMk cId="449566489" sldId="354"/>
        </pc:sldMkLst>
        <pc:spChg chg="mod">
          <ac:chgData name="Belaid, Sirine" userId="S::belaids@upmc.edu::5dcb4cf5-c058-49ea-93f8-4f4e6c877fcd" providerId="AD" clId="Web-{063A331D-F9CF-3389-F915-DE4D8F5EEB28}" dt="2024-12-04T19:41:30.519" v="658" actId="20577"/>
          <ac:spMkLst>
            <pc:docMk/>
            <pc:sldMk cId="449566489" sldId="354"/>
            <ac:spMk id="3" creationId="{777F2FD0-93E3-360A-DED8-59A3E5728BA8}"/>
          </ac:spMkLst>
        </pc:spChg>
        <pc:spChg chg="add del mod">
          <ac:chgData name="Belaid, Sirine" userId="S::belaids@upmc.edu::5dcb4cf5-c058-49ea-93f8-4f4e6c877fcd" providerId="AD" clId="Web-{063A331D-F9CF-3389-F915-DE4D8F5EEB28}" dt="2024-12-04T20:33:53.937" v="702"/>
          <ac:spMkLst>
            <pc:docMk/>
            <pc:sldMk cId="449566489" sldId="354"/>
            <ac:spMk id="5" creationId="{E97BA42B-3905-D7AD-EE5E-69978AE92026}"/>
          </ac:spMkLst>
        </pc:spChg>
        <pc:picChg chg="add del mod">
          <ac:chgData name="Belaid, Sirine" userId="S::belaids@upmc.edu::5dcb4cf5-c058-49ea-93f8-4f4e6c877fcd" providerId="AD" clId="Web-{063A331D-F9CF-3389-F915-DE4D8F5EEB28}" dt="2024-12-04T20:33:25.076" v="693"/>
          <ac:picMkLst>
            <pc:docMk/>
            <pc:sldMk cId="449566489" sldId="354"/>
            <ac:picMk id="4" creationId="{96A5BCFE-8125-A50F-68FE-B336D4D28A77}"/>
          </ac:picMkLst>
        </pc:picChg>
      </pc:sldChg>
      <pc:sldChg chg="modSp">
        <pc:chgData name="Belaid, Sirine" userId="S::belaids@upmc.edu::5dcb4cf5-c058-49ea-93f8-4f4e6c877fcd" providerId="AD" clId="Web-{063A331D-F9CF-3389-F915-DE4D8F5EEB28}" dt="2024-12-04T19:34:17.514" v="611" actId="20577"/>
        <pc:sldMkLst>
          <pc:docMk/>
          <pc:sldMk cId="3868067760" sldId="357"/>
        </pc:sldMkLst>
        <pc:spChg chg="mod">
          <ac:chgData name="Belaid, Sirine" userId="S::belaids@upmc.edu::5dcb4cf5-c058-49ea-93f8-4f4e6c877fcd" providerId="AD" clId="Web-{063A331D-F9CF-3389-F915-DE4D8F5EEB28}" dt="2024-12-04T19:34:17.514" v="611" actId="20577"/>
          <ac:spMkLst>
            <pc:docMk/>
            <pc:sldMk cId="3868067760" sldId="357"/>
            <ac:spMk id="3" creationId="{C6C10584-5F60-48A3-BCF3-AF01322CF6C3}"/>
          </ac:spMkLst>
        </pc:spChg>
      </pc:sldChg>
      <pc:sldChg chg="modSp modNotes">
        <pc:chgData name="Belaid, Sirine" userId="S::belaids@upmc.edu::5dcb4cf5-c058-49ea-93f8-4f4e6c877fcd" providerId="AD" clId="Web-{063A331D-F9CF-3389-F915-DE4D8F5EEB28}" dt="2024-12-04T19:40:47.331" v="655"/>
        <pc:sldMkLst>
          <pc:docMk/>
          <pc:sldMk cId="3825394227" sldId="358"/>
        </pc:sldMkLst>
        <pc:spChg chg="mod">
          <ac:chgData name="Belaid, Sirine" userId="S::belaids@upmc.edu::5dcb4cf5-c058-49ea-93f8-4f4e6c877fcd" providerId="AD" clId="Web-{063A331D-F9CF-3389-F915-DE4D8F5EEB28}" dt="2024-12-04T19:34:33.311" v="615" actId="20577"/>
          <ac:spMkLst>
            <pc:docMk/>
            <pc:sldMk cId="3825394227" sldId="358"/>
            <ac:spMk id="3" creationId="{4974952F-AF49-DE12-B0DE-612B936EDA11}"/>
          </ac:spMkLst>
        </pc:spChg>
      </pc:sldChg>
      <pc:sldChg chg="modSp">
        <pc:chgData name="Belaid, Sirine" userId="S::belaids@upmc.edu::5dcb4cf5-c058-49ea-93f8-4f4e6c877fcd" providerId="AD" clId="Web-{063A331D-F9CF-3389-F915-DE4D8F5EEB28}" dt="2024-12-04T20:38:36.119" v="717" actId="20577"/>
        <pc:sldMkLst>
          <pc:docMk/>
          <pc:sldMk cId="1919480477" sldId="360"/>
        </pc:sldMkLst>
        <pc:spChg chg="mod">
          <ac:chgData name="Belaid, Sirine" userId="S::belaids@upmc.edu::5dcb4cf5-c058-49ea-93f8-4f4e6c877fcd" providerId="AD" clId="Web-{063A331D-F9CF-3389-F915-DE4D8F5EEB28}" dt="2024-12-04T20:38:36.119" v="717" actId="20577"/>
          <ac:spMkLst>
            <pc:docMk/>
            <pc:sldMk cId="1919480477" sldId="360"/>
            <ac:spMk id="3" creationId="{6CCD5ABF-F289-6DF4-D01E-776F3BB7441A}"/>
          </ac:spMkLst>
        </pc:spChg>
      </pc:sldChg>
      <pc:sldChg chg="modSp">
        <pc:chgData name="Belaid, Sirine" userId="S::belaids@upmc.edu::5dcb4cf5-c058-49ea-93f8-4f4e6c877fcd" providerId="AD" clId="Web-{063A331D-F9CF-3389-F915-DE4D8F5EEB28}" dt="2024-12-04T20:58:18.399" v="718" actId="20577"/>
        <pc:sldMkLst>
          <pc:docMk/>
          <pc:sldMk cId="2817742152" sldId="361"/>
        </pc:sldMkLst>
        <pc:spChg chg="mod">
          <ac:chgData name="Belaid, Sirine" userId="S::belaids@upmc.edu::5dcb4cf5-c058-49ea-93f8-4f4e6c877fcd" providerId="AD" clId="Web-{063A331D-F9CF-3389-F915-DE4D8F5EEB28}" dt="2024-12-04T20:58:18.399" v="718" actId="20577"/>
          <ac:spMkLst>
            <pc:docMk/>
            <pc:sldMk cId="2817742152" sldId="361"/>
            <ac:spMk id="3" creationId="{B6FB2075-FE59-DFEA-3EE2-6A1D6EAFE127}"/>
          </ac:spMkLst>
        </pc:spChg>
      </pc:sldChg>
      <pc:sldChg chg="modSp modNotes">
        <pc:chgData name="Belaid, Sirine" userId="S::belaids@upmc.edu::5dcb4cf5-c058-49ea-93f8-4f4e6c877fcd" providerId="AD" clId="Web-{063A331D-F9CF-3389-F915-DE4D8F5EEB28}" dt="2024-12-04T20:58:57.307" v="756"/>
        <pc:sldMkLst>
          <pc:docMk/>
          <pc:sldMk cId="2208660293" sldId="366"/>
        </pc:sldMkLst>
        <pc:spChg chg="mod">
          <ac:chgData name="Belaid, Sirine" userId="S::belaids@upmc.edu::5dcb4cf5-c058-49ea-93f8-4f4e6c877fcd" providerId="AD" clId="Web-{063A331D-F9CF-3389-F915-DE4D8F5EEB28}" dt="2024-12-04T20:58:42.697" v="721" actId="20577"/>
          <ac:spMkLst>
            <pc:docMk/>
            <pc:sldMk cId="2208660293" sldId="366"/>
            <ac:spMk id="3" creationId="{FC73AACB-7825-85D8-03D0-48CD572599F9}"/>
          </ac:spMkLst>
        </pc:spChg>
      </pc:sldChg>
      <pc:sldChg chg="addSp delSp modSp">
        <pc:chgData name="Belaid, Sirine" userId="S::belaids@upmc.edu::5dcb4cf5-c058-49ea-93f8-4f4e6c877fcd" providerId="AD" clId="Web-{063A331D-F9CF-3389-F915-DE4D8F5EEB28}" dt="2024-12-04T19:16:55.815" v="317" actId="1076"/>
        <pc:sldMkLst>
          <pc:docMk/>
          <pc:sldMk cId="2301887968" sldId="387"/>
        </pc:sldMkLst>
        <pc:spChg chg="del mod">
          <ac:chgData name="Belaid, Sirine" userId="S::belaids@upmc.edu::5dcb4cf5-c058-49ea-93f8-4f4e6c877fcd" providerId="AD" clId="Web-{063A331D-F9CF-3389-F915-DE4D8F5EEB28}" dt="2024-12-04T15:03:11.074" v="38"/>
          <ac:spMkLst>
            <pc:docMk/>
            <pc:sldMk cId="2301887968" sldId="387"/>
            <ac:spMk id="2" creationId="{146ABACD-E5FC-771D-118F-2B844414B97D}"/>
          </ac:spMkLst>
        </pc:spChg>
        <pc:spChg chg="add mod">
          <ac:chgData name="Belaid, Sirine" userId="S::belaids@upmc.edu::5dcb4cf5-c058-49ea-93f8-4f4e6c877fcd" providerId="AD" clId="Web-{063A331D-F9CF-3389-F915-DE4D8F5EEB28}" dt="2024-12-04T18:37:07.631" v="153" actId="20577"/>
          <ac:spMkLst>
            <pc:docMk/>
            <pc:sldMk cId="2301887968" sldId="387"/>
            <ac:spMk id="3" creationId="{2E80BF24-3645-F4BA-2DCB-BA0265440DC0}"/>
          </ac:spMkLst>
        </pc:spChg>
        <pc:spChg chg="add del mod">
          <ac:chgData name="Belaid, Sirine" userId="S::belaids@upmc.edu::5dcb4cf5-c058-49ea-93f8-4f4e6c877fcd" providerId="AD" clId="Web-{063A331D-F9CF-3389-F915-DE4D8F5EEB28}" dt="2024-12-04T15:00:41.131" v="3"/>
          <ac:spMkLst>
            <pc:docMk/>
            <pc:sldMk cId="2301887968" sldId="387"/>
            <ac:spMk id="8" creationId="{AC11EAEC-A1B1-70CE-BE4A-C3E17A8D807F}"/>
          </ac:spMkLst>
        </pc:spChg>
        <pc:spChg chg="add del mod">
          <ac:chgData name="Belaid, Sirine" userId="S::belaids@upmc.edu::5dcb4cf5-c058-49ea-93f8-4f4e6c877fcd" providerId="AD" clId="Web-{063A331D-F9CF-3389-F915-DE4D8F5EEB28}" dt="2024-12-04T15:03:16.934" v="39"/>
          <ac:spMkLst>
            <pc:docMk/>
            <pc:sldMk cId="2301887968" sldId="387"/>
            <ac:spMk id="12" creationId="{1838A880-412F-4492-EAAD-D5564EE1DCDD}"/>
          </ac:spMkLst>
        </pc:spChg>
        <pc:picChg chg="add del mod">
          <ac:chgData name="Belaid, Sirine" userId="S::belaids@upmc.edu::5dcb4cf5-c058-49ea-93f8-4f4e6c877fcd" providerId="AD" clId="Web-{063A331D-F9CF-3389-F915-DE4D8F5EEB28}" dt="2024-12-04T18:12:16.092" v="104"/>
          <ac:picMkLst>
            <pc:docMk/>
            <pc:sldMk cId="2301887968" sldId="387"/>
            <ac:picMk id="2" creationId="{27948DFA-828C-C3DE-8334-2489BB355A87}"/>
          </ac:picMkLst>
        </pc:picChg>
        <pc:picChg chg="del mod">
          <ac:chgData name="Belaid, Sirine" userId="S::belaids@upmc.edu::5dcb4cf5-c058-49ea-93f8-4f4e6c877fcd" providerId="AD" clId="Web-{063A331D-F9CF-3389-F915-DE4D8F5EEB28}" dt="2024-12-04T15:07:37.882" v="78"/>
          <ac:picMkLst>
            <pc:docMk/>
            <pc:sldMk cId="2301887968" sldId="387"/>
            <ac:picMk id="3" creationId="{810541E0-8A79-01D8-C40B-C1CE60AC7C95}"/>
          </ac:picMkLst>
        </pc:picChg>
        <pc:picChg chg="del">
          <ac:chgData name="Belaid, Sirine" userId="S::belaids@upmc.edu::5dcb4cf5-c058-49ea-93f8-4f4e6c877fcd" providerId="AD" clId="Web-{063A331D-F9CF-3389-F915-DE4D8F5EEB28}" dt="2024-12-04T15:00:20.630" v="0"/>
          <ac:picMkLst>
            <pc:docMk/>
            <pc:sldMk cId="2301887968" sldId="387"/>
            <ac:picMk id="4" creationId="{66407B73-10FA-BB48-FFD3-1D37778569DD}"/>
          </ac:picMkLst>
        </pc:picChg>
        <pc:picChg chg="add mod">
          <ac:chgData name="Belaid, Sirine" userId="S::belaids@upmc.edu::5dcb4cf5-c058-49ea-93f8-4f4e6c877fcd" providerId="AD" clId="Web-{063A331D-F9CF-3389-F915-DE4D8F5EEB28}" dt="2024-12-04T19:16:55.815" v="317" actId="1076"/>
          <ac:picMkLst>
            <pc:docMk/>
            <pc:sldMk cId="2301887968" sldId="387"/>
            <ac:picMk id="4" creationId="{9EB6F262-CDE8-389A-6F7E-056379301B5F}"/>
          </ac:picMkLst>
        </pc:picChg>
        <pc:picChg chg="del mod">
          <ac:chgData name="Belaid, Sirine" userId="S::belaids@upmc.edu::5dcb4cf5-c058-49ea-93f8-4f4e6c877fcd" providerId="AD" clId="Web-{063A331D-F9CF-3389-F915-DE4D8F5EEB28}" dt="2024-12-04T15:02:16.213" v="22"/>
          <ac:picMkLst>
            <pc:docMk/>
            <pc:sldMk cId="2301887968" sldId="387"/>
            <ac:picMk id="5" creationId="{006D3BE1-39D9-E3A1-5396-C3E8E929D575}"/>
          </ac:picMkLst>
        </pc:picChg>
        <pc:picChg chg="mod">
          <ac:chgData name="Belaid, Sirine" userId="S::belaids@upmc.edu::5dcb4cf5-c058-49ea-93f8-4f4e6c877fcd" providerId="AD" clId="Web-{063A331D-F9CF-3389-F915-DE4D8F5EEB28}" dt="2024-12-04T18:17:56.072" v="130" actId="1076"/>
          <ac:picMkLst>
            <pc:docMk/>
            <pc:sldMk cId="2301887968" sldId="387"/>
            <ac:picMk id="6" creationId="{B8357494-6C64-CE7D-8E84-E3B3B91ABADD}"/>
          </ac:picMkLst>
        </pc:picChg>
        <pc:picChg chg="add mod">
          <ac:chgData name="Belaid, Sirine" userId="S::belaids@upmc.edu::5dcb4cf5-c058-49ea-93f8-4f4e6c877fcd" providerId="AD" clId="Web-{063A331D-F9CF-3389-F915-DE4D8F5EEB28}" dt="2024-12-04T19:16:18.424" v="312" actId="1076"/>
          <ac:picMkLst>
            <pc:docMk/>
            <pc:sldMk cId="2301887968" sldId="387"/>
            <ac:picMk id="9" creationId="{13463B0C-DAA6-13D2-5E88-65F9A5A5EB85}"/>
          </ac:picMkLst>
        </pc:picChg>
        <pc:picChg chg="add mod">
          <ac:chgData name="Belaid, Sirine" userId="S::belaids@upmc.edu::5dcb4cf5-c058-49ea-93f8-4f4e6c877fcd" providerId="AD" clId="Web-{063A331D-F9CF-3389-F915-DE4D8F5EEB28}" dt="2024-12-04T18:19:51.014" v="132" actId="1076"/>
          <ac:picMkLst>
            <pc:docMk/>
            <pc:sldMk cId="2301887968" sldId="387"/>
            <ac:picMk id="10" creationId="{ACE7D549-9C0A-A131-8EAE-B15299B16394}"/>
          </ac:picMkLst>
        </pc:picChg>
        <pc:picChg chg="add mod">
          <ac:chgData name="Belaid, Sirine" userId="S::belaids@upmc.edu::5dcb4cf5-c058-49ea-93f8-4f4e6c877fcd" providerId="AD" clId="Web-{063A331D-F9CF-3389-F915-DE4D8F5EEB28}" dt="2024-12-04T18:19:53.311" v="133" actId="1076"/>
          <ac:picMkLst>
            <pc:docMk/>
            <pc:sldMk cId="2301887968" sldId="387"/>
            <ac:picMk id="13" creationId="{C2A62F2F-8F2F-7799-EDB8-C935640D7E08}"/>
          </ac:picMkLst>
        </pc:picChg>
        <pc:picChg chg="add mod">
          <ac:chgData name="Belaid, Sirine" userId="S::belaids@upmc.edu::5dcb4cf5-c058-49ea-93f8-4f4e6c877fcd" providerId="AD" clId="Web-{063A331D-F9CF-3389-F915-DE4D8F5EEB28}" dt="2024-12-04T18:14:53.863" v="127" actId="1076"/>
          <ac:picMkLst>
            <pc:docMk/>
            <pc:sldMk cId="2301887968" sldId="387"/>
            <ac:picMk id="14" creationId="{77AD7A6E-0764-9CE9-4EFF-C82A47BD9C03}"/>
          </ac:picMkLst>
        </pc:picChg>
        <pc:picChg chg="add mod">
          <ac:chgData name="Belaid, Sirine" userId="S::belaids@upmc.edu::5dcb4cf5-c058-49ea-93f8-4f4e6c877fcd" providerId="AD" clId="Web-{063A331D-F9CF-3389-F915-DE4D8F5EEB28}" dt="2024-12-04T19:16:31.190" v="315" actId="1076"/>
          <ac:picMkLst>
            <pc:docMk/>
            <pc:sldMk cId="2301887968" sldId="387"/>
            <ac:picMk id="15" creationId="{06D007B3-259C-BF03-EABF-DFD1022FA9DB}"/>
          </ac:picMkLst>
        </pc:picChg>
      </pc:sldChg>
      <pc:sldChg chg="addSp modSp">
        <pc:chgData name="Belaid, Sirine" userId="S::belaids@upmc.edu::5dcb4cf5-c058-49ea-93f8-4f4e6c877fcd" providerId="AD" clId="Web-{063A331D-F9CF-3389-F915-DE4D8F5EEB28}" dt="2024-12-04T18:51:12.656" v="191" actId="1076"/>
        <pc:sldMkLst>
          <pc:docMk/>
          <pc:sldMk cId="3342538804" sldId="388"/>
        </pc:sldMkLst>
        <pc:spChg chg="mod">
          <ac:chgData name="Belaid, Sirine" userId="S::belaids@upmc.edu::5dcb4cf5-c058-49ea-93f8-4f4e6c877fcd" providerId="AD" clId="Web-{063A331D-F9CF-3389-F915-DE4D8F5EEB28}" dt="2024-12-04T18:51:12.656" v="191" actId="1076"/>
          <ac:spMkLst>
            <pc:docMk/>
            <pc:sldMk cId="3342538804" sldId="388"/>
            <ac:spMk id="3" creationId="{19813B5D-F53D-0C33-97ED-29C6246EA762}"/>
          </ac:spMkLst>
        </pc:spChg>
        <pc:picChg chg="add mod">
          <ac:chgData name="Belaid, Sirine" userId="S::belaids@upmc.edu::5dcb4cf5-c058-49ea-93f8-4f4e6c877fcd" providerId="AD" clId="Web-{063A331D-F9CF-3389-F915-DE4D8F5EEB28}" dt="2024-12-04T18:50:33.687" v="188" actId="1076"/>
          <ac:picMkLst>
            <pc:docMk/>
            <pc:sldMk cId="3342538804" sldId="388"/>
            <ac:picMk id="4" creationId="{120EBD25-4502-E6F9-A99F-9AC13470C37E}"/>
          </ac:picMkLst>
        </pc:picChg>
        <pc:picChg chg="add mod">
          <ac:chgData name="Belaid, Sirine" userId="S::belaids@upmc.edu::5dcb4cf5-c058-49ea-93f8-4f4e6c877fcd" providerId="AD" clId="Web-{063A331D-F9CF-3389-F915-DE4D8F5EEB28}" dt="2024-12-04T18:50:38.937" v="189" actId="1076"/>
          <ac:picMkLst>
            <pc:docMk/>
            <pc:sldMk cId="3342538804" sldId="388"/>
            <ac:picMk id="5" creationId="{42271115-8C23-EBF5-D216-7762795949E7}"/>
          </ac:picMkLst>
        </pc:picChg>
      </pc:sldChg>
      <pc:sldChg chg="addSp delSp modSp modNotes">
        <pc:chgData name="Belaid, Sirine" userId="S::belaids@upmc.edu::5dcb4cf5-c058-49ea-93f8-4f4e6c877fcd" providerId="AD" clId="Web-{063A331D-F9CF-3389-F915-DE4D8F5EEB28}" dt="2024-12-04T19:32:34.373" v="577"/>
        <pc:sldMkLst>
          <pc:docMk/>
          <pc:sldMk cId="200882343" sldId="389"/>
        </pc:sldMkLst>
        <pc:spChg chg="del">
          <ac:chgData name="Belaid, Sirine" userId="S::belaids@upmc.edu::5dcb4cf5-c058-49ea-93f8-4f4e6c877fcd" providerId="AD" clId="Web-{063A331D-F9CF-3389-F915-DE4D8F5EEB28}" dt="2024-12-04T19:08:34.121" v="239"/>
          <ac:spMkLst>
            <pc:docMk/>
            <pc:sldMk cId="200882343" sldId="389"/>
            <ac:spMk id="2" creationId="{F15E40A9-1ADA-D72F-B394-AE4EAAF52A32}"/>
          </ac:spMkLst>
        </pc:spChg>
        <pc:spChg chg="del">
          <ac:chgData name="Belaid, Sirine" userId="S::belaids@upmc.edu::5dcb4cf5-c058-49ea-93f8-4f4e6c877fcd" providerId="AD" clId="Web-{063A331D-F9CF-3389-F915-DE4D8F5EEB28}" dt="2024-12-04T15:00:23.755" v="1"/>
          <ac:spMkLst>
            <pc:docMk/>
            <pc:sldMk cId="200882343" sldId="389"/>
            <ac:spMk id="3" creationId="{19813B5D-F53D-0C33-97ED-29C6246EA762}"/>
          </ac:spMkLst>
        </pc:spChg>
        <pc:spChg chg="add mod">
          <ac:chgData name="Belaid, Sirine" userId="S::belaids@upmc.edu::5dcb4cf5-c058-49ea-93f8-4f4e6c877fcd" providerId="AD" clId="Web-{063A331D-F9CF-3389-F915-DE4D8F5EEB28}" dt="2024-12-04T19:09:33.169" v="270" actId="1076"/>
          <ac:spMkLst>
            <pc:docMk/>
            <pc:sldMk cId="200882343" sldId="389"/>
            <ac:spMk id="6" creationId="{4B2D22B1-BB60-1512-D5CC-EB14CD805FE6}"/>
          </ac:spMkLst>
        </pc:spChg>
        <pc:spChg chg="add mod">
          <ac:chgData name="Belaid, Sirine" userId="S::belaids@upmc.edu::5dcb4cf5-c058-49ea-93f8-4f4e6c877fcd" providerId="AD" clId="Web-{063A331D-F9CF-3389-F915-DE4D8F5EEB28}" dt="2024-12-04T19:11:07.045" v="289" actId="1076"/>
          <ac:spMkLst>
            <pc:docMk/>
            <pc:sldMk cId="200882343" sldId="389"/>
            <ac:spMk id="10" creationId="{CAFA1CF3-93E8-EBFC-9FE0-53D2DA7BCADF}"/>
          </ac:spMkLst>
        </pc:spChg>
        <pc:spChg chg="add mod">
          <ac:chgData name="Belaid, Sirine" userId="S::belaids@upmc.edu::5dcb4cf5-c058-49ea-93f8-4f4e6c877fcd" providerId="AD" clId="Web-{063A331D-F9CF-3389-F915-DE4D8F5EEB28}" dt="2024-12-04T19:12:03.405" v="295" actId="1076"/>
          <ac:spMkLst>
            <pc:docMk/>
            <pc:sldMk cId="200882343" sldId="389"/>
            <ac:spMk id="11" creationId="{E12C9442-365B-61B2-36EC-CF1E36DBA105}"/>
          </ac:spMkLst>
        </pc:spChg>
        <pc:spChg chg="add mod">
          <ac:chgData name="Belaid, Sirine" userId="S::belaids@upmc.edu::5dcb4cf5-c058-49ea-93f8-4f4e6c877fcd" providerId="AD" clId="Web-{063A331D-F9CF-3389-F915-DE4D8F5EEB28}" dt="2024-12-04T19:22:45.366" v="373" actId="1076"/>
          <ac:spMkLst>
            <pc:docMk/>
            <pc:sldMk cId="200882343" sldId="389"/>
            <ac:spMk id="16" creationId="{F3EE0729-B91D-E8C5-7CC6-B2FBBB7481B2}"/>
          </ac:spMkLst>
        </pc:spChg>
        <pc:spChg chg="add mod">
          <ac:chgData name="Belaid, Sirine" userId="S::belaids@upmc.edu::5dcb4cf5-c058-49ea-93f8-4f4e6c877fcd" providerId="AD" clId="Web-{063A331D-F9CF-3389-F915-DE4D8F5EEB28}" dt="2024-12-04T19:25:35.352" v="432" actId="1076"/>
          <ac:spMkLst>
            <pc:docMk/>
            <pc:sldMk cId="200882343" sldId="389"/>
            <ac:spMk id="17" creationId="{58251154-73FB-6AD6-17B9-8611A5847FD1}"/>
          </ac:spMkLst>
        </pc:spChg>
        <pc:spChg chg="add mod">
          <ac:chgData name="Belaid, Sirine" userId="S::belaids@upmc.edu::5dcb4cf5-c058-49ea-93f8-4f4e6c877fcd" providerId="AD" clId="Web-{063A331D-F9CF-3389-F915-DE4D8F5EEB28}" dt="2024-12-04T19:24:33.414" v="431" actId="1076"/>
          <ac:spMkLst>
            <pc:docMk/>
            <pc:sldMk cId="200882343" sldId="389"/>
            <ac:spMk id="18" creationId="{5D8BE32C-7C82-C770-0011-5ECD0EF2465D}"/>
          </ac:spMkLst>
        </pc:spChg>
        <pc:spChg chg="add mod">
          <ac:chgData name="Belaid, Sirine" userId="S::belaids@upmc.edu::5dcb4cf5-c058-49ea-93f8-4f4e6c877fcd" providerId="AD" clId="Web-{063A331D-F9CF-3389-F915-DE4D8F5EEB28}" dt="2024-12-04T19:26:00.618" v="452" actId="14100"/>
          <ac:spMkLst>
            <pc:docMk/>
            <pc:sldMk cId="200882343" sldId="389"/>
            <ac:spMk id="19" creationId="{0043638C-45D5-60A2-2BD3-922AF314EA72}"/>
          </ac:spMkLst>
        </pc:spChg>
        <pc:spChg chg="add mod">
          <ac:chgData name="Belaid, Sirine" userId="S::belaids@upmc.edu::5dcb4cf5-c058-49ea-93f8-4f4e6c877fcd" providerId="AD" clId="Web-{063A331D-F9CF-3389-F915-DE4D8F5EEB28}" dt="2024-12-04T19:30:32.262" v="479" actId="1076"/>
          <ac:spMkLst>
            <pc:docMk/>
            <pc:sldMk cId="200882343" sldId="389"/>
            <ac:spMk id="20" creationId="{54F9B086-14EA-1CB9-B537-BE83DDEBDC33}"/>
          </ac:spMkLst>
        </pc:spChg>
        <pc:picChg chg="add mod">
          <ac:chgData name="Belaid, Sirine" userId="S::belaids@upmc.edu::5dcb4cf5-c058-49ea-93f8-4f4e6c877fcd" providerId="AD" clId="Web-{063A331D-F9CF-3389-F915-DE4D8F5EEB28}" dt="2024-12-04T19:10:59.170" v="286" actId="1076"/>
          <ac:picMkLst>
            <pc:docMk/>
            <pc:sldMk cId="200882343" sldId="389"/>
            <ac:picMk id="3" creationId="{CEC32265-2615-476F-2D7F-C458C8B570E7}"/>
          </ac:picMkLst>
        </pc:picChg>
        <pc:picChg chg="add mod ord">
          <ac:chgData name="Belaid, Sirine" userId="S::belaids@upmc.edu::5dcb4cf5-c058-49ea-93f8-4f4e6c877fcd" providerId="AD" clId="Web-{063A331D-F9CF-3389-F915-DE4D8F5EEB28}" dt="2024-12-04T19:11:04.061" v="288" actId="1076"/>
          <ac:picMkLst>
            <pc:docMk/>
            <pc:sldMk cId="200882343" sldId="389"/>
            <ac:picMk id="4" creationId="{A7939DCD-F150-35BD-8615-6C389F88659C}"/>
          </ac:picMkLst>
        </pc:picChg>
        <pc:picChg chg="add mod">
          <ac:chgData name="Belaid, Sirine" userId="S::belaids@upmc.edu::5dcb4cf5-c058-49ea-93f8-4f4e6c877fcd" providerId="AD" clId="Web-{063A331D-F9CF-3389-F915-DE4D8F5EEB28}" dt="2024-12-04T19:12:17.358" v="297" actId="1076"/>
          <ac:picMkLst>
            <pc:docMk/>
            <pc:sldMk cId="200882343" sldId="389"/>
            <ac:picMk id="13" creationId="{C9DD50D9-0DCE-DF9E-FAC6-219E32F956A8}"/>
          </ac:picMkLst>
        </pc:picChg>
        <pc:picChg chg="add del mod">
          <ac:chgData name="Belaid, Sirine" userId="S::belaids@upmc.edu::5dcb4cf5-c058-49ea-93f8-4f4e6c877fcd" providerId="AD" clId="Web-{063A331D-F9CF-3389-F915-DE4D8F5EEB28}" dt="2024-12-04T19:19:01.613" v="334"/>
          <ac:picMkLst>
            <pc:docMk/>
            <pc:sldMk cId="200882343" sldId="389"/>
            <ac:picMk id="14" creationId="{7D004BB9-EAAB-E0E6-7405-19EE04F28EB5}"/>
          </ac:picMkLst>
        </pc:picChg>
        <pc:cxnChg chg="add mod">
          <ac:chgData name="Belaid, Sirine" userId="S::belaids@upmc.edu::5dcb4cf5-c058-49ea-93f8-4f4e6c877fcd" providerId="AD" clId="Web-{063A331D-F9CF-3389-F915-DE4D8F5EEB28}" dt="2024-12-04T19:11:01.436" v="287" actId="1076"/>
          <ac:cxnSpMkLst>
            <pc:docMk/>
            <pc:sldMk cId="200882343" sldId="389"/>
            <ac:cxnSpMk id="8" creationId="{C4F96CAB-3BF6-DE6A-B601-E8566B0AB755}"/>
          </ac:cxnSpMkLst>
        </pc:cxnChg>
      </pc:sldChg>
      <pc:sldChg chg="addSp delSp modSp new">
        <pc:chgData name="Belaid, Sirine" userId="S::belaids@upmc.edu::5dcb4cf5-c058-49ea-93f8-4f4e6c877fcd" providerId="AD" clId="Web-{063A331D-F9CF-3389-F915-DE4D8F5EEB28}" dt="2024-12-04T19:18:36.003" v="332" actId="1076"/>
        <pc:sldMkLst>
          <pc:docMk/>
          <pc:sldMk cId="3397044096" sldId="390"/>
        </pc:sldMkLst>
        <pc:spChg chg="del">
          <ac:chgData name="Belaid, Sirine" userId="S::belaids@upmc.edu::5dcb4cf5-c058-49ea-93f8-4f4e6c877fcd" providerId="AD" clId="Web-{063A331D-F9CF-3389-F915-DE4D8F5EEB28}" dt="2024-12-04T18:35:39.927" v="135"/>
          <ac:spMkLst>
            <pc:docMk/>
            <pc:sldMk cId="3397044096" sldId="390"/>
            <ac:spMk id="2" creationId="{A8A64903-78F8-590C-907E-29FF52ADDF94}"/>
          </ac:spMkLst>
        </pc:spChg>
        <pc:spChg chg="del">
          <ac:chgData name="Belaid, Sirine" userId="S::belaids@upmc.edu::5dcb4cf5-c058-49ea-93f8-4f4e6c877fcd" providerId="AD" clId="Web-{063A331D-F9CF-3389-F915-DE4D8F5EEB28}" dt="2024-12-04T18:35:45.177" v="136"/>
          <ac:spMkLst>
            <pc:docMk/>
            <pc:sldMk cId="3397044096" sldId="390"/>
            <ac:spMk id="3" creationId="{3FBC25DE-E321-D132-DFD5-5DD35194D364}"/>
          </ac:spMkLst>
        </pc:spChg>
        <pc:spChg chg="add del mod">
          <ac:chgData name="Belaid, Sirine" userId="S::belaids@upmc.edu::5dcb4cf5-c058-49ea-93f8-4f4e6c877fcd" providerId="AD" clId="Web-{063A331D-F9CF-3389-F915-DE4D8F5EEB28}" dt="2024-12-04T18:45:31.496" v="156"/>
          <ac:spMkLst>
            <pc:docMk/>
            <pc:sldMk cId="3397044096" sldId="390"/>
            <ac:spMk id="5" creationId="{38D5C561-FF98-39DC-14D9-3D2ACAF57DDE}"/>
          </ac:spMkLst>
        </pc:spChg>
        <pc:spChg chg="add mod">
          <ac:chgData name="Belaid, Sirine" userId="S::belaids@upmc.edu::5dcb4cf5-c058-49ea-93f8-4f4e6c877fcd" providerId="AD" clId="Web-{063A331D-F9CF-3389-F915-DE4D8F5EEB28}" dt="2024-12-04T19:01:25.976" v="224" actId="14100"/>
          <ac:spMkLst>
            <pc:docMk/>
            <pc:sldMk cId="3397044096" sldId="390"/>
            <ac:spMk id="12" creationId="{DA97FB52-3166-017D-EFEC-4F703F1E1CDA}"/>
          </ac:spMkLst>
        </pc:spChg>
        <pc:spChg chg="add mod">
          <ac:chgData name="Belaid, Sirine" userId="S::belaids@upmc.edu::5dcb4cf5-c058-49ea-93f8-4f4e6c877fcd" providerId="AD" clId="Web-{063A331D-F9CF-3389-F915-DE4D8F5EEB28}" dt="2024-12-04T19:08:15.824" v="237" actId="20577"/>
          <ac:spMkLst>
            <pc:docMk/>
            <pc:sldMk cId="3397044096" sldId="390"/>
            <ac:spMk id="14" creationId="{0A85DAAE-964A-2DDE-DCC6-4F339D7AE66A}"/>
          </ac:spMkLst>
        </pc:spChg>
        <pc:spChg chg="add mod">
          <ac:chgData name="Belaid, Sirine" userId="S::belaids@upmc.edu::5dcb4cf5-c058-49ea-93f8-4f4e6c877fcd" providerId="AD" clId="Web-{063A331D-F9CF-3389-F915-DE4D8F5EEB28}" dt="2024-12-04T19:18:36.003" v="332" actId="1076"/>
          <ac:spMkLst>
            <pc:docMk/>
            <pc:sldMk cId="3397044096" sldId="390"/>
            <ac:spMk id="15" creationId="{422DB743-F04E-F7B1-FA94-CB3C55FB7E32}"/>
          </ac:spMkLst>
        </pc:spChg>
        <pc:picChg chg="add mod">
          <ac:chgData name="Belaid, Sirine" userId="S::belaids@upmc.edu::5dcb4cf5-c058-49ea-93f8-4f4e6c877fcd" providerId="AD" clId="Web-{063A331D-F9CF-3389-F915-DE4D8F5EEB28}" dt="2024-12-04T19:00:21.616" v="198" actId="1076"/>
          <ac:picMkLst>
            <pc:docMk/>
            <pc:sldMk cId="3397044096" sldId="390"/>
            <ac:picMk id="6" creationId="{593412EE-9CD8-3360-D073-C451344448E2}"/>
          </ac:picMkLst>
        </pc:picChg>
        <pc:picChg chg="add mod">
          <ac:chgData name="Belaid, Sirine" userId="S::belaids@upmc.edu::5dcb4cf5-c058-49ea-93f8-4f4e6c877fcd" providerId="AD" clId="Web-{063A331D-F9CF-3389-F915-DE4D8F5EEB28}" dt="2024-12-04T19:00:19.944" v="197" actId="1076"/>
          <ac:picMkLst>
            <pc:docMk/>
            <pc:sldMk cId="3397044096" sldId="390"/>
            <ac:picMk id="7" creationId="{782871B7-678D-029C-488B-DCB318204F6A}"/>
          </ac:picMkLst>
        </pc:picChg>
        <pc:picChg chg="add del mod">
          <ac:chgData name="Belaid, Sirine" userId="S::belaids@upmc.edu::5dcb4cf5-c058-49ea-93f8-4f4e6c877fcd" providerId="AD" clId="Web-{063A331D-F9CF-3389-F915-DE4D8F5EEB28}" dt="2024-12-04T19:00:08.475" v="192"/>
          <ac:picMkLst>
            <pc:docMk/>
            <pc:sldMk cId="3397044096" sldId="390"/>
            <ac:picMk id="8" creationId="{86CE3819-E13B-14A5-4120-487C79C66B62}"/>
          </ac:picMkLst>
        </pc:picChg>
        <pc:picChg chg="add mod">
          <ac:chgData name="Belaid, Sirine" userId="S::belaids@upmc.edu::5dcb4cf5-c058-49ea-93f8-4f4e6c877fcd" providerId="AD" clId="Web-{063A331D-F9CF-3389-F915-DE4D8F5EEB28}" dt="2024-12-04T19:00:22.928" v="199" actId="1076"/>
          <ac:picMkLst>
            <pc:docMk/>
            <pc:sldMk cId="3397044096" sldId="390"/>
            <ac:picMk id="9" creationId="{90739691-6DF8-5C8C-CD43-A7C190DB7236}"/>
          </ac:picMkLst>
        </pc:picChg>
        <pc:picChg chg="add del mod">
          <ac:chgData name="Belaid, Sirine" userId="S::belaids@upmc.edu::5dcb4cf5-c058-49ea-93f8-4f4e6c877fcd" providerId="AD" clId="Web-{063A331D-F9CF-3389-F915-DE4D8F5EEB28}" dt="2024-12-04T18:50:04.624" v="182"/>
          <ac:picMkLst>
            <pc:docMk/>
            <pc:sldMk cId="3397044096" sldId="390"/>
            <ac:picMk id="10" creationId="{2E8FE906-4F57-B80C-ACDA-6875871DD1DD}"/>
          </ac:picMkLst>
        </pc:picChg>
      </pc:sldChg>
      <pc:sldChg chg="new del">
        <pc:chgData name="Belaid, Sirine" userId="S::belaids@upmc.edu::5dcb4cf5-c058-49ea-93f8-4f4e6c877fcd" providerId="AD" clId="Web-{063A331D-F9CF-3389-F915-DE4D8F5EEB28}" dt="2024-12-04T18:36:10.615" v="138"/>
        <pc:sldMkLst>
          <pc:docMk/>
          <pc:sldMk cId="1929126946" sldId="391"/>
        </pc:sldMkLst>
      </pc:sldChg>
    </pc:docChg>
  </pc:docChgLst>
  <pc:docChgLst>
    <pc:chgData name="Belaid, Sirine" userId="S::belaids@upmc.edu::5dcb4cf5-c058-49ea-93f8-4f4e6c877fcd" providerId="AD" clId="Web-{B44185C5-CF89-25BE-0A53-CCCDB41D0EEF}"/>
    <pc:docChg chg="modSld sldOrd">
      <pc:chgData name="Belaid, Sirine" userId="S::belaids@upmc.edu::5dcb4cf5-c058-49ea-93f8-4f4e6c877fcd" providerId="AD" clId="Web-{B44185C5-CF89-25BE-0A53-CCCDB41D0EEF}" dt="2024-12-13T03:31:35.235" v="194" actId="1076"/>
      <pc:docMkLst>
        <pc:docMk/>
      </pc:docMkLst>
      <pc:sldChg chg="addSp delSp modSp mod setBg">
        <pc:chgData name="Belaid, Sirine" userId="S::belaids@upmc.edu::5dcb4cf5-c058-49ea-93f8-4f4e6c877fcd" providerId="AD" clId="Web-{B44185C5-CF89-25BE-0A53-CCCDB41D0EEF}" dt="2024-12-13T03:15:21.523" v="173" actId="1076"/>
        <pc:sldMkLst>
          <pc:docMk/>
          <pc:sldMk cId="109857222" sldId="256"/>
        </pc:sldMkLst>
        <pc:spChg chg="mod">
          <ac:chgData name="Belaid, Sirine" userId="S::belaids@upmc.edu::5dcb4cf5-c058-49ea-93f8-4f4e6c877fcd" providerId="AD" clId="Web-{B44185C5-CF89-25BE-0A53-CCCDB41D0EEF}" dt="2024-12-13T03:15:21.523" v="173" actId="1076"/>
          <ac:spMkLst>
            <pc:docMk/>
            <pc:sldMk cId="109857222" sldId="256"/>
            <ac:spMk id="2" creationId="{00000000-0000-0000-0000-000000000000}"/>
          </ac:spMkLst>
        </pc:spChg>
        <pc:spChg chg="mod">
          <ac:chgData name="Belaid, Sirine" userId="S::belaids@upmc.edu::5dcb4cf5-c058-49ea-93f8-4f4e6c877fcd" providerId="AD" clId="Web-{B44185C5-CF89-25BE-0A53-CCCDB41D0EEF}" dt="2024-12-13T03:06:34.367" v="86"/>
          <ac:spMkLst>
            <pc:docMk/>
            <pc:sldMk cId="109857222" sldId="256"/>
            <ac:spMk id="3" creationId="{00000000-0000-0000-0000-000000000000}"/>
          </ac:spMkLst>
        </pc:spChg>
        <pc:spChg chg="add del">
          <ac:chgData name="Belaid, Sirine" userId="S::belaids@upmc.edu::5dcb4cf5-c058-49ea-93f8-4f4e6c877fcd" providerId="AD" clId="Web-{B44185C5-CF89-25BE-0A53-CCCDB41D0EEF}" dt="2024-12-13T03:06:34.367" v="86"/>
          <ac:spMkLst>
            <pc:docMk/>
            <pc:sldMk cId="109857222" sldId="256"/>
            <ac:spMk id="8" creationId="{1ACA2EA0-FFD3-42EC-9406-B595015ED96E}"/>
          </ac:spMkLst>
        </pc:spChg>
        <pc:spChg chg="add del">
          <ac:chgData name="Belaid, Sirine" userId="S::belaids@upmc.edu::5dcb4cf5-c058-49ea-93f8-4f4e6c877fcd" providerId="AD" clId="Web-{B44185C5-CF89-25BE-0A53-CCCDB41D0EEF}" dt="2024-12-13T03:06:34.367" v="86"/>
          <ac:spMkLst>
            <pc:docMk/>
            <pc:sldMk cId="109857222" sldId="256"/>
            <ac:spMk id="10" creationId="{D5288BCE-665C-472A-8C43-664BCFA31E43}"/>
          </ac:spMkLst>
        </pc:spChg>
        <pc:spChg chg="add del">
          <ac:chgData name="Belaid, Sirine" userId="S::belaids@upmc.edu::5dcb4cf5-c058-49ea-93f8-4f4e6c877fcd" providerId="AD" clId="Web-{B44185C5-CF89-25BE-0A53-CCCDB41D0EEF}" dt="2024-12-13T03:06:34.367" v="86"/>
          <ac:spMkLst>
            <pc:docMk/>
            <pc:sldMk cId="109857222" sldId="256"/>
            <ac:spMk id="12" creationId="{46C57131-53A7-4C1A-BEA8-25F06A06AD29}"/>
          </ac:spMkLst>
        </pc:spChg>
        <pc:spChg chg="add del">
          <ac:chgData name="Belaid, Sirine" userId="S::belaids@upmc.edu::5dcb4cf5-c058-49ea-93f8-4f4e6c877fcd" providerId="AD" clId="Web-{B44185C5-CF89-25BE-0A53-CCCDB41D0EEF}" dt="2024-12-13T03:06:31.460" v="83"/>
          <ac:spMkLst>
            <pc:docMk/>
            <pc:sldMk cId="109857222" sldId="256"/>
            <ac:spMk id="17" creationId="{43C48B49-6135-48B6-AC0F-97E5D8D1F03F}"/>
          </ac:spMkLst>
        </pc:spChg>
        <pc:spChg chg="add del">
          <ac:chgData name="Belaid, Sirine" userId="S::belaids@upmc.edu::5dcb4cf5-c058-49ea-93f8-4f4e6c877fcd" providerId="AD" clId="Web-{B44185C5-CF89-25BE-0A53-CCCDB41D0EEF}" dt="2024-12-13T03:06:31.460" v="83"/>
          <ac:spMkLst>
            <pc:docMk/>
            <pc:sldMk cId="109857222" sldId="256"/>
            <ac:spMk id="19" creationId="{9715DAF0-AE1B-46C9-8A6B-DB2AA05AB91D}"/>
          </ac:spMkLst>
        </pc:spChg>
        <pc:spChg chg="add del">
          <ac:chgData name="Belaid, Sirine" userId="S::belaids@upmc.edu::5dcb4cf5-c058-49ea-93f8-4f4e6c877fcd" providerId="AD" clId="Web-{B44185C5-CF89-25BE-0A53-CCCDB41D0EEF}" dt="2024-12-13T03:06:31.460" v="83"/>
          <ac:spMkLst>
            <pc:docMk/>
            <pc:sldMk cId="109857222" sldId="256"/>
            <ac:spMk id="21" creationId="{DC631C0B-6DA6-4E57-8231-CE32B3434A7E}"/>
          </ac:spMkLst>
        </pc:spChg>
        <pc:spChg chg="add del">
          <ac:chgData name="Belaid, Sirine" userId="S::belaids@upmc.edu::5dcb4cf5-c058-49ea-93f8-4f4e6c877fcd" providerId="AD" clId="Web-{B44185C5-CF89-25BE-0A53-CCCDB41D0EEF}" dt="2024-12-13T03:06:31.460" v="83"/>
          <ac:spMkLst>
            <pc:docMk/>
            <pc:sldMk cId="109857222" sldId="256"/>
            <ac:spMk id="23" creationId="{F256AC18-FB41-4977-8B0C-F5082335AB7D}"/>
          </ac:spMkLst>
        </pc:spChg>
        <pc:spChg chg="add del">
          <ac:chgData name="Belaid, Sirine" userId="S::belaids@upmc.edu::5dcb4cf5-c058-49ea-93f8-4f4e6c877fcd" providerId="AD" clId="Web-{B44185C5-CF89-25BE-0A53-CCCDB41D0EEF}" dt="2024-12-13T03:06:31.460" v="83"/>
          <ac:spMkLst>
            <pc:docMk/>
            <pc:sldMk cId="109857222" sldId="256"/>
            <ac:spMk id="25" creationId="{AFF4A713-7B75-4B21-90D7-5AB19547C728}"/>
          </ac:spMkLst>
        </pc:spChg>
        <pc:spChg chg="add del">
          <ac:chgData name="Belaid, Sirine" userId="S::belaids@upmc.edu::5dcb4cf5-c058-49ea-93f8-4f4e6c877fcd" providerId="AD" clId="Web-{B44185C5-CF89-25BE-0A53-CCCDB41D0EEF}" dt="2024-12-13T03:06:34.367" v="85"/>
          <ac:spMkLst>
            <pc:docMk/>
            <pc:sldMk cId="109857222" sldId="256"/>
            <ac:spMk id="27" creationId="{C29501E6-A978-4A61-9689-9085AF97A53A}"/>
          </ac:spMkLst>
        </pc:spChg>
        <pc:spChg chg="add del">
          <ac:chgData name="Belaid, Sirine" userId="S::belaids@upmc.edu::5dcb4cf5-c058-49ea-93f8-4f4e6c877fcd" providerId="AD" clId="Web-{B44185C5-CF89-25BE-0A53-CCCDB41D0EEF}" dt="2024-12-13T03:06:34.367" v="85"/>
          <ac:spMkLst>
            <pc:docMk/>
            <pc:sldMk cId="109857222" sldId="256"/>
            <ac:spMk id="28" creationId="{6F5A5072-7B47-4D32-B52A-4EBBF590B8A5}"/>
          </ac:spMkLst>
        </pc:spChg>
        <pc:spChg chg="add del">
          <ac:chgData name="Belaid, Sirine" userId="S::belaids@upmc.edu::5dcb4cf5-c058-49ea-93f8-4f4e6c877fcd" providerId="AD" clId="Web-{B44185C5-CF89-25BE-0A53-CCCDB41D0EEF}" dt="2024-12-13T03:06:34.367" v="85"/>
          <ac:spMkLst>
            <pc:docMk/>
            <pc:sldMk cId="109857222" sldId="256"/>
            <ac:spMk id="29" creationId="{9715DAF0-AE1B-46C9-8A6B-DB2AA05AB91D}"/>
          </ac:spMkLst>
        </pc:spChg>
        <pc:spChg chg="add del">
          <ac:chgData name="Belaid, Sirine" userId="S::belaids@upmc.edu::5dcb4cf5-c058-49ea-93f8-4f4e6c877fcd" providerId="AD" clId="Web-{B44185C5-CF89-25BE-0A53-CCCDB41D0EEF}" dt="2024-12-13T03:06:34.367" v="85"/>
          <ac:spMkLst>
            <pc:docMk/>
            <pc:sldMk cId="109857222" sldId="256"/>
            <ac:spMk id="30" creationId="{6016219D-510E-4184-9090-6D5578A87BD1}"/>
          </ac:spMkLst>
        </pc:spChg>
        <pc:spChg chg="add del">
          <ac:chgData name="Belaid, Sirine" userId="S::belaids@upmc.edu::5dcb4cf5-c058-49ea-93f8-4f4e6c877fcd" providerId="AD" clId="Web-{B44185C5-CF89-25BE-0A53-CCCDB41D0EEF}" dt="2024-12-13T03:06:34.367" v="85"/>
          <ac:spMkLst>
            <pc:docMk/>
            <pc:sldMk cId="109857222" sldId="256"/>
            <ac:spMk id="31" creationId="{AFF4A713-7B75-4B21-90D7-5AB19547C728}"/>
          </ac:spMkLst>
        </pc:spChg>
        <pc:spChg chg="add del">
          <ac:chgData name="Belaid, Sirine" userId="S::belaids@upmc.edu::5dcb4cf5-c058-49ea-93f8-4f4e6c877fcd" providerId="AD" clId="Web-{B44185C5-CF89-25BE-0A53-CCCDB41D0EEF}" dt="2024-12-13T03:06:34.367" v="85"/>
          <ac:spMkLst>
            <pc:docMk/>
            <pc:sldMk cId="109857222" sldId="256"/>
            <ac:spMk id="32" creationId="{DC631C0B-6DA6-4E57-8231-CE32B3434A7E}"/>
          </ac:spMkLst>
        </pc:spChg>
        <pc:spChg chg="add">
          <ac:chgData name="Belaid, Sirine" userId="S::belaids@upmc.edu::5dcb4cf5-c058-49ea-93f8-4f4e6c877fcd" providerId="AD" clId="Web-{B44185C5-CF89-25BE-0A53-CCCDB41D0EEF}" dt="2024-12-13T03:06:34.367" v="86"/>
          <ac:spMkLst>
            <pc:docMk/>
            <pc:sldMk cId="109857222" sldId="256"/>
            <ac:spMk id="34" creationId="{43C48B49-6135-48B6-AC0F-97E5D8D1F03F}"/>
          </ac:spMkLst>
        </pc:spChg>
        <pc:spChg chg="add">
          <ac:chgData name="Belaid, Sirine" userId="S::belaids@upmc.edu::5dcb4cf5-c058-49ea-93f8-4f4e6c877fcd" providerId="AD" clId="Web-{B44185C5-CF89-25BE-0A53-CCCDB41D0EEF}" dt="2024-12-13T03:06:34.367" v="86"/>
          <ac:spMkLst>
            <pc:docMk/>
            <pc:sldMk cId="109857222" sldId="256"/>
            <ac:spMk id="35" creationId="{9715DAF0-AE1B-46C9-8A6B-DB2AA05AB91D}"/>
          </ac:spMkLst>
        </pc:spChg>
        <pc:spChg chg="add">
          <ac:chgData name="Belaid, Sirine" userId="S::belaids@upmc.edu::5dcb4cf5-c058-49ea-93f8-4f4e6c877fcd" providerId="AD" clId="Web-{B44185C5-CF89-25BE-0A53-CCCDB41D0EEF}" dt="2024-12-13T03:06:34.367" v="86"/>
          <ac:spMkLst>
            <pc:docMk/>
            <pc:sldMk cId="109857222" sldId="256"/>
            <ac:spMk id="36" creationId="{DC631C0B-6DA6-4E57-8231-CE32B3434A7E}"/>
          </ac:spMkLst>
        </pc:spChg>
        <pc:spChg chg="add">
          <ac:chgData name="Belaid, Sirine" userId="S::belaids@upmc.edu::5dcb4cf5-c058-49ea-93f8-4f4e6c877fcd" providerId="AD" clId="Web-{B44185C5-CF89-25BE-0A53-CCCDB41D0EEF}" dt="2024-12-13T03:06:34.367" v="86"/>
          <ac:spMkLst>
            <pc:docMk/>
            <pc:sldMk cId="109857222" sldId="256"/>
            <ac:spMk id="37" creationId="{F256AC18-FB41-4977-8B0C-F5082335AB7D}"/>
          </ac:spMkLst>
        </pc:spChg>
        <pc:spChg chg="add">
          <ac:chgData name="Belaid, Sirine" userId="S::belaids@upmc.edu::5dcb4cf5-c058-49ea-93f8-4f4e6c877fcd" providerId="AD" clId="Web-{B44185C5-CF89-25BE-0A53-CCCDB41D0EEF}" dt="2024-12-13T03:06:34.367" v="86"/>
          <ac:spMkLst>
            <pc:docMk/>
            <pc:sldMk cId="109857222" sldId="256"/>
            <ac:spMk id="38" creationId="{AFF4A713-7B75-4B21-90D7-5AB19547C728}"/>
          </ac:spMkLst>
        </pc:spChg>
      </pc:sldChg>
      <pc:sldChg chg="addAnim">
        <pc:chgData name="Belaid, Sirine" userId="S::belaids@upmc.edu::5dcb4cf5-c058-49ea-93f8-4f4e6c877fcd" providerId="AD" clId="Web-{B44185C5-CF89-25BE-0A53-CCCDB41D0EEF}" dt="2024-12-13T02:51:42.668" v="14"/>
        <pc:sldMkLst>
          <pc:docMk/>
          <pc:sldMk cId="1500721348" sldId="258"/>
        </pc:sldMkLst>
      </pc:sldChg>
      <pc:sldChg chg="addAnim">
        <pc:chgData name="Belaid, Sirine" userId="S::belaids@upmc.edu::5dcb4cf5-c058-49ea-93f8-4f4e6c877fcd" providerId="AD" clId="Web-{B44185C5-CF89-25BE-0A53-CCCDB41D0EEF}" dt="2024-12-13T02:55:46.894" v="30"/>
        <pc:sldMkLst>
          <pc:docMk/>
          <pc:sldMk cId="4094227945" sldId="352"/>
        </pc:sldMkLst>
      </pc:sldChg>
      <pc:sldChg chg="addAnim">
        <pc:chgData name="Belaid, Sirine" userId="S::belaids@upmc.edu::5dcb4cf5-c058-49ea-93f8-4f4e6c877fcd" providerId="AD" clId="Web-{B44185C5-CF89-25BE-0A53-CCCDB41D0EEF}" dt="2024-12-13T02:55:53.128" v="31"/>
        <pc:sldMkLst>
          <pc:docMk/>
          <pc:sldMk cId="3868067760" sldId="357"/>
        </pc:sldMkLst>
      </pc:sldChg>
      <pc:sldChg chg="addAnim">
        <pc:chgData name="Belaid, Sirine" userId="S::belaids@upmc.edu::5dcb4cf5-c058-49ea-93f8-4f4e6c877fcd" providerId="AD" clId="Web-{B44185C5-CF89-25BE-0A53-CCCDB41D0EEF}" dt="2024-12-13T02:57:08.678" v="37"/>
        <pc:sldMkLst>
          <pc:docMk/>
          <pc:sldMk cId="1919480477" sldId="360"/>
        </pc:sldMkLst>
      </pc:sldChg>
      <pc:sldChg chg="addAnim">
        <pc:chgData name="Belaid, Sirine" userId="S::belaids@upmc.edu::5dcb4cf5-c058-49ea-93f8-4f4e6c877fcd" providerId="AD" clId="Web-{B44185C5-CF89-25BE-0A53-CCCDB41D0EEF}" dt="2024-12-13T02:57:53.304" v="38"/>
        <pc:sldMkLst>
          <pc:docMk/>
          <pc:sldMk cId="2817742152" sldId="361"/>
        </pc:sldMkLst>
      </pc:sldChg>
      <pc:sldChg chg="addAnim">
        <pc:chgData name="Belaid, Sirine" userId="S::belaids@upmc.edu::5dcb4cf5-c058-49ea-93f8-4f4e6c877fcd" providerId="AD" clId="Web-{B44185C5-CF89-25BE-0A53-CCCDB41D0EEF}" dt="2024-12-13T02:56:49.224" v="35"/>
        <pc:sldMkLst>
          <pc:docMk/>
          <pc:sldMk cId="2090633080" sldId="362"/>
        </pc:sldMkLst>
      </pc:sldChg>
      <pc:sldChg chg="addSp modSp mod setBg">
        <pc:chgData name="Belaid, Sirine" userId="S::belaids@upmc.edu::5dcb4cf5-c058-49ea-93f8-4f4e6c877fcd" providerId="AD" clId="Web-{B44185C5-CF89-25BE-0A53-CCCDB41D0EEF}" dt="2024-12-13T03:13:22.144" v="168" actId="1076"/>
        <pc:sldMkLst>
          <pc:docMk/>
          <pc:sldMk cId="3864006159" sldId="363"/>
        </pc:sldMkLst>
        <pc:spChg chg="mod">
          <ac:chgData name="Belaid, Sirine" userId="S::belaids@upmc.edu::5dcb4cf5-c058-49ea-93f8-4f4e6c877fcd" providerId="AD" clId="Web-{B44185C5-CF89-25BE-0A53-CCCDB41D0EEF}" dt="2024-12-13T03:05:45.615" v="77"/>
          <ac:spMkLst>
            <pc:docMk/>
            <pc:sldMk cId="3864006159" sldId="363"/>
            <ac:spMk id="2" creationId="{1E63AA7C-D8CC-24E2-1927-C63C14BF6FAB}"/>
          </ac:spMkLst>
        </pc:spChg>
        <pc:spChg chg="mod">
          <ac:chgData name="Belaid, Sirine" userId="S::belaids@upmc.edu::5dcb4cf5-c058-49ea-93f8-4f4e6c877fcd" providerId="AD" clId="Web-{B44185C5-CF89-25BE-0A53-CCCDB41D0EEF}" dt="2024-12-13T03:07:48.525" v="95" actId="1076"/>
          <ac:spMkLst>
            <pc:docMk/>
            <pc:sldMk cId="3864006159" sldId="363"/>
            <ac:spMk id="3" creationId="{6B57145F-A3D4-5C8F-5BBE-CC4E7BC1E90B}"/>
          </ac:spMkLst>
        </pc:spChg>
        <pc:spChg chg="add">
          <ac:chgData name="Belaid, Sirine" userId="S::belaids@upmc.edu::5dcb4cf5-c058-49ea-93f8-4f4e6c877fcd" providerId="AD" clId="Web-{B44185C5-CF89-25BE-0A53-CCCDB41D0EEF}" dt="2024-12-13T03:05:45.615" v="77"/>
          <ac:spMkLst>
            <pc:docMk/>
            <pc:sldMk cId="3864006159" sldId="363"/>
            <ac:spMk id="8" creationId="{6F5A5072-7B47-4D32-B52A-4EBBF590B8A5}"/>
          </ac:spMkLst>
        </pc:spChg>
        <pc:spChg chg="add">
          <ac:chgData name="Belaid, Sirine" userId="S::belaids@upmc.edu::5dcb4cf5-c058-49ea-93f8-4f4e6c877fcd" providerId="AD" clId="Web-{B44185C5-CF89-25BE-0A53-CCCDB41D0EEF}" dt="2024-12-13T03:05:45.615" v="77"/>
          <ac:spMkLst>
            <pc:docMk/>
            <pc:sldMk cId="3864006159" sldId="363"/>
            <ac:spMk id="10" creationId="{9715DAF0-AE1B-46C9-8A6B-DB2AA05AB91D}"/>
          </ac:spMkLst>
        </pc:spChg>
        <pc:spChg chg="add">
          <ac:chgData name="Belaid, Sirine" userId="S::belaids@upmc.edu::5dcb4cf5-c058-49ea-93f8-4f4e6c877fcd" providerId="AD" clId="Web-{B44185C5-CF89-25BE-0A53-CCCDB41D0EEF}" dt="2024-12-13T03:05:45.615" v="77"/>
          <ac:spMkLst>
            <pc:docMk/>
            <pc:sldMk cId="3864006159" sldId="363"/>
            <ac:spMk id="12" creationId="{6016219D-510E-4184-9090-6D5578A87BD1}"/>
          </ac:spMkLst>
        </pc:spChg>
        <pc:spChg chg="add">
          <ac:chgData name="Belaid, Sirine" userId="S::belaids@upmc.edu::5dcb4cf5-c058-49ea-93f8-4f4e6c877fcd" providerId="AD" clId="Web-{B44185C5-CF89-25BE-0A53-CCCDB41D0EEF}" dt="2024-12-13T03:05:45.615" v="77"/>
          <ac:spMkLst>
            <pc:docMk/>
            <pc:sldMk cId="3864006159" sldId="363"/>
            <ac:spMk id="14" creationId="{AFF4A713-7B75-4B21-90D7-5AB19547C728}"/>
          </ac:spMkLst>
        </pc:spChg>
        <pc:spChg chg="add">
          <ac:chgData name="Belaid, Sirine" userId="S::belaids@upmc.edu::5dcb4cf5-c058-49ea-93f8-4f4e6c877fcd" providerId="AD" clId="Web-{B44185C5-CF89-25BE-0A53-CCCDB41D0EEF}" dt="2024-12-13T03:05:45.615" v="77"/>
          <ac:spMkLst>
            <pc:docMk/>
            <pc:sldMk cId="3864006159" sldId="363"/>
            <ac:spMk id="16" creationId="{DC631C0B-6DA6-4E57-8231-CE32B3434A7E}"/>
          </ac:spMkLst>
        </pc:spChg>
        <pc:spChg chg="add">
          <ac:chgData name="Belaid, Sirine" userId="S::belaids@upmc.edu::5dcb4cf5-c058-49ea-93f8-4f4e6c877fcd" providerId="AD" clId="Web-{B44185C5-CF89-25BE-0A53-CCCDB41D0EEF}" dt="2024-12-13T03:05:45.615" v="77"/>
          <ac:spMkLst>
            <pc:docMk/>
            <pc:sldMk cId="3864006159" sldId="363"/>
            <ac:spMk id="18" creationId="{C29501E6-A978-4A61-9689-9085AF97A53A}"/>
          </ac:spMkLst>
        </pc:spChg>
        <pc:picChg chg="add mod">
          <ac:chgData name="Belaid, Sirine" userId="S::belaids@upmc.edu::5dcb4cf5-c058-49ea-93f8-4f4e6c877fcd" providerId="AD" clId="Web-{B44185C5-CF89-25BE-0A53-CCCDB41D0EEF}" dt="2024-12-13T03:13:22.144" v="168" actId="1076"/>
          <ac:picMkLst>
            <pc:docMk/>
            <pc:sldMk cId="3864006159" sldId="363"/>
            <ac:picMk id="5" creationId="{E019E510-CD94-201C-D283-353703756836}"/>
          </ac:picMkLst>
        </pc:picChg>
      </pc:sldChg>
      <pc:sldChg chg="addSp delSp modSp mod setBg">
        <pc:chgData name="Belaid, Sirine" userId="S::belaids@upmc.edu::5dcb4cf5-c058-49ea-93f8-4f4e6c877fcd" providerId="AD" clId="Web-{B44185C5-CF89-25BE-0A53-CCCDB41D0EEF}" dt="2024-12-13T03:13:11.347" v="166"/>
        <pc:sldMkLst>
          <pc:docMk/>
          <pc:sldMk cId="2414223819" sldId="364"/>
        </pc:sldMkLst>
        <pc:spChg chg="mod">
          <ac:chgData name="Belaid, Sirine" userId="S::belaids@upmc.edu::5dcb4cf5-c058-49ea-93f8-4f4e6c877fcd" providerId="AD" clId="Web-{B44185C5-CF89-25BE-0A53-CCCDB41D0EEF}" dt="2024-12-13T03:05:35.224" v="76"/>
          <ac:spMkLst>
            <pc:docMk/>
            <pc:sldMk cId="2414223819" sldId="364"/>
            <ac:spMk id="2" creationId="{1E63AA7C-D8CC-24E2-1927-C63C14BF6FAB}"/>
          </ac:spMkLst>
        </pc:spChg>
        <pc:spChg chg="mod">
          <ac:chgData name="Belaid, Sirine" userId="S::belaids@upmc.edu::5dcb4cf5-c058-49ea-93f8-4f4e6c877fcd" providerId="AD" clId="Web-{B44185C5-CF89-25BE-0A53-CCCDB41D0EEF}" dt="2024-12-13T03:07:04.774" v="89" actId="1076"/>
          <ac:spMkLst>
            <pc:docMk/>
            <pc:sldMk cId="2414223819" sldId="364"/>
            <ac:spMk id="3" creationId="{6B57145F-A3D4-5C8F-5BBE-CC4E7BC1E90B}"/>
          </ac:spMkLst>
        </pc:spChg>
        <pc:spChg chg="add del">
          <ac:chgData name="Belaid, Sirine" userId="S::belaids@upmc.edu::5dcb4cf5-c058-49ea-93f8-4f4e6c877fcd" providerId="AD" clId="Web-{B44185C5-CF89-25BE-0A53-CCCDB41D0EEF}" dt="2024-12-13T03:05:35.209" v="75"/>
          <ac:spMkLst>
            <pc:docMk/>
            <pc:sldMk cId="2414223819" sldId="364"/>
            <ac:spMk id="8" creationId="{934F1179-B481-4F9E-BCA3-AFB972070F83}"/>
          </ac:spMkLst>
        </pc:spChg>
        <pc:spChg chg="add del">
          <ac:chgData name="Belaid, Sirine" userId="S::belaids@upmc.edu::5dcb4cf5-c058-49ea-93f8-4f4e6c877fcd" providerId="AD" clId="Web-{B44185C5-CF89-25BE-0A53-CCCDB41D0EEF}" dt="2024-12-13T03:05:35.209" v="75"/>
          <ac:spMkLst>
            <pc:docMk/>
            <pc:sldMk cId="2414223819" sldId="364"/>
            <ac:spMk id="10" creationId="{827DC2C4-B485-428A-BF4A-472D2967F47F}"/>
          </ac:spMkLst>
        </pc:spChg>
        <pc:spChg chg="add del">
          <ac:chgData name="Belaid, Sirine" userId="S::belaids@upmc.edu::5dcb4cf5-c058-49ea-93f8-4f4e6c877fcd" providerId="AD" clId="Web-{B44185C5-CF89-25BE-0A53-CCCDB41D0EEF}" dt="2024-12-13T03:05:35.209" v="75"/>
          <ac:spMkLst>
            <pc:docMk/>
            <pc:sldMk cId="2414223819" sldId="364"/>
            <ac:spMk id="12" creationId="{EE04B5EB-F158-4507-90DD-BD23620C7CC9}"/>
          </ac:spMkLst>
        </pc:spChg>
        <pc:spChg chg="add">
          <ac:chgData name="Belaid, Sirine" userId="S::belaids@upmc.edu::5dcb4cf5-c058-49ea-93f8-4f4e6c877fcd" providerId="AD" clId="Web-{B44185C5-CF89-25BE-0A53-CCCDB41D0EEF}" dt="2024-12-13T03:05:35.224" v="76"/>
          <ac:spMkLst>
            <pc:docMk/>
            <pc:sldMk cId="2414223819" sldId="364"/>
            <ac:spMk id="14" creationId="{AFF4A713-7B75-4B21-90D7-5AB19547C728}"/>
          </ac:spMkLst>
        </pc:spChg>
        <pc:spChg chg="add">
          <ac:chgData name="Belaid, Sirine" userId="S::belaids@upmc.edu::5dcb4cf5-c058-49ea-93f8-4f4e6c877fcd" providerId="AD" clId="Web-{B44185C5-CF89-25BE-0A53-CCCDB41D0EEF}" dt="2024-12-13T03:05:35.224" v="76"/>
          <ac:spMkLst>
            <pc:docMk/>
            <pc:sldMk cId="2414223819" sldId="364"/>
            <ac:spMk id="15" creationId="{6F5A5072-7B47-4D32-B52A-4EBBF590B8A5}"/>
          </ac:spMkLst>
        </pc:spChg>
        <pc:spChg chg="add">
          <ac:chgData name="Belaid, Sirine" userId="S::belaids@upmc.edu::5dcb4cf5-c058-49ea-93f8-4f4e6c877fcd" providerId="AD" clId="Web-{B44185C5-CF89-25BE-0A53-CCCDB41D0EEF}" dt="2024-12-13T03:05:35.224" v="76"/>
          <ac:spMkLst>
            <pc:docMk/>
            <pc:sldMk cId="2414223819" sldId="364"/>
            <ac:spMk id="16" creationId="{DC631C0B-6DA6-4E57-8231-CE32B3434A7E}"/>
          </ac:spMkLst>
        </pc:spChg>
        <pc:spChg chg="add">
          <ac:chgData name="Belaid, Sirine" userId="S::belaids@upmc.edu::5dcb4cf5-c058-49ea-93f8-4f4e6c877fcd" providerId="AD" clId="Web-{B44185C5-CF89-25BE-0A53-CCCDB41D0EEF}" dt="2024-12-13T03:05:35.224" v="76"/>
          <ac:spMkLst>
            <pc:docMk/>
            <pc:sldMk cId="2414223819" sldId="364"/>
            <ac:spMk id="17" creationId="{9715DAF0-AE1B-46C9-8A6B-DB2AA05AB91D}"/>
          </ac:spMkLst>
        </pc:spChg>
        <pc:spChg chg="add">
          <ac:chgData name="Belaid, Sirine" userId="S::belaids@upmc.edu::5dcb4cf5-c058-49ea-93f8-4f4e6c877fcd" providerId="AD" clId="Web-{B44185C5-CF89-25BE-0A53-CCCDB41D0EEF}" dt="2024-12-13T03:05:35.224" v="76"/>
          <ac:spMkLst>
            <pc:docMk/>
            <pc:sldMk cId="2414223819" sldId="364"/>
            <ac:spMk id="18" creationId="{C29501E6-A978-4A61-9689-9085AF97A53A}"/>
          </ac:spMkLst>
        </pc:spChg>
        <pc:spChg chg="add">
          <ac:chgData name="Belaid, Sirine" userId="S::belaids@upmc.edu::5dcb4cf5-c058-49ea-93f8-4f4e6c877fcd" providerId="AD" clId="Web-{B44185C5-CF89-25BE-0A53-CCCDB41D0EEF}" dt="2024-12-13T03:05:35.224" v="76"/>
          <ac:spMkLst>
            <pc:docMk/>
            <pc:sldMk cId="2414223819" sldId="364"/>
            <ac:spMk id="19" creationId="{6016219D-510E-4184-9090-6D5578A87BD1}"/>
          </ac:spMkLst>
        </pc:spChg>
        <pc:picChg chg="add">
          <ac:chgData name="Belaid, Sirine" userId="S::belaids@upmc.edu::5dcb4cf5-c058-49ea-93f8-4f4e6c877fcd" providerId="AD" clId="Web-{B44185C5-CF89-25BE-0A53-CCCDB41D0EEF}" dt="2024-12-13T03:13:11.347" v="166"/>
          <ac:picMkLst>
            <pc:docMk/>
            <pc:sldMk cId="2414223819" sldId="364"/>
            <ac:picMk id="5" creationId="{0EA3ECBB-1D1A-2168-2F0E-08CC8CFE6931}"/>
          </ac:picMkLst>
        </pc:picChg>
      </pc:sldChg>
      <pc:sldChg chg="addSp modSp mod setBg">
        <pc:chgData name="Belaid, Sirine" userId="S::belaids@upmc.edu::5dcb4cf5-c058-49ea-93f8-4f4e6c877fcd" providerId="AD" clId="Web-{B44185C5-CF89-25BE-0A53-CCCDB41D0EEF}" dt="2024-12-13T03:13:04.691" v="165" actId="1076"/>
        <pc:sldMkLst>
          <pc:docMk/>
          <pc:sldMk cId="795419220" sldId="365"/>
        </pc:sldMkLst>
        <pc:spChg chg="mod">
          <ac:chgData name="Belaid, Sirine" userId="S::belaids@upmc.edu::5dcb4cf5-c058-49ea-93f8-4f4e6c877fcd" providerId="AD" clId="Web-{B44185C5-CF89-25BE-0A53-CCCDB41D0EEF}" dt="2024-12-13T03:07:20.024" v="90"/>
          <ac:spMkLst>
            <pc:docMk/>
            <pc:sldMk cId="795419220" sldId="365"/>
            <ac:spMk id="2" creationId="{1E63AA7C-D8CC-24E2-1927-C63C14BF6FAB}"/>
          </ac:spMkLst>
        </pc:spChg>
        <pc:spChg chg="mod">
          <ac:chgData name="Belaid, Sirine" userId="S::belaids@upmc.edu::5dcb4cf5-c058-49ea-93f8-4f4e6c877fcd" providerId="AD" clId="Web-{B44185C5-CF89-25BE-0A53-CCCDB41D0EEF}" dt="2024-12-13T03:07:38.525" v="94" actId="1076"/>
          <ac:spMkLst>
            <pc:docMk/>
            <pc:sldMk cId="795419220" sldId="365"/>
            <ac:spMk id="3" creationId="{6B57145F-A3D4-5C8F-5BBE-CC4E7BC1E90B}"/>
          </ac:spMkLst>
        </pc:spChg>
        <pc:spChg chg="add">
          <ac:chgData name="Belaid, Sirine" userId="S::belaids@upmc.edu::5dcb4cf5-c058-49ea-93f8-4f4e6c877fcd" providerId="AD" clId="Web-{B44185C5-CF89-25BE-0A53-CCCDB41D0EEF}" dt="2024-12-13T03:07:20.024" v="90"/>
          <ac:spMkLst>
            <pc:docMk/>
            <pc:sldMk cId="795419220" sldId="365"/>
            <ac:spMk id="8" creationId="{6F5A5072-7B47-4D32-B52A-4EBBF590B8A5}"/>
          </ac:spMkLst>
        </pc:spChg>
        <pc:spChg chg="add">
          <ac:chgData name="Belaid, Sirine" userId="S::belaids@upmc.edu::5dcb4cf5-c058-49ea-93f8-4f4e6c877fcd" providerId="AD" clId="Web-{B44185C5-CF89-25BE-0A53-CCCDB41D0EEF}" dt="2024-12-13T03:07:20.024" v="90"/>
          <ac:spMkLst>
            <pc:docMk/>
            <pc:sldMk cId="795419220" sldId="365"/>
            <ac:spMk id="10" creationId="{9715DAF0-AE1B-46C9-8A6B-DB2AA05AB91D}"/>
          </ac:spMkLst>
        </pc:spChg>
        <pc:spChg chg="add">
          <ac:chgData name="Belaid, Sirine" userId="S::belaids@upmc.edu::5dcb4cf5-c058-49ea-93f8-4f4e6c877fcd" providerId="AD" clId="Web-{B44185C5-CF89-25BE-0A53-CCCDB41D0EEF}" dt="2024-12-13T03:07:20.024" v="90"/>
          <ac:spMkLst>
            <pc:docMk/>
            <pc:sldMk cId="795419220" sldId="365"/>
            <ac:spMk id="12" creationId="{6016219D-510E-4184-9090-6D5578A87BD1}"/>
          </ac:spMkLst>
        </pc:spChg>
        <pc:spChg chg="add">
          <ac:chgData name="Belaid, Sirine" userId="S::belaids@upmc.edu::5dcb4cf5-c058-49ea-93f8-4f4e6c877fcd" providerId="AD" clId="Web-{B44185C5-CF89-25BE-0A53-CCCDB41D0EEF}" dt="2024-12-13T03:07:20.024" v="90"/>
          <ac:spMkLst>
            <pc:docMk/>
            <pc:sldMk cId="795419220" sldId="365"/>
            <ac:spMk id="14" creationId="{AFF4A713-7B75-4B21-90D7-5AB19547C728}"/>
          </ac:spMkLst>
        </pc:spChg>
        <pc:spChg chg="add">
          <ac:chgData name="Belaid, Sirine" userId="S::belaids@upmc.edu::5dcb4cf5-c058-49ea-93f8-4f4e6c877fcd" providerId="AD" clId="Web-{B44185C5-CF89-25BE-0A53-CCCDB41D0EEF}" dt="2024-12-13T03:07:20.024" v="90"/>
          <ac:spMkLst>
            <pc:docMk/>
            <pc:sldMk cId="795419220" sldId="365"/>
            <ac:spMk id="16" creationId="{DC631C0B-6DA6-4E57-8231-CE32B3434A7E}"/>
          </ac:spMkLst>
        </pc:spChg>
        <pc:spChg chg="add">
          <ac:chgData name="Belaid, Sirine" userId="S::belaids@upmc.edu::5dcb4cf5-c058-49ea-93f8-4f4e6c877fcd" providerId="AD" clId="Web-{B44185C5-CF89-25BE-0A53-CCCDB41D0EEF}" dt="2024-12-13T03:07:20.024" v="90"/>
          <ac:spMkLst>
            <pc:docMk/>
            <pc:sldMk cId="795419220" sldId="365"/>
            <ac:spMk id="18" creationId="{C29501E6-A978-4A61-9689-9085AF97A53A}"/>
          </ac:spMkLst>
        </pc:spChg>
        <pc:picChg chg="add mod">
          <ac:chgData name="Belaid, Sirine" userId="S::belaids@upmc.edu::5dcb4cf5-c058-49ea-93f8-4f4e6c877fcd" providerId="AD" clId="Web-{B44185C5-CF89-25BE-0A53-CCCDB41D0EEF}" dt="2024-12-13T03:13:04.691" v="165" actId="1076"/>
          <ac:picMkLst>
            <pc:docMk/>
            <pc:sldMk cId="795419220" sldId="365"/>
            <ac:picMk id="5" creationId="{51DD76F1-66F5-5DCA-BCEE-7A1D4582E690}"/>
          </ac:picMkLst>
        </pc:picChg>
      </pc:sldChg>
      <pc:sldChg chg="addAnim">
        <pc:chgData name="Belaid, Sirine" userId="S::belaids@upmc.edu::5dcb4cf5-c058-49ea-93f8-4f4e6c877fcd" providerId="AD" clId="Web-{B44185C5-CF89-25BE-0A53-CCCDB41D0EEF}" dt="2024-12-13T02:58:01.054" v="39"/>
        <pc:sldMkLst>
          <pc:docMk/>
          <pc:sldMk cId="2208660293" sldId="366"/>
        </pc:sldMkLst>
      </pc:sldChg>
      <pc:sldChg chg="addAnim delAnim modAnim">
        <pc:chgData name="Belaid, Sirine" userId="S::belaids@upmc.edu::5dcb4cf5-c058-49ea-93f8-4f4e6c877fcd" providerId="AD" clId="Web-{B44185C5-CF89-25BE-0A53-CCCDB41D0EEF}" dt="2024-12-13T02:55:35.206" v="29"/>
        <pc:sldMkLst>
          <pc:docMk/>
          <pc:sldMk cId="3004633114" sldId="367"/>
        </pc:sldMkLst>
      </pc:sldChg>
      <pc:sldChg chg="delSp modSp">
        <pc:chgData name="Belaid, Sirine" userId="S::belaids@upmc.edu::5dcb4cf5-c058-49ea-93f8-4f4e6c877fcd" providerId="AD" clId="Web-{B44185C5-CF89-25BE-0A53-CCCDB41D0EEF}" dt="2024-12-13T03:31:35.235" v="194" actId="1076"/>
        <pc:sldMkLst>
          <pc:docMk/>
          <pc:sldMk cId="1204613590" sldId="368"/>
        </pc:sldMkLst>
        <pc:spChg chg="mod">
          <ac:chgData name="Belaid, Sirine" userId="S::belaids@upmc.edu::5dcb4cf5-c058-49ea-93f8-4f4e6c877fcd" providerId="AD" clId="Web-{B44185C5-CF89-25BE-0A53-CCCDB41D0EEF}" dt="2024-12-13T03:31:35.235" v="194" actId="1076"/>
          <ac:spMkLst>
            <pc:docMk/>
            <pc:sldMk cId="1204613590" sldId="368"/>
            <ac:spMk id="2" creationId="{F6B1AE23-4599-CB1C-CDE6-F87BBDEA55D1}"/>
          </ac:spMkLst>
        </pc:spChg>
        <pc:graphicFrameChg chg="mod">
          <ac:chgData name="Belaid, Sirine" userId="S::belaids@upmc.edu::5dcb4cf5-c058-49ea-93f8-4f4e6c877fcd" providerId="AD" clId="Web-{B44185C5-CF89-25BE-0A53-CCCDB41D0EEF}" dt="2024-12-13T03:31:32.672" v="193" actId="1076"/>
          <ac:graphicFrameMkLst>
            <pc:docMk/>
            <pc:sldMk cId="1204613590" sldId="368"/>
            <ac:graphicFrameMk id="5" creationId="{23AF7966-5238-A790-88D7-3E2B2D408459}"/>
          </ac:graphicFrameMkLst>
        </pc:graphicFrameChg>
        <pc:picChg chg="del">
          <ac:chgData name="Belaid, Sirine" userId="S::belaids@upmc.edu::5dcb4cf5-c058-49ea-93f8-4f4e6c877fcd" providerId="AD" clId="Web-{B44185C5-CF89-25BE-0A53-CCCDB41D0EEF}" dt="2024-12-13T03:31:26.328" v="190"/>
          <ac:picMkLst>
            <pc:docMk/>
            <pc:sldMk cId="1204613590" sldId="368"/>
            <ac:picMk id="33" creationId="{700D547C-7836-8933-D13F-34F8334EF821}"/>
          </ac:picMkLst>
        </pc:picChg>
        <pc:picChg chg="del">
          <ac:chgData name="Belaid, Sirine" userId="S::belaids@upmc.edu::5dcb4cf5-c058-49ea-93f8-4f4e6c877fcd" providerId="AD" clId="Web-{B44185C5-CF89-25BE-0A53-CCCDB41D0EEF}" dt="2024-12-13T03:31:27.313" v="191"/>
          <ac:picMkLst>
            <pc:docMk/>
            <pc:sldMk cId="1204613590" sldId="368"/>
            <ac:picMk id="49" creationId="{578B8691-7512-1E34-84EA-DA518854C44C}"/>
          </ac:picMkLst>
        </pc:picChg>
        <pc:picChg chg="del">
          <ac:chgData name="Belaid, Sirine" userId="S::belaids@upmc.edu::5dcb4cf5-c058-49ea-93f8-4f4e6c877fcd" providerId="AD" clId="Web-{B44185C5-CF89-25BE-0A53-CCCDB41D0EEF}" dt="2024-12-13T03:31:28.828" v="192"/>
          <ac:picMkLst>
            <pc:docMk/>
            <pc:sldMk cId="1204613590" sldId="368"/>
            <ac:picMk id="51" creationId="{4CD103BC-B576-76EB-69C0-888FFED54ED1}"/>
          </ac:picMkLst>
        </pc:picChg>
      </pc:sldChg>
      <pc:sldChg chg="addAnim">
        <pc:chgData name="Belaid, Sirine" userId="S::belaids@upmc.edu::5dcb4cf5-c058-49ea-93f8-4f4e6c877fcd" providerId="AD" clId="Web-{B44185C5-CF89-25BE-0A53-CCCDB41D0EEF}" dt="2024-12-13T02:56:14.895" v="32"/>
        <pc:sldMkLst>
          <pc:docMk/>
          <pc:sldMk cId="13225285" sldId="370"/>
        </pc:sldMkLst>
      </pc:sldChg>
      <pc:sldChg chg="addAnim delAnim">
        <pc:chgData name="Belaid, Sirine" userId="S::belaids@upmc.edu::5dcb4cf5-c058-49ea-93f8-4f4e6c877fcd" providerId="AD" clId="Web-{B44185C5-CF89-25BE-0A53-CCCDB41D0EEF}" dt="2024-12-13T03:00:29.856" v="56"/>
        <pc:sldMkLst>
          <pc:docMk/>
          <pc:sldMk cId="1471262162" sldId="377"/>
        </pc:sldMkLst>
      </pc:sldChg>
      <pc:sldChg chg="addAnim">
        <pc:chgData name="Belaid, Sirine" userId="S::belaids@upmc.edu::5dcb4cf5-c058-49ea-93f8-4f4e6c877fcd" providerId="AD" clId="Web-{B44185C5-CF89-25BE-0A53-CCCDB41D0EEF}" dt="2024-12-13T02:59:07.712" v="46"/>
        <pc:sldMkLst>
          <pc:docMk/>
          <pc:sldMk cId="3222833950" sldId="378"/>
        </pc:sldMkLst>
      </pc:sldChg>
      <pc:sldChg chg="addSp modSp mod setBg">
        <pc:chgData name="Belaid, Sirine" userId="S::belaids@upmc.edu::5dcb4cf5-c058-49ea-93f8-4f4e6c877fcd" providerId="AD" clId="Web-{B44185C5-CF89-25BE-0A53-CCCDB41D0EEF}" dt="2024-12-13T03:11:45.782" v="159" actId="20577"/>
        <pc:sldMkLst>
          <pc:docMk/>
          <pc:sldMk cId="3434993078" sldId="379"/>
        </pc:sldMkLst>
        <pc:spChg chg="mod">
          <ac:chgData name="Belaid, Sirine" userId="S::belaids@upmc.edu::5dcb4cf5-c058-49ea-93f8-4f4e6c877fcd" providerId="AD" clId="Web-{B44185C5-CF89-25BE-0A53-CCCDB41D0EEF}" dt="2024-12-13T03:11:45.782" v="159" actId="20577"/>
          <ac:spMkLst>
            <pc:docMk/>
            <pc:sldMk cId="3434993078" sldId="379"/>
            <ac:spMk id="2" creationId="{16195E82-86AE-AB44-06FF-1A93F02750DC}"/>
          </ac:spMkLst>
        </pc:spChg>
        <pc:spChg chg="mod">
          <ac:chgData name="Belaid, Sirine" userId="S::belaids@upmc.edu::5dcb4cf5-c058-49ea-93f8-4f4e6c877fcd" providerId="AD" clId="Web-{B44185C5-CF89-25BE-0A53-CCCDB41D0EEF}" dt="2024-12-13T03:11:28.516" v="157"/>
          <ac:spMkLst>
            <pc:docMk/>
            <pc:sldMk cId="3434993078" sldId="379"/>
            <ac:spMk id="3" creationId="{0DD947CF-FC6B-318D-FE2A-A5727C629A3D}"/>
          </ac:spMkLst>
        </pc:spChg>
        <pc:spChg chg="add">
          <ac:chgData name="Belaid, Sirine" userId="S::belaids@upmc.edu::5dcb4cf5-c058-49ea-93f8-4f4e6c877fcd" providerId="AD" clId="Web-{B44185C5-CF89-25BE-0A53-CCCDB41D0EEF}" dt="2024-12-13T03:11:28.516" v="157"/>
          <ac:spMkLst>
            <pc:docMk/>
            <pc:sldMk cId="3434993078" sldId="379"/>
            <ac:spMk id="8" creationId="{43C48B49-6135-48B6-AC0F-97E5D8D1F03F}"/>
          </ac:spMkLst>
        </pc:spChg>
        <pc:spChg chg="add">
          <ac:chgData name="Belaid, Sirine" userId="S::belaids@upmc.edu::5dcb4cf5-c058-49ea-93f8-4f4e6c877fcd" providerId="AD" clId="Web-{B44185C5-CF89-25BE-0A53-CCCDB41D0EEF}" dt="2024-12-13T03:11:28.516" v="157"/>
          <ac:spMkLst>
            <pc:docMk/>
            <pc:sldMk cId="3434993078" sldId="379"/>
            <ac:spMk id="10" creationId="{9715DAF0-AE1B-46C9-8A6B-DB2AA05AB91D}"/>
          </ac:spMkLst>
        </pc:spChg>
        <pc:spChg chg="add">
          <ac:chgData name="Belaid, Sirine" userId="S::belaids@upmc.edu::5dcb4cf5-c058-49ea-93f8-4f4e6c877fcd" providerId="AD" clId="Web-{B44185C5-CF89-25BE-0A53-CCCDB41D0EEF}" dt="2024-12-13T03:11:28.516" v="157"/>
          <ac:spMkLst>
            <pc:docMk/>
            <pc:sldMk cId="3434993078" sldId="379"/>
            <ac:spMk id="12" creationId="{DC631C0B-6DA6-4E57-8231-CE32B3434A7E}"/>
          </ac:spMkLst>
        </pc:spChg>
        <pc:spChg chg="add">
          <ac:chgData name="Belaid, Sirine" userId="S::belaids@upmc.edu::5dcb4cf5-c058-49ea-93f8-4f4e6c877fcd" providerId="AD" clId="Web-{B44185C5-CF89-25BE-0A53-CCCDB41D0EEF}" dt="2024-12-13T03:11:28.516" v="157"/>
          <ac:spMkLst>
            <pc:docMk/>
            <pc:sldMk cId="3434993078" sldId="379"/>
            <ac:spMk id="14" creationId="{F256AC18-FB41-4977-8B0C-F5082335AB7D}"/>
          </ac:spMkLst>
        </pc:spChg>
        <pc:spChg chg="add">
          <ac:chgData name="Belaid, Sirine" userId="S::belaids@upmc.edu::5dcb4cf5-c058-49ea-93f8-4f4e6c877fcd" providerId="AD" clId="Web-{B44185C5-CF89-25BE-0A53-CCCDB41D0EEF}" dt="2024-12-13T03:11:28.516" v="157"/>
          <ac:spMkLst>
            <pc:docMk/>
            <pc:sldMk cId="3434993078" sldId="379"/>
            <ac:spMk id="16" creationId="{AFF4A713-7B75-4B21-90D7-5AB19547C728}"/>
          </ac:spMkLst>
        </pc:spChg>
      </pc:sldChg>
      <pc:sldChg chg="addAnim">
        <pc:chgData name="Belaid, Sirine" userId="S::belaids@upmc.edu::5dcb4cf5-c058-49ea-93f8-4f4e6c877fcd" providerId="AD" clId="Web-{B44185C5-CF89-25BE-0A53-CCCDB41D0EEF}" dt="2024-12-13T02:58:25.399" v="41"/>
        <pc:sldMkLst>
          <pc:docMk/>
          <pc:sldMk cId="3575352840" sldId="380"/>
        </pc:sldMkLst>
      </pc:sldChg>
      <pc:sldChg chg="addAnim">
        <pc:chgData name="Belaid, Sirine" userId="S::belaids@upmc.edu::5dcb4cf5-c058-49ea-93f8-4f4e6c877fcd" providerId="AD" clId="Web-{B44185C5-CF89-25BE-0A53-CCCDB41D0EEF}" dt="2024-12-13T02:59:27.604" v="49"/>
        <pc:sldMkLst>
          <pc:docMk/>
          <pc:sldMk cId="3179549796" sldId="381"/>
        </pc:sldMkLst>
      </pc:sldChg>
      <pc:sldChg chg="addAnim">
        <pc:chgData name="Belaid, Sirine" userId="S::belaids@upmc.edu::5dcb4cf5-c058-49ea-93f8-4f4e6c877fcd" providerId="AD" clId="Web-{B44185C5-CF89-25BE-0A53-CCCDB41D0EEF}" dt="2024-12-13T02:58:56.978" v="44"/>
        <pc:sldMkLst>
          <pc:docMk/>
          <pc:sldMk cId="1990103092" sldId="383"/>
        </pc:sldMkLst>
      </pc:sldChg>
      <pc:sldChg chg="addAnim">
        <pc:chgData name="Belaid, Sirine" userId="S::belaids@upmc.edu::5dcb4cf5-c058-49ea-93f8-4f4e6c877fcd" providerId="AD" clId="Web-{B44185C5-CF89-25BE-0A53-CCCDB41D0EEF}" dt="2024-12-13T03:00:48.841" v="59"/>
        <pc:sldMkLst>
          <pc:docMk/>
          <pc:sldMk cId="249774899" sldId="385"/>
        </pc:sldMkLst>
      </pc:sldChg>
      <pc:sldChg chg="addSp modSp mod setBg">
        <pc:chgData name="Belaid, Sirine" userId="S::belaids@upmc.edu::5dcb4cf5-c058-49ea-93f8-4f4e6c877fcd" providerId="AD" clId="Web-{B44185C5-CF89-25BE-0A53-CCCDB41D0EEF}" dt="2024-12-13T03:12:29.237" v="162" actId="1076"/>
        <pc:sldMkLst>
          <pc:docMk/>
          <pc:sldMk cId="3743057861" sldId="386"/>
        </pc:sldMkLst>
        <pc:spChg chg="mod">
          <ac:chgData name="Belaid, Sirine" userId="S::belaids@upmc.edu::5dcb4cf5-c058-49ea-93f8-4f4e6c877fcd" providerId="AD" clId="Web-{B44185C5-CF89-25BE-0A53-CCCDB41D0EEF}" dt="2024-12-13T03:09:47.904" v="139"/>
          <ac:spMkLst>
            <pc:docMk/>
            <pc:sldMk cId="3743057861" sldId="386"/>
            <ac:spMk id="2" creationId="{1E63AA7C-D8CC-24E2-1927-C63C14BF6FAB}"/>
          </ac:spMkLst>
        </pc:spChg>
        <pc:spChg chg="mod">
          <ac:chgData name="Belaid, Sirine" userId="S::belaids@upmc.edu::5dcb4cf5-c058-49ea-93f8-4f4e6c877fcd" providerId="AD" clId="Web-{B44185C5-CF89-25BE-0A53-CCCDB41D0EEF}" dt="2024-12-13T03:11:04.343" v="156" actId="1076"/>
          <ac:spMkLst>
            <pc:docMk/>
            <pc:sldMk cId="3743057861" sldId="386"/>
            <ac:spMk id="3" creationId="{6B57145F-A3D4-5C8F-5BBE-CC4E7BC1E90B}"/>
          </ac:spMkLst>
        </pc:spChg>
        <pc:spChg chg="add">
          <ac:chgData name="Belaid, Sirine" userId="S::belaids@upmc.edu::5dcb4cf5-c058-49ea-93f8-4f4e6c877fcd" providerId="AD" clId="Web-{B44185C5-CF89-25BE-0A53-CCCDB41D0EEF}" dt="2024-12-13T03:09:47.904" v="139"/>
          <ac:spMkLst>
            <pc:docMk/>
            <pc:sldMk cId="3743057861" sldId="386"/>
            <ac:spMk id="8" creationId="{6F5A5072-7B47-4D32-B52A-4EBBF590B8A5}"/>
          </ac:spMkLst>
        </pc:spChg>
        <pc:spChg chg="add">
          <ac:chgData name="Belaid, Sirine" userId="S::belaids@upmc.edu::5dcb4cf5-c058-49ea-93f8-4f4e6c877fcd" providerId="AD" clId="Web-{B44185C5-CF89-25BE-0A53-CCCDB41D0EEF}" dt="2024-12-13T03:09:47.904" v="139"/>
          <ac:spMkLst>
            <pc:docMk/>
            <pc:sldMk cId="3743057861" sldId="386"/>
            <ac:spMk id="10" creationId="{9715DAF0-AE1B-46C9-8A6B-DB2AA05AB91D}"/>
          </ac:spMkLst>
        </pc:spChg>
        <pc:spChg chg="add">
          <ac:chgData name="Belaid, Sirine" userId="S::belaids@upmc.edu::5dcb4cf5-c058-49ea-93f8-4f4e6c877fcd" providerId="AD" clId="Web-{B44185C5-CF89-25BE-0A53-CCCDB41D0EEF}" dt="2024-12-13T03:09:47.904" v="139"/>
          <ac:spMkLst>
            <pc:docMk/>
            <pc:sldMk cId="3743057861" sldId="386"/>
            <ac:spMk id="12" creationId="{6016219D-510E-4184-9090-6D5578A87BD1}"/>
          </ac:spMkLst>
        </pc:spChg>
        <pc:spChg chg="add">
          <ac:chgData name="Belaid, Sirine" userId="S::belaids@upmc.edu::5dcb4cf5-c058-49ea-93f8-4f4e6c877fcd" providerId="AD" clId="Web-{B44185C5-CF89-25BE-0A53-CCCDB41D0EEF}" dt="2024-12-13T03:09:47.904" v="139"/>
          <ac:spMkLst>
            <pc:docMk/>
            <pc:sldMk cId="3743057861" sldId="386"/>
            <ac:spMk id="14" creationId="{AFF4A713-7B75-4B21-90D7-5AB19547C728}"/>
          </ac:spMkLst>
        </pc:spChg>
        <pc:spChg chg="add">
          <ac:chgData name="Belaid, Sirine" userId="S::belaids@upmc.edu::5dcb4cf5-c058-49ea-93f8-4f4e6c877fcd" providerId="AD" clId="Web-{B44185C5-CF89-25BE-0A53-CCCDB41D0EEF}" dt="2024-12-13T03:09:47.904" v="139"/>
          <ac:spMkLst>
            <pc:docMk/>
            <pc:sldMk cId="3743057861" sldId="386"/>
            <ac:spMk id="16" creationId="{DC631C0B-6DA6-4E57-8231-CE32B3434A7E}"/>
          </ac:spMkLst>
        </pc:spChg>
        <pc:spChg chg="add">
          <ac:chgData name="Belaid, Sirine" userId="S::belaids@upmc.edu::5dcb4cf5-c058-49ea-93f8-4f4e6c877fcd" providerId="AD" clId="Web-{B44185C5-CF89-25BE-0A53-CCCDB41D0EEF}" dt="2024-12-13T03:09:47.904" v="139"/>
          <ac:spMkLst>
            <pc:docMk/>
            <pc:sldMk cId="3743057861" sldId="386"/>
            <ac:spMk id="18" creationId="{C29501E6-A978-4A61-9689-9085AF97A53A}"/>
          </ac:spMkLst>
        </pc:spChg>
        <pc:picChg chg="add mod">
          <ac:chgData name="Belaid, Sirine" userId="S::belaids@upmc.edu::5dcb4cf5-c058-49ea-93f8-4f4e6c877fcd" providerId="AD" clId="Web-{B44185C5-CF89-25BE-0A53-CCCDB41D0EEF}" dt="2024-12-13T03:12:29.237" v="162" actId="1076"/>
          <ac:picMkLst>
            <pc:docMk/>
            <pc:sldMk cId="3743057861" sldId="386"/>
            <ac:picMk id="5" creationId="{C6A0E3C3-4F67-7F93-23BB-9A998A6D38CC}"/>
          </ac:picMkLst>
        </pc:picChg>
      </pc:sldChg>
      <pc:sldChg chg="addAnim">
        <pc:chgData name="Belaid, Sirine" userId="S::belaids@upmc.edu::5dcb4cf5-c058-49ea-93f8-4f4e6c877fcd" providerId="AD" clId="Web-{B44185C5-CF89-25BE-0A53-CCCDB41D0EEF}" dt="2024-12-13T03:01:18.216" v="63"/>
        <pc:sldMkLst>
          <pc:docMk/>
          <pc:sldMk cId="2301887968" sldId="387"/>
        </pc:sldMkLst>
      </pc:sldChg>
      <pc:sldChg chg="addAnim">
        <pc:chgData name="Belaid, Sirine" userId="S::belaids@upmc.edu::5dcb4cf5-c058-49ea-93f8-4f4e6c877fcd" providerId="AD" clId="Web-{B44185C5-CF89-25BE-0A53-CCCDB41D0EEF}" dt="2024-12-13T03:01:33.389" v="65"/>
        <pc:sldMkLst>
          <pc:docMk/>
          <pc:sldMk cId="3342538804" sldId="388"/>
        </pc:sldMkLst>
      </pc:sldChg>
      <pc:sldChg chg="addAnim">
        <pc:chgData name="Belaid, Sirine" userId="S::belaids@upmc.edu::5dcb4cf5-c058-49ea-93f8-4f4e6c877fcd" providerId="AD" clId="Web-{B44185C5-CF89-25BE-0A53-CCCDB41D0EEF}" dt="2024-12-13T03:02:13.671" v="69"/>
        <pc:sldMkLst>
          <pc:docMk/>
          <pc:sldMk cId="200882343" sldId="389"/>
        </pc:sldMkLst>
      </pc:sldChg>
      <pc:sldChg chg="modSp addAnim">
        <pc:chgData name="Belaid, Sirine" userId="S::belaids@upmc.edu::5dcb4cf5-c058-49ea-93f8-4f4e6c877fcd" providerId="AD" clId="Web-{B44185C5-CF89-25BE-0A53-CCCDB41D0EEF}" dt="2024-12-13T03:17:26.594" v="186" actId="1076"/>
        <pc:sldMkLst>
          <pc:docMk/>
          <pc:sldMk cId="412412650" sldId="391"/>
        </pc:sldMkLst>
        <pc:spChg chg="mod">
          <ac:chgData name="Belaid, Sirine" userId="S::belaids@upmc.edu::5dcb4cf5-c058-49ea-93f8-4f4e6c877fcd" providerId="AD" clId="Web-{B44185C5-CF89-25BE-0A53-CCCDB41D0EEF}" dt="2024-12-13T03:16:12.900" v="184" actId="20577"/>
          <ac:spMkLst>
            <pc:docMk/>
            <pc:sldMk cId="412412650" sldId="391"/>
            <ac:spMk id="3" creationId="{58D555CA-A0A4-BD5A-C7A5-51D39BF63446}"/>
          </ac:spMkLst>
        </pc:spChg>
        <pc:spChg chg="mod">
          <ac:chgData name="Belaid, Sirine" userId="S::belaids@upmc.edu::5dcb4cf5-c058-49ea-93f8-4f4e6c877fcd" providerId="AD" clId="Web-{B44185C5-CF89-25BE-0A53-CCCDB41D0EEF}" dt="2024-12-13T03:17:22.765" v="185" actId="1076"/>
          <ac:spMkLst>
            <pc:docMk/>
            <pc:sldMk cId="412412650" sldId="391"/>
            <ac:spMk id="4" creationId="{0C4DFA9F-D5D8-418D-6708-4B57D7393503}"/>
          </ac:spMkLst>
        </pc:spChg>
        <pc:spChg chg="mod">
          <ac:chgData name="Belaid, Sirine" userId="S::belaids@upmc.edu::5dcb4cf5-c058-49ea-93f8-4f4e6c877fcd" providerId="AD" clId="Web-{B44185C5-CF89-25BE-0A53-CCCDB41D0EEF}" dt="2024-12-13T03:17:26.594" v="186" actId="1076"/>
          <ac:spMkLst>
            <pc:docMk/>
            <pc:sldMk cId="412412650" sldId="391"/>
            <ac:spMk id="5" creationId="{D812EF7D-4702-057B-A538-96ABF815087F}"/>
          </ac:spMkLst>
        </pc:spChg>
      </pc:sldChg>
      <pc:sldChg chg="ord">
        <pc:chgData name="Belaid, Sirine" userId="S::belaids@upmc.edu::5dcb4cf5-c058-49ea-93f8-4f4e6c877fcd" providerId="AD" clId="Web-{B44185C5-CF89-25BE-0A53-CCCDB41D0EEF}" dt="2024-12-13T03:02:19.843" v="70"/>
        <pc:sldMkLst>
          <pc:docMk/>
          <pc:sldMk cId="1731714019" sldId="393"/>
        </pc:sldMkLst>
      </pc:sldChg>
      <pc:sldChg chg="addSp modSp mod setBg">
        <pc:chgData name="Belaid, Sirine" userId="S::belaids@upmc.edu::5dcb4cf5-c058-49ea-93f8-4f4e6c877fcd" providerId="AD" clId="Web-{B44185C5-CF89-25BE-0A53-CCCDB41D0EEF}" dt="2024-12-13T03:12:48.612" v="163"/>
        <pc:sldMkLst>
          <pc:docMk/>
          <pc:sldMk cId="1117081788" sldId="399"/>
        </pc:sldMkLst>
        <pc:spChg chg="mod">
          <ac:chgData name="Belaid, Sirine" userId="S::belaids@upmc.edu::5dcb4cf5-c058-49ea-93f8-4f4e6c877fcd" providerId="AD" clId="Web-{B44185C5-CF89-25BE-0A53-CCCDB41D0EEF}" dt="2024-12-13T03:08:00.432" v="96"/>
          <ac:spMkLst>
            <pc:docMk/>
            <pc:sldMk cId="1117081788" sldId="399"/>
            <ac:spMk id="2" creationId="{1E63AA7C-D8CC-24E2-1927-C63C14BF6FAB}"/>
          </ac:spMkLst>
        </pc:spChg>
        <pc:spChg chg="mod">
          <ac:chgData name="Belaid, Sirine" userId="S::belaids@upmc.edu::5dcb4cf5-c058-49ea-93f8-4f4e6c877fcd" providerId="AD" clId="Web-{B44185C5-CF89-25BE-0A53-CCCDB41D0EEF}" dt="2024-12-13T03:09:25.981" v="137" actId="20577"/>
          <ac:spMkLst>
            <pc:docMk/>
            <pc:sldMk cId="1117081788" sldId="399"/>
            <ac:spMk id="3" creationId="{6B57145F-A3D4-5C8F-5BBE-CC4E7BC1E90B}"/>
          </ac:spMkLst>
        </pc:spChg>
        <pc:spChg chg="add">
          <ac:chgData name="Belaid, Sirine" userId="S::belaids@upmc.edu::5dcb4cf5-c058-49ea-93f8-4f4e6c877fcd" providerId="AD" clId="Web-{B44185C5-CF89-25BE-0A53-CCCDB41D0EEF}" dt="2024-12-13T03:08:00.432" v="96"/>
          <ac:spMkLst>
            <pc:docMk/>
            <pc:sldMk cId="1117081788" sldId="399"/>
            <ac:spMk id="8" creationId="{6F5A5072-7B47-4D32-B52A-4EBBF590B8A5}"/>
          </ac:spMkLst>
        </pc:spChg>
        <pc:spChg chg="add">
          <ac:chgData name="Belaid, Sirine" userId="S::belaids@upmc.edu::5dcb4cf5-c058-49ea-93f8-4f4e6c877fcd" providerId="AD" clId="Web-{B44185C5-CF89-25BE-0A53-CCCDB41D0EEF}" dt="2024-12-13T03:08:00.432" v="96"/>
          <ac:spMkLst>
            <pc:docMk/>
            <pc:sldMk cId="1117081788" sldId="399"/>
            <ac:spMk id="10" creationId="{9715DAF0-AE1B-46C9-8A6B-DB2AA05AB91D}"/>
          </ac:spMkLst>
        </pc:spChg>
        <pc:spChg chg="add">
          <ac:chgData name="Belaid, Sirine" userId="S::belaids@upmc.edu::5dcb4cf5-c058-49ea-93f8-4f4e6c877fcd" providerId="AD" clId="Web-{B44185C5-CF89-25BE-0A53-CCCDB41D0EEF}" dt="2024-12-13T03:08:00.432" v="96"/>
          <ac:spMkLst>
            <pc:docMk/>
            <pc:sldMk cId="1117081788" sldId="399"/>
            <ac:spMk id="12" creationId="{6016219D-510E-4184-9090-6D5578A87BD1}"/>
          </ac:spMkLst>
        </pc:spChg>
        <pc:spChg chg="add">
          <ac:chgData name="Belaid, Sirine" userId="S::belaids@upmc.edu::5dcb4cf5-c058-49ea-93f8-4f4e6c877fcd" providerId="AD" clId="Web-{B44185C5-CF89-25BE-0A53-CCCDB41D0EEF}" dt="2024-12-13T03:08:00.432" v="96"/>
          <ac:spMkLst>
            <pc:docMk/>
            <pc:sldMk cId="1117081788" sldId="399"/>
            <ac:spMk id="14" creationId="{AFF4A713-7B75-4B21-90D7-5AB19547C728}"/>
          </ac:spMkLst>
        </pc:spChg>
        <pc:spChg chg="add">
          <ac:chgData name="Belaid, Sirine" userId="S::belaids@upmc.edu::5dcb4cf5-c058-49ea-93f8-4f4e6c877fcd" providerId="AD" clId="Web-{B44185C5-CF89-25BE-0A53-CCCDB41D0EEF}" dt="2024-12-13T03:08:00.432" v="96"/>
          <ac:spMkLst>
            <pc:docMk/>
            <pc:sldMk cId="1117081788" sldId="399"/>
            <ac:spMk id="16" creationId="{DC631C0B-6DA6-4E57-8231-CE32B3434A7E}"/>
          </ac:spMkLst>
        </pc:spChg>
        <pc:spChg chg="add">
          <ac:chgData name="Belaid, Sirine" userId="S::belaids@upmc.edu::5dcb4cf5-c058-49ea-93f8-4f4e6c877fcd" providerId="AD" clId="Web-{B44185C5-CF89-25BE-0A53-CCCDB41D0EEF}" dt="2024-12-13T03:08:00.432" v="96"/>
          <ac:spMkLst>
            <pc:docMk/>
            <pc:sldMk cId="1117081788" sldId="399"/>
            <ac:spMk id="18" creationId="{C29501E6-A978-4A61-9689-9085AF97A53A}"/>
          </ac:spMkLst>
        </pc:spChg>
        <pc:picChg chg="add">
          <ac:chgData name="Belaid, Sirine" userId="S::belaids@upmc.edu::5dcb4cf5-c058-49ea-93f8-4f4e6c877fcd" providerId="AD" clId="Web-{B44185C5-CF89-25BE-0A53-CCCDB41D0EEF}" dt="2024-12-13T03:12:48.612" v="163"/>
          <ac:picMkLst>
            <pc:docMk/>
            <pc:sldMk cId="1117081788" sldId="399"/>
            <ac:picMk id="5" creationId="{537B9878-82EB-0CE3-B554-0F090511E355}"/>
          </ac:picMkLst>
        </pc:picChg>
      </pc:sldChg>
      <pc:sldChg chg="addSp modSp mod setBg">
        <pc:chgData name="Belaid, Sirine" userId="S::belaids@upmc.edu::5dcb4cf5-c058-49ea-93f8-4f4e6c877fcd" providerId="AD" clId="Web-{B44185C5-CF89-25BE-0A53-CCCDB41D0EEF}" dt="2024-12-13T03:09:39.997" v="138"/>
        <pc:sldMkLst>
          <pc:docMk/>
          <pc:sldMk cId="1807703115" sldId="400"/>
        </pc:sldMkLst>
        <pc:spChg chg="mod">
          <ac:chgData name="Belaid, Sirine" userId="S::belaids@upmc.edu::5dcb4cf5-c058-49ea-93f8-4f4e6c877fcd" providerId="AD" clId="Web-{B44185C5-CF89-25BE-0A53-CCCDB41D0EEF}" dt="2024-12-13T03:09:39.997" v="138"/>
          <ac:spMkLst>
            <pc:docMk/>
            <pc:sldMk cId="1807703115" sldId="400"/>
            <ac:spMk id="2" creationId="{1E63AA7C-D8CC-24E2-1927-C63C14BF6FAB}"/>
          </ac:spMkLst>
        </pc:spChg>
        <pc:spChg chg="add">
          <ac:chgData name="Belaid, Sirine" userId="S::belaids@upmc.edu::5dcb4cf5-c058-49ea-93f8-4f4e6c877fcd" providerId="AD" clId="Web-{B44185C5-CF89-25BE-0A53-CCCDB41D0EEF}" dt="2024-12-13T03:09:39.997" v="138"/>
          <ac:spMkLst>
            <pc:docMk/>
            <pc:sldMk cId="1807703115" sldId="400"/>
            <ac:spMk id="7" creationId="{43C48B49-6135-48B6-AC0F-97E5D8D1F03F}"/>
          </ac:spMkLst>
        </pc:spChg>
        <pc:spChg chg="add">
          <ac:chgData name="Belaid, Sirine" userId="S::belaids@upmc.edu::5dcb4cf5-c058-49ea-93f8-4f4e6c877fcd" providerId="AD" clId="Web-{B44185C5-CF89-25BE-0A53-CCCDB41D0EEF}" dt="2024-12-13T03:09:39.997" v="138"/>
          <ac:spMkLst>
            <pc:docMk/>
            <pc:sldMk cId="1807703115" sldId="400"/>
            <ac:spMk id="9" creationId="{9715DAF0-AE1B-46C9-8A6B-DB2AA05AB91D}"/>
          </ac:spMkLst>
        </pc:spChg>
        <pc:spChg chg="add">
          <ac:chgData name="Belaid, Sirine" userId="S::belaids@upmc.edu::5dcb4cf5-c058-49ea-93f8-4f4e6c877fcd" providerId="AD" clId="Web-{B44185C5-CF89-25BE-0A53-CCCDB41D0EEF}" dt="2024-12-13T03:09:39.997" v="138"/>
          <ac:spMkLst>
            <pc:docMk/>
            <pc:sldMk cId="1807703115" sldId="400"/>
            <ac:spMk id="11" creationId="{DC631C0B-6DA6-4E57-8231-CE32B3434A7E}"/>
          </ac:spMkLst>
        </pc:spChg>
        <pc:spChg chg="add">
          <ac:chgData name="Belaid, Sirine" userId="S::belaids@upmc.edu::5dcb4cf5-c058-49ea-93f8-4f4e6c877fcd" providerId="AD" clId="Web-{B44185C5-CF89-25BE-0A53-CCCDB41D0EEF}" dt="2024-12-13T03:09:39.997" v="138"/>
          <ac:spMkLst>
            <pc:docMk/>
            <pc:sldMk cId="1807703115" sldId="400"/>
            <ac:spMk id="13" creationId="{F256AC18-FB41-4977-8B0C-F5082335AB7D}"/>
          </ac:spMkLst>
        </pc:spChg>
        <pc:spChg chg="add">
          <ac:chgData name="Belaid, Sirine" userId="S::belaids@upmc.edu::5dcb4cf5-c058-49ea-93f8-4f4e6c877fcd" providerId="AD" clId="Web-{B44185C5-CF89-25BE-0A53-CCCDB41D0EEF}" dt="2024-12-13T03:09:39.997" v="138"/>
          <ac:spMkLst>
            <pc:docMk/>
            <pc:sldMk cId="1807703115" sldId="400"/>
            <ac:spMk id="15" creationId="{AFF4A713-7B75-4B21-90D7-5AB19547C728}"/>
          </ac:spMkLst>
        </pc:spChg>
      </pc:sldChg>
      <pc:sldChg chg="addSp delSp modSp mod setBg addAnim">
        <pc:chgData name="Belaid, Sirine" userId="S::belaids@upmc.edu::5dcb4cf5-c058-49ea-93f8-4f4e6c877fcd" providerId="AD" clId="Web-{B44185C5-CF89-25BE-0A53-CCCDB41D0EEF}" dt="2024-12-13T03:03:50.065" v="73"/>
        <pc:sldMkLst>
          <pc:docMk/>
          <pc:sldMk cId="1711055037" sldId="401"/>
        </pc:sldMkLst>
        <pc:spChg chg="mod">
          <ac:chgData name="Belaid, Sirine" userId="S::belaids@upmc.edu::5dcb4cf5-c058-49ea-93f8-4f4e6c877fcd" providerId="AD" clId="Web-{B44185C5-CF89-25BE-0A53-CCCDB41D0EEF}" dt="2024-12-13T03:03:50.065" v="73"/>
          <ac:spMkLst>
            <pc:docMk/>
            <pc:sldMk cId="1711055037" sldId="401"/>
            <ac:spMk id="2" creationId="{D6611131-E80D-221F-0518-F063E22D7C00}"/>
          </ac:spMkLst>
        </pc:spChg>
        <pc:spChg chg="mod">
          <ac:chgData name="Belaid, Sirine" userId="S::belaids@upmc.edu::5dcb4cf5-c058-49ea-93f8-4f4e6c877fcd" providerId="AD" clId="Web-{B44185C5-CF89-25BE-0A53-CCCDB41D0EEF}" dt="2024-12-13T03:03:50.065" v="73"/>
          <ac:spMkLst>
            <pc:docMk/>
            <pc:sldMk cId="1711055037" sldId="401"/>
            <ac:spMk id="3" creationId="{A954158A-E692-9D38-448A-CBA2603BCC28}"/>
          </ac:spMkLst>
        </pc:spChg>
        <pc:spChg chg="add del">
          <ac:chgData name="Belaid, Sirine" userId="S::belaids@upmc.edu::5dcb4cf5-c058-49ea-93f8-4f4e6c877fcd" providerId="AD" clId="Web-{B44185C5-CF89-25BE-0A53-CCCDB41D0EEF}" dt="2024-12-13T03:03:50.065" v="73"/>
          <ac:spMkLst>
            <pc:docMk/>
            <pc:sldMk cId="1711055037" sldId="401"/>
            <ac:spMk id="8" creationId="{DAF1966E-FD40-4A4A-B61B-C4DF7FA05F06}"/>
          </ac:spMkLst>
        </pc:spChg>
        <pc:spChg chg="add del">
          <ac:chgData name="Belaid, Sirine" userId="S::belaids@upmc.edu::5dcb4cf5-c058-49ea-93f8-4f4e6c877fcd" providerId="AD" clId="Web-{B44185C5-CF89-25BE-0A53-CCCDB41D0EEF}" dt="2024-12-13T03:03:50.065" v="73"/>
          <ac:spMkLst>
            <pc:docMk/>
            <pc:sldMk cId="1711055037" sldId="401"/>
            <ac:spMk id="10" creationId="{047BFA19-D45E-416B-A404-7AF2F3F27017}"/>
          </ac:spMkLst>
        </pc:spChg>
        <pc:spChg chg="add del">
          <ac:chgData name="Belaid, Sirine" userId="S::belaids@upmc.edu::5dcb4cf5-c058-49ea-93f8-4f4e6c877fcd" providerId="AD" clId="Web-{B44185C5-CF89-25BE-0A53-CCCDB41D0EEF}" dt="2024-12-13T03:03:50.065" v="73"/>
          <ac:spMkLst>
            <pc:docMk/>
            <pc:sldMk cId="1711055037" sldId="401"/>
            <ac:spMk id="12" creationId="{8E0105E7-23DB-4CF2-8258-FF47C7620F6E}"/>
          </ac:spMkLst>
        </pc:spChg>
        <pc:spChg chg="add del">
          <ac:chgData name="Belaid, Sirine" userId="S::belaids@upmc.edu::5dcb4cf5-c058-49ea-93f8-4f4e6c877fcd" providerId="AD" clId="Web-{B44185C5-CF89-25BE-0A53-CCCDB41D0EEF}" dt="2024-12-13T03:03:50.065" v="73"/>
          <ac:spMkLst>
            <pc:docMk/>
            <pc:sldMk cId="1711055037" sldId="401"/>
            <ac:spMk id="14" creationId="{074B4F7D-14B2-478B-8BF5-01E4E0C5D263}"/>
          </ac:spMkLst>
        </pc:spChg>
      </pc:sldChg>
      <pc:sldChg chg="addAnim">
        <pc:chgData name="Belaid, Sirine" userId="S::belaids@upmc.edu::5dcb4cf5-c058-49ea-93f8-4f4e6c877fcd" providerId="AD" clId="Web-{B44185C5-CF89-25BE-0A53-CCCDB41D0EEF}" dt="2024-12-13T02:51:07.589" v="12"/>
        <pc:sldMkLst>
          <pc:docMk/>
          <pc:sldMk cId="3969654780" sldId="403"/>
        </pc:sldMkLst>
      </pc:sldChg>
      <pc:sldChg chg="modSp">
        <pc:chgData name="Belaid, Sirine" userId="S::belaids@upmc.edu::5dcb4cf5-c058-49ea-93f8-4f4e6c877fcd" providerId="AD" clId="Web-{B44185C5-CF89-25BE-0A53-CCCDB41D0EEF}" dt="2024-12-13T03:19:39.691" v="189" actId="1076"/>
        <pc:sldMkLst>
          <pc:docMk/>
          <pc:sldMk cId="1389029600" sldId="405"/>
        </pc:sldMkLst>
        <pc:picChg chg="mod">
          <ac:chgData name="Belaid, Sirine" userId="S::belaids@upmc.edu::5dcb4cf5-c058-49ea-93f8-4f4e6c877fcd" providerId="AD" clId="Web-{B44185C5-CF89-25BE-0A53-CCCDB41D0EEF}" dt="2024-12-13T03:19:39.691" v="189" actId="1076"/>
          <ac:picMkLst>
            <pc:docMk/>
            <pc:sldMk cId="1389029600" sldId="405"/>
            <ac:picMk id="3" creationId="{40D24A7C-18C6-A7BE-190E-6FA7C07D8351}"/>
          </ac:picMkLst>
        </pc:picChg>
      </pc:sldChg>
      <pc:sldChg chg="modSp">
        <pc:chgData name="Belaid, Sirine" userId="S::belaids@upmc.edu::5dcb4cf5-c058-49ea-93f8-4f4e6c877fcd" providerId="AD" clId="Web-{B44185C5-CF89-25BE-0A53-CCCDB41D0EEF}" dt="2024-12-12T21:11:39.331" v="4" actId="14100"/>
        <pc:sldMkLst>
          <pc:docMk/>
          <pc:sldMk cId="4257167352" sldId="406"/>
        </pc:sldMkLst>
        <pc:picChg chg="mod">
          <ac:chgData name="Belaid, Sirine" userId="S::belaids@upmc.edu::5dcb4cf5-c058-49ea-93f8-4f4e6c877fcd" providerId="AD" clId="Web-{B44185C5-CF89-25BE-0A53-CCCDB41D0EEF}" dt="2024-12-12T21:11:39.331" v="4" actId="14100"/>
          <ac:picMkLst>
            <pc:docMk/>
            <pc:sldMk cId="4257167352" sldId="406"/>
            <ac:picMk id="3" creationId="{40D24A7C-18C6-A7BE-190E-6FA7C07D8351}"/>
          </ac:picMkLst>
        </pc:picChg>
      </pc:sldChg>
    </pc:docChg>
  </pc:docChgLst>
  <pc:docChgLst>
    <pc:chgData name="Belaid, Sirine" userId="S::belaids@upmc.edu::5dcb4cf5-c058-49ea-93f8-4f4e6c877fcd" providerId="AD" clId="Web-{3F2DC830-A1A1-7092-58FC-5A413FFEA2FC}"/>
    <pc:docChg chg="addSld delSld modSld sldOrd">
      <pc:chgData name="Belaid, Sirine" userId="S::belaids@upmc.edu::5dcb4cf5-c058-49ea-93f8-4f4e6c877fcd" providerId="AD" clId="Web-{3F2DC830-A1A1-7092-58FC-5A413FFEA2FC}" dt="2024-11-20T18:05:34.590" v="5132" actId="20577"/>
      <pc:docMkLst>
        <pc:docMk/>
      </pc:docMkLst>
      <pc:sldChg chg="modSp">
        <pc:chgData name="Belaid, Sirine" userId="S::belaids@upmc.edu::5dcb4cf5-c058-49ea-93f8-4f4e6c877fcd" providerId="AD" clId="Web-{3F2DC830-A1A1-7092-58FC-5A413FFEA2FC}" dt="2024-11-19T22:14:43.709" v="2761" actId="20577"/>
        <pc:sldMkLst>
          <pc:docMk/>
          <pc:sldMk cId="109857222" sldId="256"/>
        </pc:sldMkLst>
        <pc:spChg chg="mod">
          <ac:chgData name="Belaid, Sirine" userId="S::belaids@upmc.edu::5dcb4cf5-c058-49ea-93f8-4f4e6c877fcd" providerId="AD" clId="Web-{3F2DC830-A1A1-7092-58FC-5A413FFEA2FC}" dt="2024-11-19T22:14:37.099" v="2756" actId="20577"/>
          <ac:spMkLst>
            <pc:docMk/>
            <pc:sldMk cId="109857222" sldId="256"/>
            <ac:spMk id="2" creationId="{00000000-0000-0000-0000-000000000000}"/>
          </ac:spMkLst>
        </pc:spChg>
        <pc:spChg chg="mod">
          <ac:chgData name="Belaid, Sirine" userId="S::belaids@upmc.edu::5dcb4cf5-c058-49ea-93f8-4f4e6c877fcd" providerId="AD" clId="Web-{3F2DC830-A1A1-7092-58FC-5A413FFEA2FC}" dt="2024-11-19T22:14:43.709" v="2761" actId="20577"/>
          <ac:spMkLst>
            <pc:docMk/>
            <pc:sldMk cId="109857222" sldId="256"/>
            <ac:spMk id="3" creationId="{00000000-0000-0000-0000-000000000000}"/>
          </ac:spMkLst>
        </pc:spChg>
      </pc:sldChg>
      <pc:sldChg chg="modSp ord">
        <pc:chgData name="Belaid, Sirine" userId="S::belaids@upmc.edu::5dcb4cf5-c058-49ea-93f8-4f4e6c877fcd" providerId="AD" clId="Web-{3F2DC830-A1A1-7092-58FC-5A413FFEA2FC}" dt="2024-11-20T03:38:45.698" v="2859" actId="20577"/>
        <pc:sldMkLst>
          <pc:docMk/>
          <pc:sldMk cId="1491156070" sldId="257"/>
        </pc:sldMkLst>
        <pc:spChg chg="mod">
          <ac:chgData name="Belaid, Sirine" userId="S::belaids@upmc.edu::5dcb4cf5-c058-49ea-93f8-4f4e6c877fcd" providerId="AD" clId="Web-{3F2DC830-A1A1-7092-58FC-5A413FFEA2FC}" dt="2024-11-20T03:38:45.698" v="2859" actId="20577"/>
          <ac:spMkLst>
            <pc:docMk/>
            <pc:sldMk cId="1491156070" sldId="257"/>
            <ac:spMk id="3" creationId="{283F0732-6ED3-A107-57EE-B45417AADBF0}"/>
          </ac:spMkLst>
        </pc:spChg>
      </pc:sldChg>
      <pc:sldChg chg="addSp modSp ord modNotes">
        <pc:chgData name="Belaid, Sirine" userId="S::belaids@upmc.edu::5dcb4cf5-c058-49ea-93f8-4f4e6c877fcd" providerId="AD" clId="Web-{3F2DC830-A1A1-7092-58FC-5A413FFEA2FC}" dt="2024-11-20T03:46:52.997" v="2983" actId="1076"/>
        <pc:sldMkLst>
          <pc:docMk/>
          <pc:sldMk cId="1500721348" sldId="258"/>
        </pc:sldMkLst>
        <pc:spChg chg="mod">
          <ac:chgData name="Belaid, Sirine" userId="S::belaids@upmc.edu::5dcb4cf5-c058-49ea-93f8-4f4e6c877fcd" providerId="AD" clId="Web-{3F2DC830-A1A1-7092-58FC-5A413FFEA2FC}" dt="2024-11-20T03:41:53.758" v="2930" actId="20577"/>
          <ac:spMkLst>
            <pc:docMk/>
            <pc:sldMk cId="1500721348" sldId="258"/>
            <ac:spMk id="3" creationId="{76CE0DDB-F694-7507-CAB6-43B4259BD94F}"/>
          </ac:spMkLst>
        </pc:spChg>
        <pc:spChg chg="add mod">
          <ac:chgData name="Belaid, Sirine" userId="S::belaids@upmc.edu::5dcb4cf5-c058-49ea-93f8-4f4e6c877fcd" providerId="AD" clId="Web-{3F2DC830-A1A1-7092-58FC-5A413FFEA2FC}" dt="2024-11-20T03:46:52.997" v="2983" actId="1076"/>
          <ac:spMkLst>
            <pc:docMk/>
            <pc:sldMk cId="1500721348" sldId="258"/>
            <ac:spMk id="4" creationId="{DD10D27F-5D79-A7D9-F80A-6BEDF78417AC}"/>
          </ac:spMkLst>
        </pc:spChg>
      </pc:sldChg>
      <pc:sldChg chg="addSp modSp modNotes">
        <pc:chgData name="Belaid, Sirine" userId="S::belaids@upmc.edu::5dcb4cf5-c058-49ea-93f8-4f4e6c877fcd" providerId="AD" clId="Web-{3F2DC830-A1A1-7092-58FC-5A413FFEA2FC}" dt="2024-11-19T19:27:22.139" v="1960"/>
        <pc:sldMkLst>
          <pc:docMk/>
          <pc:sldMk cId="344766927" sldId="259"/>
        </pc:sldMkLst>
        <pc:spChg chg="mod">
          <ac:chgData name="Belaid, Sirine" userId="S::belaids@upmc.edu::5dcb4cf5-c058-49ea-93f8-4f4e6c877fcd" providerId="AD" clId="Web-{3F2DC830-A1A1-7092-58FC-5A413FFEA2FC}" dt="2024-11-19T18:03:27.588" v="1474" actId="20577"/>
          <ac:spMkLst>
            <pc:docMk/>
            <pc:sldMk cId="344766927" sldId="259"/>
            <ac:spMk id="2" creationId="{9BBBE17F-3388-CD35-D6F3-A1EE6652238F}"/>
          </ac:spMkLst>
        </pc:spChg>
        <pc:spChg chg="mod">
          <ac:chgData name="Belaid, Sirine" userId="S::belaids@upmc.edu::5dcb4cf5-c058-49ea-93f8-4f4e6c877fcd" providerId="AD" clId="Web-{3F2DC830-A1A1-7092-58FC-5A413FFEA2FC}" dt="2024-11-19T18:03:31.744" v="1476" actId="20577"/>
          <ac:spMkLst>
            <pc:docMk/>
            <pc:sldMk cId="344766927" sldId="259"/>
            <ac:spMk id="3" creationId="{835101AF-09D4-186B-7884-F5FA6CC50083}"/>
          </ac:spMkLst>
        </pc:spChg>
        <pc:picChg chg="add mod">
          <ac:chgData name="Belaid, Sirine" userId="S::belaids@upmc.edu::5dcb4cf5-c058-49ea-93f8-4f4e6c877fcd" providerId="AD" clId="Web-{3F2DC830-A1A1-7092-58FC-5A413FFEA2FC}" dt="2024-11-19T18:03:38.604" v="1480" actId="1076"/>
          <ac:picMkLst>
            <pc:docMk/>
            <pc:sldMk cId="344766927" sldId="259"/>
            <ac:picMk id="4" creationId="{78F32EBD-FC30-0B78-5EC2-3AC77BB2C158}"/>
          </ac:picMkLst>
        </pc:picChg>
      </pc:sldChg>
      <pc:sldChg chg="addSp delSp modSp">
        <pc:chgData name="Belaid, Sirine" userId="S::belaids@upmc.edu::5dcb4cf5-c058-49ea-93f8-4f4e6c877fcd" providerId="AD" clId="Web-{3F2DC830-A1A1-7092-58FC-5A413FFEA2FC}" dt="2024-11-20T17:51:06.601" v="5030" actId="1076"/>
        <pc:sldMkLst>
          <pc:docMk/>
          <pc:sldMk cId="3651327643" sldId="260"/>
        </pc:sldMkLst>
        <pc:spChg chg="mod">
          <ac:chgData name="Belaid, Sirine" userId="S::belaids@upmc.edu::5dcb4cf5-c058-49ea-93f8-4f4e6c877fcd" providerId="AD" clId="Web-{3F2DC830-A1A1-7092-58FC-5A413FFEA2FC}" dt="2024-11-19T00:49:20.372" v="23" actId="20577"/>
          <ac:spMkLst>
            <pc:docMk/>
            <pc:sldMk cId="3651327643" sldId="260"/>
            <ac:spMk id="2" creationId="{38B24072-5194-B87A-86EC-17D0F377272F}"/>
          </ac:spMkLst>
        </pc:spChg>
        <pc:spChg chg="add mod">
          <ac:chgData name="Belaid, Sirine" userId="S::belaids@upmc.edu::5dcb4cf5-c058-49ea-93f8-4f4e6c877fcd" providerId="AD" clId="Web-{3F2DC830-A1A1-7092-58FC-5A413FFEA2FC}" dt="2024-11-20T17:51:06.601" v="5030" actId="1076"/>
          <ac:spMkLst>
            <pc:docMk/>
            <pc:sldMk cId="3651327643" sldId="260"/>
            <ac:spMk id="3" creationId="{23C63626-BFBC-CB2F-2972-A1C1CB269B47}"/>
          </ac:spMkLst>
        </pc:spChg>
        <pc:picChg chg="add mod ord">
          <ac:chgData name="Belaid, Sirine" userId="S::belaids@upmc.edu::5dcb4cf5-c058-49ea-93f8-4f4e6c877fcd" providerId="AD" clId="Web-{3F2DC830-A1A1-7092-58FC-5A413FFEA2FC}" dt="2024-11-19T14:32:07.193" v="49" actId="14100"/>
          <ac:picMkLst>
            <pc:docMk/>
            <pc:sldMk cId="3651327643" sldId="260"/>
            <ac:picMk id="4" creationId="{841F9F36-D40C-0395-F951-040DD584F762}"/>
          </ac:picMkLst>
        </pc:picChg>
      </pc:sldChg>
      <pc:sldChg chg="addSp modSp">
        <pc:chgData name="Belaid, Sirine" userId="S::belaids@upmc.edu::5dcb4cf5-c058-49ea-93f8-4f4e6c877fcd" providerId="AD" clId="Web-{3F2DC830-A1A1-7092-58FC-5A413FFEA2FC}" dt="2024-11-20T05:13:18.921" v="3315" actId="20577"/>
        <pc:sldMkLst>
          <pc:docMk/>
          <pc:sldMk cId="2302766718" sldId="261"/>
        </pc:sldMkLst>
        <pc:spChg chg="mod">
          <ac:chgData name="Belaid, Sirine" userId="S::belaids@upmc.edu::5dcb4cf5-c058-49ea-93f8-4f4e6c877fcd" providerId="AD" clId="Web-{3F2DC830-A1A1-7092-58FC-5A413FFEA2FC}" dt="2024-11-19T18:02:30.898" v="1462" actId="20577"/>
          <ac:spMkLst>
            <pc:docMk/>
            <pc:sldMk cId="2302766718" sldId="261"/>
            <ac:spMk id="2" creationId="{049050E2-8D86-1CE2-1DAE-D1D3F05419D4}"/>
          </ac:spMkLst>
        </pc:spChg>
        <pc:spChg chg="mod">
          <ac:chgData name="Belaid, Sirine" userId="S::belaids@upmc.edu::5dcb4cf5-c058-49ea-93f8-4f4e6c877fcd" providerId="AD" clId="Web-{3F2DC830-A1A1-7092-58FC-5A413FFEA2FC}" dt="2024-11-20T05:13:18.921" v="3315" actId="20577"/>
          <ac:spMkLst>
            <pc:docMk/>
            <pc:sldMk cId="2302766718" sldId="261"/>
            <ac:spMk id="3" creationId="{28C8D225-CFB3-835A-E034-CE62DC5DCF1F}"/>
          </ac:spMkLst>
        </pc:spChg>
        <pc:picChg chg="add mod">
          <ac:chgData name="Belaid, Sirine" userId="S::belaids@upmc.edu::5dcb4cf5-c058-49ea-93f8-4f4e6c877fcd" providerId="AD" clId="Web-{3F2DC830-A1A1-7092-58FC-5A413FFEA2FC}" dt="2024-11-19T16:51:33.198" v="324" actId="1076"/>
          <ac:picMkLst>
            <pc:docMk/>
            <pc:sldMk cId="2302766718" sldId="261"/>
            <ac:picMk id="5" creationId="{BA7AEFEF-2778-5D37-4B86-BFBA360D73E1}"/>
          </ac:picMkLst>
        </pc:picChg>
      </pc:sldChg>
      <pc:sldChg chg="addSp delSp modSp">
        <pc:chgData name="Belaid, Sirine" userId="S::belaids@upmc.edu::5dcb4cf5-c058-49ea-93f8-4f4e6c877fcd" providerId="AD" clId="Web-{3F2DC830-A1A1-7092-58FC-5A413FFEA2FC}" dt="2024-11-19T18:39:56.493" v="1510" actId="14100"/>
        <pc:sldMkLst>
          <pc:docMk/>
          <pc:sldMk cId="576414548" sldId="262"/>
        </pc:sldMkLst>
        <pc:spChg chg="mod">
          <ac:chgData name="Belaid, Sirine" userId="S::belaids@upmc.edu::5dcb4cf5-c058-49ea-93f8-4f4e6c877fcd" providerId="AD" clId="Web-{3F2DC830-A1A1-7092-58FC-5A413FFEA2FC}" dt="2024-11-19T18:35:31.093" v="1487" actId="1076"/>
          <ac:spMkLst>
            <pc:docMk/>
            <pc:sldMk cId="576414548" sldId="262"/>
            <ac:spMk id="2" creationId="{DA00EA87-B133-5C4B-E8F1-300D18BF07AA}"/>
          </ac:spMkLst>
        </pc:spChg>
        <pc:picChg chg="add mod">
          <ac:chgData name="Belaid, Sirine" userId="S::belaids@upmc.edu::5dcb4cf5-c058-49ea-93f8-4f4e6c877fcd" providerId="AD" clId="Web-{3F2DC830-A1A1-7092-58FC-5A413FFEA2FC}" dt="2024-11-19T18:35:33.906" v="1488" actId="1076"/>
          <ac:picMkLst>
            <pc:docMk/>
            <pc:sldMk cId="576414548" sldId="262"/>
            <ac:picMk id="3" creationId="{1F3F9A4E-56BD-D16E-B2AC-BADC314FDA49}"/>
          </ac:picMkLst>
        </pc:picChg>
        <pc:picChg chg="add mod">
          <ac:chgData name="Belaid, Sirine" userId="S::belaids@upmc.edu::5dcb4cf5-c058-49ea-93f8-4f4e6c877fcd" providerId="AD" clId="Web-{3F2DC830-A1A1-7092-58FC-5A413FFEA2FC}" dt="2024-11-19T18:39:56.493" v="1510" actId="14100"/>
          <ac:picMkLst>
            <pc:docMk/>
            <pc:sldMk cId="576414548" sldId="262"/>
            <ac:picMk id="4" creationId="{1DF4EBF3-CB21-4D9B-C581-71579BE204AD}"/>
          </ac:picMkLst>
        </pc:picChg>
        <pc:picChg chg="add mod">
          <ac:chgData name="Belaid, Sirine" userId="S::belaids@upmc.edu::5dcb4cf5-c058-49ea-93f8-4f4e6c877fcd" providerId="AD" clId="Web-{3F2DC830-A1A1-7092-58FC-5A413FFEA2FC}" dt="2024-11-19T18:39:48.680" v="1507" actId="14100"/>
          <ac:picMkLst>
            <pc:docMk/>
            <pc:sldMk cId="576414548" sldId="262"/>
            <ac:picMk id="6" creationId="{58CFA5DF-D2A1-3AD6-8599-EA51C68057C4}"/>
          </ac:picMkLst>
        </pc:picChg>
      </pc:sldChg>
      <pc:sldChg chg="addSp delSp modSp">
        <pc:chgData name="Belaid, Sirine" userId="S::belaids@upmc.edu::5dcb4cf5-c058-49ea-93f8-4f4e6c877fcd" providerId="AD" clId="Web-{3F2DC830-A1A1-7092-58FC-5A413FFEA2FC}" dt="2024-11-19T18:42:15.279" v="1516" actId="1076"/>
        <pc:sldMkLst>
          <pc:docMk/>
          <pc:sldMk cId="339090689" sldId="263"/>
        </pc:sldMkLst>
        <pc:picChg chg="add mod">
          <ac:chgData name="Belaid, Sirine" userId="S::belaids@upmc.edu::5dcb4cf5-c058-49ea-93f8-4f4e6c877fcd" providerId="AD" clId="Web-{3F2DC830-A1A1-7092-58FC-5A413FFEA2FC}" dt="2024-11-19T18:38:55.585" v="1502" actId="14100"/>
          <ac:picMkLst>
            <pc:docMk/>
            <pc:sldMk cId="339090689" sldId="263"/>
            <ac:picMk id="5" creationId="{77C434E4-DD0E-564F-6170-2BF71D0ADAC3}"/>
          </ac:picMkLst>
        </pc:picChg>
        <pc:picChg chg="add mod">
          <ac:chgData name="Belaid, Sirine" userId="S::belaids@upmc.edu::5dcb4cf5-c058-49ea-93f8-4f4e6c877fcd" providerId="AD" clId="Web-{3F2DC830-A1A1-7092-58FC-5A413FFEA2FC}" dt="2024-11-19T18:42:15.279" v="1516" actId="1076"/>
          <ac:picMkLst>
            <pc:docMk/>
            <pc:sldMk cId="339090689" sldId="263"/>
            <ac:picMk id="6" creationId="{18F390FB-E2D9-F372-1A78-41B03A76A0F1}"/>
          </ac:picMkLst>
        </pc:picChg>
        <pc:picChg chg="add mod">
          <ac:chgData name="Belaid, Sirine" userId="S::belaids@upmc.edu::5dcb4cf5-c058-49ea-93f8-4f4e6c877fcd" providerId="AD" clId="Web-{3F2DC830-A1A1-7092-58FC-5A413FFEA2FC}" dt="2024-11-19T18:42:13.545" v="1515" actId="1076"/>
          <ac:picMkLst>
            <pc:docMk/>
            <pc:sldMk cId="339090689" sldId="263"/>
            <ac:picMk id="7" creationId="{37D3EEB2-EB6C-A8DC-25FE-1C95281E812F}"/>
          </ac:picMkLst>
        </pc:picChg>
      </pc:sldChg>
      <pc:sldChg chg="addSp delSp modSp modNotes">
        <pc:chgData name="Belaid, Sirine" userId="S::belaids@upmc.edu::5dcb4cf5-c058-49ea-93f8-4f4e6c877fcd" providerId="AD" clId="Web-{3F2DC830-A1A1-7092-58FC-5A413FFEA2FC}" dt="2024-11-20T03:31:42.648" v="2835"/>
        <pc:sldMkLst>
          <pc:docMk/>
          <pc:sldMk cId="2595590755" sldId="264"/>
        </pc:sldMkLst>
        <pc:spChg chg="add mod">
          <ac:chgData name="Belaid, Sirine" userId="S::belaids@upmc.edu::5dcb4cf5-c058-49ea-93f8-4f4e6c877fcd" providerId="AD" clId="Web-{3F2DC830-A1A1-7092-58FC-5A413FFEA2FC}" dt="2024-11-20T03:28:44.105" v="2830" actId="1076"/>
          <ac:spMkLst>
            <pc:docMk/>
            <pc:sldMk cId="2595590755" sldId="264"/>
            <ac:spMk id="3" creationId="{8CDC36B7-208D-D46B-7574-FCF790348FF4}"/>
          </ac:spMkLst>
        </pc:spChg>
        <pc:picChg chg="add mod">
          <ac:chgData name="Belaid, Sirine" userId="S::belaids@upmc.edu::5dcb4cf5-c058-49ea-93f8-4f4e6c877fcd" providerId="AD" clId="Web-{3F2DC830-A1A1-7092-58FC-5A413FFEA2FC}" dt="2024-11-20T03:28:56.168" v="2831" actId="1076"/>
          <ac:picMkLst>
            <pc:docMk/>
            <pc:sldMk cId="2595590755" sldId="264"/>
            <ac:picMk id="2" creationId="{08F67302-9B4E-8524-CA03-A31DE7C76674}"/>
          </ac:picMkLst>
        </pc:picChg>
      </pc:sldChg>
      <pc:sldChg chg="addSp modSp new">
        <pc:chgData name="Belaid, Sirine" userId="S::belaids@upmc.edu::5dcb4cf5-c058-49ea-93f8-4f4e6c877fcd" providerId="AD" clId="Web-{3F2DC830-A1A1-7092-58FC-5A413FFEA2FC}" dt="2024-11-19T14:35:42.640" v="56" actId="14100"/>
        <pc:sldMkLst>
          <pc:docMk/>
          <pc:sldMk cId="571547126" sldId="265"/>
        </pc:sldMkLst>
        <pc:picChg chg="add mod">
          <ac:chgData name="Belaid, Sirine" userId="S::belaids@upmc.edu::5dcb4cf5-c058-49ea-93f8-4f4e6c877fcd" providerId="AD" clId="Web-{3F2DC830-A1A1-7092-58FC-5A413FFEA2FC}" dt="2024-11-19T14:35:42.640" v="56" actId="14100"/>
          <ac:picMkLst>
            <pc:docMk/>
            <pc:sldMk cId="571547126" sldId="265"/>
            <ac:picMk id="2" creationId="{DE4CE9C6-10FB-957F-BA89-DD88CDE5DC77}"/>
          </ac:picMkLst>
        </pc:picChg>
      </pc:sldChg>
      <pc:sldChg chg="addSp delSp modSp new">
        <pc:chgData name="Belaid, Sirine" userId="S::belaids@upmc.edu::5dcb4cf5-c058-49ea-93f8-4f4e6c877fcd" providerId="AD" clId="Web-{3F2DC830-A1A1-7092-58FC-5A413FFEA2FC}" dt="2024-11-19T16:42:16.377" v="223" actId="1076"/>
        <pc:sldMkLst>
          <pc:docMk/>
          <pc:sldMk cId="3955110762" sldId="266"/>
        </pc:sldMkLst>
        <pc:picChg chg="add mod">
          <ac:chgData name="Belaid, Sirine" userId="S::belaids@upmc.edu::5dcb4cf5-c058-49ea-93f8-4f4e6c877fcd" providerId="AD" clId="Web-{3F2DC830-A1A1-7092-58FC-5A413FFEA2FC}" dt="2024-11-19T16:42:11.314" v="222" actId="1076"/>
          <ac:picMkLst>
            <pc:docMk/>
            <pc:sldMk cId="3955110762" sldId="266"/>
            <ac:picMk id="2" creationId="{86301785-BC4C-5320-30D4-DA8593283B2F}"/>
          </ac:picMkLst>
        </pc:picChg>
        <pc:picChg chg="add mod">
          <ac:chgData name="Belaid, Sirine" userId="S::belaids@upmc.edu::5dcb4cf5-c058-49ea-93f8-4f4e6c877fcd" providerId="AD" clId="Web-{3F2DC830-A1A1-7092-58FC-5A413FFEA2FC}" dt="2024-11-19T16:42:16.377" v="223" actId="1076"/>
          <ac:picMkLst>
            <pc:docMk/>
            <pc:sldMk cId="3955110762" sldId="266"/>
            <ac:picMk id="4" creationId="{BABDBCEE-BB5E-B762-79DB-479F019B3903}"/>
          </ac:picMkLst>
        </pc:picChg>
      </pc:sldChg>
      <pc:sldChg chg="addSp delSp modSp new">
        <pc:chgData name="Belaid, Sirine" userId="S::belaids@upmc.edu::5dcb4cf5-c058-49ea-93f8-4f4e6c877fcd" providerId="AD" clId="Web-{3F2DC830-A1A1-7092-58FC-5A413FFEA2FC}" dt="2024-11-19T14:54:15.051" v="91" actId="14100"/>
        <pc:sldMkLst>
          <pc:docMk/>
          <pc:sldMk cId="2923304690" sldId="267"/>
        </pc:sldMkLst>
        <pc:picChg chg="add mod">
          <ac:chgData name="Belaid, Sirine" userId="S::belaids@upmc.edu::5dcb4cf5-c058-49ea-93f8-4f4e6c877fcd" providerId="AD" clId="Web-{3F2DC830-A1A1-7092-58FC-5A413FFEA2FC}" dt="2024-11-19T14:54:15.051" v="91" actId="14100"/>
          <ac:picMkLst>
            <pc:docMk/>
            <pc:sldMk cId="2923304690" sldId="267"/>
            <ac:picMk id="3" creationId="{659DE7C8-F8BF-61CD-37B5-590CCDBA1760}"/>
          </ac:picMkLst>
        </pc:picChg>
      </pc:sldChg>
      <pc:sldChg chg="addSp delSp modSp new">
        <pc:chgData name="Belaid, Sirine" userId="S::belaids@upmc.edu::5dcb4cf5-c058-49ea-93f8-4f4e6c877fcd" providerId="AD" clId="Web-{3F2DC830-A1A1-7092-58FC-5A413FFEA2FC}" dt="2024-11-19T14:54:04.285" v="87"/>
        <pc:sldMkLst>
          <pc:docMk/>
          <pc:sldMk cId="280177216" sldId="268"/>
        </pc:sldMkLst>
        <pc:picChg chg="add mod">
          <ac:chgData name="Belaid, Sirine" userId="S::belaids@upmc.edu::5dcb4cf5-c058-49ea-93f8-4f4e6c877fcd" providerId="AD" clId="Web-{3F2DC830-A1A1-7092-58FC-5A413FFEA2FC}" dt="2024-11-19T14:52:07.670" v="83" actId="1076"/>
          <ac:picMkLst>
            <pc:docMk/>
            <pc:sldMk cId="280177216" sldId="268"/>
            <ac:picMk id="2" creationId="{548D115F-9288-45E7-C063-CBFCBD541398}"/>
          </ac:picMkLst>
        </pc:picChg>
        <pc:picChg chg="add mod">
          <ac:chgData name="Belaid, Sirine" userId="S::belaids@upmc.edu::5dcb4cf5-c058-49ea-93f8-4f4e6c877fcd" providerId="AD" clId="Web-{3F2DC830-A1A1-7092-58FC-5A413FFEA2FC}" dt="2024-11-19T14:52:40.562" v="85" actId="1076"/>
          <ac:picMkLst>
            <pc:docMk/>
            <pc:sldMk cId="280177216" sldId="268"/>
            <ac:picMk id="4" creationId="{B9FE9E1D-8671-6261-E549-0CF4B7F048AA}"/>
          </ac:picMkLst>
        </pc:picChg>
      </pc:sldChg>
      <pc:sldChg chg="addSp modSp new">
        <pc:chgData name="Belaid, Sirine" userId="S::belaids@upmc.edu::5dcb4cf5-c058-49ea-93f8-4f4e6c877fcd" providerId="AD" clId="Web-{3F2DC830-A1A1-7092-58FC-5A413FFEA2FC}" dt="2024-11-19T15:00:09.130" v="95" actId="14100"/>
        <pc:sldMkLst>
          <pc:docMk/>
          <pc:sldMk cId="666331701" sldId="269"/>
        </pc:sldMkLst>
        <pc:picChg chg="add mod">
          <ac:chgData name="Belaid, Sirine" userId="S::belaids@upmc.edu::5dcb4cf5-c058-49ea-93f8-4f4e6c877fcd" providerId="AD" clId="Web-{3F2DC830-A1A1-7092-58FC-5A413FFEA2FC}" dt="2024-11-19T15:00:09.130" v="95" actId="14100"/>
          <ac:picMkLst>
            <pc:docMk/>
            <pc:sldMk cId="666331701" sldId="269"/>
            <ac:picMk id="2" creationId="{00D8A194-5B46-C07E-6F73-16CE0E69576E}"/>
          </ac:picMkLst>
        </pc:picChg>
      </pc:sldChg>
      <pc:sldChg chg="addSp modSp new">
        <pc:chgData name="Belaid, Sirine" userId="S::belaids@upmc.edu::5dcb4cf5-c058-49ea-93f8-4f4e6c877fcd" providerId="AD" clId="Web-{3F2DC830-A1A1-7092-58FC-5A413FFEA2FC}" dt="2024-11-19T15:08:14.231" v="99" actId="14100"/>
        <pc:sldMkLst>
          <pc:docMk/>
          <pc:sldMk cId="3489943564" sldId="270"/>
        </pc:sldMkLst>
        <pc:picChg chg="add mod">
          <ac:chgData name="Belaid, Sirine" userId="S::belaids@upmc.edu::5dcb4cf5-c058-49ea-93f8-4f4e6c877fcd" providerId="AD" clId="Web-{3F2DC830-A1A1-7092-58FC-5A413FFEA2FC}" dt="2024-11-19T15:08:14.231" v="99" actId="14100"/>
          <ac:picMkLst>
            <pc:docMk/>
            <pc:sldMk cId="3489943564" sldId="270"/>
            <ac:picMk id="2" creationId="{E5F539E8-8A1B-873C-F616-9EE00D7D9F9E}"/>
          </ac:picMkLst>
        </pc:picChg>
      </pc:sldChg>
      <pc:sldChg chg="addSp modSp new">
        <pc:chgData name="Belaid, Sirine" userId="S::belaids@upmc.edu::5dcb4cf5-c058-49ea-93f8-4f4e6c877fcd" providerId="AD" clId="Web-{3F2DC830-A1A1-7092-58FC-5A413FFEA2FC}" dt="2024-11-19T15:12:12.585" v="103" actId="14100"/>
        <pc:sldMkLst>
          <pc:docMk/>
          <pc:sldMk cId="4163017298" sldId="271"/>
        </pc:sldMkLst>
        <pc:picChg chg="add mod">
          <ac:chgData name="Belaid, Sirine" userId="S::belaids@upmc.edu::5dcb4cf5-c058-49ea-93f8-4f4e6c877fcd" providerId="AD" clId="Web-{3F2DC830-A1A1-7092-58FC-5A413FFEA2FC}" dt="2024-11-19T15:12:12.585" v="103" actId="14100"/>
          <ac:picMkLst>
            <pc:docMk/>
            <pc:sldMk cId="4163017298" sldId="271"/>
            <ac:picMk id="2" creationId="{8D90AB9F-86EF-3500-3530-46687F20E609}"/>
          </ac:picMkLst>
        </pc:picChg>
      </pc:sldChg>
      <pc:sldChg chg="addSp modSp new">
        <pc:chgData name="Belaid, Sirine" userId="S::belaids@upmc.edu::5dcb4cf5-c058-49ea-93f8-4f4e6c877fcd" providerId="AD" clId="Web-{3F2DC830-A1A1-7092-58FC-5A413FFEA2FC}" dt="2024-11-19T15:14:22.701" v="113" actId="14100"/>
        <pc:sldMkLst>
          <pc:docMk/>
          <pc:sldMk cId="138475673" sldId="272"/>
        </pc:sldMkLst>
        <pc:picChg chg="add mod">
          <ac:chgData name="Belaid, Sirine" userId="S::belaids@upmc.edu::5dcb4cf5-c058-49ea-93f8-4f4e6c877fcd" providerId="AD" clId="Web-{3F2DC830-A1A1-7092-58FC-5A413FFEA2FC}" dt="2024-11-19T15:13:11.994" v="107" actId="1076"/>
          <ac:picMkLst>
            <pc:docMk/>
            <pc:sldMk cId="138475673" sldId="272"/>
            <ac:picMk id="2" creationId="{031F6F2D-15CB-C5FE-64DD-76E4EBEF0726}"/>
          </ac:picMkLst>
        </pc:picChg>
        <pc:picChg chg="add mod">
          <ac:chgData name="Belaid, Sirine" userId="S::belaids@upmc.edu::5dcb4cf5-c058-49ea-93f8-4f4e6c877fcd" providerId="AD" clId="Web-{3F2DC830-A1A1-7092-58FC-5A413FFEA2FC}" dt="2024-11-19T15:14:22.701" v="113" actId="14100"/>
          <ac:picMkLst>
            <pc:docMk/>
            <pc:sldMk cId="138475673" sldId="272"/>
            <ac:picMk id="3" creationId="{8A13BC03-44D4-0458-BA9C-98228A9AD56B}"/>
          </ac:picMkLst>
        </pc:picChg>
      </pc:sldChg>
      <pc:sldChg chg="addSp new">
        <pc:chgData name="Belaid, Sirine" userId="S::belaids@upmc.edu::5dcb4cf5-c058-49ea-93f8-4f4e6c877fcd" providerId="AD" clId="Web-{3F2DC830-A1A1-7092-58FC-5A413FFEA2FC}" dt="2024-11-19T15:14:41.420" v="114"/>
        <pc:sldMkLst>
          <pc:docMk/>
          <pc:sldMk cId="2876258149" sldId="273"/>
        </pc:sldMkLst>
        <pc:picChg chg="add">
          <ac:chgData name="Belaid, Sirine" userId="S::belaids@upmc.edu::5dcb4cf5-c058-49ea-93f8-4f4e6c877fcd" providerId="AD" clId="Web-{3F2DC830-A1A1-7092-58FC-5A413FFEA2FC}" dt="2024-11-19T15:14:41.420" v="114"/>
          <ac:picMkLst>
            <pc:docMk/>
            <pc:sldMk cId="2876258149" sldId="273"/>
            <ac:picMk id="3" creationId="{DC1F1B1C-BF2D-A3A7-56ED-95B330C6E465}"/>
          </ac:picMkLst>
        </pc:picChg>
      </pc:sldChg>
      <pc:sldChg chg="addSp modSp new">
        <pc:chgData name="Belaid, Sirine" userId="S::belaids@upmc.edu::5dcb4cf5-c058-49ea-93f8-4f4e6c877fcd" providerId="AD" clId="Web-{3F2DC830-A1A1-7092-58FC-5A413FFEA2FC}" dt="2024-11-19T15:19:11.027" v="122" actId="14100"/>
        <pc:sldMkLst>
          <pc:docMk/>
          <pc:sldMk cId="1037168473" sldId="274"/>
        </pc:sldMkLst>
        <pc:picChg chg="add mod">
          <ac:chgData name="Belaid, Sirine" userId="S::belaids@upmc.edu::5dcb4cf5-c058-49ea-93f8-4f4e6c877fcd" providerId="AD" clId="Web-{3F2DC830-A1A1-7092-58FC-5A413FFEA2FC}" dt="2024-11-19T15:18:08.571" v="120" actId="14100"/>
          <ac:picMkLst>
            <pc:docMk/>
            <pc:sldMk cId="1037168473" sldId="274"/>
            <ac:picMk id="2" creationId="{7EB9E41C-CE66-D2EC-060F-EE1D4756046F}"/>
          </ac:picMkLst>
        </pc:picChg>
        <pc:picChg chg="add mod">
          <ac:chgData name="Belaid, Sirine" userId="S::belaids@upmc.edu::5dcb4cf5-c058-49ea-93f8-4f4e6c877fcd" providerId="AD" clId="Web-{3F2DC830-A1A1-7092-58FC-5A413FFEA2FC}" dt="2024-11-19T15:19:11.027" v="122" actId="14100"/>
          <ac:picMkLst>
            <pc:docMk/>
            <pc:sldMk cId="1037168473" sldId="274"/>
            <ac:picMk id="3" creationId="{68F65515-2D4E-1C69-A3EE-F7D7FAEC23EC}"/>
          </ac:picMkLst>
        </pc:picChg>
      </pc:sldChg>
      <pc:sldChg chg="addSp delSp modSp new">
        <pc:chgData name="Belaid, Sirine" userId="S::belaids@upmc.edu::5dcb4cf5-c058-49ea-93f8-4f4e6c877fcd" providerId="AD" clId="Web-{3F2DC830-A1A1-7092-58FC-5A413FFEA2FC}" dt="2024-11-19T15:58:35.510" v="158" actId="14100"/>
        <pc:sldMkLst>
          <pc:docMk/>
          <pc:sldMk cId="460022324" sldId="275"/>
        </pc:sldMkLst>
        <pc:picChg chg="add mod">
          <ac:chgData name="Belaid, Sirine" userId="S::belaids@upmc.edu::5dcb4cf5-c058-49ea-93f8-4f4e6c877fcd" providerId="AD" clId="Web-{3F2DC830-A1A1-7092-58FC-5A413FFEA2FC}" dt="2024-11-19T15:56:00.365" v="146" actId="1076"/>
          <ac:picMkLst>
            <pc:docMk/>
            <pc:sldMk cId="460022324" sldId="275"/>
            <ac:picMk id="3" creationId="{A7D018EA-1425-8A40-131E-D968305371A2}"/>
          </ac:picMkLst>
        </pc:picChg>
        <pc:picChg chg="add mod">
          <ac:chgData name="Belaid, Sirine" userId="S::belaids@upmc.edu::5dcb4cf5-c058-49ea-93f8-4f4e6c877fcd" providerId="AD" clId="Web-{3F2DC830-A1A1-7092-58FC-5A413FFEA2FC}" dt="2024-11-19T15:57:26.352" v="153" actId="1076"/>
          <ac:picMkLst>
            <pc:docMk/>
            <pc:sldMk cId="460022324" sldId="275"/>
            <ac:picMk id="4" creationId="{29B50A29-AA21-E924-00DF-7F71861CD3D4}"/>
          </ac:picMkLst>
        </pc:picChg>
        <pc:picChg chg="add mod">
          <ac:chgData name="Belaid, Sirine" userId="S::belaids@upmc.edu::5dcb4cf5-c058-49ea-93f8-4f4e6c877fcd" providerId="AD" clId="Web-{3F2DC830-A1A1-7092-58FC-5A413FFEA2FC}" dt="2024-11-19T15:58:32.385" v="157" actId="14100"/>
          <ac:picMkLst>
            <pc:docMk/>
            <pc:sldMk cId="460022324" sldId="275"/>
            <ac:picMk id="5" creationId="{D0A40B72-A448-7CED-0238-F94A2B9AF53B}"/>
          </ac:picMkLst>
        </pc:picChg>
        <pc:picChg chg="add mod">
          <ac:chgData name="Belaid, Sirine" userId="S::belaids@upmc.edu::5dcb4cf5-c058-49ea-93f8-4f4e6c877fcd" providerId="AD" clId="Web-{3F2DC830-A1A1-7092-58FC-5A413FFEA2FC}" dt="2024-11-19T15:58:35.510" v="158" actId="14100"/>
          <ac:picMkLst>
            <pc:docMk/>
            <pc:sldMk cId="460022324" sldId="275"/>
            <ac:picMk id="6" creationId="{2103AE8E-BE3F-8E84-1183-5AB00DBDB2AB}"/>
          </ac:picMkLst>
        </pc:picChg>
      </pc:sldChg>
      <pc:sldChg chg="addSp delSp modSp new">
        <pc:chgData name="Belaid, Sirine" userId="S::belaids@upmc.edu::5dcb4cf5-c058-49ea-93f8-4f4e6c877fcd" providerId="AD" clId="Web-{3F2DC830-A1A1-7092-58FC-5A413FFEA2FC}" dt="2024-11-19T15:53:08.766" v="143" actId="14100"/>
        <pc:sldMkLst>
          <pc:docMk/>
          <pc:sldMk cId="890179914" sldId="276"/>
        </pc:sldMkLst>
        <pc:spChg chg="mod">
          <ac:chgData name="Belaid, Sirine" userId="S::belaids@upmc.edu::5dcb4cf5-c058-49ea-93f8-4f4e6c877fcd" providerId="AD" clId="Web-{3F2DC830-A1A1-7092-58FC-5A413FFEA2FC}" dt="2024-11-19T15:52:03.233" v="133" actId="20577"/>
          <ac:spMkLst>
            <pc:docMk/>
            <pc:sldMk cId="890179914" sldId="276"/>
            <ac:spMk id="2" creationId="{4111335E-0275-7F85-1A60-B2E9C5BFCB5E}"/>
          </ac:spMkLst>
        </pc:spChg>
        <pc:picChg chg="add mod">
          <ac:chgData name="Belaid, Sirine" userId="S::belaids@upmc.edu::5dcb4cf5-c058-49ea-93f8-4f4e6c877fcd" providerId="AD" clId="Web-{3F2DC830-A1A1-7092-58FC-5A413FFEA2FC}" dt="2024-11-19T15:53:04.938" v="142" actId="1076"/>
          <ac:picMkLst>
            <pc:docMk/>
            <pc:sldMk cId="890179914" sldId="276"/>
            <ac:picMk id="4" creationId="{9CA5B310-D03A-7329-33CD-95586F092B1B}"/>
          </ac:picMkLst>
        </pc:picChg>
        <pc:picChg chg="add mod">
          <ac:chgData name="Belaid, Sirine" userId="S::belaids@upmc.edu::5dcb4cf5-c058-49ea-93f8-4f4e6c877fcd" providerId="AD" clId="Web-{3F2DC830-A1A1-7092-58FC-5A413FFEA2FC}" dt="2024-11-19T15:53:08.766" v="143" actId="14100"/>
          <ac:picMkLst>
            <pc:docMk/>
            <pc:sldMk cId="890179914" sldId="276"/>
            <ac:picMk id="5" creationId="{4A8D6F5F-34DB-D300-210A-6B40BA20F752}"/>
          </ac:picMkLst>
        </pc:picChg>
      </pc:sldChg>
      <pc:sldChg chg="addSp delSp modSp new">
        <pc:chgData name="Belaid, Sirine" userId="S::belaids@upmc.edu::5dcb4cf5-c058-49ea-93f8-4f4e6c877fcd" providerId="AD" clId="Web-{3F2DC830-A1A1-7092-58FC-5A413FFEA2FC}" dt="2024-11-19T18:02:54.368" v="1468" actId="20577"/>
        <pc:sldMkLst>
          <pc:docMk/>
          <pc:sldMk cId="2737701447" sldId="277"/>
        </pc:sldMkLst>
        <pc:spChg chg="mod">
          <ac:chgData name="Belaid, Sirine" userId="S::belaids@upmc.edu::5dcb4cf5-c058-49ea-93f8-4f4e6c877fcd" providerId="AD" clId="Web-{3F2DC830-A1A1-7092-58FC-5A413FFEA2FC}" dt="2024-11-19T18:02:54.368" v="1468" actId="20577"/>
          <ac:spMkLst>
            <pc:docMk/>
            <pc:sldMk cId="2737701447" sldId="277"/>
            <ac:spMk id="2" creationId="{3B54EFCF-191A-6287-E565-C9AC7EAFA3A6}"/>
          </ac:spMkLst>
        </pc:spChg>
        <pc:picChg chg="add mod">
          <ac:chgData name="Belaid, Sirine" userId="S::belaids@upmc.edu::5dcb4cf5-c058-49ea-93f8-4f4e6c877fcd" providerId="AD" clId="Web-{3F2DC830-A1A1-7092-58FC-5A413FFEA2FC}" dt="2024-11-19T16:41:14.124" v="219" actId="1076"/>
          <ac:picMkLst>
            <pc:docMk/>
            <pc:sldMk cId="2737701447" sldId="277"/>
            <ac:picMk id="4" creationId="{EB09960A-C6BF-FCA2-9E9D-924DCF628229}"/>
          </ac:picMkLst>
        </pc:picChg>
        <pc:picChg chg="add mod">
          <ac:chgData name="Belaid, Sirine" userId="S::belaids@upmc.edu::5dcb4cf5-c058-49ea-93f8-4f4e6c877fcd" providerId="AD" clId="Web-{3F2DC830-A1A1-7092-58FC-5A413FFEA2FC}" dt="2024-11-19T16:35:48.829" v="198" actId="1076"/>
          <ac:picMkLst>
            <pc:docMk/>
            <pc:sldMk cId="2737701447" sldId="277"/>
            <ac:picMk id="5" creationId="{1E0460D6-FEFB-2DA3-0F87-6FA17228C78D}"/>
          </ac:picMkLst>
        </pc:picChg>
        <pc:picChg chg="add mod">
          <ac:chgData name="Belaid, Sirine" userId="S::belaids@upmc.edu::5dcb4cf5-c058-49ea-93f8-4f4e6c877fcd" providerId="AD" clId="Web-{3F2DC830-A1A1-7092-58FC-5A413FFEA2FC}" dt="2024-11-19T16:39:21.229" v="211" actId="1076"/>
          <ac:picMkLst>
            <pc:docMk/>
            <pc:sldMk cId="2737701447" sldId="277"/>
            <ac:picMk id="6" creationId="{395BE260-6AD7-CFCD-F3E8-16A2EC444A42}"/>
          </ac:picMkLst>
        </pc:picChg>
        <pc:picChg chg="add mod">
          <ac:chgData name="Belaid, Sirine" userId="S::belaids@upmc.edu::5dcb4cf5-c058-49ea-93f8-4f4e6c877fcd" providerId="AD" clId="Web-{3F2DC830-A1A1-7092-58FC-5A413FFEA2FC}" dt="2024-11-19T16:40:18.528" v="213" actId="1076"/>
          <ac:picMkLst>
            <pc:docMk/>
            <pc:sldMk cId="2737701447" sldId="277"/>
            <ac:picMk id="7" creationId="{4CB0D616-5E4B-6E5F-C929-7FC16D45248F}"/>
          </ac:picMkLst>
        </pc:picChg>
      </pc:sldChg>
      <pc:sldChg chg="addSp delSp modSp new">
        <pc:chgData name="Belaid, Sirine" userId="S::belaids@upmc.edu::5dcb4cf5-c058-49ea-93f8-4f4e6c877fcd" providerId="AD" clId="Web-{3F2DC830-A1A1-7092-58FC-5A413FFEA2FC}" dt="2024-11-19T18:02:46.445" v="1465" actId="20577"/>
        <pc:sldMkLst>
          <pc:docMk/>
          <pc:sldMk cId="3040203494" sldId="278"/>
        </pc:sldMkLst>
        <pc:spChg chg="mod">
          <ac:chgData name="Belaid, Sirine" userId="S::belaids@upmc.edu::5dcb4cf5-c058-49ea-93f8-4f4e6c877fcd" providerId="AD" clId="Web-{3F2DC830-A1A1-7092-58FC-5A413FFEA2FC}" dt="2024-11-19T18:02:46.445" v="1465" actId="20577"/>
          <ac:spMkLst>
            <pc:docMk/>
            <pc:sldMk cId="3040203494" sldId="278"/>
            <ac:spMk id="2" creationId="{7EF46163-41C0-84F5-5AA7-1C10CAB73748}"/>
          </ac:spMkLst>
        </pc:spChg>
        <pc:picChg chg="add mod">
          <ac:chgData name="Belaid, Sirine" userId="S::belaids@upmc.edu::5dcb4cf5-c058-49ea-93f8-4f4e6c877fcd" providerId="AD" clId="Web-{3F2DC830-A1A1-7092-58FC-5A413FFEA2FC}" dt="2024-11-19T16:40:38.341" v="214" actId="1076"/>
          <ac:picMkLst>
            <pc:docMk/>
            <pc:sldMk cId="3040203494" sldId="278"/>
            <ac:picMk id="4" creationId="{2E5E6F8F-2001-B58C-04D3-3E9446529007}"/>
          </ac:picMkLst>
        </pc:picChg>
        <pc:picChg chg="add mod">
          <ac:chgData name="Belaid, Sirine" userId="S::belaids@upmc.edu::5dcb4cf5-c058-49ea-93f8-4f4e6c877fcd" providerId="AD" clId="Web-{3F2DC830-A1A1-7092-58FC-5A413FFEA2FC}" dt="2024-11-19T16:40:52.045" v="218" actId="1076"/>
          <ac:picMkLst>
            <pc:docMk/>
            <pc:sldMk cId="3040203494" sldId="278"/>
            <ac:picMk id="5" creationId="{55E18AF8-C29D-D359-1718-D4962B624461}"/>
          </ac:picMkLst>
        </pc:picChg>
        <pc:picChg chg="add mod">
          <ac:chgData name="Belaid, Sirine" userId="S::belaids@upmc.edu::5dcb4cf5-c058-49ea-93f8-4f4e6c877fcd" providerId="AD" clId="Web-{3F2DC830-A1A1-7092-58FC-5A413FFEA2FC}" dt="2024-11-19T16:40:50.264" v="217" actId="1076"/>
          <ac:picMkLst>
            <pc:docMk/>
            <pc:sldMk cId="3040203494" sldId="278"/>
            <ac:picMk id="6" creationId="{D6EBE4EA-0D21-7864-4E0F-865BFE58FC88}"/>
          </ac:picMkLst>
        </pc:picChg>
      </pc:sldChg>
      <pc:sldChg chg="addSp delSp modSp new">
        <pc:chgData name="Belaid, Sirine" userId="S::belaids@upmc.edu::5dcb4cf5-c058-49ea-93f8-4f4e6c877fcd" providerId="AD" clId="Web-{3F2DC830-A1A1-7092-58FC-5A413FFEA2FC}" dt="2024-11-19T19:01:08.819" v="1847" actId="1076"/>
        <pc:sldMkLst>
          <pc:docMk/>
          <pc:sldMk cId="1691135755" sldId="279"/>
        </pc:sldMkLst>
        <pc:spChg chg="mod">
          <ac:chgData name="Belaid, Sirine" userId="S::belaids@upmc.edu::5dcb4cf5-c058-49ea-93f8-4f4e6c877fcd" providerId="AD" clId="Web-{3F2DC830-A1A1-7092-58FC-5A413FFEA2FC}" dt="2024-11-19T19:01:08.819" v="1847" actId="1076"/>
          <ac:spMkLst>
            <pc:docMk/>
            <pc:sldMk cId="1691135755" sldId="279"/>
            <ac:spMk id="2" creationId="{7ADAE76A-E90F-16DD-E8F0-6521F5FFBD56}"/>
          </ac:spMkLst>
        </pc:spChg>
        <pc:spChg chg="mod">
          <ac:chgData name="Belaid, Sirine" userId="S::belaids@upmc.edu::5dcb4cf5-c058-49ea-93f8-4f4e6c877fcd" providerId="AD" clId="Web-{3F2DC830-A1A1-7092-58FC-5A413FFEA2FC}" dt="2024-11-19T19:01:04.740" v="1846" actId="1076"/>
          <ac:spMkLst>
            <pc:docMk/>
            <pc:sldMk cId="1691135755" sldId="279"/>
            <ac:spMk id="3" creationId="{40154E4A-504B-F285-191C-FC2B0F11F3E3}"/>
          </ac:spMkLst>
        </pc:spChg>
        <pc:picChg chg="add mod">
          <ac:chgData name="Belaid, Sirine" userId="S::belaids@upmc.edu::5dcb4cf5-c058-49ea-93f8-4f4e6c877fcd" providerId="AD" clId="Web-{3F2DC830-A1A1-7092-58FC-5A413FFEA2FC}" dt="2024-11-19T17:57:45.714" v="1373" actId="1076"/>
          <ac:picMkLst>
            <pc:docMk/>
            <pc:sldMk cId="1691135755" sldId="279"/>
            <ac:picMk id="7" creationId="{1EAC6257-F9E8-3BF4-F995-1D9310AA4073}"/>
          </ac:picMkLst>
        </pc:picChg>
      </pc:sldChg>
      <pc:sldChg chg="addSp delSp modSp new">
        <pc:chgData name="Belaid, Sirine" userId="S::belaids@upmc.edu::5dcb4cf5-c058-49ea-93f8-4f4e6c877fcd" providerId="AD" clId="Web-{3F2DC830-A1A1-7092-58FC-5A413FFEA2FC}" dt="2024-11-19T19:01:25.960" v="1850" actId="1076"/>
        <pc:sldMkLst>
          <pc:docMk/>
          <pc:sldMk cId="2334828839" sldId="280"/>
        </pc:sldMkLst>
        <pc:spChg chg="mod">
          <ac:chgData name="Belaid, Sirine" userId="S::belaids@upmc.edu::5dcb4cf5-c058-49ea-93f8-4f4e6c877fcd" providerId="AD" clId="Web-{3F2DC830-A1A1-7092-58FC-5A413FFEA2FC}" dt="2024-11-19T19:01:25.960" v="1850" actId="1076"/>
          <ac:spMkLst>
            <pc:docMk/>
            <pc:sldMk cId="2334828839" sldId="280"/>
            <ac:spMk id="2" creationId="{7B0CDAA9-25AE-B069-7EC7-77A005C3B358}"/>
          </ac:spMkLst>
        </pc:spChg>
        <pc:spChg chg="add mod">
          <ac:chgData name="Belaid, Sirine" userId="S::belaids@upmc.edu::5dcb4cf5-c058-49ea-93f8-4f4e6c877fcd" providerId="AD" clId="Web-{3F2DC830-A1A1-7092-58FC-5A413FFEA2FC}" dt="2024-11-19T17:43:59.084" v="1160" actId="1076"/>
          <ac:spMkLst>
            <pc:docMk/>
            <pc:sldMk cId="2334828839" sldId="280"/>
            <ac:spMk id="4" creationId="{D1BCFB39-CF04-FACC-1188-03C1357FB1F6}"/>
          </ac:spMkLst>
        </pc:spChg>
        <pc:spChg chg="add mod">
          <ac:chgData name="Belaid, Sirine" userId="S::belaids@upmc.edu::5dcb4cf5-c058-49ea-93f8-4f4e6c877fcd" providerId="AD" clId="Web-{3F2DC830-A1A1-7092-58FC-5A413FFEA2FC}" dt="2024-11-19T17:45:13.228" v="1164" actId="20577"/>
          <ac:spMkLst>
            <pc:docMk/>
            <pc:sldMk cId="2334828839" sldId="280"/>
            <ac:spMk id="8" creationId="{BB0D772D-D99B-C49D-9E5F-43EFC2F0F2CB}"/>
          </ac:spMkLst>
        </pc:spChg>
      </pc:sldChg>
      <pc:sldChg chg="addSp delSp modSp new">
        <pc:chgData name="Belaid, Sirine" userId="S::belaids@upmc.edu::5dcb4cf5-c058-49ea-93f8-4f4e6c877fcd" providerId="AD" clId="Web-{3F2DC830-A1A1-7092-58FC-5A413FFEA2FC}" dt="2024-11-19T17:55:49.896" v="1327" actId="1076"/>
        <pc:sldMkLst>
          <pc:docMk/>
          <pc:sldMk cId="1811786192" sldId="281"/>
        </pc:sldMkLst>
        <pc:spChg chg="mod">
          <ac:chgData name="Belaid, Sirine" userId="S::belaids@upmc.edu::5dcb4cf5-c058-49ea-93f8-4f4e6c877fcd" providerId="AD" clId="Web-{3F2DC830-A1A1-7092-58FC-5A413FFEA2FC}" dt="2024-11-19T17:55:31.739" v="1323" actId="20577"/>
          <ac:spMkLst>
            <pc:docMk/>
            <pc:sldMk cId="1811786192" sldId="281"/>
            <ac:spMk id="3" creationId="{D68BC3AB-8ABB-9334-4030-19543AF9FAAE}"/>
          </ac:spMkLst>
        </pc:spChg>
        <pc:spChg chg="add mod">
          <ac:chgData name="Belaid, Sirine" userId="S::belaids@upmc.edu::5dcb4cf5-c058-49ea-93f8-4f4e6c877fcd" providerId="AD" clId="Web-{3F2DC830-A1A1-7092-58FC-5A413FFEA2FC}" dt="2024-11-19T17:52:58.373" v="1265" actId="1076"/>
          <ac:spMkLst>
            <pc:docMk/>
            <pc:sldMk cId="1811786192" sldId="281"/>
            <ac:spMk id="4" creationId="{B91A50B9-F3FA-EFE6-8ED6-40E75CF0009A}"/>
          </ac:spMkLst>
        </pc:spChg>
        <pc:spChg chg="add mod">
          <ac:chgData name="Belaid, Sirine" userId="S::belaids@upmc.edu::5dcb4cf5-c058-49ea-93f8-4f4e6c877fcd" providerId="AD" clId="Web-{3F2DC830-A1A1-7092-58FC-5A413FFEA2FC}" dt="2024-11-19T17:55:49.896" v="1327" actId="1076"/>
          <ac:spMkLst>
            <pc:docMk/>
            <pc:sldMk cId="1811786192" sldId="281"/>
            <ac:spMk id="5" creationId="{C415C56E-5949-157B-9D64-F3640484FC20}"/>
          </ac:spMkLst>
        </pc:spChg>
      </pc:sldChg>
      <pc:sldChg chg="modSp new del">
        <pc:chgData name="Belaid, Sirine" userId="S::belaids@upmc.edu::5dcb4cf5-c058-49ea-93f8-4f4e6c877fcd" providerId="AD" clId="Web-{3F2DC830-A1A1-7092-58FC-5A413FFEA2FC}" dt="2024-11-19T17:42:42.487" v="1148"/>
        <pc:sldMkLst>
          <pc:docMk/>
          <pc:sldMk cId="3116982130" sldId="281"/>
        </pc:sldMkLst>
      </pc:sldChg>
      <pc:sldChg chg="addSp delSp modSp new">
        <pc:chgData name="Belaid, Sirine" userId="S::belaids@upmc.edu::5dcb4cf5-c058-49ea-93f8-4f4e6c877fcd" providerId="AD" clId="Web-{3F2DC830-A1A1-7092-58FC-5A413FFEA2FC}" dt="2024-11-19T18:54:04.554" v="1577" actId="14100"/>
        <pc:sldMkLst>
          <pc:docMk/>
          <pc:sldMk cId="534894233" sldId="282"/>
        </pc:sldMkLst>
        <pc:spChg chg="mod">
          <ac:chgData name="Belaid, Sirine" userId="S::belaids@upmc.edu::5dcb4cf5-c058-49ea-93f8-4f4e6c877fcd" providerId="AD" clId="Web-{3F2DC830-A1A1-7092-58FC-5A413FFEA2FC}" dt="2024-11-19T18:02:17.819" v="1457" actId="20577"/>
          <ac:spMkLst>
            <pc:docMk/>
            <pc:sldMk cId="534894233" sldId="282"/>
            <ac:spMk id="2" creationId="{50F05A1E-7D68-690D-B86B-A196B57173EB}"/>
          </ac:spMkLst>
        </pc:spChg>
        <pc:spChg chg="mod">
          <ac:chgData name="Belaid, Sirine" userId="S::belaids@upmc.edu::5dcb4cf5-c058-49ea-93f8-4f4e6c877fcd" providerId="AD" clId="Web-{3F2DC830-A1A1-7092-58FC-5A413FFEA2FC}" dt="2024-11-19T18:01:45.536" v="1447" actId="1076"/>
          <ac:spMkLst>
            <pc:docMk/>
            <pc:sldMk cId="534894233" sldId="282"/>
            <ac:spMk id="3" creationId="{A1B7AAB6-BB61-7DFB-4D0F-445959B95253}"/>
          </ac:spMkLst>
        </pc:spChg>
        <pc:picChg chg="add mod">
          <ac:chgData name="Belaid, Sirine" userId="S::belaids@upmc.edu::5dcb4cf5-c058-49ea-93f8-4f4e6c877fcd" providerId="AD" clId="Web-{3F2DC830-A1A1-7092-58FC-5A413FFEA2FC}" dt="2024-11-19T18:01:37.380" v="1446" actId="14100"/>
          <ac:picMkLst>
            <pc:docMk/>
            <pc:sldMk cId="534894233" sldId="282"/>
            <ac:picMk id="6" creationId="{1317407D-2086-93D9-DF86-CB319101199B}"/>
          </ac:picMkLst>
        </pc:picChg>
        <pc:picChg chg="add mod">
          <ac:chgData name="Belaid, Sirine" userId="S::belaids@upmc.edu::5dcb4cf5-c058-49ea-93f8-4f4e6c877fcd" providerId="AD" clId="Web-{3F2DC830-A1A1-7092-58FC-5A413FFEA2FC}" dt="2024-11-19T18:54:04.554" v="1577" actId="14100"/>
          <ac:picMkLst>
            <pc:docMk/>
            <pc:sldMk cId="534894233" sldId="282"/>
            <ac:picMk id="7" creationId="{046213C4-A40F-67FD-2B8E-5264F73037CF}"/>
          </ac:picMkLst>
        </pc:picChg>
      </pc:sldChg>
      <pc:sldChg chg="addSp delSp modSp new">
        <pc:chgData name="Belaid, Sirine" userId="S::belaids@upmc.edu::5dcb4cf5-c058-49ea-93f8-4f4e6c877fcd" providerId="AD" clId="Web-{3F2DC830-A1A1-7092-58FC-5A413FFEA2FC}" dt="2024-11-19T19:01:47.945" v="1852" actId="1076"/>
        <pc:sldMkLst>
          <pc:docMk/>
          <pc:sldMk cId="3128388144" sldId="283"/>
        </pc:sldMkLst>
        <pc:spChg chg="mod">
          <ac:chgData name="Belaid, Sirine" userId="S::belaids@upmc.edu::5dcb4cf5-c058-49ea-93f8-4f4e6c877fcd" providerId="AD" clId="Web-{3F2DC830-A1A1-7092-58FC-5A413FFEA2FC}" dt="2024-11-19T18:50:41.797" v="1556" actId="1076"/>
          <ac:spMkLst>
            <pc:docMk/>
            <pc:sldMk cId="3128388144" sldId="283"/>
            <ac:spMk id="2" creationId="{ABCC8FD2-3CB9-27C5-CB16-C17FDA4CB338}"/>
          </ac:spMkLst>
        </pc:spChg>
        <pc:picChg chg="add mod">
          <ac:chgData name="Belaid, Sirine" userId="S::belaids@upmc.edu::5dcb4cf5-c058-49ea-93f8-4f4e6c877fcd" providerId="AD" clId="Web-{3F2DC830-A1A1-7092-58FC-5A413FFEA2FC}" dt="2024-11-19T19:01:42.476" v="1851" actId="1076"/>
          <ac:picMkLst>
            <pc:docMk/>
            <pc:sldMk cId="3128388144" sldId="283"/>
            <ac:picMk id="6" creationId="{C87D51B0-3545-EFC7-6C02-E5164A7C2C6A}"/>
          </ac:picMkLst>
        </pc:picChg>
        <pc:picChg chg="add mod">
          <ac:chgData name="Belaid, Sirine" userId="S::belaids@upmc.edu::5dcb4cf5-c058-49ea-93f8-4f4e6c877fcd" providerId="AD" clId="Web-{3F2DC830-A1A1-7092-58FC-5A413FFEA2FC}" dt="2024-11-19T18:51:32.080" v="1565" actId="1076"/>
          <ac:picMkLst>
            <pc:docMk/>
            <pc:sldMk cId="3128388144" sldId="283"/>
            <ac:picMk id="7" creationId="{1166902D-307A-5ABC-9A8A-90B4D2624A39}"/>
          </ac:picMkLst>
        </pc:picChg>
        <pc:picChg chg="add mod">
          <ac:chgData name="Belaid, Sirine" userId="S::belaids@upmc.edu::5dcb4cf5-c058-49ea-93f8-4f4e6c877fcd" providerId="AD" clId="Web-{3F2DC830-A1A1-7092-58FC-5A413FFEA2FC}" dt="2024-11-19T18:51:36.908" v="1566" actId="14100"/>
          <ac:picMkLst>
            <pc:docMk/>
            <pc:sldMk cId="3128388144" sldId="283"/>
            <ac:picMk id="8" creationId="{1FE0F9BA-1898-4744-5853-74C063ADF952}"/>
          </ac:picMkLst>
        </pc:picChg>
        <pc:picChg chg="add mod">
          <ac:chgData name="Belaid, Sirine" userId="S::belaids@upmc.edu::5dcb4cf5-c058-49ea-93f8-4f4e6c877fcd" providerId="AD" clId="Web-{3F2DC830-A1A1-7092-58FC-5A413FFEA2FC}" dt="2024-11-19T19:01:47.945" v="1852" actId="1076"/>
          <ac:picMkLst>
            <pc:docMk/>
            <pc:sldMk cId="3128388144" sldId="283"/>
            <ac:picMk id="9" creationId="{D243B4E3-EF28-5DD5-D258-97A257A7C4D2}"/>
          </ac:picMkLst>
        </pc:picChg>
      </pc:sldChg>
      <pc:sldChg chg="addSp modSp new mod modShow modNotes">
        <pc:chgData name="Belaid, Sirine" userId="S::belaids@upmc.edu::5dcb4cf5-c058-49ea-93f8-4f4e6c877fcd" providerId="AD" clId="Web-{3F2DC830-A1A1-7092-58FC-5A413FFEA2FC}" dt="2024-11-19T22:14:15.349" v="2744"/>
        <pc:sldMkLst>
          <pc:docMk/>
          <pc:sldMk cId="1929808205" sldId="284"/>
        </pc:sldMkLst>
        <pc:spChg chg="mod">
          <ac:chgData name="Belaid, Sirine" userId="S::belaids@upmc.edu::5dcb4cf5-c058-49ea-93f8-4f4e6c877fcd" providerId="AD" clId="Web-{3F2DC830-A1A1-7092-58FC-5A413FFEA2FC}" dt="2024-11-19T19:27:11.530" v="1959" actId="20577"/>
          <ac:spMkLst>
            <pc:docMk/>
            <pc:sldMk cId="1929808205" sldId="284"/>
            <ac:spMk id="2" creationId="{12FEC93E-BAE3-8E25-0A92-C71506366C6D}"/>
          </ac:spMkLst>
        </pc:spChg>
        <pc:spChg chg="mod">
          <ac:chgData name="Belaid, Sirine" userId="S::belaids@upmc.edu::5dcb4cf5-c058-49ea-93f8-4f4e6c877fcd" providerId="AD" clId="Web-{3F2DC830-A1A1-7092-58FC-5A413FFEA2FC}" dt="2024-11-19T22:06:54.677" v="2743" actId="14100"/>
          <ac:spMkLst>
            <pc:docMk/>
            <pc:sldMk cId="1929808205" sldId="284"/>
            <ac:spMk id="3" creationId="{58FCD493-5D8B-98D4-345B-FD2F49D6AADC}"/>
          </ac:spMkLst>
        </pc:spChg>
        <pc:graphicFrameChg chg="add mod modGraphic">
          <ac:chgData name="Belaid, Sirine" userId="S::belaids@upmc.edu::5dcb4cf5-c058-49ea-93f8-4f4e6c877fcd" providerId="AD" clId="Web-{3F2DC830-A1A1-7092-58FC-5A413FFEA2FC}" dt="2024-11-19T19:43:04.922" v="2196"/>
          <ac:graphicFrameMkLst>
            <pc:docMk/>
            <pc:sldMk cId="1929808205" sldId="284"/>
            <ac:graphicFrameMk id="5" creationId="{E1A37F6D-EC50-D8CE-8B6E-ACF516327FCA}"/>
          </ac:graphicFrameMkLst>
        </pc:graphicFrameChg>
      </pc:sldChg>
      <pc:sldChg chg="addSp modSp new">
        <pc:chgData name="Belaid, Sirine" userId="S::belaids@upmc.edu::5dcb4cf5-c058-49ea-93f8-4f4e6c877fcd" providerId="AD" clId="Web-{3F2DC830-A1A1-7092-58FC-5A413FFEA2FC}" dt="2024-11-19T18:46:01.178" v="1532" actId="14100"/>
        <pc:sldMkLst>
          <pc:docMk/>
          <pc:sldMk cId="117287384" sldId="285"/>
        </pc:sldMkLst>
        <pc:picChg chg="add mod">
          <ac:chgData name="Belaid, Sirine" userId="S::belaids@upmc.edu::5dcb4cf5-c058-49ea-93f8-4f4e6c877fcd" providerId="AD" clId="Web-{3F2DC830-A1A1-7092-58FC-5A413FFEA2FC}" dt="2024-11-19T18:45:51.568" v="1531" actId="1076"/>
          <ac:picMkLst>
            <pc:docMk/>
            <pc:sldMk cId="117287384" sldId="285"/>
            <ac:picMk id="2" creationId="{86838AB3-C8E3-0F7E-CC59-F2DC83FCD014}"/>
          </ac:picMkLst>
        </pc:picChg>
        <pc:picChg chg="add mod">
          <ac:chgData name="Belaid, Sirine" userId="S::belaids@upmc.edu::5dcb4cf5-c058-49ea-93f8-4f4e6c877fcd" providerId="AD" clId="Web-{3F2DC830-A1A1-7092-58FC-5A413FFEA2FC}" dt="2024-11-19T18:46:01.178" v="1532" actId="14100"/>
          <ac:picMkLst>
            <pc:docMk/>
            <pc:sldMk cId="117287384" sldId="285"/>
            <ac:picMk id="3" creationId="{E01BC16B-B2D4-BB1A-1FE4-F014A93C74D4}"/>
          </ac:picMkLst>
        </pc:picChg>
      </pc:sldChg>
      <pc:sldChg chg="modSp new">
        <pc:chgData name="Belaid, Sirine" userId="S::belaids@upmc.edu::5dcb4cf5-c058-49ea-93f8-4f4e6c877fcd" providerId="AD" clId="Web-{3F2DC830-A1A1-7092-58FC-5A413FFEA2FC}" dt="2024-11-19T18:55:23.729" v="1585" actId="20577"/>
        <pc:sldMkLst>
          <pc:docMk/>
          <pc:sldMk cId="1161013520" sldId="286"/>
        </pc:sldMkLst>
        <pc:spChg chg="mod">
          <ac:chgData name="Belaid, Sirine" userId="S::belaids@upmc.edu::5dcb4cf5-c058-49ea-93f8-4f4e6c877fcd" providerId="AD" clId="Web-{3F2DC830-A1A1-7092-58FC-5A413FFEA2FC}" dt="2024-11-19T18:55:23.729" v="1585" actId="20577"/>
          <ac:spMkLst>
            <pc:docMk/>
            <pc:sldMk cId="1161013520" sldId="286"/>
            <ac:spMk id="2" creationId="{3A60022D-BB98-C63F-C7FF-4BA03544345A}"/>
          </ac:spMkLst>
        </pc:spChg>
      </pc:sldChg>
      <pc:sldChg chg="modSp new">
        <pc:chgData name="Belaid, Sirine" userId="S::belaids@upmc.edu::5dcb4cf5-c058-49ea-93f8-4f4e6c877fcd" providerId="AD" clId="Web-{3F2DC830-A1A1-7092-58FC-5A413FFEA2FC}" dt="2024-11-20T03:25:59.687" v="2786" actId="20577"/>
        <pc:sldMkLst>
          <pc:docMk/>
          <pc:sldMk cId="931904134" sldId="287"/>
        </pc:sldMkLst>
        <pc:spChg chg="mod">
          <ac:chgData name="Belaid, Sirine" userId="S::belaids@upmc.edu::5dcb4cf5-c058-49ea-93f8-4f4e6c877fcd" providerId="AD" clId="Web-{3F2DC830-A1A1-7092-58FC-5A413FFEA2FC}" dt="2024-11-19T18:55:55.636" v="1596" actId="20577"/>
          <ac:spMkLst>
            <pc:docMk/>
            <pc:sldMk cId="931904134" sldId="287"/>
            <ac:spMk id="2" creationId="{3913824F-ECD1-10CA-7CE8-EE77DB7B4E4C}"/>
          </ac:spMkLst>
        </pc:spChg>
        <pc:spChg chg="mod">
          <ac:chgData name="Belaid, Sirine" userId="S::belaids@upmc.edu::5dcb4cf5-c058-49ea-93f8-4f4e6c877fcd" providerId="AD" clId="Web-{3F2DC830-A1A1-7092-58FC-5A413FFEA2FC}" dt="2024-11-20T03:25:59.687" v="2786" actId="20577"/>
          <ac:spMkLst>
            <pc:docMk/>
            <pc:sldMk cId="931904134" sldId="287"/>
            <ac:spMk id="3" creationId="{3DB2B855-1F64-5184-A62B-BB64F2950C59}"/>
          </ac:spMkLst>
        </pc:spChg>
      </pc:sldChg>
      <pc:sldChg chg="addSp modSp new ord">
        <pc:chgData name="Belaid, Sirine" userId="S::belaids@upmc.edu::5dcb4cf5-c058-49ea-93f8-4f4e6c877fcd" providerId="AD" clId="Web-{3F2DC830-A1A1-7092-58FC-5A413FFEA2FC}" dt="2024-11-20T17:25:19.105" v="4903" actId="1076"/>
        <pc:sldMkLst>
          <pc:docMk/>
          <pc:sldMk cId="2064663832" sldId="288"/>
        </pc:sldMkLst>
        <pc:spChg chg="add mod">
          <ac:chgData name="Belaid, Sirine" userId="S::belaids@upmc.edu::5dcb4cf5-c058-49ea-93f8-4f4e6c877fcd" providerId="AD" clId="Web-{3F2DC830-A1A1-7092-58FC-5A413FFEA2FC}" dt="2024-11-20T17:24:45.930" v="4896" actId="20577"/>
          <ac:spMkLst>
            <pc:docMk/>
            <pc:sldMk cId="2064663832" sldId="288"/>
            <ac:spMk id="4" creationId="{9FEA30E3-677C-4B49-0CA0-68676A816BFF}"/>
          </ac:spMkLst>
        </pc:spChg>
        <pc:spChg chg="add mod">
          <ac:chgData name="Belaid, Sirine" userId="S::belaids@upmc.edu::5dcb4cf5-c058-49ea-93f8-4f4e6c877fcd" providerId="AD" clId="Web-{3F2DC830-A1A1-7092-58FC-5A413FFEA2FC}" dt="2024-11-20T17:25:19.105" v="4903" actId="1076"/>
          <ac:spMkLst>
            <pc:docMk/>
            <pc:sldMk cId="2064663832" sldId="288"/>
            <ac:spMk id="6" creationId="{0E49BBB2-033B-6630-BF0B-B629A70FFCCE}"/>
          </ac:spMkLst>
        </pc:spChg>
        <pc:picChg chg="add mod">
          <ac:chgData name="Belaid, Sirine" userId="S::belaids@upmc.edu::5dcb4cf5-c058-49ea-93f8-4f4e6c877fcd" providerId="AD" clId="Web-{3F2DC830-A1A1-7092-58FC-5A413FFEA2FC}" dt="2024-11-20T17:24:32.913" v="4892" actId="1076"/>
          <ac:picMkLst>
            <pc:docMk/>
            <pc:sldMk cId="2064663832" sldId="288"/>
            <ac:picMk id="2" creationId="{D29F9914-125C-47D2-415A-9432AD406734}"/>
          </ac:picMkLst>
        </pc:picChg>
        <pc:picChg chg="add mod">
          <ac:chgData name="Belaid, Sirine" userId="S::belaids@upmc.edu::5dcb4cf5-c058-49ea-93f8-4f4e6c877fcd" providerId="AD" clId="Web-{3F2DC830-A1A1-7092-58FC-5A413FFEA2FC}" dt="2024-11-20T17:24:31.398" v="4891" actId="1076"/>
          <ac:picMkLst>
            <pc:docMk/>
            <pc:sldMk cId="2064663832" sldId="288"/>
            <ac:picMk id="3" creationId="{172995E9-8C6D-8F93-2D3D-40CE78594C48}"/>
          </ac:picMkLst>
        </pc:picChg>
      </pc:sldChg>
      <pc:sldChg chg="addSp modSp new ord">
        <pc:chgData name="Belaid, Sirine" userId="S::belaids@upmc.edu::5dcb4cf5-c058-49ea-93f8-4f4e6c877fcd" providerId="AD" clId="Web-{3F2DC830-A1A1-7092-58FC-5A413FFEA2FC}" dt="2024-11-20T17:26:42.486" v="4933" actId="14100"/>
        <pc:sldMkLst>
          <pc:docMk/>
          <pc:sldMk cId="1403967867" sldId="289"/>
        </pc:sldMkLst>
        <pc:spChg chg="add mod">
          <ac:chgData name="Belaid, Sirine" userId="S::belaids@upmc.edu::5dcb4cf5-c058-49ea-93f8-4f4e6c877fcd" providerId="AD" clId="Web-{3F2DC830-A1A1-7092-58FC-5A413FFEA2FC}" dt="2024-11-20T17:25:56.186" v="4914" actId="1076"/>
          <ac:spMkLst>
            <pc:docMk/>
            <pc:sldMk cId="1403967867" sldId="289"/>
            <ac:spMk id="5" creationId="{CF55DD2B-1D61-55B2-AC08-E7AAC805145C}"/>
          </ac:spMkLst>
        </pc:spChg>
        <pc:spChg chg="add mod">
          <ac:chgData name="Belaid, Sirine" userId="S::belaids@upmc.edu::5dcb4cf5-c058-49ea-93f8-4f4e6c877fcd" providerId="AD" clId="Web-{3F2DC830-A1A1-7092-58FC-5A413FFEA2FC}" dt="2024-11-20T17:26:42.486" v="4933" actId="14100"/>
          <ac:spMkLst>
            <pc:docMk/>
            <pc:sldMk cId="1403967867" sldId="289"/>
            <ac:spMk id="6" creationId="{68292658-3663-6BA4-20A7-448B238A1793}"/>
          </ac:spMkLst>
        </pc:spChg>
        <pc:picChg chg="add mod">
          <ac:chgData name="Belaid, Sirine" userId="S::belaids@upmc.edu::5dcb4cf5-c058-49ea-93f8-4f4e6c877fcd" providerId="AD" clId="Web-{3F2DC830-A1A1-7092-58FC-5A413FFEA2FC}" dt="2024-11-20T17:25:28.027" v="4905" actId="1076"/>
          <ac:picMkLst>
            <pc:docMk/>
            <pc:sldMk cId="1403967867" sldId="289"/>
            <ac:picMk id="2" creationId="{AC117B21-C236-3ABB-F877-A8D331F2008A}"/>
          </ac:picMkLst>
        </pc:picChg>
        <pc:picChg chg="add mod">
          <ac:chgData name="Belaid, Sirine" userId="S::belaids@upmc.edu::5dcb4cf5-c058-49ea-93f8-4f4e6c877fcd" providerId="AD" clId="Web-{3F2DC830-A1A1-7092-58FC-5A413FFEA2FC}" dt="2024-11-20T17:26:37.236" v="4932" actId="1076"/>
          <ac:picMkLst>
            <pc:docMk/>
            <pc:sldMk cId="1403967867" sldId="289"/>
            <ac:picMk id="3" creationId="{B4A33C0E-7390-E692-37EE-19AC15474356}"/>
          </ac:picMkLst>
        </pc:picChg>
      </pc:sldChg>
      <pc:sldChg chg="addSp modSp new ord">
        <pc:chgData name="Belaid, Sirine" userId="S::belaids@upmc.edu::5dcb4cf5-c058-49ea-93f8-4f4e6c877fcd" providerId="AD" clId="Web-{3F2DC830-A1A1-7092-58FC-5A413FFEA2FC}" dt="2024-11-20T17:27:52.210" v="4953" actId="1076"/>
        <pc:sldMkLst>
          <pc:docMk/>
          <pc:sldMk cId="1981928479" sldId="290"/>
        </pc:sldMkLst>
        <pc:spChg chg="add mod">
          <ac:chgData name="Belaid, Sirine" userId="S::belaids@upmc.edu::5dcb4cf5-c058-49ea-93f8-4f4e6c877fcd" providerId="AD" clId="Web-{3F2DC830-A1A1-7092-58FC-5A413FFEA2FC}" dt="2024-11-20T17:26:57.581" v="4938" actId="20577"/>
          <ac:spMkLst>
            <pc:docMk/>
            <pc:sldMk cId="1981928479" sldId="290"/>
            <ac:spMk id="5" creationId="{CC5422EA-4B02-0034-7C27-306656668FB0}"/>
          </ac:spMkLst>
        </pc:spChg>
        <pc:spChg chg="add mod">
          <ac:chgData name="Belaid, Sirine" userId="S::belaids@upmc.edu::5dcb4cf5-c058-49ea-93f8-4f4e6c877fcd" providerId="AD" clId="Web-{3F2DC830-A1A1-7092-58FC-5A413FFEA2FC}" dt="2024-11-20T17:27:50.179" v="4952" actId="1076"/>
          <ac:spMkLst>
            <pc:docMk/>
            <pc:sldMk cId="1981928479" sldId="290"/>
            <ac:spMk id="6" creationId="{C63AC20E-7038-E80A-DE5C-D04C25D8B883}"/>
          </ac:spMkLst>
        </pc:spChg>
        <pc:picChg chg="add mod">
          <ac:chgData name="Belaid, Sirine" userId="S::belaids@upmc.edu::5dcb4cf5-c058-49ea-93f8-4f4e6c877fcd" providerId="AD" clId="Web-{3F2DC830-A1A1-7092-58FC-5A413FFEA2FC}" dt="2024-11-20T17:27:02.972" v="4939" actId="1076"/>
          <ac:picMkLst>
            <pc:docMk/>
            <pc:sldMk cId="1981928479" sldId="290"/>
            <ac:picMk id="2" creationId="{B5C40716-89A1-2BD6-41B0-BC4107CF793A}"/>
          </ac:picMkLst>
        </pc:picChg>
        <pc:picChg chg="add mod">
          <ac:chgData name="Belaid, Sirine" userId="S::belaids@upmc.edu::5dcb4cf5-c058-49ea-93f8-4f4e6c877fcd" providerId="AD" clId="Web-{3F2DC830-A1A1-7092-58FC-5A413FFEA2FC}" dt="2024-11-20T17:27:52.210" v="4953" actId="1076"/>
          <ac:picMkLst>
            <pc:docMk/>
            <pc:sldMk cId="1981928479" sldId="290"/>
            <ac:picMk id="3" creationId="{591ED0AC-85B4-D879-E23B-E76699C1BBEC}"/>
          </ac:picMkLst>
        </pc:picChg>
      </pc:sldChg>
      <pc:sldChg chg="addSp modSp new ord">
        <pc:chgData name="Belaid, Sirine" userId="S::belaids@upmc.edu::5dcb4cf5-c058-49ea-93f8-4f4e6c877fcd" providerId="AD" clId="Web-{3F2DC830-A1A1-7092-58FC-5A413FFEA2FC}" dt="2024-11-20T03:42:41.683" v="2953"/>
        <pc:sldMkLst>
          <pc:docMk/>
          <pc:sldMk cId="1575805153" sldId="291"/>
        </pc:sldMkLst>
        <pc:picChg chg="add mod">
          <ac:chgData name="Belaid, Sirine" userId="S::belaids@upmc.edu::5dcb4cf5-c058-49ea-93f8-4f4e6c877fcd" providerId="AD" clId="Web-{3F2DC830-A1A1-7092-58FC-5A413FFEA2FC}" dt="2024-11-19T19:22:05.191" v="1888" actId="1076"/>
          <ac:picMkLst>
            <pc:docMk/>
            <pc:sldMk cId="1575805153" sldId="291"/>
            <ac:picMk id="2" creationId="{5A5AF7B2-F832-D154-7A42-A41BF70830E9}"/>
          </ac:picMkLst>
        </pc:picChg>
      </pc:sldChg>
      <pc:sldChg chg="addSp delSp modSp new ord modNotes">
        <pc:chgData name="Belaid, Sirine" userId="S::belaids@upmc.edu::5dcb4cf5-c058-49ea-93f8-4f4e6c877fcd" providerId="AD" clId="Web-{3F2DC830-A1A1-7092-58FC-5A413FFEA2FC}" dt="2024-11-20T18:01:49.823" v="5037"/>
        <pc:sldMkLst>
          <pc:docMk/>
          <pc:sldMk cId="707447650" sldId="292"/>
        </pc:sldMkLst>
        <pc:spChg chg="add mod">
          <ac:chgData name="Belaid, Sirine" userId="S::belaids@upmc.edu::5dcb4cf5-c058-49ea-93f8-4f4e6c877fcd" providerId="AD" clId="Web-{3F2DC830-A1A1-7092-58FC-5A413FFEA2FC}" dt="2024-11-20T17:49:23.124" v="4980" actId="20577"/>
          <ac:spMkLst>
            <pc:docMk/>
            <pc:sldMk cId="707447650" sldId="292"/>
            <ac:spMk id="4" creationId="{16D5F698-1466-B30B-5CE7-AC93819EA30B}"/>
          </ac:spMkLst>
        </pc:spChg>
        <pc:spChg chg="add del mod">
          <ac:chgData name="Belaid, Sirine" userId="S::belaids@upmc.edu::5dcb4cf5-c058-49ea-93f8-4f4e6c877fcd" providerId="AD" clId="Web-{3F2DC830-A1A1-7092-58FC-5A413FFEA2FC}" dt="2024-11-20T18:01:49.823" v="5037"/>
          <ac:spMkLst>
            <pc:docMk/>
            <pc:sldMk cId="707447650" sldId="292"/>
            <ac:spMk id="5" creationId="{56DA616B-395E-7053-B5B2-7523040B6492}"/>
          </ac:spMkLst>
        </pc:spChg>
        <pc:picChg chg="add mod">
          <ac:chgData name="Belaid, Sirine" userId="S::belaids@upmc.edu::5dcb4cf5-c058-49ea-93f8-4f4e6c877fcd" providerId="AD" clId="Web-{3F2DC830-A1A1-7092-58FC-5A413FFEA2FC}" dt="2024-11-19T19:23:43.757" v="1895" actId="1076"/>
          <ac:picMkLst>
            <pc:docMk/>
            <pc:sldMk cId="707447650" sldId="292"/>
            <ac:picMk id="2" creationId="{F5CD9B15-460F-21E8-6979-30102A6F2EA1}"/>
          </ac:picMkLst>
        </pc:picChg>
        <pc:picChg chg="add mod">
          <ac:chgData name="Belaid, Sirine" userId="S::belaids@upmc.edu::5dcb4cf5-c058-49ea-93f8-4f4e6c877fcd" providerId="AD" clId="Web-{3F2DC830-A1A1-7092-58FC-5A413FFEA2FC}" dt="2024-11-19T19:23:45.022" v="1896" actId="1076"/>
          <ac:picMkLst>
            <pc:docMk/>
            <pc:sldMk cId="707447650" sldId="292"/>
            <ac:picMk id="3" creationId="{595D8CA0-EC01-5C10-7C2F-1674E932BC2B}"/>
          </ac:picMkLst>
        </pc:picChg>
      </pc:sldChg>
      <pc:sldChg chg="add del">
        <pc:chgData name="Belaid, Sirine" userId="S::belaids@upmc.edu::5dcb4cf5-c058-49ea-93f8-4f4e6c877fcd" providerId="AD" clId="Web-{3F2DC830-A1A1-7092-58FC-5A413FFEA2FC}" dt="2024-11-19T19:29:03.127" v="1984"/>
        <pc:sldMkLst>
          <pc:docMk/>
          <pc:sldMk cId="1328231281" sldId="293"/>
        </pc:sldMkLst>
      </pc:sldChg>
      <pc:sldChg chg="new">
        <pc:chgData name="Belaid, Sirine" userId="S::belaids@upmc.edu::5dcb4cf5-c058-49ea-93f8-4f4e6c877fcd" providerId="AD" clId="Web-{3F2DC830-A1A1-7092-58FC-5A413FFEA2FC}" dt="2024-11-19T19:33:46.778" v="2067"/>
        <pc:sldMkLst>
          <pc:docMk/>
          <pc:sldMk cId="2531899748" sldId="293"/>
        </pc:sldMkLst>
      </pc:sldChg>
      <pc:sldChg chg="new">
        <pc:chgData name="Belaid, Sirine" userId="S::belaids@upmc.edu::5dcb4cf5-c058-49ea-93f8-4f4e6c877fcd" providerId="AD" clId="Web-{3F2DC830-A1A1-7092-58FC-5A413FFEA2FC}" dt="2024-11-19T19:33:49.715" v="2068"/>
        <pc:sldMkLst>
          <pc:docMk/>
          <pc:sldMk cId="3594639168" sldId="294"/>
        </pc:sldMkLst>
      </pc:sldChg>
      <pc:sldChg chg="add del">
        <pc:chgData name="Belaid, Sirine" userId="S::belaids@upmc.edu::5dcb4cf5-c058-49ea-93f8-4f4e6c877fcd" providerId="AD" clId="Web-{3F2DC830-A1A1-7092-58FC-5A413FFEA2FC}" dt="2024-11-19T20:36:13.999" v="2240"/>
        <pc:sldMkLst>
          <pc:docMk/>
          <pc:sldMk cId="0" sldId="316"/>
        </pc:sldMkLst>
      </pc:sldChg>
      <pc:sldChg chg="add del">
        <pc:chgData name="Belaid, Sirine" userId="S::belaids@upmc.edu::5dcb4cf5-c058-49ea-93f8-4f4e6c877fcd" providerId="AD" clId="Web-{3F2DC830-A1A1-7092-58FC-5A413FFEA2FC}" dt="2024-11-19T19:35:24.250" v="2078"/>
        <pc:sldMkLst>
          <pc:docMk/>
          <pc:sldMk cId="0" sldId="323"/>
        </pc:sldMkLst>
      </pc:sldChg>
      <pc:sldChg chg="add del">
        <pc:chgData name="Belaid, Sirine" userId="S::belaids@upmc.edu::5dcb4cf5-c058-49ea-93f8-4f4e6c877fcd" providerId="AD" clId="Web-{3F2DC830-A1A1-7092-58FC-5A413FFEA2FC}" dt="2024-11-19T19:35:21.093" v="2077"/>
        <pc:sldMkLst>
          <pc:docMk/>
          <pc:sldMk cId="692425481" sldId="324"/>
        </pc:sldMkLst>
      </pc:sldChg>
      <pc:sldChg chg="delSp modSp add mod ord modShow modNotes">
        <pc:chgData name="Belaid, Sirine" userId="S::belaids@upmc.edu::5dcb4cf5-c058-49ea-93f8-4f4e6c877fcd" providerId="AD" clId="Web-{3F2DC830-A1A1-7092-58FC-5A413FFEA2FC}" dt="2024-11-20T15:27:16.071" v="4197"/>
        <pc:sldMkLst>
          <pc:docMk/>
          <pc:sldMk cId="0" sldId="349"/>
        </pc:sldMkLst>
        <pc:spChg chg="mod">
          <ac:chgData name="Belaid, Sirine" userId="S::belaids@upmc.edu::5dcb4cf5-c058-49ea-93f8-4f4e6c877fcd" providerId="AD" clId="Web-{3F2DC830-A1A1-7092-58FC-5A413FFEA2FC}" dt="2024-11-19T20:36:11.921" v="2239" actId="20577"/>
          <ac:spMkLst>
            <pc:docMk/>
            <pc:sldMk cId="0" sldId="349"/>
            <ac:spMk id="39938" creationId="{D214F88E-9DF1-8AD6-98A0-22A817DFB03B}"/>
          </ac:spMkLst>
        </pc:spChg>
      </pc:sldChg>
      <pc:sldChg chg="modSp new del modNotes">
        <pc:chgData name="Belaid, Sirine" userId="S::belaids@upmc.edu::5dcb4cf5-c058-49ea-93f8-4f4e6c877fcd" providerId="AD" clId="Web-{3F2DC830-A1A1-7092-58FC-5A413FFEA2FC}" dt="2024-11-20T17:27:57.242" v="4954"/>
        <pc:sldMkLst>
          <pc:docMk/>
          <pc:sldMk cId="696136780" sldId="350"/>
        </pc:sldMkLst>
        <pc:spChg chg="mod">
          <ac:chgData name="Belaid, Sirine" userId="S::belaids@upmc.edu::5dcb4cf5-c058-49ea-93f8-4f4e6c877fcd" providerId="AD" clId="Web-{3F2DC830-A1A1-7092-58FC-5A413FFEA2FC}" dt="2024-11-20T01:54:22.808" v="2772" actId="20577"/>
          <ac:spMkLst>
            <pc:docMk/>
            <pc:sldMk cId="696136780" sldId="350"/>
            <ac:spMk id="2" creationId="{281A9956-28F5-D45B-CD98-9F7A9869B1E5}"/>
          </ac:spMkLst>
        </pc:spChg>
        <pc:spChg chg="mod">
          <ac:chgData name="Belaid, Sirine" userId="S::belaids@upmc.edu::5dcb4cf5-c058-49ea-93f8-4f4e6c877fcd" providerId="AD" clId="Web-{3F2DC830-A1A1-7092-58FC-5A413FFEA2FC}" dt="2024-11-20T17:23:15.032" v="4875" actId="20577"/>
          <ac:spMkLst>
            <pc:docMk/>
            <pc:sldMk cId="696136780" sldId="350"/>
            <ac:spMk id="3" creationId="{428BEFB3-B36B-7AF6-8373-E88BA61C016D}"/>
          </ac:spMkLst>
        </pc:spChg>
      </pc:sldChg>
      <pc:sldChg chg="addSp delSp modSp new modNotes">
        <pc:chgData name="Belaid, Sirine" userId="S::belaids@upmc.edu::5dcb4cf5-c058-49ea-93f8-4f4e6c877fcd" providerId="AD" clId="Web-{3F2DC830-A1A1-7092-58FC-5A413FFEA2FC}" dt="2024-11-20T03:56:15.551" v="3072" actId="20577"/>
        <pc:sldMkLst>
          <pc:docMk/>
          <pc:sldMk cId="3765036932" sldId="351"/>
        </pc:sldMkLst>
        <pc:spChg chg="mod">
          <ac:chgData name="Belaid, Sirine" userId="S::belaids@upmc.edu::5dcb4cf5-c058-49ea-93f8-4f4e6c877fcd" providerId="AD" clId="Web-{3F2DC830-A1A1-7092-58FC-5A413FFEA2FC}" dt="2024-11-20T03:42:07.103" v="2939" actId="20577"/>
          <ac:spMkLst>
            <pc:docMk/>
            <pc:sldMk cId="3765036932" sldId="351"/>
            <ac:spMk id="2" creationId="{C156F3B4-A8E7-4038-457E-13DE0860033B}"/>
          </ac:spMkLst>
        </pc:spChg>
        <pc:spChg chg="del mod">
          <ac:chgData name="Belaid, Sirine" userId="S::belaids@upmc.edu::5dcb4cf5-c058-49ea-93f8-4f4e6c877fcd" providerId="AD" clId="Web-{3F2DC830-A1A1-7092-58FC-5A413FFEA2FC}" dt="2024-11-20T03:50:48.576" v="2985"/>
          <ac:spMkLst>
            <pc:docMk/>
            <pc:sldMk cId="3765036932" sldId="351"/>
            <ac:spMk id="3" creationId="{6D14470D-CFC2-1FEB-1722-CC54B790DBCE}"/>
          </ac:spMkLst>
        </pc:spChg>
        <pc:spChg chg="add mod">
          <ac:chgData name="Belaid, Sirine" userId="S::belaids@upmc.edu::5dcb4cf5-c058-49ea-93f8-4f4e6c877fcd" providerId="AD" clId="Web-{3F2DC830-A1A1-7092-58FC-5A413FFEA2FC}" dt="2024-11-20T03:56:15.551" v="3072" actId="20577"/>
          <ac:spMkLst>
            <pc:docMk/>
            <pc:sldMk cId="3765036932" sldId="351"/>
            <ac:spMk id="5" creationId="{A92B86F5-FF6F-56F7-A149-E75340027B3E}"/>
          </ac:spMkLst>
        </pc:spChg>
        <pc:picChg chg="add mod ord">
          <ac:chgData name="Belaid, Sirine" userId="S::belaids@upmc.edu::5dcb4cf5-c058-49ea-93f8-4f4e6c877fcd" providerId="AD" clId="Web-{3F2DC830-A1A1-7092-58FC-5A413FFEA2FC}" dt="2024-11-20T03:50:59.483" v="2987" actId="1076"/>
          <ac:picMkLst>
            <pc:docMk/>
            <pc:sldMk cId="3765036932" sldId="351"/>
            <ac:picMk id="4" creationId="{6C8C619F-E4D2-6D36-A67E-0F3BB7B8FEF2}"/>
          </ac:picMkLst>
        </pc:picChg>
      </pc:sldChg>
      <pc:sldChg chg="modSp new modNotes">
        <pc:chgData name="Belaid, Sirine" userId="S::belaids@upmc.edu::5dcb4cf5-c058-49ea-93f8-4f4e6c877fcd" providerId="AD" clId="Web-{3F2DC830-A1A1-7092-58FC-5A413FFEA2FC}" dt="2024-11-20T05:13:46.469" v="3319" actId="20577"/>
        <pc:sldMkLst>
          <pc:docMk/>
          <pc:sldMk cId="4094227945" sldId="352"/>
        </pc:sldMkLst>
        <pc:spChg chg="mod">
          <ac:chgData name="Belaid, Sirine" userId="S::belaids@upmc.edu::5dcb4cf5-c058-49ea-93f8-4f4e6c877fcd" providerId="AD" clId="Web-{3F2DC830-A1A1-7092-58FC-5A413FFEA2FC}" dt="2024-11-20T03:42:13.103" v="2940" actId="20577"/>
          <ac:spMkLst>
            <pc:docMk/>
            <pc:sldMk cId="4094227945" sldId="352"/>
            <ac:spMk id="2" creationId="{4B33365C-6782-0662-DDB6-AA040DA89222}"/>
          </ac:spMkLst>
        </pc:spChg>
        <pc:spChg chg="mod">
          <ac:chgData name="Belaid, Sirine" userId="S::belaids@upmc.edu::5dcb4cf5-c058-49ea-93f8-4f4e6c877fcd" providerId="AD" clId="Web-{3F2DC830-A1A1-7092-58FC-5A413FFEA2FC}" dt="2024-11-20T05:13:46.469" v="3319" actId="20577"/>
          <ac:spMkLst>
            <pc:docMk/>
            <pc:sldMk cId="4094227945" sldId="352"/>
            <ac:spMk id="3" creationId="{54D52FF0-F483-CAD8-917A-930506D4F12A}"/>
          </ac:spMkLst>
        </pc:spChg>
      </pc:sldChg>
      <pc:sldChg chg="modSp new">
        <pc:chgData name="Belaid, Sirine" userId="S::belaids@upmc.edu::5dcb4cf5-c058-49ea-93f8-4f4e6c877fcd" providerId="AD" clId="Web-{3F2DC830-A1A1-7092-58FC-5A413FFEA2FC}" dt="2024-11-20T03:39:07.356" v="2862" actId="20577"/>
        <pc:sldMkLst>
          <pc:docMk/>
          <pc:sldMk cId="481006994" sldId="353"/>
        </pc:sldMkLst>
        <pc:spChg chg="mod">
          <ac:chgData name="Belaid, Sirine" userId="S::belaids@upmc.edu::5dcb4cf5-c058-49ea-93f8-4f4e6c877fcd" providerId="AD" clId="Web-{3F2DC830-A1A1-7092-58FC-5A413FFEA2FC}" dt="2024-11-20T03:39:07.356" v="2862" actId="20577"/>
          <ac:spMkLst>
            <pc:docMk/>
            <pc:sldMk cId="481006994" sldId="353"/>
            <ac:spMk id="2" creationId="{BE1AC552-72AD-DD2B-882E-695954EA90CC}"/>
          </ac:spMkLst>
        </pc:spChg>
      </pc:sldChg>
      <pc:sldChg chg="add del">
        <pc:chgData name="Belaid, Sirine" userId="S::belaids@upmc.edu::5dcb4cf5-c058-49ea-93f8-4f4e6c877fcd" providerId="AD" clId="Web-{3F2DC830-A1A1-7092-58FC-5A413FFEA2FC}" dt="2024-11-20T03:28:37.589" v="2829"/>
        <pc:sldMkLst>
          <pc:docMk/>
          <pc:sldMk cId="3404213581" sldId="353"/>
        </pc:sldMkLst>
      </pc:sldChg>
      <pc:sldChg chg="modSp new modNotes">
        <pc:chgData name="Belaid, Sirine" userId="S::belaids@upmc.edu::5dcb4cf5-c058-49ea-93f8-4f4e6c877fcd" providerId="AD" clId="Web-{3F2DC830-A1A1-7092-58FC-5A413FFEA2FC}" dt="2024-11-20T12:42:00.230" v="3775" actId="20577"/>
        <pc:sldMkLst>
          <pc:docMk/>
          <pc:sldMk cId="449566489" sldId="354"/>
        </pc:sldMkLst>
        <pc:spChg chg="mod">
          <ac:chgData name="Belaid, Sirine" userId="S::belaids@upmc.edu::5dcb4cf5-c058-49ea-93f8-4f4e6c877fcd" providerId="AD" clId="Web-{3F2DC830-A1A1-7092-58FC-5A413FFEA2FC}" dt="2024-11-20T03:42:36.464" v="2952" actId="20577"/>
          <ac:spMkLst>
            <pc:docMk/>
            <pc:sldMk cId="449566489" sldId="354"/>
            <ac:spMk id="2" creationId="{EFBAB475-6F9B-433D-8649-AD771C8CF814}"/>
          </ac:spMkLst>
        </pc:spChg>
        <pc:spChg chg="mod">
          <ac:chgData name="Belaid, Sirine" userId="S::belaids@upmc.edu::5dcb4cf5-c058-49ea-93f8-4f4e6c877fcd" providerId="AD" clId="Web-{3F2DC830-A1A1-7092-58FC-5A413FFEA2FC}" dt="2024-11-20T12:42:00.230" v="3775" actId="20577"/>
          <ac:spMkLst>
            <pc:docMk/>
            <pc:sldMk cId="449566489" sldId="354"/>
            <ac:spMk id="3" creationId="{777F2FD0-93E3-360A-DED8-59A3E5728BA8}"/>
          </ac:spMkLst>
        </pc:spChg>
      </pc:sldChg>
      <pc:sldChg chg="modSp new modNotes">
        <pc:chgData name="Belaid, Sirine" userId="S::belaids@upmc.edu::5dcb4cf5-c058-49ea-93f8-4f4e6c877fcd" providerId="AD" clId="Web-{3F2DC830-A1A1-7092-58FC-5A413FFEA2FC}" dt="2024-11-20T14:48:12.495" v="3898"/>
        <pc:sldMkLst>
          <pc:docMk/>
          <pc:sldMk cId="1022786307" sldId="355"/>
        </pc:sldMkLst>
        <pc:spChg chg="mod">
          <ac:chgData name="Belaid, Sirine" userId="S::belaids@upmc.edu::5dcb4cf5-c058-49ea-93f8-4f4e6c877fcd" providerId="AD" clId="Web-{3F2DC830-A1A1-7092-58FC-5A413FFEA2FC}" dt="2024-11-20T05:54:52.541" v="3765" actId="20577"/>
          <ac:spMkLst>
            <pc:docMk/>
            <pc:sldMk cId="1022786307" sldId="355"/>
            <ac:spMk id="2" creationId="{0EDE86FA-127C-32B5-5E79-B776E06C8F1C}"/>
          </ac:spMkLst>
        </pc:spChg>
        <pc:spChg chg="mod">
          <ac:chgData name="Belaid, Sirine" userId="S::belaids@upmc.edu::5dcb4cf5-c058-49ea-93f8-4f4e6c877fcd" providerId="AD" clId="Web-{3F2DC830-A1A1-7092-58FC-5A413FFEA2FC}" dt="2024-11-20T14:47:16.118" v="3886" actId="20577"/>
          <ac:spMkLst>
            <pc:docMk/>
            <pc:sldMk cId="1022786307" sldId="355"/>
            <ac:spMk id="3" creationId="{1C74E49B-EF04-8C3D-7D26-98DBD002E7B7}"/>
          </ac:spMkLst>
        </pc:spChg>
      </pc:sldChg>
      <pc:sldChg chg="modSp new del">
        <pc:chgData name="Belaid, Sirine" userId="S::belaids@upmc.edu::5dcb4cf5-c058-49ea-93f8-4f4e6c877fcd" providerId="AD" clId="Web-{3F2DC830-A1A1-7092-58FC-5A413FFEA2FC}" dt="2024-11-20T15:55:01.876" v="4475"/>
        <pc:sldMkLst>
          <pc:docMk/>
          <pc:sldMk cId="3989466077" sldId="356"/>
        </pc:sldMkLst>
        <pc:spChg chg="mod">
          <ac:chgData name="Belaid, Sirine" userId="S::belaids@upmc.edu::5dcb4cf5-c058-49ea-93f8-4f4e6c877fcd" providerId="AD" clId="Web-{3F2DC830-A1A1-7092-58FC-5A413FFEA2FC}" dt="2024-11-20T03:45:01.880" v="2976" actId="20577"/>
          <ac:spMkLst>
            <pc:docMk/>
            <pc:sldMk cId="3989466077" sldId="356"/>
            <ac:spMk id="2" creationId="{327C882B-58D0-56AF-38CE-B9C53F3C5535}"/>
          </ac:spMkLst>
        </pc:spChg>
      </pc:sldChg>
      <pc:sldChg chg="new del">
        <pc:chgData name="Belaid, Sirine" userId="S::belaids@upmc.edu::5dcb4cf5-c058-49ea-93f8-4f4e6c877fcd" providerId="AD" clId="Web-{3F2DC830-A1A1-7092-58FC-5A413FFEA2FC}" dt="2024-11-20T03:45:11.225" v="2977"/>
        <pc:sldMkLst>
          <pc:docMk/>
          <pc:sldMk cId="1035237256" sldId="357"/>
        </pc:sldMkLst>
      </pc:sldChg>
      <pc:sldChg chg="modSp new modNotes">
        <pc:chgData name="Belaid, Sirine" userId="S::belaids@upmc.edu::5dcb4cf5-c058-49ea-93f8-4f4e6c877fcd" providerId="AD" clId="Web-{3F2DC830-A1A1-7092-58FC-5A413FFEA2FC}" dt="2024-11-20T05:23:27.584" v="3336" actId="20577"/>
        <pc:sldMkLst>
          <pc:docMk/>
          <pc:sldMk cId="3868067760" sldId="357"/>
        </pc:sldMkLst>
        <pc:spChg chg="mod">
          <ac:chgData name="Belaid, Sirine" userId="S::belaids@upmc.edu::5dcb4cf5-c058-49ea-93f8-4f4e6c877fcd" providerId="AD" clId="Web-{3F2DC830-A1A1-7092-58FC-5A413FFEA2FC}" dt="2024-11-20T05:10:34.072" v="3279" actId="20577"/>
          <ac:spMkLst>
            <pc:docMk/>
            <pc:sldMk cId="3868067760" sldId="357"/>
            <ac:spMk id="2" creationId="{581FE4D8-97FC-9D5D-08B8-E3FD15466589}"/>
          </ac:spMkLst>
        </pc:spChg>
        <pc:spChg chg="mod">
          <ac:chgData name="Belaid, Sirine" userId="S::belaids@upmc.edu::5dcb4cf5-c058-49ea-93f8-4f4e6c877fcd" providerId="AD" clId="Web-{3F2DC830-A1A1-7092-58FC-5A413FFEA2FC}" dt="2024-11-20T05:23:27.584" v="3336" actId="20577"/>
          <ac:spMkLst>
            <pc:docMk/>
            <pc:sldMk cId="3868067760" sldId="357"/>
            <ac:spMk id="3" creationId="{C6C10584-5F60-48A3-BCF3-AF01322CF6C3}"/>
          </ac:spMkLst>
        </pc:spChg>
      </pc:sldChg>
      <pc:sldChg chg="modSp new">
        <pc:chgData name="Belaid, Sirine" userId="S::belaids@upmc.edu::5dcb4cf5-c058-49ea-93f8-4f4e6c877fcd" providerId="AD" clId="Web-{3F2DC830-A1A1-7092-58FC-5A413FFEA2FC}" dt="2024-11-20T17:07:20.395" v="4686" actId="20577"/>
        <pc:sldMkLst>
          <pc:docMk/>
          <pc:sldMk cId="3825394227" sldId="358"/>
        </pc:sldMkLst>
        <pc:spChg chg="mod">
          <ac:chgData name="Belaid, Sirine" userId="S::belaids@upmc.edu::5dcb4cf5-c058-49ea-93f8-4f4e6c877fcd" providerId="AD" clId="Web-{3F2DC830-A1A1-7092-58FC-5A413FFEA2FC}" dt="2024-11-20T05:30:18.383" v="3472" actId="20577"/>
          <ac:spMkLst>
            <pc:docMk/>
            <pc:sldMk cId="3825394227" sldId="358"/>
            <ac:spMk id="2" creationId="{8C250599-C153-7EDE-0470-823429B0D231}"/>
          </ac:spMkLst>
        </pc:spChg>
        <pc:spChg chg="mod">
          <ac:chgData name="Belaid, Sirine" userId="S::belaids@upmc.edu::5dcb4cf5-c058-49ea-93f8-4f4e6c877fcd" providerId="AD" clId="Web-{3F2DC830-A1A1-7092-58FC-5A413FFEA2FC}" dt="2024-11-20T17:07:20.395" v="4686" actId="20577"/>
          <ac:spMkLst>
            <pc:docMk/>
            <pc:sldMk cId="3825394227" sldId="358"/>
            <ac:spMk id="3" creationId="{4974952F-AF49-DE12-B0DE-612B936EDA11}"/>
          </ac:spMkLst>
        </pc:spChg>
      </pc:sldChg>
      <pc:sldChg chg="modSp new del">
        <pc:chgData name="Belaid, Sirine" userId="S::belaids@upmc.edu::5dcb4cf5-c058-49ea-93f8-4f4e6c877fcd" providerId="AD" clId="Web-{3F2DC830-A1A1-7092-58FC-5A413FFEA2FC}" dt="2024-11-20T17:57:59.414" v="5031"/>
        <pc:sldMkLst>
          <pc:docMk/>
          <pc:sldMk cId="3237139223" sldId="359"/>
        </pc:sldMkLst>
        <pc:spChg chg="mod">
          <ac:chgData name="Belaid, Sirine" userId="S::belaids@upmc.edu::5dcb4cf5-c058-49ea-93f8-4f4e6c877fcd" providerId="AD" clId="Web-{3F2DC830-A1A1-7092-58FC-5A413FFEA2FC}" dt="2024-11-20T05:26:57.608" v="3352" actId="20577"/>
          <ac:spMkLst>
            <pc:docMk/>
            <pc:sldMk cId="3237139223" sldId="359"/>
            <ac:spMk id="2" creationId="{C8477C20-E788-0128-615B-FFE41E525E3C}"/>
          </ac:spMkLst>
        </pc:spChg>
        <pc:spChg chg="mod">
          <ac:chgData name="Belaid, Sirine" userId="S::belaids@upmc.edu::5dcb4cf5-c058-49ea-93f8-4f4e6c877fcd" providerId="AD" clId="Web-{3F2DC830-A1A1-7092-58FC-5A413FFEA2FC}" dt="2024-11-20T15:56:21.566" v="4479" actId="20577"/>
          <ac:spMkLst>
            <pc:docMk/>
            <pc:sldMk cId="3237139223" sldId="359"/>
            <ac:spMk id="3" creationId="{C035C295-B680-4178-F656-C510CDA1CAC9}"/>
          </ac:spMkLst>
        </pc:spChg>
      </pc:sldChg>
      <pc:sldChg chg="modSp new modNotes">
        <pc:chgData name="Belaid, Sirine" userId="S::belaids@upmc.edu::5dcb4cf5-c058-49ea-93f8-4f4e6c877fcd" providerId="AD" clId="Web-{3F2DC830-A1A1-7092-58FC-5A413FFEA2FC}" dt="2024-11-20T15:54:49.266" v="4474" actId="20577"/>
        <pc:sldMkLst>
          <pc:docMk/>
          <pc:sldMk cId="1919480477" sldId="360"/>
        </pc:sldMkLst>
        <pc:spChg chg="mod">
          <ac:chgData name="Belaid, Sirine" userId="S::belaids@upmc.edu::5dcb4cf5-c058-49ea-93f8-4f4e6c877fcd" providerId="AD" clId="Web-{3F2DC830-A1A1-7092-58FC-5A413FFEA2FC}" dt="2024-11-20T15:36:22.495" v="4318" actId="20577"/>
          <ac:spMkLst>
            <pc:docMk/>
            <pc:sldMk cId="1919480477" sldId="360"/>
            <ac:spMk id="2" creationId="{F6D64424-A927-6867-0632-D218B464FCAA}"/>
          </ac:spMkLst>
        </pc:spChg>
        <pc:spChg chg="mod">
          <ac:chgData name="Belaid, Sirine" userId="S::belaids@upmc.edu::5dcb4cf5-c058-49ea-93f8-4f4e6c877fcd" providerId="AD" clId="Web-{3F2DC830-A1A1-7092-58FC-5A413FFEA2FC}" dt="2024-11-20T15:54:49.266" v="4474" actId="20577"/>
          <ac:spMkLst>
            <pc:docMk/>
            <pc:sldMk cId="1919480477" sldId="360"/>
            <ac:spMk id="3" creationId="{6CCD5ABF-F289-6DF4-D01E-776F3BB7441A}"/>
          </ac:spMkLst>
        </pc:spChg>
      </pc:sldChg>
      <pc:sldChg chg="modSp new modNotes">
        <pc:chgData name="Belaid, Sirine" userId="S::belaids@upmc.edu::5dcb4cf5-c058-49ea-93f8-4f4e6c877fcd" providerId="AD" clId="Web-{3F2DC830-A1A1-7092-58FC-5A413FFEA2FC}" dt="2024-11-20T17:13:30.018" v="4802" actId="20577"/>
        <pc:sldMkLst>
          <pc:docMk/>
          <pc:sldMk cId="2817742152" sldId="361"/>
        </pc:sldMkLst>
        <pc:spChg chg="mod">
          <ac:chgData name="Belaid, Sirine" userId="S::belaids@upmc.edu::5dcb4cf5-c058-49ea-93f8-4f4e6c877fcd" providerId="AD" clId="Web-{3F2DC830-A1A1-7092-58FC-5A413FFEA2FC}" dt="2024-11-20T12:54:37.095" v="3792" actId="20577"/>
          <ac:spMkLst>
            <pc:docMk/>
            <pc:sldMk cId="2817742152" sldId="361"/>
            <ac:spMk id="2" creationId="{66D00203-E8F5-1EE6-096A-DC9422B980E3}"/>
          </ac:spMkLst>
        </pc:spChg>
        <pc:spChg chg="mod">
          <ac:chgData name="Belaid, Sirine" userId="S::belaids@upmc.edu::5dcb4cf5-c058-49ea-93f8-4f4e6c877fcd" providerId="AD" clId="Web-{3F2DC830-A1A1-7092-58FC-5A413FFEA2FC}" dt="2024-11-20T17:13:30.018" v="4802" actId="20577"/>
          <ac:spMkLst>
            <pc:docMk/>
            <pc:sldMk cId="2817742152" sldId="361"/>
            <ac:spMk id="3" creationId="{B6FB2075-FE59-DFEA-3EE2-6A1D6EAFE127}"/>
          </ac:spMkLst>
        </pc:spChg>
      </pc:sldChg>
      <pc:sldChg chg="modSp new modNotes">
        <pc:chgData name="Belaid, Sirine" userId="S::belaids@upmc.edu::5dcb4cf5-c058-49ea-93f8-4f4e6c877fcd" providerId="AD" clId="Web-{3F2DC830-A1A1-7092-58FC-5A413FFEA2FC}" dt="2024-11-20T15:35:58.385" v="4308" actId="20577"/>
        <pc:sldMkLst>
          <pc:docMk/>
          <pc:sldMk cId="2090633080" sldId="362"/>
        </pc:sldMkLst>
        <pc:spChg chg="mod">
          <ac:chgData name="Belaid, Sirine" userId="S::belaids@upmc.edu::5dcb4cf5-c058-49ea-93f8-4f4e6c877fcd" providerId="AD" clId="Web-{3F2DC830-A1A1-7092-58FC-5A413FFEA2FC}" dt="2024-11-20T14:31:48.698" v="3848" actId="20577"/>
          <ac:spMkLst>
            <pc:docMk/>
            <pc:sldMk cId="2090633080" sldId="362"/>
            <ac:spMk id="2" creationId="{C48941FB-E149-0D2C-B85E-E5D47986915D}"/>
          </ac:spMkLst>
        </pc:spChg>
        <pc:spChg chg="mod">
          <ac:chgData name="Belaid, Sirine" userId="S::belaids@upmc.edu::5dcb4cf5-c058-49ea-93f8-4f4e6c877fcd" providerId="AD" clId="Web-{3F2DC830-A1A1-7092-58FC-5A413FFEA2FC}" dt="2024-11-20T15:35:58.385" v="4308" actId="20577"/>
          <ac:spMkLst>
            <pc:docMk/>
            <pc:sldMk cId="2090633080" sldId="362"/>
            <ac:spMk id="3" creationId="{7639CC8F-08C3-8406-49DC-53CA41C3EDD0}"/>
          </ac:spMkLst>
        </pc:spChg>
      </pc:sldChg>
      <pc:sldChg chg="modSp new del">
        <pc:chgData name="Belaid, Sirine" userId="S::belaids@upmc.edu::5dcb4cf5-c058-49ea-93f8-4f4e6c877fcd" providerId="AD" clId="Web-{3F2DC830-A1A1-7092-58FC-5A413FFEA2FC}" dt="2024-11-20T15:10:26.039" v="4003"/>
        <pc:sldMkLst>
          <pc:docMk/>
          <pc:sldMk cId="1461188139" sldId="363"/>
        </pc:sldMkLst>
        <pc:spChg chg="mod">
          <ac:chgData name="Belaid, Sirine" userId="S::belaids@upmc.edu::5dcb4cf5-c058-49ea-93f8-4f4e6c877fcd" providerId="AD" clId="Web-{3F2DC830-A1A1-7092-58FC-5A413FFEA2FC}" dt="2024-11-20T14:56:38.949" v="3951" actId="20577"/>
          <ac:spMkLst>
            <pc:docMk/>
            <pc:sldMk cId="1461188139" sldId="363"/>
            <ac:spMk id="2" creationId="{BB3B096C-58EC-512A-40FD-1CB4F0CBE808}"/>
          </ac:spMkLst>
        </pc:spChg>
      </pc:sldChg>
      <pc:sldChg chg="modSp new">
        <pc:chgData name="Belaid, Sirine" userId="S::belaids@upmc.edu::5dcb4cf5-c058-49ea-93f8-4f4e6c877fcd" providerId="AD" clId="Web-{3F2DC830-A1A1-7092-58FC-5A413FFEA2FC}" dt="2024-11-20T16:00:49.153" v="4562" actId="20577"/>
        <pc:sldMkLst>
          <pc:docMk/>
          <pc:sldMk cId="3864006159" sldId="363"/>
        </pc:sldMkLst>
        <pc:spChg chg="mod">
          <ac:chgData name="Belaid, Sirine" userId="S::belaids@upmc.edu::5dcb4cf5-c058-49ea-93f8-4f4e6c877fcd" providerId="AD" clId="Web-{3F2DC830-A1A1-7092-58FC-5A413FFEA2FC}" dt="2024-11-20T15:57:54.194" v="4489" actId="1076"/>
          <ac:spMkLst>
            <pc:docMk/>
            <pc:sldMk cId="3864006159" sldId="363"/>
            <ac:spMk id="2" creationId="{1E63AA7C-D8CC-24E2-1927-C63C14BF6FAB}"/>
          </ac:spMkLst>
        </pc:spChg>
        <pc:spChg chg="mod">
          <ac:chgData name="Belaid, Sirine" userId="S::belaids@upmc.edu::5dcb4cf5-c058-49ea-93f8-4f4e6c877fcd" providerId="AD" clId="Web-{3F2DC830-A1A1-7092-58FC-5A413FFEA2FC}" dt="2024-11-20T16:00:49.153" v="4562" actId="20577"/>
          <ac:spMkLst>
            <pc:docMk/>
            <pc:sldMk cId="3864006159" sldId="363"/>
            <ac:spMk id="3" creationId="{6B57145F-A3D4-5C8F-5BBE-CC4E7BC1E90B}"/>
          </ac:spMkLst>
        </pc:spChg>
      </pc:sldChg>
      <pc:sldChg chg="modSp add replId">
        <pc:chgData name="Belaid, Sirine" userId="S::belaids@upmc.edu::5dcb4cf5-c058-49ea-93f8-4f4e6c877fcd" providerId="AD" clId="Web-{3F2DC830-A1A1-7092-58FC-5A413FFEA2FC}" dt="2024-11-20T16:00:52.731" v="4565" actId="20577"/>
        <pc:sldMkLst>
          <pc:docMk/>
          <pc:sldMk cId="2414223819" sldId="364"/>
        </pc:sldMkLst>
        <pc:spChg chg="mod">
          <ac:chgData name="Belaid, Sirine" userId="S::belaids@upmc.edu::5dcb4cf5-c058-49ea-93f8-4f4e6c877fcd" providerId="AD" clId="Web-{3F2DC830-A1A1-7092-58FC-5A413FFEA2FC}" dt="2024-11-20T15:58:12.242" v="4493" actId="20577"/>
          <ac:spMkLst>
            <pc:docMk/>
            <pc:sldMk cId="2414223819" sldId="364"/>
            <ac:spMk id="2" creationId="{1E63AA7C-D8CC-24E2-1927-C63C14BF6FAB}"/>
          </ac:spMkLst>
        </pc:spChg>
        <pc:spChg chg="mod">
          <ac:chgData name="Belaid, Sirine" userId="S::belaids@upmc.edu::5dcb4cf5-c058-49ea-93f8-4f4e6c877fcd" providerId="AD" clId="Web-{3F2DC830-A1A1-7092-58FC-5A413FFEA2FC}" dt="2024-11-20T16:00:52.731" v="4565" actId="20577"/>
          <ac:spMkLst>
            <pc:docMk/>
            <pc:sldMk cId="2414223819" sldId="364"/>
            <ac:spMk id="3" creationId="{6B57145F-A3D4-5C8F-5BBE-CC4E7BC1E90B}"/>
          </ac:spMkLst>
        </pc:spChg>
      </pc:sldChg>
      <pc:sldChg chg="modSp add ord replId">
        <pc:chgData name="Belaid, Sirine" userId="S::belaids@upmc.edu::5dcb4cf5-c058-49ea-93f8-4f4e6c877fcd" providerId="AD" clId="Web-{3F2DC830-A1A1-7092-58FC-5A413FFEA2FC}" dt="2024-11-20T18:01:08.288" v="5032"/>
        <pc:sldMkLst>
          <pc:docMk/>
          <pc:sldMk cId="795419220" sldId="365"/>
        </pc:sldMkLst>
        <pc:spChg chg="mod">
          <ac:chgData name="Belaid, Sirine" userId="S::belaids@upmc.edu::5dcb4cf5-c058-49ea-93f8-4f4e6c877fcd" providerId="AD" clId="Web-{3F2DC830-A1A1-7092-58FC-5A413FFEA2FC}" dt="2024-11-20T15:59:29.885" v="4500" actId="20577"/>
          <ac:spMkLst>
            <pc:docMk/>
            <pc:sldMk cId="795419220" sldId="365"/>
            <ac:spMk id="2" creationId="{1E63AA7C-D8CC-24E2-1927-C63C14BF6FAB}"/>
          </ac:spMkLst>
        </pc:spChg>
        <pc:spChg chg="mod">
          <ac:chgData name="Belaid, Sirine" userId="S::belaids@upmc.edu::5dcb4cf5-c058-49ea-93f8-4f4e6c877fcd" providerId="AD" clId="Web-{3F2DC830-A1A1-7092-58FC-5A413FFEA2FC}" dt="2024-11-20T16:00:40.950" v="4559" actId="20577"/>
          <ac:spMkLst>
            <pc:docMk/>
            <pc:sldMk cId="795419220" sldId="365"/>
            <ac:spMk id="3" creationId="{6B57145F-A3D4-5C8F-5BBE-CC4E7BC1E90B}"/>
          </ac:spMkLst>
        </pc:spChg>
      </pc:sldChg>
      <pc:sldChg chg="modSp new modNotes">
        <pc:chgData name="Belaid, Sirine" userId="S::belaids@upmc.edu::5dcb4cf5-c058-49ea-93f8-4f4e6c877fcd" providerId="AD" clId="Web-{3F2DC830-A1A1-7092-58FC-5A413FFEA2FC}" dt="2024-11-20T17:04:35.679" v="4654" actId="20577"/>
        <pc:sldMkLst>
          <pc:docMk/>
          <pc:sldMk cId="2208660293" sldId="366"/>
        </pc:sldMkLst>
        <pc:spChg chg="mod">
          <ac:chgData name="Belaid, Sirine" userId="S::belaids@upmc.edu::5dcb4cf5-c058-49ea-93f8-4f4e6c877fcd" providerId="AD" clId="Web-{3F2DC830-A1A1-7092-58FC-5A413FFEA2FC}" dt="2024-11-20T16:15:17.807" v="4589" actId="20577"/>
          <ac:spMkLst>
            <pc:docMk/>
            <pc:sldMk cId="2208660293" sldId="366"/>
            <ac:spMk id="2" creationId="{2E8C5286-2E95-EDD7-150F-1FD524545EA1}"/>
          </ac:spMkLst>
        </pc:spChg>
        <pc:spChg chg="mod">
          <ac:chgData name="Belaid, Sirine" userId="S::belaids@upmc.edu::5dcb4cf5-c058-49ea-93f8-4f4e6c877fcd" providerId="AD" clId="Web-{3F2DC830-A1A1-7092-58FC-5A413FFEA2FC}" dt="2024-11-20T17:04:35.679" v="4654" actId="20577"/>
          <ac:spMkLst>
            <pc:docMk/>
            <pc:sldMk cId="2208660293" sldId="366"/>
            <ac:spMk id="3" creationId="{FC73AACB-7825-85D8-03D0-48CD572599F9}"/>
          </ac:spMkLst>
        </pc:spChg>
      </pc:sldChg>
      <pc:sldChg chg="modSp new">
        <pc:chgData name="Belaid, Sirine" userId="S::belaids@upmc.edu::5dcb4cf5-c058-49ea-93f8-4f4e6c877fcd" providerId="AD" clId="Web-{3F2DC830-A1A1-7092-58FC-5A413FFEA2FC}" dt="2024-11-20T17:06:00.092" v="4680" actId="20577"/>
        <pc:sldMkLst>
          <pc:docMk/>
          <pc:sldMk cId="3004633114" sldId="367"/>
        </pc:sldMkLst>
        <pc:spChg chg="mod">
          <ac:chgData name="Belaid, Sirine" userId="S::belaids@upmc.edu::5dcb4cf5-c058-49ea-93f8-4f4e6c877fcd" providerId="AD" clId="Web-{3F2DC830-A1A1-7092-58FC-5A413FFEA2FC}" dt="2024-11-20T17:05:03.556" v="4664" actId="20577"/>
          <ac:spMkLst>
            <pc:docMk/>
            <pc:sldMk cId="3004633114" sldId="367"/>
            <ac:spMk id="2" creationId="{E037B1A6-5DAA-0569-3233-BA14B35AED7B}"/>
          </ac:spMkLst>
        </pc:spChg>
        <pc:spChg chg="mod">
          <ac:chgData name="Belaid, Sirine" userId="S::belaids@upmc.edu::5dcb4cf5-c058-49ea-93f8-4f4e6c877fcd" providerId="AD" clId="Web-{3F2DC830-A1A1-7092-58FC-5A413FFEA2FC}" dt="2024-11-20T17:06:00.092" v="4680" actId="20577"/>
          <ac:spMkLst>
            <pc:docMk/>
            <pc:sldMk cId="3004633114" sldId="367"/>
            <ac:spMk id="3" creationId="{9AE938D2-B05F-4829-BA51-1B2B9A25680E}"/>
          </ac:spMkLst>
        </pc:spChg>
      </pc:sldChg>
      <pc:sldChg chg="modSp add modNotes">
        <pc:chgData name="Belaid, Sirine" userId="S::belaids@upmc.edu::5dcb4cf5-c058-49ea-93f8-4f4e6c877fcd" providerId="AD" clId="Web-{3F2DC830-A1A1-7092-58FC-5A413FFEA2FC}" dt="2024-11-20T17:23:42.503" v="4876"/>
        <pc:sldMkLst>
          <pc:docMk/>
          <pc:sldMk cId="1204613590" sldId="368"/>
        </pc:sldMkLst>
        <pc:graphicFrameChg chg="mod modGraphic">
          <ac:chgData name="Belaid, Sirine" userId="S::belaids@upmc.edu::5dcb4cf5-c058-49ea-93f8-4f4e6c877fcd" providerId="AD" clId="Web-{3F2DC830-A1A1-7092-58FC-5A413FFEA2FC}" dt="2024-11-20T17:20:39.958" v="4811" actId="20577"/>
          <ac:graphicFrameMkLst>
            <pc:docMk/>
            <pc:sldMk cId="1204613590" sldId="368"/>
            <ac:graphicFrameMk id="5" creationId="{23AF7966-5238-A790-88D7-3E2B2D408459}"/>
          </ac:graphicFrameMkLst>
        </pc:graphicFrameChg>
      </pc:sldChg>
      <pc:sldChg chg="new del">
        <pc:chgData name="Belaid, Sirine" userId="S::belaids@upmc.edu::5dcb4cf5-c058-49ea-93f8-4f4e6c877fcd" providerId="AD" clId="Web-{3F2DC830-A1A1-7092-58FC-5A413FFEA2FC}" dt="2024-11-20T18:02:24.779" v="5054"/>
        <pc:sldMkLst>
          <pc:docMk/>
          <pc:sldMk cId="2553474507" sldId="369"/>
        </pc:sldMkLst>
      </pc:sldChg>
      <pc:sldChg chg="modSp new">
        <pc:chgData name="Belaid, Sirine" userId="S::belaids@upmc.edu::5dcb4cf5-c058-49ea-93f8-4f4e6c877fcd" providerId="AD" clId="Web-{3F2DC830-A1A1-7092-58FC-5A413FFEA2FC}" dt="2024-11-20T18:05:34.590" v="5132" actId="20577"/>
        <pc:sldMkLst>
          <pc:docMk/>
          <pc:sldMk cId="13225285" sldId="370"/>
        </pc:sldMkLst>
        <pc:spChg chg="mod">
          <ac:chgData name="Belaid, Sirine" userId="S::belaids@upmc.edu::5dcb4cf5-c058-49ea-93f8-4f4e6c877fcd" providerId="AD" clId="Web-{3F2DC830-A1A1-7092-58FC-5A413FFEA2FC}" dt="2024-11-20T18:02:17.247" v="5050" actId="20577"/>
          <ac:spMkLst>
            <pc:docMk/>
            <pc:sldMk cId="13225285" sldId="370"/>
            <ac:spMk id="2" creationId="{390210F8-63D0-95C3-DEF9-3C8314A55FAA}"/>
          </ac:spMkLst>
        </pc:spChg>
        <pc:spChg chg="mod">
          <ac:chgData name="Belaid, Sirine" userId="S::belaids@upmc.edu::5dcb4cf5-c058-49ea-93f8-4f4e6c877fcd" providerId="AD" clId="Web-{3F2DC830-A1A1-7092-58FC-5A413FFEA2FC}" dt="2024-11-20T18:05:34.590" v="5132" actId="20577"/>
          <ac:spMkLst>
            <pc:docMk/>
            <pc:sldMk cId="13225285" sldId="370"/>
            <ac:spMk id="3" creationId="{5F301AD2-63C3-E004-C0F9-E2CADF494E6A}"/>
          </ac:spMkLst>
        </pc:spChg>
      </pc:sldChg>
    </pc:docChg>
  </pc:docChgLst>
  <pc:docChgLst>
    <pc:chgData name="Belaid, Sirine" userId="S::belaids@upmc.edu::5dcb4cf5-c058-49ea-93f8-4f4e6c877fcd" providerId="AD" clId="Web-{97271933-6BFD-84AA-6789-103D4E23045A}"/>
    <pc:docChg chg="modSld">
      <pc:chgData name="Belaid, Sirine" userId="S::belaids@upmc.edu::5dcb4cf5-c058-49ea-93f8-4f4e6c877fcd" providerId="AD" clId="Web-{97271933-6BFD-84AA-6789-103D4E23045A}" dt="2025-02-25T12:25:26.060" v="116"/>
      <pc:docMkLst>
        <pc:docMk/>
      </pc:docMkLst>
      <pc:sldChg chg="modNotes">
        <pc:chgData name="Belaid, Sirine" userId="S::belaids@upmc.edu::5dcb4cf5-c058-49ea-93f8-4f4e6c877fcd" providerId="AD" clId="Web-{97271933-6BFD-84AA-6789-103D4E23045A}" dt="2025-02-25T12:25:26.060" v="116"/>
        <pc:sldMkLst>
          <pc:docMk/>
          <pc:sldMk cId="1919480477" sldId="360"/>
        </pc:sldMkLst>
      </pc:sldChg>
    </pc:docChg>
  </pc:docChgLst>
  <pc:docChgLst>
    <pc:chgData name="Belaid, Sirine" userId="S::belaids@upmc.edu::5dcb4cf5-c058-49ea-93f8-4f4e6c877fcd" providerId="AD" clId="Web-{729B6B04-4D1A-AFD6-EC63-B48C8BDA2C58}"/>
    <pc:docChg chg="addSld delSld modSld sldOrd">
      <pc:chgData name="Belaid, Sirine" userId="S::belaids@upmc.edu::5dcb4cf5-c058-49ea-93f8-4f4e6c877fcd" providerId="AD" clId="Web-{729B6B04-4D1A-AFD6-EC63-B48C8BDA2C58}" dt="2024-12-29T20:17:12.084" v="503"/>
      <pc:docMkLst>
        <pc:docMk/>
      </pc:docMkLst>
      <pc:sldChg chg="modSp">
        <pc:chgData name="Belaid, Sirine" userId="S::belaids@upmc.edu::5dcb4cf5-c058-49ea-93f8-4f4e6c877fcd" providerId="AD" clId="Web-{729B6B04-4D1A-AFD6-EC63-B48C8BDA2C58}" dt="2024-12-29T17:48:54.966" v="247" actId="14100"/>
        <pc:sldMkLst>
          <pc:docMk/>
          <pc:sldMk cId="2064663832" sldId="288"/>
        </pc:sldMkLst>
        <pc:picChg chg="mod">
          <ac:chgData name="Belaid, Sirine" userId="S::belaids@upmc.edu::5dcb4cf5-c058-49ea-93f8-4f4e6c877fcd" providerId="AD" clId="Web-{729B6B04-4D1A-AFD6-EC63-B48C8BDA2C58}" dt="2024-12-29T17:48:54.966" v="247" actId="14100"/>
          <ac:picMkLst>
            <pc:docMk/>
            <pc:sldMk cId="2064663832" sldId="288"/>
            <ac:picMk id="2" creationId="{D29F9914-125C-47D2-415A-9432AD406734}"/>
          </ac:picMkLst>
        </pc:picChg>
      </pc:sldChg>
      <pc:sldChg chg="modSp">
        <pc:chgData name="Belaid, Sirine" userId="S::belaids@upmc.edu::5dcb4cf5-c058-49ea-93f8-4f4e6c877fcd" providerId="AD" clId="Web-{729B6B04-4D1A-AFD6-EC63-B48C8BDA2C58}" dt="2024-12-29T17:49:02.700" v="248" actId="14100"/>
        <pc:sldMkLst>
          <pc:docMk/>
          <pc:sldMk cId="1403967867" sldId="289"/>
        </pc:sldMkLst>
        <pc:picChg chg="mod">
          <ac:chgData name="Belaid, Sirine" userId="S::belaids@upmc.edu::5dcb4cf5-c058-49ea-93f8-4f4e6c877fcd" providerId="AD" clId="Web-{729B6B04-4D1A-AFD6-EC63-B48C8BDA2C58}" dt="2024-12-29T17:49:02.700" v="248" actId="14100"/>
          <ac:picMkLst>
            <pc:docMk/>
            <pc:sldMk cId="1403967867" sldId="289"/>
            <ac:picMk id="3" creationId="{B4A33C0E-7390-E692-37EE-19AC15474356}"/>
          </ac:picMkLst>
        </pc:picChg>
      </pc:sldChg>
      <pc:sldChg chg="modSp">
        <pc:chgData name="Belaid, Sirine" userId="S::belaids@upmc.edu::5dcb4cf5-c058-49ea-93f8-4f4e6c877fcd" providerId="AD" clId="Web-{729B6B04-4D1A-AFD6-EC63-B48C8BDA2C58}" dt="2024-12-29T17:49:17.685" v="253" actId="1076"/>
        <pc:sldMkLst>
          <pc:docMk/>
          <pc:sldMk cId="1981928479" sldId="290"/>
        </pc:sldMkLst>
        <pc:picChg chg="mod">
          <ac:chgData name="Belaid, Sirine" userId="S::belaids@upmc.edu::5dcb4cf5-c058-49ea-93f8-4f4e6c877fcd" providerId="AD" clId="Web-{729B6B04-4D1A-AFD6-EC63-B48C8BDA2C58}" dt="2024-12-29T17:49:17.685" v="253" actId="1076"/>
          <ac:picMkLst>
            <pc:docMk/>
            <pc:sldMk cId="1981928479" sldId="290"/>
            <ac:picMk id="3" creationId="{591ED0AC-85B4-D879-E23B-E76699C1BBEC}"/>
          </ac:picMkLst>
        </pc:picChg>
      </pc:sldChg>
      <pc:sldChg chg="modSp">
        <pc:chgData name="Belaid, Sirine" userId="S::belaids@upmc.edu::5dcb4cf5-c058-49ea-93f8-4f4e6c877fcd" providerId="AD" clId="Web-{729B6B04-4D1A-AFD6-EC63-B48C8BDA2C58}" dt="2024-12-29T18:03:39.710" v="354" actId="20577"/>
        <pc:sldMkLst>
          <pc:docMk/>
          <pc:sldMk cId="4094227945" sldId="352"/>
        </pc:sldMkLst>
        <pc:spChg chg="mod">
          <ac:chgData name="Belaid, Sirine" userId="S::belaids@upmc.edu::5dcb4cf5-c058-49ea-93f8-4f4e6c877fcd" providerId="AD" clId="Web-{729B6B04-4D1A-AFD6-EC63-B48C8BDA2C58}" dt="2024-12-29T18:03:39.710" v="354" actId="20577"/>
          <ac:spMkLst>
            <pc:docMk/>
            <pc:sldMk cId="4094227945" sldId="352"/>
            <ac:spMk id="3" creationId="{54D52FF0-F483-CAD8-917A-930506D4F12A}"/>
          </ac:spMkLst>
        </pc:spChg>
      </pc:sldChg>
      <pc:sldChg chg="modNotes">
        <pc:chgData name="Belaid, Sirine" userId="S::belaids@upmc.edu::5dcb4cf5-c058-49ea-93f8-4f4e6c877fcd" providerId="AD" clId="Web-{729B6B04-4D1A-AFD6-EC63-B48C8BDA2C58}" dt="2024-12-29T19:24:28.580" v="487"/>
        <pc:sldMkLst>
          <pc:docMk/>
          <pc:sldMk cId="1022786307" sldId="355"/>
        </pc:sldMkLst>
      </pc:sldChg>
      <pc:sldChg chg="modSp">
        <pc:chgData name="Belaid, Sirine" userId="S::belaids@upmc.edu::5dcb4cf5-c058-49ea-93f8-4f4e6c877fcd" providerId="AD" clId="Web-{729B6B04-4D1A-AFD6-EC63-B48C8BDA2C58}" dt="2024-12-29T18:56:59.086" v="359" actId="20577"/>
        <pc:sldMkLst>
          <pc:docMk/>
          <pc:sldMk cId="3868067760" sldId="357"/>
        </pc:sldMkLst>
        <pc:spChg chg="mod">
          <ac:chgData name="Belaid, Sirine" userId="S::belaids@upmc.edu::5dcb4cf5-c058-49ea-93f8-4f4e6c877fcd" providerId="AD" clId="Web-{729B6B04-4D1A-AFD6-EC63-B48C8BDA2C58}" dt="2024-12-29T18:56:59.086" v="359" actId="20577"/>
          <ac:spMkLst>
            <pc:docMk/>
            <pc:sldMk cId="3868067760" sldId="357"/>
            <ac:spMk id="3" creationId="{C6C10584-5F60-48A3-BCF3-AF01322CF6C3}"/>
          </ac:spMkLst>
        </pc:spChg>
      </pc:sldChg>
      <pc:sldChg chg="modSp modNotes">
        <pc:chgData name="Belaid, Sirine" userId="S::belaids@upmc.edu::5dcb4cf5-c058-49ea-93f8-4f4e6c877fcd" providerId="AD" clId="Web-{729B6B04-4D1A-AFD6-EC63-B48C8BDA2C58}" dt="2024-12-29T19:00:33.901" v="381" actId="20577"/>
        <pc:sldMkLst>
          <pc:docMk/>
          <pc:sldMk cId="3825394227" sldId="358"/>
        </pc:sldMkLst>
        <pc:spChg chg="mod">
          <ac:chgData name="Belaid, Sirine" userId="S::belaids@upmc.edu::5dcb4cf5-c058-49ea-93f8-4f4e6c877fcd" providerId="AD" clId="Web-{729B6B04-4D1A-AFD6-EC63-B48C8BDA2C58}" dt="2024-12-29T19:00:33.901" v="381" actId="20577"/>
          <ac:spMkLst>
            <pc:docMk/>
            <pc:sldMk cId="3825394227" sldId="358"/>
            <ac:spMk id="3" creationId="{4974952F-AF49-DE12-B0DE-612B936EDA11}"/>
          </ac:spMkLst>
        </pc:spChg>
      </pc:sldChg>
      <pc:sldChg chg="modSp">
        <pc:chgData name="Belaid, Sirine" userId="S::belaids@upmc.edu::5dcb4cf5-c058-49ea-93f8-4f4e6c877fcd" providerId="AD" clId="Web-{729B6B04-4D1A-AFD6-EC63-B48C8BDA2C58}" dt="2024-12-29T19:34:35.122" v="499" actId="1076"/>
        <pc:sldMkLst>
          <pc:docMk/>
          <pc:sldMk cId="1919480477" sldId="360"/>
        </pc:sldMkLst>
        <pc:spChg chg="mod">
          <ac:chgData name="Belaid, Sirine" userId="S::belaids@upmc.edu::5dcb4cf5-c058-49ea-93f8-4f4e6c877fcd" providerId="AD" clId="Web-{729B6B04-4D1A-AFD6-EC63-B48C8BDA2C58}" dt="2024-12-29T19:34:35.122" v="499" actId="1076"/>
          <ac:spMkLst>
            <pc:docMk/>
            <pc:sldMk cId="1919480477" sldId="360"/>
            <ac:spMk id="3" creationId="{6CCD5ABF-F289-6DF4-D01E-776F3BB7441A}"/>
          </ac:spMkLst>
        </pc:spChg>
        <pc:spChg chg="mod">
          <ac:chgData name="Belaid, Sirine" userId="S::belaids@upmc.edu::5dcb4cf5-c058-49ea-93f8-4f4e6c877fcd" providerId="AD" clId="Web-{729B6B04-4D1A-AFD6-EC63-B48C8BDA2C58}" dt="2024-12-29T19:33:49.855" v="492" actId="14100"/>
          <ac:spMkLst>
            <pc:docMk/>
            <pc:sldMk cId="1919480477" sldId="360"/>
            <ac:spMk id="6" creationId="{C33B9BD3-ECFC-E1EF-D683-0E97D7FA1078}"/>
          </ac:spMkLst>
        </pc:spChg>
      </pc:sldChg>
      <pc:sldChg chg="mod modShow">
        <pc:chgData name="Belaid, Sirine" userId="S::belaids@upmc.edu::5dcb4cf5-c058-49ea-93f8-4f4e6c877fcd" providerId="AD" clId="Web-{729B6B04-4D1A-AFD6-EC63-B48C8BDA2C58}" dt="2024-12-29T20:02:29.467" v="500"/>
        <pc:sldMkLst>
          <pc:docMk/>
          <pc:sldMk cId="2817742152" sldId="361"/>
        </pc:sldMkLst>
      </pc:sldChg>
      <pc:sldChg chg="modSp">
        <pc:chgData name="Belaid, Sirine" userId="S::belaids@upmc.edu::5dcb4cf5-c058-49ea-93f8-4f4e6c877fcd" providerId="AD" clId="Web-{729B6B04-4D1A-AFD6-EC63-B48C8BDA2C58}" dt="2024-12-29T19:27:24.260" v="488" actId="1076"/>
        <pc:sldMkLst>
          <pc:docMk/>
          <pc:sldMk cId="2090633080" sldId="362"/>
        </pc:sldMkLst>
        <pc:picChg chg="mod">
          <ac:chgData name="Belaid, Sirine" userId="S::belaids@upmc.edu::5dcb4cf5-c058-49ea-93f8-4f4e6c877fcd" providerId="AD" clId="Web-{729B6B04-4D1A-AFD6-EC63-B48C8BDA2C58}" dt="2024-12-29T19:27:24.260" v="488" actId="1076"/>
          <ac:picMkLst>
            <pc:docMk/>
            <pc:sldMk cId="2090633080" sldId="362"/>
            <ac:picMk id="6" creationId="{4BFA40AF-853D-CFF9-DF8A-410FE0CFD66E}"/>
          </ac:picMkLst>
        </pc:picChg>
      </pc:sldChg>
      <pc:sldChg chg="delSp">
        <pc:chgData name="Belaid, Sirine" userId="S::belaids@upmc.edu::5dcb4cf5-c058-49ea-93f8-4f4e6c877fcd" providerId="AD" clId="Web-{729B6B04-4D1A-AFD6-EC63-B48C8BDA2C58}" dt="2024-12-29T17:58:49.170" v="309"/>
        <pc:sldMkLst>
          <pc:docMk/>
          <pc:sldMk cId="3864006159" sldId="363"/>
        </pc:sldMkLst>
        <pc:picChg chg="del">
          <ac:chgData name="Belaid, Sirine" userId="S::belaids@upmc.edu::5dcb4cf5-c058-49ea-93f8-4f4e6c877fcd" providerId="AD" clId="Web-{729B6B04-4D1A-AFD6-EC63-B48C8BDA2C58}" dt="2024-12-29T17:58:49.170" v="309"/>
          <ac:picMkLst>
            <pc:docMk/>
            <pc:sldMk cId="3864006159" sldId="363"/>
            <ac:picMk id="5" creationId="{E019E510-CD94-201C-D283-353703756836}"/>
          </ac:picMkLst>
        </pc:picChg>
      </pc:sldChg>
      <pc:sldChg chg="delSp">
        <pc:chgData name="Belaid, Sirine" userId="S::belaids@upmc.edu::5dcb4cf5-c058-49ea-93f8-4f4e6c877fcd" providerId="AD" clId="Web-{729B6B04-4D1A-AFD6-EC63-B48C8BDA2C58}" dt="2024-12-29T19:01:02.824" v="382"/>
        <pc:sldMkLst>
          <pc:docMk/>
          <pc:sldMk cId="2414223819" sldId="364"/>
        </pc:sldMkLst>
        <pc:picChg chg="del">
          <ac:chgData name="Belaid, Sirine" userId="S::belaids@upmc.edu::5dcb4cf5-c058-49ea-93f8-4f4e6c877fcd" providerId="AD" clId="Web-{729B6B04-4D1A-AFD6-EC63-B48C8BDA2C58}" dt="2024-12-29T19:01:02.824" v="382"/>
          <ac:picMkLst>
            <pc:docMk/>
            <pc:sldMk cId="2414223819" sldId="364"/>
            <ac:picMk id="5" creationId="{0EA3ECBB-1D1A-2168-2F0E-08CC8CFE6931}"/>
          </ac:picMkLst>
        </pc:picChg>
      </pc:sldChg>
      <pc:sldChg chg="delSp">
        <pc:chgData name="Belaid, Sirine" userId="S::belaids@upmc.edu::5dcb4cf5-c058-49ea-93f8-4f4e6c877fcd" providerId="AD" clId="Web-{729B6B04-4D1A-AFD6-EC63-B48C8BDA2C58}" dt="2024-12-29T19:30:48.782" v="489"/>
        <pc:sldMkLst>
          <pc:docMk/>
          <pc:sldMk cId="795419220" sldId="365"/>
        </pc:sldMkLst>
        <pc:picChg chg="del">
          <ac:chgData name="Belaid, Sirine" userId="S::belaids@upmc.edu::5dcb4cf5-c058-49ea-93f8-4f4e6c877fcd" providerId="AD" clId="Web-{729B6B04-4D1A-AFD6-EC63-B48C8BDA2C58}" dt="2024-12-29T19:30:48.782" v="489"/>
          <ac:picMkLst>
            <pc:docMk/>
            <pc:sldMk cId="795419220" sldId="365"/>
            <ac:picMk id="5" creationId="{51DD76F1-66F5-5DCA-BCEE-7A1D4582E690}"/>
          </ac:picMkLst>
        </pc:picChg>
      </pc:sldChg>
      <pc:sldChg chg="mod modShow">
        <pc:chgData name="Belaid, Sirine" userId="S::belaids@upmc.edu::5dcb4cf5-c058-49ea-93f8-4f4e6c877fcd" providerId="AD" clId="Web-{729B6B04-4D1A-AFD6-EC63-B48C8BDA2C58}" dt="2024-12-29T20:02:45.983" v="501"/>
        <pc:sldMkLst>
          <pc:docMk/>
          <pc:sldMk cId="2208660293" sldId="366"/>
        </pc:sldMkLst>
      </pc:sldChg>
      <pc:sldChg chg="mod modShow">
        <pc:chgData name="Belaid, Sirine" userId="S::belaids@upmc.edu::5dcb4cf5-c058-49ea-93f8-4f4e6c877fcd" providerId="AD" clId="Web-{729B6B04-4D1A-AFD6-EC63-B48C8BDA2C58}" dt="2024-12-29T17:58:16.060" v="308"/>
        <pc:sldMkLst>
          <pc:docMk/>
          <pc:sldMk cId="3004633114" sldId="367"/>
        </pc:sldMkLst>
      </pc:sldChg>
      <pc:sldChg chg="addSp modSp">
        <pc:chgData name="Belaid, Sirine" userId="S::belaids@upmc.edu::5dcb4cf5-c058-49ea-93f8-4f4e6c877fcd" providerId="AD" clId="Web-{729B6B04-4D1A-AFD6-EC63-B48C8BDA2C58}" dt="2024-12-29T19:15:03.214" v="463" actId="14100"/>
        <pc:sldMkLst>
          <pc:docMk/>
          <pc:sldMk cId="13225285" sldId="370"/>
        </pc:sldMkLst>
        <pc:spChg chg="mod">
          <ac:chgData name="Belaid, Sirine" userId="S::belaids@upmc.edu::5dcb4cf5-c058-49ea-93f8-4f4e6c877fcd" providerId="AD" clId="Web-{729B6B04-4D1A-AFD6-EC63-B48C8BDA2C58}" dt="2024-12-29T19:14:17.525" v="450" actId="1076"/>
          <ac:spMkLst>
            <pc:docMk/>
            <pc:sldMk cId="13225285" sldId="370"/>
            <ac:spMk id="2" creationId="{390210F8-63D0-95C3-DEF9-3C8314A55FAA}"/>
          </ac:spMkLst>
        </pc:spChg>
        <pc:spChg chg="mod">
          <ac:chgData name="Belaid, Sirine" userId="S::belaids@upmc.edu::5dcb4cf5-c058-49ea-93f8-4f4e6c877fcd" providerId="AD" clId="Web-{729B6B04-4D1A-AFD6-EC63-B48C8BDA2C58}" dt="2024-12-29T19:13:46.196" v="441" actId="1076"/>
          <ac:spMkLst>
            <pc:docMk/>
            <pc:sldMk cId="13225285" sldId="370"/>
            <ac:spMk id="3" creationId="{5F301AD2-63C3-E004-C0F9-E2CADF494E6A}"/>
          </ac:spMkLst>
        </pc:spChg>
        <pc:spChg chg="add mod">
          <ac:chgData name="Belaid, Sirine" userId="S::belaids@upmc.edu::5dcb4cf5-c058-49ea-93f8-4f4e6c877fcd" providerId="AD" clId="Web-{729B6B04-4D1A-AFD6-EC63-B48C8BDA2C58}" dt="2024-12-29T19:14:41.619" v="456" actId="14100"/>
          <ac:spMkLst>
            <pc:docMk/>
            <pc:sldMk cId="13225285" sldId="370"/>
            <ac:spMk id="9" creationId="{5F32714F-E9C0-1187-B044-1098DE24B850}"/>
          </ac:spMkLst>
        </pc:spChg>
        <pc:spChg chg="add mod">
          <ac:chgData name="Belaid, Sirine" userId="S::belaids@upmc.edu::5dcb4cf5-c058-49ea-93f8-4f4e6c877fcd" providerId="AD" clId="Web-{729B6B04-4D1A-AFD6-EC63-B48C8BDA2C58}" dt="2024-12-29T19:15:03.214" v="463" actId="14100"/>
          <ac:spMkLst>
            <pc:docMk/>
            <pc:sldMk cId="13225285" sldId="370"/>
            <ac:spMk id="11" creationId="{6FE9D977-E081-0C96-5A6F-6246BD1C63B9}"/>
          </ac:spMkLst>
        </pc:spChg>
        <pc:picChg chg="add mod">
          <ac:chgData name="Belaid, Sirine" userId="S::belaids@upmc.edu::5dcb4cf5-c058-49ea-93f8-4f4e6c877fcd" providerId="AD" clId="Web-{729B6B04-4D1A-AFD6-EC63-B48C8BDA2C58}" dt="2024-12-29T19:14:19.384" v="451" actId="1076"/>
          <ac:picMkLst>
            <pc:docMk/>
            <pc:sldMk cId="13225285" sldId="370"/>
            <ac:picMk id="5" creationId="{B02E1EBA-509B-E301-E044-0E7BF331C887}"/>
          </ac:picMkLst>
        </pc:picChg>
        <pc:picChg chg="add mod">
          <ac:chgData name="Belaid, Sirine" userId="S::belaids@upmc.edu::5dcb4cf5-c058-49ea-93f8-4f4e6c877fcd" providerId="AD" clId="Web-{729B6B04-4D1A-AFD6-EC63-B48C8BDA2C58}" dt="2024-12-29T19:14:20.822" v="452" actId="1076"/>
          <ac:picMkLst>
            <pc:docMk/>
            <pc:sldMk cId="13225285" sldId="370"/>
            <ac:picMk id="7" creationId="{05D259E3-F102-FD78-86AC-41459BBF3936}"/>
          </ac:picMkLst>
        </pc:picChg>
      </pc:sldChg>
      <pc:sldChg chg="delSp">
        <pc:chgData name="Belaid, Sirine" userId="S::belaids@upmc.edu::5dcb4cf5-c058-49ea-93f8-4f4e6c877fcd" providerId="AD" clId="Web-{729B6B04-4D1A-AFD6-EC63-B48C8BDA2C58}" dt="2024-12-29T20:17:12.084" v="503"/>
        <pc:sldMkLst>
          <pc:docMk/>
          <pc:sldMk cId="3743057861" sldId="386"/>
        </pc:sldMkLst>
        <pc:picChg chg="del">
          <ac:chgData name="Belaid, Sirine" userId="S::belaids@upmc.edu::5dcb4cf5-c058-49ea-93f8-4f4e6c877fcd" providerId="AD" clId="Web-{729B6B04-4D1A-AFD6-EC63-B48C8BDA2C58}" dt="2024-12-29T20:17:12.084" v="503"/>
          <ac:picMkLst>
            <pc:docMk/>
            <pc:sldMk cId="3743057861" sldId="386"/>
            <ac:picMk id="5" creationId="{C6A0E3C3-4F67-7F93-23BB-9A998A6D38CC}"/>
          </ac:picMkLst>
        </pc:picChg>
      </pc:sldChg>
      <pc:sldChg chg="modSp">
        <pc:chgData name="Belaid, Sirine" userId="S::belaids@upmc.edu::5dcb4cf5-c058-49ea-93f8-4f4e6c877fcd" providerId="AD" clId="Web-{729B6B04-4D1A-AFD6-EC63-B48C8BDA2C58}" dt="2024-12-29T02:33:25.695" v="2" actId="1076"/>
        <pc:sldMkLst>
          <pc:docMk/>
          <pc:sldMk cId="412412650" sldId="391"/>
        </pc:sldMkLst>
        <pc:spChg chg="mod">
          <ac:chgData name="Belaid, Sirine" userId="S::belaids@upmc.edu::5dcb4cf5-c058-49ea-93f8-4f4e6c877fcd" providerId="AD" clId="Web-{729B6B04-4D1A-AFD6-EC63-B48C8BDA2C58}" dt="2024-12-29T02:33:19.711" v="1" actId="1076"/>
          <ac:spMkLst>
            <pc:docMk/>
            <pc:sldMk cId="412412650" sldId="391"/>
            <ac:spMk id="4" creationId="{0C4DFA9F-D5D8-418D-6708-4B57D7393503}"/>
          </ac:spMkLst>
        </pc:spChg>
        <pc:spChg chg="mod">
          <ac:chgData name="Belaid, Sirine" userId="S::belaids@upmc.edu::5dcb4cf5-c058-49ea-93f8-4f4e6c877fcd" providerId="AD" clId="Web-{729B6B04-4D1A-AFD6-EC63-B48C8BDA2C58}" dt="2024-12-29T02:33:25.695" v="2" actId="1076"/>
          <ac:spMkLst>
            <pc:docMk/>
            <pc:sldMk cId="412412650" sldId="391"/>
            <ac:spMk id="5" creationId="{D812EF7D-4702-057B-A538-96ABF815087F}"/>
          </ac:spMkLst>
        </pc:spChg>
      </pc:sldChg>
      <pc:sldChg chg="modSp">
        <pc:chgData name="Belaid, Sirine" userId="S::belaids@upmc.edu::5dcb4cf5-c058-49ea-93f8-4f4e6c877fcd" providerId="AD" clId="Web-{729B6B04-4D1A-AFD6-EC63-B48C8BDA2C58}" dt="2024-12-29T17:53:12.238" v="307"/>
        <pc:sldMkLst>
          <pc:docMk/>
          <pc:sldMk cId="1625999220" sldId="395"/>
        </pc:sldMkLst>
        <pc:graphicFrameChg chg="mod modGraphic">
          <ac:chgData name="Belaid, Sirine" userId="S::belaids@upmc.edu::5dcb4cf5-c058-49ea-93f8-4f4e6c877fcd" providerId="AD" clId="Web-{729B6B04-4D1A-AFD6-EC63-B48C8BDA2C58}" dt="2024-12-29T17:53:12.238" v="307"/>
          <ac:graphicFrameMkLst>
            <pc:docMk/>
            <pc:sldMk cId="1625999220" sldId="395"/>
            <ac:graphicFrameMk id="2" creationId="{5AF5F66F-7F30-C7FD-12D8-EE5A388FDE96}"/>
          </ac:graphicFrameMkLst>
        </pc:graphicFrameChg>
      </pc:sldChg>
      <pc:sldChg chg="modNotes">
        <pc:chgData name="Belaid, Sirine" userId="S::belaids@upmc.edu::5dcb4cf5-c058-49ea-93f8-4f4e6c877fcd" providerId="AD" clId="Web-{729B6B04-4D1A-AFD6-EC63-B48C8BDA2C58}" dt="2024-12-29T19:22:26.123" v="476"/>
        <pc:sldMkLst>
          <pc:docMk/>
          <pc:sldMk cId="565133894" sldId="398"/>
        </pc:sldMkLst>
      </pc:sldChg>
      <pc:sldChg chg="delSp">
        <pc:chgData name="Belaid, Sirine" userId="S::belaids@upmc.edu::5dcb4cf5-c058-49ea-93f8-4f4e6c877fcd" providerId="AD" clId="Web-{729B6B04-4D1A-AFD6-EC63-B48C8BDA2C58}" dt="2024-12-29T20:12:07.472" v="502"/>
        <pc:sldMkLst>
          <pc:docMk/>
          <pc:sldMk cId="1117081788" sldId="399"/>
        </pc:sldMkLst>
        <pc:picChg chg="del">
          <ac:chgData name="Belaid, Sirine" userId="S::belaids@upmc.edu::5dcb4cf5-c058-49ea-93f8-4f4e6c877fcd" providerId="AD" clId="Web-{729B6B04-4D1A-AFD6-EC63-B48C8BDA2C58}" dt="2024-12-29T20:12:07.472" v="502"/>
          <ac:picMkLst>
            <pc:docMk/>
            <pc:sldMk cId="1117081788" sldId="399"/>
            <ac:picMk id="5" creationId="{537B9878-82EB-0CE3-B554-0F090511E355}"/>
          </ac:picMkLst>
        </pc:picChg>
      </pc:sldChg>
      <pc:sldChg chg="modSp">
        <pc:chgData name="Belaid, Sirine" userId="S::belaids@upmc.edu::5dcb4cf5-c058-49ea-93f8-4f4e6c877fcd" providerId="AD" clId="Web-{729B6B04-4D1A-AFD6-EC63-B48C8BDA2C58}" dt="2024-12-29T02:36:49.739" v="8" actId="20577"/>
        <pc:sldMkLst>
          <pc:docMk/>
          <pc:sldMk cId="1711055037" sldId="401"/>
        </pc:sldMkLst>
        <pc:spChg chg="mod">
          <ac:chgData name="Belaid, Sirine" userId="S::belaids@upmc.edu::5dcb4cf5-c058-49ea-93f8-4f4e6c877fcd" providerId="AD" clId="Web-{729B6B04-4D1A-AFD6-EC63-B48C8BDA2C58}" dt="2024-12-29T02:36:49.739" v="8" actId="20577"/>
          <ac:spMkLst>
            <pc:docMk/>
            <pc:sldMk cId="1711055037" sldId="401"/>
            <ac:spMk id="3" creationId="{A954158A-E692-9D38-448A-CBA2603BCC28}"/>
          </ac:spMkLst>
        </pc:spChg>
      </pc:sldChg>
      <pc:sldChg chg="modNotes">
        <pc:chgData name="Belaid, Sirine" userId="S::belaids@upmc.edu::5dcb4cf5-c058-49ea-93f8-4f4e6c877fcd" providerId="AD" clId="Web-{729B6B04-4D1A-AFD6-EC63-B48C8BDA2C58}" dt="2024-12-29T17:14:08.018" v="37"/>
        <pc:sldMkLst>
          <pc:docMk/>
          <pc:sldMk cId="4125576382" sldId="402"/>
        </pc:sldMkLst>
      </pc:sldChg>
      <pc:sldChg chg="modSp modNotes">
        <pc:chgData name="Belaid, Sirine" userId="S::belaids@upmc.edu::5dcb4cf5-c058-49ea-93f8-4f4e6c877fcd" providerId="AD" clId="Web-{729B6B04-4D1A-AFD6-EC63-B48C8BDA2C58}" dt="2024-12-29T17:44:43.187" v="243"/>
        <pc:sldMkLst>
          <pc:docMk/>
          <pc:sldMk cId="3969654780" sldId="403"/>
        </pc:sldMkLst>
        <pc:spChg chg="mod">
          <ac:chgData name="Belaid, Sirine" userId="S::belaids@upmc.edu::5dcb4cf5-c058-49ea-93f8-4f4e6c877fcd" providerId="AD" clId="Web-{729B6B04-4D1A-AFD6-EC63-B48C8BDA2C58}" dt="2024-12-29T02:42:50.907" v="10"/>
          <ac:spMkLst>
            <pc:docMk/>
            <pc:sldMk cId="3969654780" sldId="403"/>
            <ac:spMk id="3" creationId="{413D458D-0166-F4A0-0D32-6DC38DB896D9}"/>
          </ac:spMkLst>
        </pc:spChg>
      </pc:sldChg>
      <pc:sldChg chg="del">
        <pc:chgData name="Belaid, Sirine" userId="S::belaids@upmc.edu::5dcb4cf5-c058-49ea-93f8-4f4e6c877fcd" providerId="AD" clId="Web-{729B6B04-4D1A-AFD6-EC63-B48C8BDA2C58}" dt="2024-12-29T02:34:49.901" v="3"/>
        <pc:sldMkLst>
          <pc:docMk/>
          <pc:sldMk cId="1389029600" sldId="405"/>
        </pc:sldMkLst>
      </pc:sldChg>
      <pc:sldChg chg="modSp new">
        <pc:chgData name="Belaid, Sirine" userId="S::belaids@upmc.edu::5dcb4cf5-c058-49ea-93f8-4f4e6c877fcd" providerId="AD" clId="Web-{729B6B04-4D1A-AFD6-EC63-B48C8BDA2C58}" dt="2024-12-29T19:06:13.318" v="400" actId="20577"/>
        <pc:sldMkLst>
          <pc:docMk/>
          <pc:sldMk cId="2980877215" sldId="405"/>
        </pc:sldMkLst>
        <pc:spChg chg="mod">
          <ac:chgData name="Belaid, Sirine" userId="S::belaids@upmc.edu::5dcb4cf5-c058-49ea-93f8-4f4e6c877fcd" providerId="AD" clId="Web-{729B6B04-4D1A-AFD6-EC63-B48C8BDA2C58}" dt="2024-12-29T19:05:56.849" v="384" actId="20577"/>
          <ac:spMkLst>
            <pc:docMk/>
            <pc:sldMk cId="2980877215" sldId="405"/>
            <ac:spMk id="2" creationId="{66BB6751-B6AA-40CD-4421-E30109F0F92F}"/>
          </ac:spMkLst>
        </pc:spChg>
        <pc:spChg chg="mod">
          <ac:chgData name="Belaid, Sirine" userId="S::belaids@upmc.edu::5dcb4cf5-c058-49ea-93f8-4f4e6c877fcd" providerId="AD" clId="Web-{729B6B04-4D1A-AFD6-EC63-B48C8BDA2C58}" dt="2024-12-29T19:06:13.318" v="400" actId="20577"/>
          <ac:spMkLst>
            <pc:docMk/>
            <pc:sldMk cId="2980877215" sldId="405"/>
            <ac:spMk id="3" creationId="{27CD8494-A0E2-9210-FFC9-4E5E76A3F1BA}"/>
          </ac:spMkLst>
        </pc:spChg>
      </pc:sldChg>
      <pc:sldChg chg="new del">
        <pc:chgData name="Belaid, Sirine" userId="S::belaids@upmc.edu::5dcb4cf5-c058-49ea-93f8-4f4e6c877fcd" providerId="AD" clId="Web-{729B6B04-4D1A-AFD6-EC63-B48C8BDA2C58}" dt="2024-12-29T19:10:14.486" v="402"/>
        <pc:sldMkLst>
          <pc:docMk/>
          <pc:sldMk cId="211236065" sldId="406"/>
        </pc:sldMkLst>
      </pc:sldChg>
      <pc:sldChg chg="addSp modSp new del mod ord setBg">
        <pc:chgData name="Belaid, Sirine" userId="S::belaids@upmc.edu::5dcb4cf5-c058-49ea-93f8-4f4e6c877fcd" providerId="AD" clId="Web-{729B6B04-4D1A-AFD6-EC63-B48C8BDA2C58}" dt="2024-12-29T19:15:12.730" v="464"/>
        <pc:sldMkLst>
          <pc:docMk/>
          <pc:sldMk cId="3689238765" sldId="406"/>
        </pc:sldMkLst>
        <pc:spChg chg="add mod">
          <ac:chgData name="Belaid, Sirine" userId="S::belaids@upmc.edu::5dcb4cf5-c058-49ea-93f8-4f4e6c877fcd" providerId="AD" clId="Web-{729B6B04-4D1A-AFD6-EC63-B48C8BDA2C58}" dt="2024-12-29T19:12:23.224" v="429" actId="14100"/>
          <ac:spMkLst>
            <pc:docMk/>
            <pc:sldMk cId="3689238765" sldId="406"/>
            <ac:spMk id="4" creationId="{AE0CC82A-B912-D2F8-274F-CB168C362816}"/>
          </ac:spMkLst>
        </pc:spChg>
        <pc:spChg chg="add mod">
          <ac:chgData name="Belaid, Sirine" userId="S::belaids@upmc.edu::5dcb4cf5-c058-49ea-93f8-4f4e6c877fcd" providerId="AD" clId="Web-{729B6B04-4D1A-AFD6-EC63-B48C8BDA2C58}" dt="2024-12-29T19:12:10.646" v="427" actId="14100"/>
          <ac:spMkLst>
            <pc:docMk/>
            <pc:sldMk cId="3689238765" sldId="406"/>
            <ac:spMk id="5" creationId="{97010760-6D09-CBB8-03AA-B39798427F0D}"/>
          </ac:spMkLst>
        </pc:spChg>
        <pc:picChg chg="add mod ord">
          <ac:chgData name="Belaid, Sirine" userId="S::belaids@upmc.edu::5dcb4cf5-c058-49ea-93f8-4f4e6c877fcd" providerId="AD" clId="Web-{729B6B04-4D1A-AFD6-EC63-B48C8BDA2C58}" dt="2024-12-29T19:11:20.925" v="416" actId="1076"/>
          <ac:picMkLst>
            <pc:docMk/>
            <pc:sldMk cId="3689238765" sldId="406"/>
            <ac:picMk id="2" creationId="{2E138BCB-F367-3277-7355-EC27983D4F5C}"/>
          </ac:picMkLst>
        </pc:picChg>
        <pc:picChg chg="add mod">
          <ac:chgData name="Belaid, Sirine" userId="S::belaids@upmc.edu::5dcb4cf5-c058-49ea-93f8-4f4e6c877fcd" providerId="AD" clId="Web-{729B6B04-4D1A-AFD6-EC63-B48C8BDA2C58}" dt="2024-12-29T19:11:06.800" v="413" actId="14100"/>
          <ac:picMkLst>
            <pc:docMk/>
            <pc:sldMk cId="3689238765" sldId="406"/>
            <ac:picMk id="3" creationId="{BA31857B-C160-E695-6128-00B497177662}"/>
          </ac:picMkLst>
        </pc:picChg>
      </pc:sldChg>
      <pc:sldChg chg="del">
        <pc:chgData name="Belaid, Sirine" userId="S::belaids@upmc.edu::5dcb4cf5-c058-49ea-93f8-4f4e6c877fcd" providerId="AD" clId="Web-{729B6B04-4D1A-AFD6-EC63-B48C8BDA2C58}" dt="2024-12-29T16:53:49.065" v="11"/>
        <pc:sldMkLst>
          <pc:docMk/>
          <pc:sldMk cId="4257167352" sldId="406"/>
        </pc:sldMkLst>
      </pc:sldChg>
    </pc:docChg>
  </pc:docChgLst>
  <pc:docChgLst>
    <pc:chgData name="Belaid, Sirine" userId="S::belaids@upmc.edu::5dcb4cf5-c058-49ea-93f8-4f4e6c877fcd" providerId="AD" clId="Web-{FD565D63-41E7-B8D3-1CC0-0E8F4802A810}"/>
    <pc:docChg chg="addSld modSld">
      <pc:chgData name="Belaid, Sirine" userId="S::belaids@upmc.edu::5dcb4cf5-c058-49ea-93f8-4f4e6c877fcd" providerId="AD" clId="Web-{FD565D63-41E7-B8D3-1CC0-0E8F4802A810}" dt="2024-12-09T14:26:39.259" v="66" actId="1076"/>
      <pc:docMkLst>
        <pc:docMk/>
      </pc:docMkLst>
      <pc:sldChg chg="modSp">
        <pc:chgData name="Belaid, Sirine" userId="S::belaids@upmc.edu::5dcb4cf5-c058-49ea-93f8-4f4e6c877fcd" providerId="AD" clId="Web-{FD565D63-41E7-B8D3-1CC0-0E8F4802A810}" dt="2024-12-05T17:31:22.651" v="22" actId="20577"/>
        <pc:sldMkLst>
          <pc:docMk/>
          <pc:sldMk cId="2302766718" sldId="261"/>
        </pc:sldMkLst>
        <pc:spChg chg="mod">
          <ac:chgData name="Belaid, Sirine" userId="S::belaids@upmc.edu::5dcb4cf5-c058-49ea-93f8-4f4e6c877fcd" providerId="AD" clId="Web-{FD565D63-41E7-B8D3-1CC0-0E8F4802A810}" dt="2024-12-05T17:31:22.651" v="22" actId="20577"/>
          <ac:spMkLst>
            <pc:docMk/>
            <pc:sldMk cId="2302766718" sldId="261"/>
            <ac:spMk id="3" creationId="{28C8D225-CFB3-835A-E034-CE62DC5DCF1F}"/>
          </ac:spMkLst>
        </pc:spChg>
      </pc:sldChg>
      <pc:sldChg chg="modSp">
        <pc:chgData name="Belaid, Sirine" userId="S::belaids@upmc.edu::5dcb4cf5-c058-49ea-93f8-4f4e6c877fcd" providerId="AD" clId="Web-{FD565D63-41E7-B8D3-1CC0-0E8F4802A810}" dt="2024-12-05T16:49:26.882" v="6" actId="20577"/>
        <pc:sldMkLst>
          <pc:docMk/>
          <pc:sldMk cId="1919480477" sldId="360"/>
        </pc:sldMkLst>
        <pc:spChg chg="mod">
          <ac:chgData name="Belaid, Sirine" userId="S::belaids@upmc.edu::5dcb4cf5-c058-49ea-93f8-4f4e6c877fcd" providerId="AD" clId="Web-{FD565D63-41E7-B8D3-1CC0-0E8F4802A810}" dt="2024-12-05T16:49:26.882" v="6" actId="20577"/>
          <ac:spMkLst>
            <pc:docMk/>
            <pc:sldMk cId="1919480477" sldId="360"/>
            <ac:spMk id="3" creationId="{6CCD5ABF-F289-6DF4-D01E-776F3BB7441A}"/>
          </ac:spMkLst>
        </pc:spChg>
      </pc:sldChg>
      <pc:sldChg chg="modSp">
        <pc:chgData name="Belaid, Sirine" userId="S::belaids@upmc.edu::5dcb4cf5-c058-49ea-93f8-4f4e6c877fcd" providerId="AD" clId="Web-{FD565D63-41E7-B8D3-1CC0-0E8F4802A810}" dt="2024-12-05T16:50:57.651" v="7" actId="20577"/>
        <pc:sldMkLst>
          <pc:docMk/>
          <pc:sldMk cId="2817742152" sldId="361"/>
        </pc:sldMkLst>
        <pc:spChg chg="mod">
          <ac:chgData name="Belaid, Sirine" userId="S::belaids@upmc.edu::5dcb4cf5-c058-49ea-93f8-4f4e6c877fcd" providerId="AD" clId="Web-{FD565D63-41E7-B8D3-1CC0-0E8F4802A810}" dt="2024-12-05T16:50:57.651" v="7" actId="20577"/>
          <ac:spMkLst>
            <pc:docMk/>
            <pc:sldMk cId="2817742152" sldId="361"/>
            <ac:spMk id="3" creationId="{B6FB2075-FE59-DFEA-3EE2-6A1D6EAFE127}"/>
          </ac:spMkLst>
        </pc:spChg>
      </pc:sldChg>
      <pc:sldChg chg="modSp">
        <pc:chgData name="Belaid, Sirine" userId="S::belaids@upmc.edu::5dcb4cf5-c058-49ea-93f8-4f4e6c877fcd" providerId="AD" clId="Web-{FD565D63-41E7-B8D3-1CC0-0E8F4802A810}" dt="2024-12-05T16:41:03.863" v="1" actId="20577"/>
        <pc:sldMkLst>
          <pc:docMk/>
          <pc:sldMk cId="13225285" sldId="370"/>
        </pc:sldMkLst>
        <pc:spChg chg="mod">
          <ac:chgData name="Belaid, Sirine" userId="S::belaids@upmc.edu::5dcb4cf5-c058-49ea-93f8-4f4e6c877fcd" providerId="AD" clId="Web-{FD565D63-41E7-B8D3-1CC0-0E8F4802A810}" dt="2024-12-05T16:41:03.863" v="1" actId="20577"/>
          <ac:spMkLst>
            <pc:docMk/>
            <pc:sldMk cId="13225285" sldId="370"/>
            <ac:spMk id="3" creationId="{5F301AD2-63C3-E004-C0F9-E2CADF494E6A}"/>
          </ac:spMkLst>
        </pc:spChg>
      </pc:sldChg>
      <pc:sldChg chg="modSp new">
        <pc:chgData name="Belaid, Sirine" userId="S::belaids@upmc.edu::5dcb4cf5-c058-49ea-93f8-4f4e6c877fcd" providerId="AD" clId="Web-{FD565D63-41E7-B8D3-1CC0-0E8F4802A810}" dt="2024-12-05T17:25:49.873" v="19" actId="20577"/>
        <pc:sldMkLst>
          <pc:docMk/>
          <pc:sldMk cId="412412650" sldId="391"/>
        </pc:sldMkLst>
        <pc:spChg chg="mod">
          <ac:chgData name="Belaid, Sirine" userId="S::belaids@upmc.edu::5dcb4cf5-c058-49ea-93f8-4f4e6c877fcd" providerId="AD" clId="Web-{FD565D63-41E7-B8D3-1CC0-0E8F4802A810}" dt="2024-12-05T17:25:49.873" v="19" actId="20577"/>
          <ac:spMkLst>
            <pc:docMk/>
            <pc:sldMk cId="412412650" sldId="391"/>
            <ac:spMk id="3" creationId="{58D555CA-A0A4-BD5A-C7A5-51D39BF63446}"/>
          </ac:spMkLst>
        </pc:spChg>
      </pc:sldChg>
      <pc:sldChg chg="addSp delSp modSp new">
        <pc:chgData name="Belaid, Sirine" userId="S::belaids@upmc.edu::5dcb4cf5-c058-49ea-93f8-4f4e6c877fcd" providerId="AD" clId="Web-{FD565D63-41E7-B8D3-1CC0-0E8F4802A810}" dt="2024-12-09T14:26:39.259" v="66" actId="1076"/>
        <pc:sldMkLst>
          <pc:docMk/>
          <pc:sldMk cId="3818458034" sldId="392"/>
        </pc:sldMkLst>
        <pc:spChg chg="add mod">
          <ac:chgData name="Belaid, Sirine" userId="S::belaids@upmc.edu::5dcb4cf5-c058-49ea-93f8-4f4e6c877fcd" providerId="AD" clId="Web-{FD565D63-41E7-B8D3-1CC0-0E8F4802A810}" dt="2024-12-09T14:24:41.680" v="52" actId="1076"/>
          <ac:spMkLst>
            <pc:docMk/>
            <pc:sldMk cId="3818458034" sldId="392"/>
            <ac:spMk id="4" creationId="{D283376C-E258-9B0F-B62B-D694E979149E}"/>
          </ac:spMkLst>
        </pc:spChg>
        <pc:spChg chg="add mod">
          <ac:chgData name="Belaid, Sirine" userId="S::belaids@upmc.edu::5dcb4cf5-c058-49ea-93f8-4f4e6c877fcd" providerId="AD" clId="Web-{FD565D63-41E7-B8D3-1CC0-0E8F4802A810}" dt="2024-12-09T14:24:36.649" v="51" actId="1076"/>
          <ac:spMkLst>
            <pc:docMk/>
            <pc:sldMk cId="3818458034" sldId="392"/>
            <ac:spMk id="5" creationId="{BD07E713-A39B-5678-BB8F-FB4DAF545BA7}"/>
          </ac:spMkLst>
        </pc:spChg>
        <pc:spChg chg="add mod">
          <ac:chgData name="Belaid, Sirine" userId="S::belaids@upmc.edu::5dcb4cf5-c058-49ea-93f8-4f4e6c877fcd" providerId="AD" clId="Web-{FD565D63-41E7-B8D3-1CC0-0E8F4802A810}" dt="2024-12-09T14:26:24.759" v="62" actId="1076"/>
          <ac:spMkLst>
            <pc:docMk/>
            <pc:sldMk cId="3818458034" sldId="392"/>
            <ac:spMk id="7" creationId="{4DE769C2-A501-0F43-6419-2C9CD2D1132E}"/>
          </ac:spMkLst>
        </pc:spChg>
        <pc:spChg chg="add del">
          <ac:chgData name="Belaid, Sirine" userId="S::belaids@upmc.edu::5dcb4cf5-c058-49ea-93f8-4f4e6c877fcd" providerId="AD" clId="Web-{FD565D63-41E7-B8D3-1CC0-0E8F4802A810}" dt="2024-12-09T14:25:44.009" v="59"/>
          <ac:spMkLst>
            <pc:docMk/>
            <pc:sldMk cId="3818458034" sldId="392"/>
            <ac:spMk id="8" creationId="{2CD6C79E-CB61-CE9C-B70D-5F73AB853FF3}"/>
          </ac:spMkLst>
        </pc:spChg>
        <pc:spChg chg="add mod">
          <ac:chgData name="Belaid, Sirine" userId="S::belaids@upmc.edu::5dcb4cf5-c058-49ea-93f8-4f4e6c877fcd" providerId="AD" clId="Web-{FD565D63-41E7-B8D3-1CC0-0E8F4802A810}" dt="2024-12-09T14:26:39.259" v="66" actId="1076"/>
          <ac:spMkLst>
            <pc:docMk/>
            <pc:sldMk cId="3818458034" sldId="392"/>
            <ac:spMk id="9" creationId="{6464D224-469B-223B-5282-CCCB0FA56301}"/>
          </ac:spMkLst>
        </pc:spChg>
        <pc:picChg chg="add mod">
          <ac:chgData name="Belaid, Sirine" userId="S::belaids@upmc.edu::5dcb4cf5-c058-49ea-93f8-4f4e6c877fcd" providerId="AD" clId="Web-{FD565D63-41E7-B8D3-1CC0-0E8F4802A810}" dt="2024-12-09T14:24:47.555" v="53" actId="14100"/>
          <ac:picMkLst>
            <pc:docMk/>
            <pc:sldMk cId="3818458034" sldId="392"/>
            <ac:picMk id="2" creationId="{A6F75A81-814B-699D-7CC0-2F38B1DBF462}"/>
          </ac:picMkLst>
        </pc:picChg>
        <pc:picChg chg="add mod">
          <ac:chgData name="Belaid, Sirine" userId="S::belaids@upmc.edu::5dcb4cf5-c058-49ea-93f8-4f4e6c877fcd" providerId="AD" clId="Web-{FD565D63-41E7-B8D3-1CC0-0E8F4802A810}" dt="2024-12-09T14:24:33.039" v="50" actId="14100"/>
          <ac:picMkLst>
            <pc:docMk/>
            <pc:sldMk cId="3818458034" sldId="392"/>
            <ac:picMk id="6" creationId="{B712A7C5-71E4-8212-4326-C6BBB95A457C}"/>
          </ac:picMkLst>
        </pc:picChg>
      </pc:sldChg>
    </pc:docChg>
  </pc:docChgLst>
  <pc:docChgLst>
    <pc:chgData name="Belaid, Sirine" userId="S::belaids@upmc.edu::5dcb4cf5-c058-49ea-93f8-4f4e6c877fcd" providerId="AD" clId="Web-{4ADD7696-066A-E0D1-576D-F83DB8BE30CB}"/>
    <pc:docChg chg="modSld">
      <pc:chgData name="Belaid, Sirine" userId="S::belaids@upmc.edu::5dcb4cf5-c058-49ea-93f8-4f4e6c877fcd" providerId="AD" clId="Web-{4ADD7696-066A-E0D1-576D-F83DB8BE30CB}" dt="2025-01-02T15:03:23.736" v="7" actId="20577"/>
      <pc:docMkLst>
        <pc:docMk/>
      </pc:docMkLst>
      <pc:sldChg chg="modSp">
        <pc:chgData name="Belaid, Sirine" userId="S::belaids@upmc.edu::5dcb4cf5-c058-49ea-93f8-4f4e6c877fcd" providerId="AD" clId="Web-{4ADD7696-066A-E0D1-576D-F83DB8BE30CB}" dt="2025-01-02T15:03:23.736" v="7" actId="20577"/>
        <pc:sldMkLst>
          <pc:docMk/>
          <pc:sldMk cId="1919480477" sldId="360"/>
        </pc:sldMkLst>
        <pc:spChg chg="mod">
          <ac:chgData name="Belaid, Sirine" userId="S::belaids@upmc.edu::5dcb4cf5-c058-49ea-93f8-4f4e6c877fcd" providerId="AD" clId="Web-{4ADD7696-066A-E0D1-576D-F83DB8BE30CB}" dt="2025-01-02T15:03:23.736" v="7" actId="20577"/>
          <ac:spMkLst>
            <pc:docMk/>
            <pc:sldMk cId="1919480477" sldId="360"/>
            <ac:spMk id="3" creationId="{6CCD5ABF-F289-6DF4-D01E-776F3BB7441A}"/>
          </ac:spMkLst>
        </pc:spChg>
      </pc:sldChg>
    </pc:docChg>
  </pc:docChgLst>
  <pc:docChgLst>
    <pc:chgData name="Belaid, Sirine" userId="S::belaids@upmc.edu::5dcb4cf5-c058-49ea-93f8-4f4e6c877fcd" providerId="AD" clId="Web-{FB2D7AA6-6C06-E74D-CCED-92D2B0A7E5AB}"/>
    <pc:docChg chg="addSld modSld">
      <pc:chgData name="Belaid, Sirine" userId="S::belaids@upmc.edu::5dcb4cf5-c058-49ea-93f8-4f4e6c877fcd" providerId="AD" clId="Web-{FB2D7AA6-6C06-E74D-CCED-92D2B0A7E5AB}" dt="2024-12-10T02:29:57.067" v="532"/>
      <pc:docMkLst>
        <pc:docMk/>
      </pc:docMkLst>
      <pc:sldChg chg="modSp">
        <pc:chgData name="Belaid, Sirine" userId="S::belaids@upmc.edu::5dcb4cf5-c058-49ea-93f8-4f4e6c877fcd" providerId="AD" clId="Web-{FB2D7AA6-6C06-E74D-CCED-92D2B0A7E5AB}" dt="2024-12-09T21:53:30.448" v="158" actId="20577"/>
        <pc:sldMkLst>
          <pc:docMk/>
          <pc:sldMk cId="412412650" sldId="391"/>
        </pc:sldMkLst>
        <pc:spChg chg="mod">
          <ac:chgData name="Belaid, Sirine" userId="S::belaids@upmc.edu::5dcb4cf5-c058-49ea-93f8-4f4e6c877fcd" providerId="AD" clId="Web-{FB2D7AA6-6C06-E74D-CCED-92D2B0A7E5AB}" dt="2024-12-09T21:53:30.448" v="158" actId="20577"/>
          <ac:spMkLst>
            <pc:docMk/>
            <pc:sldMk cId="412412650" sldId="391"/>
            <ac:spMk id="3" creationId="{58D555CA-A0A4-BD5A-C7A5-51D39BF63446}"/>
          </ac:spMkLst>
        </pc:spChg>
      </pc:sldChg>
      <pc:sldChg chg="modSp new">
        <pc:chgData name="Belaid, Sirine" userId="S::belaids@upmc.edu::5dcb4cf5-c058-49ea-93f8-4f4e6c877fcd" providerId="AD" clId="Web-{FB2D7AA6-6C06-E74D-CCED-92D2B0A7E5AB}" dt="2024-12-09T22:47:55.986" v="179" actId="20577"/>
        <pc:sldMkLst>
          <pc:docMk/>
          <pc:sldMk cId="1731714019" sldId="393"/>
        </pc:sldMkLst>
        <pc:spChg chg="mod">
          <ac:chgData name="Belaid, Sirine" userId="S::belaids@upmc.edu::5dcb4cf5-c058-49ea-93f8-4f4e6c877fcd" providerId="AD" clId="Web-{FB2D7AA6-6C06-E74D-CCED-92D2B0A7E5AB}" dt="2024-12-09T22:11:45.538" v="166" actId="20577"/>
          <ac:spMkLst>
            <pc:docMk/>
            <pc:sldMk cId="1731714019" sldId="393"/>
            <ac:spMk id="2" creationId="{333500BA-240B-4E4F-1936-2100A23516CA}"/>
          </ac:spMkLst>
        </pc:spChg>
        <pc:spChg chg="mod">
          <ac:chgData name="Belaid, Sirine" userId="S::belaids@upmc.edu::5dcb4cf5-c058-49ea-93f8-4f4e6c877fcd" providerId="AD" clId="Web-{FB2D7AA6-6C06-E74D-CCED-92D2B0A7E5AB}" dt="2024-12-09T22:47:55.986" v="179" actId="20577"/>
          <ac:spMkLst>
            <pc:docMk/>
            <pc:sldMk cId="1731714019" sldId="393"/>
            <ac:spMk id="3" creationId="{4A01C084-E4E4-6950-077A-5C215D5C06BE}"/>
          </ac:spMkLst>
        </pc:spChg>
      </pc:sldChg>
      <pc:sldChg chg="addSp modSp new mod setBg">
        <pc:chgData name="Belaid, Sirine" userId="S::belaids@upmc.edu::5dcb4cf5-c058-49ea-93f8-4f4e6c877fcd" providerId="AD" clId="Web-{FB2D7AA6-6C06-E74D-CCED-92D2B0A7E5AB}" dt="2024-12-09T22:15:06.310" v="176"/>
        <pc:sldMkLst>
          <pc:docMk/>
          <pc:sldMk cId="2086705072" sldId="394"/>
        </pc:sldMkLst>
        <pc:picChg chg="add mod">
          <ac:chgData name="Belaid, Sirine" userId="S::belaids@upmc.edu::5dcb4cf5-c058-49ea-93f8-4f4e6c877fcd" providerId="AD" clId="Web-{FB2D7AA6-6C06-E74D-CCED-92D2B0A7E5AB}" dt="2024-12-09T22:15:06.310" v="176"/>
          <ac:picMkLst>
            <pc:docMk/>
            <pc:sldMk cId="2086705072" sldId="394"/>
            <ac:picMk id="2" creationId="{0AAF42F8-7009-623A-9BD1-677722DF31B7}"/>
          </ac:picMkLst>
        </pc:picChg>
      </pc:sldChg>
      <pc:sldChg chg="addSp modSp new modNotes">
        <pc:chgData name="Belaid, Sirine" userId="S::belaids@upmc.edu::5dcb4cf5-c058-49ea-93f8-4f4e6c877fcd" providerId="AD" clId="Web-{FB2D7AA6-6C06-E74D-CCED-92D2B0A7E5AB}" dt="2024-12-10T02:29:57.067" v="532"/>
        <pc:sldMkLst>
          <pc:docMk/>
          <pc:sldMk cId="1625999220" sldId="395"/>
        </pc:sldMkLst>
        <pc:graphicFrameChg chg="add mod modGraphic">
          <ac:chgData name="Belaid, Sirine" userId="S::belaids@upmc.edu::5dcb4cf5-c058-49ea-93f8-4f4e6c877fcd" providerId="AD" clId="Web-{FB2D7AA6-6C06-E74D-CCED-92D2B0A7E5AB}" dt="2024-12-10T02:29:57.067" v="532"/>
          <ac:graphicFrameMkLst>
            <pc:docMk/>
            <pc:sldMk cId="1625999220" sldId="395"/>
            <ac:graphicFrameMk id="2" creationId="{5AF5F66F-7F30-C7FD-12D8-EE5A388FDE96}"/>
          </ac:graphicFrameMkLst>
        </pc:graphicFrameChg>
      </pc:sldChg>
    </pc:docChg>
  </pc:docChgLst>
</pc:chgInfo>
</file>

<file path=ppt/diagrams/colors1.xml><?xml version="1.0" encoding="utf-8"?>
<dgm:colorsDef xmlns:dgm="http://schemas.openxmlformats.org/drawingml/2006/diagram" xmlns:a="http://schemas.openxmlformats.org/drawingml/2006/main" uniqueId="urn:microsoft.com/office/officeart/2005/8/colors/accent0_3">
  <dgm:title val=""/>
  <dgm:desc val=""/>
  <dgm:catLst>
    <dgm:cat type="mainScheme" pri="10300"/>
  </dgm:catLst>
  <dgm:styleLbl name="node0">
    <dgm:fillClrLst meth="repeat">
      <a:schemeClr val="dk2"/>
    </dgm:fillClrLst>
    <dgm:linClrLst meth="repeat">
      <a:schemeClr val="lt2"/>
    </dgm:linClrLst>
    <dgm:effectClrLst/>
    <dgm:txLinClrLst/>
    <dgm:txFillClrLst/>
    <dgm:txEffectClrLst/>
  </dgm:styleLbl>
  <dgm:styleLbl name="alignNode1">
    <dgm:fillClrLst meth="repeat">
      <a:schemeClr val="dk2"/>
    </dgm:fillClrLst>
    <dgm:linClrLst meth="repeat">
      <a:schemeClr val="dk2"/>
    </dgm:linClrLst>
    <dgm:effectClrLst/>
    <dgm:txLinClrLst/>
    <dgm:txFillClrLst/>
    <dgm:txEffectClrLst/>
  </dgm:styleLbl>
  <dgm:styleLbl name="node1">
    <dgm:fillClrLst meth="repeat">
      <a:schemeClr val="dk2"/>
    </dgm:fillClrLst>
    <dgm:linClrLst meth="repeat">
      <a:schemeClr val="lt2"/>
    </dgm:linClrLst>
    <dgm:effectClrLst/>
    <dgm:txLinClrLst/>
    <dgm:txFillClrLst/>
    <dgm:txEffectClrLst/>
  </dgm:styleLbl>
  <dgm:styleLbl name="lnNode1">
    <dgm:fillClrLst meth="repeat">
      <a:schemeClr val="dk2"/>
    </dgm:fillClrLst>
    <dgm:linClrLst meth="repeat">
      <a:schemeClr val="lt2"/>
    </dgm:linClrLst>
    <dgm:effectClrLst/>
    <dgm:txLinClrLst/>
    <dgm:txFillClrLst/>
    <dgm:txEffectClrLst/>
  </dgm:styleLbl>
  <dgm:styleLbl name="vennNode1">
    <dgm:fillClrLst meth="repeat">
      <a:schemeClr val="dk2">
        <a:alpha val="50000"/>
      </a:schemeClr>
    </dgm:fillClrLst>
    <dgm:linClrLst meth="repeat">
      <a:schemeClr val="lt2"/>
    </dgm:linClrLst>
    <dgm:effectClrLst/>
    <dgm:txLinClrLst/>
    <dgm:txFillClrLst/>
    <dgm:txEffectClrLst/>
  </dgm:styleLbl>
  <dgm:styleLbl name="node2">
    <dgm:fillClrLst meth="repeat">
      <a:schemeClr val="dk2"/>
    </dgm:fillClrLst>
    <dgm:linClrLst meth="repeat">
      <a:schemeClr val="lt2"/>
    </dgm:linClrLst>
    <dgm:effectClrLst/>
    <dgm:txLinClrLst/>
    <dgm:txFillClrLst/>
    <dgm:txEffectClrLst/>
  </dgm:styleLbl>
  <dgm:styleLbl name="node3">
    <dgm:fillClrLst meth="repeat">
      <a:schemeClr val="dk2"/>
    </dgm:fillClrLst>
    <dgm:linClrLst meth="repeat">
      <a:schemeClr val="lt2"/>
    </dgm:linClrLst>
    <dgm:effectClrLst/>
    <dgm:txLinClrLst/>
    <dgm:txFillClrLst/>
    <dgm:txEffectClrLst/>
  </dgm:styleLbl>
  <dgm:styleLbl name="node4">
    <dgm:fillClrLst meth="repeat">
      <a:schemeClr val="dk2"/>
    </dgm:fillClrLst>
    <dgm:linClrLst meth="repeat">
      <a:schemeClr val="lt2"/>
    </dgm:linClrLst>
    <dgm:effectClrLst/>
    <dgm:txLinClrLst/>
    <dgm:txFillClrLst/>
    <dgm:txEffectClrLst/>
  </dgm:styleLbl>
  <dgm:styleLbl name="fgImgPlace1">
    <dgm:fillClrLst meth="repeat">
      <a:schemeClr val="dk2">
        <a:tint val="50000"/>
      </a:schemeClr>
    </dgm:fillClrLst>
    <dgm:linClrLst meth="repeat">
      <a:schemeClr val="lt2"/>
    </dgm:linClrLst>
    <dgm:effectClrLst/>
    <dgm:txLinClrLst/>
    <dgm:txFillClrLst meth="repeat">
      <a:schemeClr val="lt2"/>
    </dgm:txFillClrLst>
    <dgm:txEffectClrLst/>
  </dgm:styleLbl>
  <dgm:styleLbl name="align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bgImgPlace1">
    <dgm:fillClrLst meth="repeat">
      <a:schemeClr val="dk2">
        <a:tint val="50000"/>
      </a:schemeClr>
    </dgm:fillClrLst>
    <dgm:linClrLst meth="repeat">
      <a:schemeClr val="dk2">
        <a:shade val="80000"/>
      </a:schemeClr>
    </dgm:linClrLst>
    <dgm:effectClrLst/>
    <dgm:txLinClrLst/>
    <dgm:txFillClrLst meth="repeat">
      <a:schemeClr val="lt2"/>
    </dgm:txFillClrLst>
    <dgm:txEffectClrLst/>
  </dgm:styleLbl>
  <dgm:styleLbl name="sibTrans2D1">
    <dgm:fillClrLst meth="repeat">
      <a:schemeClr val="dk2">
        <a:tint val="60000"/>
      </a:schemeClr>
    </dgm:fillClrLst>
    <dgm:linClrLst meth="repeat">
      <a:schemeClr val="dk2">
        <a:tint val="60000"/>
      </a:schemeClr>
    </dgm:linClrLst>
    <dgm:effectClrLst/>
    <dgm:txLinClrLst/>
    <dgm:txFillClrLst/>
    <dgm:txEffectClrLst/>
  </dgm:styleLbl>
  <dgm:styleLbl name="fgSibTrans2D1">
    <dgm:fillClrLst meth="repeat">
      <a:schemeClr val="dk2">
        <a:tint val="60000"/>
      </a:schemeClr>
    </dgm:fillClrLst>
    <dgm:linClrLst meth="repeat">
      <a:schemeClr val="dk2">
        <a:tint val="60000"/>
      </a:schemeClr>
    </dgm:linClrLst>
    <dgm:effectClrLst/>
    <dgm:txLinClrLst/>
    <dgm:txFillClrLst/>
    <dgm:txEffectClrLst/>
  </dgm:styleLbl>
  <dgm:styleLbl name="bgSibTrans2D1">
    <dgm:fillClrLst meth="repeat">
      <a:schemeClr val="dk2">
        <a:tint val="60000"/>
      </a:schemeClr>
    </dgm:fillClrLst>
    <dgm:linClrLst meth="repeat">
      <a:schemeClr val="dk2">
        <a:tint val="60000"/>
      </a:schemeClr>
    </dgm:linClrLst>
    <dgm:effectClrLst/>
    <dgm:txLinClrLst/>
    <dgm:txFillClrLst/>
    <dgm:txEffectClrLst/>
  </dgm:styleLbl>
  <dgm:styleLbl name="sibTrans1D1">
    <dgm:fillClrLst meth="repeat">
      <a:schemeClr val="dk2"/>
    </dgm:fillClrLst>
    <dgm:linClrLst meth="repeat">
      <a:schemeClr val="dk2"/>
    </dgm:linClrLst>
    <dgm:effectClrLst/>
    <dgm:txLinClrLst/>
    <dgm:txFillClrLst meth="repeat">
      <a:schemeClr val="lt2"/>
    </dgm:txFillClrLst>
    <dgm:txEffectClrLst/>
  </dgm:styleLbl>
  <dgm:styleLbl name="callout">
    <dgm:fillClrLst meth="repeat">
      <a:schemeClr val="dk2"/>
    </dgm:fillClrLst>
    <dgm:linClrLst meth="repeat">
      <a:schemeClr val="dk2">
        <a:tint val="50000"/>
      </a:schemeClr>
    </dgm:linClrLst>
    <dgm:effectClrLst/>
    <dgm:txLinClrLst/>
    <dgm:txFillClrLst meth="repeat">
      <a:schemeClr val="lt2"/>
    </dgm:txFillClrLst>
    <dgm:txEffectClrLst/>
  </dgm:styleLbl>
  <dgm:styleLbl name="asst0">
    <dgm:fillClrLst meth="repeat">
      <a:schemeClr val="dk2"/>
    </dgm:fillClrLst>
    <dgm:linClrLst meth="repeat">
      <a:schemeClr val="lt2"/>
    </dgm:linClrLst>
    <dgm:effectClrLst/>
    <dgm:txLinClrLst/>
    <dgm:txFillClrLst/>
    <dgm:txEffectClrLst/>
  </dgm:styleLbl>
  <dgm:styleLbl name="asst1">
    <dgm:fillClrLst meth="repeat">
      <a:schemeClr val="dk2"/>
    </dgm:fillClrLst>
    <dgm:linClrLst meth="repeat">
      <a:schemeClr val="lt2"/>
    </dgm:linClrLst>
    <dgm:effectClrLst/>
    <dgm:txLinClrLst/>
    <dgm:txFillClrLst/>
    <dgm:txEffectClrLst/>
  </dgm:styleLbl>
  <dgm:styleLbl name="asst2">
    <dgm:fillClrLst meth="repeat">
      <a:schemeClr val="dk2"/>
    </dgm:fillClrLst>
    <dgm:linClrLst meth="repeat">
      <a:schemeClr val="lt2"/>
    </dgm:linClrLst>
    <dgm:effectClrLst/>
    <dgm:txLinClrLst/>
    <dgm:txFillClrLst/>
    <dgm:txEffectClrLst/>
  </dgm:styleLbl>
  <dgm:styleLbl name="asst3">
    <dgm:fillClrLst meth="repeat">
      <a:schemeClr val="dk2"/>
    </dgm:fillClrLst>
    <dgm:linClrLst meth="repeat">
      <a:schemeClr val="lt2"/>
    </dgm:linClrLst>
    <dgm:effectClrLst/>
    <dgm:txLinClrLst/>
    <dgm:txFillClrLst/>
    <dgm:txEffectClrLst/>
  </dgm:styleLbl>
  <dgm:styleLbl name="asst4">
    <dgm:fillClrLst meth="repeat">
      <a:schemeClr val="dk2"/>
    </dgm:fillClrLst>
    <dgm:linClrLst meth="repeat">
      <a:schemeClr val="lt2"/>
    </dgm:linClrLst>
    <dgm:effectClrLst/>
    <dgm:txLinClrLst/>
    <dgm:txFillClrLst/>
    <dgm:txEffectClrLst/>
  </dgm:styleLbl>
  <dgm:styleLbl name="parChTrans2D1">
    <dgm:fillClrLst meth="repeat">
      <a:schemeClr val="dk2">
        <a:tint val="60000"/>
      </a:schemeClr>
    </dgm:fillClrLst>
    <dgm:linClrLst meth="repeat">
      <a:schemeClr val="dk2">
        <a:tint val="60000"/>
      </a:schemeClr>
    </dgm:linClrLst>
    <dgm:effectClrLst/>
    <dgm:txLinClrLst/>
    <dgm:txFillClrLst meth="repeat">
      <a:schemeClr val="lt2"/>
    </dgm:txFillClrLst>
    <dgm:txEffectClrLst/>
  </dgm:styleLbl>
  <dgm:styleLbl name="parChTrans2D2">
    <dgm:fillClrLst meth="repeat">
      <a:schemeClr val="dk2"/>
    </dgm:fillClrLst>
    <dgm:linClrLst meth="repeat">
      <a:schemeClr val="dk2"/>
    </dgm:linClrLst>
    <dgm:effectClrLst/>
    <dgm:txLinClrLst/>
    <dgm:txFillClrLst meth="repeat">
      <a:schemeClr val="lt2"/>
    </dgm:txFillClrLst>
    <dgm:txEffectClrLst/>
  </dgm:styleLbl>
  <dgm:styleLbl name="parChTrans2D3">
    <dgm:fillClrLst meth="repeat">
      <a:schemeClr val="dk2"/>
    </dgm:fillClrLst>
    <dgm:linClrLst meth="repeat">
      <a:schemeClr val="dk2"/>
    </dgm:linClrLst>
    <dgm:effectClrLst/>
    <dgm:txLinClrLst/>
    <dgm:txFillClrLst meth="repeat">
      <a:schemeClr val="lt2"/>
    </dgm:txFillClrLst>
    <dgm:txEffectClrLst/>
  </dgm:styleLbl>
  <dgm:styleLbl name="parChTrans2D4">
    <dgm:fillClrLst meth="repeat">
      <a:schemeClr val="dk2"/>
    </dgm:fillClrLst>
    <dgm:linClrLst meth="repeat">
      <a:schemeClr val="dk2"/>
    </dgm:linClrLst>
    <dgm:effectClrLst/>
    <dgm:txLinClrLst/>
    <dgm:txFillClrLst meth="repeat">
      <a:schemeClr val="lt2"/>
    </dgm:txFillClrLst>
    <dgm:txEffectClrLst/>
  </dgm:styleLbl>
  <dgm:styleLbl name="parChTrans1D1">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2">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3">
    <dgm:fillClrLst meth="repeat">
      <a:schemeClr val="dk2"/>
    </dgm:fillClrLst>
    <dgm:linClrLst meth="repeat">
      <a:schemeClr val="dk2">
        <a:shade val="80000"/>
      </a:schemeClr>
    </dgm:linClrLst>
    <dgm:effectClrLst/>
    <dgm:txLinClrLst/>
    <dgm:txFillClrLst meth="repeat">
      <a:schemeClr val="tx1"/>
    </dgm:txFillClrLst>
    <dgm:txEffectClrLst/>
  </dgm:styleLbl>
  <dgm:styleLbl name="parChTrans1D4">
    <dgm:fillClrLst meth="repeat">
      <a:schemeClr val="dk2"/>
    </dgm:fillClrLst>
    <dgm:linClrLst meth="repeat">
      <a:schemeClr val="dk2">
        <a:shade val="80000"/>
      </a:schemeClr>
    </dgm:linClrLst>
    <dgm:effectClrLst/>
    <dgm:txLinClrLst/>
    <dgm:txFillClrLst meth="repeat">
      <a:schemeClr val="tx1"/>
    </dgm:txFillClrLst>
    <dgm:txEffectClrLst/>
  </dgm:styleLbl>
  <dgm:styleLbl name="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conF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align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trAlignAcc1">
    <dgm:fillClrLst meth="repeat">
      <a:schemeClr val="lt2">
        <a:alpha val="40000"/>
      </a:schemeClr>
    </dgm:fillClrLst>
    <dgm:linClrLst meth="repeat">
      <a:schemeClr val="dk2"/>
    </dgm:linClrLst>
    <dgm:effectClrLst/>
    <dgm:txLinClrLst/>
    <dgm:txFillClrLst meth="repeat">
      <a:schemeClr val="dk1"/>
    </dgm:txFillClrLst>
    <dgm:txEffectClrLst/>
  </dgm:styleLbl>
  <dgm:styleLbl name="bgAcc1">
    <dgm:fillClrLst meth="repeat">
      <a:schemeClr val="lt2">
        <a:alpha val="90000"/>
      </a:schemeClr>
    </dgm:fillClrLst>
    <dgm:linClrLst meth="repeat">
      <a:schemeClr val="dk2"/>
    </dgm:linClrLst>
    <dgm:effectClrLst/>
    <dgm:txLinClrLst/>
    <dgm:txFillClrLst meth="repeat">
      <a:schemeClr val="dk1"/>
    </dgm:txFillClrLst>
    <dgm:txEffectClrLst/>
  </dgm:styleLbl>
  <dgm:styleLbl name="solidFgAcc1">
    <dgm:fillClrLst meth="repeat">
      <a:schemeClr val="lt2"/>
    </dgm:fillClrLst>
    <dgm:linClrLst meth="repeat">
      <a:schemeClr val="dk2"/>
    </dgm:linClrLst>
    <dgm:effectClrLst/>
    <dgm:txLinClrLst/>
    <dgm:txFillClrLst meth="repeat">
      <a:schemeClr val="dk1"/>
    </dgm:txFillClrLst>
    <dgm:txEffectClrLst/>
  </dgm:styleLbl>
  <dgm:styleLbl name="solidAlignAcc1">
    <dgm:fillClrLst meth="repeat">
      <a:schemeClr val="lt2"/>
    </dgm:fillClrLst>
    <dgm:linClrLst meth="repeat">
      <a:schemeClr val="dk2"/>
    </dgm:linClrLst>
    <dgm:effectClrLst/>
    <dgm:txLinClrLst/>
    <dgm:txFillClrLst meth="repeat">
      <a:schemeClr val="dk1"/>
    </dgm:txFillClrLst>
    <dgm:txEffectClrLst/>
  </dgm:styleLbl>
  <dgm:styleLbl name="solidBgAcc1">
    <dgm:fillClrLst meth="repeat">
      <a:schemeClr val="lt2"/>
    </dgm:fillClrLst>
    <dgm:linClrLst meth="repeat">
      <a:schemeClr val="dk2"/>
    </dgm:linClrLst>
    <dgm:effectClrLst/>
    <dgm:txLinClrLst/>
    <dgm:txFillClrLst meth="repeat">
      <a:schemeClr val="dk1"/>
    </dgm:txFillClrLst>
    <dgm:txEffectClrLst/>
  </dgm:styleLbl>
  <dgm:styleLbl name="f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align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bgAccFollowNode1">
    <dgm:fillClrLst meth="repeat">
      <a:schemeClr val="dk2">
        <a:alpha val="90000"/>
        <a:tint val="40000"/>
      </a:schemeClr>
    </dgm:fillClrLst>
    <dgm:linClrLst meth="repeat">
      <a:schemeClr val="dk2">
        <a:alpha val="90000"/>
        <a:tint val="40000"/>
      </a:schemeClr>
    </dgm:linClrLst>
    <dgm:effectClrLst/>
    <dgm:txLinClrLst/>
    <dgm:txFillClrLst meth="repeat">
      <a:schemeClr val="dk1"/>
    </dgm:txFillClrLst>
    <dgm:txEffectClrLst/>
  </dgm:styleLbl>
  <dgm:styleLbl name="fgAcc0">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2">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3">
    <dgm:fillClrLst meth="repeat">
      <a:schemeClr val="lt2">
        <a:alpha val="90000"/>
      </a:schemeClr>
    </dgm:fillClrLst>
    <dgm:linClrLst meth="repeat">
      <a:schemeClr val="dk2"/>
    </dgm:linClrLst>
    <dgm:effectClrLst/>
    <dgm:txLinClrLst/>
    <dgm:txFillClrLst meth="repeat">
      <a:schemeClr val="dk1"/>
    </dgm:txFillClrLst>
    <dgm:txEffectClrLst/>
  </dgm:styleLbl>
  <dgm:styleLbl name="fgAcc4">
    <dgm:fillClrLst meth="repeat">
      <a:schemeClr val="lt2">
        <a:alpha val="90000"/>
      </a:schemeClr>
    </dgm:fillClrLst>
    <dgm:linClrLst meth="repeat">
      <a:schemeClr val="dk2"/>
    </dgm:linClrLst>
    <dgm:effectClrLst/>
    <dgm:txLinClrLst/>
    <dgm:txFillClrLst meth="repeat">
      <a:schemeClr val="dk1"/>
    </dgm:txFillClrLst>
    <dgm:txEffectClrLst/>
  </dgm:styleLbl>
  <dgm:styleLbl name="bgShp">
    <dgm:fillClrLst meth="repeat">
      <a:schemeClr val="dk2">
        <a:tint val="40000"/>
      </a:schemeClr>
    </dgm:fillClrLst>
    <dgm:linClrLst meth="repeat">
      <a:schemeClr val="dk2"/>
    </dgm:linClrLst>
    <dgm:effectClrLst/>
    <dgm:txLinClrLst/>
    <dgm:txFillClrLst meth="repeat">
      <a:schemeClr val="dk1"/>
    </dgm:txFillClrLst>
    <dgm:txEffectClrLst/>
  </dgm:styleLbl>
  <dgm:styleLbl name="dkBgShp">
    <dgm:fillClrLst meth="repeat">
      <a:schemeClr val="dk2">
        <a:shade val="80000"/>
      </a:schemeClr>
    </dgm:fillClrLst>
    <dgm:linClrLst meth="repeat">
      <a:schemeClr val="dk2"/>
    </dgm:linClrLst>
    <dgm:effectClrLst/>
    <dgm:txLinClrLst/>
    <dgm:txFillClrLst meth="repeat">
      <a:schemeClr val="lt1"/>
    </dgm:txFillClrLst>
    <dgm:txEffectClrLst/>
  </dgm:styleLbl>
  <dgm:styleLbl name="trBgShp">
    <dgm:fillClrLst meth="repeat">
      <a:schemeClr val="dk2">
        <a:tint val="50000"/>
        <a:alpha val="40000"/>
      </a:schemeClr>
    </dgm:fillClrLst>
    <dgm:linClrLst meth="repeat">
      <a:schemeClr val="dk2"/>
    </dgm:linClrLst>
    <dgm:effectClrLst/>
    <dgm:txLinClrLst/>
    <dgm:txFillClrLst meth="repeat">
      <a:schemeClr val="lt1"/>
    </dgm:txFillClrLst>
    <dgm:txEffectClrLst/>
  </dgm:styleLbl>
  <dgm:styleLbl name="fgShp">
    <dgm:fillClrLst meth="repeat">
      <a:schemeClr val="dk2">
        <a:tint val="60000"/>
      </a:schemeClr>
    </dgm:fillClrLst>
    <dgm:linClrLst meth="repeat">
      <a:schemeClr val="lt2"/>
    </dgm:linClrLst>
    <dgm:effectClrLst/>
    <dgm:txLinClrLst/>
    <dgm:txFillClrLst meth="repeat">
      <a:schemeClr val="dk1"/>
    </dgm:txFillClrLst>
    <dgm:txEffectClrLst/>
  </dgm:styleLbl>
  <dgm:styleLbl name="revTx">
    <dgm:fillClrLst meth="repeat">
      <a:schemeClr val="lt2">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B61A09A6-1D46-4B18-96DC-746F95EDD243}" type="doc">
      <dgm:prSet loTypeId="urn:microsoft.com/office/officeart/2005/8/layout/hierarchy1" loCatId="hierarchy" qsTypeId="urn:microsoft.com/office/officeart/2005/8/quickstyle/simple1" qsCatId="simple" csTypeId="urn:microsoft.com/office/officeart/2005/8/colors/accent0_3" csCatId="mainScheme"/>
      <dgm:spPr/>
      <dgm:t>
        <a:bodyPr/>
        <a:lstStyle/>
        <a:p>
          <a:endParaRPr lang="en-US"/>
        </a:p>
      </dgm:t>
    </dgm:pt>
    <dgm:pt modelId="{06F4AAD3-A1E7-4881-AAAD-5B18554454DE}">
      <dgm:prSet/>
      <dgm:spPr/>
      <dgm:t>
        <a:bodyPr/>
        <a:lstStyle/>
        <a:p>
          <a:r>
            <a:rPr lang="en-US" dirty="0"/>
            <a:t>Peripherally inserted central catheters (PICC)</a:t>
          </a:r>
        </a:p>
      </dgm:t>
    </dgm:pt>
    <dgm:pt modelId="{A40C42F3-64EA-4A0E-AC87-5E77E509F5E0}" type="parTrans" cxnId="{1D63E757-FED6-4F2E-A150-DEF98219D012}">
      <dgm:prSet/>
      <dgm:spPr/>
      <dgm:t>
        <a:bodyPr/>
        <a:lstStyle/>
        <a:p>
          <a:endParaRPr lang="en-US"/>
        </a:p>
      </dgm:t>
    </dgm:pt>
    <dgm:pt modelId="{EAB8F4E8-1E28-45EE-A69F-8C49278CEFB9}" type="sibTrans" cxnId="{1D63E757-FED6-4F2E-A150-DEF98219D012}">
      <dgm:prSet/>
      <dgm:spPr/>
      <dgm:t>
        <a:bodyPr/>
        <a:lstStyle/>
        <a:p>
          <a:endParaRPr lang="en-US"/>
        </a:p>
      </dgm:t>
    </dgm:pt>
    <dgm:pt modelId="{FDE14FA0-E41C-481D-9ED6-7D206B215776}">
      <dgm:prSet/>
      <dgm:spPr/>
      <dgm:t>
        <a:bodyPr/>
        <a:lstStyle/>
        <a:p>
          <a:r>
            <a:rPr lang="en-US" dirty="0"/>
            <a:t>Tunneled central catheter</a:t>
          </a:r>
        </a:p>
      </dgm:t>
    </dgm:pt>
    <dgm:pt modelId="{3FCA837E-348B-4F11-A3A7-DC419A28968B}" type="parTrans" cxnId="{0B706DD1-2D57-4112-B11A-EA413C03F49D}">
      <dgm:prSet/>
      <dgm:spPr/>
      <dgm:t>
        <a:bodyPr/>
        <a:lstStyle/>
        <a:p>
          <a:endParaRPr lang="en-US"/>
        </a:p>
      </dgm:t>
    </dgm:pt>
    <dgm:pt modelId="{70C3C6B6-8B31-4A8B-93CE-1CF3D5D29E0C}" type="sibTrans" cxnId="{0B706DD1-2D57-4112-B11A-EA413C03F49D}">
      <dgm:prSet/>
      <dgm:spPr/>
      <dgm:t>
        <a:bodyPr/>
        <a:lstStyle/>
        <a:p>
          <a:endParaRPr lang="en-US"/>
        </a:p>
      </dgm:t>
    </dgm:pt>
    <dgm:pt modelId="{E157AFBA-67B0-4D3F-B966-05DD8B91694F}">
      <dgm:prSet/>
      <dgm:spPr/>
      <dgm:t>
        <a:bodyPr/>
        <a:lstStyle/>
        <a:p>
          <a:r>
            <a:rPr lang="en-US">
              <a:latin typeface="Aptos Display" panose="020F0302020204030204"/>
            </a:rPr>
            <a:t>Port</a:t>
          </a:r>
          <a:r>
            <a:rPr lang="en-US"/>
            <a:t> </a:t>
          </a:r>
        </a:p>
      </dgm:t>
    </dgm:pt>
    <dgm:pt modelId="{9E7AA4B3-8ED0-4471-BE20-D4EA0EAFCF7D}" type="parTrans" cxnId="{CA6FA7D6-0F6B-43A0-8D92-C0C43C653D3A}">
      <dgm:prSet/>
      <dgm:spPr/>
      <dgm:t>
        <a:bodyPr/>
        <a:lstStyle/>
        <a:p>
          <a:endParaRPr lang="en-US"/>
        </a:p>
      </dgm:t>
    </dgm:pt>
    <dgm:pt modelId="{B064AB63-9B98-4499-838B-227A1BA8FEA8}" type="sibTrans" cxnId="{CA6FA7D6-0F6B-43A0-8D92-C0C43C653D3A}">
      <dgm:prSet/>
      <dgm:spPr/>
      <dgm:t>
        <a:bodyPr/>
        <a:lstStyle/>
        <a:p>
          <a:endParaRPr lang="en-US"/>
        </a:p>
      </dgm:t>
    </dgm:pt>
    <dgm:pt modelId="{552DE669-092F-483B-9CC5-00CB89C29F3B}" type="pres">
      <dgm:prSet presAssocID="{B61A09A6-1D46-4B18-96DC-746F95EDD243}" presName="hierChild1" presStyleCnt="0">
        <dgm:presLayoutVars>
          <dgm:chPref val="1"/>
          <dgm:dir/>
          <dgm:animOne val="branch"/>
          <dgm:animLvl val="lvl"/>
          <dgm:resizeHandles/>
        </dgm:presLayoutVars>
      </dgm:prSet>
      <dgm:spPr/>
    </dgm:pt>
    <dgm:pt modelId="{E454CDFA-0CA6-4CA2-8F0D-4C48A98BC283}" type="pres">
      <dgm:prSet presAssocID="{06F4AAD3-A1E7-4881-AAAD-5B18554454DE}" presName="hierRoot1" presStyleCnt="0"/>
      <dgm:spPr/>
    </dgm:pt>
    <dgm:pt modelId="{40C9E0C1-315D-4BC1-BD94-39C1094A4740}" type="pres">
      <dgm:prSet presAssocID="{06F4AAD3-A1E7-4881-AAAD-5B18554454DE}" presName="composite" presStyleCnt="0"/>
      <dgm:spPr/>
    </dgm:pt>
    <dgm:pt modelId="{71C7DC09-C077-4386-BC7F-C795F0BCA1B5}" type="pres">
      <dgm:prSet presAssocID="{06F4AAD3-A1E7-4881-AAAD-5B18554454DE}" presName="background" presStyleLbl="node0" presStyleIdx="0" presStyleCnt="3"/>
      <dgm:spPr/>
    </dgm:pt>
    <dgm:pt modelId="{8DB5D357-6808-43B3-BD9F-4CAF7F966CB9}" type="pres">
      <dgm:prSet presAssocID="{06F4AAD3-A1E7-4881-AAAD-5B18554454DE}" presName="text" presStyleLbl="fgAcc0" presStyleIdx="0" presStyleCnt="3">
        <dgm:presLayoutVars>
          <dgm:chPref val="3"/>
        </dgm:presLayoutVars>
      </dgm:prSet>
      <dgm:spPr/>
    </dgm:pt>
    <dgm:pt modelId="{A7E98064-ECB4-42F9-A8E3-43CDEDB39367}" type="pres">
      <dgm:prSet presAssocID="{06F4AAD3-A1E7-4881-AAAD-5B18554454DE}" presName="hierChild2" presStyleCnt="0"/>
      <dgm:spPr/>
    </dgm:pt>
    <dgm:pt modelId="{7EAD380E-ED6A-4AF3-BD56-73ABD241B679}" type="pres">
      <dgm:prSet presAssocID="{FDE14FA0-E41C-481D-9ED6-7D206B215776}" presName="hierRoot1" presStyleCnt="0"/>
      <dgm:spPr/>
    </dgm:pt>
    <dgm:pt modelId="{5092D1BD-C52E-403E-B0F9-5339ED6D018B}" type="pres">
      <dgm:prSet presAssocID="{FDE14FA0-E41C-481D-9ED6-7D206B215776}" presName="composite" presStyleCnt="0"/>
      <dgm:spPr/>
    </dgm:pt>
    <dgm:pt modelId="{C1E41067-406C-4B91-BC33-F6B5B0744E9E}" type="pres">
      <dgm:prSet presAssocID="{FDE14FA0-E41C-481D-9ED6-7D206B215776}" presName="background" presStyleLbl="node0" presStyleIdx="1" presStyleCnt="3"/>
      <dgm:spPr/>
    </dgm:pt>
    <dgm:pt modelId="{D25569CB-8614-4B19-98F6-5B13B5948A2F}" type="pres">
      <dgm:prSet presAssocID="{FDE14FA0-E41C-481D-9ED6-7D206B215776}" presName="text" presStyleLbl="fgAcc0" presStyleIdx="1" presStyleCnt="3">
        <dgm:presLayoutVars>
          <dgm:chPref val="3"/>
        </dgm:presLayoutVars>
      </dgm:prSet>
      <dgm:spPr/>
    </dgm:pt>
    <dgm:pt modelId="{5BD14C40-6940-493F-BE4D-1870E0B42307}" type="pres">
      <dgm:prSet presAssocID="{FDE14FA0-E41C-481D-9ED6-7D206B215776}" presName="hierChild2" presStyleCnt="0"/>
      <dgm:spPr/>
    </dgm:pt>
    <dgm:pt modelId="{02CA64CB-7F55-4A15-B6CE-EA806C3E9067}" type="pres">
      <dgm:prSet presAssocID="{E157AFBA-67B0-4D3F-B966-05DD8B91694F}" presName="hierRoot1" presStyleCnt="0"/>
      <dgm:spPr/>
    </dgm:pt>
    <dgm:pt modelId="{DE27669C-951E-4492-9CED-A6C6B794CA1F}" type="pres">
      <dgm:prSet presAssocID="{E157AFBA-67B0-4D3F-B966-05DD8B91694F}" presName="composite" presStyleCnt="0"/>
      <dgm:spPr/>
    </dgm:pt>
    <dgm:pt modelId="{56E888F0-EE27-47BD-9BB1-FE6D7D3F12B0}" type="pres">
      <dgm:prSet presAssocID="{E157AFBA-67B0-4D3F-B966-05DD8B91694F}" presName="background" presStyleLbl="node0" presStyleIdx="2" presStyleCnt="3"/>
      <dgm:spPr/>
    </dgm:pt>
    <dgm:pt modelId="{98735A31-33A2-4BA0-A86A-337DB3E4816C}" type="pres">
      <dgm:prSet presAssocID="{E157AFBA-67B0-4D3F-B966-05DD8B91694F}" presName="text" presStyleLbl="fgAcc0" presStyleIdx="2" presStyleCnt="3">
        <dgm:presLayoutVars>
          <dgm:chPref val="3"/>
        </dgm:presLayoutVars>
      </dgm:prSet>
      <dgm:spPr/>
    </dgm:pt>
    <dgm:pt modelId="{D4CD483A-0126-4B55-B890-C1765A179B1B}" type="pres">
      <dgm:prSet presAssocID="{E157AFBA-67B0-4D3F-B966-05DD8B91694F}" presName="hierChild2" presStyleCnt="0"/>
      <dgm:spPr/>
    </dgm:pt>
  </dgm:ptLst>
  <dgm:cxnLst>
    <dgm:cxn modelId="{58005D10-3330-44B0-8EE5-2D0BA912A00C}" type="presOf" srcId="{B61A09A6-1D46-4B18-96DC-746F95EDD243}" destId="{552DE669-092F-483B-9CC5-00CB89C29F3B}" srcOrd="0" destOrd="0" presId="urn:microsoft.com/office/officeart/2005/8/layout/hierarchy1"/>
    <dgm:cxn modelId="{8F9D4F30-EFAA-4D24-B229-29CBF0AA611B}" type="presOf" srcId="{E157AFBA-67B0-4D3F-B966-05DD8B91694F}" destId="{98735A31-33A2-4BA0-A86A-337DB3E4816C}" srcOrd="0" destOrd="0" presId="urn:microsoft.com/office/officeart/2005/8/layout/hierarchy1"/>
    <dgm:cxn modelId="{F0F50C3A-EEE9-4A5C-8980-130DBCFBF65E}" type="presOf" srcId="{FDE14FA0-E41C-481D-9ED6-7D206B215776}" destId="{D25569CB-8614-4B19-98F6-5B13B5948A2F}" srcOrd="0" destOrd="0" presId="urn:microsoft.com/office/officeart/2005/8/layout/hierarchy1"/>
    <dgm:cxn modelId="{1D63E757-FED6-4F2E-A150-DEF98219D012}" srcId="{B61A09A6-1D46-4B18-96DC-746F95EDD243}" destId="{06F4AAD3-A1E7-4881-AAAD-5B18554454DE}" srcOrd="0" destOrd="0" parTransId="{A40C42F3-64EA-4A0E-AC87-5E77E509F5E0}" sibTransId="{EAB8F4E8-1E28-45EE-A69F-8C49278CEFB9}"/>
    <dgm:cxn modelId="{0B706DD1-2D57-4112-B11A-EA413C03F49D}" srcId="{B61A09A6-1D46-4B18-96DC-746F95EDD243}" destId="{FDE14FA0-E41C-481D-9ED6-7D206B215776}" srcOrd="1" destOrd="0" parTransId="{3FCA837E-348B-4F11-A3A7-DC419A28968B}" sibTransId="{70C3C6B6-8B31-4A8B-93CE-1CF3D5D29E0C}"/>
    <dgm:cxn modelId="{CA6FA7D6-0F6B-43A0-8D92-C0C43C653D3A}" srcId="{B61A09A6-1D46-4B18-96DC-746F95EDD243}" destId="{E157AFBA-67B0-4D3F-B966-05DD8B91694F}" srcOrd="2" destOrd="0" parTransId="{9E7AA4B3-8ED0-4471-BE20-D4EA0EAFCF7D}" sibTransId="{B064AB63-9B98-4499-838B-227A1BA8FEA8}"/>
    <dgm:cxn modelId="{7C14C6EA-CEA4-49C1-8AA1-E81333683E79}" type="presOf" srcId="{06F4AAD3-A1E7-4881-AAAD-5B18554454DE}" destId="{8DB5D357-6808-43B3-BD9F-4CAF7F966CB9}" srcOrd="0" destOrd="0" presId="urn:microsoft.com/office/officeart/2005/8/layout/hierarchy1"/>
    <dgm:cxn modelId="{8BE2C29A-DCB0-4467-A384-7A1E7DDD59E3}" type="presParOf" srcId="{552DE669-092F-483B-9CC5-00CB89C29F3B}" destId="{E454CDFA-0CA6-4CA2-8F0D-4C48A98BC283}" srcOrd="0" destOrd="0" presId="urn:microsoft.com/office/officeart/2005/8/layout/hierarchy1"/>
    <dgm:cxn modelId="{55C74811-1D82-427C-99C8-0D52008F2DFC}" type="presParOf" srcId="{E454CDFA-0CA6-4CA2-8F0D-4C48A98BC283}" destId="{40C9E0C1-315D-4BC1-BD94-39C1094A4740}" srcOrd="0" destOrd="0" presId="urn:microsoft.com/office/officeart/2005/8/layout/hierarchy1"/>
    <dgm:cxn modelId="{7196E668-38A1-4303-A74B-9CA8090F8E8D}" type="presParOf" srcId="{40C9E0C1-315D-4BC1-BD94-39C1094A4740}" destId="{71C7DC09-C077-4386-BC7F-C795F0BCA1B5}" srcOrd="0" destOrd="0" presId="urn:microsoft.com/office/officeart/2005/8/layout/hierarchy1"/>
    <dgm:cxn modelId="{93C11A3E-E8E2-42F8-B688-0631957151D0}" type="presParOf" srcId="{40C9E0C1-315D-4BC1-BD94-39C1094A4740}" destId="{8DB5D357-6808-43B3-BD9F-4CAF7F966CB9}" srcOrd="1" destOrd="0" presId="urn:microsoft.com/office/officeart/2005/8/layout/hierarchy1"/>
    <dgm:cxn modelId="{88A6D439-384C-4DC3-B482-9336EF940509}" type="presParOf" srcId="{E454CDFA-0CA6-4CA2-8F0D-4C48A98BC283}" destId="{A7E98064-ECB4-42F9-A8E3-43CDEDB39367}" srcOrd="1" destOrd="0" presId="urn:microsoft.com/office/officeart/2005/8/layout/hierarchy1"/>
    <dgm:cxn modelId="{16020FA0-A7ED-48BC-A57E-1BE8CFA9819A}" type="presParOf" srcId="{552DE669-092F-483B-9CC5-00CB89C29F3B}" destId="{7EAD380E-ED6A-4AF3-BD56-73ABD241B679}" srcOrd="1" destOrd="0" presId="urn:microsoft.com/office/officeart/2005/8/layout/hierarchy1"/>
    <dgm:cxn modelId="{7A0E947C-EDE6-4283-A5D8-AF1B4D2F0741}" type="presParOf" srcId="{7EAD380E-ED6A-4AF3-BD56-73ABD241B679}" destId="{5092D1BD-C52E-403E-B0F9-5339ED6D018B}" srcOrd="0" destOrd="0" presId="urn:microsoft.com/office/officeart/2005/8/layout/hierarchy1"/>
    <dgm:cxn modelId="{2A0625E5-55A8-422C-AA20-90BC43DA6C5D}" type="presParOf" srcId="{5092D1BD-C52E-403E-B0F9-5339ED6D018B}" destId="{C1E41067-406C-4B91-BC33-F6B5B0744E9E}" srcOrd="0" destOrd="0" presId="urn:microsoft.com/office/officeart/2005/8/layout/hierarchy1"/>
    <dgm:cxn modelId="{495B19B4-1EE5-456A-A56A-8A2A3C07628B}" type="presParOf" srcId="{5092D1BD-C52E-403E-B0F9-5339ED6D018B}" destId="{D25569CB-8614-4B19-98F6-5B13B5948A2F}" srcOrd="1" destOrd="0" presId="urn:microsoft.com/office/officeart/2005/8/layout/hierarchy1"/>
    <dgm:cxn modelId="{4C1E14A8-685E-462E-98BF-394994CDDE7B}" type="presParOf" srcId="{7EAD380E-ED6A-4AF3-BD56-73ABD241B679}" destId="{5BD14C40-6940-493F-BE4D-1870E0B42307}" srcOrd="1" destOrd="0" presId="urn:microsoft.com/office/officeart/2005/8/layout/hierarchy1"/>
    <dgm:cxn modelId="{3B31EF25-9B22-4355-9BAA-94F785195BAF}" type="presParOf" srcId="{552DE669-092F-483B-9CC5-00CB89C29F3B}" destId="{02CA64CB-7F55-4A15-B6CE-EA806C3E9067}" srcOrd="2" destOrd="0" presId="urn:microsoft.com/office/officeart/2005/8/layout/hierarchy1"/>
    <dgm:cxn modelId="{C5B6C368-1A7F-4DAE-9C8C-FB9BDC99D8FA}" type="presParOf" srcId="{02CA64CB-7F55-4A15-B6CE-EA806C3E9067}" destId="{DE27669C-951E-4492-9CED-A6C6B794CA1F}" srcOrd="0" destOrd="0" presId="urn:microsoft.com/office/officeart/2005/8/layout/hierarchy1"/>
    <dgm:cxn modelId="{5E1D6CDD-EDF3-422C-8E9F-E3E13044911D}" type="presParOf" srcId="{DE27669C-951E-4492-9CED-A6C6B794CA1F}" destId="{56E888F0-EE27-47BD-9BB1-FE6D7D3F12B0}" srcOrd="0" destOrd="0" presId="urn:microsoft.com/office/officeart/2005/8/layout/hierarchy1"/>
    <dgm:cxn modelId="{C9E275C9-3689-4309-BFD9-15F7E0C8320E}" type="presParOf" srcId="{DE27669C-951E-4492-9CED-A6C6B794CA1F}" destId="{98735A31-33A2-4BA0-A86A-337DB3E4816C}" srcOrd="1" destOrd="0" presId="urn:microsoft.com/office/officeart/2005/8/layout/hierarchy1"/>
    <dgm:cxn modelId="{E7FF0DDD-E441-4E03-B6DA-DA548C91E4B9}" type="presParOf" srcId="{02CA64CB-7F55-4A15-B6CE-EA806C3E9067}" destId="{D4CD483A-0126-4B55-B890-C1765A179B1B}" srcOrd="1" destOrd="0" presId="urn:microsoft.com/office/officeart/2005/8/layout/hierarchy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F72FA10A-3B6D-44B0-B054-9DC7F76A13C5}" type="doc">
      <dgm:prSet loTypeId="urn:microsoft.com/office/officeart/2005/8/layout/hierarchy2" loCatId="hierarchy" qsTypeId="urn:microsoft.com/office/officeart/2005/8/quickstyle/simple1" qsCatId="simple" csTypeId="urn:microsoft.com/office/officeart/2005/8/colors/accent1_2" csCatId="accent1" phldr="1"/>
      <dgm:spPr/>
      <dgm:t>
        <a:bodyPr/>
        <a:lstStyle/>
        <a:p>
          <a:endParaRPr lang="en-US"/>
        </a:p>
      </dgm:t>
    </dgm:pt>
    <dgm:pt modelId="{8735E0AC-417C-437E-8EEE-4D59FFC5BC49}">
      <dgm:prSet phldrT="[Text]"/>
      <dgm:spPr>
        <a:solidFill>
          <a:schemeClr val="accent6">
            <a:lumMod val="50000"/>
          </a:schemeClr>
        </a:solidFill>
      </dgm:spPr>
      <dgm:t>
        <a:bodyPr/>
        <a:lstStyle/>
        <a:p>
          <a:r>
            <a:rPr lang="en-US" dirty="0"/>
            <a:t>GT with heavy drainage</a:t>
          </a:r>
        </a:p>
      </dgm:t>
    </dgm:pt>
    <dgm:pt modelId="{66F05FD8-4D9A-4A70-8B42-88CBD1ADDFD7}" type="parTrans" cxnId="{30417B46-B6B7-4BE1-B5C2-69EE0F854ED5}">
      <dgm:prSet/>
      <dgm:spPr/>
      <dgm:t>
        <a:bodyPr/>
        <a:lstStyle/>
        <a:p>
          <a:endParaRPr lang="en-US"/>
        </a:p>
      </dgm:t>
    </dgm:pt>
    <dgm:pt modelId="{480BBCA9-AD3B-48EA-9135-7D66B3E7EC95}" type="sibTrans" cxnId="{30417B46-B6B7-4BE1-B5C2-69EE0F854ED5}">
      <dgm:prSet/>
      <dgm:spPr/>
      <dgm:t>
        <a:bodyPr/>
        <a:lstStyle/>
        <a:p>
          <a:endParaRPr lang="en-US"/>
        </a:p>
      </dgm:t>
    </dgm:pt>
    <dgm:pt modelId="{3FAC3EAE-7B88-4571-BACB-3FB3664B7983}">
      <dgm:prSet phldrT="[Text]"/>
      <dgm:spPr>
        <a:solidFill>
          <a:schemeClr val="accent6">
            <a:lumMod val="75000"/>
          </a:schemeClr>
        </a:solidFill>
      </dgm:spPr>
      <dgm:t>
        <a:bodyPr/>
        <a:lstStyle/>
        <a:p>
          <a:r>
            <a:rPr lang="en-US" dirty="0"/>
            <a:t>8-12 weeks post-op with first change complete</a:t>
          </a:r>
        </a:p>
      </dgm:t>
    </dgm:pt>
    <dgm:pt modelId="{64461A48-0BA0-4BBA-B780-A97C81B5C225}" type="parTrans" cxnId="{C4E96AE7-12B7-4839-B702-AD664256D1E2}">
      <dgm:prSet/>
      <dgm:spPr/>
      <dgm:t>
        <a:bodyPr/>
        <a:lstStyle/>
        <a:p>
          <a:endParaRPr lang="en-US"/>
        </a:p>
      </dgm:t>
    </dgm:pt>
    <dgm:pt modelId="{82E01481-DBEB-4721-ABF2-F09CB46F5DE8}" type="sibTrans" cxnId="{C4E96AE7-12B7-4839-B702-AD664256D1E2}">
      <dgm:prSet/>
      <dgm:spPr/>
      <dgm:t>
        <a:bodyPr/>
        <a:lstStyle/>
        <a:p>
          <a:endParaRPr lang="en-US"/>
        </a:p>
      </dgm:t>
    </dgm:pt>
    <dgm:pt modelId="{9DAAFB6A-9319-41C5-BCE4-98DD25E37782}">
      <dgm:prSet phldrT="[Text]"/>
      <dgm:spPr>
        <a:solidFill>
          <a:schemeClr val="accent2">
            <a:lumMod val="75000"/>
          </a:schemeClr>
        </a:solidFill>
      </dgm:spPr>
      <dgm:t>
        <a:bodyPr/>
        <a:lstStyle/>
        <a:p>
          <a:r>
            <a:rPr lang="en-US" dirty="0"/>
            <a:t>Consult CWON</a:t>
          </a:r>
        </a:p>
      </dgm:t>
    </dgm:pt>
    <dgm:pt modelId="{41291018-2D70-4ACB-B689-D42BB36973F7}" type="parTrans" cxnId="{9BC28190-C34B-4E14-83AC-C7667E140528}">
      <dgm:prSet/>
      <dgm:spPr/>
      <dgm:t>
        <a:bodyPr/>
        <a:lstStyle/>
        <a:p>
          <a:endParaRPr lang="en-US"/>
        </a:p>
      </dgm:t>
    </dgm:pt>
    <dgm:pt modelId="{2FB3E2B3-FC74-46C8-A3CA-25648B82DA3D}" type="sibTrans" cxnId="{9BC28190-C34B-4E14-83AC-C7667E140528}">
      <dgm:prSet/>
      <dgm:spPr/>
      <dgm:t>
        <a:bodyPr/>
        <a:lstStyle/>
        <a:p>
          <a:endParaRPr lang="en-US"/>
        </a:p>
      </dgm:t>
    </dgm:pt>
    <dgm:pt modelId="{3783F645-E944-4E43-A632-F0C4AA74690B}">
      <dgm:prSet phldrT="[Text]"/>
      <dgm:spPr/>
      <dgm:t>
        <a:bodyPr/>
        <a:lstStyle/>
        <a:p>
          <a:r>
            <a:rPr lang="en-US" dirty="0"/>
            <a:t>Consult Ped Surg</a:t>
          </a:r>
        </a:p>
      </dgm:t>
    </dgm:pt>
    <dgm:pt modelId="{B73C8DCE-4288-4F19-9E4F-22B6BAC7B291}" type="parTrans" cxnId="{F017A06A-E3D8-44CB-A9D2-C0965D6C3783}">
      <dgm:prSet/>
      <dgm:spPr/>
      <dgm:t>
        <a:bodyPr/>
        <a:lstStyle/>
        <a:p>
          <a:endParaRPr lang="en-US"/>
        </a:p>
      </dgm:t>
    </dgm:pt>
    <dgm:pt modelId="{7F57212B-F659-4223-BEEA-8C7B0A92C330}" type="sibTrans" cxnId="{F017A06A-E3D8-44CB-A9D2-C0965D6C3783}">
      <dgm:prSet/>
      <dgm:spPr/>
      <dgm:t>
        <a:bodyPr/>
        <a:lstStyle/>
        <a:p>
          <a:endParaRPr lang="en-US"/>
        </a:p>
      </dgm:t>
    </dgm:pt>
    <dgm:pt modelId="{066FDE64-5C38-4FBB-A2C2-5B188388EA52}">
      <dgm:prSet phldrT="[Text]"/>
      <dgm:spPr>
        <a:solidFill>
          <a:schemeClr val="accent6">
            <a:lumMod val="75000"/>
          </a:schemeClr>
        </a:solidFill>
      </dgm:spPr>
      <dgm:t>
        <a:bodyPr/>
        <a:lstStyle/>
        <a:p>
          <a:r>
            <a:rPr lang="en-US" dirty="0"/>
            <a:t>Skin Breakdown</a:t>
          </a:r>
        </a:p>
      </dgm:t>
    </dgm:pt>
    <dgm:pt modelId="{7F5FF439-BDB7-4285-B0CA-57608AF6A291}" type="parTrans" cxnId="{076194D1-F06A-40D5-ADD9-E792BC0392BE}">
      <dgm:prSet/>
      <dgm:spPr/>
      <dgm:t>
        <a:bodyPr/>
        <a:lstStyle/>
        <a:p>
          <a:endParaRPr lang="en-US"/>
        </a:p>
      </dgm:t>
    </dgm:pt>
    <dgm:pt modelId="{ABD1CAB9-1341-4367-8AF4-330925EED6C2}" type="sibTrans" cxnId="{076194D1-F06A-40D5-ADD9-E792BC0392BE}">
      <dgm:prSet/>
      <dgm:spPr/>
      <dgm:t>
        <a:bodyPr/>
        <a:lstStyle/>
        <a:p>
          <a:endParaRPr lang="en-US"/>
        </a:p>
      </dgm:t>
    </dgm:pt>
    <dgm:pt modelId="{A058ECC9-A520-45DE-AF51-9B379FAFDF5D}">
      <dgm:prSet phldrT="[Text]"/>
      <dgm:spPr>
        <a:solidFill>
          <a:schemeClr val="accent2">
            <a:lumMod val="75000"/>
          </a:schemeClr>
        </a:solidFill>
      </dgm:spPr>
      <dgm:t>
        <a:bodyPr/>
        <a:lstStyle/>
        <a:p>
          <a:r>
            <a:rPr lang="en-US" dirty="0"/>
            <a:t>Consult CWON</a:t>
          </a:r>
        </a:p>
      </dgm:t>
    </dgm:pt>
    <dgm:pt modelId="{04B2CFB3-94FB-4AE8-8B2F-448764B197AC}" type="parTrans" cxnId="{87AC0233-1DF5-4734-BB68-41D77CC07D88}">
      <dgm:prSet/>
      <dgm:spPr/>
      <dgm:t>
        <a:bodyPr/>
        <a:lstStyle/>
        <a:p>
          <a:endParaRPr lang="en-US"/>
        </a:p>
      </dgm:t>
    </dgm:pt>
    <dgm:pt modelId="{3ED3B946-45DD-42EF-8EBC-F03C293ECA4C}" type="sibTrans" cxnId="{87AC0233-1DF5-4734-BB68-41D77CC07D88}">
      <dgm:prSet/>
      <dgm:spPr/>
      <dgm:t>
        <a:bodyPr/>
        <a:lstStyle/>
        <a:p>
          <a:endParaRPr lang="en-US"/>
        </a:p>
      </dgm:t>
    </dgm:pt>
    <dgm:pt modelId="{7863872D-946E-4F73-BF36-4D5B5F6D68C2}" type="pres">
      <dgm:prSet presAssocID="{F72FA10A-3B6D-44B0-B054-9DC7F76A13C5}" presName="diagram" presStyleCnt="0">
        <dgm:presLayoutVars>
          <dgm:chPref val="1"/>
          <dgm:dir/>
          <dgm:animOne val="branch"/>
          <dgm:animLvl val="lvl"/>
          <dgm:resizeHandles val="exact"/>
        </dgm:presLayoutVars>
      </dgm:prSet>
      <dgm:spPr/>
    </dgm:pt>
    <dgm:pt modelId="{8686D5A9-F3BF-46CA-B957-8C0AC204E5A1}" type="pres">
      <dgm:prSet presAssocID="{8735E0AC-417C-437E-8EEE-4D59FFC5BC49}" presName="root1" presStyleCnt="0"/>
      <dgm:spPr/>
    </dgm:pt>
    <dgm:pt modelId="{368BEA8D-F55D-4953-B97F-8ACA8C26DC58}" type="pres">
      <dgm:prSet presAssocID="{8735E0AC-417C-437E-8EEE-4D59FFC5BC49}" presName="LevelOneTextNode" presStyleLbl="node0" presStyleIdx="0" presStyleCnt="1" custScaleX="130908">
        <dgm:presLayoutVars>
          <dgm:chPref val="3"/>
        </dgm:presLayoutVars>
      </dgm:prSet>
      <dgm:spPr/>
    </dgm:pt>
    <dgm:pt modelId="{B45E9027-6E56-492A-B5E5-94CEC9281AAF}" type="pres">
      <dgm:prSet presAssocID="{8735E0AC-417C-437E-8EEE-4D59FFC5BC49}" presName="level2hierChild" presStyleCnt="0"/>
      <dgm:spPr/>
    </dgm:pt>
    <dgm:pt modelId="{FCAE83D4-AB9A-4FA7-BB5B-C377BFB36004}" type="pres">
      <dgm:prSet presAssocID="{64461A48-0BA0-4BBA-B780-A97C81B5C225}" presName="conn2-1" presStyleLbl="parChTrans1D2" presStyleIdx="0" presStyleCnt="2"/>
      <dgm:spPr/>
    </dgm:pt>
    <dgm:pt modelId="{6F2EAF07-C637-4F80-8CEB-EA780C06A7F3}" type="pres">
      <dgm:prSet presAssocID="{64461A48-0BA0-4BBA-B780-A97C81B5C225}" presName="connTx" presStyleLbl="parChTrans1D2" presStyleIdx="0" presStyleCnt="2"/>
      <dgm:spPr/>
    </dgm:pt>
    <dgm:pt modelId="{535225FA-CAB0-47AC-83BC-11F9D8B6DDCE}" type="pres">
      <dgm:prSet presAssocID="{3FAC3EAE-7B88-4571-BACB-3FB3664B7983}" presName="root2" presStyleCnt="0"/>
      <dgm:spPr/>
    </dgm:pt>
    <dgm:pt modelId="{0D544886-99AC-4D19-91D6-628CC5DC13B1}" type="pres">
      <dgm:prSet presAssocID="{3FAC3EAE-7B88-4571-BACB-3FB3664B7983}" presName="LevelTwoTextNode" presStyleLbl="node2" presStyleIdx="0" presStyleCnt="2">
        <dgm:presLayoutVars>
          <dgm:chPref val="3"/>
        </dgm:presLayoutVars>
      </dgm:prSet>
      <dgm:spPr/>
    </dgm:pt>
    <dgm:pt modelId="{85FE8B6B-07E3-44AB-B75C-E99991E57DC1}" type="pres">
      <dgm:prSet presAssocID="{3FAC3EAE-7B88-4571-BACB-3FB3664B7983}" presName="level3hierChild" presStyleCnt="0"/>
      <dgm:spPr/>
    </dgm:pt>
    <dgm:pt modelId="{A0C09F11-EA6A-4EEF-B740-770CAA4D78E1}" type="pres">
      <dgm:prSet presAssocID="{41291018-2D70-4ACB-B689-D42BB36973F7}" presName="conn2-1" presStyleLbl="parChTrans1D3" presStyleIdx="0" presStyleCnt="3"/>
      <dgm:spPr/>
    </dgm:pt>
    <dgm:pt modelId="{1F41A5F3-3A27-4E52-B680-90BA89AD19EE}" type="pres">
      <dgm:prSet presAssocID="{41291018-2D70-4ACB-B689-D42BB36973F7}" presName="connTx" presStyleLbl="parChTrans1D3" presStyleIdx="0" presStyleCnt="3"/>
      <dgm:spPr/>
    </dgm:pt>
    <dgm:pt modelId="{EDC59971-6AE2-46E5-9A61-C37CF3F8D544}" type="pres">
      <dgm:prSet presAssocID="{9DAAFB6A-9319-41C5-BCE4-98DD25E37782}" presName="root2" presStyleCnt="0"/>
      <dgm:spPr/>
    </dgm:pt>
    <dgm:pt modelId="{CF2C7FFD-C3C2-4B7C-AEE7-B2773FBD6147}" type="pres">
      <dgm:prSet presAssocID="{9DAAFB6A-9319-41C5-BCE4-98DD25E37782}" presName="LevelTwoTextNode" presStyleLbl="node3" presStyleIdx="0" presStyleCnt="3">
        <dgm:presLayoutVars>
          <dgm:chPref val="3"/>
        </dgm:presLayoutVars>
      </dgm:prSet>
      <dgm:spPr/>
    </dgm:pt>
    <dgm:pt modelId="{DE6BDB59-E85A-4B44-8A29-BEFA5B560406}" type="pres">
      <dgm:prSet presAssocID="{9DAAFB6A-9319-41C5-BCE4-98DD25E37782}" presName="level3hierChild" presStyleCnt="0"/>
      <dgm:spPr/>
    </dgm:pt>
    <dgm:pt modelId="{A603B908-9860-4C6F-9D79-0271CED45C0C}" type="pres">
      <dgm:prSet presAssocID="{B73C8DCE-4288-4F19-9E4F-22B6BAC7B291}" presName="conn2-1" presStyleLbl="parChTrans1D3" presStyleIdx="1" presStyleCnt="3"/>
      <dgm:spPr/>
    </dgm:pt>
    <dgm:pt modelId="{5DB19780-B86A-4843-8104-43F8159CE0C6}" type="pres">
      <dgm:prSet presAssocID="{B73C8DCE-4288-4F19-9E4F-22B6BAC7B291}" presName="connTx" presStyleLbl="parChTrans1D3" presStyleIdx="1" presStyleCnt="3"/>
      <dgm:spPr/>
    </dgm:pt>
    <dgm:pt modelId="{4A0DFFB9-CC65-4C96-B630-C629CD96E6CE}" type="pres">
      <dgm:prSet presAssocID="{3783F645-E944-4E43-A632-F0C4AA74690B}" presName="root2" presStyleCnt="0"/>
      <dgm:spPr/>
    </dgm:pt>
    <dgm:pt modelId="{69D4CCA4-D6C7-4172-B214-A3DA96BEBF23}" type="pres">
      <dgm:prSet presAssocID="{3783F645-E944-4E43-A632-F0C4AA74690B}" presName="LevelTwoTextNode" presStyleLbl="node3" presStyleIdx="1" presStyleCnt="3">
        <dgm:presLayoutVars>
          <dgm:chPref val="3"/>
        </dgm:presLayoutVars>
      </dgm:prSet>
      <dgm:spPr/>
    </dgm:pt>
    <dgm:pt modelId="{A49D9C04-9924-4B11-901F-5B85F1EED85F}" type="pres">
      <dgm:prSet presAssocID="{3783F645-E944-4E43-A632-F0C4AA74690B}" presName="level3hierChild" presStyleCnt="0"/>
      <dgm:spPr/>
    </dgm:pt>
    <dgm:pt modelId="{725E3F5F-784F-4313-9234-346988889417}" type="pres">
      <dgm:prSet presAssocID="{7F5FF439-BDB7-4285-B0CA-57608AF6A291}" presName="conn2-1" presStyleLbl="parChTrans1D2" presStyleIdx="1" presStyleCnt="2"/>
      <dgm:spPr/>
    </dgm:pt>
    <dgm:pt modelId="{5B64EF76-00DA-41D7-866D-3C6C358BF3A0}" type="pres">
      <dgm:prSet presAssocID="{7F5FF439-BDB7-4285-B0CA-57608AF6A291}" presName="connTx" presStyleLbl="parChTrans1D2" presStyleIdx="1" presStyleCnt="2"/>
      <dgm:spPr/>
    </dgm:pt>
    <dgm:pt modelId="{250DD451-A991-4AA1-A265-C5E11EBD2091}" type="pres">
      <dgm:prSet presAssocID="{066FDE64-5C38-4FBB-A2C2-5B188388EA52}" presName="root2" presStyleCnt="0"/>
      <dgm:spPr/>
    </dgm:pt>
    <dgm:pt modelId="{2348CA0E-AB4E-4A40-9DEA-9D625837DCCE}" type="pres">
      <dgm:prSet presAssocID="{066FDE64-5C38-4FBB-A2C2-5B188388EA52}" presName="LevelTwoTextNode" presStyleLbl="node2" presStyleIdx="1" presStyleCnt="2">
        <dgm:presLayoutVars>
          <dgm:chPref val="3"/>
        </dgm:presLayoutVars>
      </dgm:prSet>
      <dgm:spPr/>
    </dgm:pt>
    <dgm:pt modelId="{2CB34D22-B9E7-468D-9320-2F7F3955D480}" type="pres">
      <dgm:prSet presAssocID="{066FDE64-5C38-4FBB-A2C2-5B188388EA52}" presName="level3hierChild" presStyleCnt="0"/>
      <dgm:spPr/>
    </dgm:pt>
    <dgm:pt modelId="{6799A8CB-B409-47D6-B2EE-FCF32D526356}" type="pres">
      <dgm:prSet presAssocID="{04B2CFB3-94FB-4AE8-8B2F-448764B197AC}" presName="conn2-1" presStyleLbl="parChTrans1D3" presStyleIdx="2" presStyleCnt="3"/>
      <dgm:spPr/>
    </dgm:pt>
    <dgm:pt modelId="{82C3E75F-253F-48D1-AFAD-D9708E742E06}" type="pres">
      <dgm:prSet presAssocID="{04B2CFB3-94FB-4AE8-8B2F-448764B197AC}" presName="connTx" presStyleLbl="parChTrans1D3" presStyleIdx="2" presStyleCnt="3"/>
      <dgm:spPr/>
    </dgm:pt>
    <dgm:pt modelId="{3C118BFF-895A-4660-8CE3-42A4B37C86EB}" type="pres">
      <dgm:prSet presAssocID="{A058ECC9-A520-45DE-AF51-9B379FAFDF5D}" presName="root2" presStyleCnt="0"/>
      <dgm:spPr/>
    </dgm:pt>
    <dgm:pt modelId="{B713A46A-A77A-4995-AD45-B69E67867E46}" type="pres">
      <dgm:prSet presAssocID="{A058ECC9-A520-45DE-AF51-9B379FAFDF5D}" presName="LevelTwoTextNode" presStyleLbl="node3" presStyleIdx="2" presStyleCnt="3">
        <dgm:presLayoutVars>
          <dgm:chPref val="3"/>
        </dgm:presLayoutVars>
      </dgm:prSet>
      <dgm:spPr/>
    </dgm:pt>
    <dgm:pt modelId="{17968735-E4E6-4950-A27C-11333C2E4C95}" type="pres">
      <dgm:prSet presAssocID="{A058ECC9-A520-45DE-AF51-9B379FAFDF5D}" presName="level3hierChild" presStyleCnt="0"/>
      <dgm:spPr/>
    </dgm:pt>
  </dgm:ptLst>
  <dgm:cxnLst>
    <dgm:cxn modelId="{AAA70300-6616-43C0-AFA6-97AA7A73BB2D}" type="presOf" srcId="{066FDE64-5C38-4FBB-A2C2-5B188388EA52}" destId="{2348CA0E-AB4E-4A40-9DEA-9D625837DCCE}" srcOrd="0" destOrd="0" presId="urn:microsoft.com/office/officeart/2005/8/layout/hierarchy2"/>
    <dgm:cxn modelId="{5ACE3519-0F5A-4093-8A47-A840F81085D5}" type="presOf" srcId="{3FAC3EAE-7B88-4571-BACB-3FB3664B7983}" destId="{0D544886-99AC-4D19-91D6-628CC5DC13B1}" srcOrd="0" destOrd="0" presId="urn:microsoft.com/office/officeart/2005/8/layout/hierarchy2"/>
    <dgm:cxn modelId="{4343572F-9ECD-413A-8598-7BDD9608EF72}" type="presOf" srcId="{64461A48-0BA0-4BBA-B780-A97C81B5C225}" destId="{FCAE83D4-AB9A-4FA7-BB5B-C377BFB36004}" srcOrd="0" destOrd="0" presId="urn:microsoft.com/office/officeart/2005/8/layout/hierarchy2"/>
    <dgm:cxn modelId="{33B06230-17FB-49DD-80D8-C2D73B8E6ACF}" type="presOf" srcId="{04B2CFB3-94FB-4AE8-8B2F-448764B197AC}" destId="{6799A8CB-B409-47D6-B2EE-FCF32D526356}" srcOrd="0" destOrd="0" presId="urn:microsoft.com/office/officeart/2005/8/layout/hierarchy2"/>
    <dgm:cxn modelId="{87AC0233-1DF5-4734-BB68-41D77CC07D88}" srcId="{066FDE64-5C38-4FBB-A2C2-5B188388EA52}" destId="{A058ECC9-A520-45DE-AF51-9B379FAFDF5D}" srcOrd="0" destOrd="0" parTransId="{04B2CFB3-94FB-4AE8-8B2F-448764B197AC}" sibTransId="{3ED3B946-45DD-42EF-8EBC-F03C293ECA4C}"/>
    <dgm:cxn modelId="{70877E3D-D434-43EA-A395-0DB32C21A9F7}" type="presOf" srcId="{41291018-2D70-4ACB-B689-D42BB36973F7}" destId="{1F41A5F3-3A27-4E52-B680-90BA89AD19EE}" srcOrd="1" destOrd="0" presId="urn:microsoft.com/office/officeart/2005/8/layout/hierarchy2"/>
    <dgm:cxn modelId="{30417B46-B6B7-4BE1-B5C2-69EE0F854ED5}" srcId="{F72FA10A-3B6D-44B0-B054-9DC7F76A13C5}" destId="{8735E0AC-417C-437E-8EEE-4D59FFC5BC49}" srcOrd="0" destOrd="0" parTransId="{66F05FD8-4D9A-4A70-8B42-88CBD1ADDFD7}" sibTransId="{480BBCA9-AD3B-48EA-9135-7D66B3E7EC95}"/>
    <dgm:cxn modelId="{0A86E047-DDB9-4D70-9C0E-4FFF5C05ADF4}" type="presOf" srcId="{B73C8DCE-4288-4F19-9E4F-22B6BAC7B291}" destId="{5DB19780-B86A-4843-8104-43F8159CE0C6}" srcOrd="1" destOrd="0" presId="urn:microsoft.com/office/officeart/2005/8/layout/hierarchy2"/>
    <dgm:cxn modelId="{F017A06A-E3D8-44CB-A9D2-C0965D6C3783}" srcId="{3FAC3EAE-7B88-4571-BACB-3FB3664B7983}" destId="{3783F645-E944-4E43-A632-F0C4AA74690B}" srcOrd="1" destOrd="0" parTransId="{B73C8DCE-4288-4F19-9E4F-22B6BAC7B291}" sibTransId="{7F57212B-F659-4223-BEEA-8C7B0A92C330}"/>
    <dgm:cxn modelId="{96724E4F-E51A-45D7-B3E1-B5E34B71FA3E}" type="presOf" srcId="{9DAAFB6A-9319-41C5-BCE4-98DD25E37782}" destId="{CF2C7FFD-C3C2-4B7C-AEE7-B2773FBD6147}" srcOrd="0" destOrd="0" presId="urn:microsoft.com/office/officeart/2005/8/layout/hierarchy2"/>
    <dgm:cxn modelId="{19B7C776-189F-41ED-9090-37697DF47865}" type="presOf" srcId="{41291018-2D70-4ACB-B689-D42BB36973F7}" destId="{A0C09F11-EA6A-4EEF-B740-770CAA4D78E1}" srcOrd="0" destOrd="0" presId="urn:microsoft.com/office/officeart/2005/8/layout/hierarchy2"/>
    <dgm:cxn modelId="{1D5D087C-5012-477D-89E6-DF6C0744A635}" type="presOf" srcId="{F72FA10A-3B6D-44B0-B054-9DC7F76A13C5}" destId="{7863872D-946E-4F73-BF36-4D5B5F6D68C2}" srcOrd="0" destOrd="0" presId="urn:microsoft.com/office/officeart/2005/8/layout/hierarchy2"/>
    <dgm:cxn modelId="{B69C8485-724C-47F3-8E27-AF0C61EB15BA}" type="presOf" srcId="{04B2CFB3-94FB-4AE8-8B2F-448764B197AC}" destId="{82C3E75F-253F-48D1-AFAD-D9708E742E06}" srcOrd="1" destOrd="0" presId="urn:microsoft.com/office/officeart/2005/8/layout/hierarchy2"/>
    <dgm:cxn modelId="{276C298C-F14E-4DA1-A8BE-2BFB8140D202}" type="presOf" srcId="{3783F645-E944-4E43-A632-F0C4AA74690B}" destId="{69D4CCA4-D6C7-4172-B214-A3DA96BEBF23}" srcOrd="0" destOrd="0" presId="urn:microsoft.com/office/officeart/2005/8/layout/hierarchy2"/>
    <dgm:cxn modelId="{9BC28190-C34B-4E14-83AC-C7667E140528}" srcId="{3FAC3EAE-7B88-4571-BACB-3FB3664B7983}" destId="{9DAAFB6A-9319-41C5-BCE4-98DD25E37782}" srcOrd="0" destOrd="0" parTransId="{41291018-2D70-4ACB-B689-D42BB36973F7}" sibTransId="{2FB3E2B3-FC74-46C8-A3CA-25648B82DA3D}"/>
    <dgm:cxn modelId="{5EB7A8AC-0597-4C59-9AFB-5000F4E484C9}" type="presOf" srcId="{7F5FF439-BDB7-4285-B0CA-57608AF6A291}" destId="{725E3F5F-784F-4313-9234-346988889417}" srcOrd="0" destOrd="0" presId="urn:microsoft.com/office/officeart/2005/8/layout/hierarchy2"/>
    <dgm:cxn modelId="{4DC573BA-7488-4552-9251-C5438D7E6D29}" type="presOf" srcId="{B73C8DCE-4288-4F19-9E4F-22B6BAC7B291}" destId="{A603B908-9860-4C6F-9D79-0271CED45C0C}" srcOrd="0" destOrd="0" presId="urn:microsoft.com/office/officeart/2005/8/layout/hierarchy2"/>
    <dgm:cxn modelId="{3F56D9BF-4D8F-48C4-B996-55DB2EC10390}" type="presOf" srcId="{64461A48-0BA0-4BBA-B780-A97C81B5C225}" destId="{6F2EAF07-C637-4F80-8CEB-EA780C06A7F3}" srcOrd="1" destOrd="0" presId="urn:microsoft.com/office/officeart/2005/8/layout/hierarchy2"/>
    <dgm:cxn modelId="{94ECD0C5-5E73-4A79-A4B5-82272C3DEAD5}" type="presOf" srcId="{7F5FF439-BDB7-4285-B0CA-57608AF6A291}" destId="{5B64EF76-00DA-41D7-866D-3C6C358BF3A0}" srcOrd="1" destOrd="0" presId="urn:microsoft.com/office/officeart/2005/8/layout/hierarchy2"/>
    <dgm:cxn modelId="{E39363C7-1561-4802-85B5-507CB0167872}" type="presOf" srcId="{8735E0AC-417C-437E-8EEE-4D59FFC5BC49}" destId="{368BEA8D-F55D-4953-B97F-8ACA8C26DC58}" srcOrd="0" destOrd="0" presId="urn:microsoft.com/office/officeart/2005/8/layout/hierarchy2"/>
    <dgm:cxn modelId="{4F87C3C7-5C07-46F1-A83D-4F26D798B712}" type="presOf" srcId="{A058ECC9-A520-45DE-AF51-9B379FAFDF5D}" destId="{B713A46A-A77A-4995-AD45-B69E67867E46}" srcOrd="0" destOrd="0" presId="urn:microsoft.com/office/officeart/2005/8/layout/hierarchy2"/>
    <dgm:cxn modelId="{076194D1-F06A-40D5-ADD9-E792BC0392BE}" srcId="{8735E0AC-417C-437E-8EEE-4D59FFC5BC49}" destId="{066FDE64-5C38-4FBB-A2C2-5B188388EA52}" srcOrd="1" destOrd="0" parTransId="{7F5FF439-BDB7-4285-B0CA-57608AF6A291}" sibTransId="{ABD1CAB9-1341-4367-8AF4-330925EED6C2}"/>
    <dgm:cxn modelId="{C4E96AE7-12B7-4839-B702-AD664256D1E2}" srcId="{8735E0AC-417C-437E-8EEE-4D59FFC5BC49}" destId="{3FAC3EAE-7B88-4571-BACB-3FB3664B7983}" srcOrd="0" destOrd="0" parTransId="{64461A48-0BA0-4BBA-B780-A97C81B5C225}" sibTransId="{82E01481-DBEB-4721-ABF2-F09CB46F5DE8}"/>
    <dgm:cxn modelId="{CE3E7363-1174-4C16-BEEF-E6345C31CA63}" type="presParOf" srcId="{7863872D-946E-4F73-BF36-4D5B5F6D68C2}" destId="{8686D5A9-F3BF-46CA-B957-8C0AC204E5A1}" srcOrd="0" destOrd="0" presId="urn:microsoft.com/office/officeart/2005/8/layout/hierarchy2"/>
    <dgm:cxn modelId="{CC1D8519-9984-4AB9-BC78-FB506EAF1632}" type="presParOf" srcId="{8686D5A9-F3BF-46CA-B957-8C0AC204E5A1}" destId="{368BEA8D-F55D-4953-B97F-8ACA8C26DC58}" srcOrd="0" destOrd="0" presId="urn:microsoft.com/office/officeart/2005/8/layout/hierarchy2"/>
    <dgm:cxn modelId="{710101E0-D1AA-4C95-A3F4-95BFF4058221}" type="presParOf" srcId="{8686D5A9-F3BF-46CA-B957-8C0AC204E5A1}" destId="{B45E9027-6E56-492A-B5E5-94CEC9281AAF}" srcOrd="1" destOrd="0" presId="urn:microsoft.com/office/officeart/2005/8/layout/hierarchy2"/>
    <dgm:cxn modelId="{03997244-4B0A-419E-9597-F2B1CDE532EA}" type="presParOf" srcId="{B45E9027-6E56-492A-B5E5-94CEC9281AAF}" destId="{FCAE83D4-AB9A-4FA7-BB5B-C377BFB36004}" srcOrd="0" destOrd="0" presId="urn:microsoft.com/office/officeart/2005/8/layout/hierarchy2"/>
    <dgm:cxn modelId="{AC07E6B6-899D-465C-9250-6D3B14EB7C36}" type="presParOf" srcId="{FCAE83D4-AB9A-4FA7-BB5B-C377BFB36004}" destId="{6F2EAF07-C637-4F80-8CEB-EA780C06A7F3}" srcOrd="0" destOrd="0" presId="urn:microsoft.com/office/officeart/2005/8/layout/hierarchy2"/>
    <dgm:cxn modelId="{9A16750B-63FA-42EC-A4FB-D5B1E54E0951}" type="presParOf" srcId="{B45E9027-6E56-492A-B5E5-94CEC9281AAF}" destId="{535225FA-CAB0-47AC-83BC-11F9D8B6DDCE}" srcOrd="1" destOrd="0" presId="urn:microsoft.com/office/officeart/2005/8/layout/hierarchy2"/>
    <dgm:cxn modelId="{0E2DF547-3D8D-4AFD-9EF7-A8EB706659D9}" type="presParOf" srcId="{535225FA-CAB0-47AC-83BC-11F9D8B6DDCE}" destId="{0D544886-99AC-4D19-91D6-628CC5DC13B1}" srcOrd="0" destOrd="0" presId="urn:microsoft.com/office/officeart/2005/8/layout/hierarchy2"/>
    <dgm:cxn modelId="{AF3FC19C-A2BB-4B9D-9115-B394E66FF23A}" type="presParOf" srcId="{535225FA-CAB0-47AC-83BC-11F9D8B6DDCE}" destId="{85FE8B6B-07E3-44AB-B75C-E99991E57DC1}" srcOrd="1" destOrd="0" presId="urn:microsoft.com/office/officeart/2005/8/layout/hierarchy2"/>
    <dgm:cxn modelId="{CA17AACF-9564-47A3-B789-EA10FA65B3E1}" type="presParOf" srcId="{85FE8B6B-07E3-44AB-B75C-E99991E57DC1}" destId="{A0C09F11-EA6A-4EEF-B740-770CAA4D78E1}" srcOrd="0" destOrd="0" presId="urn:microsoft.com/office/officeart/2005/8/layout/hierarchy2"/>
    <dgm:cxn modelId="{90A74A23-9DE9-43E8-AEB5-A6CF337DB94F}" type="presParOf" srcId="{A0C09F11-EA6A-4EEF-B740-770CAA4D78E1}" destId="{1F41A5F3-3A27-4E52-B680-90BA89AD19EE}" srcOrd="0" destOrd="0" presId="urn:microsoft.com/office/officeart/2005/8/layout/hierarchy2"/>
    <dgm:cxn modelId="{4806BF8F-64B9-4CA8-83B0-74BC4C8E64ED}" type="presParOf" srcId="{85FE8B6B-07E3-44AB-B75C-E99991E57DC1}" destId="{EDC59971-6AE2-46E5-9A61-C37CF3F8D544}" srcOrd="1" destOrd="0" presId="urn:microsoft.com/office/officeart/2005/8/layout/hierarchy2"/>
    <dgm:cxn modelId="{2E5C5694-73B2-43A1-83B4-5473A7BF5CD4}" type="presParOf" srcId="{EDC59971-6AE2-46E5-9A61-C37CF3F8D544}" destId="{CF2C7FFD-C3C2-4B7C-AEE7-B2773FBD6147}" srcOrd="0" destOrd="0" presId="urn:microsoft.com/office/officeart/2005/8/layout/hierarchy2"/>
    <dgm:cxn modelId="{EE59FC98-6F35-4975-BE07-00E39BDEA34E}" type="presParOf" srcId="{EDC59971-6AE2-46E5-9A61-C37CF3F8D544}" destId="{DE6BDB59-E85A-4B44-8A29-BEFA5B560406}" srcOrd="1" destOrd="0" presId="urn:microsoft.com/office/officeart/2005/8/layout/hierarchy2"/>
    <dgm:cxn modelId="{CC022B84-170B-4AC5-8520-3208968A1481}" type="presParOf" srcId="{85FE8B6B-07E3-44AB-B75C-E99991E57DC1}" destId="{A603B908-9860-4C6F-9D79-0271CED45C0C}" srcOrd="2" destOrd="0" presId="urn:microsoft.com/office/officeart/2005/8/layout/hierarchy2"/>
    <dgm:cxn modelId="{581667F9-70A2-429B-8F9A-1B715A430646}" type="presParOf" srcId="{A603B908-9860-4C6F-9D79-0271CED45C0C}" destId="{5DB19780-B86A-4843-8104-43F8159CE0C6}" srcOrd="0" destOrd="0" presId="urn:microsoft.com/office/officeart/2005/8/layout/hierarchy2"/>
    <dgm:cxn modelId="{1815CA02-F25A-4515-A71F-B40CD8F22B5E}" type="presParOf" srcId="{85FE8B6B-07E3-44AB-B75C-E99991E57DC1}" destId="{4A0DFFB9-CC65-4C96-B630-C629CD96E6CE}" srcOrd="3" destOrd="0" presId="urn:microsoft.com/office/officeart/2005/8/layout/hierarchy2"/>
    <dgm:cxn modelId="{EE3717B1-D903-449F-B6F0-78AA730FE923}" type="presParOf" srcId="{4A0DFFB9-CC65-4C96-B630-C629CD96E6CE}" destId="{69D4CCA4-D6C7-4172-B214-A3DA96BEBF23}" srcOrd="0" destOrd="0" presId="urn:microsoft.com/office/officeart/2005/8/layout/hierarchy2"/>
    <dgm:cxn modelId="{0554A9F6-85AC-4A26-AB2E-7446FE15E33C}" type="presParOf" srcId="{4A0DFFB9-CC65-4C96-B630-C629CD96E6CE}" destId="{A49D9C04-9924-4B11-901F-5B85F1EED85F}" srcOrd="1" destOrd="0" presId="urn:microsoft.com/office/officeart/2005/8/layout/hierarchy2"/>
    <dgm:cxn modelId="{2137A740-75AF-41E2-B865-EC93043F6EA4}" type="presParOf" srcId="{B45E9027-6E56-492A-B5E5-94CEC9281AAF}" destId="{725E3F5F-784F-4313-9234-346988889417}" srcOrd="2" destOrd="0" presId="urn:microsoft.com/office/officeart/2005/8/layout/hierarchy2"/>
    <dgm:cxn modelId="{6B7A7FF9-C49E-456A-8FE5-77EE2887B210}" type="presParOf" srcId="{725E3F5F-784F-4313-9234-346988889417}" destId="{5B64EF76-00DA-41D7-866D-3C6C358BF3A0}" srcOrd="0" destOrd="0" presId="urn:microsoft.com/office/officeart/2005/8/layout/hierarchy2"/>
    <dgm:cxn modelId="{8C54947F-5F53-4E98-8673-C6506B8999C6}" type="presParOf" srcId="{B45E9027-6E56-492A-B5E5-94CEC9281AAF}" destId="{250DD451-A991-4AA1-A265-C5E11EBD2091}" srcOrd="3" destOrd="0" presId="urn:microsoft.com/office/officeart/2005/8/layout/hierarchy2"/>
    <dgm:cxn modelId="{2CB738A0-82EF-4300-8DD5-5211A98806D1}" type="presParOf" srcId="{250DD451-A991-4AA1-A265-C5E11EBD2091}" destId="{2348CA0E-AB4E-4A40-9DEA-9D625837DCCE}" srcOrd="0" destOrd="0" presId="urn:microsoft.com/office/officeart/2005/8/layout/hierarchy2"/>
    <dgm:cxn modelId="{D72A4572-FC63-4D94-8491-E2ABBEE7625A}" type="presParOf" srcId="{250DD451-A991-4AA1-A265-C5E11EBD2091}" destId="{2CB34D22-B9E7-468D-9320-2F7F3955D480}" srcOrd="1" destOrd="0" presId="urn:microsoft.com/office/officeart/2005/8/layout/hierarchy2"/>
    <dgm:cxn modelId="{387A0D5A-7613-4111-9D6D-021D094D4E6C}" type="presParOf" srcId="{2CB34D22-B9E7-468D-9320-2F7F3955D480}" destId="{6799A8CB-B409-47D6-B2EE-FCF32D526356}" srcOrd="0" destOrd="0" presId="urn:microsoft.com/office/officeart/2005/8/layout/hierarchy2"/>
    <dgm:cxn modelId="{EC18EA56-17CA-456E-9965-F125AB7DB6E2}" type="presParOf" srcId="{6799A8CB-B409-47D6-B2EE-FCF32D526356}" destId="{82C3E75F-253F-48D1-AFAD-D9708E742E06}" srcOrd="0" destOrd="0" presId="urn:microsoft.com/office/officeart/2005/8/layout/hierarchy2"/>
    <dgm:cxn modelId="{6D29115B-2891-45D5-B4D2-49BD513EC3B6}" type="presParOf" srcId="{2CB34D22-B9E7-468D-9320-2F7F3955D480}" destId="{3C118BFF-895A-4660-8CE3-42A4B37C86EB}" srcOrd="1" destOrd="0" presId="urn:microsoft.com/office/officeart/2005/8/layout/hierarchy2"/>
    <dgm:cxn modelId="{C5F9E401-475F-42E4-BE80-5D71CFB8BFD3}" type="presParOf" srcId="{3C118BFF-895A-4660-8CE3-42A4B37C86EB}" destId="{B713A46A-A77A-4995-AD45-B69E67867E46}" srcOrd="0" destOrd="0" presId="urn:microsoft.com/office/officeart/2005/8/layout/hierarchy2"/>
    <dgm:cxn modelId="{04488087-5CC4-49F5-A3DA-CF5E0EF7059A}" type="presParOf" srcId="{3C118BFF-895A-4660-8CE3-42A4B37C86EB}" destId="{17968735-E4E6-4950-A27C-11333C2E4C95}" srcOrd="1" destOrd="0" presId="urn:microsoft.com/office/officeart/2005/8/layout/hierarchy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71C7DC09-C077-4386-BC7F-C795F0BCA1B5}">
      <dsp:nvSpPr>
        <dsp:cNvPr id="0" name=""/>
        <dsp:cNvSpPr/>
      </dsp:nvSpPr>
      <dsp:spPr>
        <a:xfrm>
          <a:off x="0" y="380809"/>
          <a:ext cx="2623071" cy="1665650"/>
        </a:xfrm>
        <a:prstGeom prst="roundRect">
          <a:avLst>
            <a:gd name="adj" fmla="val 10000"/>
          </a:avLst>
        </a:prstGeom>
        <a:solidFill>
          <a:schemeClr val="dk2">
            <a:hueOff val="0"/>
            <a:satOff val="0"/>
            <a:lumOff val="0"/>
            <a:alphaOff val="0"/>
          </a:schemeClr>
        </a:solidFill>
        <a:ln w="19050" cap="flat" cmpd="sng" algn="ctr">
          <a:solidFill>
            <a:schemeClr val="lt2">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8DB5D357-6808-43B3-BD9F-4CAF7F966CB9}">
      <dsp:nvSpPr>
        <dsp:cNvPr id="0" name=""/>
        <dsp:cNvSpPr/>
      </dsp:nvSpPr>
      <dsp:spPr>
        <a:xfrm>
          <a:off x="291452" y="657689"/>
          <a:ext cx="2623071" cy="1665650"/>
        </a:xfrm>
        <a:prstGeom prst="roundRect">
          <a:avLst>
            <a:gd name="adj" fmla="val 10000"/>
          </a:avLst>
        </a:prstGeom>
        <a:solidFill>
          <a:schemeClr val="lt2">
            <a:alpha val="90000"/>
            <a:hueOff val="0"/>
            <a:satOff val="0"/>
            <a:lumOff val="0"/>
            <a:alphaOff val="0"/>
          </a:schemeClr>
        </a:solidFill>
        <a:ln w="19050" cap="flat" cmpd="sng" algn="ctr">
          <a:solidFill>
            <a:schemeClr val="dk2">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95250" tIns="95250" rIns="95250" bIns="95250" numCol="1" spcCol="1270" anchor="ctr" anchorCtr="0">
          <a:noAutofit/>
        </a:bodyPr>
        <a:lstStyle/>
        <a:p>
          <a:pPr marL="0" lvl="0" indent="0" algn="ctr" defTabSz="1111250">
            <a:lnSpc>
              <a:spcPct val="90000"/>
            </a:lnSpc>
            <a:spcBef>
              <a:spcPct val="0"/>
            </a:spcBef>
            <a:spcAft>
              <a:spcPct val="35000"/>
            </a:spcAft>
            <a:buNone/>
          </a:pPr>
          <a:r>
            <a:rPr lang="en-US" sz="2500" kern="1200" dirty="0"/>
            <a:t>Peripherally inserted central catheters (PICC)</a:t>
          </a:r>
        </a:p>
      </dsp:txBody>
      <dsp:txXfrm>
        <a:off x="340237" y="706474"/>
        <a:ext cx="2525501" cy="1568080"/>
      </dsp:txXfrm>
    </dsp:sp>
    <dsp:sp modelId="{C1E41067-406C-4B91-BC33-F6B5B0744E9E}">
      <dsp:nvSpPr>
        <dsp:cNvPr id="0" name=""/>
        <dsp:cNvSpPr/>
      </dsp:nvSpPr>
      <dsp:spPr>
        <a:xfrm>
          <a:off x="3205976" y="380809"/>
          <a:ext cx="2623071" cy="1665650"/>
        </a:xfrm>
        <a:prstGeom prst="roundRect">
          <a:avLst>
            <a:gd name="adj" fmla="val 10000"/>
          </a:avLst>
        </a:prstGeom>
        <a:solidFill>
          <a:schemeClr val="dk2">
            <a:hueOff val="0"/>
            <a:satOff val="0"/>
            <a:lumOff val="0"/>
            <a:alphaOff val="0"/>
          </a:schemeClr>
        </a:solidFill>
        <a:ln w="19050" cap="flat" cmpd="sng" algn="ctr">
          <a:solidFill>
            <a:schemeClr val="lt2">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D25569CB-8614-4B19-98F6-5B13B5948A2F}">
      <dsp:nvSpPr>
        <dsp:cNvPr id="0" name=""/>
        <dsp:cNvSpPr/>
      </dsp:nvSpPr>
      <dsp:spPr>
        <a:xfrm>
          <a:off x="3497428" y="657689"/>
          <a:ext cx="2623071" cy="1665650"/>
        </a:xfrm>
        <a:prstGeom prst="roundRect">
          <a:avLst>
            <a:gd name="adj" fmla="val 10000"/>
          </a:avLst>
        </a:prstGeom>
        <a:solidFill>
          <a:schemeClr val="lt2">
            <a:alpha val="90000"/>
            <a:hueOff val="0"/>
            <a:satOff val="0"/>
            <a:lumOff val="0"/>
            <a:alphaOff val="0"/>
          </a:schemeClr>
        </a:solidFill>
        <a:ln w="19050" cap="flat" cmpd="sng" algn="ctr">
          <a:solidFill>
            <a:schemeClr val="dk2">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95250" tIns="95250" rIns="95250" bIns="95250" numCol="1" spcCol="1270" anchor="ctr" anchorCtr="0">
          <a:noAutofit/>
        </a:bodyPr>
        <a:lstStyle/>
        <a:p>
          <a:pPr marL="0" lvl="0" indent="0" algn="ctr" defTabSz="1111250">
            <a:lnSpc>
              <a:spcPct val="90000"/>
            </a:lnSpc>
            <a:spcBef>
              <a:spcPct val="0"/>
            </a:spcBef>
            <a:spcAft>
              <a:spcPct val="35000"/>
            </a:spcAft>
            <a:buNone/>
          </a:pPr>
          <a:r>
            <a:rPr lang="en-US" sz="2500" kern="1200" dirty="0"/>
            <a:t>Tunneled central catheter</a:t>
          </a:r>
        </a:p>
      </dsp:txBody>
      <dsp:txXfrm>
        <a:off x="3546213" y="706474"/>
        <a:ext cx="2525501" cy="1568080"/>
      </dsp:txXfrm>
    </dsp:sp>
    <dsp:sp modelId="{56E888F0-EE27-47BD-9BB1-FE6D7D3F12B0}">
      <dsp:nvSpPr>
        <dsp:cNvPr id="0" name=""/>
        <dsp:cNvSpPr/>
      </dsp:nvSpPr>
      <dsp:spPr>
        <a:xfrm>
          <a:off x="6411952" y="380809"/>
          <a:ext cx="2623071" cy="1665650"/>
        </a:xfrm>
        <a:prstGeom prst="roundRect">
          <a:avLst>
            <a:gd name="adj" fmla="val 10000"/>
          </a:avLst>
        </a:prstGeom>
        <a:solidFill>
          <a:schemeClr val="dk2">
            <a:hueOff val="0"/>
            <a:satOff val="0"/>
            <a:lumOff val="0"/>
            <a:alphaOff val="0"/>
          </a:schemeClr>
        </a:solidFill>
        <a:ln w="19050" cap="flat" cmpd="sng" algn="ctr">
          <a:solidFill>
            <a:schemeClr val="lt2">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98735A31-33A2-4BA0-A86A-337DB3E4816C}">
      <dsp:nvSpPr>
        <dsp:cNvPr id="0" name=""/>
        <dsp:cNvSpPr/>
      </dsp:nvSpPr>
      <dsp:spPr>
        <a:xfrm>
          <a:off x="6703404" y="657689"/>
          <a:ext cx="2623071" cy="1665650"/>
        </a:xfrm>
        <a:prstGeom prst="roundRect">
          <a:avLst>
            <a:gd name="adj" fmla="val 10000"/>
          </a:avLst>
        </a:prstGeom>
        <a:solidFill>
          <a:schemeClr val="lt2">
            <a:alpha val="90000"/>
            <a:hueOff val="0"/>
            <a:satOff val="0"/>
            <a:lumOff val="0"/>
            <a:alphaOff val="0"/>
          </a:schemeClr>
        </a:solidFill>
        <a:ln w="19050" cap="flat" cmpd="sng" algn="ctr">
          <a:solidFill>
            <a:schemeClr val="dk2">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95250" tIns="95250" rIns="95250" bIns="95250" numCol="1" spcCol="1270" anchor="ctr" anchorCtr="0">
          <a:noAutofit/>
        </a:bodyPr>
        <a:lstStyle/>
        <a:p>
          <a:pPr marL="0" lvl="0" indent="0" algn="ctr" defTabSz="1111250">
            <a:lnSpc>
              <a:spcPct val="90000"/>
            </a:lnSpc>
            <a:spcBef>
              <a:spcPct val="0"/>
            </a:spcBef>
            <a:spcAft>
              <a:spcPct val="35000"/>
            </a:spcAft>
            <a:buNone/>
          </a:pPr>
          <a:r>
            <a:rPr lang="en-US" sz="2500" kern="1200">
              <a:latin typeface="Aptos Display" panose="020F0302020204030204"/>
            </a:rPr>
            <a:t>Port</a:t>
          </a:r>
          <a:r>
            <a:rPr lang="en-US" sz="2500" kern="1200"/>
            <a:t> </a:t>
          </a:r>
        </a:p>
      </dsp:txBody>
      <dsp:txXfrm>
        <a:off x="6752189" y="706474"/>
        <a:ext cx="2525501" cy="1568080"/>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368BEA8D-F55D-4953-B97F-8ACA8C26DC58}">
      <dsp:nvSpPr>
        <dsp:cNvPr id="0" name=""/>
        <dsp:cNvSpPr/>
      </dsp:nvSpPr>
      <dsp:spPr>
        <a:xfrm>
          <a:off x="425037" y="1941392"/>
          <a:ext cx="3531951" cy="1349020"/>
        </a:xfrm>
        <a:prstGeom prst="roundRect">
          <a:avLst>
            <a:gd name="adj" fmla="val 10000"/>
          </a:avLst>
        </a:prstGeom>
        <a:solidFill>
          <a:schemeClr val="accent6">
            <a:lumMod val="50000"/>
          </a:schemeClr>
        </a:solidFill>
        <a:ln w="1905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7145" tIns="17145" rIns="17145" bIns="17145" numCol="1" spcCol="1270" anchor="ctr" anchorCtr="0">
          <a:noAutofit/>
        </a:bodyPr>
        <a:lstStyle/>
        <a:p>
          <a:pPr marL="0" lvl="0" indent="0" algn="ctr" defTabSz="1200150">
            <a:lnSpc>
              <a:spcPct val="90000"/>
            </a:lnSpc>
            <a:spcBef>
              <a:spcPct val="0"/>
            </a:spcBef>
            <a:spcAft>
              <a:spcPct val="35000"/>
            </a:spcAft>
            <a:buNone/>
          </a:pPr>
          <a:r>
            <a:rPr lang="en-US" sz="2700" kern="1200" dirty="0"/>
            <a:t>GT with heavy drainage</a:t>
          </a:r>
        </a:p>
      </dsp:txBody>
      <dsp:txXfrm>
        <a:off x="464548" y="1980903"/>
        <a:ext cx="3452929" cy="1269998"/>
      </dsp:txXfrm>
    </dsp:sp>
    <dsp:sp modelId="{FCAE83D4-AB9A-4FA7-BB5B-C377BFB36004}">
      <dsp:nvSpPr>
        <dsp:cNvPr id="0" name=""/>
        <dsp:cNvSpPr/>
      </dsp:nvSpPr>
      <dsp:spPr>
        <a:xfrm rot="18770822">
          <a:off x="3703105" y="2006891"/>
          <a:ext cx="1586981" cy="54492"/>
        </a:xfrm>
        <a:custGeom>
          <a:avLst/>
          <a:gdLst/>
          <a:ahLst/>
          <a:cxnLst/>
          <a:rect l="0" t="0" r="0" b="0"/>
          <a:pathLst>
            <a:path>
              <a:moveTo>
                <a:pt x="0" y="27246"/>
              </a:moveTo>
              <a:lnTo>
                <a:pt x="1586981" y="27246"/>
              </a:lnTo>
            </a:path>
          </a:pathLst>
        </a:custGeom>
        <a:noFill/>
        <a:ln w="19050" cap="flat" cmpd="sng" algn="ctr">
          <a:solidFill>
            <a:schemeClr val="accent1">
              <a:shade val="6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222250">
            <a:lnSpc>
              <a:spcPct val="90000"/>
            </a:lnSpc>
            <a:spcBef>
              <a:spcPct val="0"/>
            </a:spcBef>
            <a:spcAft>
              <a:spcPct val="35000"/>
            </a:spcAft>
            <a:buNone/>
          </a:pPr>
          <a:endParaRPr lang="en-US" sz="500" kern="1200"/>
        </a:p>
      </dsp:txBody>
      <dsp:txXfrm>
        <a:off x="4456922" y="1994463"/>
        <a:ext cx="79349" cy="79349"/>
      </dsp:txXfrm>
    </dsp:sp>
    <dsp:sp modelId="{0D544886-99AC-4D19-91D6-628CC5DC13B1}">
      <dsp:nvSpPr>
        <dsp:cNvPr id="0" name=""/>
        <dsp:cNvSpPr/>
      </dsp:nvSpPr>
      <dsp:spPr>
        <a:xfrm>
          <a:off x="5036204" y="777862"/>
          <a:ext cx="2698040" cy="1349020"/>
        </a:xfrm>
        <a:prstGeom prst="roundRect">
          <a:avLst>
            <a:gd name="adj" fmla="val 10000"/>
          </a:avLst>
        </a:prstGeom>
        <a:solidFill>
          <a:schemeClr val="accent6">
            <a:lumMod val="75000"/>
          </a:schemeClr>
        </a:solidFill>
        <a:ln w="1905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7145" tIns="17145" rIns="17145" bIns="17145" numCol="1" spcCol="1270" anchor="ctr" anchorCtr="0">
          <a:noAutofit/>
        </a:bodyPr>
        <a:lstStyle/>
        <a:p>
          <a:pPr marL="0" lvl="0" indent="0" algn="ctr" defTabSz="1200150">
            <a:lnSpc>
              <a:spcPct val="90000"/>
            </a:lnSpc>
            <a:spcBef>
              <a:spcPct val="0"/>
            </a:spcBef>
            <a:spcAft>
              <a:spcPct val="35000"/>
            </a:spcAft>
            <a:buNone/>
          </a:pPr>
          <a:r>
            <a:rPr lang="en-US" sz="2700" kern="1200" dirty="0"/>
            <a:t>8-12 weeks post-op with first change complete</a:t>
          </a:r>
        </a:p>
      </dsp:txBody>
      <dsp:txXfrm>
        <a:off x="5075715" y="817373"/>
        <a:ext cx="2619018" cy="1269998"/>
      </dsp:txXfrm>
    </dsp:sp>
    <dsp:sp modelId="{A0C09F11-EA6A-4EEF-B740-770CAA4D78E1}">
      <dsp:nvSpPr>
        <dsp:cNvPr id="0" name=""/>
        <dsp:cNvSpPr/>
      </dsp:nvSpPr>
      <dsp:spPr>
        <a:xfrm rot="19457599">
          <a:off x="7609324" y="1037283"/>
          <a:ext cx="1329058" cy="54492"/>
        </a:xfrm>
        <a:custGeom>
          <a:avLst/>
          <a:gdLst/>
          <a:ahLst/>
          <a:cxnLst/>
          <a:rect l="0" t="0" r="0" b="0"/>
          <a:pathLst>
            <a:path>
              <a:moveTo>
                <a:pt x="0" y="27246"/>
              </a:moveTo>
              <a:lnTo>
                <a:pt x="1329058" y="27246"/>
              </a:lnTo>
            </a:path>
          </a:pathLst>
        </a:custGeom>
        <a:noFill/>
        <a:ln w="19050" cap="flat" cmpd="sng" algn="ctr">
          <a:solidFill>
            <a:schemeClr val="accent1">
              <a:shade val="8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222250">
            <a:lnSpc>
              <a:spcPct val="90000"/>
            </a:lnSpc>
            <a:spcBef>
              <a:spcPct val="0"/>
            </a:spcBef>
            <a:spcAft>
              <a:spcPct val="35000"/>
            </a:spcAft>
            <a:buNone/>
          </a:pPr>
          <a:endParaRPr lang="en-US" sz="500" kern="1200"/>
        </a:p>
      </dsp:txBody>
      <dsp:txXfrm>
        <a:off x="8240627" y="1031302"/>
        <a:ext cx="66452" cy="66452"/>
      </dsp:txXfrm>
    </dsp:sp>
    <dsp:sp modelId="{CF2C7FFD-C3C2-4B7C-AEE7-B2773FBD6147}">
      <dsp:nvSpPr>
        <dsp:cNvPr id="0" name=""/>
        <dsp:cNvSpPr/>
      </dsp:nvSpPr>
      <dsp:spPr>
        <a:xfrm>
          <a:off x="8813461" y="2175"/>
          <a:ext cx="2698040" cy="1349020"/>
        </a:xfrm>
        <a:prstGeom prst="roundRect">
          <a:avLst>
            <a:gd name="adj" fmla="val 10000"/>
          </a:avLst>
        </a:prstGeom>
        <a:solidFill>
          <a:schemeClr val="accent2">
            <a:lumMod val="75000"/>
          </a:schemeClr>
        </a:solidFill>
        <a:ln w="1905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7145" tIns="17145" rIns="17145" bIns="17145" numCol="1" spcCol="1270" anchor="ctr" anchorCtr="0">
          <a:noAutofit/>
        </a:bodyPr>
        <a:lstStyle/>
        <a:p>
          <a:pPr marL="0" lvl="0" indent="0" algn="ctr" defTabSz="1200150">
            <a:lnSpc>
              <a:spcPct val="90000"/>
            </a:lnSpc>
            <a:spcBef>
              <a:spcPct val="0"/>
            </a:spcBef>
            <a:spcAft>
              <a:spcPct val="35000"/>
            </a:spcAft>
            <a:buNone/>
          </a:pPr>
          <a:r>
            <a:rPr lang="en-US" sz="2700" kern="1200" dirty="0"/>
            <a:t>Consult CWON</a:t>
          </a:r>
        </a:p>
      </dsp:txBody>
      <dsp:txXfrm>
        <a:off x="8852972" y="41686"/>
        <a:ext cx="2619018" cy="1269998"/>
      </dsp:txXfrm>
    </dsp:sp>
    <dsp:sp modelId="{A603B908-9860-4C6F-9D79-0271CED45C0C}">
      <dsp:nvSpPr>
        <dsp:cNvPr id="0" name=""/>
        <dsp:cNvSpPr/>
      </dsp:nvSpPr>
      <dsp:spPr>
        <a:xfrm rot="2142401">
          <a:off x="7609324" y="1812970"/>
          <a:ext cx="1329058" cy="54492"/>
        </a:xfrm>
        <a:custGeom>
          <a:avLst/>
          <a:gdLst/>
          <a:ahLst/>
          <a:cxnLst/>
          <a:rect l="0" t="0" r="0" b="0"/>
          <a:pathLst>
            <a:path>
              <a:moveTo>
                <a:pt x="0" y="27246"/>
              </a:moveTo>
              <a:lnTo>
                <a:pt x="1329058" y="27246"/>
              </a:lnTo>
            </a:path>
          </a:pathLst>
        </a:custGeom>
        <a:noFill/>
        <a:ln w="19050" cap="flat" cmpd="sng" algn="ctr">
          <a:solidFill>
            <a:schemeClr val="accent1">
              <a:shade val="8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222250">
            <a:lnSpc>
              <a:spcPct val="90000"/>
            </a:lnSpc>
            <a:spcBef>
              <a:spcPct val="0"/>
            </a:spcBef>
            <a:spcAft>
              <a:spcPct val="35000"/>
            </a:spcAft>
            <a:buNone/>
          </a:pPr>
          <a:endParaRPr lang="en-US" sz="500" kern="1200"/>
        </a:p>
      </dsp:txBody>
      <dsp:txXfrm>
        <a:off x="8240627" y="1806989"/>
        <a:ext cx="66452" cy="66452"/>
      </dsp:txXfrm>
    </dsp:sp>
    <dsp:sp modelId="{69D4CCA4-D6C7-4172-B214-A3DA96BEBF23}">
      <dsp:nvSpPr>
        <dsp:cNvPr id="0" name=""/>
        <dsp:cNvSpPr/>
      </dsp:nvSpPr>
      <dsp:spPr>
        <a:xfrm>
          <a:off x="8813461" y="1553549"/>
          <a:ext cx="2698040" cy="1349020"/>
        </a:xfrm>
        <a:prstGeom prst="roundRect">
          <a:avLst>
            <a:gd name="adj" fmla="val 10000"/>
          </a:avLst>
        </a:prstGeom>
        <a:solidFill>
          <a:schemeClr val="accent1">
            <a:hueOff val="0"/>
            <a:satOff val="0"/>
            <a:lumOff val="0"/>
            <a:alphaOff val="0"/>
          </a:schemeClr>
        </a:solidFill>
        <a:ln w="1905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7145" tIns="17145" rIns="17145" bIns="17145" numCol="1" spcCol="1270" anchor="ctr" anchorCtr="0">
          <a:noAutofit/>
        </a:bodyPr>
        <a:lstStyle/>
        <a:p>
          <a:pPr marL="0" lvl="0" indent="0" algn="ctr" defTabSz="1200150">
            <a:lnSpc>
              <a:spcPct val="90000"/>
            </a:lnSpc>
            <a:spcBef>
              <a:spcPct val="0"/>
            </a:spcBef>
            <a:spcAft>
              <a:spcPct val="35000"/>
            </a:spcAft>
            <a:buNone/>
          </a:pPr>
          <a:r>
            <a:rPr lang="en-US" sz="2700" kern="1200" dirty="0"/>
            <a:t>Consult Ped Surg</a:t>
          </a:r>
        </a:p>
      </dsp:txBody>
      <dsp:txXfrm>
        <a:off x="8852972" y="1593060"/>
        <a:ext cx="2619018" cy="1269998"/>
      </dsp:txXfrm>
    </dsp:sp>
    <dsp:sp modelId="{725E3F5F-784F-4313-9234-346988889417}">
      <dsp:nvSpPr>
        <dsp:cNvPr id="0" name=""/>
        <dsp:cNvSpPr/>
      </dsp:nvSpPr>
      <dsp:spPr>
        <a:xfrm rot="2829178">
          <a:off x="3703105" y="3170421"/>
          <a:ext cx="1586981" cy="54492"/>
        </a:xfrm>
        <a:custGeom>
          <a:avLst/>
          <a:gdLst/>
          <a:ahLst/>
          <a:cxnLst/>
          <a:rect l="0" t="0" r="0" b="0"/>
          <a:pathLst>
            <a:path>
              <a:moveTo>
                <a:pt x="0" y="27246"/>
              </a:moveTo>
              <a:lnTo>
                <a:pt x="1586981" y="27246"/>
              </a:lnTo>
            </a:path>
          </a:pathLst>
        </a:custGeom>
        <a:noFill/>
        <a:ln w="19050" cap="flat" cmpd="sng" algn="ctr">
          <a:solidFill>
            <a:schemeClr val="accent1">
              <a:shade val="6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222250">
            <a:lnSpc>
              <a:spcPct val="90000"/>
            </a:lnSpc>
            <a:spcBef>
              <a:spcPct val="0"/>
            </a:spcBef>
            <a:spcAft>
              <a:spcPct val="35000"/>
            </a:spcAft>
            <a:buNone/>
          </a:pPr>
          <a:endParaRPr lang="en-US" sz="500" kern="1200"/>
        </a:p>
      </dsp:txBody>
      <dsp:txXfrm>
        <a:off x="4456922" y="3157993"/>
        <a:ext cx="79349" cy="79349"/>
      </dsp:txXfrm>
    </dsp:sp>
    <dsp:sp modelId="{2348CA0E-AB4E-4A40-9DEA-9D625837DCCE}">
      <dsp:nvSpPr>
        <dsp:cNvPr id="0" name=""/>
        <dsp:cNvSpPr/>
      </dsp:nvSpPr>
      <dsp:spPr>
        <a:xfrm>
          <a:off x="5036204" y="3104922"/>
          <a:ext cx="2698040" cy="1349020"/>
        </a:xfrm>
        <a:prstGeom prst="roundRect">
          <a:avLst>
            <a:gd name="adj" fmla="val 10000"/>
          </a:avLst>
        </a:prstGeom>
        <a:solidFill>
          <a:schemeClr val="accent6">
            <a:lumMod val="75000"/>
          </a:schemeClr>
        </a:solidFill>
        <a:ln w="1905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7145" tIns="17145" rIns="17145" bIns="17145" numCol="1" spcCol="1270" anchor="ctr" anchorCtr="0">
          <a:noAutofit/>
        </a:bodyPr>
        <a:lstStyle/>
        <a:p>
          <a:pPr marL="0" lvl="0" indent="0" algn="ctr" defTabSz="1200150">
            <a:lnSpc>
              <a:spcPct val="90000"/>
            </a:lnSpc>
            <a:spcBef>
              <a:spcPct val="0"/>
            </a:spcBef>
            <a:spcAft>
              <a:spcPct val="35000"/>
            </a:spcAft>
            <a:buNone/>
          </a:pPr>
          <a:r>
            <a:rPr lang="en-US" sz="2700" kern="1200" dirty="0"/>
            <a:t>Skin Breakdown</a:t>
          </a:r>
        </a:p>
      </dsp:txBody>
      <dsp:txXfrm>
        <a:off x="5075715" y="3144433"/>
        <a:ext cx="2619018" cy="1269998"/>
      </dsp:txXfrm>
    </dsp:sp>
    <dsp:sp modelId="{6799A8CB-B409-47D6-B2EE-FCF32D526356}">
      <dsp:nvSpPr>
        <dsp:cNvPr id="0" name=""/>
        <dsp:cNvSpPr/>
      </dsp:nvSpPr>
      <dsp:spPr>
        <a:xfrm>
          <a:off x="7734245" y="3752186"/>
          <a:ext cx="1079216" cy="54492"/>
        </a:xfrm>
        <a:custGeom>
          <a:avLst/>
          <a:gdLst/>
          <a:ahLst/>
          <a:cxnLst/>
          <a:rect l="0" t="0" r="0" b="0"/>
          <a:pathLst>
            <a:path>
              <a:moveTo>
                <a:pt x="0" y="27246"/>
              </a:moveTo>
              <a:lnTo>
                <a:pt x="1079216" y="27246"/>
              </a:lnTo>
            </a:path>
          </a:pathLst>
        </a:custGeom>
        <a:noFill/>
        <a:ln w="19050" cap="flat" cmpd="sng" algn="ctr">
          <a:solidFill>
            <a:schemeClr val="accent1">
              <a:shade val="8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marL="0" lvl="0" indent="0" algn="ctr" defTabSz="222250">
            <a:lnSpc>
              <a:spcPct val="90000"/>
            </a:lnSpc>
            <a:spcBef>
              <a:spcPct val="0"/>
            </a:spcBef>
            <a:spcAft>
              <a:spcPct val="35000"/>
            </a:spcAft>
            <a:buNone/>
          </a:pPr>
          <a:endParaRPr lang="en-US" sz="500" kern="1200"/>
        </a:p>
      </dsp:txBody>
      <dsp:txXfrm>
        <a:off x="8246873" y="3752452"/>
        <a:ext cx="53960" cy="53960"/>
      </dsp:txXfrm>
    </dsp:sp>
    <dsp:sp modelId="{B713A46A-A77A-4995-AD45-B69E67867E46}">
      <dsp:nvSpPr>
        <dsp:cNvPr id="0" name=""/>
        <dsp:cNvSpPr/>
      </dsp:nvSpPr>
      <dsp:spPr>
        <a:xfrm>
          <a:off x="8813461" y="3104922"/>
          <a:ext cx="2698040" cy="1349020"/>
        </a:xfrm>
        <a:prstGeom prst="roundRect">
          <a:avLst>
            <a:gd name="adj" fmla="val 10000"/>
          </a:avLst>
        </a:prstGeom>
        <a:solidFill>
          <a:schemeClr val="accent2">
            <a:lumMod val="75000"/>
          </a:schemeClr>
        </a:solidFill>
        <a:ln w="1905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7145" tIns="17145" rIns="17145" bIns="17145" numCol="1" spcCol="1270" anchor="ctr" anchorCtr="0">
          <a:noAutofit/>
        </a:bodyPr>
        <a:lstStyle/>
        <a:p>
          <a:pPr marL="0" lvl="0" indent="0" algn="ctr" defTabSz="1200150">
            <a:lnSpc>
              <a:spcPct val="90000"/>
            </a:lnSpc>
            <a:spcBef>
              <a:spcPct val="0"/>
            </a:spcBef>
            <a:spcAft>
              <a:spcPct val="35000"/>
            </a:spcAft>
            <a:buNone/>
          </a:pPr>
          <a:r>
            <a:rPr lang="en-US" sz="2700" kern="1200" dirty="0"/>
            <a:t>Consult CWON</a:t>
          </a:r>
        </a:p>
      </dsp:txBody>
      <dsp:txXfrm>
        <a:off x="8852972" y="3144433"/>
        <a:ext cx="2619018" cy="1269998"/>
      </dsp:txXfrm>
    </dsp:sp>
  </dsp:spTree>
</dsp:drawing>
</file>

<file path=ppt/diagrams/layout1.xml><?xml version="1.0" encoding="utf-8"?>
<dgm:layoutDef xmlns:dgm="http://schemas.openxmlformats.org/drawingml/2006/diagram" xmlns:a="http://schemas.openxmlformats.org/drawingml/2006/main" uniqueId="urn:microsoft.com/office/officeart/2005/8/layout/hierarchy1">
  <dgm:title val=""/>
  <dgm:desc val=""/>
  <dgm:catLst>
    <dgm:cat type="hierarchy" pri="2000"/>
  </dgm:catLst>
  <dgm:sampData>
    <dgm:dataModel>
      <dgm:ptLst>
        <dgm:pt modelId="0" type="doc"/>
        <dgm:pt modelId="1">
          <dgm:prSet phldr="1"/>
        </dgm:pt>
        <dgm:pt modelId="2">
          <dgm:prSet phldr="1"/>
        </dgm:pt>
        <dgm:pt modelId="21">
          <dgm:prSet phldr="1"/>
        </dgm:pt>
        <dgm:pt modelId="22">
          <dgm:prSet phldr="1"/>
        </dgm:pt>
        <dgm:pt modelId="3">
          <dgm:prSet phldr="1"/>
        </dgm:pt>
        <dgm:pt modelId="31">
          <dgm:prSet phldr="1"/>
        </dgm:pt>
      </dgm:ptLst>
      <dgm:cxnLst>
        <dgm:cxn modelId="4" srcId="0" destId="1" srcOrd="0" destOrd="0"/>
        <dgm:cxn modelId="5" srcId="1" destId="2" srcOrd="0" destOrd="0"/>
        <dgm:cxn modelId="6" srcId="1" destId="3" srcOrd="1" destOrd="0"/>
        <dgm:cxn modelId="23" srcId="2" destId="21" srcOrd="0" destOrd="0"/>
        <dgm:cxn modelId="24" srcId="2" destId="22" srcOrd="1" destOrd="0"/>
        <dgm:cxn modelId="33" srcId="3" destId="31" srcOrd="0" destOrd="0"/>
      </dgm:cxnLst>
      <dgm:bg/>
      <dgm:whole/>
    </dgm:dataModel>
  </dgm:sampData>
  <dgm:styleData>
    <dgm:dataModel>
      <dgm:ptLst>
        <dgm:pt modelId="0" type="doc"/>
        <dgm:pt modelId="1"/>
        <dgm:pt modelId="11"/>
        <dgm:pt modelId="12"/>
      </dgm:ptLst>
      <dgm:cxnLst>
        <dgm:cxn modelId="2" srcId="0" destId="1" srcOrd="0" destOrd="0"/>
        <dgm:cxn modelId="13" srcId="1" destId="11" srcOrd="0" destOrd="0"/>
        <dgm:cxn modelId="14" srcId="1" destId="12" srcOrd="1" destOrd="0"/>
      </dgm:cxnLst>
      <dgm:bg/>
      <dgm:whole/>
    </dgm:dataModel>
  </dgm:styleData>
  <dgm:clrData>
    <dgm:dataModel>
      <dgm:ptLst>
        <dgm:pt modelId="0" type="doc"/>
        <dgm:pt modelId="1"/>
        <dgm:pt modelId="2"/>
        <dgm:pt modelId="21"/>
        <dgm:pt modelId="211"/>
        <dgm:pt modelId="3"/>
        <dgm:pt modelId="31"/>
        <dgm:pt modelId="311"/>
      </dgm:ptLst>
      <dgm:cxnLst>
        <dgm:cxn modelId="4" srcId="0" destId="1" srcOrd="0" destOrd="0"/>
        <dgm:cxn modelId="5" srcId="1" destId="2" srcOrd="0" destOrd="0"/>
        <dgm:cxn modelId="6" srcId="1" destId="3" srcOrd="1" destOrd="0"/>
        <dgm:cxn modelId="23" srcId="2" destId="21" srcOrd="0" destOrd="0"/>
        <dgm:cxn modelId="24" srcId="21" destId="211" srcOrd="0" destOrd="0"/>
        <dgm:cxn modelId="33" srcId="3" destId="31" srcOrd="0" destOrd="0"/>
        <dgm:cxn modelId="34" srcId="31" destId="311" srcOrd="0" destOrd="0"/>
      </dgm:cxnLst>
      <dgm:bg/>
      <dgm:whole/>
    </dgm:dataModel>
  </dgm:clrData>
  <dgm:layoutNode name="hierChild1">
    <dgm:varLst>
      <dgm:chPref val="1"/>
      <dgm:dir/>
      <dgm:animOne val="branch"/>
      <dgm:animLvl val="lvl"/>
      <dgm:resizeHandles/>
    </dgm:varLst>
    <dgm:choose name="Name0">
      <dgm:if name="Name1" func="var" arg="dir" op="equ" val="norm">
        <dgm:alg type="hierChild">
          <dgm:param type="linDir" val="fromL"/>
        </dgm:alg>
      </dgm:if>
      <dgm:else name="Name2">
        <dgm:alg type="hierChild">
          <dgm:param type="linDir" val="fromR"/>
        </dgm:alg>
      </dgm:else>
    </dgm:choose>
    <dgm:shape xmlns:r="http://schemas.openxmlformats.org/officeDocument/2006/relationships" r:blip="">
      <dgm:adjLst/>
    </dgm:shape>
    <dgm:presOf/>
    <dgm:constrLst>
      <dgm:constr type="primFontSz" for="des" ptType="node" op="equ" val="65"/>
      <dgm:constr type="w" for="des" forName="composite" refType="w"/>
      <dgm:constr type="h" for="des" forName="composite" refType="w" refFor="des" refForName="composite" fact="0.667"/>
      <dgm:constr type="w" for="des" forName="composite2" refType="w" refFor="des" refForName="composite"/>
      <dgm:constr type="h" for="des" forName="composite2" refType="h" refFor="des" refForName="composite"/>
      <dgm:constr type="w" for="des" forName="composite3" refType="w" refFor="des" refForName="composite"/>
      <dgm:constr type="h" for="des" forName="composite3" refType="h" refFor="des" refForName="composite"/>
      <dgm:constr type="w" for="des" forName="composite4" refType="w" refFor="des" refForName="composite"/>
      <dgm:constr type="h" for="des" forName="composite4" refType="h" refFor="des" refForName="composite"/>
      <dgm:constr type="w" for="des" forName="composite5" refType="w" refFor="des" refForName="composite"/>
      <dgm:constr type="h" for="des" forName="composite5" refType="h" refFor="des" refForName="composite"/>
      <dgm:constr type="sibSp" refType="w" refFor="des" refForName="composite" fact="0.1"/>
      <dgm:constr type="sibSp" for="des" forName="hierChild2" refType="sibSp"/>
      <dgm:constr type="sibSp" for="des" forName="hierChild3" refType="sibSp"/>
      <dgm:constr type="sibSp" for="des" forName="hierChild4" refType="sibSp"/>
      <dgm:constr type="sibSp" for="des" forName="hierChild5" refType="sibSp"/>
      <dgm:constr type="sibSp" for="des" forName="hierChild6" refType="sibSp"/>
      <dgm:constr type="sp" for="des" forName="hierRoot1" refType="h" refFor="des" refForName="composite" fact="0.25"/>
      <dgm:constr type="sp" for="des" forName="hierRoot2" refType="sp" refFor="des" refForName="hierRoot1"/>
      <dgm:constr type="sp" for="des" forName="hierRoot3" refType="sp" refFor="des" refForName="hierRoot1"/>
      <dgm:constr type="sp" for="des" forName="hierRoot4" refType="sp" refFor="des" refForName="hierRoot1"/>
      <dgm:constr type="sp" for="des" forName="hierRoot5" refType="sp" refFor="des" refForName="hierRoot1"/>
    </dgm:constrLst>
    <dgm:ruleLst/>
    <dgm:forEach name="Name3" axis="ch">
      <dgm:forEach name="Name4" axis="self" ptType="node">
        <dgm:layoutNode name="hierRoot1">
          <dgm:alg type="hierRoot"/>
          <dgm:shape xmlns:r="http://schemas.openxmlformats.org/officeDocument/2006/relationships" r:blip="">
            <dgm:adjLst/>
          </dgm:shape>
          <dgm:presOf/>
          <dgm:constrLst>
            <dgm:constr type="bendDist" for="des" ptType="parTrans" refType="sp" fact="0.5"/>
          </dgm:constrLst>
          <dgm:ruleLst/>
          <dgm:layoutNode name="composite">
            <dgm:alg type="composite"/>
            <dgm:shape xmlns:r="http://schemas.openxmlformats.org/officeDocument/2006/relationships" r:blip="">
              <dgm:adjLst/>
            </dgm:shape>
            <dgm:presOf/>
            <dgm:constrLst>
              <dgm:constr type="w" for="ch" forName="background" refType="w" fact="0.9"/>
              <dgm:constr type="h" for="ch" forName="background" refType="w" refFor="ch" refForName="background" fact="0.635"/>
              <dgm:constr type="t" for="ch" forName="background"/>
              <dgm:constr type="l" for="ch" forName="background"/>
              <dgm:constr type="w" for="ch" forName="text" refType="w" fact="0.9"/>
              <dgm:constr type="h" for="ch" forName="text" refType="w" refFor="ch" refForName="text" fact="0.635"/>
              <dgm:constr type="t" for="ch" forName="text" refType="w" fact="0.095"/>
              <dgm:constr type="l" for="ch" forName="text" refType="w" fact="0.1"/>
            </dgm:constrLst>
            <dgm:ruleLst/>
            <dgm:layoutNode name="background" styleLbl="node0" moveWith="text">
              <dgm:alg type="sp"/>
              <dgm:shape xmlns:r="http://schemas.openxmlformats.org/officeDocument/2006/relationships" type="roundRect" r:blip="">
                <dgm:adjLst>
                  <dgm:adj idx="1" val="0.1"/>
                </dgm:adjLst>
              </dgm:shape>
              <dgm:presOf/>
              <dgm:constrLst/>
              <dgm:ruleLst/>
            </dgm:layoutNode>
            <dgm:layoutNode name="text" styleLbl="fgAcc0">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2">
            <dgm:choose name="Name5">
              <dgm:if name="Name6" func="var" arg="dir" op="equ" val="norm">
                <dgm:alg type="hierChild">
                  <dgm:param type="linDir" val="fromL"/>
                </dgm:alg>
              </dgm:if>
              <dgm:else name="Name7">
                <dgm:alg type="hierChild">
                  <dgm:param type="linDir" val="fromR"/>
                </dgm:alg>
              </dgm:else>
            </dgm:choose>
            <dgm:shape xmlns:r="http://schemas.openxmlformats.org/officeDocument/2006/relationships" r:blip="">
              <dgm:adjLst/>
            </dgm:shape>
            <dgm:presOf/>
            <dgm:constrLst/>
            <dgm:ruleLst/>
            <dgm:forEach name="Name8" axis="ch">
              <dgm:forEach name="Name9" axis="self" ptType="parTrans" cnt="1">
                <dgm:layoutNode name="Name10">
                  <dgm:alg type="conn">
                    <dgm:param type="dim" val="1D"/>
                    <dgm:param type="endSty" val="noArr"/>
                    <dgm:param type="connRout" val="bend"/>
                    <dgm:param type="bendPt" val="end"/>
                    <dgm:param type="begPts" val="bCtr"/>
                    <dgm:param type="endPts" val="tCtr"/>
                    <dgm:param type="srcNode" val="background"/>
                    <dgm:param type="dstNode" val="background2"/>
                  </dgm:alg>
                  <dgm:shape xmlns:r="http://schemas.openxmlformats.org/officeDocument/2006/relationships" type="conn" r:blip="" zOrderOff="-999">
                    <dgm:adjLst/>
                  </dgm:shape>
                  <dgm:presOf axis="self"/>
                  <dgm:constrLst>
                    <dgm:constr type="begPad"/>
                    <dgm:constr type="endPad"/>
                  </dgm:constrLst>
                  <dgm:ruleLst/>
                </dgm:layoutNode>
              </dgm:forEach>
              <dgm:forEach name="Name11" axis="self" ptType="node">
                <dgm:layoutNode name="hierRoot2">
                  <dgm:alg type="hierRoot"/>
                  <dgm:shape xmlns:r="http://schemas.openxmlformats.org/officeDocument/2006/relationships" r:blip="">
                    <dgm:adjLst/>
                  </dgm:shape>
                  <dgm:presOf/>
                  <dgm:constrLst>
                    <dgm:constr type="bendDist" for="des" ptType="parTrans" refType="sp" fact="0.5"/>
                  </dgm:constrLst>
                  <dgm:ruleLst/>
                  <dgm:layoutNode name="composite2">
                    <dgm:alg type="composite"/>
                    <dgm:shape xmlns:r="http://schemas.openxmlformats.org/officeDocument/2006/relationships" r:blip="">
                      <dgm:adjLst/>
                    </dgm:shape>
                    <dgm:presOf/>
                    <dgm:constrLst>
                      <dgm:constr type="w" for="ch" forName="background2" refType="w" fact="0.9"/>
                      <dgm:constr type="h" for="ch" forName="background2" refType="w" refFor="ch" refForName="background2" fact="0.635"/>
                      <dgm:constr type="t" for="ch" forName="background2"/>
                      <dgm:constr type="l" for="ch" forName="background2"/>
                      <dgm:constr type="w" for="ch" forName="text2" refType="w" fact="0.9"/>
                      <dgm:constr type="h" for="ch" forName="text2" refType="w" refFor="ch" refForName="text2" fact="0.635"/>
                      <dgm:constr type="t" for="ch" forName="text2" refType="w" fact="0.095"/>
                      <dgm:constr type="l" for="ch" forName="text2" refType="w" fact="0.1"/>
                    </dgm:constrLst>
                    <dgm:ruleLst/>
                    <dgm:layoutNode name="background2" moveWith="text2">
                      <dgm:alg type="sp"/>
                      <dgm:shape xmlns:r="http://schemas.openxmlformats.org/officeDocument/2006/relationships" type="roundRect" r:blip="">
                        <dgm:adjLst>
                          <dgm:adj idx="1" val="0.1"/>
                        </dgm:adjLst>
                      </dgm:shape>
                      <dgm:presOf/>
                      <dgm:constrLst/>
                      <dgm:ruleLst/>
                    </dgm:layoutNode>
                    <dgm:layoutNode name="text2" styleLbl="fgAcc2">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3">
                    <dgm:choose name="Name12">
                      <dgm:if name="Name13" func="var" arg="dir" op="equ" val="norm">
                        <dgm:alg type="hierChild">
                          <dgm:param type="linDir" val="fromL"/>
                        </dgm:alg>
                      </dgm:if>
                      <dgm:else name="Name14">
                        <dgm:alg type="hierChild">
                          <dgm:param type="linDir" val="fromR"/>
                        </dgm:alg>
                      </dgm:else>
                    </dgm:choose>
                    <dgm:shape xmlns:r="http://schemas.openxmlformats.org/officeDocument/2006/relationships" r:blip="">
                      <dgm:adjLst/>
                    </dgm:shape>
                    <dgm:presOf/>
                    <dgm:constrLst/>
                    <dgm:ruleLst/>
                    <dgm:forEach name="Name15" axis="ch">
                      <dgm:forEach name="Name16" axis="self" ptType="parTrans" cnt="1">
                        <dgm:layoutNode name="Name17">
                          <dgm:alg type="conn">
                            <dgm:param type="dim" val="1D"/>
                            <dgm:param type="endSty" val="noArr"/>
                            <dgm:param type="connRout" val="bend"/>
                            <dgm:param type="bendPt" val="end"/>
                            <dgm:param type="begPts" val="bCtr"/>
                            <dgm:param type="endPts" val="tCtr"/>
                            <dgm:param type="srcNode" val="background2"/>
                            <dgm:param type="dstNode" val="background3"/>
                          </dgm:alg>
                          <dgm:shape xmlns:r="http://schemas.openxmlformats.org/officeDocument/2006/relationships" type="conn" r:blip="" zOrderOff="-999">
                            <dgm:adjLst/>
                          </dgm:shape>
                          <dgm:presOf axis="self"/>
                          <dgm:constrLst>
                            <dgm:constr type="begPad"/>
                            <dgm:constr type="endPad"/>
                          </dgm:constrLst>
                          <dgm:ruleLst/>
                        </dgm:layoutNode>
                      </dgm:forEach>
                      <dgm:forEach name="Name18" axis="self" ptType="node">
                        <dgm:layoutNode name="hierRoot3">
                          <dgm:alg type="hierRoot"/>
                          <dgm:shape xmlns:r="http://schemas.openxmlformats.org/officeDocument/2006/relationships" r:blip="">
                            <dgm:adjLst/>
                          </dgm:shape>
                          <dgm:presOf/>
                          <dgm:constrLst>
                            <dgm:constr type="bendDist" for="des" ptType="parTrans" refType="sp" fact="0.5"/>
                          </dgm:constrLst>
                          <dgm:ruleLst/>
                          <dgm:layoutNode name="composite3">
                            <dgm:alg type="composite"/>
                            <dgm:shape xmlns:r="http://schemas.openxmlformats.org/officeDocument/2006/relationships" r:blip="">
                              <dgm:adjLst/>
                            </dgm:shape>
                            <dgm:presOf/>
                            <dgm:constrLst>
                              <dgm:constr type="w" for="ch" forName="background3" refType="w" fact="0.9"/>
                              <dgm:constr type="h" for="ch" forName="background3" refType="w" refFor="ch" refForName="background3" fact="0.635"/>
                              <dgm:constr type="t" for="ch" forName="background3"/>
                              <dgm:constr type="l" for="ch" forName="background3"/>
                              <dgm:constr type="w" for="ch" forName="text3" refType="w" fact="0.9"/>
                              <dgm:constr type="h" for="ch" forName="text3" refType="w" refFor="ch" refForName="text3" fact="0.635"/>
                              <dgm:constr type="t" for="ch" forName="text3" refType="w" fact="0.095"/>
                              <dgm:constr type="l" for="ch" forName="text3" refType="w" fact="0.1"/>
                            </dgm:constrLst>
                            <dgm:ruleLst/>
                            <dgm:layoutNode name="background3" moveWith="text3">
                              <dgm:alg type="sp"/>
                              <dgm:shape xmlns:r="http://schemas.openxmlformats.org/officeDocument/2006/relationships" type="roundRect" r:blip="">
                                <dgm:adjLst>
                                  <dgm:adj idx="1" val="0.1"/>
                                </dgm:adjLst>
                              </dgm:shape>
                              <dgm:presOf/>
                              <dgm:constrLst/>
                              <dgm:ruleLst/>
                            </dgm:layoutNode>
                            <dgm:layoutNode name="text3" styleLbl="fgAcc3">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4">
                            <dgm:choose name="Name19">
                              <dgm:if name="Name20" func="var" arg="dir" op="equ" val="norm">
                                <dgm:alg type="hierChild">
                                  <dgm:param type="linDir" val="fromL"/>
                                </dgm:alg>
                              </dgm:if>
                              <dgm:else name="Name21">
                                <dgm:alg type="hierChild">
                                  <dgm:param type="linDir" val="fromR"/>
                                </dgm:alg>
                              </dgm:else>
                            </dgm:choose>
                            <dgm:shape xmlns:r="http://schemas.openxmlformats.org/officeDocument/2006/relationships" r:blip="">
                              <dgm:adjLst/>
                            </dgm:shape>
                            <dgm:presOf/>
                            <dgm:constrLst/>
                            <dgm:ruleLst/>
                            <dgm:forEach name="repeat" axis="ch">
                              <dgm:forEach name="Name22" axis="self" ptType="parTrans" cnt="1">
                                <dgm:layoutNode name="Name23">
                                  <dgm:choose name="Name24">
                                    <dgm:if name="Name25" axis="self" func="depth" op="lte" val="4">
                                      <dgm:alg type="conn">
                                        <dgm:param type="dim" val="1D"/>
                                        <dgm:param type="endSty" val="noArr"/>
                                        <dgm:param type="connRout" val="bend"/>
                                        <dgm:param type="bendPt" val="end"/>
                                        <dgm:param type="begPts" val="bCtr"/>
                                        <dgm:param type="endPts" val="tCtr"/>
                                        <dgm:param type="srcNode" val="background3"/>
                                        <dgm:param type="dstNode" val="background4"/>
                                      </dgm:alg>
                                    </dgm:if>
                                    <dgm:else name="Name26">
                                      <dgm:alg type="conn">
                                        <dgm:param type="dim" val="1D"/>
                                        <dgm:param type="endSty" val="noArr"/>
                                        <dgm:param type="connRout" val="bend"/>
                                        <dgm:param type="bendPt" val="end"/>
                                        <dgm:param type="begPts" val="bCtr"/>
                                        <dgm:param type="endPts" val="tCtr"/>
                                        <dgm:param type="srcNode" val="background4"/>
                                        <dgm:param type="dstNode" val="background4"/>
                                      </dgm:alg>
                                    </dgm:else>
                                  </dgm:choose>
                                  <dgm:shape xmlns:r="http://schemas.openxmlformats.org/officeDocument/2006/relationships" type="conn" r:blip="" zOrderOff="-999">
                                    <dgm:adjLst/>
                                  </dgm:shape>
                                  <dgm:presOf axis="self"/>
                                  <dgm:constrLst>
                                    <dgm:constr type="begPad"/>
                                    <dgm:constr type="endPad"/>
                                  </dgm:constrLst>
                                  <dgm:ruleLst/>
                                </dgm:layoutNode>
                              </dgm:forEach>
                              <dgm:forEach name="Name27" axis="self" ptType="node">
                                <dgm:layoutNode name="hierRoot4">
                                  <dgm:alg type="hierRoot"/>
                                  <dgm:shape xmlns:r="http://schemas.openxmlformats.org/officeDocument/2006/relationships" r:blip="">
                                    <dgm:adjLst/>
                                  </dgm:shape>
                                  <dgm:presOf/>
                                  <dgm:constrLst>
                                    <dgm:constr type="bendDist" for="des" ptType="parTrans" refType="sp" fact="0.5"/>
                                  </dgm:constrLst>
                                  <dgm:ruleLst/>
                                  <dgm:layoutNode name="composite4">
                                    <dgm:alg type="composite"/>
                                    <dgm:shape xmlns:r="http://schemas.openxmlformats.org/officeDocument/2006/relationships" r:blip="">
                                      <dgm:adjLst/>
                                    </dgm:shape>
                                    <dgm:presOf/>
                                    <dgm:constrLst>
                                      <dgm:constr type="w" for="ch" forName="background4" refType="w" fact="0.9"/>
                                      <dgm:constr type="h" for="ch" forName="background4" refType="w" refFor="ch" refForName="background4" fact="0.635"/>
                                      <dgm:constr type="t" for="ch" forName="background4"/>
                                      <dgm:constr type="l" for="ch" forName="background4"/>
                                      <dgm:constr type="w" for="ch" forName="text4" refType="w" fact="0.9"/>
                                      <dgm:constr type="h" for="ch" forName="text4" refType="w" refFor="ch" refForName="text4" fact="0.635"/>
                                      <dgm:constr type="t" for="ch" forName="text4" refType="w" fact="0.095"/>
                                      <dgm:constr type="l" for="ch" forName="text4" refType="w" fact="0.1"/>
                                    </dgm:constrLst>
                                    <dgm:ruleLst/>
                                    <dgm:layoutNode name="background4" moveWith="text4">
                                      <dgm:alg type="sp"/>
                                      <dgm:shape xmlns:r="http://schemas.openxmlformats.org/officeDocument/2006/relationships" type="roundRect" r:blip="">
                                        <dgm:adjLst>
                                          <dgm:adj idx="1" val="0.1"/>
                                        </dgm:adjLst>
                                      </dgm:shape>
                                      <dgm:presOf/>
                                      <dgm:constrLst/>
                                      <dgm:ruleLst/>
                                    </dgm:layoutNode>
                                    <dgm:layoutNode name="text4" styleLbl="fgAcc4">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5">
                                    <dgm:choose name="Name28">
                                      <dgm:if name="Name29" func="var" arg="dir" op="equ" val="norm">
                                        <dgm:alg type="hierChild">
                                          <dgm:param type="linDir" val="fromL"/>
                                        </dgm:alg>
                                      </dgm:if>
                                      <dgm:else name="Name30">
                                        <dgm:alg type="hierChild">
                                          <dgm:param type="linDir" val="fromR"/>
                                        </dgm:alg>
                                      </dgm:else>
                                    </dgm:choose>
                                    <dgm:shape xmlns:r="http://schemas.openxmlformats.org/officeDocument/2006/relationships" r:blip="">
                                      <dgm:adjLst/>
                                    </dgm:shape>
                                    <dgm:presOf/>
                                    <dgm:constrLst/>
                                    <dgm:ruleLst/>
                                    <dgm:forEach name="Name31" ref="repeat"/>
                                  </dgm:layoutNode>
                                </dgm:layoutNode>
                              </dgm:forEach>
                            </dgm:forEach>
                          </dgm:layoutNode>
                        </dgm:layoutNode>
                      </dgm:forEach>
                    </dgm:forEach>
                  </dgm:layoutNode>
                </dgm:layoutNode>
              </dgm:forEach>
            </dgm:forEach>
          </dgm:layoutNode>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hierarchy2">
  <dgm:title val=""/>
  <dgm:desc val=""/>
  <dgm:catLst>
    <dgm:cat type="hierarchy" pri="5000"/>
  </dgm:catLst>
  <dgm:sampData>
    <dgm:dataModel>
      <dgm:ptLst>
        <dgm:pt modelId="0" type="doc"/>
        <dgm:pt modelId="1">
          <dgm:prSet phldr="1"/>
        </dgm:pt>
        <dgm:pt modelId="2">
          <dgm:prSet phldr="1"/>
        </dgm:pt>
        <dgm:pt modelId="21">
          <dgm:prSet phldr="1"/>
        </dgm:pt>
        <dgm:pt modelId="22">
          <dgm:prSet phldr="1"/>
        </dgm:pt>
        <dgm:pt modelId="3">
          <dgm:prSet phldr="1"/>
        </dgm:pt>
        <dgm:pt modelId="31">
          <dgm:prSet phldr="1"/>
        </dgm:pt>
      </dgm:ptLst>
      <dgm:cxnLst>
        <dgm:cxn modelId="4" srcId="0" destId="1" srcOrd="0" destOrd="0"/>
        <dgm:cxn modelId="5" srcId="1" destId="2" srcOrd="0" destOrd="0"/>
        <dgm:cxn modelId="6" srcId="1" destId="3" srcOrd="1" destOrd="0"/>
        <dgm:cxn modelId="23" srcId="2" destId="21" srcOrd="0" destOrd="0"/>
        <dgm:cxn modelId="24" srcId="2" destId="22" srcOrd="1" destOrd="0"/>
        <dgm:cxn modelId="33" srcId="3" destId="31" srcOrd="0" destOrd="0"/>
      </dgm:cxnLst>
      <dgm:bg/>
      <dgm:whole/>
    </dgm:dataModel>
  </dgm:sampData>
  <dgm:styleData>
    <dgm:dataModel>
      <dgm:ptLst>
        <dgm:pt modelId="0" type="doc"/>
        <dgm:pt modelId="1"/>
        <dgm:pt modelId="11"/>
        <dgm:pt modelId="12"/>
      </dgm:ptLst>
      <dgm:cxnLst>
        <dgm:cxn modelId="2" srcId="0" destId="1" srcOrd="0" destOrd="0"/>
        <dgm:cxn modelId="13" srcId="1" destId="11" srcOrd="0" destOrd="0"/>
        <dgm:cxn modelId="14" srcId="1" destId="12" srcOrd="1" destOrd="0"/>
      </dgm:cxnLst>
      <dgm:bg/>
      <dgm:whole/>
    </dgm:dataModel>
  </dgm:styleData>
  <dgm:clrData>
    <dgm:dataModel>
      <dgm:ptLst>
        <dgm:pt modelId="0" type="doc"/>
        <dgm:pt modelId="1"/>
        <dgm:pt modelId="2"/>
        <dgm:pt modelId="21"/>
        <dgm:pt modelId="211"/>
        <dgm:pt modelId="3"/>
        <dgm:pt modelId="31"/>
        <dgm:pt modelId="311"/>
      </dgm:ptLst>
      <dgm:cxnLst>
        <dgm:cxn modelId="4" srcId="0" destId="1" srcOrd="0" destOrd="0"/>
        <dgm:cxn modelId="5" srcId="1" destId="2" srcOrd="0" destOrd="0"/>
        <dgm:cxn modelId="6" srcId="1" destId="3" srcOrd="1" destOrd="0"/>
        <dgm:cxn modelId="23" srcId="2" destId="21" srcOrd="0" destOrd="0"/>
        <dgm:cxn modelId="24" srcId="21" destId="211" srcOrd="0" destOrd="0"/>
        <dgm:cxn modelId="33" srcId="3" destId="31" srcOrd="0" destOrd="0"/>
        <dgm:cxn modelId="34" srcId="31" destId="311" srcOrd="0" destOrd="0"/>
      </dgm:cxnLst>
      <dgm:bg/>
      <dgm:whole/>
    </dgm:dataModel>
  </dgm:clrData>
  <dgm:layoutNode name="diagram">
    <dgm:varLst>
      <dgm:chPref val="1"/>
      <dgm:dir/>
      <dgm:animOne val="branch"/>
      <dgm:animLvl val="lvl"/>
      <dgm:resizeHandles val="exact"/>
    </dgm:varLst>
    <dgm:choose name="Name0">
      <dgm:if name="Name1" func="var" arg="dir" op="equ" val="norm">
        <dgm:alg type="hierChild">
          <dgm:param type="linDir" val="fromT"/>
          <dgm:param type="chAlign" val="l"/>
        </dgm:alg>
      </dgm:if>
      <dgm:else name="Name2">
        <dgm:alg type="hierChild">
          <dgm:param type="linDir" val="fromT"/>
          <dgm:param type="chAlign" val="r"/>
        </dgm:alg>
      </dgm:else>
    </dgm:choose>
    <dgm:shape xmlns:r="http://schemas.openxmlformats.org/officeDocument/2006/relationships" r:blip="">
      <dgm:adjLst/>
    </dgm:shape>
    <dgm:presOf/>
    <dgm:constrLst>
      <dgm:constr type="h" for="des" ptType="node" refType="h"/>
      <dgm:constr type="w" for="des" ptType="node" refType="h" refFor="des" refPtType="node" fact="2"/>
      <dgm:constr type="sibSp" refType="h" refFor="des" refPtType="node" op="equ" fact="0.15"/>
      <dgm:constr type="sibSp" for="des" forName="level2hierChild" refType="h" refFor="des" refPtType="node" op="equ" fact="0.15"/>
      <dgm:constr type="sibSp" for="des" forName="level3hierChild" refType="h" refFor="des" refPtType="node" op="equ" fact="0.15"/>
      <dgm:constr type="sp" for="des" forName="root1" refType="w" refFor="des" refPtType="node" fact="0.4"/>
      <dgm:constr type="sp" for="des" forName="root2" refType="sp" refFor="des" refForName="root1" op="equ"/>
      <dgm:constr type="primFontSz" for="des" ptType="node" op="equ" val="65"/>
      <dgm:constr type="primFontSz" for="des" forName="connTx" op="equ" val="55"/>
      <dgm:constr type="primFontSz" for="des" forName="connTx" refType="primFontSz" refFor="des" refPtType="node" op="lte" fact="0.8"/>
    </dgm:constrLst>
    <dgm:ruleLst/>
    <dgm:forEach name="Name3" axis="ch">
      <dgm:forEach name="Name4" axis="self" ptType="node">
        <dgm:layoutNode name="root1">
          <dgm:choose name="Name5">
            <dgm:if name="Name6" func="var" arg="dir" op="equ" val="norm">
              <dgm:alg type="hierRoot">
                <dgm:param type="hierAlign" val="lCtrCh"/>
              </dgm:alg>
            </dgm:if>
            <dgm:else name="Name7">
              <dgm:alg type="hierRoot">
                <dgm:param type="hierAlign" val="rCtrCh"/>
              </dgm:alg>
            </dgm:else>
          </dgm:choose>
          <dgm:shape xmlns:r="http://schemas.openxmlformats.org/officeDocument/2006/relationships" r:blip="">
            <dgm:adjLst/>
          </dgm:shape>
          <dgm:presOf/>
          <dgm:constrLst/>
          <dgm:ruleLst/>
          <dgm:layoutNode name="LevelOneTextNode" styleLbl="node0">
            <dgm:varLst>
              <dgm:chPref val="3"/>
            </dgm:varLst>
            <dgm:alg type="tx"/>
            <dgm:shape xmlns:r="http://schemas.openxmlformats.org/officeDocument/2006/relationships" type="roundRect" r:blip="">
              <dgm:adjLst>
                <dgm:adj idx="1" val="0.1"/>
              </dgm:adjLst>
            </dgm:shape>
            <dgm:presOf axis="self"/>
            <dgm:constrLst>
              <dgm:constr type="tMarg" refType="primFontSz" fact="0.05"/>
              <dgm:constr type="bMarg" refType="primFontSz" fact="0.05"/>
              <dgm:constr type="lMarg" refType="primFontSz" fact="0.05"/>
              <dgm:constr type="rMarg" refType="primFontSz" fact="0.05"/>
            </dgm:constrLst>
            <dgm:ruleLst>
              <dgm:rule type="primFontSz" val="5" fact="NaN" max="NaN"/>
            </dgm:ruleLst>
          </dgm:layoutNode>
          <dgm:layoutNode name="level2hierChild">
            <dgm:choose name="Name8">
              <dgm:if name="Name9" func="var" arg="dir" op="equ" val="norm">
                <dgm:alg type="hierChild">
                  <dgm:param type="linDir" val="fromT"/>
                  <dgm:param type="chAlign" val="l"/>
                </dgm:alg>
              </dgm:if>
              <dgm:else name="Name10">
                <dgm:alg type="hierChild">
                  <dgm:param type="linDir" val="fromT"/>
                  <dgm:param type="chAlign" val="r"/>
                </dgm:alg>
              </dgm:else>
            </dgm:choose>
            <dgm:shape xmlns:r="http://schemas.openxmlformats.org/officeDocument/2006/relationships" r:blip="">
              <dgm:adjLst/>
            </dgm:shape>
            <dgm:presOf/>
            <dgm:constrLst/>
            <dgm:ruleLst/>
            <dgm:forEach name="repeat" axis="ch">
              <dgm:forEach name="Name11" axis="self" ptType="parTrans" cnt="1">
                <dgm:layoutNode name="conn2-1">
                  <dgm:choose name="Name12">
                    <dgm:if name="Name13" func="var" arg="dir" op="equ" val="norm">
                      <dgm:alg type="conn">
                        <dgm:param type="dim" val="1D"/>
                        <dgm:param type="begPts" val="midR"/>
                        <dgm:param type="endPts" val="midL"/>
                        <dgm:param type="endSty" val="noArr"/>
                      </dgm:alg>
                    </dgm:if>
                    <dgm:else name="Name14">
                      <dgm:alg type="conn">
                        <dgm:param type="dim" val="1D"/>
                        <dgm:param type="begPts" val="midL"/>
                        <dgm:param type="endPts" val="midR"/>
                        <dgm:param type="endSty" val="noArr"/>
                      </dgm:alg>
                    </dgm:else>
                  </dgm:choose>
                  <dgm:shape xmlns:r="http://schemas.openxmlformats.org/officeDocument/2006/relationships" type="conn" r:blip="">
                    <dgm:adjLst/>
                  </dgm:shape>
                  <dgm:presOf axis="self"/>
                  <dgm:constrLst>
                    <dgm:constr type="w" val="1"/>
                    <dgm:constr type="h" val="5"/>
                    <dgm:constr type="connDist"/>
                    <dgm:constr type="begPad"/>
                    <dgm:constr type="endPad"/>
                    <dgm:constr type="userA" for="ch" refType="connDist"/>
                  </dgm:constrLst>
                  <dgm:ruleLst/>
                  <dgm:layoutNode name="connTx">
                    <dgm:alg type="tx">
                      <dgm:param type="autoTxRot" val="grav"/>
                    </dgm:alg>
                    <dgm:shape xmlns:r="http://schemas.openxmlformats.org/officeDocument/2006/relationships" type="rect" r:blip="" hideGeom="1">
                      <dgm:adjLst/>
                    </dgm:shape>
                    <dgm:presOf axis="self"/>
                    <dgm:constrLst>
                      <dgm:constr type="userA"/>
                      <dgm:constr type="w" refType="userA" fact="0.05"/>
                      <dgm:constr type="h" refType="userA" fact="0.05"/>
                      <dgm:constr type="lMarg" val="1"/>
                      <dgm:constr type="rMarg" val="1"/>
                      <dgm:constr type="tMarg"/>
                      <dgm:constr type="bMarg"/>
                    </dgm:constrLst>
                    <dgm:ruleLst>
                      <dgm:rule type="h" val="NaN" fact="0.25" max="NaN"/>
                      <dgm:rule type="w" val="NaN" fact="0.8" max="NaN"/>
                      <dgm:rule type="primFontSz" val="5" fact="NaN" max="NaN"/>
                    </dgm:ruleLst>
                  </dgm:layoutNode>
                </dgm:layoutNode>
              </dgm:forEach>
              <dgm:forEach name="Name15" axis="self" ptType="node">
                <dgm:layoutNode name="root2">
                  <dgm:choose name="Name16">
                    <dgm:if name="Name17" func="var" arg="dir" op="equ" val="norm">
                      <dgm:alg type="hierRoot">
                        <dgm:param type="hierAlign" val="lCtrCh"/>
                      </dgm:alg>
                    </dgm:if>
                    <dgm:else name="Name18">
                      <dgm:alg type="hierRoot">
                        <dgm:param type="hierAlign" val="rCtrCh"/>
                      </dgm:alg>
                    </dgm:else>
                  </dgm:choose>
                  <dgm:shape xmlns:r="http://schemas.openxmlformats.org/officeDocument/2006/relationships" r:blip="">
                    <dgm:adjLst/>
                  </dgm:shape>
                  <dgm:presOf/>
                  <dgm:constrLst/>
                  <dgm:ruleLst/>
                  <dgm:layoutNode name="LevelTwoTextNode">
                    <dgm:varLst>
                      <dgm:chPref val="3"/>
                    </dgm:varLst>
                    <dgm:alg type="tx"/>
                    <dgm:shape xmlns:r="http://schemas.openxmlformats.org/officeDocument/2006/relationships" type="roundRect" r:blip="">
                      <dgm:adjLst>
                        <dgm:adj idx="1" val="0.1"/>
                      </dgm:adjLst>
                    </dgm:shape>
                    <dgm:presOf axis="self"/>
                    <dgm:constrLst>
                      <dgm:constr type="tMarg" refType="primFontSz" fact="0.05"/>
                      <dgm:constr type="bMarg" refType="primFontSz" fact="0.05"/>
                      <dgm:constr type="lMarg" refType="primFontSz" fact="0.05"/>
                      <dgm:constr type="rMarg" refType="primFontSz" fact="0.05"/>
                    </dgm:constrLst>
                    <dgm:ruleLst>
                      <dgm:rule type="primFontSz" val="5" fact="NaN" max="NaN"/>
                    </dgm:ruleLst>
                  </dgm:layoutNode>
                  <dgm:layoutNode name="level3hierChild">
                    <dgm:choose name="Name19">
                      <dgm:if name="Name20" func="var" arg="dir" op="equ" val="norm">
                        <dgm:alg type="hierChild">
                          <dgm:param type="linDir" val="fromT"/>
                          <dgm:param type="chAlign" val="l"/>
                        </dgm:alg>
                      </dgm:if>
                      <dgm:else name="Name21">
                        <dgm:alg type="hierChild">
                          <dgm:param type="linDir" val="fromT"/>
                          <dgm:param type="chAlign" val="r"/>
                        </dgm:alg>
                      </dgm:else>
                    </dgm:choose>
                    <dgm:shape xmlns:r="http://schemas.openxmlformats.org/officeDocument/2006/relationships" r:blip="">
                      <dgm:adjLst/>
                    </dgm:shape>
                    <dgm:presOf/>
                    <dgm:constrLst/>
                    <dgm:ruleLst/>
                    <dgm:forEach name="Name22" ref="repeat"/>
                  </dgm:layoutNode>
                </dgm:layoutNode>
              </dgm:forEach>
            </dgm:forEach>
          </dgm:layoutNode>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E216377-8FC3-4132-A2EA-AA16A44545B6}" type="datetimeFigureOut">
              <a:t>4/24/20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606601F-3A51-494E-B4DA-8AE7D58CBF0E}" type="slidenum">
              <a:t>‹#›</a:t>
            </a:fld>
            <a:endParaRPr lang="en-US"/>
          </a:p>
        </p:txBody>
      </p:sp>
    </p:spTree>
    <p:extLst>
      <p:ext uri="{BB962C8B-B14F-4D97-AF65-F5344CB8AC3E}">
        <p14:creationId xmlns:p14="http://schemas.microsoft.com/office/powerpoint/2010/main" val="123784560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4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50.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BS can be categorized according to anatomical, pathophysiological (with/without colon in continuity) and post-operative evolution criteria (acute vs adaptation vs maintenance).</a:t>
            </a:r>
          </a:p>
          <a:p>
            <a:r>
              <a:rPr lang="en-US" dirty="0"/>
              <a:t>CIF reversibility is higher when there is more than 35 cm SB with a </a:t>
            </a:r>
            <a:r>
              <a:rPr lang="en-US" dirty="0" err="1"/>
              <a:t>jejuno</a:t>
            </a:r>
            <a:r>
              <a:rPr lang="en-US" dirty="0"/>
              <a:t>-ileal anastomosis, the ileo-cecal valve and an intact colon, more than 60 cm SB with a </a:t>
            </a:r>
            <a:r>
              <a:rPr lang="en-US" dirty="0" err="1"/>
              <a:t>jejuno</a:t>
            </a:r>
            <a:r>
              <a:rPr lang="en-US" dirty="0"/>
              <a:t>-colic anastomosis or more than 115 cm SB with an end-jejunostomy</a:t>
            </a:r>
            <a:endParaRPr lang="en-US"/>
          </a:p>
        </p:txBody>
      </p:sp>
      <p:sp>
        <p:nvSpPr>
          <p:cNvPr id="4" name="Slide Number Placeholder 3"/>
          <p:cNvSpPr>
            <a:spLocks noGrp="1"/>
          </p:cNvSpPr>
          <p:nvPr>
            <p:ph type="sldNum" sz="quarter" idx="5"/>
          </p:nvPr>
        </p:nvSpPr>
        <p:spPr/>
        <p:txBody>
          <a:bodyPr/>
          <a:lstStyle/>
          <a:p>
            <a:fld id="{5606601F-3A51-494E-B4DA-8AE7D58CBF0E}" type="slidenum">
              <a:rPr lang="en-US"/>
              <a:t>4</a:t>
            </a:fld>
            <a:endParaRPr lang="en-US"/>
          </a:p>
        </p:txBody>
      </p:sp>
    </p:spTree>
    <p:extLst>
      <p:ext uri="{BB962C8B-B14F-4D97-AF65-F5344CB8AC3E}">
        <p14:creationId xmlns:p14="http://schemas.microsoft.com/office/powerpoint/2010/main" val="2579191804"/>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ates of bacteremia may be as high as 70% in PN dependent children with CVC who present with fever </a:t>
            </a:r>
          </a:p>
          <a:p>
            <a:r>
              <a:rPr lang="en-US" dirty="0">
                <a:cs typeface="Calibri"/>
              </a:rPr>
              <a:t>Abx: </a:t>
            </a:r>
            <a:r>
              <a:rPr lang="en-US" dirty="0"/>
              <a:t>Antipseudomonal penicillin, 3rd/4th-generation cephalosporin, or carbapenem to provide broad Gram-negative coverage including Pseudomonas + Vancomycin (against MRSA and coagulase-negative species)</a:t>
            </a:r>
            <a:endParaRPr lang="en-US" dirty="0">
              <a:cs typeface="Calibri" panose="020F0502020204030204"/>
            </a:endParaRPr>
          </a:p>
          <a:p>
            <a:r>
              <a:rPr lang="en-US" dirty="0"/>
              <a:t>Tailor antimicrobial regimens to individual pathogen history especially as multidrug resistant bacteria become more prevalent. Can consult ID the next day after presentation. </a:t>
            </a:r>
            <a:endParaRPr lang="en-US" dirty="0">
              <a:ea typeface="Calibri"/>
              <a:cs typeface="Calibri"/>
            </a:endParaRPr>
          </a:p>
        </p:txBody>
      </p:sp>
      <p:sp>
        <p:nvSpPr>
          <p:cNvPr id="4" name="Slide Number Placeholder 3"/>
          <p:cNvSpPr>
            <a:spLocks noGrp="1"/>
          </p:cNvSpPr>
          <p:nvPr>
            <p:ph type="sldNum" sz="quarter" idx="5"/>
          </p:nvPr>
        </p:nvSpPr>
        <p:spPr/>
        <p:txBody>
          <a:bodyPr/>
          <a:lstStyle/>
          <a:p>
            <a:fld id="{5606601F-3A51-494E-B4DA-8AE7D58CBF0E}" type="slidenum">
              <a:rPr lang="en-US"/>
              <a:t>18</a:t>
            </a:fld>
            <a:endParaRPr lang="en-US"/>
          </a:p>
        </p:txBody>
      </p:sp>
    </p:spTree>
    <p:extLst>
      <p:ext uri="{BB962C8B-B14F-4D97-AF65-F5344CB8AC3E}">
        <p14:creationId xmlns:p14="http://schemas.microsoft.com/office/powerpoint/2010/main" val="786728683"/>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5606601F-3A51-494E-B4DA-8AE7D58CBF0E}" type="slidenum">
              <a:rPr lang="en-US"/>
              <a:t>19</a:t>
            </a:fld>
            <a:endParaRPr lang="en-US"/>
          </a:p>
        </p:txBody>
      </p:sp>
    </p:spTree>
    <p:extLst>
      <p:ext uri="{BB962C8B-B14F-4D97-AF65-F5344CB8AC3E}">
        <p14:creationId xmlns:p14="http://schemas.microsoft.com/office/powerpoint/2010/main" val="2760267106"/>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25% ethanol as effective as 75%. 25% didn't increase line damage. Ethanol locks do not significantly increase thrombosis risk (based on meta analysis) (Zhang 2018)</a:t>
            </a:r>
            <a:endParaRPr lang="en-US" dirty="0"/>
          </a:p>
          <a:p>
            <a:r>
              <a:rPr lang="en-US" dirty="0">
                <a:ea typeface="Calibri"/>
                <a:cs typeface="Calibri"/>
              </a:rPr>
              <a:t>Ethanol locks can be used for </a:t>
            </a:r>
            <a:r>
              <a:rPr lang="en-US" dirty="0" err="1">
                <a:ea typeface="Calibri"/>
                <a:cs typeface="Calibri"/>
              </a:rPr>
              <a:t>px</a:t>
            </a:r>
            <a:r>
              <a:rPr lang="en-US" dirty="0">
                <a:ea typeface="Calibri"/>
                <a:cs typeface="Calibri"/>
              </a:rPr>
              <a:t> or </a:t>
            </a:r>
            <a:r>
              <a:rPr lang="en-US" dirty="0" err="1">
                <a:ea typeface="Calibri"/>
                <a:cs typeface="Calibri"/>
              </a:rPr>
              <a:t>tt</a:t>
            </a:r>
            <a:r>
              <a:rPr lang="en-US" dirty="0">
                <a:ea typeface="Calibri"/>
                <a:cs typeface="Calibri"/>
              </a:rPr>
              <a:t> (Wendel, 2021) </a:t>
            </a:r>
            <a:endParaRPr lang="en-US" dirty="0"/>
          </a:p>
          <a:p>
            <a:r>
              <a:rPr lang="en-US" dirty="0"/>
              <a:t>Sodium EDTA lock actually lowers thrombosis risk compared to Taurolidine</a:t>
            </a:r>
            <a:endParaRPr lang="en-US" dirty="0">
              <a:ea typeface="Calibri"/>
              <a:cs typeface="Calibri"/>
            </a:endParaRPr>
          </a:p>
          <a:p>
            <a:endParaRPr lang="en-US" dirty="0">
              <a:ea typeface="Calibri"/>
              <a:cs typeface="Calibri"/>
            </a:endParaRPr>
          </a:p>
          <a:p>
            <a:endParaRPr lang="en-US" dirty="0">
              <a:ea typeface="Calibri"/>
              <a:cs typeface="Calibri"/>
            </a:endParaRPr>
          </a:p>
          <a:p>
            <a:endParaRPr lang="en-US" dirty="0">
              <a:ea typeface="Calibri"/>
              <a:cs typeface="Calibri"/>
            </a:endParaRPr>
          </a:p>
        </p:txBody>
      </p:sp>
      <p:sp>
        <p:nvSpPr>
          <p:cNvPr id="4" name="Slide Number Placeholder 3"/>
          <p:cNvSpPr>
            <a:spLocks noGrp="1"/>
          </p:cNvSpPr>
          <p:nvPr>
            <p:ph type="sldNum" sz="quarter" idx="5"/>
          </p:nvPr>
        </p:nvSpPr>
        <p:spPr/>
        <p:txBody>
          <a:bodyPr/>
          <a:lstStyle/>
          <a:p>
            <a:fld id="{5606601F-3A51-494E-B4DA-8AE7D58CBF0E}" type="slidenum">
              <a:rPr lang="en-US"/>
              <a:t>20</a:t>
            </a:fld>
            <a:endParaRPr lang="en-US"/>
          </a:p>
        </p:txBody>
      </p:sp>
    </p:spTree>
    <p:extLst>
      <p:ext uri="{BB962C8B-B14F-4D97-AF65-F5344CB8AC3E}">
        <p14:creationId xmlns:p14="http://schemas.microsoft.com/office/powerpoint/2010/main" val="3702182669"/>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Usually check line placement with CXR monthly for PICC and every 6-12m for tunneled CVCs. </a:t>
            </a:r>
          </a:p>
          <a:p>
            <a:endParaRPr lang="en-US" dirty="0">
              <a:ea typeface="Calibri"/>
              <a:cs typeface="Calibri"/>
            </a:endParaRPr>
          </a:p>
        </p:txBody>
      </p:sp>
      <p:sp>
        <p:nvSpPr>
          <p:cNvPr id="4" name="Slide Number Placeholder 3"/>
          <p:cNvSpPr>
            <a:spLocks noGrp="1"/>
          </p:cNvSpPr>
          <p:nvPr>
            <p:ph type="sldNum" sz="quarter" idx="5"/>
          </p:nvPr>
        </p:nvSpPr>
        <p:spPr/>
        <p:txBody>
          <a:bodyPr/>
          <a:lstStyle/>
          <a:p>
            <a:fld id="{5606601F-3A51-494E-B4DA-8AE7D58CBF0E}" type="slidenum">
              <a:rPr lang="en-US"/>
              <a:t>22</a:t>
            </a:fld>
            <a:endParaRPr lang="en-US"/>
          </a:p>
        </p:txBody>
      </p:sp>
    </p:spTree>
    <p:extLst>
      <p:ext uri="{BB962C8B-B14F-4D97-AF65-F5344CB8AC3E}">
        <p14:creationId xmlns:p14="http://schemas.microsoft.com/office/powerpoint/2010/main" val="370676566"/>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Can accept up to brachiocephalic vein (to still be central). </a:t>
            </a:r>
          </a:p>
        </p:txBody>
      </p:sp>
      <p:sp>
        <p:nvSpPr>
          <p:cNvPr id="4" name="Slide Number Placeholder 3"/>
          <p:cNvSpPr>
            <a:spLocks noGrp="1"/>
          </p:cNvSpPr>
          <p:nvPr>
            <p:ph type="sldNum" sz="quarter" idx="5"/>
          </p:nvPr>
        </p:nvSpPr>
        <p:spPr/>
        <p:txBody>
          <a:bodyPr/>
          <a:lstStyle/>
          <a:p>
            <a:fld id="{5606601F-3A51-494E-B4DA-8AE7D58CBF0E}" type="slidenum">
              <a:rPr lang="en-US"/>
              <a:t>23</a:t>
            </a:fld>
            <a:endParaRPr lang="en-US"/>
          </a:p>
        </p:txBody>
      </p:sp>
    </p:spTree>
    <p:extLst>
      <p:ext uri="{BB962C8B-B14F-4D97-AF65-F5344CB8AC3E}">
        <p14:creationId xmlns:p14="http://schemas.microsoft.com/office/powerpoint/2010/main" val="2541241244"/>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cuff is the internal securement device and is considered “stable” after 14 days post insertion</a:t>
            </a:r>
          </a:p>
          <a:p>
            <a:endParaRPr lang="en-US" dirty="0">
              <a:cs typeface="Calibri"/>
            </a:endParaRPr>
          </a:p>
        </p:txBody>
      </p:sp>
      <p:sp>
        <p:nvSpPr>
          <p:cNvPr id="4" name="Slide Number Placeholder 3"/>
          <p:cNvSpPr>
            <a:spLocks noGrp="1"/>
          </p:cNvSpPr>
          <p:nvPr>
            <p:ph type="sldNum" sz="quarter" idx="5"/>
          </p:nvPr>
        </p:nvSpPr>
        <p:spPr/>
        <p:txBody>
          <a:bodyPr/>
          <a:lstStyle/>
          <a:p>
            <a:fld id="{5606601F-3A51-494E-B4DA-8AE7D58CBF0E}" type="slidenum">
              <a:rPr lang="en-US"/>
              <a:t>24</a:t>
            </a:fld>
            <a:endParaRPr lang="en-US"/>
          </a:p>
        </p:txBody>
      </p:sp>
    </p:spTree>
    <p:extLst>
      <p:ext uri="{BB962C8B-B14F-4D97-AF65-F5344CB8AC3E}">
        <p14:creationId xmlns:p14="http://schemas.microsoft.com/office/powerpoint/2010/main" val="1988543283"/>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artial (inability to aspirate blood but the ability to flush or infuse through the catheter) or complete (inability to aspirate, flush or infuse via the catheter) occlusion</a:t>
            </a:r>
          </a:p>
          <a:p>
            <a:r>
              <a:rPr lang="en-US" dirty="0"/>
              <a:t>Fibrin sheath: formed from endothelial damage, made of fibrous film with endothelial and inflammatory cs, with superimposed thrombus.</a:t>
            </a:r>
            <a:endParaRPr lang="en-US" dirty="0">
              <a:ea typeface="Calibri"/>
              <a:cs typeface="Calibri"/>
            </a:endParaRPr>
          </a:p>
          <a:p>
            <a:endParaRPr lang="en-US" dirty="0">
              <a:ea typeface="Calibri"/>
              <a:cs typeface="Calibri"/>
            </a:endParaRPr>
          </a:p>
          <a:p>
            <a:endParaRPr lang="en-US" dirty="0">
              <a:cs typeface="Calibri"/>
            </a:endParaRPr>
          </a:p>
          <a:p>
            <a:endParaRPr lang="en-US" dirty="0">
              <a:cs typeface="Calibri"/>
            </a:endParaRPr>
          </a:p>
          <a:p>
            <a:endParaRPr lang="en-US" dirty="0">
              <a:cs typeface="Calibri"/>
            </a:endParaRPr>
          </a:p>
          <a:p>
            <a:endParaRPr lang="en-US" dirty="0">
              <a:cs typeface="Calibri"/>
            </a:endParaRPr>
          </a:p>
        </p:txBody>
      </p:sp>
      <p:sp>
        <p:nvSpPr>
          <p:cNvPr id="4" name="Slide Number Placeholder 3"/>
          <p:cNvSpPr>
            <a:spLocks noGrp="1"/>
          </p:cNvSpPr>
          <p:nvPr>
            <p:ph type="sldNum" sz="quarter" idx="5"/>
          </p:nvPr>
        </p:nvSpPr>
        <p:spPr/>
        <p:txBody>
          <a:bodyPr/>
          <a:lstStyle/>
          <a:p>
            <a:fld id="{5606601F-3A51-494E-B4DA-8AE7D58CBF0E}" type="slidenum">
              <a:rPr lang="en-US"/>
              <a:t>28</a:t>
            </a:fld>
            <a:endParaRPr lang="en-US"/>
          </a:p>
        </p:txBody>
      </p:sp>
    </p:spTree>
    <p:extLst>
      <p:ext uri="{BB962C8B-B14F-4D97-AF65-F5344CB8AC3E}">
        <p14:creationId xmlns:p14="http://schemas.microsoft.com/office/powerpoint/2010/main" val="1744397508"/>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tiologies: mechanical (</a:t>
            </a:r>
            <a:r>
              <a:rPr lang="en-US" dirty="0" err="1"/>
              <a:t>eg</a:t>
            </a:r>
            <a:r>
              <a:rPr lang="en-US" dirty="0"/>
              <a:t>: blood vessel wall occluding tip, or pinch-off syndrome), precipitate could be from incompatible mixtures or inappropriate medication concentration (</a:t>
            </a:r>
            <a:r>
              <a:rPr lang="en-US" dirty="0" err="1"/>
              <a:t>eg</a:t>
            </a:r>
            <a:r>
              <a:rPr lang="en-US" dirty="0"/>
              <a:t>: lipid and iron, insulin with TPN, heparin/ethanol lock, CaPHO4 crystals)</a:t>
            </a:r>
          </a:p>
          <a:p>
            <a:r>
              <a:rPr lang="en-US" dirty="0">
                <a:ea typeface="Calibri"/>
                <a:cs typeface="Calibri"/>
              </a:rPr>
              <a:t>Fibrin sheath: formed from endothelial damage, made of fibrous film with endothelial and inflammatory cs, with superimposed thrombus.</a:t>
            </a:r>
            <a:endParaRPr lang="en-US" dirty="0"/>
          </a:p>
        </p:txBody>
      </p:sp>
      <p:sp>
        <p:nvSpPr>
          <p:cNvPr id="4" name="Slide Number Placeholder 3"/>
          <p:cNvSpPr>
            <a:spLocks noGrp="1"/>
          </p:cNvSpPr>
          <p:nvPr>
            <p:ph type="sldNum" sz="quarter" idx="5"/>
          </p:nvPr>
        </p:nvSpPr>
        <p:spPr/>
        <p:txBody>
          <a:bodyPr/>
          <a:lstStyle/>
          <a:p>
            <a:fld id="{5606601F-3A51-494E-B4DA-8AE7D58CBF0E}" type="slidenum">
              <a:rPr lang="en-US"/>
              <a:t>29</a:t>
            </a:fld>
            <a:endParaRPr lang="en-US"/>
          </a:p>
        </p:txBody>
      </p:sp>
    </p:spTree>
    <p:extLst>
      <p:ext uri="{BB962C8B-B14F-4D97-AF65-F5344CB8AC3E}">
        <p14:creationId xmlns:p14="http://schemas.microsoft.com/office/powerpoint/2010/main" val="674192122"/>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Fibrin sheath: formed from endothelial damage, made of fibrous film with endothelial and inflammatory cs, with superimposed thrombus.</a:t>
            </a:r>
          </a:p>
          <a:p>
            <a:r>
              <a:rPr lang="en-US">
                <a:ea typeface="Calibri"/>
                <a:cs typeface="Calibri"/>
              </a:rPr>
              <a:t>Fibrin sheath </a:t>
            </a:r>
            <a:r>
              <a:rPr lang="en-US" dirty="0"/>
              <a:t>can occur within 24 h to 2 weeks of line placement</a:t>
            </a:r>
            <a:endParaRPr lang="en-US" dirty="0">
              <a:ea typeface="Calibri"/>
              <a:cs typeface="Calibri"/>
            </a:endParaRPr>
          </a:p>
          <a:p>
            <a:r>
              <a:rPr lang="en-US" dirty="0"/>
              <a:t>Intraluminal clot within the CVC (5-25% of all occlusions)</a:t>
            </a:r>
          </a:p>
          <a:p>
            <a:r>
              <a:rPr lang="en-US" dirty="0">
                <a:ea typeface="Calibri"/>
                <a:cs typeface="Calibri"/>
              </a:rPr>
              <a:t>CRT happens up to 50% with long term CVC, but half of them are </a:t>
            </a:r>
            <a:r>
              <a:rPr lang="en-US" dirty="0" err="1">
                <a:ea typeface="Calibri"/>
                <a:cs typeface="Calibri"/>
              </a:rPr>
              <a:t>asx</a:t>
            </a:r>
            <a:r>
              <a:rPr lang="en-US" dirty="0">
                <a:ea typeface="Calibri"/>
                <a:cs typeface="Calibri"/>
              </a:rPr>
              <a:t>. </a:t>
            </a:r>
          </a:p>
          <a:p>
            <a:r>
              <a:rPr lang="en-US"/>
              <a:t>Hypercoagulable states such as CLABSI, high PN dextrose or calcium concentration, and inherited thrombophilic conditions. </a:t>
            </a:r>
          </a:p>
          <a:p>
            <a:endParaRPr lang="en-US" dirty="0">
              <a:ea typeface="Calibri"/>
              <a:cs typeface="Calibri"/>
            </a:endParaRPr>
          </a:p>
        </p:txBody>
      </p:sp>
      <p:sp>
        <p:nvSpPr>
          <p:cNvPr id="4" name="Slide Number Placeholder 3"/>
          <p:cNvSpPr>
            <a:spLocks noGrp="1"/>
          </p:cNvSpPr>
          <p:nvPr>
            <p:ph type="sldNum" sz="quarter" idx="5"/>
          </p:nvPr>
        </p:nvSpPr>
        <p:spPr/>
        <p:txBody>
          <a:bodyPr/>
          <a:lstStyle/>
          <a:p>
            <a:fld id="{5606601F-3A51-494E-B4DA-8AE7D58CBF0E}" type="slidenum">
              <a:rPr lang="en-US"/>
              <a:t>30</a:t>
            </a:fld>
            <a:endParaRPr lang="en-US"/>
          </a:p>
        </p:txBody>
      </p:sp>
    </p:spTree>
    <p:extLst>
      <p:ext uri="{BB962C8B-B14F-4D97-AF65-F5344CB8AC3E}">
        <p14:creationId xmlns:p14="http://schemas.microsoft.com/office/powerpoint/2010/main" val="501879510"/>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f suspect positional: raise or lower the ipsilateral arm, moving the patient to a standing or sitting position, or roll onto their side</a:t>
            </a:r>
          </a:p>
          <a:p>
            <a:r>
              <a:rPr lang="en-US" dirty="0">
                <a:ea typeface="Calibri"/>
                <a:cs typeface="Calibri"/>
              </a:rPr>
              <a:t>TPA </a:t>
            </a:r>
            <a:r>
              <a:rPr lang="en-US" dirty="0"/>
              <a:t>safe, rapidly metabolized by the liver (plasma half-life &lt; 5 min), making systemic complications such as bleeding unlikely</a:t>
            </a:r>
            <a:endParaRPr lang="en-US" dirty="0">
              <a:ea typeface="Calibri"/>
              <a:cs typeface="Calibri"/>
            </a:endParaRPr>
          </a:p>
          <a:p>
            <a:r>
              <a:rPr lang="en-US" dirty="0"/>
              <a:t>Non-fibrinolytic agents were used in the past to increase precipitate solubility by changing the pH in the catheter lumen (</a:t>
            </a:r>
            <a:r>
              <a:rPr lang="en-US" dirty="0" err="1"/>
              <a:t>eg</a:t>
            </a:r>
            <a:r>
              <a:rPr lang="en-US" dirty="0"/>
              <a:t>: 70% ethanol for lipid residues, Na bicarbonate). Due to concern for CVC damage, no longer used.</a:t>
            </a:r>
            <a:endParaRPr lang="en-US"/>
          </a:p>
          <a:p>
            <a:endParaRPr lang="en-US" dirty="0">
              <a:ea typeface="Calibri"/>
              <a:cs typeface="Calibri"/>
            </a:endParaRPr>
          </a:p>
          <a:p>
            <a:r>
              <a:rPr lang="en-US" dirty="0"/>
              <a:t>Venous US not sensitive for dx of occlusions, but can be used as screening tool for vascular access as long as not on anticoagulants (cheap, safe), used more to follow up established lesions.</a:t>
            </a:r>
            <a:endParaRPr lang="en-US" dirty="0">
              <a:ea typeface="Calibri"/>
              <a:cs typeface="Calibri"/>
            </a:endParaRPr>
          </a:p>
          <a:p>
            <a:r>
              <a:rPr lang="en-US" dirty="0">
                <a:ea typeface="Calibri"/>
                <a:cs typeface="Calibri"/>
              </a:rPr>
              <a:t>Fluoroscopy: </a:t>
            </a:r>
            <a:r>
              <a:rPr lang="en-US" dirty="0"/>
              <a:t>provides direct evidence of catheter location, patency, presence of fibrin sheath, or internal fracture of the line. </a:t>
            </a:r>
            <a:endParaRPr lang="en-US" dirty="0">
              <a:ea typeface="Calibri"/>
              <a:cs typeface="Calibri"/>
            </a:endParaRPr>
          </a:p>
          <a:p>
            <a:r>
              <a:rPr lang="en-US" dirty="0"/>
              <a:t>Venography (gold standard to assess venous patency) uses fluoroscopy to image the veins by injecting a contrast dye, detect blood clots.</a:t>
            </a:r>
            <a:endParaRPr lang="en-US" dirty="0">
              <a:ea typeface="Calibri"/>
              <a:cs typeface="Calibri"/>
            </a:endParaRPr>
          </a:p>
          <a:p>
            <a:r>
              <a:rPr lang="en-US" dirty="0">
                <a:ea typeface="Calibri"/>
                <a:cs typeface="Calibri"/>
              </a:rPr>
              <a:t>Once completed </a:t>
            </a:r>
            <a:r>
              <a:rPr lang="en-US" dirty="0" err="1">
                <a:ea typeface="Calibri"/>
                <a:cs typeface="Calibri"/>
              </a:rPr>
              <a:t>tt</a:t>
            </a:r>
            <a:r>
              <a:rPr lang="en-US" dirty="0">
                <a:ea typeface="Calibri"/>
                <a:cs typeface="Calibri"/>
              </a:rPr>
              <a:t> course for thrombosis, will keep them on prophylactic </a:t>
            </a:r>
            <a:r>
              <a:rPr lang="en-US" dirty="0" err="1">
                <a:ea typeface="Calibri"/>
                <a:cs typeface="Calibri"/>
              </a:rPr>
              <a:t>Lovenox</a:t>
            </a:r>
            <a:r>
              <a:rPr lang="en-US" dirty="0">
                <a:ea typeface="Calibri"/>
                <a:cs typeface="Calibri"/>
              </a:rPr>
              <a:t> while line is in to prevent further thrombosis risk. Can consider </a:t>
            </a:r>
            <a:r>
              <a:rPr lang="en-US">
                <a:ea typeface="Calibri"/>
                <a:cs typeface="Calibri"/>
              </a:rPr>
              <a:t>transitioning</a:t>
            </a:r>
            <a:r>
              <a:rPr lang="en-US" dirty="0">
                <a:ea typeface="Calibri"/>
                <a:cs typeface="Calibri"/>
              </a:rPr>
              <a:t> to Xarelto (PO) but make sure can good enteral absorption. </a:t>
            </a:r>
          </a:p>
          <a:p>
            <a:endParaRPr lang="en-US" dirty="0">
              <a:ea typeface="Calibri"/>
              <a:cs typeface="Calibri"/>
            </a:endParaRPr>
          </a:p>
        </p:txBody>
      </p:sp>
      <p:sp>
        <p:nvSpPr>
          <p:cNvPr id="4" name="Slide Number Placeholder 3"/>
          <p:cNvSpPr>
            <a:spLocks noGrp="1"/>
          </p:cNvSpPr>
          <p:nvPr>
            <p:ph type="sldNum" sz="quarter" idx="5"/>
          </p:nvPr>
        </p:nvSpPr>
        <p:spPr/>
        <p:txBody>
          <a:bodyPr/>
          <a:lstStyle/>
          <a:p>
            <a:fld id="{5606601F-3A51-494E-B4DA-8AE7D58CBF0E}" type="slidenum">
              <a:rPr lang="en-US"/>
              <a:t>32</a:t>
            </a:fld>
            <a:endParaRPr lang="en-US"/>
          </a:p>
        </p:txBody>
      </p:sp>
    </p:spTree>
    <p:extLst>
      <p:ext uri="{BB962C8B-B14F-4D97-AF65-F5344CB8AC3E}">
        <p14:creationId xmlns:p14="http://schemas.microsoft.com/office/powerpoint/2010/main" val="385056800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oss of ileum leads to loss of inhibitory segments in the small intestine, leading to increased gastric acidity that inactivates pancreatic enzymes and bile salts (conjugated bile acids, occur in the liver) which digest fat (so can't absorb fat or ADEK vit), and causes rapid transit through the stomach and duodenum</a:t>
            </a:r>
          </a:p>
          <a:p>
            <a:r>
              <a:rPr lang="en-US" dirty="0"/>
              <a:t>In TI and proximal colon, many GI hormones and neuromodulators, which play a key role in the control of gastrointestinal secretions, motility and intestinal growth are produced (like GLP-2 receptors).</a:t>
            </a:r>
            <a:endParaRPr lang="en-US" dirty="0">
              <a:ea typeface="Calibri"/>
              <a:cs typeface="Calibri"/>
            </a:endParaRPr>
          </a:p>
          <a:p>
            <a:r>
              <a:rPr lang="en-US" dirty="0">
                <a:ea typeface="Calibri"/>
                <a:cs typeface="Calibri"/>
              </a:rPr>
              <a:t>Colonic bacteria ferment soluble fibers into SCFA (good source of energy) + important for intestinal barrier function and immune response. Some bacteria (like Lactobacillus and Streptococcus) break fermentable single sugars and cause D-lactic acidosis (acidosis, D-lactate elevate (lactate in blood is L-lactate so can be normal), AMS) TT: restrict CHO, hydration and Bicarb and sometimes Abx against D-lactate bacteria (</a:t>
            </a:r>
            <a:r>
              <a:rPr lang="en-US" dirty="0"/>
              <a:t>Flagyl, Clindamycin, Tetracycline, Vancomycin, Neomycin)</a:t>
            </a:r>
            <a:endParaRPr lang="en-US" dirty="0">
              <a:ea typeface="Calibri"/>
              <a:cs typeface="Calibri"/>
            </a:endParaRPr>
          </a:p>
        </p:txBody>
      </p:sp>
      <p:sp>
        <p:nvSpPr>
          <p:cNvPr id="4" name="Slide Number Placeholder 3"/>
          <p:cNvSpPr>
            <a:spLocks noGrp="1"/>
          </p:cNvSpPr>
          <p:nvPr>
            <p:ph type="sldNum" sz="quarter" idx="5"/>
          </p:nvPr>
        </p:nvSpPr>
        <p:spPr/>
        <p:txBody>
          <a:bodyPr/>
          <a:lstStyle/>
          <a:p>
            <a:fld id="{5606601F-3A51-494E-B4DA-8AE7D58CBF0E}" type="slidenum">
              <a:rPr lang="en-US"/>
              <a:t>5</a:t>
            </a:fld>
            <a:endParaRPr lang="en-US"/>
          </a:p>
        </p:txBody>
      </p:sp>
    </p:spTree>
    <p:extLst>
      <p:ext uri="{BB962C8B-B14F-4D97-AF65-F5344CB8AC3E}">
        <p14:creationId xmlns:p14="http://schemas.microsoft.com/office/powerpoint/2010/main" val="838050855"/>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lush before and after PN administration, IV medication administration, laboratory draws, and blood transfusions. </a:t>
            </a:r>
          </a:p>
          <a:p>
            <a:r>
              <a:rPr lang="en-US" dirty="0">
                <a:cs typeface="Calibri"/>
              </a:rPr>
              <a:t>Avoid using Ethanol with Heparin locks (not compatible, so separate with NS flush)</a:t>
            </a:r>
            <a:endParaRPr lang="en-US" dirty="0"/>
          </a:p>
          <a:p>
            <a:r>
              <a:rPr lang="en-US" dirty="0"/>
              <a:t>For dormant catheter: To maintain patency, should be flushed with NS and locked at least daily, and ports should be accessed and flushed monthly.</a:t>
            </a:r>
            <a:endParaRPr lang="en-US" dirty="0">
              <a:ea typeface="Calibri"/>
              <a:cs typeface="Calibri"/>
            </a:endParaRPr>
          </a:p>
        </p:txBody>
      </p:sp>
      <p:sp>
        <p:nvSpPr>
          <p:cNvPr id="4" name="Slide Number Placeholder 3"/>
          <p:cNvSpPr>
            <a:spLocks noGrp="1"/>
          </p:cNvSpPr>
          <p:nvPr>
            <p:ph type="sldNum" sz="quarter" idx="5"/>
          </p:nvPr>
        </p:nvSpPr>
        <p:spPr/>
        <p:txBody>
          <a:bodyPr/>
          <a:lstStyle/>
          <a:p>
            <a:fld id="{5606601F-3A51-494E-B4DA-8AE7D58CBF0E}" type="slidenum">
              <a:rPr lang="en-US"/>
              <a:t>33</a:t>
            </a:fld>
            <a:endParaRPr lang="en-US"/>
          </a:p>
        </p:txBody>
      </p:sp>
    </p:spTree>
    <p:extLst>
      <p:ext uri="{BB962C8B-B14F-4D97-AF65-F5344CB8AC3E}">
        <p14:creationId xmlns:p14="http://schemas.microsoft.com/office/powerpoint/2010/main" val="1990234090"/>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eed free central access and negative blood cx before inset new central line. </a:t>
            </a:r>
          </a:p>
          <a:p>
            <a:r>
              <a:rPr lang="en-US" dirty="0">
                <a:ea typeface="Calibri"/>
                <a:cs typeface="Calibri"/>
              </a:rPr>
              <a:t>Chronic thrombus is not a reason to remove central line </a:t>
            </a:r>
          </a:p>
          <a:p>
            <a:endParaRPr lang="en-US" dirty="0">
              <a:ea typeface="Calibri"/>
              <a:cs typeface="Calibri"/>
            </a:endParaRPr>
          </a:p>
        </p:txBody>
      </p:sp>
      <p:sp>
        <p:nvSpPr>
          <p:cNvPr id="4" name="Slide Number Placeholder 3"/>
          <p:cNvSpPr>
            <a:spLocks noGrp="1"/>
          </p:cNvSpPr>
          <p:nvPr>
            <p:ph type="sldNum" sz="quarter" idx="5"/>
          </p:nvPr>
        </p:nvSpPr>
        <p:spPr/>
        <p:txBody>
          <a:bodyPr/>
          <a:lstStyle/>
          <a:p>
            <a:fld id="{5606601F-3A51-494E-B4DA-8AE7D58CBF0E}" type="slidenum">
              <a:rPr lang="en-US"/>
              <a:t>34</a:t>
            </a:fld>
            <a:endParaRPr lang="en-US"/>
          </a:p>
        </p:txBody>
      </p:sp>
    </p:spTree>
    <p:extLst>
      <p:ext uri="{BB962C8B-B14F-4D97-AF65-F5344CB8AC3E}">
        <p14:creationId xmlns:p14="http://schemas.microsoft.com/office/powerpoint/2010/main" val="1165175399"/>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place GT for the first time 2 months after it was placed </a:t>
            </a:r>
          </a:p>
        </p:txBody>
      </p:sp>
      <p:sp>
        <p:nvSpPr>
          <p:cNvPr id="4" name="Slide Number Placeholder 3"/>
          <p:cNvSpPr>
            <a:spLocks noGrp="1"/>
          </p:cNvSpPr>
          <p:nvPr>
            <p:ph type="sldNum" sz="quarter" idx="5"/>
          </p:nvPr>
        </p:nvSpPr>
        <p:spPr/>
        <p:txBody>
          <a:bodyPr/>
          <a:lstStyle/>
          <a:p>
            <a:fld id="{5606601F-3A51-494E-B4DA-8AE7D58CBF0E}" type="slidenum">
              <a:rPr lang="en-US"/>
              <a:t>36</a:t>
            </a:fld>
            <a:endParaRPr lang="en-US"/>
          </a:p>
        </p:txBody>
      </p:sp>
    </p:spTree>
    <p:extLst>
      <p:ext uri="{BB962C8B-B14F-4D97-AF65-F5344CB8AC3E}">
        <p14:creationId xmlns:p14="http://schemas.microsoft.com/office/powerpoint/2010/main" val="2261264165"/>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Normal skin care : daily to BID </a:t>
            </a:r>
          </a:p>
        </p:txBody>
      </p:sp>
      <p:sp>
        <p:nvSpPr>
          <p:cNvPr id="4" name="Slide Number Placeholder 3"/>
          <p:cNvSpPr>
            <a:spLocks noGrp="1"/>
          </p:cNvSpPr>
          <p:nvPr>
            <p:ph type="sldNum" sz="quarter" idx="5"/>
          </p:nvPr>
        </p:nvSpPr>
        <p:spPr/>
        <p:txBody>
          <a:bodyPr/>
          <a:lstStyle/>
          <a:p>
            <a:fld id="{5606601F-3A51-494E-B4DA-8AE7D58CBF0E}" type="slidenum">
              <a:rPr lang="en-US"/>
              <a:t>38</a:t>
            </a:fld>
            <a:endParaRPr lang="en-US"/>
          </a:p>
        </p:txBody>
      </p:sp>
    </p:spTree>
    <p:extLst>
      <p:ext uri="{BB962C8B-B14F-4D97-AF65-F5344CB8AC3E}">
        <p14:creationId xmlns:p14="http://schemas.microsoft.com/office/powerpoint/2010/main" val="4280672482"/>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Clean site regularly </a:t>
            </a:r>
          </a:p>
          <a:p>
            <a:r>
              <a:rPr lang="en-US" dirty="0"/>
              <a:t>Barrier cream absorbs moisture and creates a dry coating</a:t>
            </a:r>
            <a:endParaRPr lang="en-US" dirty="0">
              <a:cs typeface="Calibri"/>
            </a:endParaRPr>
          </a:p>
        </p:txBody>
      </p:sp>
      <p:sp>
        <p:nvSpPr>
          <p:cNvPr id="4" name="Slide Number Placeholder 3"/>
          <p:cNvSpPr>
            <a:spLocks noGrp="1"/>
          </p:cNvSpPr>
          <p:nvPr>
            <p:ph type="sldNum" sz="quarter" idx="5"/>
          </p:nvPr>
        </p:nvSpPr>
        <p:spPr/>
        <p:txBody>
          <a:bodyPr/>
          <a:lstStyle/>
          <a:p>
            <a:fld id="{5606601F-3A51-494E-B4DA-8AE7D58CBF0E}" type="slidenum">
              <a:rPr lang="en-US"/>
              <a:t>39</a:t>
            </a:fld>
            <a:endParaRPr lang="en-US"/>
          </a:p>
        </p:txBody>
      </p:sp>
    </p:spTree>
    <p:extLst>
      <p:ext uri="{BB962C8B-B14F-4D97-AF65-F5344CB8AC3E}">
        <p14:creationId xmlns:p14="http://schemas.microsoft.com/office/powerpoint/2010/main" val="1480791488"/>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3M main agent is </a:t>
            </a:r>
            <a:r>
              <a:rPr lang="en-US" dirty="0"/>
              <a:t>Dimethicone: protects the skin against damage, moisturizes and soothes the skin.</a:t>
            </a:r>
          </a:p>
          <a:p>
            <a:r>
              <a:rPr lang="en-US" dirty="0"/>
              <a:t>Nystatin antifungal (powder for wet lesions, cream for dry ones)</a:t>
            </a:r>
          </a:p>
        </p:txBody>
      </p:sp>
      <p:sp>
        <p:nvSpPr>
          <p:cNvPr id="4" name="Slide Number Placeholder 3"/>
          <p:cNvSpPr>
            <a:spLocks noGrp="1"/>
          </p:cNvSpPr>
          <p:nvPr>
            <p:ph type="sldNum" sz="quarter" idx="5"/>
          </p:nvPr>
        </p:nvSpPr>
        <p:spPr/>
        <p:txBody>
          <a:bodyPr/>
          <a:lstStyle/>
          <a:p>
            <a:fld id="{5606601F-3A51-494E-B4DA-8AE7D58CBF0E}" type="slidenum">
              <a:rPr lang="en-US"/>
              <a:t>42</a:t>
            </a:fld>
            <a:endParaRPr lang="en-US"/>
          </a:p>
        </p:txBody>
      </p:sp>
    </p:spTree>
    <p:extLst>
      <p:ext uri="{BB962C8B-B14F-4D97-AF65-F5344CB8AC3E}">
        <p14:creationId xmlns:p14="http://schemas.microsoft.com/office/powerpoint/2010/main" val="1052935170"/>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Granulation tissue caused by excess moisture, so keep area clean and dry with gauze and barrier cream PRN</a:t>
            </a:r>
          </a:p>
        </p:txBody>
      </p:sp>
      <p:sp>
        <p:nvSpPr>
          <p:cNvPr id="4" name="Slide Number Placeholder 3"/>
          <p:cNvSpPr>
            <a:spLocks noGrp="1"/>
          </p:cNvSpPr>
          <p:nvPr>
            <p:ph type="sldNum" sz="quarter" idx="5"/>
          </p:nvPr>
        </p:nvSpPr>
        <p:spPr/>
        <p:txBody>
          <a:bodyPr/>
          <a:lstStyle/>
          <a:p>
            <a:fld id="{5606601F-3A51-494E-B4DA-8AE7D58CBF0E}" type="slidenum">
              <a:rPr lang="en-US"/>
              <a:t>43</a:t>
            </a:fld>
            <a:endParaRPr lang="en-US"/>
          </a:p>
        </p:txBody>
      </p:sp>
    </p:spTree>
    <p:extLst>
      <p:ext uri="{BB962C8B-B14F-4D97-AF65-F5344CB8AC3E}">
        <p14:creationId xmlns:p14="http://schemas.microsoft.com/office/powerpoint/2010/main" val="587559569"/>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ea typeface="Calibri"/>
              <a:cs typeface="Calibri"/>
            </a:endParaRPr>
          </a:p>
        </p:txBody>
      </p:sp>
      <p:sp>
        <p:nvSpPr>
          <p:cNvPr id="4" name="Slide Number Placeholder 3"/>
          <p:cNvSpPr>
            <a:spLocks noGrp="1"/>
          </p:cNvSpPr>
          <p:nvPr>
            <p:ph type="sldNum" sz="quarter" idx="5"/>
          </p:nvPr>
        </p:nvSpPr>
        <p:spPr/>
        <p:txBody>
          <a:bodyPr/>
          <a:lstStyle/>
          <a:p>
            <a:fld id="{5606601F-3A51-494E-B4DA-8AE7D58CBF0E}" type="slidenum">
              <a:rPr lang="en-US"/>
              <a:t>45</a:t>
            </a:fld>
            <a:endParaRPr lang="en-US"/>
          </a:p>
        </p:txBody>
      </p:sp>
    </p:spTree>
    <p:extLst>
      <p:ext uri="{BB962C8B-B14F-4D97-AF65-F5344CB8AC3E}">
        <p14:creationId xmlns:p14="http://schemas.microsoft.com/office/powerpoint/2010/main" val="1126157270"/>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ea typeface="Calibri"/>
                <a:cs typeface="Calibri"/>
              </a:rPr>
              <a:t>Ok if stoma gets smaller with time </a:t>
            </a:r>
          </a:p>
        </p:txBody>
      </p:sp>
      <p:sp>
        <p:nvSpPr>
          <p:cNvPr id="4" name="Slide Number Placeholder 3"/>
          <p:cNvSpPr>
            <a:spLocks noGrp="1"/>
          </p:cNvSpPr>
          <p:nvPr>
            <p:ph type="sldNum" sz="quarter" idx="5"/>
          </p:nvPr>
        </p:nvSpPr>
        <p:spPr/>
        <p:txBody>
          <a:bodyPr/>
          <a:lstStyle/>
          <a:p>
            <a:fld id="{5606601F-3A51-494E-B4DA-8AE7D58CBF0E}" type="slidenum">
              <a:rPr lang="en-US"/>
              <a:t>47</a:t>
            </a:fld>
            <a:endParaRPr lang="en-US"/>
          </a:p>
        </p:txBody>
      </p:sp>
    </p:spTree>
    <p:extLst>
      <p:ext uri="{BB962C8B-B14F-4D97-AF65-F5344CB8AC3E}">
        <p14:creationId xmlns:p14="http://schemas.microsoft.com/office/powerpoint/2010/main" val="3379866426"/>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For dehisced incisions adjacent to stoma: use thin non-adherent absorbent dressing over incision then reapply pouch over the wound. </a:t>
            </a:r>
          </a:p>
        </p:txBody>
      </p:sp>
      <p:sp>
        <p:nvSpPr>
          <p:cNvPr id="4" name="Slide Number Placeholder 3"/>
          <p:cNvSpPr>
            <a:spLocks noGrp="1"/>
          </p:cNvSpPr>
          <p:nvPr>
            <p:ph type="sldNum" sz="quarter" idx="5"/>
          </p:nvPr>
        </p:nvSpPr>
        <p:spPr/>
        <p:txBody>
          <a:bodyPr/>
          <a:lstStyle/>
          <a:p>
            <a:fld id="{5606601F-3A51-494E-B4DA-8AE7D58CBF0E}" type="slidenum">
              <a:rPr lang="en-US"/>
              <a:t>49</a:t>
            </a:fld>
            <a:endParaRPr lang="en-US"/>
          </a:p>
        </p:txBody>
      </p:sp>
    </p:spTree>
    <p:extLst>
      <p:ext uri="{BB962C8B-B14F-4D97-AF65-F5344CB8AC3E}">
        <p14:creationId xmlns:p14="http://schemas.microsoft.com/office/powerpoint/2010/main" val="147626625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Upper extremity access is the preferred location when available. SC or IJ vein access is typically preferred to femoral vein access to improve comfort and reduce risk of thrombosis and infection from stool or enteric tube output</a:t>
            </a:r>
          </a:p>
        </p:txBody>
      </p:sp>
      <p:sp>
        <p:nvSpPr>
          <p:cNvPr id="4" name="Slide Number Placeholder 3"/>
          <p:cNvSpPr>
            <a:spLocks noGrp="1"/>
          </p:cNvSpPr>
          <p:nvPr>
            <p:ph type="sldNum" sz="quarter" idx="5"/>
          </p:nvPr>
        </p:nvSpPr>
        <p:spPr/>
        <p:txBody>
          <a:bodyPr/>
          <a:lstStyle/>
          <a:p>
            <a:fld id="{5606601F-3A51-494E-B4DA-8AE7D58CBF0E}" type="slidenum">
              <a:rPr lang="en-US"/>
              <a:t>8</a:t>
            </a:fld>
            <a:endParaRPr lang="en-US"/>
          </a:p>
        </p:txBody>
      </p:sp>
    </p:spTree>
    <p:extLst>
      <p:ext uri="{BB962C8B-B14F-4D97-AF65-F5344CB8AC3E}">
        <p14:creationId xmlns:p14="http://schemas.microsoft.com/office/powerpoint/2010/main" val="2800566192"/>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ea typeface="Calibri"/>
              <a:cs typeface="Calibri"/>
            </a:endParaRPr>
          </a:p>
        </p:txBody>
      </p:sp>
      <p:sp>
        <p:nvSpPr>
          <p:cNvPr id="4" name="Slide Number Placeholder 3"/>
          <p:cNvSpPr>
            <a:spLocks noGrp="1"/>
          </p:cNvSpPr>
          <p:nvPr>
            <p:ph type="sldNum" sz="quarter" idx="5"/>
          </p:nvPr>
        </p:nvSpPr>
        <p:spPr/>
        <p:txBody>
          <a:bodyPr/>
          <a:lstStyle/>
          <a:p>
            <a:fld id="{5606601F-3A51-494E-B4DA-8AE7D58CBF0E}" type="slidenum">
              <a:rPr lang="en-US"/>
              <a:t>50</a:t>
            </a:fld>
            <a:endParaRPr lang="en-US"/>
          </a:p>
        </p:txBody>
      </p:sp>
    </p:spTree>
    <p:extLst>
      <p:ext uri="{BB962C8B-B14F-4D97-AF65-F5344CB8AC3E}">
        <p14:creationId xmlns:p14="http://schemas.microsoft.com/office/powerpoint/2010/main" val="181345111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Polyurethane catheters: stronger, stiffer more resistant to mechanical compl like breakage, good for high pressure/volume fluid infusions, </a:t>
            </a:r>
            <a:r>
              <a:rPr lang="en-US"/>
              <a:t>no repair kit</a:t>
            </a:r>
            <a:endParaRPr lang="en-US">
              <a:ea typeface="Calibri"/>
              <a:cs typeface="Calibri"/>
            </a:endParaRPr>
          </a:p>
          <a:p>
            <a:r>
              <a:rPr lang="en-US">
                <a:ea typeface="Calibri"/>
                <a:cs typeface="Calibri"/>
              </a:rPr>
              <a:t>Silicon catheters: flexible, can use ethanol locks, more likely to break, can be repaired, lower risk for infection and thrombosis </a:t>
            </a:r>
          </a:p>
          <a:p>
            <a:r>
              <a:rPr lang="en-US"/>
              <a:t>Tunneled, single lumen, cuffed silicone catheters should be used for children with IF. </a:t>
            </a:r>
          </a:p>
        </p:txBody>
      </p:sp>
      <p:sp>
        <p:nvSpPr>
          <p:cNvPr id="4" name="Slide Number Placeholder 3"/>
          <p:cNvSpPr>
            <a:spLocks noGrp="1"/>
          </p:cNvSpPr>
          <p:nvPr>
            <p:ph type="sldNum" sz="quarter" idx="5"/>
          </p:nvPr>
        </p:nvSpPr>
        <p:spPr/>
        <p:txBody>
          <a:bodyPr/>
          <a:lstStyle/>
          <a:p>
            <a:fld id="{5606601F-3A51-494E-B4DA-8AE7D58CBF0E}" type="slidenum">
              <a:rPr lang="en-US"/>
              <a:t>9</a:t>
            </a:fld>
            <a:endParaRPr lang="en-US"/>
          </a:p>
        </p:txBody>
      </p:sp>
    </p:spTree>
    <p:extLst>
      <p:ext uri="{BB962C8B-B14F-4D97-AF65-F5344CB8AC3E}">
        <p14:creationId xmlns:p14="http://schemas.microsoft.com/office/powerpoint/2010/main" val="215387171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ICC have increased risk of venous stenosis, and site infection or phlebitis (Wendel, 2021). </a:t>
            </a:r>
          </a:p>
          <a:p>
            <a:r>
              <a:rPr lang="en-US" dirty="0"/>
              <a:t>Cuffed better than uncuffed in terms of infection, malposition, and thrombus formation. </a:t>
            </a:r>
            <a:endParaRPr lang="en-US" dirty="0">
              <a:ea typeface="Calibri"/>
              <a:cs typeface="Calibri"/>
            </a:endParaRPr>
          </a:p>
        </p:txBody>
      </p:sp>
      <p:sp>
        <p:nvSpPr>
          <p:cNvPr id="4" name="Slide Number Placeholder 3"/>
          <p:cNvSpPr>
            <a:spLocks noGrp="1"/>
          </p:cNvSpPr>
          <p:nvPr>
            <p:ph type="sldNum" sz="quarter" idx="5"/>
          </p:nvPr>
        </p:nvSpPr>
        <p:spPr/>
        <p:txBody>
          <a:bodyPr/>
          <a:lstStyle/>
          <a:p>
            <a:fld id="{5606601F-3A51-494E-B4DA-8AE7D58CBF0E}" type="slidenum">
              <a:rPr lang="en-US"/>
              <a:t>10</a:t>
            </a:fld>
            <a:endParaRPr lang="en-US"/>
          </a:p>
        </p:txBody>
      </p:sp>
    </p:spTree>
    <p:extLst>
      <p:ext uri="{BB962C8B-B14F-4D97-AF65-F5344CB8AC3E}">
        <p14:creationId xmlns:p14="http://schemas.microsoft.com/office/powerpoint/2010/main" val="85150485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The cuff is the internal securement device and is considered “stable” after 14 days post insertion</a:t>
            </a:r>
          </a:p>
        </p:txBody>
      </p:sp>
      <p:sp>
        <p:nvSpPr>
          <p:cNvPr id="4" name="Slide Number Placeholder 3"/>
          <p:cNvSpPr>
            <a:spLocks noGrp="1"/>
          </p:cNvSpPr>
          <p:nvPr>
            <p:ph type="sldNum" sz="quarter" idx="5"/>
          </p:nvPr>
        </p:nvSpPr>
        <p:spPr/>
        <p:txBody>
          <a:bodyPr/>
          <a:lstStyle/>
          <a:p>
            <a:fld id="{5606601F-3A51-494E-B4DA-8AE7D58CBF0E}" type="slidenum">
              <a:rPr lang="en-US"/>
              <a:t>11</a:t>
            </a:fld>
            <a:endParaRPr lang="en-US"/>
          </a:p>
        </p:txBody>
      </p:sp>
    </p:spTree>
    <p:extLst>
      <p:ext uri="{BB962C8B-B14F-4D97-AF65-F5344CB8AC3E}">
        <p14:creationId xmlns:p14="http://schemas.microsoft.com/office/powerpoint/2010/main" val="2433337888"/>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dults on home PN, Broviac higher catheter infection, Only PICC had venous thrombosis (Wall, 2016)</a:t>
            </a:r>
            <a:endParaRPr lang="en-US" dirty="0">
              <a:ea typeface="Calibri"/>
              <a:cs typeface="Calibri"/>
            </a:endParaRPr>
          </a:p>
          <a:p>
            <a:r>
              <a:rPr lang="en-US" dirty="0"/>
              <a:t>PICC increased thrombosis (Toure, 2015)</a:t>
            </a:r>
            <a:endParaRPr lang="en-US" dirty="0">
              <a:ea typeface="Calibri"/>
              <a:cs typeface="Calibri"/>
            </a:endParaRPr>
          </a:p>
          <a:p>
            <a:r>
              <a:rPr lang="en-US" dirty="0"/>
              <a:t>PICC increased thrombosis risk (</a:t>
            </a:r>
            <a:r>
              <a:rPr lang="en-US" err="1"/>
              <a:t>Schears</a:t>
            </a:r>
            <a:r>
              <a:rPr lang="en-US" dirty="0"/>
              <a:t>, 2021)</a:t>
            </a:r>
            <a:endParaRPr lang="en-US" dirty="0">
              <a:ea typeface="Calibri"/>
              <a:cs typeface="Calibri"/>
            </a:endParaRPr>
          </a:p>
          <a:p>
            <a:r>
              <a:rPr lang="en-US" dirty="0"/>
              <a:t>Except 1 paper: Pediatric patients with IF: PICC more likely to break, LESS thrombosis, Broviac higher infection rate. When comparing same size catheters (3F), no significant difference in infection, breakage, or occlusion. (</a:t>
            </a:r>
            <a:r>
              <a:rPr lang="en-US" dirty="0" err="1"/>
              <a:t>Blotte</a:t>
            </a:r>
            <a:r>
              <a:rPr lang="en-US" dirty="0"/>
              <a:t> 2017)</a:t>
            </a:r>
            <a:endParaRPr lang="en-US" dirty="0">
              <a:ea typeface="Calibri"/>
              <a:cs typeface="Calibri"/>
            </a:endParaRPr>
          </a:p>
          <a:p>
            <a:endParaRPr lang="en-US" dirty="0">
              <a:ea typeface="Calibri"/>
              <a:cs typeface="Calibri"/>
            </a:endParaRPr>
          </a:p>
        </p:txBody>
      </p:sp>
      <p:sp>
        <p:nvSpPr>
          <p:cNvPr id="4" name="Slide Number Placeholder 3"/>
          <p:cNvSpPr>
            <a:spLocks noGrp="1"/>
          </p:cNvSpPr>
          <p:nvPr>
            <p:ph type="sldNum" sz="quarter" idx="5"/>
          </p:nvPr>
        </p:nvSpPr>
        <p:spPr/>
        <p:txBody>
          <a:bodyPr/>
          <a:lstStyle/>
          <a:p>
            <a:fld id="{5606601F-3A51-494E-B4DA-8AE7D58CBF0E}" type="slidenum">
              <a:rPr lang="en-US"/>
              <a:t>13</a:t>
            </a:fld>
            <a:endParaRPr lang="en-US"/>
          </a:p>
        </p:txBody>
      </p:sp>
    </p:spTree>
    <p:extLst>
      <p:ext uri="{BB962C8B-B14F-4D97-AF65-F5344CB8AC3E}">
        <p14:creationId xmlns:p14="http://schemas.microsoft.com/office/powerpoint/2010/main" val="2978092318"/>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CUFF CAN MINIMIZE TUNNELED LINE INFECTIONS </a:t>
            </a:r>
            <a:endParaRPr lang="en-US" dirty="0"/>
          </a:p>
          <a:p>
            <a:r>
              <a:rPr lang="en-US" dirty="0"/>
              <a:t>To prevent complications, it is best practice to use the smallest diameter and least number of lumens that meet the patient’s clinical needs</a:t>
            </a:r>
            <a:endParaRPr lang="en-US" dirty="0">
              <a:ea typeface="Calibri"/>
              <a:cs typeface="Calibri"/>
            </a:endParaRPr>
          </a:p>
          <a:p>
            <a:r>
              <a:rPr lang="en-US"/>
              <a:t>Large diameter catheters can cause thrombosis and venous obstruction while multi lumen</a:t>
            </a:r>
            <a:r>
              <a:rPr lang="en-US" dirty="0"/>
              <a:t> catheters are associated with infection, thrombosis, and malfunction.</a:t>
            </a:r>
          </a:p>
        </p:txBody>
      </p:sp>
      <p:sp>
        <p:nvSpPr>
          <p:cNvPr id="4" name="Slide Number Placeholder 3"/>
          <p:cNvSpPr>
            <a:spLocks noGrp="1"/>
          </p:cNvSpPr>
          <p:nvPr>
            <p:ph type="sldNum" sz="quarter" idx="5"/>
          </p:nvPr>
        </p:nvSpPr>
        <p:spPr/>
        <p:txBody>
          <a:bodyPr/>
          <a:lstStyle/>
          <a:p>
            <a:fld id="{5606601F-3A51-494E-B4DA-8AE7D58CBF0E}" type="slidenum">
              <a:rPr lang="en-US"/>
              <a:t>14</a:t>
            </a:fld>
            <a:endParaRPr lang="en-US"/>
          </a:p>
        </p:txBody>
      </p:sp>
    </p:spTree>
    <p:extLst>
      <p:ext uri="{BB962C8B-B14F-4D97-AF65-F5344CB8AC3E}">
        <p14:creationId xmlns:p14="http://schemas.microsoft.com/office/powerpoint/2010/main" val="559029415"/>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ea typeface="Calibri"/>
                <a:cs typeface="Calibri"/>
              </a:rPr>
              <a:t>Abx like mupirocin </a:t>
            </a:r>
            <a:endParaRPr lang="en-US" dirty="0"/>
          </a:p>
          <a:p>
            <a:endParaRPr lang="en-US" dirty="0">
              <a:ea typeface="Calibri"/>
              <a:cs typeface="Calibri"/>
            </a:endParaRPr>
          </a:p>
          <a:p>
            <a:endParaRPr lang="en-US" dirty="0"/>
          </a:p>
          <a:p>
            <a:endParaRPr lang="en-US" dirty="0">
              <a:cs typeface="Calibri"/>
            </a:endParaRPr>
          </a:p>
          <a:p>
            <a:endParaRPr lang="en-US" dirty="0">
              <a:ea typeface="Calibri"/>
              <a:cs typeface="Calibri"/>
            </a:endParaRPr>
          </a:p>
        </p:txBody>
      </p:sp>
      <p:sp>
        <p:nvSpPr>
          <p:cNvPr id="4" name="Slide Number Placeholder 3"/>
          <p:cNvSpPr>
            <a:spLocks noGrp="1"/>
          </p:cNvSpPr>
          <p:nvPr>
            <p:ph type="sldNum" sz="quarter" idx="5"/>
          </p:nvPr>
        </p:nvSpPr>
        <p:spPr/>
        <p:txBody>
          <a:bodyPr/>
          <a:lstStyle/>
          <a:p>
            <a:fld id="{5606601F-3A51-494E-B4DA-8AE7D58CBF0E}" type="slidenum">
              <a:rPr lang="en-US"/>
              <a:t>15</a:t>
            </a:fld>
            <a:endParaRPr lang="en-US"/>
          </a:p>
        </p:txBody>
      </p:sp>
    </p:spTree>
    <p:extLst>
      <p:ext uri="{BB962C8B-B14F-4D97-AF65-F5344CB8AC3E}">
        <p14:creationId xmlns:p14="http://schemas.microsoft.com/office/powerpoint/2010/main" val="289866034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846CE7D5-CF57-46EF-B807-FDD0502418D4}" type="datetimeFigureOut">
              <a:rPr lang="en-US" smtClean="0"/>
              <a:t>4/24/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238538789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46CE7D5-CF57-46EF-B807-FDD0502418D4}" type="datetimeFigureOut">
              <a:rPr lang="en-US" smtClean="0"/>
              <a:t>4/24/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220290545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46CE7D5-CF57-46EF-B807-FDD0502418D4}" type="datetimeFigureOut">
              <a:rPr lang="en-US" smtClean="0"/>
              <a:t>4/24/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47944565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846CE7D5-CF57-46EF-B807-FDD0502418D4}" type="datetimeFigureOut">
              <a:rPr lang="en-US" smtClean="0"/>
              <a:t>4/24/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94913845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46CE7D5-CF57-46EF-B807-FDD0502418D4}" type="datetimeFigureOut">
              <a:rPr lang="en-US" smtClean="0"/>
              <a:t>4/24/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259152452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846CE7D5-CF57-46EF-B807-FDD0502418D4}" type="datetimeFigureOut">
              <a:rPr lang="en-US" smtClean="0"/>
              <a:t>4/24/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120309203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846CE7D5-CF57-46EF-B807-FDD0502418D4}" type="datetimeFigureOut">
              <a:rPr lang="en-US" smtClean="0"/>
              <a:t>4/24/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73317233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846CE7D5-CF57-46EF-B807-FDD0502418D4}" type="datetimeFigureOut">
              <a:rPr lang="en-US" smtClean="0"/>
              <a:t>4/24/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21031255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46CE7D5-CF57-46EF-B807-FDD0502418D4}" type="datetimeFigureOut">
              <a:rPr lang="en-US" smtClean="0"/>
              <a:t>4/24/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14638898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846CE7D5-CF57-46EF-B807-FDD0502418D4}" type="datetimeFigureOut">
              <a:rPr lang="en-US" smtClean="0"/>
              <a:t>4/24/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17184145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noChangeAspect="1"/>
          </p:cNvSpPr>
          <p:nvPr>
            <p:ph type="pic" idx="1"/>
          </p:nvPr>
        </p:nvSpPr>
        <p:spPr>
          <a:xfrm>
            <a:off x="5183188" y="987425"/>
            <a:ext cx="617220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846CE7D5-CF57-46EF-B807-FDD0502418D4}" type="datetimeFigureOut">
              <a:rPr lang="en-US" smtClean="0"/>
              <a:t>4/24/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171895827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846CE7D5-CF57-46EF-B807-FDD0502418D4}" type="datetimeFigureOut">
              <a:rPr lang="en-US" smtClean="0"/>
              <a:t>4/24/2025</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330EA680-D336-4FF7-8B7A-9848BB0A1C32}" type="slidenum">
              <a:rPr lang="en-US" smtClean="0"/>
              <a:t>‹#›</a:t>
            </a:fld>
            <a:endParaRPr lang="en-US"/>
          </a:p>
        </p:txBody>
      </p:sp>
    </p:spTree>
    <p:extLst>
      <p:ext uri="{BB962C8B-B14F-4D97-AF65-F5344CB8AC3E}">
        <p14:creationId xmlns:p14="http://schemas.microsoft.com/office/powerpoint/2010/main" val="246095407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notesSlide" Target="../notesSlides/notesSlide5.xml"/><Relationship Id="rId1" Type="http://schemas.openxmlformats.org/officeDocument/2006/relationships/slideLayout" Target="../slideLayouts/slideLayout7.xml"/><Relationship Id="rId4" Type="http://schemas.openxmlformats.org/officeDocument/2006/relationships/image" Target="../media/image7.gif"/></Relationships>
</file>

<file path=ppt/slides/_rels/slide11.xml.rels><?xml version="1.0" encoding="UTF-8" standalone="yes"?>
<Relationships xmlns="http://schemas.openxmlformats.org/package/2006/relationships"><Relationship Id="rId3" Type="http://schemas.openxmlformats.org/officeDocument/2006/relationships/image" Target="../media/image8.jpeg"/><Relationship Id="rId2" Type="http://schemas.openxmlformats.org/officeDocument/2006/relationships/notesSlide" Target="../notesSlides/notesSlide6.xml"/><Relationship Id="rId1" Type="http://schemas.openxmlformats.org/officeDocument/2006/relationships/slideLayout" Target="../slideLayouts/slideLayout7.xml"/><Relationship Id="rId4" Type="http://schemas.openxmlformats.org/officeDocument/2006/relationships/image" Target="../media/image9.jpeg"/></Relationships>
</file>

<file path=ppt/slides/_rels/slide12.xml.rels><?xml version="1.0" encoding="UTF-8" standalone="yes"?>
<Relationships xmlns="http://schemas.openxmlformats.org/package/2006/relationships"><Relationship Id="rId3" Type="http://schemas.openxmlformats.org/officeDocument/2006/relationships/image" Target="../media/image11.jpeg"/><Relationship Id="rId2" Type="http://schemas.openxmlformats.org/officeDocument/2006/relationships/image" Target="../media/image10.jpeg"/><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image" Target="../media/image12.jpeg"/><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image" Target="../media/image14.jpeg"/><Relationship Id="rId2" Type="http://schemas.openxmlformats.org/officeDocument/2006/relationships/image" Target="../media/image13.jpeg"/><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3" Type="http://schemas.openxmlformats.org/officeDocument/2006/relationships/image" Target="../media/image15.jpeg"/><Relationship Id="rId2" Type="http://schemas.openxmlformats.org/officeDocument/2006/relationships/notesSlide" Target="../notesSlides/notesSlide14.xml"/><Relationship Id="rId1" Type="http://schemas.openxmlformats.org/officeDocument/2006/relationships/slideLayout" Target="../slideLayouts/slideLayout7.xml"/><Relationship Id="rId4" Type="http://schemas.openxmlformats.org/officeDocument/2006/relationships/image" Target="../media/image16.jpeg"/></Relationships>
</file>

<file path=ppt/slides/_rels/slide24.xml.rels><?xml version="1.0" encoding="UTF-8" standalone="yes"?>
<Relationships xmlns="http://schemas.openxmlformats.org/package/2006/relationships"><Relationship Id="rId3" Type="http://schemas.openxmlformats.org/officeDocument/2006/relationships/image" Target="../media/image17.jpeg"/><Relationship Id="rId2" Type="http://schemas.openxmlformats.org/officeDocument/2006/relationships/notesSlide" Target="../notesSlides/notesSlide15.xml"/><Relationship Id="rId1" Type="http://schemas.openxmlformats.org/officeDocument/2006/relationships/slideLayout" Target="../slideLayouts/slideLayout7.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3" Type="http://schemas.openxmlformats.org/officeDocument/2006/relationships/image" Target="../media/image19.jpeg"/><Relationship Id="rId2" Type="http://schemas.openxmlformats.org/officeDocument/2006/relationships/image" Target="../media/image18.jpeg"/><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image" Target="../media/image20.jpeg"/><Relationship Id="rId1" Type="http://schemas.openxmlformats.org/officeDocument/2006/relationships/slideLayout" Target="../slideLayouts/slideLayout7.xml"/></Relationships>
</file>

<file path=ppt/slides/_rels/slide28.xml.rels><?xml version="1.0" encoding="UTF-8" standalone="yes"?>
<Relationships xmlns="http://schemas.openxmlformats.org/package/2006/relationships"><Relationship Id="rId3" Type="http://schemas.openxmlformats.org/officeDocument/2006/relationships/image" Target="../media/image22.jpeg"/><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3" Type="http://schemas.openxmlformats.org/officeDocument/2006/relationships/image" Target="../media/image23.jpeg"/><Relationship Id="rId2" Type="http://schemas.openxmlformats.org/officeDocument/2006/relationships/notesSlide" Target="../notesSlides/notesSlide18.xml"/><Relationship Id="rId1" Type="http://schemas.openxmlformats.org/officeDocument/2006/relationships/slideLayout" Target="../slideLayouts/slideLayout2.xml"/><Relationship Id="rId4" Type="http://schemas.openxmlformats.org/officeDocument/2006/relationships/image" Target="../media/image24.jpeg"/></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36.xml.rels><?xml version="1.0" encoding="UTF-8" standalone="yes"?>
<Relationships xmlns="http://schemas.openxmlformats.org/package/2006/relationships"><Relationship Id="rId3" Type="http://schemas.openxmlformats.org/officeDocument/2006/relationships/image" Target="../media/image25.jpeg"/><Relationship Id="rId2" Type="http://schemas.openxmlformats.org/officeDocument/2006/relationships/notesSlide" Target="../notesSlides/notesSlide22.xml"/><Relationship Id="rId1" Type="http://schemas.openxmlformats.org/officeDocument/2006/relationships/slideLayout" Target="../slideLayouts/slideLayout2.xml"/><Relationship Id="rId5" Type="http://schemas.openxmlformats.org/officeDocument/2006/relationships/image" Target="../media/image27.jpeg"/><Relationship Id="rId4" Type="http://schemas.openxmlformats.org/officeDocument/2006/relationships/image" Target="../media/image26.png"/></Relationships>
</file>

<file path=ppt/slides/_rels/slide37.xml.rels><?xml version="1.0" encoding="UTF-8" standalone="yes"?>
<Relationships xmlns="http://schemas.openxmlformats.org/package/2006/relationships"><Relationship Id="rId2" Type="http://schemas.openxmlformats.org/officeDocument/2006/relationships/image" Target="../media/image28.png"/><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23.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39.xml.rels><?xml version="1.0" encoding="UTF-8" standalone="yes"?>
<Relationships xmlns="http://schemas.openxmlformats.org/package/2006/relationships"><Relationship Id="rId3" Type="http://schemas.openxmlformats.org/officeDocument/2006/relationships/image" Target="../media/image29.png"/><Relationship Id="rId2" Type="http://schemas.openxmlformats.org/officeDocument/2006/relationships/notesSlide" Target="../notesSlides/notesSlide24.xml"/><Relationship Id="rId1" Type="http://schemas.openxmlformats.org/officeDocument/2006/relationships/slideLayout" Target="../slideLayouts/slideLayout7.xml"/><Relationship Id="rId6" Type="http://schemas.openxmlformats.org/officeDocument/2006/relationships/image" Target="../media/image32.jpeg"/><Relationship Id="rId5" Type="http://schemas.openxmlformats.org/officeDocument/2006/relationships/image" Target="../media/image31.jpeg"/><Relationship Id="rId4" Type="http://schemas.openxmlformats.org/officeDocument/2006/relationships/image" Target="../media/image30.jpeg"/></Relationships>
</file>

<file path=ppt/slides/_rels/slide4.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41.xml.rels><?xml version="1.0" encoding="UTF-8" standalone="yes"?>
<Relationships xmlns="http://schemas.openxmlformats.org/package/2006/relationships"><Relationship Id="rId2" Type="http://schemas.openxmlformats.org/officeDocument/2006/relationships/image" Target="../media/image33.png"/><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3" Type="http://schemas.openxmlformats.org/officeDocument/2006/relationships/image" Target="../media/image34.png"/><Relationship Id="rId2" Type="http://schemas.openxmlformats.org/officeDocument/2006/relationships/notesSlide" Target="../notesSlides/notesSlide25.xml"/><Relationship Id="rId1" Type="http://schemas.openxmlformats.org/officeDocument/2006/relationships/slideLayout" Target="../slideLayouts/slideLayout7.xml"/><Relationship Id="rId6" Type="http://schemas.openxmlformats.org/officeDocument/2006/relationships/image" Target="../media/image37.png"/><Relationship Id="rId5" Type="http://schemas.openxmlformats.org/officeDocument/2006/relationships/image" Target="../media/image36.jpeg"/><Relationship Id="rId4" Type="http://schemas.openxmlformats.org/officeDocument/2006/relationships/image" Target="../media/image35.jpeg"/></Relationships>
</file>

<file path=ppt/slides/_rels/slide43.xml.rels><?xml version="1.0" encoding="UTF-8" standalone="yes"?>
<Relationships xmlns="http://schemas.openxmlformats.org/package/2006/relationships"><Relationship Id="rId3" Type="http://schemas.openxmlformats.org/officeDocument/2006/relationships/image" Target="../media/image38.png"/><Relationship Id="rId2" Type="http://schemas.openxmlformats.org/officeDocument/2006/relationships/notesSlide" Target="../notesSlides/notesSlide26.xml"/><Relationship Id="rId1" Type="http://schemas.openxmlformats.org/officeDocument/2006/relationships/slideLayout" Target="../slideLayouts/slideLayout2.xml"/><Relationship Id="rId5" Type="http://schemas.openxmlformats.org/officeDocument/2006/relationships/image" Target="../media/image40.jpeg"/><Relationship Id="rId4" Type="http://schemas.openxmlformats.org/officeDocument/2006/relationships/image" Target="../media/image39.jpeg"/></Relationships>
</file>

<file path=ppt/slides/_rels/slide44.xml.rels><?xml version="1.0" encoding="UTF-8" standalone="yes"?>
<Relationships xmlns="http://schemas.openxmlformats.org/package/2006/relationships"><Relationship Id="rId3" Type="http://schemas.openxmlformats.org/officeDocument/2006/relationships/image" Target="../media/image32.jpeg"/><Relationship Id="rId2" Type="http://schemas.openxmlformats.org/officeDocument/2006/relationships/image" Target="../media/image41.jpeg"/><Relationship Id="rId1" Type="http://schemas.openxmlformats.org/officeDocument/2006/relationships/slideLayout" Target="../slideLayouts/slideLayout2.xml"/><Relationship Id="rId4" Type="http://schemas.openxmlformats.org/officeDocument/2006/relationships/image" Target="../media/image42.jpeg"/></Relationships>
</file>

<file path=ppt/slides/_rels/slide45.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3.xml"/></Relationships>
</file>

<file path=ppt/slides/_rels/slide46.xml.rels><?xml version="1.0" encoding="UTF-8" standalone="yes"?>
<Relationships xmlns="http://schemas.openxmlformats.org/package/2006/relationships"><Relationship Id="rId8" Type="http://schemas.openxmlformats.org/officeDocument/2006/relationships/image" Target="../media/image49.jpeg"/><Relationship Id="rId3" Type="http://schemas.openxmlformats.org/officeDocument/2006/relationships/image" Target="../media/image44.png"/><Relationship Id="rId7" Type="http://schemas.openxmlformats.org/officeDocument/2006/relationships/image" Target="../media/image48.png"/><Relationship Id="rId2" Type="http://schemas.openxmlformats.org/officeDocument/2006/relationships/image" Target="../media/image43.png"/><Relationship Id="rId1" Type="http://schemas.openxmlformats.org/officeDocument/2006/relationships/slideLayout" Target="../slideLayouts/slideLayout2.xml"/><Relationship Id="rId6" Type="http://schemas.openxmlformats.org/officeDocument/2006/relationships/image" Target="../media/image47.png"/><Relationship Id="rId5" Type="http://schemas.openxmlformats.org/officeDocument/2006/relationships/image" Target="../media/image46.png"/><Relationship Id="rId4" Type="http://schemas.openxmlformats.org/officeDocument/2006/relationships/image" Target="../media/image45.png"/></Relationships>
</file>

<file path=ppt/slides/_rels/slide47.xml.rels><?xml version="1.0" encoding="UTF-8" standalone="yes"?>
<Relationships xmlns="http://schemas.openxmlformats.org/package/2006/relationships"><Relationship Id="rId3" Type="http://schemas.openxmlformats.org/officeDocument/2006/relationships/image" Target="../media/image50.jpeg"/><Relationship Id="rId2" Type="http://schemas.openxmlformats.org/officeDocument/2006/relationships/notesSlide" Target="../notesSlides/notesSlide28.xml"/><Relationship Id="rId1" Type="http://schemas.openxmlformats.org/officeDocument/2006/relationships/slideLayout" Target="../slideLayouts/slideLayout2.xml"/><Relationship Id="rId4" Type="http://schemas.openxmlformats.org/officeDocument/2006/relationships/image" Target="../media/image51.jpeg"/></Relationships>
</file>

<file path=ppt/slides/_rels/slide48.xml.rels><?xml version="1.0" encoding="UTF-8" standalone="yes"?>
<Relationships xmlns="http://schemas.openxmlformats.org/package/2006/relationships"><Relationship Id="rId3" Type="http://schemas.openxmlformats.org/officeDocument/2006/relationships/image" Target="../media/image53.png"/><Relationship Id="rId2" Type="http://schemas.openxmlformats.org/officeDocument/2006/relationships/image" Target="../media/image52.png"/><Relationship Id="rId1" Type="http://schemas.openxmlformats.org/officeDocument/2006/relationships/slideLayout" Target="../slideLayouts/slideLayout2.xml"/><Relationship Id="rId4" Type="http://schemas.openxmlformats.org/officeDocument/2006/relationships/image" Target="../media/image54.png"/></Relationships>
</file>

<file path=ppt/slides/_rels/slide49.xml.rels><?xml version="1.0" encoding="UTF-8" standalone="yes"?>
<Relationships xmlns="http://schemas.openxmlformats.org/package/2006/relationships"><Relationship Id="rId3" Type="http://schemas.openxmlformats.org/officeDocument/2006/relationships/image" Target="../media/image55.jpeg"/><Relationship Id="rId2" Type="http://schemas.openxmlformats.org/officeDocument/2006/relationships/notesSlide" Target="../notesSlides/notesSlide29.xml"/><Relationship Id="rId1" Type="http://schemas.openxmlformats.org/officeDocument/2006/relationships/slideLayout" Target="../slideLayouts/slideLayout2.xml"/><Relationship Id="rId5" Type="http://schemas.openxmlformats.org/officeDocument/2006/relationships/image" Target="../media/image32.jpeg"/><Relationship Id="rId4" Type="http://schemas.openxmlformats.org/officeDocument/2006/relationships/image" Target="../media/image56.jpeg"/></Relationships>
</file>

<file path=ppt/slides/_rels/slide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5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1.xml"/></Relationships>
</file>

<file path=ppt/slides/_rels/slide51.xml.rels><?xml version="1.0" encoding="UTF-8" standalone="yes"?>
<Relationships xmlns="http://schemas.openxmlformats.org/package/2006/relationships"><Relationship Id="rId8" Type="http://schemas.openxmlformats.org/officeDocument/2006/relationships/hyperlink" Target="https://doi.org/10.1186/s12871-018-0548-y" TargetMode="External"/><Relationship Id="rId3" Type="http://schemas.openxmlformats.org/officeDocument/2006/relationships/hyperlink" Target="https://doi.org/10.1016/j.bpg.2016.02.011" TargetMode="External"/><Relationship Id="rId7" Type="http://schemas.openxmlformats.org/officeDocument/2006/relationships/hyperlink" Target="https://doi.org/10.1177/1129729820916113" TargetMode="External"/><Relationship Id="rId2" Type="http://schemas.openxmlformats.org/officeDocument/2006/relationships/hyperlink" Target="https://doi.org/10.1097/MPG.0000000000003036" TargetMode="External"/><Relationship Id="rId1" Type="http://schemas.openxmlformats.org/officeDocument/2006/relationships/slideLayout" Target="../slideLayouts/slideLayout2.xml"/><Relationship Id="rId6" Type="http://schemas.openxmlformats.org/officeDocument/2006/relationships/hyperlink" Target="https://doi.org/10.1016/j.clnu.2013.12.017" TargetMode="External"/><Relationship Id="rId5" Type="http://schemas.openxmlformats.org/officeDocument/2006/relationships/hyperlink" Target="https://doi.org/10.1177/1751143715618683" TargetMode="External"/><Relationship Id="rId4" Type="http://schemas.openxmlformats.org/officeDocument/2006/relationships/hyperlink" Target="https://doi.org/10.1097/00007890-199904150-00021" TargetMode="External"/></Relationships>
</file>

<file path=ppt/slides/_rels/slide6.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9.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notesSlide" Target="../notesSlides/notesSlide4.xml"/><Relationship Id="rId1" Type="http://schemas.openxmlformats.org/officeDocument/2006/relationships/slideLayout" Target="../slideLayouts/slideLayout7.xml"/><Relationship Id="rId4" Type="http://schemas.openxmlformats.org/officeDocument/2006/relationships/image" Target="../media/image5.jpeg"/></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34" name="Rectangle 33">
            <a:extLst>
              <a:ext uri="{FF2B5EF4-FFF2-40B4-BE49-F238E27FC236}">
                <a16:creationId xmlns:a16="http://schemas.microsoft.com/office/drawing/2014/main" id="{43C48B49-6135-48B6-AC0F-97E5D8D1F03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w="12700" cap="flat" cmpd="sng" algn="ctr">
            <a:noFill/>
            <a:prstDash val="solid"/>
            <a:miter lim="800000"/>
          </a:ln>
          <a:effectLst/>
          <a:extLst>
            <a:ext uri="{91240B29-F687-4F45-9708-019B960494DF}">
              <a14:hiddenLine xmlns:a14="http://schemas.microsoft.com/office/drawing/2010/main" w="12700" cap="flat" cmpd="sng" algn="ctr">
                <a:solidFill>
                  <a:schemeClr val="accent1">
                    <a:shade val="50000"/>
                  </a:schemeClr>
                </a:solidFill>
                <a:prstDash val="solid"/>
                <a:miter lim="800000"/>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ctrTitle"/>
          </p:nvPr>
        </p:nvSpPr>
        <p:spPr>
          <a:xfrm>
            <a:off x="1499799" y="705586"/>
            <a:ext cx="9014348" cy="2402006"/>
          </a:xfrm>
        </p:spPr>
        <p:txBody>
          <a:bodyPr anchor="b">
            <a:normAutofit/>
          </a:bodyPr>
          <a:lstStyle/>
          <a:p>
            <a:r>
              <a:rPr lang="en-US" sz="5400" dirty="0"/>
              <a:t>Intestinal Rehab </a:t>
            </a:r>
            <a:br>
              <a:rPr lang="en-US" sz="5400" dirty="0"/>
            </a:br>
            <a:r>
              <a:rPr lang="en-US" sz="5400" dirty="0"/>
              <a:t>Residency Curriculum</a:t>
            </a:r>
          </a:p>
        </p:txBody>
      </p:sp>
      <p:sp>
        <p:nvSpPr>
          <p:cNvPr id="35" name="Rectangle 34">
            <a:extLst>
              <a:ext uri="{FF2B5EF4-FFF2-40B4-BE49-F238E27FC236}">
                <a16:creationId xmlns:a16="http://schemas.microsoft.com/office/drawing/2014/main" id="{9715DAF0-AE1B-46C9-8A6B-DB2AA05AB91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0800000">
            <a:off x="-8" y="4374554"/>
            <a:ext cx="12192007" cy="2483444"/>
          </a:xfrm>
          <a:prstGeom prst="rect">
            <a:avLst/>
          </a:prstGeom>
          <a:gradFill>
            <a:gsLst>
              <a:gs pos="0">
                <a:schemeClr val="accent1">
                  <a:lumMod val="75000"/>
                </a:schemeClr>
              </a:gs>
              <a:gs pos="100000">
                <a:srgbClr val="000000"/>
              </a:gs>
            </a:gsLst>
            <a:lin ang="156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 name="Rectangle 35">
            <a:extLst>
              <a:ext uri="{FF2B5EF4-FFF2-40B4-BE49-F238E27FC236}">
                <a16:creationId xmlns:a16="http://schemas.microsoft.com/office/drawing/2014/main" id="{DC631C0B-6DA6-4E57-8231-CE32B3434A7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0800000" flipH="1">
            <a:off x="8140655" y="4374554"/>
            <a:ext cx="4051344" cy="2483446"/>
          </a:xfrm>
          <a:prstGeom prst="rect">
            <a:avLst/>
          </a:prstGeom>
          <a:gradFill>
            <a:gsLst>
              <a:gs pos="4000">
                <a:schemeClr val="accent1">
                  <a:alpha val="21000"/>
                </a:schemeClr>
              </a:gs>
              <a:gs pos="83000">
                <a:schemeClr val="accent1">
                  <a:lumMod val="50000"/>
                  <a:alpha val="61000"/>
                </a:schemeClr>
              </a:gs>
            </a:gsLst>
            <a:lin ang="18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7" name="Rectangle 36">
            <a:extLst>
              <a:ext uri="{FF2B5EF4-FFF2-40B4-BE49-F238E27FC236}">
                <a16:creationId xmlns:a16="http://schemas.microsoft.com/office/drawing/2014/main" id="{F256AC18-FB41-4977-8B0C-F5082335AB7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0800000">
            <a:off x="0" y="4379429"/>
            <a:ext cx="12191984" cy="1953928"/>
          </a:xfrm>
          <a:prstGeom prst="rect">
            <a:avLst/>
          </a:prstGeom>
          <a:gradFill>
            <a:gsLst>
              <a:gs pos="32000">
                <a:schemeClr val="accent1">
                  <a:lumMod val="50000"/>
                  <a:alpha val="0"/>
                </a:schemeClr>
              </a:gs>
              <a:gs pos="100000">
                <a:schemeClr val="accent1">
                  <a:alpha val="55000"/>
                </a:schemeClr>
              </a:gs>
            </a:gsLst>
            <a:lin ang="66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8" name="Rectangle 37">
            <a:extLst>
              <a:ext uri="{FF2B5EF4-FFF2-40B4-BE49-F238E27FC236}">
                <a16:creationId xmlns:a16="http://schemas.microsoft.com/office/drawing/2014/main" id="{AFF4A713-7B75-4B21-90D7-5AB19547C72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 y="4380927"/>
            <a:ext cx="12192000" cy="2019443"/>
          </a:xfrm>
          <a:prstGeom prst="rect">
            <a:avLst/>
          </a:prstGeom>
          <a:gradFill>
            <a:gsLst>
              <a:gs pos="32000">
                <a:schemeClr val="accent1">
                  <a:lumMod val="50000"/>
                  <a:alpha val="0"/>
                </a:schemeClr>
              </a:gs>
              <a:gs pos="100000">
                <a:srgbClr val="000000">
                  <a:alpha val="45000"/>
                </a:srgbClr>
              </a:gs>
            </a:gsLst>
            <a:lin ang="7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Subtitle 2"/>
          <p:cNvSpPr>
            <a:spLocks noGrp="1"/>
          </p:cNvSpPr>
          <p:nvPr>
            <p:ph type="subTitle" idx="1"/>
          </p:nvPr>
        </p:nvSpPr>
        <p:spPr>
          <a:xfrm>
            <a:off x="1329765" y="4892722"/>
            <a:ext cx="6387155" cy="1078173"/>
          </a:xfrm>
        </p:spPr>
        <p:txBody>
          <a:bodyPr vert="horz" lIns="91440" tIns="45720" rIns="91440" bIns="45720" rtlCol="0" anchor="ctr">
            <a:normAutofit/>
          </a:bodyPr>
          <a:lstStyle/>
          <a:p>
            <a:pPr algn="l"/>
            <a:r>
              <a:rPr lang="en-US">
                <a:solidFill>
                  <a:srgbClr val="FFFFFF"/>
                </a:solidFill>
              </a:rPr>
              <a:t>Sirine Belaid </a:t>
            </a:r>
          </a:p>
          <a:p>
            <a:pPr algn="l"/>
            <a:r>
              <a:rPr lang="en-US">
                <a:solidFill>
                  <a:srgbClr val="FFFFFF"/>
                </a:solidFill>
              </a:rPr>
              <a:t>January 2nd 2025</a:t>
            </a:r>
          </a:p>
        </p:txBody>
      </p:sp>
    </p:spTree>
    <p:extLst>
      <p:ext uri="{BB962C8B-B14F-4D97-AF65-F5344CB8AC3E}">
        <p14:creationId xmlns:p14="http://schemas.microsoft.com/office/powerpoint/2010/main" val="10985722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PICC double lumen.jpg">
            <a:extLst>
              <a:ext uri="{FF2B5EF4-FFF2-40B4-BE49-F238E27FC236}">
                <a16:creationId xmlns:a16="http://schemas.microsoft.com/office/drawing/2014/main" id="{D29F9914-125C-47D2-415A-9432AD406734}"/>
              </a:ext>
            </a:extLst>
          </p:cNvPr>
          <p:cNvPicPr>
            <a:picLocks noChangeAspect="1"/>
          </p:cNvPicPr>
          <p:nvPr/>
        </p:nvPicPr>
        <p:blipFill>
          <a:blip r:embed="rId3"/>
          <a:stretch>
            <a:fillRect/>
          </a:stretch>
        </p:blipFill>
        <p:spPr>
          <a:xfrm>
            <a:off x="6204887" y="1065363"/>
            <a:ext cx="5403144" cy="2995436"/>
          </a:xfrm>
          <a:prstGeom prst="rect">
            <a:avLst/>
          </a:prstGeom>
        </p:spPr>
      </p:pic>
      <p:pic>
        <p:nvPicPr>
          <p:cNvPr id="3" name="Picture 2" descr="PICC.gif">
            <a:extLst>
              <a:ext uri="{FF2B5EF4-FFF2-40B4-BE49-F238E27FC236}">
                <a16:creationId xmlns:a16="http://schemas.microsoft.com/office/drawing/2014/main" id="{172995E9-8C6D-8F93-2D3D-40CE78594C48}"/>
              </a:ext>
            </a:extLst>
          </p:cNvPr>
          <p:cNvPicPr>
            <a:picLocks noChangeAspect="1"/>
          </p:cNvPicPr>
          <p:nvPr/>
        </p:nvPicPr>
        <p:blipFill>
          <a:blip r:embed="rId4"/>
          <a:stretch>
            <a:fillRect/>
          </a:stretch>
        </p:blipFill>
        <p:spPr>
          <a:xfrm>
            <a:off x="1139" y="1295281"/>
            <a:ext cx="5553075" cy="4648200"/>
          </a:xfrm>
          <a:prstGeom prst="rect">
            <a:avLst/>
          </a:prstGeom>
        </p:spPr>
      </p:pic>
      <p:sp>
        <p:nvSpPr>
          <p:cNvPr id="4" name="TextBox 3">
            <a:extLst>
              <a:ext uri="{FF2B5EF4-FFF2-40B4-BE49-F238E27FC236}">
                <a16:creationId xmlns:a16="http://schemas.microsoft.com/office/drawing/2014/main" id="{9FEA30E3-677C-4B49-0CA0-68676A816BFF}"/>
              </a:ext>
            </a:extLst>
          </p:cNvPr>
          <p:cNvSpPr txBox="1"/>
          <p:nvPr/>
        </p:nvSpPr>
        <p:spPr>
          <a:xfrm>
            <a:off x="5992120" y="4556505"/>
            <a:ext cx="5927385" cy="181588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marL="457200" indent="-457200">
              <a:buFont typeface="Arial"/>
              <a:buChar char="•"/>
            </a:pPr>
            <a:r>
              <a:rPr lang="en-US" sz="2800" dirty="0"/>
              <a:t>Short term</a:t>
            </a:r>
            <a:endParaRPr lang="en-US" dirty="0"/>
          </a:p>
          <a:p>
            <a:pPr marL="457200" indent="-457200">
              <a:buFont typeface="Arial"/>
              <a:buChar char="•"/>
            </a:pPr>
            <a:r>
              <a:rPr lang="en-US" sz="2800"/>
              <a:t>Increased risk of line breakage, peripheral clots, site infection or phlebitis</a:t>
            </a:r>
          </a:p>
        </p:txBody>
      </p:sp>
      <p:sp>
        <p:nvSpPr>
          <p:cNvPr id="6" name="Title 1">
            <a:extLst>
              <a:ext uri="{FF2B5EF4-FFF2-40B4-BE49-F238E27FC236}">
                <a16:creationId xmlns:a16="http://schemas.microsoft.com/office/drawing/2014/main" id="{0E49BBB2-033B-6630-BF0B-B629A70FFCCE}"/>
              </a:ext>
            </a:extLst>
          </p:cNvPr>
          <p:cNvSpPr txBox="1">
            <a:spLocks/>
          </p:cNvSpPr>
          <p:nvPr/>
        </p:nvSpPr>
        <p:spPr>
          <a:xfrm>
            <a:off x="1407850" y="261552"/>
            <a:ext cx="10515600" cy="1325563"/>
          </a:xfrm>
          <a:prstGeom prst="rect">
            <a:avLst/>
          </a:prstGeom>
        </p:spPr>
        <p:txBody>
          <a:bodyPr lIns="91440" tIns="45720" rIns="91440" bIns="45720" anchor="t"/>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a:t>PICC: </a:t>
            </a:r>
          </a:p>
        </p:txBody>
      </p:sp>
    </p:spTree>
    <p:extLst>
      <p:ext uri="{BB962C8B-B14F-4D97-AF65-F5344CB8AC3E}">
        <p14:creationId xmlns:p14="http://schemas.microsoft.com/office/powerpoint/2010/main" val="206466383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Hickman.jpg">
            <a:extLst>
              <a:ext uri="{FF2B5EF4-FFF2-40B4-BE49-F238E27FC236}">
                <a16:creationId xmlns:a16="http://schemas.microsoft.com/office/drawing/2014/main" id="{AC117B21-C236-3ABB-F877-A8D331F2008A}"/>
              </a:ext>
            </a:extLst>
          </p:cNvPr>
          <p:cNvPicPr>
            <a:picLocks noChangeAspect="1"/>
          </p:cNvPicPr>
          <p:nvPr/>
        </p:nvPicPr>
        <p:blipFill>
          <a:blip r:embed="rId3"/>
          <a:stretch>
            <a:fillRect/>
          </a:stretch>
        </p:blipFill>
        <p:spPr>
          <a:xfrm>
            <a:off x="204245" y="1858709"/>
            <a:ext cx="7162800" cy="4495800"/>
          </a:xfrm>
          <a:prstGeom prst="rect">
            <a:avLst/>
          </a:prstGeom>
        </p:spPr>
      </p:pic>
      <p:pic>
        <p:nvPicPr>
          <p:cNvPr id="3" name="Picture 2" descr="Single lumen broviac.jpg">
            <a:extLst>
              <a:ext uri="{FF2B5EF4-FFF2-40B4-BE49-F238E27FC236}">
                <a16:creationId xmlns:a16="http://schemas.microsoft.com/office/drawing/2014/main" id="{B4A33C0E-7390-E692-37EE-19AC15474356}"/>
              </a:ext>
            </a:extLst>
          </p:cNvPr>
          <p:cNvPicPr>
            <a:picLocks noChangeAspect="1"/>
          </p:cNvPicPr>
          <p:nvPr/>
        </p:nvPicPr>
        <p:blipFill>
          <a:blip r:embed="rId4"/>
          <a:stretch>
            <a:fillRect/>
          </a:stretch>
        </p:blipFill>
        <p:spPr>
          <a:xfrm>
            <a:off x="7490577" y="1023790"/>
            <a:ext cx="4412896" cy="2501546"/>
          </a:xfrm>
          <a:prstGeom prst="rect">
            <a:avLst/>
          </a:prstGeom>
        </p:spPr>
      </p:pic>
      <p:sp>
        <p:nvSpPr>
          <p:cNvPr id="5" name="Title 1">
            <a:extLst>
              <a:ext uri="{FF2B5EF4-FFF2-40B4-BE49-F238E27FC236}">
                <a16:creationId xmlns:a16="http://schemas.microsoft.com/office/drawing/2014/main" id="{CF55DD2B-1D61-55B2-AC08-E7AAC805145C}"/>
              </a:ext>
            </a:extLst>
          </p:cNvPr>
          <p:cNvSpPr txBox="1">
            <a:spLocks/>
          </p:cNvSpPr>
          <p:nvPr/>
        </p:nvSpPr>
        <p:spPr>
          <a:xfrm>
            <a:off x="1348666" y="379921"/>
            <a:ext cx="10515600" cy="1325563"/>
          </a:xfrm>
          <a:prstGeom prst="rect">
            <a:avLst/>
          </a:prstGeom>
        </p:spPr>
        <p:txBody>
          <a:bodyPr lIns="91440" tIns="45720" rIns="91440" bIns="45720" anchor="t"/>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a:t>Tunneled central lines: </a:t>
            </a:r>
          </a:p>
        </p:txBody>
      </p:sp>
      <p:sp>
        <p:nvSpPr>
          <p:cNvPr id="6" name="TextBox 5">
            <a:extLst>
              <a:ext uri="{FF2B5EF4-FFF2-40B4-BE49-F238E27FC236}">
                <a16:creationId xmlns:a16="http://schemas.microsoft.com/office/drawing/2014/main" id="{68292658-3663-6BA4-20A7-448B238A1793}"/>
              </a:ext>
            </a:extLst>
          </p:cNvPr>
          <p:cNvSpPr txBox="1"/>
          <p:nvPr/>
        </p:nvSpPr>
        <p:spPr>
          <a:xfrm>
            <a:off x="7492893" y="4110869"/>
            <a:ext cx="4406806" cy="2523768"/>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marL="457200" indent="-457200">
              <a:buFont typeface="Arial"/>
              <a:buChar char="•"/>
            </a:pPr>
            <a:r>
              <a:rPr lang="en-US" sz="2800" dirty="0"/>
              <a:t>Most common</a:t>
            </a:r>
            <a:endParaRPr lang="en-US" dirty="0"/>
          </a:p>
          <a:p>
            <a:pPr marL="457200" indent="-457200">
              <a:buFont typeface="Arial"/>
              <a:buChar char="•"/>
            </a:pPr>
            <a:r>
              <a:rPr lang="en-US" sz="2800" dirty="0"/>
              <a:t>Stable and secure </a:t>
            </a:r>
            <a:endParaRPr lang="en-US" dirty="0"/>
          </a:p>
          <a:p>
            <a:pPr marL="457200" indent="-457200">
              <a:buFont typeface="Arial"/>
              <a:buChar char="•"/>
            </a:pPr>
            <a:r>
              <a:rPr lang="en-US" sz="2800" dirty="0"/>
              <a:t>Longevity</a:t>
            </a:r>
            <a:endParaRPr lang="en-US" dirty="0"/>
          </a:p>
          <a:p>
            <a:pPr marL="457200" indent="-457200">
              <a:buFont typeface="Arial"/>
              <a:buChar char="•"/>
            </a:pPr>
            <a:r>
              <a:rPr lang="en-US" sz="2800" dirty="0"/>
              <a:t>Cuff reduces tunneled </a:t>
            </a:r>
            <a:r>
              <a:rPr lang="en-US" sz="2800"/>
              <a:t>infection</a:t>
            </a:r>
            <a:endParaRPr lang="en-US" dirty="0"/>
          </a:p>
          <a:p>
            <a:pPr algn="l"/>
            <a:endParaRPr lang="en-US" dirty="0"/>
          </a:p>
        </p:txBody>
      </p:sp>
    </p:spTree>
    <p:extLst>
      <p:ext uri="{BB962C8B-B14F-4D97-AF65-F5344CB8AC3E}">
        <p14:creationId xmlns:p14="http://schemas.microsoft.com/office/powerpoint/2010/main" val="140396786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Mediport.jpg">
            <a:extLst>
              <a:ext uri="{FF2B5EF4-FFF2-40B4-BE49-F238E27FC236}">
                <a16:creationId xmlns:a16="http://schemas.microsoft.com/office/drawing/2014/main" id="{B5C40716-89A1-2BD6-41B0-BC4107CF793A}"/>
              </a:ext>
            </a:extLst>
          </p:cNvPr>
          <p:cNvPicPr>
            <a:picLocks noChangeAspect="1"/>
          </p:cNvPicPr>
          <p:nvPr/>
        </p:nvPicPr>
        <p:blipFill>
          <a:blip r:embed="rId2"/>
          <a:stretch>
            <a:fillRect/>
          </a:stretch>
        </p:blipFill>
        <p:spPr>
          <a:xfrm>
            <a:off x="379314" y="1534697"/>
            <a:ext cx="5715000" cy="4791075"/>
          </a:xfrm>
          <a:prstGeom prst="rect">
            <a:avLst/>
          </a:prstGeom>
        </p:spPr>
      </p:pic>
      <p:pic>
        <p:nvPicPr>
          <p:cNvPr id="3" name="Picture 2" descr="portacath.jpg">
            <a:extLst>
              <a:ext uri="{FF2B5EF4-FFF2-40B4-BE49-F238E27FC236}">
                <a16:creationId xmlns:a16="http://schemas.microsoft.com/office/drawing/2014/main" id="{591ED0AC-85B4-D879-E23B-E76699C1BBEC}"/>
              </a:ext>
            </a:extLst>
          </p:cNvPr>
          <p:cNvPicPr>
            <a:picLocks noChangeAspect="1"/>
          </p:cNvPicPr>
          <p:nvPr/>
        </p:nvPicPr>
        <p:blipFill>
          <a:blip r:embed="rId3"/>
          <a:stretch>
            <a:fillRect/>
          </a:stretch>
        </p:blipFill>
        <p:spPr>
          <a:xfrm>
            <a:off x="6834996" y="1149875"/>
            <a:ext cx="4779079" cy="2597149"/>
          </a:xfrm>
          <a:prstGeom prst="rect">
            <a:avLst/>
          </a:prstGeom>
        </p:spPr>
      </p:pic>
      <p:sp>
        <p:nvSpPr>
          <p:cNvPr id="5" name="Title 1">
            <a:extLst>
              <a:ext uri="{FF2B5EF4-FFF2-40B4-BE49-F238E27FC236}">
                <a16:creationId xmlns:a16="http://schemas.microsoft.com/office/drawing/2014/main" id="{CC5422EA-4B02-0034-7C27-306656668FB0}"/>
              </a:ext>
            </a:extLst>
          </p:cNvPr>
          <p:cNvSpPr txBox="1">
            <a:spLocks/>
          </p:cNvSpPr>
          <p:nvPr/>
        </p:nvSpPr>
        <p:spPr>
          <a:xfrm>
            <a:off x="1348666" y="379921"/>
            <a:ext cx="10515600" cy="1325563"/>
          </a:xfrm>
          <a:prstGeom prst="rect">
            <a:avLst/>
          </a:prstGeom>
        </p:spPr>
        <p:txBody>
          <a:bodyPr lIns="91440" tIns="45720" rIns="91440" bIns="45720" anchor="t"/>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a:t>Port: </a:t>
            </a:r>
          </a:p>
        </p:txBody>
      </p:sp>
      <p:sp>
        <p:nvSpPr>
          <p:cNvPr id="6" name="TextBox 5">
            <a:extLst>
              <a:ext uri="{FF2B5EF4-FFF2-40B4-BE49-F238E27FC236}">
                <a16:creationId xmlns:a16="http://schemas.microsoft.com/office/drawing/2014/main" id="{C63AC20E-7038-E80A-DE5C-D04C25D8B883}"/>
              </a:ext>
            </a:extLst>
          </p:cNvPr>
          <p:cNvSpPr txBox="1"/>
          <p:nvPr/>
        </p:nvSpPr>
        <p:spPr>
          <a:xfrm>
            <a:off x="6497527" y="4184816"/>
            <a:ext cx="5117228" cy="2246769"/>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marL="457200" indent="-457200">
              <a:buFont typeface="Arial"/>
              <a:buChar char="•"/>
            </a:pPr>
            <a:r>
              <a:rPr lang="en-US" sz="2800" dirty="0"/>
              <a:t>Requires needle stick to </a:t>
            </a:r>
            <a:r>
              <a:rPr lang="en-US" sz="2800"/>
              <a:t>access port</a:t>
            </a:r>
            <a:endParaRPr lang="en-US"/>
          </a:p>
          <a:p>
            <a:pPr marL="457200" indent="-457200">
              <a:buFont typeface="Arial"/>
              <a:buChar char="•"/>
            </a:pPr>
            <a:r>
              <a:rPr lang="en-US" sz="2800"/>
              <a:t>Lower infection risk: usually infrequent access and line under the skin</a:t>
            </a:r>
            <a:endParaRPr lang="en-US" dirty="0"/>
          </a:p>
        </p:txBody>
      </p:sp>
    </p:spTree>
    <p:extLst>
      <p:ext uri="{BB962C8B-B14F-4D97-AF65-F5344CB8AC3E}">
        <p14:creationId xmlns:p14="http://schemas.microsoft.com/office/powerpoint/2010/main" val="1981928479"/>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5AF5F66F-7F30-C7FD-12D8-EE5A388FDE96}"/>
              </a:ext>
            </a:extLst>
          </p:cNvPr>
          <p:cNvGraphicFramePr>
            <a:graphicFrameLocks noGrp="1"/>
          </p:cNvGraphicFramePr>
          <p:nvPr>
            <p:extLst>
              <p:ext uri="{D42A27DB-BD31-4B8C-83A1-F6EECF244321}">
                <p14:modId xmlns:p14="http://schemas.microsoft.com/office/powerpoint/2010/main" val="3128048441"/>
              </p:ext>
            </p:extLst>
          </p:nvPr>
        </p:nvGraphicFramePr>
        <p:xfrm>
          <a:off x="893021" y="610179"/>
          <a:ext cx="10407471" cy="5793643"/>
        </p:xfrm>
        <a:graphic>
          <a:graphicData uri="http://schemas.openxmlformats.org/drawingml/2006/table">
            <a:tbl>
              <a:tblPr firstRow="1" bandRow="1">
                <a:tableStyleId>{5C22544A-7EE6-4342-B048-85BDC9FD1C3A}</a:tableStyleId>
              </a:tblPr>
              <a:tblGrid>
                <a:gridCol w="3469157">
                  <a:extLst>
                    <a:ext uri="{9D8B030D-6E8A-4147-A177-3AD203B41FA5}">
                      <a16:colId xmlns:a16="http://schemas.microsoft.com/office/drawing/2014/main" val="1309471451"/>
                    </a:ext>
                  </a:extLst>
                </a:gridCol>
                <a:gridCol w="3469157">
                  <a:extLst>
                    <a:ext uri="{9D8B030D-6E8A-4147-A177-3AD203B41FA5}">
                      <a16:colId xmlns:a16="http://schemas.microsoft.com/office/drawing/2014/main" val="2955988588"/>
                    </a:ext>
                  </a:extLst>
                </a:gridCol>
                <a:gridCol w="3469157">
                  <a:extLst>
                    <a:ext uri="{9D8B030D-6E8A-4147-A177-3AD203B41FA5}">
                      <a16:colId xmlns:a16="http://schemas.microsoft.com/office/drawing/2014/main" val="2743344192"/>
                    </a:ext>
                  </a:extLst>
                </a:gridCol>
              </a:tblGrid>
              <a:tr h="849249">
                <a:tc>
                  <a:txBody>
                    <a:bodyPr/>
                    <a:lstStyle/>
                    <a:p>
                      <a:endParaRPr lang="en-US"/>
                    </a:p>
                  </a:txBody>
                  <a:tcPr/>
                </a:tc>
                <a:tc>
                  <a:txBody>
                    <a:bodyPr/>
                    <a:lstStyle/>
                    <a:p>
                      <a:pPr algn="ctr"/>
                      <a:r>
                        <a:rPr lang="en-US" sz="2000" dirty="0"/>
                        <a:t>Advantages</a:t>
                      </a:r>
                    </a:p>
                  </a:txBody>
                  <a:tcPr anchor="ctr"/>
                </a:tc>
                <a:tc>
                  <a:txBody>
                    <a:bodyPr/>
                    <a:lstStyle/>
                    <a:p>
                      <a:pPr algn="ctr"/>
                      <a:r>
                        <a:rPr lang="en-US" sz="2000" dirty="0"/>
                        <a:t>Disadvantages</a:t>
                      </a:r>
                    </a:p>
                  </a:txBody>
                  <a:tcPr anchor="ctr"/>
                </a:tc>
                <a:extLst>
                  <a:ext uri="{0D108BD9-81ED-4DB2-BD59-A6C34878D82A}">
                    <a16:rowId xmlns:a16="http://schemas.microsoft.com/office/drawing/2014/main" val="3672909898"/>
                  </a:ext>
                </a:extLst>
              </a:tr>
              <a:tr h="1512077">
                <a:tc>
                  <a:txBody>
                    <a:bodyPr/>
                    <a:lstStyle/>
                    <a:p>
                      <a:r>
                        <a:rPr lang="en-US" sz="2400" dirty="0"/>
                        <a:t>PICC</a:t>
                      </a:r>
                    </a:p>
                  </a:txBody>
                  <a:tcPr/>
                </a:tc>
                <a:tc>
                  <a:txBody>
                    <a:bodyPr/>
                    <a:lstStyle/>
                    <a:p>
                      <a:pPr marL="285750" indent="-285750">
                        <a:buFont typeface="Wingdings"/>
                        <a:buChar char="Ø"/>
                      </a:pPr>
                      <a:r>
                        <a:rPr lang="en-US" sz="2000" dirty="0"/>
                        <a:t>No sedation required for insertion or removal </a:t>
                      </a:r>
                    </a:p>
                  </a:txBody>
                  <a:tcPr/>
                </a:tc>
                <a:tc>
                  <a:txBody>
                    <a:bodyPr/>
                    <a:lstStyle/>
                    <a:p>
                      <a:pPr marL="285750" indent="-285750">
                        <a:buFont typeface="Wingdings"/>
                        <a:buChar char="Ø"/>
                      </a:pPr>
                      <a:r>
                        <a:rPr lang="en-US" sz="2000" dirty="0"/>
                        <a:t>For short term</a:t>
                      </a:r>
                    </a:p>
                    <a:p>
                      <a:pPr marL="285750" lvl="0" indent="-285750">
                        <a:buFont typeface="Wingdings"/>
                        <a:buChar char="Ø"/>
                      </a:pPr>
                      <a:r>
                        <a:rPr lang="en-US" sz="2000" dirty="0"/>
                        <a:t>Higher risk for line breakage, thrombosis, infection/ phlebitis</a:t>
                      </a:r>
                    </a:p>
                  </a:txBody>
                  <a:tcPr/>
                </a:tc>
                <a:extLst>
                  <a:ext uri="{0D108BD9-81ED-4DB2-BD59-A6C34878D82A}">
                    <a16:rowId xmlns:a16="http://schemas.microsoft.com/office/drawing/2014/main" val="2476716532"/>
                  </a:ext>
                </a:extLst>
              </a:tr>
              <a:tr h="1512077">
                <a:tc>
                  <a:txBody>
                    <a:bodyPr/>
                    <a:lstStyle/>
                    <a:p>
                      <a:r>
                        <a:rPr lang="en-US" sz="2400" dirty="0"/>
                        <a:t>Broviac</a:t>
                      </a:r>
                    </a:p>
                  </a:txBody>
                  <a:tcPr/>
                </a:tc>
                <a:tc>
                  <a:txBody>
                    <a:bodyPr/>
                    <a:lstStyle/>
                    <a:p>
                      <a:pPr marL="285750" indent="-285750">
                        <a:buFont typeface="Wingdings"/>
                        <a:buChar char="Ø"/>
                      </a:pPr>
                      <a:r>
                        <a:rPr lang="en-US" sz="2000" dirty="0"/>
                        <a:t>Stable and secure </a:t>
                      </a:r>
                    </a:p>
                    <a:p>
                      <a:pPr marL="285750" lvl="0" indent="-285750">
                        <a:buFont typeface="Wingdings"/>
                        <a:buChar char="Ø"/>
                      </a:pPr>
                      <a:r>
                        <a:rPr lang="en-US" sz="2000" dirty="0"/>
                        <a:t>Reduced tunneled infection with cuffed line</a:t>
                      </a:r>
                    </a:p>
                  </a:txBody>
                  <a:tcPr/>
                </a:tc>
                <a:tc>
                  <a:txBody>
                    <a:bodyPr/>
                    <a:lstStyle/>
                    <a:p>
                      <a:pPr marL="285750" indent="-285750">
                        <a:buFont typeface="Wingdings"/>
                        <a:buChar char="Ø"/>
                      </a:pPr>
                      <a:r>
                        <a:rPr lang="en-US" sz="2000" dirty="0"/>
                        <a:t>Sedation required for insertion and removal </a:t>
                      </a:r>
                    </a:p>
                  </a:txBody>
                  <a:tcPr/>
                </a:tc>
                <a:extLst>
                  <a:ext uri="{0D108BD9-81ED-4DB2-BD59-A6C34878D82A}">
                    <a16:rowId xmlns:a16="http://schemas.microsoft.com/office/drawing/2014/main" val="3147139963"/>
                  </a:ext>
                </a:extLst>
              </a:tr>
              <a:tr h="1760634">
                <a:tc>
                  <a:txBody>
                    <a:bodyPr/>
                    <a:lstStyle/>
                    <a:p>
                      <a:r>
                        <a:rPr lang="en-US" sz="2400" dirty="0"/>
                        <a:t>Port</a:t>
                      </a:r>
                    </a:p>
                  </a:txBody>
                  <a:tcPr/>
                </a:tc>
                <a:tc>
                  <a:txBody>
                    <a:bodyPr/>
                    <a:lstStyle/>
                    <a:p>
                      <a:pPr marL="285750" indent="-285750">
                        <a:buFont typeface="Wingdings"/>
                        <a:buChar char="Ø"/>
                      </a:pPr>
                      <a:r>
                        <a:rPr lang="en-US" sz="2000" dirty="0"/>
                        <a:t>Secure</a:t>
                      </a:r>
                    </a:p>
                    <a:p>
                      <a:pPr marL="285750" lvl="0" indent="-285750">
                        <a:buFont typeface="Wingdings"/>
                        <a:buChar char="Ø"/>
                      </a:pPr>
                      <a:r>
                        <a:rPr lang="en-US" sz="2000" dirty="0"/>
                        <a:t>Decreased risk for infection (under skin)</a:t>
                      </a:r>
                    </a:p>
                    <a:p>
                      <a:pPr marL="285750" lvl="0" indent="-285750">
                        <a:buFont typeface="Wingdings"/>
                        <a:buChar char="Ø"/>
                      </a:pPr>
                      <a:r>
                        <a:rPr lang="en-US" sz="2000" dirty="0"/>
                        <a:t>Can be submerged in water </a:t>
                      </a:r>
                    </a:p>
                  </a:txBody>
                  <a:tcPr/>
                </a:tc>
                <a:tc>
                  <a:txBody>
                    <a:bodyPr/>
                    <a:lstStyle/>
                    <a:p>
                      <a:pPr marL="285750" lvl="0" indent="-285750">
                        <a:buFont typeface="Wingdings"/>
                        <a:buChar char="Ø"/>
                      </a:pPr>
                      <a:r>
                        <a:rPr lang="en-US" sz="2000" b="0" i="0" u="none" strike="noStrike" noProof="0" dirty="0">
                          <a:solidFill>
                            <a:srgbClr val="000000"/>
                          </a:solidFill>
                          <a:latin typeface="Aptos"/>
                        </a:rPr>
                        <a:t>Sedation required for insertion and removal </a:t>
                      </a:r>
                    </a:p>
                    <a:p>
                      <a:pPr marL="285750" lvl="0" indent="-285750">
                        <a:buFont typeface="Wingdings"/>
                        <a:buChar char="Ø"/>
                      </a:pPr>
                      <a:r>
                        <a:rPr lang="en-US" sz="2000" b="0" i="0" u="none" strike="noStrike" noProof="0" dirty="0">
                          <a:solidFill>
                            <a:srgbClr val="000000"/>
                          </a:solidFill>
                          <a:latin typeface="Aptos"/>
                        </a:rPr>
                        <a:t>Needle stick required for access</a:t>
                      </a:r>
                    </a:p>
                    <a:p>
                      <a:pPr marL="285750" lvl="0" indent="-285750">
                        <a:buFont typeface="Wingdings"/>
                        <a:buChar char="Ø"/>
                      </a:pPr>
                      <a:r>
                        <a:rPr lang="en-US" sz="2000" b="0" i="0" u="none" strike="noStrike" noProof="0" dirty="0">
                          <a:solidFill>
                            <a:srgbClr val="000000"/>
                          </a:solidFill>
                          <a:latin typeface="Aptos"/>
                        </a:rPr>
                        <a:t>For infrequent use </a:t>
                      </a:r>
                    </a:p>
                    <a:p>
                      <a:pPr marL="0" lvl="0" indent="0">
                        <a:buNone/>
                      </a:pPr>
                      <a:endParaRPr lang="en-US" sz="2000" b="0" i="0" u="none" strike="noStrike" noProof="0" dirty="0">
                        <a:solidFill>
                          <a:srgbClr val="000000"/>
                        </a:solidFill>
                        <a:latin typeface="Aptos"/>
                      </a:endParaRPr>
                    </a:p>
                  </a:txBody>
                  <a:tcPr/>
                </a:tc>
                <a:extLst>
                  <a:ext uri="{0D108BD9-81ED-4DB2-BD59-A6C34878D82A}">
                    <a16:rowId xmlns:a16="http://schemas.microsoft.com/office/drawing/2014/main" val="2268450604"/>
                  </a:ext>
                </a:extLst>
              </a:tr>
            </a:tbl>
          </a:graphicData>
        </a:graphic>
      </p:graphicFrame>
    </p:spTree>
    <p:extLst>
      <p:ext uri="{BB962C8B-B14F-4D97-AF65-F5344CB8AC3E}">
        <p14:creationId xmlns:p14="http://schemas.microsoft.com/office/powerpoint/2010/main" val="1625999220"/>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92E322D-5432-20CD-FED8-415687922947}"/>
              </a:ext>
            </a:extLst>
          </p:cNvPr>
          <p:cNvSpPr>
            <a:spLocks noGrp="1"/>
          </p:cNvSpPr>
          <p:nvPr>
            <p:ph type="title"/>
          </p:nvPr>
        </p:nvSpPr>
        <p:spPr/>
        <p:txBody>
          <a:bodyPr/>
          <a:lstStyle/>
          <a:p>
            <a:r>
              <a:rPr lang="en-US"/>
              <a:t>CVC complications: </a:t>
            </a:r>
          </a:p>
        </p:txBody>
      </p:sp>
      <p:sp>
        <p:nvSpPr>
          <p:cNvPr id="3" name="Content Placeholder 2">
            <a:extLst>
              <a:ext uri="{FF2B5EF4-FFF2-40B4-BE49-F238E27FC236}">
                <a16:creationId xmlns:a16="http://schemas.microsoft.com/office/drawing/2014/main" id="{76CE0DDB-F694-7507-CAB6-43B4259BD94F}"/>
              </a:ext>
            </a:extLst>
          </p:cNvPr>
          <p:cNvSpPr>
            <a:spLocks noGrp="1"/>
          </p:cNvSpPr>
          <p:nvPr>
            <p:ph idx="1"/>
          </p:nvPr>
        </p:nvSpPr>
        <p:spPr/>
        <p:txBody>
          <a:bodyPr vert="horz" lIns="91440" tIns="45720" rIns="91440" bIns="45720" rtlCol="0" anchor="t">
            <a:normAutofit/>
          </a:bodyPr>
          <a:lstStyle/>
          <a:p>
            <a:r>
              <a:rPr lang="en-US" dirty="0"/>
              <a:t>Infections:  </a:t>
            </a:r>
          </a:p>
          <a:p>
            <a:pPr lvl="1">
              <a:buFont typeface="Courier New" panose="020B0604020202020204" pitchFamily="34" charset="0"/>
              <a:buChar char="o"/>
            </a:pPr>
            <a:r>
              <a:rPr lang="en-US" dirty="0"/>
              <a:t>Local infection (exit)</a:t>
            </a:r>
          </a:p>
          <a:p>
            <a:pPr lvl="1">
              <a:buFont typeface="Courier New" panose="020B0604020202020204" pitchFamily="34" charset="0"/>
              <a:buChar char="o"/>
            </a:pPr>
            <a:r>
              <a:rPr lang="en-US"/>
              <a:t>Tunneled/Track infection </a:t>
            </a:r>
          </a:p>
          <a:p>
            <a:pPr lvl="1">
              <a:buFont typeface="Courier New" panose="020B0604020202020204" pitchFamily="34" charset="0"/>
              <a:buChar char="o"/>
            </a:pPr>
            <a:r>
              <a:rPr lang="en-US" dirty="0"/>
              <a:t>Central Line Associated Blood Stream Infections (CLABSI) </a:t>
            </a:r>
          </a:p>
          <a:p>
            <a:r>
              <a:rPr lang="en-US" dirty="0"/>
              <a:t>Malposition/Dislodgement </a:t>
            </a:r>
          </a:p>
          <a:p>
            <a:r>
              <a:rPr lang="en-US" dirty="0"/>
              <a:t>Line dysfunction (breakage -&gt;leakage, occlusion)</a:t>
            </a:r>
          </a:p>
          <a:p>
            <a:r>
              <a:rPr lang="en-US" dirty="0"/>
              <a:t>Venous injury (stenosis, thrombosis) </a:t>
            </a:r>
            <a:endParaRPr lang="en-US" dirty="0">
              <a:highlight>
                <a:srgbClr val="FFFF00"/>
              </a:highlight>
            </a:endParaRPr>
          </a:p>
        </p:txBody>
      </p:sp>
      <p:sp>
        <p:nvSpPr>
          <p:cNvPr id="4" name="TextBox 3">
            <a:extLst>
              <a:ext uri="{FF2B5EF4-FFF2-40B4-BE49-F238E27FC236}">
                <a16:creationId xmlns:a16="http://schemas.microsoft.com/office/drawing/2014/main" id="{DD10D27F-5D79-A7D9-F80A-6BEDF78417AC}"/>
              </a:ext>
            </a:extLst>
          </p:cNvPr>
          <p:cNvSpPr txBox="1"/>
          <p:nvPr/>
        </p:nvSpPr>
        <p:spPr>
          <a:xfrm>
            <a:off x="744582" y="5556178"/>
            <a:ext cx="10609263" cy="1231106"/>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2800">
                <a:ea typeface="+mn-lt"/>
                <a:cs typeface="+mn-lt"/>
              </a:rPr>
              <a:t>Complications can lead to repeated vascular interventions and loss of access, which can predispose to requiring intestinal transplant. </a:t>
            </a:r>
            <a:endParaRPr lang="en-US" sz="2800"/>
          </a:p>
          <a:p>
            <a:pPr algn="l"/>
            <a:endParaRPr lang="en-US" dirty="0"/>
          </a:p>
        </p:txBody>
      </p:sp>
    </p:spTree>
    <p:extLst>
      <p:ext uri="{BB962C8B-B14F-4D97-AF65-F5344CB8AC3E}">
        <p14:creationId xmlns:p14="http://schemas.microsoft.com/office/powerpoint/2010/main" val="150072134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grpId="0" nodeType="clickEffect">
                                  <p:stCondLst>
                                    <p:cond delay="0"/>
                                  </p:stCondLst>
                                  <p:childTnLst>
                                    <p:set>
                                      <p:cBhvr>
                                        <p:cTn id="24"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grpId="0" nodeType="clickEffect">
                                  <p:stCondLst>
                                    <p:cond delay="0"/>
                                  </p:stCondLst>
                                  <p:childTnLst>
                                    <p:set>
                                      <p:cBhvr>
                                        <p:cTn id="28" dur="1" fill="hold">
                                          <p:stCondLst>
                                            <p:cond delay="0"/>
                                          </p:stCondLst>
                                        </p:cTn>
                                        <p:tgtEl>
                                          <p:spTgt spid="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P spid="4" grpId="0"/>
    </p:bld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156F3B4-A8E7-4038-457E-13DE0860033B}"/>
              </a:ext>
            </a:extLst>
          </p:cNvPr>
          <p:cNvSpPr>
            <a:spLocks noGrp="1"/>
          </p:cNvSpPr>
          <p:nvPr>
            <p:ph type="title"/>
          </p:nvPr>
        </p:nvSpPr>
        <p:spPr/>
        <p:txBody>
          <a:bodyPr/>
          <a:lstStyle/>
          <a:p>
            <a:r>
              <a:rPr lang="en-US" dirty="0"/>
              <a:t>Local Infection</a:t>
            </a:r>
          </a:p>
        </p:txBody>
      </p:sp>
      <p:pic>
        <p:nvPicPr>
          <p:cNvPr id="4" name="Content Placeholder 3" descr="A close up of a tube&#10;&#10;Description automatically generated">
            <a:extLst>
              <a:ext uri="{FF2B5EF4-FFF2-40B4-BE49-F238E27FC236}">
                <a16:creationId xmlns:a16="http://schemas.microsoft.com/office/drawing/2014/main" id="{6C8C619F-E4D2-6D36-A67E-0F3BB7B8FEF2}"/>
              </a:ext>
            </a:extLst>
          </p:cNvPr>
          <p:cNvPicPr>
            <a:picLocks noGrp="1" noChangeAspect="1"/>
          </p:cNvPicPr>
          <p:nvPr>
            <p:ph idx="1"/>
          </p:nvPr>
        </p:nvPicPr>
        <p:blipFill>
          <a:blip r:embed="rId3"/>
          <a:stretch>
            <a:fillRect/>
          </a:stretch>
        </p:blipFill>
        <p:spPr>
          <a:xfrm>
            <a:off x="1006686" y="1874359"/>
            <a:ext cx="2443609" cy="4351338"/>
          </a:xfrm>
        </p:spPr>
      </p:pic>
      <p:sp>
        <p:nvSpPr>
          <p:cNvPr id="5" name="TextBox 4">
            <a:extLst>
              <a:ext uri="{FF2B5EF4-FFF2-40B4-BE49-F238E27FC236}">
                <a16:creationId xmlns:a16="http://schemas.microsoft.com/office/drawing/2014/main" id="{A92B86F5-FF6F-56F7-A149-E75340027B3E}"/>
              </a:ext>
            </a:extLst>
          </p:cNvPr>
          <p:cNvSpPr txBox="1"/>
          <p:nvPr/>
        </p:nvSpPr>
        <p:spPr>
          <a:xfrm>
            <a:off x="3743970" y="1869724"/>
            <a:ext cx="8314848" cy="3970318"/>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2800" dirty="0">
                <a:ea typeface="+mn-lt"/>
                <a:cs typeface="+mn-lt"/>
              </a:rPr>
              <a:t>For localized area of discharge or suspected skin infection:</a:t>
            </a:r>
          </a:p>
          <a:p>
            <a:pPr marL="457200" indent="-457200">
              <a:buFont typeface="Arial"/>
              <a:buChar char="•"/>
            </a:pPr>
            <a:r>
              <a:rPr lang="en-US" sz="2800" dirty="0">
                <a:ea typeface="+mn-lt"/>
                <a:cs typeface="+mn-lt"/>
              </a:rPr>
              <a:t>Culture the site</a:t>
            </a:r>
          </a:p>
          <a:p>
            <a:pPr marL="457200" indent="-457200">
              <a:buFont typeface="Arial"/>
              <a:buChar char="•"/>
            </a:pPr>
            <a:r>
              <a:rPr lang="en-US" sz="2800" dirty="0">
                <a:ea typeface="+mn-lt"/>
                <a:cs typeface="+mn-lt"/>
              </a:rPr>
              <a:t>May consider limited use antibiotic ointment  </a:t>
            </a:r>
          </a:p>
          <a:p>
            <a:pPr marL="457200" indent="-457200">
              <a:buFont typeface="Arial"/>
              <a:buChar char="•"/>
            </a:pPr>
            <a:r>
              <a:rPr lang="en-US" sz="2800" dirty="0">
                <a:ea typeface="+mn-lt"/>
                <a:cs typeface="+mn-lt"/>
              </a:rPr>
              <a:t>Daily dressing changes (gauze dressings to prevent moisture)</a:t>
            </a:r>
          </a:p>
          <a:p>
            <a:pPr marL="457200" indent="-457200">
              <a:buFont typeface="Arial"/>
              <a:buChar char="•"/>
            </a:pPr>
            <a:r>
              <a:rPr lang="en-US" sz="2800" dirty="0">
                <a:ea typeface="+mn-lt"/>
                <a:cs typeface="+mn-lt"/>
              </a:rPr>
              <a:t>If the suspected infection worsens or does not respond to topical treatments intravenous antibiotics must be considered</a:t>
            </a:r>
            <a:endParaRPr lang="en-US" sz="2800" dirty="0"/>
          </a:p>
        </p:txBody>
      </p:sp>
    </p:spTree>
    <p:extLst>
      <p:ext uri="{BB962C8B-B14F-4D97-AF65-F5344CB8AC3E}">
        <p14:creationId xmlns:p14="http://schemas.microsoft.com/office/powerpoint/2010/main" val="3765036932"/>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037B1A6-5DAA-0569-3233-BA14B35AED7B}"/>
              </a:ext>
            </a:extLst>
          </p:cNvPr>
          <p:cNvSpPr>
            <a:spLocks noGrp="1"/>
          </p:cNvSpPr>
          <p:nvPr>
            <p:ph type="title"/>
          </p:nvPr>
        </p:nvSpPr>
        <p:spPr/>
        <p:txBody>
          <a:bodyPr/>
          <a:lstStyle/>
          <a:p>
            <a:r>
              <a:rPr lang="en-US" dirty="0"/>
              <a:t>Local Infection Prevention</a:t>
            </a:r>
          </a:p>
        </p:txBody>
      </p:sp>
      <p:sp>
        <p:nvSpPr>
          <p:cNvPr id="3" name="Content Placeholder 2">
            <a:extLst>
              <a:ext uri="{FF2B5EF4-FFF2-40B4-BE49-F238E27FC236}">
                <a16:creationId xmlns:a16="http://schemas.microsoft.com/office/drawing/2014/main" id="{9AE938D2-B05F-4829-BA51-1B2B9A25680E}"/>
              </a:ext>
            </a:extLst>
          </p:cNvPr>
          <p:cNvSpPr>
            <a:spLocks noGrp="1"/>
          </p:cNvSpPr>
          <p:nvPr>
            <p:ph idx="1"/>
          </p:nvPr>
        </p:nvSpPr>
        <p:spPr/>
        <p:txBody>
          <a:bodyPr vert="horz" lIns="91440" tIns="45720" rIns="91440" bIns="45720" rtlCol="0" anchor="t">
            <a:normAutofit/>
          </a:bodyPr>
          <a:lstStyle/>
          <a:p>
            <a:r>
              <a:rPr lang="en-US" dirty="0">
                <a:ea typeface="+mn-lt"/>
                <a:cs typeface="+mn-lt"/>
              </a:rPr>
              <a:t>Chlorhexidine gluconate (CHG)–alcohol antiseptic solution for skin preparation</a:t>
            </a:r>
          </a:p>
          <a:p>
            <a:r>
              <a:rPr lang="en-US" dirty="0">
                <a:ea typeface="+mn-lt"/>
                <a:cs typeface="+mn-lt"/>
              </a:rPr>
              <a:t>CHG impregnated patches to reduce infection risk</a:t>
            </a:r>
          </a:p>
          <a:p>
            <a:r>
              <a:rPr lang="en-US" dirty="0">
                <a:ea typeface="+mn-lt"/>
                <a:cs typeface="+mn-lt"/>
              </a:rPr>
              <a:t>Change the dressing weekly </a:t>
            </a:r>
            <a:endParaRPr lang="en-US" dirty="0"/>
          </a:p>
          <a:p>
            <a:r>
              <a:rPr lang="en-US" dirty="0">
                <a:ea typeface="+mn-lt"/>
                <a:cs typeface="+mn-lt"/>
              </a:rPr>
              <a:t>Administration sets, including tubing, should be changed at least every 24 h in patients receiving lipids, but may be changed less frequently in patients not receiving lipids (every 3–4 days)</a:t>
            </a:r>
            <a:endParaRPr lang="en-US"/>
          </a:p>
          <a:p>
            <a:endParaRPr lang="en-US" dirty="0"/>
          </a:p>
          <a:p>
            <a:endParaRPr lang="en-US" dirty="0"/>
          </a:p>
        </p:txBody>
      </p:sp>
      <p:pic>
        <p:nvPicPr>
          <p:cNvPr id="4" name="Picture 3" descr="GNP ANTISEPTIC SKIN CLEANS LIQ 8 OZ chlorhexidine gluconate TOPICAL LIQUID  4 % | eBay">
            <a:extLst>
              <a:ext uri="{FF2B5EF4-FFF2-40B4-BE49-F238E27FC236}">
                <a16:creationId xmlns:a16="http://schemas.microsoft.com/office/drawing/2014/main" id="{F0C4D6B0-31BC-CC15-D9C8-1BDAC7F533F3}"/>
              </a:ext>
            </a:extLst>
          </p:cNvPr>
          <p:cNvPicPr>
            <a:picLocks noChangeAspect="1"/>
          </p:cNvPicPr>
          <p:nvPr/>
        </p:nvPicPr>
        <p:blipFill>
          <a:blip r:embed="rId2"/>
          <a:stretch>
            <a:fillRect/>
          </a:stretch>
        </p:blipFill>
        <p:spPr>
          <a:xfrm>
            <a:off x="10982618" y="928265"/>
            <a:ext cx="753150" cy="2101823"/>
          </a:xfrm>
          <a:prstGeom prst="rect">
            <a:avLst/>
          </a:prstGeom>
        </p:spPr>
      </p:pic>
      <p:pic>
        <p:nvPicPr>
          <p:cNvPr id="5" name="Picture 4" descr="Aegis Chg Disc - Medline">
            <a:extLst>
              <a:ext uri="{FF2B5EF4-FFF2-40B4-BE49-F238E27FC236}">
                <a16:creationId xmlns:a16="http://schemas.microsoft.com/office/drawing/2014/main" id="{D9102F3E-D968-C1EC-3C84-215E0AAEE767}"/>
              </a:ext>
            </a:extLst>
          </p:cNvPr>
          <p:cNvPicPr>
            <a:picLocks noChangeAspect="1"/>
          </p:cNvPicPr>
          <p:nvPr/>
        </p:nvPicPr>
        <p:blipFill>
          <a:blip r:embed="rId3"/>
          <a:stretch>
            <a:fillRect/>
          </a:stretch>
        </p:blipFill>
        <p:spPr>
          <a:xfrm>
            <a:off x="8904509" y="2319319"/>
            <a:ext cx="1557802" cy="1212794"/>
          </a:xfrm>
          <a:prstGeom prst="rect">
            <a:avLst/>
          </a:prstGeom>
        </p:spPr>
      </p:pic>
    </p:spTree>
    <p:extLst>
      <p:ext uri="{BB962C8B-B14F-4D97-AF65-F5344CB8AC3E}">
        <p14:creationId xmlns:p14="http://schemas.microsoft.com/office/powerpoint/2010/main" val="3004633114"/>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6F5A5072-7B47-4D32-B52A-4EBBF590B8A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w="12700" cap="flat" cmpd="sng" algn="ctr">
            <a:noFill/>
            <a:prstDash val="solid"/>
            <a:miter lim="800000"/>
          </a:ln>
          <a:effectLst/>
          <a:extLst>
            <a:ext uri="{91240B29-F687-4F45-9708-019B960494DF}">
              <a14:hiddenLine xmlns:a14="http://schemas.microsoft.com/office/drawing/2010/main" w="12700" cap="flat" cmpd="sng" algn="ctr">
                <a:solidFill>
                  <a:schemeClr val="accent1">
                    <a:shade val="50000"/>
                  </a:schemeClr>
                </a:solidFill>
                <a:prstDash val="solid"/>
                <a:miter lim="800000"/>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9715DAF0-AE1B-46C9-8A6B-DB2AA05AB91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0800000">
            <a:off x="-2" y="-22693"/>
            <a:ext cx="12191999" cy="4374129"/>
          </a:xfrm>
          <a:prstGeom prst="rect">
            <a:avLst/>
          </a:prstGeom>
          <a:gradFill>
            <a:gsLst>
              <a:gs pos="0">
                <a:schemeClr val="accent1">
                  <a:lumMod val="75000"/>
                </a:schemeClr>
              </a:gs>
              <a:gs pos="100000">
                <a:srgbClr val="000000"/>
              </a:gs>
            </a:gsLst>
            <a:lin ang="15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6016219D-510E-4184-9090-6D5578A87BD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3908719" y="-3931841"/>
            <a:ext cx="4374557" cy="12192000"/>
          </a:xfrm>
          <a:prstGeom prst="rect">
            <a:avLst/>
          </a:prstGeom>
          <a:gradFill>
            <a:gsLst>
              <a:gs pos="40000">
                <a:schemeClr val="accent1">
                  <a:alpha val="0"/>
                </a:schemeClr>
              </a:gs>
              <a:gs pos="100000">
                <a:schemeClr val="accent1">
                  <a:lumMod val="75000"/>
                  <a:alpha val="52000"/>
                </a:schemeClr>
              </a:gs>
            </a:gsLst>
            <a:lin ang="24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13">
            <a:extLst>
              <a:ext uri="{FF2B5EF4-FFF2-40B4-BE49-F238E27FC236}">
                <a16:creationId xmlns:a16="http://schemas.microsoft.com/office/drawing/2014/main" id="{AFF4A713-7B75-4B21-90D7-5AB19547C72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4136696" y="-3703868"/>
            <a:ext cx="4374128" cy="11736479"/>
          </a:xfrm>
          <a:prstGeom prst="rect">
            <a:avLst/>
          </a:prstGeom>
          <a:gradFill>
            <a:gsLst>
              <a:gs pos="17000">
                <a:schemeClr val="accent1">
                  <a:alpha val="0"/>
                </a:schemeClr>
              </a:gs>
              <a:gs pos="100000">
                <a:srgbClr val="000000">
                  <a:alpha val="37000"/>
                </a:srgbClr>
              </a:gs>
            </a:gsLst>
            <a:lin ang="7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ectangle 15">
            <a:extLst>
              <a:ext uri="{FF2B5EF4-FFF2-40B4-BE49-F238E27FC236}">
                <a16:creationId xmlns:a16="http://schemas.microsoft.com/office/drawing/2014/main" id="{DC631C0B-6DA6-4E57-8231-CE32B3434A7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 y="-22690"/>
            <a:ext cx="8542485" cy="4374126"/>
          </a:xfrm>
          <a:prstGeom prst="rect">
            <a:avLst/>
          </a:prstGeom>
          <a:gradFill>
            <a:gsLst>
              <a:gs pos="0">
                <a:schemeClr val="accent1">
                  <a:lumMod val="50000"/>
                  <a:alpha val="0"/>
                </a:schemeClr>
              </a:gs>
              <a:gs pos="100000">
                <a:srgbClr val="000000">
                  <a:alpha val="25000"/>
                </a:srgbClr>
              </a:gs>
            </a:gsLst>
            <a:lin ang="186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Freeform: Shape 17">
            <a:extLst>
              <a:ext uri="{FF2B5EF4-FFF2-40B4-BE49-F238E27FC236}">
                <a16:creationId xmlns:a16="http://schemas.microsoft.com/office/drawing/2014/main" id="{C29501E6-A978-4A61-9689-9085AF97A53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2508972">
            <a:off x="5945431" y="-1032053"/>
            <a:ext cx="4990147" cy="4439131"/>
          </a:xfrm>
          <a:custGeom>
            <a:avLst/>
            <a:gdLst>
              <a:gd name="connsiteX0" fmla="*/ 4990147 w 4990147"/>
              <a:gd name="connsiteY0" fmla="*/ 2229378 h 4439131"/>
              <a:gd name="connsiteX1" fmla="*/ 917384 w 4990147"/>
              <a:gd name="connsiteY1" fmla="*/ 4439131 h 4439131"/>
              <a:gd name="connsiteX2" fmla="*/ 910814 w 4990147"/>
              <a:gd name="connsiteY2" fmla="*/ 4434219 h 4439131"/>
              <a:gd name="connsiteX3" fmla="*/ 0 w 4990147"/>
              <a:gd name="connsiteY3" fmla="*/ 2502877 h 4439131"/>
              <a:gd name="connsiteX4" fmla="*/ 2502877 w 4990147"/>
              <a:gd name="connsiteY4" fmla="*/ 0 h 4439131"/>
              <a:gd name="connsiteX5" fmla="*/ 4954904 w 4990147"/>
              <a:gd name="connsiteY5" fmla="*/ 1998460 h 443913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4990147" h="4439131">
                <a:moveTo>
                  <a:pt x="4990147" y="2229378"/>
                </a:moveTo>
                <a:lnTo>
                  <a:pt x="917384" y="4439131"/>
                </a:lnTo>
                <a:lnTo>
                  <a:pt x="910814" y="4434219"/>
                </a:lnTo>
                <a:cubicBezTo>
                  <a:pt x="354557" y="3975154"/>
                  <a:pt x="0" y="3280421"/>
                  <a:pt x="0" y="2502877"/>
                </a:cubicBezTo>
                <a:cubicBezTo>
                  <a:pt x="0" y="1120576"/>
                  <a:pt x="1120576" y="0"/>
                  <a:pt x="2502877" y="0"/>
                </a:cubicBezTo>
                <a:cubicBezTo>
                  <a:pt x="3712390" y="0"/>
                  <a:pt x="4721520" y="857941"/>
                  <a:pt x="4954904" y="1998460"/>
                </a:cubicBezTo>
                <a:close/>
              </a:path>
            </a:pathLst>
          </a:custGeom>
          <a:gradFill>
            <a:gsLst>
              <a:gs pos="0">
                <a:schemeClr val="accent1">
                  <a:alpha val="22000"/>
                </a:schemeClr>
              </a:gs>
              <a:gs pos="87000">
                <a:schemeClr val="accent1">
                  <a:lumMod val="60000"/>
                  <a:lumOff val="40000"/>
                  <a:alpha val="2000"/>
                </a:schemeClr>
              </a:gs>
            </a:gsLst>
            <a:lin ang="84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p>
        </p:txBody>
      </p:sp>
      <p:sp>
        <p:nvSpPr>
          <p:cNvPr id="2" name="Title 1">
            <a:extLst>
              <a:ext uri="{FF2B5EF4-FFF2-40B4-BE49-F238E27FC236}">
                <a16:creationId xmlns:a16="http://schemas.microsoft.com/office/drawing/2014/main" id="{1E63AA7C-D8CC-24E2-1927-C63C14BF6FAB}"/>
              </a:ext>
            </a:extLst>
          </p:cNvPr>
          <p:cNvSpPr>
            <a:spLocks noGrp="1"/>
          </p:cNvSpPr>
          <p:nvPr>
            <p:ph type="title"/>
          </p:nvPr>
        </p:nvSpPr>
        <p:spPr>
          <a:xfrm>
            <a:off x="1314824" y="735106"/>
            <a:ext cx="10053763" cy="2928470"/>
          </a:xfrm>
        </p:spPr>
        <p:txBody>
          <a:bodyPr vert="horz" lIns="91440" tIns="45720" rIns="91440" bIns="45720" rtlCol="0" anchor="b">
            <a:normAutofit/>
          </a:bodyPr>
          <a:lstStyle/>
          <a:p>
            <a:r>
              <a:rPr lang="en-US" sz="4800" kern="1200">
                <a:solidFill>
                  <a:srgbClr val="FFFFFF"/>
                </a:solidFill>
                <a:latin typeface="+mj-lt"/>
                <a:ea typeface="+mj-ea"/>
                <a:cs typeface="+mj-cs"/>
              </a:rPr>
              <a:t>Case 1:</a:t>
            </a:r>
          </a:p>
        </p:txBody>
      </p:sp>
      <p:sp>
        <p:nvSpPr>
          <p:cNvPr id="3" name="Text Placeholder 2">
            <a:extLst>
              <a:ext uri="{FF2B5EF4-FFF2-40B4-BE49-F238E27FC236}">
                <a16:creationId xmlns:a16="http://schemas.microsoft.com/office/drawing/2014/main" id="{6B57145F-A3D4-5C8F-5BBE-CC4E7BC1E90B}"/>
              </a:ext>
            </a:extLst>
          </p:cNvPr>
          <p:cNvSpPr>
            <a:spLocks noGrp="1"/>
          </p:cNvSpPr>
          <p:nvPr>
            <p:ph type="body" idx="1"/>
          </p:nvPr>
        </p:nvSpPr>
        <p:spPr>
          <a:xfrm>
            <a:off x="689443" y="4870824"/>
            <a:ext cx="11498462" cy="1458258"/>
          </a:xfrm>
        </p:spPr>
        <p:txBody>
          <a:bodyPr vert="horz" lIns="91440" tIns="45720" rIns="91440" bIns="45720" rtlCol="0" anchor="ctr">
            <a:noAutofit/>
          </a:bodyPr>
          <a:lstStyle/>
          <a:p>
            <a:r>
              <a:rPr lang="en-US" sz="3600" kern="1200" dirty="0">
                <a:solidFill>
                  <a:schemeClr val="tx1"/>
                </a:solidFill>
                <a:latin typeface="+mn-lt"/>
                <a:ea typeface="+mn-ea"/>
                <a:cs typeface="+mn-cs"/>
              </a:rPr>
              <a:t>A 6-year-old boy with history of NEC, dependent on TPN, presents with fever, viral URI symptoms to the ED. </a:t>
            </a:r>
          </a:p>
        </p:txBody>
      </p:sp>
    </p:spTree>
    <p:extLst>
      <p:ext uri="{BB962C8B-B14F-4D97-AF65-F5344CB8AC3E}">
        <p14:creationId xmlns:p14="http://schemas.microsoft.com/office/powerpoint/2010/main" val="3864006159"/>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B33365C-6782-0662-DDB6-AA040DA89222}"/>
              </a:ext>
            </a:extLst>
          </p:cNvPr>
          <p:cNvSpPr>
            <a:spLocks noGrp="1"/>
          </p:cNvSpPr>
          <p:nvPr>
            <p:ph type="title"/>
          </p:nvPr>
        </p:nvSpPr>
        <p:spPr/>
        <p:txBody>
          <a:bodyPr/>
          <a:lstStyle/>
          <a:p>
            <a:r>
              <a:rPr lang="en-US" dirty="0"/>
              <a:t>CLABSI</a:t>
            </a:r>
          </a:p>
        </p:txBody>
      </p:sp>
      <p:sp>
        <p:nvSpPr>
          <p:cNvPr id="3" name="Content Placeholder 2">
            <a:extLst>
              <a:ext uri="{FF2B5EF4-FFF2-40B4-BE49-F238E27FC236}">
                <a16:creationId xmlns:a16="http://schemas.microsoft.com/office/drawing/2014/main" id="{54D52FF0-F483-CAD8-917A-930506D4F12A}"/>
              </a:ext>
            </a:extLst>
          </p:cNvPr>
          <p:cNvSpPr>
            <a:spLocks noGrp="1"/>
          </p:cNvSpPr>
          <p:nvPr>
            <p:ph idx="1"/>
          </p:nvPr>
        </p:nvSpPr>
        <p:spPr>
          <a:xfrm>
            <a:off x="838200" y="1615523"/>
            <a:ext cx="10772898" cy="4876685"/>
          </a:xfrm>
        </p:spPr>
        <p:txBody>
          <a:bodyPr vert="horz" lIns="91440" tIns="45720" rIns="91440" bIns="45720" rtlCol="0" anchor="t">
            <a:normAutofit/>
          </a:bodyPr>
          <a:lstStyle/>
          <a:p>
            <a:r>
              <a:rPr lang="en-US" dirty="0">
                <a:ea typeface="+mn-lt"/>
                <a:cs typeface="+mn-lt"/>
              </a:rPr>
              <a:t>Fever (temperature  100.48 F / 38.0 C) + central line with variable clinical appearance = </a:t>
            </a:r>
            <a:r>
              <a:rPr lang="en-US" dirty="0">
                <a:solidFill>
                  <a:srgbClr val="FF0000"/>
                </a:solidFill>
                <a:ea typeface="+mn-lt"/>
                <a:cs typeface="+mn-lt"/>
              </a:rPr>
              <a:t>CLABSI rule out </a:t>
            </a:r>
            <a:r>
              <a:rPr lang="en-US" i="1" u="sng">
                <a:ea typeface="+mn-lt"/>
                <a:cs typeface="+mn-lt"/>
              </a:rPr>
              <a:t>(or not his normal self)</a:t>
            </a:r>
          </a:p>
          <a:p>
            <a:r>
              <a:rPr lang="en-US" dirty="0">
                <a:solidFill>
                  <a:srgbClr val="000000"/>
                </a:solidFill>
                <a:ea typeface="+mn-lt"/>
                <a:cs typeface="+mn-lt"/>
              </a:rPr>
              <a:t>Obtain</a:t>
            </a:r>
            <a:r>
              <a:rPr lang="en-US" dirty="0">
                <a:ea typeface="+mn-lt"/>
                <a:cs typeface="+mn-lt"/>
              </a:rPr>
              <a:t> blood cultures of </a:t>
            </a:r>
            <a:r>
              <a:rPr lang="en-US" b="1" u="sng" dirty="0">
                <a:ea typeface="+mn-lt"/>
                <a:cs typeface="+mn-lt"/>
              </a:rPr>
              <a:t>all </a:t>
            </a:r>
            <a:r>
              <a:rPr lang="en-US" dirty="0">
                <a:ea typeface="+mn-lt"/>
                <a:cs typeface="+mn-lt"/>
              </a:rPr>
              <a:t>lumens of the CVC </a:t>
            </a:r>
            <a:r>
              <a:rPr lang="en-US" b="1" u="sng" dirty="0">
                <a:ea typeface="+mn-lt"/>
                <a:cs typeface="+mn-lt"/>
              </a:rPr>
              <a:t>with peripheral culture</a:t>
            </a:r>
            <a:r>
              <a:rPr lang="en-US" b="1" dirty="0">
                <a:ea typeface="+mn-lt"/>
                <a:cs typeface="+mn-lt"/>
              </a:rPr>
              <a:t> </a:t>
            </a:r>
            <a:r>
              <a:rPr lang="en-US" i="1" dirty="0">
                <a:ea typeface="+mn-lt"/>
                <a:cs typeface="+mn-lt"/>
              </a:rPr>
              <a:t>(order set available)</a:t>
            </a:r>
            <a:endParaRPr lang="en-US" i="1"/>
          </a:p>
          <a:p>
            <a:r>
              <a:rPr lang="en-US" dirty="0">
                <a:ea typeface="+mn-lt"/>
                <a:cs typeface="+mn-lt"/>
              </a:rPr>
              <a:t>Diagnosis evaluation (labs, urine testing, seasonal viral testing, or chest radiography)</a:t>
            </a:r>
          </a:p>
          <a:p>
            <a:r>
              <a:rPr lang="en-US" dirty="0">
                <a:ea typeface="+mn-lt"/>
                <a:cs typeface="+mn-lt"/>
              </a:rPr>
              <a:t>Fluid resuscitation if needed (</a:t>
            </a:r>
            <a:r>
              <a:rPr lang="en-US">
                <a:highlight>
                  <a:srgbClr val="FFFF00"/>
                </a:highlight>
                <a:ea typeface="+mn-lt"/>
                <a:cs typeface="+mn-lt"/>
              </a:rPr>
              <a:t>up to 60/kg NS bolus before PICU)</a:t>
            </a:r>
          </a:p>
          <a:p>
            <a:r>
              <a:rPr lang="en-US" dirty="0">
                <a:ea typeface="+mn-lt"/>
                <a:cs typeface="+mn-lt"/>
              </a:rPr>
              <a:t>Should start with IV Abx: Cefepime and Vancomycin (trough prior to 4th dose) </a:t>
            </a:r>
          </a:p>
          <a:p>
            <a:r>
              <a:rPr lang="en-US" dirty="0"/>
              <a:t>If </a:t>
            </a:r>
            <a:r>
              <a:rPr lang="en-US" dirty="0" err="1"/>
              <a:t>hx</a:t>
            </a:r>
            <a:r>
              <a:rPr lang="en-US" dirty="0"/>
              <a:t> of multidrug resistant bacteria --&gt; consult ID </a:t>
            </a:r>
          </a:p>
          <a:p>
            <a:endParaRPr lang="en-US" dirty="0"/>
          </a:p>
        </p:txBody>
      </p:sp>
    </p:spTree>
    <p:extLst>
      <p:ext uri="{BB962C8B-B14F-4D97-AF65-F5344CB8AC3E}">
        <p14:creationId xmlns:p14="http://schemas.microsoft.com/office/powerpoint/2010/main" val="409422794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81FE4D8-97FC-9D5D-08B8-E3FD15466589}"/>
              </a:ext>
            </a:extLst>
          </p:cNvPr>
          <p:cNvSpPr>
            <a:spLocks noGrp="1"/>
          </p:cNvSpPr>
          <p:nvPr>
            <p:ph type="title"/>
          </p:nvPr>
        </p:nvSpPr>
        <p:spPr/>
        <p:txBody>
          <a:bodyPr/>
          <a:lstStyle/>
          <a:p>
            <a:r>
              <a:rPr lang="en-US" dirty="0"/>
              <a:t>CLABSI cont.</a:t>
            </a:r>
          </a:p>
        </p:txBody>
      </p:sp>
      <p:sp>
        <p:nvSpPr>
          <p:cNvPr id="3" name="Content Placeholder 2">
            <a:extLst>
              <a:ext uri="{FF2B5EF4-FFF2-40B4-BE49-F238E27FC236}">
                <a16:creationId xmlns:a16="http://schemas.microsoft.com/office/drawing/2014/main" id="{C6C10584-5F60-48A3-BCF3-AF01322CF6C3}"/>
              </a:ext>
            </a:extLst>
          </p:cNvPr>
          <p:cNvSpPr>
            <a:spLocks noGrp="1"/>
          </p:cNvSpPr>
          <p:nvPr>
            <p:ph idx="1"/>
          </p:nvPr>
        </p:nvSpPr>
        <p:spPr/>
        <p:txBody>
          <a:bodyPr vert="horz" lIns="91440" tIns="45720" rIns="91440" bIns="45720" rtlCol="0" anchor="t">
            <a:normAutofit lnSpcReduction="10000"/>
          </a:bodyPr>
          <a:lstStyle/>
          <a:p>
            <a:r>
              <a:rPr lang="en-US" dirty="0">
                <a:ea typeface="+mn-lt"/>
                <a:cs typeface="+mn-lt"/>
              </a:rPr>
              <a:t>Observe in hospital setting on IV Abx for min 48h. If negative cx, consider D/S. </a:t>
            </a:r>
            <a:endParaRPr lang="en-US"/>
          </a:p>
          <a:p>
            <a:r>
              <a:rPr lang="en-US" dirty="0">
                <a:ea typeface="+mn-lt"/>
                <a:cs typeface="+mn-lt"/>
              </a:rPr>
              <a:t>If positive cx, repeat central cx every 24 h until bacteremia clears. </a:t>
            </a:r>
          </a:p>
          <a:p>
            <a:r>
              <a:rPr lang="en-US" dirty="0">
                <a:ea typeface="+mn-lt"/>
                <a:cs typeface="+mn-lt"/>
              </a:rPr>
              <a:t>Repeat peripheral cx every 24h </a:t>
            </a:r>
            <a:r>
              <a:rPr lang="en-US" b="1" dirty="0">
                <a:ea typeface="+mn-lt"/>
                <a:cs typeface="+mn-lt"/>
              </a:rPr>
              <a:t>only</a:t>
            </a:r>
            <a:r>
              <a:rPr lang="en-US" dirty="0">
                <a:ea typeface="+mn-lt"/>
                <a:cs typeface="+mn-lt"/>
              </a:rPr>
              <a:t> if returns positive. </a:t>
            </a:r>
          </a:p>
          <a:p>
            <a:r>
              <a:rPr lang="en-US" dirty="0">
                <a:ea typeface="+mn-lt"/>
                <a:cs typeface="+mn-lt"/>
              </a:rPr>
              <a:t>Observe until full antimicrobial sensitivity is available (min of 48h to assess for polymicrobial bacteremia (ID))</a:t>
            </a:r>
            <a:endParaRPr lang="en-US" dirty="0"/>
          </a:p>
          <a:p>
            <a:r>
              <a:rPr lang="en-US" dirty="0"/>
              <a:t>Common to start antibiotic lock therapy for central line infections</a:t>
            </a:r>
          </a:p>
          <a:p>
            <a:r>
              <a:rPr lang="en-US" dirty="0"/>
              <a:t>Consider antifungals such as Micafungin if pseudo hyphae on cx or blood smear, in the ill-appearing child or if clinical concern persists despite adequate antibacterial coverage. </a:t>
            </a:r>
          </a:p>
          <a:p>
            <a:endParaRPr lang="en-US" dirty="0"/>
          </a:p>
          <a:p>
            <a:endParaRPr lang="en-US" dirty="0"/>
          </a:p>
        </p:txBody>
      </p:sp>
    </p:spTree>
    <p:extLst>
      <p:ext uri="{BB962C8B-B14F-4D97-AF65-F5344CB8AC3E}">
        <p14:creationId xmlns:p14="http://schemas.microsoft.com/office/powerpoint/2010/main" val="386806776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771AC68-97E2-9045-5BCF-44AA08915141}"/>
              </a:ext>
            </a:extLst>
          </p:cNvPr>
          <p:cNvSpPr>
            <a:spLocks noGrp="1"/>
          </p:cNvSpPr>
          <p:nvPr>
            <p:ph type="title"/>
          </p:nvPr>
        </p:nvSpPr>
        <p:spPr/>
        <p:txBody>
          <a:bodyPr/>
          <a:lstStyle/>
          <a:p>
            <a:r>
              <a:rPr lang="en-US"/>
              <a:t>Purpose </a:t>
            </a:r>
          </a:p>
        </p:txBody>
      </p:sp>
      <p:sp>
        <p:nvSpPr>
          <p:cNvPr id="3" name="Content Placeholder 2">
            <a:extLst>
              <a:ext uri="{FF2B5EF4-FFF2-40B4-BE49-F238E27FC236}">
                <a16:creationId xmlns:a16="http://schemas.microsoft.com/office/drawing/2014/main" id="{58D555CA-A0A4-BD5A-C7A5-51D39BF63446}"/>
              </a:ext>
            </a:extLst>
          </p:cNvPr>
          <p:cNvSpPr>
            <a:spLocks noGrp="1"/>
          </p:cNvSpPr>
          <p:nvPr>
            <p:ph idx="1"/>
          </p:nvPr>
        </p:nvSpPr>
        <p:spPr>
          <a:xfrm>
            <a:off x="585989" y="1825625"/>
            <a:ext cx="11223937" cy="4351338"/>
          </a:xfrm>
        </p:spPr>
        <p:txBody>
          <a:bodyPr vert="horz" lIns="91440" tIns="45720" rIns="91440" bIns="45720" rtlCol="0" anchor="t">
            <a:normAutofit lnSpcReduction="10000"/>
          </a:bodyPr>
          <a:lstStyle/>
          <a:p>
            <a:r>
              <a:rPr lang="en-US" dirty="0">
                <a:ea typeface="+mn-lt"/>
                <a:cs typeface="+mn-lt"/>
              </a:rPr>
              <a:t>Lack of curriculum in managing intestinal failure patients for residents</a:t>
            </a:r>
          </a:p>
          <a:p>
            <a:r>
              <a:rPr lang="en-US" dirty="0">
                <a:ea typeface="+mn-lt"/>
                <a:cs typeface="+mn-lt"/>
              </a:rPr>
              <a:t>A Need’s Assessment Among Pediatric Residents in the Management of Patients with Intestinal Failure – Road Towards  a Curriculum Development Project </a:t>
            </a:r>
            <a:endParaRPr lang="en-US" dirty="0"/>
          </a:p>
          <a:p>
            <a:r>
              <a:rPr lang="en-US" dirty="0"/>
              <a:t>Based on survey results: struggle with # of ICARE topics </a:t>
            </a:r>
          </a:p>
          <a:p>
            <a:pPr lvl="1">
              <a:buFont typeface="Courier New" panose="020B0604020202020204" pitchFamily="34" charset="0"/>
              <a:buChar char="o"/>
            </a:pPr>
            <a:r>
              <a:rPr lang="en-US" dirty="0"/>
              <a:t>TPN and TPN like fluids </a:t>
            </a:r>
          </a:p>
          <a:p>
            <a:pPr lvl="1">
              <a:buFont typeface="Courier New" panose="020B0604020202020204" pitchFamily="34" charset="0"/>
              <a:buChar char="o"/>
            </a:pPr>
            <a:r>
              <a:rPr lang="en-US" dirty="0"/>
              <a:t>Understand patients' remaining anatomy </a:t>
            </a:r>
          </a:p>
          <a:p>
            <a:pPr lvl="1">
              <a:buFont typeface="Courier New" panose="020B0604020202020204" pitchFamily="34" charset="0"/>
              <a:buChar char="o"/>
            </a:pPr>
            <a:r>
              <a:rPr lang="en-US" dirty="0"/>
              <a:t>CVC complications </a:t>
            </a:r>
          </a:p>
          <a:p>
            <a:pPr lvl="1">
              <a:buFont typeface="Courier New" panose="020B0604020202020204" pitchFamily="34" charset="0"/>
              <a:buChar char="o"/>
            </a:pPr>
            <a:r>
              <a:rPr lang="en-US" dirty="0"/>
              <a:t>CLABSI management</a:t>
            </a:r>
          </a:p>
          <a:p>
            <a:pPr lvl="1">
              <a:buFont typeface="Courier New,monospace" panose="020B0604020202020204" pitchFamily="34" charset="0"/>
              <a:buChar char="o"/>
            </a:pPr>
            <a:r>
              <a:rPr lang="en-US" dirty="0"/>
              <a:t>GT/GJ tube complications</a:t>
            </a:r>
          </a:p>
          <a:p>
            <a:pPr lvl="1">
              <a:buFont typeface="Courier New" panose="020B0604020202020204" pitchFamily="34" charset="0"/>
              <a:buChar char="o"/>
            </a:pPr>
            <a:r>
              <a:rPr lang="en-US" dirty="0"/>
              <a:t>Stoma complications</a:t>
            </a:r>
          </a:p>
          <a:p>
            <a:pPr lvl="1">
              <a:buFont typeface="Courier New" panose="020B0604020202020204" pitchFamily="34" charset="0"/>
              <a:buChar char="o"/>
            </a:pPr>
            <a:endParaRPr lang="en-US" dirty="0"/>
          </a:p>
        </p:txBody>
      </p:sp>
      <p:sp>
        <p:nvSpPr>
          <p:cNvPr id="4" name="Arrow: Right 3">
            <a:extLst>
              <a:ext uri="{FF2B5EF4-FFF2-40B4-BE49-F238E27FC236}">
                <a16:creationId xmlns:a16="http://schemas.microsoft.com/office/drawing/2014/main" id="{0C4DFA9F-D5D8-418D-6708-4B57D7393503}"/>
              </a:ext>
            </a:extLst>
          </p:cNvPr>
          <p:cNvSpPr/>
          <p:nvPr/>
        </p:nvSpPr>
        <p:spPr>
          <a:xfrm>
            <a:off x="4466467" y="3877087"/>
            <a:ext cx="1061785" cy="242693"/>
          </a:xfrm>
          <a:prstGeom prst="righ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D812EF7D-4702-057B-A538-96ABF815087F}"/>
              </a:ext>
            </a:extLst>
          </p:cNvPr>
          <p:cNvSpPr txBox="1"/>
          <p:nvPr/>
        </p:nvSpPr>
        <p:spPr>
          <a:xfrm>
            <a:off x="5655080" y="3811089"/>
            <a:ext cx="2588735"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dirty="0"/>
              <a:t>Addressed separately</a:t>
            </a:r>
          </a:p>
        </p:txBody>
      </p:sp>
    </p:spTree>
    <p:extLst>
      <p:ext uri="{BB962C8B-B14F-4D97-AF65-F5344CB8AC3E}">
        <p14:creationId xmlns:p14="http://schemas.microsoft.com/office/powerpoint/2010/main" val="41241265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3">
                                            <p:txEl>
                                              <p:pRg st="5" end="5"/>
                                            </p:txEl>
                                          </p:spTgt>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3">
                                            <p:txEl>
                                              <p:pRg st="6" end="6"/>
                                            </p:txEl>
                                          </p:spTgt>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3">
                                            <p:txEl>
                                              <p:pRg st="7" end="7"/>
                                            </p:txEl>
                                          </p:spTgt>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4"/>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grpId="0" nodeType="clickEffect">
                                  <p:stCondLst>
                                    <p:cond delay="0"/>
                                  </p:stCondLst>
                                  <p:childTnLst>
                                    <p:set>
                                      <p:cBhvr>
                                        <p:cTn id="34"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P spid="4" grpId="0" animBg="1"/>
      <p:bldP spid="5" grpId="0"/>
    </p:bld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C250599-C153-7EDE-0470-823429B0D231}"/>
              </a:ext>
            </a:extLst>
          </p:cNvPr>
          <p:cNvSpPr>
            <a:spLocks noGrp="1"/>
          </p:cNvSpPr>
          <p:nvPr>
            <p:ph type="title"/>
          </p:nvPr>
        </p:nvSpPr>
        <p:spPr/>
        <p:txBody>
          <a:bodyPr/>
          <a:lstStyle/>
          <a:p>
            <a:r>
              <a:rPr lang="en-US" dirty="0"/>
              <a:t>CLABSI Prevention</a:t>
            </a:r>
          </a:p>
        </p:txBody>
      </p:sp>
      <p:sp>
        <p:nvSpPr>
          <p:cNvPr id="3" name="Content Placeholder 2">
            <a:extLst>
              <a:ext uri="{FF2B5EF4-FFF2-40B4-BE49-F238E27FC236}">
                <a16:creationId xmlns:a16="http://schemas.microsoft.com/office/drawing/2014/main" id="{4974952F-AF49-DE12-B0DE-612B936EDA11}"/>
              </a:ext>
            </a:extLst>
          </p:cNvPr>
          <p:cNvSpPr>
            <a:spLocks noGrp="1"/>
          </p:cNvSpPr>
          <p:nvPr>
            <p:ph idx="1"/>
          </p:nvPr>
        </p:nvSpPr>
        <p:spPr/>
        <p:txBody>
          <a:bodyPr vert="horz" lIns="91440" tIns="45720" rIns="91440" bIns="45720" rtlCol="0" anchor="t">
            <a:normAutofit/>
          </a:bodyPr>
          <a:lstStyle/>
          <a:p>
            <a:r>
              <a:rPr lang="en-US" dirty="0">
                <a:ea typeface="+mn-lt"/>
                <a:cs typeface="+mn-lt"/>
              </a:rPr>
              <a:t>Prophylactic ethanol lock therapy should be strongly considered in all children with IF who have had </a:t>
            </a:r>
            <a:r>
              <a:rPr lang="en-US" u="sng" dirty="0">
                <a:ea typeface="+mn-lt"/>
                <a:cs typeface="+mn-lt"/>
              </a:rPr>
              <a:t>at least 1 CLABSI</a:t>
            </a:r>
            <a:r>
              <a:rPr lang="en-US" dirty="0">
                <a:ea typeface="+mn-lt"/>
                <a:cs typeface="+mn-lt"/>
              </a:rPr>
              <a:t>.</a:t>
            </a:r>
            <a:endParaRPr lang="en-US" dirty="0"/>
          </a:p>
          <a:p>
            <a:r>
              <a:rPr lang="en-US" dirty="0">
                <a:ea typeface="+mn-lt"/>
                <a:cs typeface="+mn-lt"/>
              </a:rPr>
              <a:t>25%-70% ethanol locks significantly reduces the rate of CLABSI compared to heparin locks </a:t>
            </a:r>
          </a:p>
          <a:p>
            <a:r>
              <a:rPr lang="en-US" dirty="0">
                <a:ea typeface="+mn-lt"/>
                <a:cs typeface="+mn-lt"/>
              </a:rPr>
              <a:t>Taurolidine lock (not for infants)</a:t>
            </a:r>
            <a:endParaRPr lang="en-US" dirty="0"/>
          </a:p>
          <a:p>
            <a:r>
              <a:rPr lang="en-US" dirty="0">
                <a:ea typeface="+mn-lt"/>
                <a:cs typeface="+mn-lt"/>
              </a:rPr>
              <a:t>Sodium EDTA lock </a:t>
            </a:r>
            <a:endParaRPr lang="en-US" dirty="0"/>
          </a:p>
          <a:p>
            <a:endParaRPr lang="en-US" dirty="0"/>
          </a:p>
        </p:txBody>
      </p:sp>
    </p:spTree>
    <p:extLst>
      <p:ext uri="{BB962C8B-B14F-4D97-AF65-F5344CB8AC3E}">
        <p14:creationId xmlns:p14="http://schemas.microsoft.com/office/powerpoint/2010/main" val="3825394227"/>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5" name="Rectangle 14">
            <a:extLst>
              <a:ext uri="{FF2B5EF4-FFF2-40B4-BE49-F238E27FC236}">
                <a16:creationId xmlns:a16="http://schemas.microsoft.com/office/drawing/2014/main" id="{6F5A5072-7B47-4D32-B52A-4EBBF590B8A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w="12700" cap="flat" cmpd="sng" algn="ctr">
            <a:noFill/>
            <a:prstDash val="solid"/>
            <a:miter lim="800000"/>
          </a:ln>
          <a:effectLst/>
          <a:extLst>
            <a:ext uri="{91240B29-F687-4F45-9708-019B960494DF}">
              <a14:hiddenLine xmlns:a14="http://schemas.microsoft.com/office/drawing/2010/main" w="12700" cap="flat" cmpd="sng" algn="ctr">
                <a:solidFill>
                  <a:schemeClr val="accent1">
                    <a:shade val="50000"/>
                  </a:schemeClr>
                </a:solidFill>
                <a:prstDash val="solid"/>
                <a:miter lim="800000"/>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ectangle 16">
            <a:extLst>
              <a:ext uri="{FF2B5EF4-FFF2-40B4-BE49-F238E27FC236}">
                <a16:creationId xmlns:a16="http://schemas.microsoft.com/office/drawing/2014/main" id="{9715DAF0-AE1B-46C9-8A6B-DB2AA05AB91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0800000">
            <a:off x="-2" y="-22693"/>
            <a:ext cx="12191999" cy="4374129"/>
          </a:xfrm>
          <a:prstGeom prst="rect">
            <a:avLst/>
          </a:prstGeom>
          <a:gradFill>
            <a:gsLst>
              <a:gs pos="0">
                <a:schemeClr val="accent1">
                  <a:lumMod val="75000"/>
                </a:schemeClr>
              </a:gs>
              <a:gs pos="100000">
                <a:srgbClr val="000000"/>
              </a:gs>
            </a:gsLst>
            <a:lin ang="15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ectangle 18">
            <a:extLst>
              <a:ext uri="{FF2B5EF4-FFF2-40B4-BE49-F238E27FC236}">
                <a16:creationId xmlns:a16="http://schemas.microsoft.com/office/drawing/2014/main" id="{6016219D-510E-4184-9090-6D5578A87BD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3908719" y="-3931841"/>
            <a:ext cx="4374557" cy="12192000"/>
          </a:xfrm>
          <a:prstGeom prst="rect">
            <a:avLst/>
          </a:prstGeom>
          <a:gradFill>
            <a:gsLst>
              <a:gs pos="40000">
                <a:schemeClr val="accent1">
                  <a:alpha val="0"/>
                </a:schemeClr>
              </a:gs>
              <a:gs pos="100000">
                <a:schemeClr val="accent1">
                  <a:lumMod val="75000"/>
                  <a:alpha val="52000"/>
                </a:schemeClr>
              </a:gs>
            </a:gsLst>
            <a:lin ang="24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13">
            <a:extLst>
              <a:ext uri="{FF2B5EF4-FFF2-40B4-BE49-F238E27FC236}">
                <a16:creationId xmlns:a16="http://schemas.microsoft.com/office/drawing/2014/main" id="{AFF4A713-7B75-4B21-90D7-5AB19547C72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4136696" y="-3703868"/>
            <a:ext cx="4374128" cy="11736479"/>
          </a:xfrm>
          <a:prstGeom prst="rect">
            <a:avLst/>
          </a:prstGeom>
          <a:gradFill>
            <a:gsLst>
              <a:gs pos="17000">
                <a:schemeClr val="accent1">
                  <a:alpha val="0"/>
                </a:schemeClr>
              </a:gs>
              <a:gs pos="100000">
                <a:srgbClr val="000000">
                  <a:alpha val="37000"/>
                </a:srgbClr>
              </a:gs>
            </a:gsLst>
            <a:lin ang="7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ectangle 15">
            <a:extLst>
              <a:ext uri="{FF2B5EF4-FFF2-40B4-BE49-F238E27FC236}">
                <a16:creationId xmlns:a16="http://schemas.microsoft.com/office/drawing/2014/main" id="{DC631C0B-6DA6-4E57-8231-CE32B3434A7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 y="-22690"/>
            <a:ext cx="8542485" cy="4374126"/>
          </a:xfrm>
          <a:prstGeom prst="rect">
            <a:avLst/>
          </a:prstGeom>
          <a:gradFill>
            <a:gsLst>
              <a:gs pos="0">
                <a:schemeClr val="accent1">
                  <a:lumMod val="50000"/>
                  <a:alpha val="0"/>
                </a:schemeClr>
              </a:gs>
              <a:gs pos="100000">
                <a:srgbClr val="000000">
                  <a:alpha val="25000"/>
                </a:srgbClr>
              </a:gs>
            </a:gsLst>
            <a:lin ang="186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Freeform: Shape 17">
            <a:extLst>
              <a:ext uri="{FF2B5EF4-FFF2-40B4-BE49-F238E27FC236}">
                <a16:creationId xmlns:a16="http://schemas.microsoft.com/office/drawing/2014/main" id="{C29501E6-A978-4A61-9689-9085AF97A53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2508972">
            <a:off x="5945431" y="-1032053"/>
            <a:ext cx="4990147" cy="4439131"/>
          </a:xfrm>
          <a:custGeom>
            <a:avLst/>
            <a:gdLst>
              <a:gd name="connsiteX0" fmla="*/ 4990147 w 4990147"/>
              <a:gd name="connsiteY0" fmla="*/ 2229378 h 4439131"/>
              <a:gd name="connsiteX1" fmla="*/ 917384 w 4990147"/>
              <a:gd name="connsiteY1" fmla="*/ 4439131 h 4439131"/>
              <a:gd name="connsiteX2" fmla="*/ 910814 w 4990147"/>
              <a:gd name="connsiteY2" fmla="*/ 4434219 h 4439131"/>
              <a:gd name="connsiteX3" fmla="*/ 0 w 4990147"/>
              <a:gd name="connsiteY3" fmla="*/ 2502877 h 4439131"/>
              <a:gd name="connsiteX4" fmla="*/ 2502877 w 4990147"/>
              <a:gd name="connsiteY4" fmla="*/ 0 h 4439131"/>
              <a:gd name="connsiteX5" fmla="*/ 4954904 w 4990147"/>
              <a:gd name="connsiteY5" fmla="*/ 1998460 h 443913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4990147" h="4439131">
                <a:moveTo>
                  <a:pt x="4990147" y="2229378"/>
                </a:moveTo>
                <a:lnTo>
                  <a:pt x="917384" y="4439131"/>
                </a:lnTo>
                <a:lnTo>
                  <a:pt x="910814" y="4434219"/>
                </a:lnTo>
                <a:cubicBezTo>
                  <a:pt x="354557" y="3975154"/>
                  <a:pt x="0" y="3280421"/>
                  <a:pt x="0" y="2502877"/>
                </a:cubicBezTo>
                <a:cubicBezTo>
                  <a:pt x="0" y="1120576"/>
                  <a:pt x="1120576" y="0"/>
                  <a:pt x="2502877" y="0"/>
                </a:cubicBezTo>
                <a:cubicBezTo>
                  <a:pt x="3712390" y="0"/>
                  <a:pt x="4721520" y="857941"/>
                  <a:pt x="4954904" y="1998460"/>
                </a:cubicBezTo>
                <a:close/>
              </a:path>
            </a:pathLst>
          </a:custGeom>
          <a:gradFill>
            <a:gsLst>
              <a:gs pos="0">
                <a:schemeClr val="accent1">
                  <a:alpha val="22000"/>
                </a:schemeClr>
              </a:gs>
              <a:gs pos="87000">
                <a:schemeClr val="accent1">
                  <a:lumMod val="60000"/>
                  <a:lumOff val="40000"/>
                  <a:alpha val="2000"/>
                </a:schemeClr>
              </a:gs>
            </a:gsLst>
            <a:lin ang="84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p>
        </p:txBody>
      </p:sp>
      <p:sp>
        <p:nvSpPr>
          <p:cNvPr id="2" name="Title 1">
            <a:extLst>
              <a:ext uri="{FF2B5EF4-FFF2-40B4-BE49-F238E27FC236}">
                <a16:creationId xmlns:a16="http://schemas.microsoft.com/office/drawing/2014/main" id="{1E63AA7C-D8CC-24E2-1927-C63C14BF6FAB}"/>
              </a:ext>
            </a:extLst>
          </p:cNvPr>
          <p:cNvSpPr>
            <a:spLocks noGrp="1"/>
          </p:cNvSpPr>
          <p:nvPr>
            <p:ph type="title"/>
          </p:nvPr>
        </p:nvSpPr>
        <p:spPr>
          <a:xfrm>
            <a:off x="1314824" y="735106"/>
            <a:ext cx="10053763" cy="2928470"/>
          </a:xfrm>
        </p:spPr>
        <p:txBody>
          <a:bodyPr vert="horz" lIns="91440" tIns="45720" rIns="91440" bIns="45720" rtlCol="0" anchor="b">
            <a:normAutofit/>
          </a:bodyPr>
          <a:lstStyle/>
          <a:p>
            <a:r>
              <a:rPr lang="en-US" sz="4800" kern="1200">
                <a:solidFill>
                  <a:srgbClr val="FFFFFF"/>
                </a:solidFill>
                <a:latin typeface="+mj-lt"/>
                <a:ea typeface="+mj-ea"/>
                <a:cs typeface="+mj-cs"/>
              </a:rPr>
              <a:t>Case 2:</a:t>
            </a:r>
          </a:p>
        </p:txBody>
      </p:sp>
      <p:sp>
        <p:nvSpPr>
          <p:cNvPr id="3" name="Text Placeholder 2">
            <a:extLst>
              <a:ext uri="{FF2B5EF4-FFF2-40B4-BE49-F238E27FC236}">
                <a16:creationId xmlns:a16="http://schemas.microsoft.com/office/drawing/2014/main" id="{6B57145F-A3D4-5C8F-5BBE-CC4E7BC1E90B}"/>
              </a:ext>
            </a:extLst>
          </p:cNvPr>
          <p:cNvSpPr>
            <a:spLocks noGrp="1"/>
          </p:cNvSpPr>
          <p:nvPr>
            <p:ph type="body" idx="1"/>
          </p:nvPr>
        </p:nvSpPr>
        <p:spPr>
          <a:xfrm>
            <a:off x="645361" y="4870824"/>
            <a:ext cx="10906495" cy="1458258"/>
          </a:xfrm>
        </p:spPr>
        <p:txBody>
          <a:bodyPr vert="horz" lIns="91440" tIns="45720" rIns="91440" bIns="45720" rtlCol="0" anchor="ctr">
            <a:noAutofit/>
          </a:bodyPr>
          <a:lstStyle/>
          <a:p>
            <a:r>
              <a:rPr lang="en-US" sz="3600" kern="1200" dirty="0">
                <a:solidFill>
                  <a:schemeClr val="tx1"/>
                </a:solidFill>
                <a:latin typeface="+mn-lt"/>
                <a:ea typeface="+mn-ea"/>
                <a:cs typeface="+mn-cs"/>
              </a:rPr>
              <a:t>A 6-year-old boy with history of NEC, dependent on TPN, presents to the ED after he accidentally pulled his central line. </a:t>
            </a:r>
            <a:endParaRPr lang="en-US" sz="3600" kern="1200" dirty="0">
              <a:solidFill>
                <a:schemeClr val="tx1"/>
              </a:solidFill>
              <a:latin typeface="+mn-lt"/>
            </a:endParaRPr>
          </a:p>
        </p:txBody>
      </p:sp>
    </p:spTree>
    <p:extLst>
      <p:ext uri="{BB962C8B-B14F-4D97-AF65-F5344CB8AC3E}">
        <p14:creationId xmlns:p14="http://schemas.microsoft.com/office/powerpoint/2010/main" val="2414223819"/>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FBAB475-6F9B-433D-8649-AD771C8CF814}"/>
              </a:ext>
            </a:extLst>
          </p:cNvPr>
          <p:cNvSpPr>
            <a:spLocks noGrp="1"/>
          </p:cNvSpPr>
          <p:nvPr>
            <p:ph type="title"/>
          </p:nvPr>
        </p:nvSpPr>
        <p:spPr/>
        <p:txBody>
          <a:bodyPr/>
          <a:lstStyle/>
          <a:p>
            <a:r>
              <a:rPr lang="en-US" dirty="0"/>
              <a:t>Malposition/Dislodgement </a:t>
            </a:r>
          </a:p>
        </p:txBody>
      </p:sp>
      <p:sp>
        <p:nvSpPr>
          <p:cNvPr id="3" name="Content Placeholder 2">
            <a:extLst>
              <a:ext uri="{FF2B5EF4-FFF2-40B4-BE49-F238E27FC236}">
                <a16:creationId xmlns:a16="http://schemas.microsoft.com/office/drawing/2014/main" id="{777F2FD0-93E3-360A-DED8-59A3E5728BA8}"/>
              </a:ext>
            </a:extLst>
          </p:cNvPr>
          <p:cNvSpPr>
            <a:spLocks noGrp="1"/>
          </p:cNvSpPr>
          <p:nvPr>
            <p:ph idx="1"/>
          </p:nvPr>
        </p:nvSpPr>
        <p:spPr/>
        <p:txBody>
          <a:bodyPr vert="horz" lIns="91440" tIns="45720" rIns="91440" bIns="45720" rtlCol="0" anchor="t">
            <a:normAutofit/>
          </a:bodyPr>
          <a:lstStyle/>
          <a:p>
            <a:r>
              <a:rPr lang="en-US" dirty="0">
                <a:ea typeface="+mn-lt"/>
                <a:cs typeface="+mn-lt"/>
              </a:rPr>
              <a:t>If suspected, get CXR. </a:t>
            </a:r>
          </a:p>
          <a:p>
            <a:r>
              <a:rPr lang="en-US" dirty="0">
                <a:ea typeface="+mn-lt"/>
                <a:cs typeface="+mn-lt"/>
              </a:rPr>
              <a:t>Central: Tip approximates at the </a:t>
            </a:r>
            <a:r>
              <a:rPr lang="en-US" dirty="0" err="1">
                <a:ea typeface="+mn-lt"/>
                <a:cs typeface="+mn-lt"/>
              </a:rPr>
              <a:t>cavoatrial</a:t>
            </a:r>
            <a:r>
              <a:rPr lang="en-US" dirty="0">
                <a:ea typeface="+mn-lt"/>
                <a:cs typeface="+mn-lt"/>
              </a:rPr>
              <a:t> junction </a:t>
            </a:r>
            <a:endParaRPr lang="en-US" dirty="0">
              <a:highlight>
                <a:srgbClr val="FFFF00"/>
              </a:highlight>
            </a:endParaRPr>
          </a:p>
          <a:p>
            <a:endParaRPr lang="en-US" dirty="0"/>
          </a:p>
          <a:p>
            <a:endParaRPr lang="en-US" dirty="0"/>
          </a:p>
        </p:txBody>
      </p:sp>
    </p:spTree>
    <p:extLst>
      <p:ext uri="{BB962C8B-B14F-4D97-AF65-F5344CB8AC3E}">
        <p14:creationId xmlns:p14="http://schemas.microsoft.com/office/powerpoint/2010/main" val="449566489"/>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CXR.jpg">
            <a:extLst>
              <a:ext uri="{FF2B5EF4-FFF2-40B4-BE49-F238E27FC236}">
                <a16:creationId xmlns:a16="http://schemas.microsoft.com/office/drawing/2014/main" id="{5A5AF7B2-F832-D154-7A42-A41BF70830E9}"/>
              </a:ext>
            </a:extLst>
          </p:cNvPr>
          <p:cNvPicPr>
            <a:picLocks noChangeAspect="1"/>
          </p:cNvPicPr>
          <p:nvPr/>
        </p:nvPicPr>
        <p:blipFill>
          <a:blip r:embed="rId3"/>
          <a:stretch>
            <a:fillRect/>
          </a:stretch>
        </p:blipFill>
        <p:spPr>
          <a:xfrm>
            <a:off x="-3034" y="116297"/>
            <a:ext cx="6000918" cy="6738979"/>
          </a:xfrm>
          <a:prstGeom prst="rect">
            <a:avLst/>
          </a:prstGeom>
        </p:spPr>
      </p:pic>
      <p:pic>
        <p:nvPicPr>
          <p:cNvPr id="3" name="Picture 2" descr="A diagram of veins and veins&#10;&#10;Description automatically generated">
            <a:extLst>
              <a:ext uri="{FF2B5EF4-FFF2-40B4-BE49-F238E27FC236}">
                <a16:creationId xmlns:a16="http://schemas.microsoft.com/office/drawing/2014/main" id="{0A24DA9C-91D8-D8C5-28ED-0B9A089B35DA}"/>
              </a:ext>
            </a:extLst>
          </p:cNvPr>
          <p:cNvPicPr>
            <a:picLocks noChangeAspect="1"/>
          </p:cNvPicPr>
          <p:nvPr/>
        </p:nvPicPr>
        <p:blipFill>
          <a:blip r:embed="rId4"/>
          <a:stretch>
            <a:fillRect/>
          </a:stretch>
        </p:blipFill>
        <p:spPr>
          <a:xfrm>
            <a:off x="6096000" y="1617663"/>
            <a:ext cx="6096000" cy="3876675"/>
          </a:xfrm>
          <a:prstGeom prst="rect">
            <a:avLst/>
          </a:prstGeom>
        </p:spPr>
      </p:pic>
      <p:sp>
        <p:nvSpPr>
          <p:cNvPr id="4" name="Rectangle 3">
            <a:extLst>
              <a:ext uri="{FF2B5EF4-FFF2-40B4-BE49-F238E27FC236}">
                <a16:creationId xmlns:a16="http://schemas.microsoft.com/office/drawing/2014/main" id="{E97BA42B-3905-D7AD-EE5E-69978AE92026}"/>
              </a:ext>
            </a:extLst>
          </p:cNvPr>
          <p:cNvSpPr/>
          <p:nvPr/>
        </p:nvSpPr>
        <p:spPr>
          <a:xfrm>
            <a:off x="9862553" y="1620827"/>
            <a:ext cx="2065845" cy="417856"/>
          </a:xfrm>
          <a:prstGeom prst="rect">
            <a:avLst/>
          </a:prstGeom>
          <a:noFill/>
          <a:ln w="28575">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endParaRPr lang="en-US"/>
          </a:p>
        </p:txBody>
      </p:sp>
      <p:sp>
        <p:nvSpPr>
          <p:cNvPr id="5" name="Oval 4">
            <a:extLst>
              <a:ext uri="{FF2B5EF4-FFF2-40B4-BE49-F238E27FC236}">
                <a16:creationId xmlns:a16="http://schemas.microsoft.com/office/drawing/2014/main" id="{074554DC-F2C1-2E85-E789-E023EAC35183}"/>
              </a:ext>
            </a:extLst>
          </p:cNvPr>
          <p:cNvSpPr/>
          <p:nvPr/>
        </p:nvSpPr>
        <p:spPr>
          <a:xfrm>
            <a:off x="2578395" y="2516372"/>
            <a:ext cx="691116" cy="779720"/>
          </a:xfrm>
          <a:prstGeom prst="ellipse">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575805153"/>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16D5F698-1466-B30B-5CE7-AC93819EA30B}"/>
              </a:ext>
            </a:extLst>
          </p:cNvPr>
          <p:cNvSpPr txBox="1"/>
          <p:nvPr/>
        </p:nvSpPr>
        <p:spPr>
          <a:xfrm>
            <a:off x="3565092" y="270671"/>
            <a:ext cx="6269177"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2800" dirty="0"/>
              <a:t>CUFF OUT  =   Dislodged central line</a:t>
            </a:r>
            <a:endParaRPr lang="en-US" sz="2800" dirty="0">
              <a:highlight>
                <a:srgbClr val="FFFF00"/>
              </a:highlight>
            </a:endParaRPr>
          </a:p>
        </p:txBody>
      </p:sp>
      <p:pic>
        <p:nvPicPr>
          <p:cNvPr id="5" name="Picture 4" descr="A close up of a person&amp;#39;s arm&#10;&#10;Description automatically generated">
            <a:extLst>
              <a:ext uri="{FF2B5EF4-FFF2-40B4-BE49-F238E27FC236}">
                <a16:creationId xmlns:a16="http://schemas.microsoft.com/office/drawing/2014/main" id="{79BFA588-BAB5-8037-DCDC-77CE5DF30BF9}"/>
              </a:ext>
            </a:extLst>
          </p:cNvPr>
          <p:cNvPicPr>
            <a:picLocks noChangeAspect="1"/>
          </p:cNvPicPr>
          <p:nvPr/>
        </p:nvPicPr>
        <p:blipFill>
          <a:blip r:embed="rId3"/>
          <a:stretch>
            <a:fillRect/>
          </a:stretch>
        </p:blipFill>
        <p:spPr>
          <a:xfrm>
            <a:off x="4252912" y="985206"/>
            <a:ext cx="3686175" cy="5791200"/>
          </a:xfrm>
          <a:prstGeom prst="rect">
            <a:avLst/>
          </a:prstGeom>
        </p:spPr>
      </p:pic>
    </p:spTree>
    <p:extLst>
      <p:ext uri="{BB962C8B-B14F-4D97-AF65-F5344CB8AC3E}">
        <p14:creationId xmlns:p14="http://schemas.microsoft.com/office/powerpoint/2010/main" val="707447650"/>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BB6751-B6AA-40CD-4421-E30109F0F92F}"/>
              </a:ext>
            </a:extLst>
          </p:cNvPr>
          <p:cNvSpPr>
            <a:spLocks noGrp="1"/>
          </p:cNvSpPr>
          <p:nvPr>
            <p:ph type="title"/>
          </p:nvPr>
        </p:nvSpPr>
        <p:spPr/>
        <p:txBody>
          <a:bodyPr/>
          <a:lstStyle/>
          <a:p>
            <a:r>
              <a:rPr lang="en-US" dirty="0"/>
              <a:t>Treatment </a:t>
            </a:r>
          </a:p>
        </p:txBody>
      </p:sp>
      <p:sp>
        <p:nvSpPr>
          <p:cNvPr id="3" name="Content Placeholder 2">
            <a:extLst>
              <a:ext uri="{FF2B5EF4-FFF2-40B4-BE49-F238E27FC236}">
                <a16:creationId xmlns:a16="http://schemas.microsoft.com/office/drawing/2014/main" id="{27CD8494-A0E2-9210-FFC9-4E5E76A3F1BA}"/>
              </a:ext>
            </a:extLst>
          </p:cNvPr>
          <p:cNvSpPr>
            <a:spLocks noGrp="1"/>
          </p:cNvSpPr>
          <p:nvPr>
            <p:ph idx="1"/>
          </p:nvPr>
        </p:nvSpPr>
        <p:spPr/>
        <p:txBody>
          <a:bodyPr vert="horz" lIns="91440" tIns="45720" rIns="91440" bIns="45720" rtlCol="0" anchor="t">
            <a:normAutofit/>
          </a:bodyPr>
          <a:lstStyle/>
          <a:p>
            <a:r>
              <a:rPr lang="en-US" dirty="0"/>
              <a:t>Replace the line with IR or Ped Surgery </a:t>
            </a:r>
          </a:p>
        </p:txBody>
      </p:sp>
    </p:spTree>
    <p:extLst>
      <p:ext uri="{BB962C8B-B14F-4D97-AF65-F5344CB8AC3E}">
        <p14:creationId xmlns:p14="http://schemas.microsoft.com/office/powerpoint/2010/main" val="2980877215"/>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0210F8-63D0-95C3-DEF9-3C8314A55FAA}"/>
              </a:ext>
            </a:extLst>
          </p:cNvPr>
          <p:cNvSpPr>
            <a:spLocks noGrp="1"/>
          </p:cNvSpPr>
          <p:nvPr>
            <p:ph type="title"/>
          </p:nvPr>
        </p:nvSpPr>
        <p:spPr>
          <a:xfrm>
            <a:off x="217311" y="1268236"/>
            <a:ext cx="4038601" cy="1339674"/>
          </a:xfrm>
        </p:spPr>
        <p:txBody>
          <a:bodyPr/>
          <a:lstStyle/>
          <a:p>
            <a:r>
              <a:rPr lang="en-US" dirty="0"/>
              <a:t>Line Dysfunction (breakage) </a:t>
            </a:r>
            <a:endParaRPr lang="en-US" dirty="0">
              <a:highlight>
                <a:srgbClr val="FFFF00"/>
              </a:highlight>
            </a:endParaRPr>
          </a:p>
        </p:txBody>
      </p:sp>
      <p:sp>
        <p:nvSpPr>
          <p:cNvPr id="3" name="Content Placeholder 2">
            <a:extLst>
              <a:ext uri="{FF2B5EF4-FFF2-40B4-BE49-F238E27FC236}">
                <a16:creationId xmlns:a16="http://schemas.microsoft.com/office/drawing/2014/main" id="{5F301AD2-63C3-E004-C0F9-E2CADF494E6A}"/>
              </a:ext>
            </a:extLst>
          </p:cNvPr>
          <p:cNvSpPr>
            <a:spLocks noGrp="1"/>
          </p:cNvSpPr>
          <p:nvPr>
            <p:ph idx="1"/>
          </p:nvPr>
        </p:nvSpPr>
        <p:spPr>
          <a:xfrm>
            <a:off x="126000" y="3259958"/>
            <a:ext cx="10515600" cy="3666950"/>
          </a:xfrm>
        </p:spPr>
        <p:txBody>
          <a:bodyPr vert="horz" lIns="91440" tIns="45720" rIns="91440" bIns="45720" rtlCol="0" anchor="t">
            <a:noAutofit/>
          </a:bodyPr>
          <a:lstStyle/>
          <a:p>
            <a:pPr marL="457200" indent="-457200">
              <a:lnSpc>
                <a:spcPct val="100000"/>
              </a:lnSpc>
            </a:pPr>
            <a:r>
              <a:rPr lang="en-US" dirty="0">
                <a:latin typeface="Aptos"/>
                <a:cs typeface="Calibri"/>
              </a:rPr>
              <a:t>IV team to assess in ED (silicone lines repairable) </a:t>
            </a:r>
            <a:endParaRPr lang="en-US" dirty="0"/>
          </a:p>
          <a:p>
            <a:pPr marL="457200" indent="-457200">
              <a:lnSpc>
                <a:spcPct val="100000"/>
              </a:lnSpc>
            </a:pPr>
            <a:r>
              <a:rPr lang="en-US" dirty="0">
                <a:latin typeface="Aptos"/>
                <a:cs typeface="Calibri"/>
              </a:rPr>
              <a:t>If unrepairable admit to ICARE for replacement/rewire</a:t>
            </a:r>
          </a:p>
          <a:p>
            <a:pPr marL="457200" indent="-457200">
              <a:lnSpc>
                <a:spcPct val="100000"/>
              </a:lnSpc>
            </a:pPr>
            <a:r>
              <a:rPr lang="en-US" dirty="0">
                <a:solidFill>
                  <a:srgbClr val="FF0000"/>
                </a:solidFill>
                <a:latin typeface="Aptos"/>
                <a:cs typeface="Calibri"/>
              </a:rPr>
              <a:t>Consult</a:t>
            </a:r>
            <a:r>
              <a:rPr lang="en-US" sz="2800" dirty="0">
                <a:solidFill>
                  <a:srgbClr val="FF0000"/>
                </a:solidFill>
                <a:latin typeface="Aptos"/>
                <a:cs typeface="Calibri"/>
              </a:rPr>
              <a:t> vascular access order set</a:t>
            </a:r>
            <a:r>
              <a:rPr lang="en-US" sz="2800" dirty="0">
                <a:latin typeface="Aptos"/>
                <a:cs typeface="Calibri"/>
              </a:rPr>
              <a:t>, not consult </a:t>
            </a:r>
            <a:r>
              <a:rPr lang="en-US" dirty="0">
                <a:latin typeface="Aptos"/>
                <a:cs typeface="Calibri"/>
              </a:rPr>
              <a:t>IR (allows</a:t>
            </a:r>
            <a:r>
              <a:rPr lang="en-US" sz="2800" dirty="0">
                <a:latin typeface="Aptos"/>
                <a:cs typeface="Calibri"/>
              </a:rPr>
              <a:t> IV team to facilitate the scheduling with IR</a:t>
            </a:r>
            <a:r>
              <a:rPr lang="en-US" dirty="0">
                <a:latin typeface="Aptos"/>
                <a:cs typeface="Calibri"/>
              </a:rPr>
              <a:t>)</a:t>
            </a:r>
          </a:p>
          <a:p>
            <a:pPr marL="0" indent="0">
              <a:lnSpc>
                <a:spcPct val="100000"/>
              </a:lnSpc>
              <a:buNone/>
            </a:pPr>
            <a:r>
              <a:rPr lang="en-US" dirty="0">
                <a:latin typeface="Aptos"/>
                <a:cs typeface="Calibri"/>
              </a:rPr>
              <a:t>      *</a:t>
            </a:r>
            <a:r>
              <a:rPr lang="en-US" sz="2800" dirty="0">
                <a:latin typeface="Aptos"/>
                <a:cs typeface="Calibri"/>
              </a:rPr>
              <a:t>If the line was placed by ped surg, will need to consult surgery</a:t>
            </a:r>
            <a:r>
              <a:rPr lang="en-US" dirty="0">
                <a:latin typeface="Aptos"/>
                <a:cs typeface="Calibri"/>
              </a:rPr>
              <a:t>*</a:t>
            </a:r>
            <a:endParaRPr lang="en-US" dirty="0">
              <a:cs typeface="Calibri"/>
            </a:endParaRPr>
          </a:p>
          <a:p>
            <a:pPr marL="457200" indent="-457200">
              <a:lnSpc>
                <a:spcPct val="100000"/>
              </a:lnSpc>
            </a:pPr>
            <a:r>
              <a:rPr lang="en-US" dirty="0">
                <a:latin typeface="Aptos"/>
                <a:cs typeface="Calibri"/>
              </a:rPr>
              <a:t>NPO, Order TPN-like IVF, CBC and </a:t>
            </a:r>
            <a:r>
              <a:rPr lang="en-US" err="1">
                <a:latin typeface="Aptos"/>
                <a:cs typeface="Calibri"/>
              </a:rPr>
              <a:t>coags</a:t>
            </a:r>
            <a:r>
              <a:rPr lang="en-US" dirty="0">
                <a:latin typeface="Aptos"/>
                <a:cs typeface="Calibri"/>
              </a:rPr>
              <a:t>. Hold</a:t>
            </a:r>
            <a:r>
              <a:rPr lang="en-US" sz="2800" dirty="0">
                <a:latin typeface="Aptos"/>
                <a:cs typeface="Calibri"/>
              </a:rPr>
              <a:t> </a:t>
            </a:r>
            <a:r>
              <a:rPr lang="en-US">
                <a:latin typeface="Aptos"/>
                <a:cs typeface="Calibri"/>
              </a:rPr>
              <a:t>Lovenox/Xarelto</a:t>
            </a:r>
            <a:endParaRPr lang="en-US" sz="2800" dirty="0">
              <a:latin typeface="Aptos"/>
              <a:cs typeface="Calibri"/>
            </a:endParaRPr>
          </a:p>
          <a:p>
            <a:endParaRPr lang="en-US" sz="1700" dirty="0">
              <a:latin typeface="Calibri"/>
              <a:cs typeface="Calibri"/>
            </a:endParaRPr>
          </a:p>
          <a:p>
            <a:endParaRPr lang="en-US" dirty="0">
              <a:latin typeface="Aptos" panose="020B0004020202020204"/>
              <a:cs typeface="Calibri"/>
            </a:endParaRPr>
          </a:p>
        </p:txBody>
      </p:sp>
      <p:pic>
        <p:nvPicPr>
          <p:cNvPr id="5" name="Picture 4" descr="Silastic Catheters (Broviac, Hickman ...">
            <a:extLst>
              <a:ext uri="{FF2B5EF4-FFF2-40B4-BE49-F238E27FC236}">
                <a16:creationId xmlns:a16="http://schemas.microsoft.com/office/drawing/2014/main" id="{B02E1EBA-509B-E301-E044-0E7BF331C887}"/>
              </a:ext>
            </a:extLst>
          </p:cNvPr>
          <p:cNvPicPr>
            <a:picLocks noChangeAspect="1"/>
          </p:cNvPicPr>
          <p:nvPr/>
        </p:nvPicPr>
        <p:blipFill>
          <a:blip r:embed="rId2"/>
          <a:stretch>
            <a:fillRect/>
          </a:stretch>
        </p:blipFill>
        <p:spPr>
          <a:xfrm>
            <a:off x="4251540" y="593500"/>
            <a:ext cx="3426316" cy="2453567"/>
          </a:xfrm>
          <a:prstGeom prst="rect">
            <a:avLst/>
          </a:prstGeom>
        </p:spPr>
      </p:pic>
      <p:pic>
        <p:nvPicPr>
          <p:cNvPr id="7" name="Picture 6" descr="Silastic Catheters (Broviac, Hickman ...">
            <a:extLst>
              <a:ext uri="{FF2B5EF4-FFF2-40B4-BE49-F238E27FC236}">
                <a16:creationId xmlns:a16="http://schemas.microsoft.com/office/drawing/2014/main" id="{05D259E3-F102-FD78-86AC-41459BBF3936}"/>
              </a:ext>
            </a:extLst>
          </p:cNvPr>
          <p:cNvPicPr>
            <a:picLocks noChangeAspect="1"/>
          </p:cNvPicPr>
          <p:nvPr/>
        </p:nvPicPr>
        <p:blipFill>
          <a:blip r:embed="rId3"/>
          <a:stretch>
            <a:fillRect/>
          </a:stretch>
        </p:blipFill>
        <p:spPr>
          <a:xfrm>
            <a:off x="8098364" y="582364"/>
            <a:ext cx="3834844" cy="2475442"/>
          </a:xfrm>
          <a:prstGeom prst="rect">
            <a:avLst/>
          </a:prstGeom>
        </p:spPr>
      </p:pic>
      <p:sp>
        <p:nvSpPr>
          <p:cNvPr id="9" name="Oval 8">
            <a:extLst>
              <a:ext uri="{FF2B5EF4-FFF2-40B4-BE49-F238E27FC236}">
                <a16:creationId xmlns:a16="http://schemas.microsoft.com/office/drawing/2014/main" id="{5F32714F-E9C0-1187-B044-1098DE24B850}"/>
              </a:ext>
            </a:extLst>
          </p:cNvPr>
          <p:cNvSpPr/>
          <p:nvPr/>
        </p:nvSpPr>
        <p:spPr>
          <a:xfrm>
            <a:off x="9508453" y="1080445"/>
            <a:ext cx="1113586" cy="1081437"/>
          </a:xfrm>
          <a:prstGeom prst="ellipse">
            <a:avLst/>
          </a:prstGeom>
          <a:noFill/>
          <a:ln w="28575">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Oval 10">
            <a:extLst>
              <a:ext uri="{FF2B5EF4-FFF2-40B4-BE49-F238E27FC236}">
                <a16:creationId xmlns:a16="http://schemas.microsoft.com/office/drawing/2014/main" id="{6FE9D977-E081-0C96-5A6F-6246BD1C63B9}"/>
              </a:ext>
            </a:extLst>
          </p:cNvPr>
          <p:cNvSpPr/>
          <p:nvPr/>
        </p:nvSpPr>
        <p:spPr>
          <a:xfrm>
            <a:off x="6770897" y="1821278"/>
            <a:ext cx="817253" cy="1074381"/>
          </a:xfrm>
          <a:prstGeom prst="ellipse">
            <a:avLst/>
          </a:prstGeom>
          <a:noFill/>
          <a:ln w="28575">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322528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X-ray of a person&amp;#39;s chest&#10;&#10;Description automatically generated">
            <a:extLst>
              <a:ext uri="{FF2B5EF4-FFF2-40B4-BE49-F238E27FC236}">
                <a16:creationId xmlns:a16="http://schemas.microsoft.com/office/drawing/2014/main" id="{A6F75A81-814B-699D-7CC0-2F38B1DBF462}"/>
              </a:ext>
            </a:extLst>
          </p:cNvPr>
          <p:cNvPicPr>
            <a:picLocks noChangeAspect="1"/>
          </p:cNvPicPr>
          <p:nvPr/>
        </p:nvPicPr>
        <p:blipFill>
          <a:blip r:embed="rId2"/>
          <a:stretch>
            <a:fillRect/>
          </a:stretch>
        </p:blipFill>
        <p:spPr>
          <a:xfrm>
            <a:off x="6820861" y="1634138"/>
            <a:ext cx="4537421" cy="4486194"/>
          </a:xfrm>
          <a:prstGeom prst="rect">
            <a:avLst/>
          </a:prstGeom>
        </p:spPr>
      </p:pic>
      <p:sp>
        <p:nvSpPr>
          <p:cNvPr id="4" name="TextBox 3">
            <a:extLst>
              <a:ext uri="{FF2B5EF4-FFF2-40B4-BE49-F238E27FC236}">
                <a16:creationId xmlns:a16="http://schemas.microsoft.com/office/drawing/2014/main" id="{D283376C-E258-9B0F-B62B-D694E979149E}"/>
              </a:ext>
            </a:extLst>
          </p:cNvPr>
          <p:cNvSpPr txBox="1"/>
          <p:nvPr/>
        </p:nvSpPr>
        <p:spPr>
          <a:xfrm>
            <a:off x="8021831" y="629258"/>
            <a:ext cx="2171026" cy="52322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2800" dirty="0"/>
              <a:t>Broken Port </a:t>
            </a:r>
            <a:endParaRPr lang="en-US" dirty="0"/>
          </a:p>
        </p:txBody>
      </p:sp>
      <p:sp>
        <p:nvSpPr>
          <p:cNvPr id="5" name="TextBox 4">
            <a:extLst>
              <a:ext uri="{FF2B5EF4-FFF2-40B4-BE49-F238E27FC236}">
                <a16:creationId xmlns:a16="http://schemas.microsoft.com/office/drawing/2014/main" id="{BD07E713-A39B-5678-BB8F-FB4DAF545BA7}"/>
              </a:ext>
            </a:extLst>
          </p:cNvPr>
          <p:cNvSpPr txBox="1"/>
          <p:nvPr/>
        </p:nvSpPr>
        <p:spPr>
          <a:xfrm>
            <a:off x="1714519" y="680484"/>
            <a:ext cx="2471983" cy="954107"/>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2800" dirty="0"/>
              <a:t>Broken Broviac</a:t>
            </a:r>
            <a:endParaRPr lang="en-US" dirty="0"/>
          </a:p>
        </p:txBody>
      </p:sp>
      <p:pic>
        <p:nvPicPr>
          <p:cNvPr id="6" name="Picture 5" descr="X-ray of a person&amp;#39;s chest&#10;&#10;Description automatically generated">
            <a:extLst>
              <a:ext uri="{FF2B5EF4-FFF2-40B4-BE49-F238E27FC236}">
                <a16:creationId xmlns:a16="http://schemas.microsoft.com/office/drawing/2014/main" id="{B712A7C5-71E4-8212-4326-C6BBB95A457C}"/>
              </a:ext>
            </a:extLst>
          </p:cNvPr>
          <p:cNvPicPr>
            <a:picLocks noChangeAspect="1"/>
          </p:cNvPicPr>
          <p:nvPr/>
        </p:nvPicPr>
        <p:blipFill>
          <a:blip r:embed="rId3"/>
          <a:stretch>
            <a:fillRect/>
          </a:stretch>
        </p:blipFill>
        <p:spPr>
          <a:xfrm>
            <a:off x="829522" y="1637340"/>
            <a:ext cx="4840366" cy="4486194"/>
          </a:xfrm>
          <a:prstGeom prst="rect">
            <a:avLst/>
          </a:prstGeom>
        </p:spPr>
      </p:pic>
      <p:sp>
        <p:nvSpPr>
          <p:cNvPr id="7" name="Oval 6">
            <a:extLst>
              <a:ext uri="{FF2B5EF4-FFF2-40B4-BE49-F238E27FC236}">
                <a16:creationId xmlns:a16="http://schemas.microsoft.com/office/drawing/2014/main" id="{4DE769C2-A501-0F43-6419-2C9CD2D1132E}"/>
              </a:ext>
            </a:extLst>
          </p:cNvPr>
          <p:cNvSpPr/>
          <p:nvPr/>
        </p:nvSpPr>
        <p:spPr>
          <a:xfrm>
            <a:off x="3245676" y="2640687"/>
            <a:ext cx="364895" cy="691381"/>
          </a:xfrm>
          <a:prstGeom prst="ellipse">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Oval 8">
            <a:extLst>
              <a:ext uri="{FF2B5EF4-FFF2-40B4-BE49-F238E27FC236}">
                <a16:creationId xmlns:a16="http://schemas.microsoft.com/office/drawing/2014/main" id="{6464D224-469B-223B-5282-CCCB0FA56301}"/>
              </a:ext>
            </a:extLst>
          </p:cNvPr>
          <p:cNvSpPr/>
          <p:nvPr/>
        </p:nvSpPr>
        <p:spPr>
          <a:xfrm>
            <a:off x="7599961" y="2038771"/>
            <a:ext cx="512172" cy="768221"/>
          </a:xfrm>
          <a:prstGeom prst="ellipse">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818458034"/>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EDE86FA-127C-32B5-5E79-B776E06C8F1C}"/>
              </a:ext>
            </a:extLst>
          </p:cNvPr>
          <p:cNvSpPr>
            <a:spLocks noGrp="1"/>
          </p:cNvSpPr>
          <p:nvPr>
            <p:ph type="title"/>
          </p:nvPr>
        </p:nvSpPr>
        <p:spPr>
          <a:xfrm>
            <a:off x="838200" y="684866"/>
            <a:ext cx="10515600" cy="929719"/>
          </a:xfrm>
        </p:spPr>
        <p:txBody>
          <a:bodyPr/>
          <a:lstStyle/>
          <a:p>
            <a:pPr>
              <a:spcBef>
                <a:spcPts val="1000"/>
              </a:spcBef>
            </a:pPr>
            <a:r>
              <a:rPr lang="en-US" dirty="0">
                <a:latin typeface="Aptos Display"/>
              </a:rPr>
              <a:t>Line Dysfunction (occlusion)</a:t>
            </a:r>
          </a:p>
          <a:p>
            <a:endParaRPr lang="en-US" dirty="0"/>
          </a:p>
        </p:txBody>
      </p:sp>
      <p:sp>
        <p:nvSpPr>
          <p:cNvPr id="3" name="Content Placeholder 2">
            <a:extLst>
              <a:ext uri="{FF2B5EF4-FFF2-40B4-BE49-F238E27FC236}">
                <a16:creationId xmlns:a16="http://schemas.microsoft.com/office/drawing/2014/main" id="{1C74E49B-EF04-8C3D-7D26-98DBD002E7B7}"/>
              </a:ext>
            </a:extLst>
          </p:cNvPr>
          <p:cNvSpPr>
            <a:spLocks noGrp="1"/>
          </p:cNvSpPr>
          <p:nvPr>
            <p:ph idx="1"/>
          </p:nvPr>
        </p:nvSpPr>
        <p:spPr>
          <a:xfrm>
            <a:off x="410028" y="1711245"/>
            <a:ext cx="10515600" cy="4351338"/>
          </a:xfrm>
        </p:spPr>
        <p:txBody>
          <a:bodyPr vert="horz" lIns="91440" tIns="45720" rIns="91440" bIns="45720" rtlCol="0" anchor="t">
            <a:normAutofit/>
          </a:bodyPr>
          <a:lstStyle/>
          <a:p>
            <a:r>
              <a:rPr lang="en-US" dirty="0">
                <a:ea typeface="+mn-lt"/>
                <a:cs typeface="+mn-lt"/>
              </a:rPr>
              <a:t>Within 1–2 years of catheter placement, 15–35% of patients will experience a CVC occlusion. </a:t>
            </a:r>
          </a:p>
          <a:p>
            <a:r>
              <a:rPr lang="en-US" dirty="0">
                <a:ea typeface="+mn-lt"/>
                <a:cs typeface="+mn-lt"/>
              </a:rPr>
              <a:t>Can be </a:t>
            </a:r>
            <a:r>
              <a:rPr lang="en-US" dirty="0"/>
              <a:t>partial or complete occlusion</a:t>
            </a:r>
          </a:p>
          <a:p>
            <a:r>
              <a:rPr lang="en-US" dirty="0"/>
              <a:t>Greater risk if </a:t>
            </a:r>
            <a:r>
              <a:rPr lang="en-US">
                <a:ea typeface="+mn-lt"/>
                <a:cs typeface="+mn-lt"/>
              </a:rPr>
              <a:t>tunneled (larger diameter) line, multiple lumens, a distal tip.</a:t>
            </a:r>
          </a:p>
          <a:p>
            <a:endParaRPr lang="en-US" dirty="0"/>
          </a:p>
          <a:p>
            <a:endParaRPr lang="en-US" dirty="0"/>
          </a:p>
          <a:p>
            <a:endParaRPr lang="en-US" dirty="0"/>
          </a:p>
        </p:txBody>
      </p:sp>
      <p:pic>
        <p:nvPicPr>
          <p:cNvPr id="4" name="Picture 3" descr="CVC fibrinsheath.jpg">
            <a:extLst>
              <a:ext uri="{FF2B5EF4-FFF2-40B4-BE49-F238E27FC236}">
                <a16:creationId xmlns:a16="http://schemas.microsoft.com/office/drawing/2014/main" id="{6CEBC467-148F-4F34-2DCF-5CB061C2F9E8}"/>
              </a:ext>
            </a:extLst>
          </p:cNvPr>
          <p:cNvPicPr>
            <a:picLocks noChangeAspect="1"/>
          </p:cNvPicPr>
          <p:nvPr/>
        </p:nvPicPr>
        <p:blipFill>
          <a:blip r:embed="rId3"/>
          <a:stretch>
            <a:fillRect/>
          </a:stretch>
        </p:blipFill>
        <p:spPr>
          <a:xfrm>
            <a:off x="8490404" y="3573236"/>
            <a:ext cx="3346449" cy="3282043"/>
          </a:xfrm>
          <a:prstGeom prst="rect">
            <a:avLst/>
          </a:prstGeom>
        </p:spPr>
      </p:pic>
    </p:spTree>
    <p:extLst>
      <p:ext uri="{BB962C8B-B14F-4D97-AF65-F5344CB8AC3E}">
        <p14:creationId xmlns:p14="http://schemas.microsoft.com/office/powerpoint/2010/main" val="1022786307"/>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ABA23EE-C15F-B75B-E6B0-94DC56DAFC1D}"/>
              </a:ext>
            </a:extLst>
          </p:cNvPr>
          <p:cNvSpPr>
            <a:spLocks noGrp="1"/>
          </p:cNvSpPr>
          <p:nvPr>
            <p:ph type="title"/>
          </p:nvPr>
        </p:nvSpPr>
        <p:spPr/>
        <p:txBody>
          <a:bodyPr/>
          <a:lstStyle/>
          <a:p>
            <a:r>
              <a:rPr lang="en-US"/>
              <a:t>Etiologies: </a:t>
            </a:r>
          </a:p>
        </p:txBody>
      </p:sp>
      <p:sp>
        <p:nvSpPr>
          <p:cNvPr id="3" name="Content Placeholder 2">
            <a:extLst>
              <a:ext uri="{FF2B5EF4-FFF2-40B4-BE49-F238E27FC236}">
                <a16:creationId xmlns:a16="http://schemas.microsoft.com/office/drawing/2014/main" id="{6E0CC8E0-6974-A9C5-368B-AA1D2079188B}"/>
              </a:ext>
            </a:extLst>
          </p:cNvPr>
          <p:cNvSpPr>
            <a:spLocks noGrp="1"/>
          </p:cNvSpPr>
          <p:nvPr>
            <p:ph idx="1"/>
          </p:nvPr>
        </p:nvSpPr>
        <p:spPr>
          <a:xfrm>
            <a:off x="838200" y="1825625"/>
            <a:ext cx="10819051" cy="4351338"/>
          </a:xfrm>
        </p:spPr>
        <p:txBody>
          <a:bodyPr vert="horz" lIns="91440" tIns="45720" rIns="91440" bIns="45720" rtlCol="0" anchor="t">
            <a:normAutofit/>
          </a:bodyPr>
          <a:lstStyle/>
          <a:p>
            <a:r>
              <a:rPr lang="en-US"/>
              <a:t>Mechanical (eg: line clamping, repeated kinking, direct trauma)</a:t>
            </a:r>
          </a:p>
          <a:p>
            <a:r>
              <a:rPr lang="en-US"/>
              <a:t>Postural</a:t>
            </a:r>
          </a:p>
          <a:p>
            <a:r>
              <a:rPr lang="en-US"/>
              <a:t>Precipitate (from incompatible mixtures or inappropriate med concentration)</a:t>
            </a:r>
          </a:p>
          <a:p>
            <a:r>
              <a:rPr lang="en-US"/>
              <a:t>Thrombosis</a:t>
            </a:r>
          </a:p>
        </p:txBody>
      </p:sp>
    </p:spTree>
    <p:extLst>
      <p:ext uri="{BB962C8B-B14F-4D97-AF65-F5344CB8AC3E}">
        <p14:creationId xmlns:p14="http://schemas.microsoft.com/office/powerpoint/2010/main" val="56513389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6611131-E80D-221F-0518-F063E22D7C00}"/>
              </a:ext>
            </a:extLst>
          </p:cNvPr>
          <p:cNvSpPr>
            <a:spLocks noGrp="1"/>
          </p:cNvSpPr>
          <p:nvPr>
            <p:ph type="title"/>
          </p:nvPr>
        </p:nvSpPr>
        <p:spPr/>
        <p:txBody>
          <a:bodyPr/>
          <a:lstStyle/>
          <a:p>
            <a:r>
              <a:rPr lang="en-US" dirty="0"/>
              <a:t>Introduction</a:t>
            </a:r>
          </a:p>
        </p:txBody>
      </p:sp>
      <p:sp>
        <p:nvSpPr>
          <p:cNvPr id="3" name="Content Placeholder 2">
            <a:extLst>
              <a:ext uri="{FF2B5EF4-FFF2-40B4-BE49-F238E27FC236}">
                <a16:creationId xmlns:a16="http://schemas.microsoft.com/office/drawing/2014/main" id="{A954158A-E692-9D38-448A-CBA2603BCC28}"/>
              </a:ext>
            </a:extLst>
          </p:cNvPr>
          <p:cNvSpPr>
            <a:spLocks noGrp="1"/>
          </p:cNvSpPr>
          <p:nvPr>
            <p:ph idx="1"/>
          </p:nvPr>
        </p:nvSpPr>
        <p:spPr/>
        <p:txBody>
          <a:bodyPr vert="horz" lIns="91440" tIns="45720" rIns="91440" bIns="45720" rtlCol="0" anchor="t">
            <a:normAutofit/>
          </a:bodyPr>
          <a:lstStyle/>
          <a:p>
            <a:pPr marL="457200" indent="-457200"/>
            <a:r>
              <a:rPr lang="en-US" dirty="0">
                <a:ea typeface="+mn-lt"/>
                <a:cs typeface="+mn-lt"/>
              </a:rPr>
              <a:t>Short Bowel (SB): residual SB length of less than 25% expected for gestational age. </a:t>
            </a:r>
            <a:endParaRPr lang="en-US"/>
          </a:p>
          <a:p>
            <a:pPr marL="914400" lvl="1" indent="-457200">
              <a:buFont typeface="Courier New" panose="020B0604020202020204" pitchFamily="34" charset="0"/>
              <a:buChar char="o"/>
            </a:pPr>
            <a:r>
              <a:rPr lang="en-US" dirty="0">
                <a:ea typeface="+mn-lt"/>
                <a:cs typeface="+mn-lt"/>
              </a:rPr>
              <a:t>Most common causes of SBS: necrotizing enterocolitis (NEC), intestinal volvulus, and intestinal malformations.  </a:t>
            </a:r>
          </a:p>
          <a:p>
            <a:pPr marL="457200" indent="-457200"/>
            <a:r>
              <a:rPr lang="en-US" dirty="0">
                <a:ea typeface="+mn-lt"/>
                <a:cs typeface="+mn-lt"/>
              </a:rPr>
              <a:t>Decreased surface area for nutrient absorption -&gt; malabsorption, FTT, Intestinal Failure (IF) </a:t>
            </a:r>
          </a:p>
          <a:p>
            <a:pPr marL="457200" indent="-457200"/>
            <a:r>
              <a:rPr lang="en-US" dirty="0">
                <a:ea typeface="+mn-lt"/>
                <a:cs typeface="+mn-lt"/>
              </a:rPr>
              <a:t>IF: </a:t>
            </a:r>
            <a:r>
              <a:rPr lang="en-US" i="1" dirty="0">
                <a:ea typeface="+mn-lt"/>
                <a:cs typeface="+mn-lt"/>
              </a:rPr>
              <a:t>"Reduction of gut function below the minimum necessary for the absorption of macronutrients and/or water and electrolytes, such that IVF is required to maintain health and/or growth"</a:t>
            </a:r>
          </a:p>
          <a:p>
            <a:endParaRPr lang="en-US" i="1" dirty="0">
              <a:ea typeface="+mn-lt"/>
              <a:cs typeface="+mn-lt"/>
            </a:endParaRPr>
          </a:p>
        </p:txBody>
      </p:sp>
    </p:spTree>
    <p:extLst>
      <p:ext uri="{BB962C8B-B14F-4D97-AF65-F5344CB8AC3E}">
        <p14:creationId xmlns:p14="http://schemas.microsoft.com/office/powerpoint/2010/main" val="171105503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48941FB-E149-0D2C-B85E-E5D47986915D}"/>
              </a:ext>
            </a:extLst>
          </p:cNvPr>
          <p:cNvSpPr>
            <a:spLocks noGrp="1"/>
          </p:cNvSpPr>
          <p:nvPr>
            <p:ph type="title"/>
          </p:nvPr>
        </p:nvSpPr>
        <p:spPr>
          <a:xfrm>
            <a:off x="1041400" y="249011"/>
            <a:ext cx="10515600" cy="1325563"/>
          </a:xfrm>
        </p:spPr>
        <p:txBody>
          <a:bodyPr/>
          <a:lstStyle/>
          <a:p>
            <a:r>
              <a:rPr lang="en-US" dirty="0"/>
              <a:t>Thrombosis </a:t>
            </a:r>
          </a:p>
        </p:txBody>
      </p:sp>
      <p:sp>
        <p:nvSpPr>
          <p:cNvPr id="3" name="Content Placeholder 2">
            <a:extLst>
              <a:ext uri="{FF2B5EF4-FFF2-40B4-BE49-F238E27FC236}">
                <a16:creationId xmlns:a16="http://schemas.microsoft.com/office/drawing/2014/main" id="{7639CC8F-08C3-8406-49DC-53CA41C3EDD0}"/>
              </a:ext>
            </a:extLst>
          </p:cNvPr>
          <p:cNvSpPr>
            <a:spLocks noGrp="1"/>
          </p:cNvSpPr>
          <p:nvPr>
            <p:ph idx="1"/>
          </p:nvPr>
        </p:nvSpPr>
        <p:spPr>
          <a:xfrm>
            <a:off x="328840" y="3267981"/>
            <a:ext cx="10515600" cy="3589338"/>
          </a:xfrm>
        </p:spPr>
        <p:txBody>
          <a:bodyPr vert="horz" lIns="91440" tIns="45720" rIns="91440" bIns="45720" rtlCol="0" anchor="t">
            <a:normAutofit/>
          </a:bodyPr>
          <a:lstStyle/>
          <a:p>
            <a:r>
              <a:rPr lang="en-US" dirty="0">
                <a:ea typeface="+mn-lt"/>
                <a:cs typeface="+mn-lt"/>
              </a:rPr>
              <a:t>Fibrin sheath around the catheter tip  </a:t>
            </a:r>
          </a:p>
          <a:p>
            <a:r>
              <a:rPr lang="en-US" dirty="0">
                <a:ea typeface="+mn-lt"/>
                <a:cs typeface="+mn-lt"/>
              </a:rPr>
              <a:t>Intraluminal clot within the CVC  </a:t>
            </a:r>
            <a:endParaRPr lang="en-US"/>
          </a:p>
          <a:p>
            <a:r>
              <a:rPr lang="en-US" dirty="0">
                <a:ea typeface="+mn-lt"/>
                <a:cs typeface="+mn-lt"/>
              </a:rPr>
              <a:t>Catheter Related Thrombosis (CRT) secondary to endothelial damage, disrupted blood flow from the CVC, and hypercoagulable states (such as CLABSI, high Dex%)</a:t>
            </a:r>
          </a:p>
          <a:p>
            <a:r>
              <a:rPr lang="en-US" dirty="0">
                <a:ea typeface="+mn-lt"/>
                <a:cs typeface="+mn-lt"/>
              </a:rPr>
              <a:t>CRT have increased risk of CLABSI, PE, SVC syndrome.</a:t>
            </a:r>
            <a:endParaRPr lang="en-US" dirty="0"/>
          </a:p>
          <a:p>
            <a:endParaRPr lang="en-US" dirty="0"/>
          </a:p>
        </p:txBody>
      </p:sp>
      <p:pic>
        <p:nvPicPr>
          <p:cNvPr id="6" name="Picture 5" descr="Figure 1.">
            <a:extLst>
              <a:ext uri="{FF2B5EF4-FFF2-40B4-BE49-F238E27FC236}">
                <a16:creationId xmlns:a16="http://schemas.microsoft.com/office/drawing/2014/main" id="{4BFA40AF-853D-CFF9-DF8A-410FE0CFD66E}"/>
              </a:ext>
            </a:extLst>
          </p:cNvPr>
          <p:cNvPicPr>
            <a:picLocks noChangeAspect="1"/>
          </p:cNvPicPr>
          <p:nvPr/>
        </p:nvPicPr>
        <p:blipFill>
          <a:blip r:embed="rId3"/>
          <a:stretch>
            <a:fillRect/>
          </a:stretch>
        </p:blipFill>
        <p:spPr>
          <a:xfrm>
            <a:off x="6795068" y="124580"/>
            <a:ext cx="4573285" cy="3865638"/>
          </a:xfrm>
          <a:prstGeom prst="rect">
            <a:avLst/>
          </a:prstGeom>
        </p:spPr>
      </p:pic>
      <p:pic>
        <p:nvPicPr>
          <p:cNvPr id="8" name="Picture 7" descr="A diagram of a wall and wall clot&#10;&#10;Description automatically generated">
            <a:extLst>
              <a:ext uri="{FF2B5EF4-FFF2-40B4-BE49-F238E27FC236}">
                <a16:creationId xmlns:a16="http://schemas.microsoft.com/office/drawing/2014/main" id="{22CB9261-5166-8F4B-4E5C-424F7C469E83}"/>
              </a:ext>
            </a:extLst>
          </p:cNvPr>
          <p:cNvPicPr>
            <a:picLocks noChangeAspect="1"/>
          </p:cNvPicPr>
          <p:nvPr/>
        </p:nvPicPr>
        <p:blipFill>
          <a:blip r:embed="rId4"/>
          <a:stretch>
            <a:fillRect/>
          </a:stretch>
        </p:blipFill>
        <p:spPr>
          <a:xfrm>
            <a:off x="1407372" y="1424543"/>
            <a:ext cx="4062781" cy="1726639"/>
          </a:xfrm>
          <a:prstGeom prst="rect">
            <a:avLst/>
          </a:prstGeom>
        </p:spPr>
      </p:pic>
    </p:spTree>
    <p:extLst>
      <p:ext uri="{BB962C8B-B14F-4D97-AF65-F5344CB8AC3E}">
        <p14:creationId xmlns:p14="http://schemas.microsoft.com/office/powerpoint/2010/main" val="209063308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8"/>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6"/>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3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6F5A5072-7B47-4D32-B52A-4EBBF590B8A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w="12700" cap="flat" cmpd="sng" algn="ctr">
            <a:noFill/>
            <a:prstDash val="solid"/>
            <a:miter lim="800000"/>
          </a:ln>
          <a:effectLst/>
          <a:extLst>
            <a:ext uri="{91240B29-F687-4F45-9708-019B960494DF}">
              <a14:hiddenLine xmlns:a14="http://schemas.microsoft.com/office/drawing/2010/main" w="12700" cap="flat" cmpd="sng" algn="ctr">
                <a:solidFill>
                  <a:schemeClr val="accent1">
                    <a:shade val="50000"/>
                  </a:schemeClr>
                </a:solidFill>
                <a:prstDash val="solid"/>
                <a:miter lim="800000"/>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9715DAF0-AE1B-46C9-8A6B-DB2AA05AB91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0800000">
            <a:off x="-2" y="-22693"/>
            <a:ext cx="12191999" cy="4374129"/>
          </a:xfrm>
          <a:prstGeom prst="rect">
            <a:avLst/>
          </a:prstGeom>
          <a:gradFill>
            <a:gsLst>
              <a:gs pos="0">
                <a:schemeClr val="accent1">
                  <a:lumMod val="75000"/>
                </a:schemeClr>
              </a:gs>
              <a:gs pos="100000">
                <a:srgbClr val="000000"/>
              </a:gs>
            </a:gsLst>
            <a:lin ang="15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6016219D-510E-4184-9090-6D5578A87BD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3908719" y="-3931841"/>
            <a:ext cx="4374557" cy="12192000"/>
          </a:xfrm>
          <a:prstGeom prst="rect">
            <a:avLst/>
          </a:prstGeom>
          <a:gradFill>
            <a:gsLst>
              <a:gs pos="40000">
                <a:schemeClr val="accent1">
                  <a:alpha val="0"/>
                </a:schemeClr>
              </a:gs>
              <a:gs pos="100000">
                <a:schemeClr val="accent1">
                  <a:lumMod val="75000"/>
                  <a:alpha val="52000"/>
                </a:schemeClr>
              </a:gs>
            </a:gsLst>
            <a:lin ang="24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13">
            <a:extLst>
              <a:ext uri="{FF2B5EF4-FFF2-40B4-BE49-F238E27FC236}">
                <a16:creationId xmlns:a16="http://schemas.microsoft.com/office/drawing/2014/main" id="{AFF4A713-7B75-4B21-90D7-5AB19547C72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4136696" y="-3703868"/>
            <a:ext cx="4374128" cy="11736479"/>
          </a:xfrm>
          <a:prstGeom prst="rect">
            <a:avLst/>
          </a:prstGeom>
          <a:gradFill>
            <a:gsLst>
              <a:gs pos="17000">
                <a:schemeClr val="accent1">
                  <a:alpha val="0"/>
                </a:schemeClr>
              </a:gs>
              <a:gs pos="100000">
                <a:srgbClr val="000000">
                  <a:alpha val="37000"/>
                </a:srgbClr>
              </a:gs>
            </a:gsLst>
            <a:lin ang="7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ectangle 15">
            <a:extLst>
              <a:ext uri="{FF2B5EF4-FFF2-40B4-BE49-F238E27FC236}">
                <a16:creationId xmlns:a16="http://schemas.microsoft.com/office/drawing/2014/main" id="{DC631C0B-6DA6-4E57-8231-CE32B3434A7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 y="-22690"/>
            <a:ext cx="8542485" cy="4374126"/>
          </a:xfrm>
          <a:prstGeom prst="rect">
            <a:avLst/>
          </a:prstGeom>
          <a:gradFill>
            <a:gsLst>
              <a:gs pos="0">
                <a:schemeClr val="accent1">
                  <a:lumMod val="50000"/>
                  <a:alpha val="0"/>
                </a:schemeClr>
              </a:gs>
              <a:gs pos="100000">
                <a:srgbClr val="000000">
                  <a:alpha val="25000"/>
                </a:srgbClr>
              </a:gs>
            </a:gsLst>
            <a:lin ang="186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Freeform: Shape 17">
            <a:extLst>
              <a:ext uri="{FF2B5EF4-FFF2-40B4-BE49-F238E27FC236}">
                <a16:creationId xmlns:a16="http://schemas.microsoft.com/office/drawing/2014/main" id="{C29501E6-A978-4A61-9689-9085AF97A53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2508972">
            <a:off x="5945431" y="-1032053"/>
            <a:ext cx="4990147" cy="4439131"/>
          </a:xfrm>
          <a:custGeom>
            <a:avLst/>
            <a:gdLst>
              <a:gd name="connsiteX0" fmla="*/ 4990147 w 4990147"/>
              <a:gd name="connsiteY0" fmla="*/ 2229378 h 4439131"/>
              <a:gd name="connsiteX1" fmla="*/ 917384 w 4990147"/>
              <a:gd name="connsiteY1" fmla="*/ 4439131 h 4439131"/>
              <a:gd name="connsiteX2" fmla="*/ 910814 w 4990147"/>
              <a:gd name="connsiteY2" fmla="*/ 4434219 h 4439131"/>
              <a:gd name="connsiteX3" fmla="*/ 0 w 4990147"/>
              <a:gd name="connsiteY3" fmla="*/ 2502877 h 4439131"/>
              <a:gd name="connsiteX4" fmla="*/ 2502877 w 4990147"/>
              <a:gd name="connsiteY4" fmla="*/ 0 h 4439131"/>
              <a:gd name="connsiteX5" fmla="*/ 4954904 w 4990147"/>
              <a:gd name="connsiteY5" fmla="*/ 1998460 h 443913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4990147" h="4439131">
                <a:moveTo>
                  <a:pt x="4990147" y="2229378"/>
                </a:moveTo>
                <a:lnTo>
                  <a:pt x="917384" y="4439131"/>
                </a:lnTo>
                <a:lnTo>
                  <a:pt x="910814" y="4434219"/>
                </a:lnTo>
                <a:cubicBezTo>
                  <a:pt x="354557" y="3975154"/>
                  <a:pt x="0" y="3280421"/>
                  <a:pt x="0" y="2502877"/>
                </a:cubicBezTo>
                <a:cubicBezTo>
                  <a:pt x="0" y="1120576"/>
                  <a:pt x="1120576" y="0"/>
                  <a:pt x="2502877" y="0"/>
                </a:cubicBezTo>
                <a:cubicBezTo>
                  <a:pt x="3712390" y="0"/>
                  <a:pt x="4721520" y="857941"/>
                  <a:pt x="4954904" y="1998460"/>
                </a:cubicBezTo>
                <a:close/>
              </a:path>
            </a:pathLst>
          </a:custGeom>
          <a:gradFill>
            <a:gsLst>
              <a:gs pos="0">
                <a:schemeClr val="accent1">
                  <a:alpha val="22000"/>
                </a:schemeClr>
              </a:gs>
              <a:gs pos="87000">
                <a:schemeClr val="accent1">
                  <a:lumMod val="60000"/>
                  <a:lumOff val="40000"/>
                  <a:alpha val="2000"/>
                </a:schemeClr>
              </a:gs>
            </a:gsLst>
            <a:lin ang="84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p>
        </p:txBody>
      </p:sp>
      <p:sp>
        <p:nvSpPr>
          <p:cNvPr id="2" name="Title 1">
            <a:extLst>
              <a:ext uri="{FF2B5EF4-FFF2-40B4-BE49-F238E27FC236}">
                <a16:creationId xmlns:a16="http://schemas.microsoft.com/office/drawing/2014/main" id="{1E63AA7C-D8CC-24E2-1927-C63C14BF6FAB}"/>
              </a:ext>
            </a:extLst>
          </p:cNvPr>
          <p:cNvSpPr>
            <a:spLocks noGrp="1"/>
          </p:cNvSpPr>
          <p:nvPr>
            <p:ph type="title"/>
          </p:nvPr>
        </p:nvSpPr>
        <p:spPr>
          <a:xfrm>
            <a:off x="1314824" y="735106"/>
            <a:ext cx="10053763" cy="2928470"/>
          </a:xfrm>
        </p:spPr>
        <p:txBody>
          <a:bodyPr vert="horz" lIns="91440" tIns="45720" rIns="91440" bIns="45720" rtlCol="0" anchor="b">
            <a:normAutofit/>
          </a:bodyPr>
          <a:lstStyle/>
          <a:p>
            <a:r>
              <a:rPr lang="en-US" sz="4800" kern="1200">
                <a:solidFill>
                  <a:srgbClr val="FFFFFF"/>
                </a:solidFill>
                <a:latin typeface="+mj-lt"/>
                <a:ea typeface="+mj-ea"/>
                <a:cs typeface="+mj-cs"/>
              </a:rPr>
              <a:t>Case 3:</a:t>
            </a:r>
          </a:p>
        </p:txBody>
      </p:sp>
      <p:sp>
        <p:nvSpPr>
          <p:cNvPr id="3" name="Text Placeholder 2">
            <a:extLst>
              <a:ext uri="{FF2B5EF4-FFF2-40B4-BE49-F238E27FC236}">
                <a16:creationId xmlns:a16="http://schemas.microsoft.com/office/drawing/2014/main" id="{6B57145F-A3D4-5C8F-5BBE-CC4E7BC1E90B}"/>
              </a:ext>
            </a:extLst>
          </p:cNvPr>
          <p:cNvSpPr>
            <a:spLocks noGrp="1"/>
          </p:cNvSpPr>
          <p:nvPr>
            <p:ph type="body" idx="1"/>
          </p:nvPr>
        </p:nvSpPr>
        <p:spPr>
          <a:xfrm>
            <a:off x="557195" y="4870824"/>
            <a:ext cx="11133206" cy="1458258"/>
          </a:xfrm>
        </p:spPr>
        <p:txBody>
          <a:bodyPr vert="horz" lIns="91440" tIns="45720" rIns="91440" bIns="45720" rtlCol="0" anchor="ctr">
            <a:noAutofit/>
          </a:bodyPr>
          <a:lstStyle/>
          <a:p>
            <a:r>
              <a:rPr lang="en-US" sz="3600" kern="1200" dirty="0">
                <a:solidFill>
                  <a:schemeClr val="tx1"/>
                </a:solidFill>
                <a:latin typeface="+mn-lt"/>
                <a:ea typeface="+mn-ea"/>
                <a:cs typeface="+mn-cs"/>
              </a:rPr>
              <a:t>Nurse reports she is no longer able to draw blood from central catheter in a 6-year-old boy who has IF and is currently admitted for CLABSI. </a:t>
            </a:r>
            <a:endParaRPr lang="en-US" sz="3600" kern="1200" dirty="0">
              <a:solidFill>
                <a:schemeClr val="tx1"/>
              </a:solidFill>
              <a:latin typeface="+mn-lt"/>
            </a:endParaRPr>
          </a:p>
        </p:txBody>
      </p:sp>
    </p:spTree>
    <p:extLst>
      <p:ext uri="{BB962C8B-B14F-4D97-AF65-F5344CB8AC3E}">
        <p14:creationId xmlns:p14="http://schemas.microsoft.com/office/powerpoint/2010/main" val="795419220"/>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6D64424-A927-6867-0632-D218B464FCAA}"/>
              </a:ext>
            </a:extLst>
          </p:cNvPr>
          <p:cNvSpPr>
            <a:spLocks noGrp="1"/>
          </p:cNvSpPr>
          <p:nvPr>
            <p:ph type="title"/>
          </p:nvPr>
        </p:nvSpPr>
        <p:spPr/>
        <p:txBody>
          <a:bodyPr/>
          <a:lstStyle/>
          <a:p>
            <a:r>
              <a:rPr lang="en-US" dirty="0"/>
              <a:t>Line Occlusion Management </a:t>
            </a:r>
          </a:p>
        </p:txBody>
      </p:sp>
      <p:sp>
        <p:nvSpPr>
          <p:cNvPr id="3" name="Content Placeholder 2">
            <a:extLst>
              <a:ext uri="{FF2B5EF4-FFF2-40B4-BE49-F238E27FC236}">
                <a16:creationId xmlns:a16="http://schemas.microsoft.com/office/drawing/2014/main" id="{6CCD5ABF-F289-6DF4-D01E-776F3BB7441A}"/>
              </a:ext>
            </a:extLst>
          </p:cNvPr>
          <p:cNvSpPr>
            <a:spLocks noGrp="1"/>
          </p:cNvSpPr>
          <p:nvPr>
            <p:ph idx="1"/>
          </p:nvPr>
        </p:nvSpPr>
        <p:spPr>
          <a:xfrm>
            <a:off x="403626" y="1580545"/>
            <a:ext cx="10542573" cy="5054119"/>
          </a:xfrm>
        </p:spPr>
        <p:txBody>
          <a:bodyPr vert="horz" lIns="91440" tIns="45720" rIns="91440" bIns="45720" rtlCol="0" anchor="t">
            <a:normAutofit fontScale="92500" lnSpcReduction="10000"/>
          </a:bodyPr>
          <a:lstStyle/>
          <a:p>
            <a:pPr marL="514350" indent="-514350">
              <a:lnSpc>
                <a:spcPct val="100000"/>
              </a:lnSpc>
              <a:buAutoNum type="arabicPeriod"/>
            </a:pPr>
            <a:r>
              <a:rPr lang="en-US" dirty="0"/>
              <a:t>Rule out external mechanical causes </a:t>
            </a:r>
            <a:endParaRPr lang="en-US"/>
          </a:p>
          <a:p>
            <a:pPr marL="514350" indent="-514350">
              <a:lnSpc>
                <a:spcPct val="100000"/>
              </a:lnSpc>
              <a:buAutoNum type="arabicPeriod"/>
            </a:pPr>
            <a:r>
              <a:rPr lang="en-US" dirty="0"/>
              <a:t>Attempt positional changes </a:t>
            </a:r>
          </a:p>
          <a:p>
            <a:pPr marL="514350" indent="-514350">
              <a:lnSpc>
                <a:spcPct val="100000"/>
              </a:lnSpc>
              <a:buAutoNum type="arabicPeriod"/>
            </a:pPr>
            <a:r>
              <a:rPr lang="en-US" dirty="0">
                <a:ea typeface="+mn-lt"/>
                <a:cs typeface="+mn-lt"/>
              </a:rPr>
              <a:t>CXR to assess for malposition and kink (+/- dye)</a:t>
            </a:r>
          </a:p>
          <a:p>
            <a:pPr marL="514350" indent="-514350">
              <a:lnSpc>
                <a:spcPct val="100000"/>
              </a:lnSpc>
              <a:buAutoNum type="arabicPeriod"/>
            </a:pPr>
            <a:r>
              <a:rPr lang="en-US" dirty="0"/>
              <a:t>NS flush for possible fibrin sheath (don't force it)</a:t>
            </a:r>
          </a:p>
          <a:p>
            <a:pPr marL="514350" indent="-514350">
              <a:lnSpc>
                <a:spcPct val="100000"/>
              </a:lnSpc>
              <a:buAutoNum type="arabicPeriod"/>
            </a:pPr>
            <a:r>
              <a:rPr lang="en-US" dirty="0"/>
              <a:t>Fibrinolytic agents like TPA (catalyzes conversion of plasminogen --&gt; plasmin)</a:t>
            </a:r>
          </a:p>
          <a:p>
            <a:pPr marL="514350" indent="-514350">
              <a:lnSpc>
                <a:spcPct val="100000"/>
              </a:lnSpc>
              <a:buAutoNum type="arabicPeriod"/>
            </a:pPr>
            <a:r>
              <a:rPr lang="en-US" dirty="0"/>
              <a:t>If TPA fails x2 , consider further imaging: Venous US (low sensitivity),</a:t>
            </a:r>
            <a:r>
              <a:rPr lang="en-US" dirty="0">
                <a:ea typeface="+mn-lt"/>
                <a:cs typeface="+mn-lt"/>
              </a:rPr>
              <a:t> CT/MR venography, Venography.</a:t>
            </a:r>
            <a:endParaRPr lang="en-US" dirty="0"/>
          </a:p>
          <a:p>
            <a:pPr marL="514350" indent="-514350">
              <a:lnSpc>
                <a:spcPct val="100000"/>
              </a:lnSpc>
              <a:buAutoNum type="arabicPeriod"/>
            </a:pPr>
            <a:r>
              <a:rPr lang="en-US" dirty="0"/>
              <a:t>Dislodge thrombus at tip of CVC with a guidewire</a:t>
            </a:r>
          </a:p>
          <a:p>
            <a:pPr marL="514350" indent="-514350">
              <a:lnSpc>
                <a:spcPct val="100000"/>
              </a:lnSpc>
              <a:buAutoNum type="arabicPeriod"/>
            </a:pPr>
            <a:r>
              <a:rPr lang="en-US" dirty="0"/>
              <a:t>Rewire the line </a:t>
            </a:r>
          </a:p>
          <a:p>
            <a:pPr marL="514350" indent="-514350">
              <a:lnSpc>
                <a:spcPct val="100000"/>
              </a:lnSpc>
              <a:buAutoNum type="arabicPeriod"/>
            </a:pPr>
            <a:r>
              <a:rPr lang="en-US" dirty="0"/>
              <a:t>Thrombus: LMWH for 6w-3m. </a:t>
            </a:r>
          </a:p>
        </p:txBody>
      </p:sp>
      <p:sp>
        <p:nvSpPr>
          <p:cNvPr id="4" name="TextBox 3">
            <a:extLst>
              <a:ext uri="{FF2B5EF4-FFF2-40B4-BE49-F238E27FC236}">
                <a16:creationId xmlns:a16="http://schemas.microsoft.com/office/drawing/2014/main" id="{BC1764D5-760C-CB8E-B008-E46689C2012F}"/>
              </a:ext>
            </a:extLst>
          </p:cNvPr>
          <p:cNvSpPr txBox="1"/>
          <p:nvPr/>
        </p:nvSpPr>
        <p:spPr>
          <a:xfrm>
            <a:off x="7048888" y="1210695"/>
            <a:ext cx="5296660" cy="194848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lvl="2">
              <a:lnSpc>
                <a:spcPct val="90000"/>
              </a:lnSpc>
              <a:spcBef>
                <a:spcPts val="500"/>
              </a:spcBef>
            </a:pPr>
            <a:r>
              <a:rPr lang="en-US" sz="2000" b="1" dirty="0">
                <a:ea typeface="+mn-lt"/>
                <a:cs typeface="+mn-lt"/>
              </a:rPr>
              <a:t>      </a:t>
            </a:r>
            <a:r>
              <a:rPr lang="en-US" sz="2000" b="1" u="sng" dirty="0">
                <a:ea typeface="+mn-lt"/>
                <a:cs typeface="+mn-lt"/>
              </a:rPr>
              <a:t>TPA (1mg/ml):</a:t>
            </a:r>
          </a:p>
          <a:p>
            <a:pPr marL="1257300" lvl="2" indent="-342900">
              <a:lnSpc>
                <a:spcPct val="90000"/>
              </a:lnSpc>
              <a:spcBef>
                <a:spcPts val="500"/>
              </a:spcBef>
              <a:buFont typeface="Arial"/>
              <a:buChar char="•"/>
            </a:pPr>
            <a:r>
              <a:rPr lang="en-US" sz="2000" dirty="0">
                <a:ea typeface="+mn-lt"/>
                <a:cs typeface="+mn-lt"/>
              </a:rPr>
              <a:t>&lt; 10kg: 0.5mg; &gt;10kg: 1mg</a:t>
            </a:r>
            <a:endParaRPr lang="en-US" dirty="0"/>
          </a:p>
          <a:p>
            <a:pPr marL="1257300" lvl="2" indent="-342900">
              <a:lnSpc>
                <a:spcPct val="90000"/>
              </a:lnSpc>
              <a:spcBef>
                <a:spcPts val="500"/>
              </a:spcBef>
              <a:buFont typeface="Arial"/>
              <a:buChar char="•"/>
            </a:pPr>
            <a:r>
              <a:rPr lang="en-US" sz="2000" dirty="0">
                <a:ea typeface="+mn-lt"/>
                <a:cs typeface="+mn-lt"/>
              </a:rPr>
              <a:t>Dilutes with NaCl and fill catheter lumen</a:t>
            </a:r>
          </a:p>
          <a:p>
            <a:pPr marL="1257300" lvl="2" indent="-342900">
              <a:lnSpc>
                <a:spcPct val="90000"/>
              </a:lnSpc>
              <a:spcBef>
                <a:spcPts val="500"/>
              </a:spcBef>
              <a:buFont typeface="Arial"/>
              <a:buChar char="•"/>
            </a:pPr>
            <a:r>
              <a:rPr lang="en-US" sz="2000" dirty="0">
                <a:ea typeface="+mn-lt"/>
                <a:cs typeface="+mn-lt"/>
              </a:rPr>
              <a:t>Leave in the lumen for 1-2 hours, aspirate TPA and flush with NS</a:t>
            </a:r>
            <a:endParaRPr lang="en-US" dirty="0"/>
          </a:p>
        </p:txBody>
      </p:sp>
      <p:sp>
        <p:nvSpPr>
          <p:cNvPr id="6" name="Rectangle: Rounded Corners 5">
            <a:extLst>
              <a:ext uri="{FF2B5EF4-FFF2-40B4-BE49-F238E27FC236}">
                <a16:creationId xmlns:a16="http://schemas.microsoft.com/office/drawing/2014/main" id="{C33B9BD3-ECFC-E1EF-D683-0E97D7FA1078}"/>
              </a:ext>
            </a:extLst>
          </p:cNvPr>
          <p:cNvSpPr/>
          <p:nvPr/>
        </p:nvSpPr>
        <p:spPr>
          <a:xfrm>
            <a:off x="7981894" y="953065"/>
            <a:ext cx="4125109" cy="2475921"/>
          </a:xfrm>
          <a:prstGeom prst="roundRect">
            <a:avLst/>
          </a:prstGeom>
          <a:noFill/>
          <a:ln w="28575">
            <a:solidFill>
              <a:srgbClr val="C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91948047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grpId="0" nodeType="clickEffect">
                                  <p:stCondLst>
                                    <p:cond delay="0"/>
                                  </p:stCondLst>
                                  <p:childTnLst>
                                    <p:set>
                                      <p:cBhvr>
                                        <p:cTn id="34"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grpId="0" nodeType="clickEffect">
                                  <p:stCondLst>
                                    <p:cond delay="0"/>
                                  </p:stCondLst>
                                  <p:childTnLst>
                                    <p:set>
                                      <p:cBhvr>
                                        <p:cTn id="38"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grpId="0" nodeType="clickEffect">
                                  <p:stCondLst>
                                    <p:cond delay="0"/>
                                  </p:stCondLst>
                                  <p:childTnLst>
                                    <p:set>
                                      <p:cBhvr>
                                        <p:cTn id="42" dur="1" fill="hold">
                                          <p:stCondLst>
                                            <p:cond delay="0"/>
                                          </p:stCondLst>
                                        </p:cTn>
                                        <p:tgtEl>
                                          <p:spTgt spid="6"/>
                                        </p:tgtEl>
                                        <p:attrNameLst>
                                          <p:attrName>style.visibility</p:attrName>
                                        </p:attrNameLst>
                                      </p:cBhvr>
                                      <p:to>
                                        <p:strVal val="visible"/>
                                      </p:to>
                                    </p:set>
                                  </p:childTnLst>
                                </p:cTn>
                              </p:par>
                              <p:par>
                                <p:cTn id="43" presetID="1" presetClass="entr" presetSubtype="0" fill="hold" grpId="0" nodeType="withEffect">
                                  <p:stCondLst>
                                    <p:cond delay="0"/>
                                  </p:stCondLst>
                                  <p:childTnLst>
                                    <p:set>
                                      <p:cBhvr>
                                        <p:cTn id="44" dur="1" fill="hold">
                                          <p:stCondLst>
                                            <p:cond delay="0"/>
                                          </p:stCondLst>
                                        </p:cTn>
                                        <p:tgtEl>
                                          <p:spTgt spid="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P spid="4" grpId="0"/>
      <p:bldP spid="6" grpId="0" animBg="1"/>
    </p:bld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D00203-E8F5-1EE6-096A-DC9422B980E3}"/>
              </a:ext>
            </a:extLst>
          </p:cNvPr>
          <p:cNvSpPr>
            <a:spLocks noGrp="1"/>
          </p:cNvSpPr>
          <p:nvPr>
            <p:ph type="title"/>
          </p:nvPr>
        </p:nvSpPr>
        <p:spPr/>
        <p:txBody>
          <a:bodyPr/>
          <a:lstStyle/>
          <a:p>
            <a:r>
              <a:rPr lang="en-US" dirty="0"/>
              <a:t>Occlusion prevention</a:t>
            </a:r>
          </a:p>
        </p:txBody>
      </p:sp>
      <p:sp>
        <p:nvSpPr>
          <p:cNvPr id="3" name="Content Placeholder 2">
            <a:extLst>
              <a:ext uri="{FF2B5EF4-FFF2-40B4-BE49-F238E27FC236}">
                <a16:creationId xmlns:a16="http://schemas.microsoft.com/office/drawing/2014/main" id="{B6FB2075-FE59-DFEA-3EE2-6A1D6EAFE127}"/>
              </a:ext>
            </a:extLst>
          </p:cNvPr>
          <p:cNvSpPr>
            <a:spLocks noGrp="1"/>
          </p:cNvSpPr>
          <p:nvPr>
            <p:ph idx="1"/>
          </p:nvPr>
        </p:nvSpPr>
        <p:spPr/>
        <p:txBody>
          <a:bodyPr vert="horz" lIns="91440" tIns="45720" rIns="91440" bIns="45720" rtlCol="0" anchor="t">
            <a:normAutofit/>
          </a:bodyPr>
          <a:lstStyle/>
          <a:p>
            <a:pPr>
              <a:buFont typeface="Courier New" panose="020B0604020202020204" pitchFamily="34" charset="0"/>
              <a:buChar char="o"/>
            </a:pPr>
            <a:r>
              <a:rPr lang="en-US" dirty="0">
                <a:ea typeface="+mn-lt"/>
                <a:cs typeface="+mn-lt"/>
              </a:rPr>
              <a:t>Medication-precipitate: </a:t>
            </a:r>
          </a:p>
          <a:p>
            <a:pPr lvl="1" indent="-285750">
              <a:buFont typeface="Courier New" panose="020B0604020202020204" pitchFamily="34" charset="0"/>
              <a:buChar char="o"/>
            </a:pPr>
            <a:r>
              <a:rPr lang="en-US" dirty="0">
                <a:ea typeface="+mn-lt"/>
                <a:cs typeface="+mn-lt"/>
              </a:rPr>
              <a:t>Flush CVC with NS between each medication dose</a:t>
            </a:r>
          </a:p>
          <a:p>
            <a:pPr lvl="1" indent="-285750">
              <a:buFont typeface="Courier New" panose="020B0604020202020204" pitchFamily="34" charset="0"/>
              <a:buChar char="o"/>
            </a:pPr>
            <a:r>
              <a:rPr lang="en-US" dirty="0">
                <a:ea typeface="+mn-lt"/>
                <a:cs typeface="+mn-lt"/>
              </a:rPr>
              <a:t>Don't give incompatible agents at the same time. </a:t>
            </a:r>
            <a:endParaRPr lang="en-US" dirty="0"/>
          </a:p>
          <a:p>
            <a:pPr marL="400050" lvl="1" indent="0">
              <a:buNone/>
            </a:pPr>
            <a:endParaRPr lang="en-US" dirty="0"/>
          </a:p>
          <a:p>
            <a:pPr>
              <a:buFont typeface="Courier New" panose="020B0604020202020204" pitchFamily="34" charset="0"/>
              <a:buChar char="o"/>
            </a:pPr>
            <a:r>
              <a:rPr lang="en-US" dirty="0"/>
              <a:t>Thrombosis:</a:t>
            </a:r>
          </a:p>
          <a:p>
            <a:pPr lvl="1" indent="-285750">
              <a:buFont typeface="Courier New" panose="020B0604020202020204" pitchFamily="34" charset="0"/>
              <a:buChar char="o"/>
            </a:pPr>
            <a:r>
              <a:rPr lang="en-US" dirty="0"/>
              <a:t>Flush CVS with NS </a:t>
            </a:r>
          </a:p>
          <a:p>
            <a:pPr lvl="1" indent="-285750">
              <a:buFont typeface="Courier New" panose="020B0604020202020204" pitchFamily="34" charset="0"/>
              <a:buChar char="o"/>
            </a:pPr>
            <a:r>
              <a:rPr lang="en-US" dirty="0"/>
              <a:t>Flush CVS with Heparin (prophylaxis)</a:t>
            </a:r>
          </a:p>
          <a:p>
            <a:pPr marL="400050" lvl="1" indent="0">
              <a:buNone/>
            </a:pPr>
            <a:r>
              <a:rPr lang="en-US" sz="2600" dirty="0"/>
              <a:t>*Prophylactic LMWH to prevent further thrombus in a patient with at least 1 chronic thrombus</a:t>
            </a:r>
            <a:endParaRPr lang="en-US" dirty="0"/>
          </a:p>
          <a:p>
            <a:pPr lvl="1" indent="-285750">
              <a:buFont typeface="Courier New" panose="020B0604020202020204" pitchFamily="34" charset="0"/>
              <a:buChar char="o"/>
            </a:pPr>
            <a:endParaRPr lang="en-US" dirty="0"/>
          </a:p>
          <a:p>
            <a:pPr marL="0" indent="0">
              <a:buNone/>
            </a:pPr>
            <a:endParaRPr lang="en-US" dirty="0"/>
          </a:p>
          <a:p>
            <a:pPr lvl="1" indent="-285750">
              <a:buFont typeface="Courier New" panose="020B0604020202020204" pitchFamily="34" charset="0"/>
              <a:buChar char="o"/>
            </a:pPr>
            <a:endParaRPr lang="en-US" dirty="0"/>
          </a:p>
          <a:p>
            <a:pPr marL="400050" lvl="1" indent="0">
              <a:buNone/>
            </a:pPr>
            <a:endParaRPr lang="en-US" dirty="0"/>
          </a:p>
          <a:p>
            <a:pPr>
              <a:buFont typeface="Courier New" panose="020B0604020202020204" pitchFamily="34" charset="0"/>
              <a:buChar char="o"/>
            </a:pPr>
            <a:endParaRPr lang="en-US" dirty="0"/>
          </a:p>
        </p:txBody>
      </p:sp>
    </p:spTree>
    <p:extLst>
      <p:ext uri="{BB962C8B-B14F-4D97-AF65-F5344CB8AC3E}">
        <p14:creationId xmlns:p14="http://schemas.microsoft.com/office/powerpoint/2010/main" val="281774215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3">
                                            <p:txEl>
                                              <p:pRg st="5" end="5"/>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3">
                                            <p:txEl>
                                              <p:pRg st="6" end="6"/>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E8C5286-2E95-EDD7-150F-1FD524545EA1}"/>
              </a:ext>
            </a:extLst>
          </p:cNvPr>
          <p:cNvSpPr>
            <a:spLocks noGrp="1"/>
          </p:cNvSpPr>
          <p:nvPr>
            <p:ph type="title"/>
          </p:nvPr>
        </p:nvSpPr>
        <p:spPr/>
        <p:txBody>
          <a:bodyPr/>
          <a:lstStyle/>
          <a:p>
            <a:r>
              <a:rPr lang="en-US" dirty="0"/>
              <a:t>When To Remove CVC?</a:t>
            </a:r>
          </a:p>
        </p:txBody>
      </p:sp>
      <p:sp>
        <p:nvSpPr>
          <p:cNvPr id="3" name="Content Placeholder 2">
            <a:extLst>
              <a:ext uri="{FF2B5EF4-FFF2-40B4-BE49-F238E27FC236}">
                <a16:creationId xmlns:a16="http://schemas.microsoft.com/office/drawing/2014/main" id="{FC73AACB-7825-85D8-03D0-48CD572599F9}"/>
              </a:ext>
            </a:extLst>
          </p:cNvPr>
          <p:cNvSpPr>
            <a:spLocks noGrp="1"/>
          </p:cNvSpPr>
          <p:nvPr>
            <p:ph idx="1"/>
          </p:nvPr>
        </p:nvSpPr>
        <p:spPr/>
        <p:txBody>
          <a:bodyPr vert="horz" lIns="91440" tIns="45720" rIns="91440" bIns="45720" rtlCol="0" anchor="t">
            <a:normAutofit/>
          </a:bodyPr>
          <a:lstStyle/>
          <a:p>
            <a:r>
              <a:rPr lang="en-US" dirty="0">
                <a:ea typeface="+mn-lt"/>
                <a:cs typeface="+mn-lt"/>
              </a:rPr>
              <a:t>Failed CLABSI therapy:</a:t>
            </a:r>
          </a:p>
          <a:p>
            <a:pPr lvl="1">
              <a:buFont typeface="Courier New" panose="020B0604020202020204" pitchFamily="34" charset="0"/>
              <a:buChar char="o"/>
            </a:pPr>
            <a:r>
              <a:rPr lang="en-US" dirty="0">
                <a:ea typeface="+mn-lt"/>
                <a:cs typeface="+mn-lt"/>
              </a:rPr>
              <a:t>Persistently positive blood cx for </a:t>
            </a:r>
            <a:r>
              <a:rPr lang="en-US" u="sng" dirty="0">
                <a:ea typeface="+mn-lt"/>
                <a:cs typeface="+mn-lt"/>
              </a:rPr>
              <a:t>&gt;</a:t>
            </a:r>
            <a:r>
              <a:rPr lang="en-US" dirty="0">
                <a:ea typeface="+mn-lt"/>
                <a:cs typeface="+mn-lt"/>
              </a:rPr>
              <a:t> 3 days despite appropriate antimicrobial therapy</a:t>
            </a:r>
          </a:p>
          <a:p>
            <a:pPr lvl="1">
              <a:buFont typeface="Courier New" panose="020B0604020202020204" pitchFamily="34" charset="0"/>
              <a:buChar char="o"/>
            </a:pPr>
            <a:r>
              <a:rPr lang="en-US" dirty="0">
                <a:ea typeface="+mn-lt"/>
                <a:cs typeface="+mn-lt"/>
              </a:rPr>
              <a:t>Recurrence of infection with the same organism and sensitivity profile (despite a prior completed Abx course) suggesting biofilm formation within the CVC</a:t>
            </a:r>
          </a:p>
          <a:p>
            <a:r>
              <a:rPr lang="en-US" dirty="0">
                <a:ea typeface="+mn-lt"/>
                <a:cs typeface="+mn-lt"/>
              </a:rPr>
              <a:t>Severe clinical compromise. </a:t>
            </a:r>
            <a:endParaRPr lang="en-US" dirty="0"/>
          </a:p>
          <a:p>
            <a:r>
              <a:rPr lang="en-US" dirty="0">
                <a:ea typeface="+mn-lt"/>
                <a:cs typeface="+mn-lt"/>
              </a:rPr>
              <a:t>Tunnel or pocket infections (inadequate response to IV Abx)</a:t>
            </a:r>
            <a:endParaRPr lang="en-US" dirty="0"/>
          </a:p>
          <a:p>
            <a:pPr marL="0" indent="0">
              <a:buNone/>
            </a:pPr>
            <a:endParaRPr lang="en-US" dirty="0"/>
          </a:p>
          <a:p>
            <a:endParaRPr lang="en-US" dirty="0"/>
          </a:p>
        </p:txBody>
      </p:sp>
    </p:spTree>
    <p:extLst>
      <p:ext uri="{BB962C8B-B14F-4D97-AF65-F5344CB8AC3E}">
        <p14:creationId xmlns:p14="http://schemas.microsoft.com/office/powerpoint/2010/main" val="220866029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3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6F5A5072-7B47-4D32-B52A-4EBBF590B8A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w="12700" cap="flat" cmpd="sng" algn="ctr">
            <a:noFill/>
            <a:prstDash val="solid"/>
            <a:miter lim="800000"/>
          </a:ln>
          <a:effectLst/>
          <a:extLst>
            <a:ext uri="{91240B29-F687-4F45-9708-019B960494DF}">
              <a14:hiddenLine xmlns:a14="http://schemas.microsoft.com/office/drawing/2010/main" w="12700" cap="flat" cmpd="sng" algn="ctr">
                <a:solidFill>
                  <a:schemeClr val="accent1">
                    <a:shade val="50000"/>
                  </a:schemeClr>
                </a:solidFill>
                <a:prstDash val="solid"/>
                <a:miter lim="800000"/>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9715DAF0-AE1B-46C9-8A6B-DB2AA05AB91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0800000">
            <a:off x="-2" y="-22693"/>
            <a:ext cx="12191999" cy="4374129"/>
          </a:xfrm>
          <a:prstGeom prst="rect">
            <a:avLst/>
          </a:prstGeom>
          <a:gradFill>
            <a:gsLst>
              <a:gs pos="0">
                <a:schemeClr val="accent1">
                  <a:lumMod val="75000"/>
                </a:schemeClr>
              </a:gs>
              <a:gs pos="100000">
                <a:srgbClr val="000000"/>
              </a:gs>
            </a:gsLst>
            <a:lin ang="15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6016219D-510E-4184-9090-6D5578A87BD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3908719" y="-3931841"/>
            <a:ext cx="4374557" cy="12192000"/>
          </a:xfrm>
          <a:prstGeom prst="rect">
            <a:avLst/>
          </a:prstGeom>
          <a:gradFill>
            <a:gsLst>
              <a:gs pos="40000">
                <a:schemeClr val="accent1">
                  <a:alpha val="0"/>
                </a:schemeClr>
              </a:gs>
              <a:gs pos="100000">
                <a:schemeClr val="accent1">
                  <a:lumMod val="75000"/>
                  <a:alpha val="52000"/>
                </a:schemeClr>
              </a:gs>
            </a:gsLst>
            <a:lin ang="24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13">
            <a:extLst>
              <a:ext uri="{FF2B5EF4-FFF2-40B4-BE49-F238E27FC236}">
                <a16:creationId xmlns:a16="http://schemas.microsoft.com/office/drawing/2014/main" id="{AFF4A713-7B75-4B21-90D7-5AB19547C72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4136696" y="-3703868"/>
            <a:ext cx="4374128" cy="11736479"/>
          </a:xfrm>
          <a:prstGeom prst="rect">
            <a:avLst/>
          </a:prstGeom>
          <a:gradFill>
            <a:gsLst>
              <a:gs pos="17000">
                <a:schemeClr val="accent1">
                  <a:alpha val="0"/>
                </a:schemeClr>
              </a:gs>
              <a:gs pos="100000">
                <a:srgbClr val="000000">
                  <a:alpha val="37000"/>
                </a:srgbClr>
              </a:gs>
            </a:gsLst>
            <a:lin ang="7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ectangle 15">
            <a:extLst>
              <a:ext uri="{FF2B5EF4-FFF2-40B4-BE49-F238E27FC236}">
                <a16:creationId xmlns:a16="http://schemas.microsoft.com/office/drawing/2014/main" id="{DC631C0B-6DA6-4E57-8231-CE32B3434A7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 y="-22690"/>
            <a:ext cx="8542485" cy="4374126"/>
          </a:xfrm>
          <a:prstGeom prst="rect">
            <a:avLst/>
          </a:prstGeom>
          <a:gradFill>
            <a:gsLst>
              <a:gs pos="0">
                <a:schemeClr val="accent1">
                  <a:lumMod val="50000"/>
                  <a:alpha val="0"/>
                </a:schemeClr>
              </a:gs>
              <a:gs pos="100000">
                <a:srgbClr val="000000">
                  <a:alpha val="25000"/>
                </a:srgbClr>
              </a:gs>
            </a:gsLst>
            <a:lin ang="186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Freeform: Shape 17">
            <a:extLst>
              <a:ext uri="{FF2B5EF4-FFF2-40B4-BE49-F238E27FC236}">
                <a16:creationId xmlns:a16="http://schemas.microsoft.com/office/drawing/2014/main" id="{C29501E6-A978-4A61-9689-9085AF97A53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2508972">
            <a:off x="5945431" y="-1032053"/>
            <a:ext cx="4990147" cy="4439131"/>
          </a:xfrm>
          <a:custGeom>
            <a:avLst/>
            <a:gdLst>
              <a:gd name="connsiteX0" fmla="*/ 4990147 w 4990147"/>
              <a:gd name="connsiteY0" fmla="*/ 2229378 h 4439131"/>
              <a:gd name="connsiteX1" fmla="*/ 917384 w 4990147"/>
              <a:gd name="connsiteY1" fmla="*/ 4439131 h 4439131"/>
              <a:gd name="connsiteX2" fmla="*/ 910814 w 4990147"/>
              <a:gd name="connsiteY2" fmla="*/ 4434219 h 4439131"/>
              <a:gd name="connsiteX3" fmla="*/ 0 w 4990147"/>
              <a:gd name="connsiteY3" fmla="*/ 2502877 h 4439131"/>
              <a:gd name="connsiteX4" fmla="*/ 2502877 w 4990147"/>
              <a:gd name="connsiteY4" fmla="*/ 0 h 4439131"/>
              <a:gd name="connsiteX5" fmla="*/ 4954904 w 4990147"/>
              <a:gd name="connsiteY5" fmla="*/ 1998460 h 443913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4990147" h="4439131">
                <a:moveTo>
                  <a:pt x="4990147" y="2229378"/>
                </a:moveTo>
                <a:lnTo>
                  <a:pt x="917384" y="4439131"/>
                </a:lnTo>
                <a:lnTo>
                  <a:pt x="910814" y="4434219"/>
                </a:lnTo>
                <a:cubicBezTo>
                  <a:pt x="354557" y="3975154"/>
                  <a:pt x="0" y="3280421"/>
                  <a:pt x="0" y="2502877"/>
                </a:cubicBezTo>
                <a:cubicBezTo>
                  <a:pt x="0" y="1120576"/>
                  <a:pt x="1120576" y="0"/>
                  <a:pt x="2502877" y="0"/>
                </a:cubicBezTo>
                <a:cubicBezTo>
                  <a:pt x="3712390" y="0"/>
                  <a:pt x="4721520" y="857941"/>
                  <a:pt x="4954904" y="1998460"/>
                </a:cubicBezTo>
                <a:close/>
              </a:path>
            </a:pathLst>
          </a:custGeom>
          <a:gradFill>
            <a:gsLst>
              <a:gs pos="0">
                <a:schemeClr val="accent1">
                  <a:alpha val="22000"/>
                </a:schemeClr>
              </a:gs>
              <a:gs pos="87000">
                <a:schemeClr val="accent1">
                  <a:lumMod val="60000"/>
                  <a:lumOff val="40000"/>
                  <a:alpha val="2000"/>
                </a:schemeClr>
              </a:gs>
            </a:gsLst>
            <a:lin ang="84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p>
        </p:txBody>
      </p:sp>
      <p:sp>
        <p:nvSpPr>
          <p:cNvPr id="2" name="Title 1">
            <a:extLst>
              <a:ext uri="{FF2B5EF4-FFF2-40B4-BE49-F238E27FC236}">
                <a16:creationId xmlns:a16="http://schemas.microsoft.com/office/drawing/2014/main" id="{1E63AA7C-D8CC-24E2-1927-C63C14BF6FAB}"/>
              </a:ext>
            </a:extLst>
          </p:cNvPr>
          <p:cNvSpPr>
            <a:spLocks noGrp="1"/>
          </p:cNvSpPr>
          <p:nvPr>
            <p:ph type="title"/>
          </p:nvPr>
        </p:nvSpPr>
        <p:spPr>
          <a:xfrm>
            <a:off x="1314824" y="735106"/>
            <a:ext cx="10053763" cy="2928470"/>
          </a:xfrm>
        </p:spPr>
        <p:txBody>
          <a:bodyPr vert="horz" lIns="91440" tIns="45720" rIns="91440" bIns="45720" rtlCol="0" anchor="b">
            <a:normAutofit/>
          </a:bodyPr>
          <a:lstStyle/>
          <a:p>
            <a:r>
              <a:rPr lang="en-US" sz="4800" kern="1200">
                <a:solidFill>
                  <a:srgbClr val="FFFFFF"/>
                </a:solidFill>
                <a:latin typeface="+mj-lt"/>
                <a:ea typeface="+mj-ea"/>
                <a:cs typeface="+mj-cs"/>
              </a:rPr>
              <a:t>Case 4:</a:t>
            </a:r>
          </a:p>
        </p:txBody>
      </p:sp>
      <p:sp>
        <p:nvSpPr>
          <p:cNvPr id="3" name="Text Placeholder 2">
            <a:extLst>
              <a:ext uri="{FF2B5EF4-FFF2-40B4-BE49-F238E27FC236}">
                <a16:creationId xmlns:a16="http://schemas.microsoft.com/office/drawing/2014/main" id="{6B57145F-A3D4-5C8F-5BBE-CC4E7BC1E90B}"/>
              </a:ext>
            </a:extLst>
          </p:cNvPr>
          <p:cNvSpPr>
            <a:spLocks noGrp="1"/>
          </p:cNvSpPr>
          <p:nvPr>
            <p:ph type="body" idx="1"/>
          </p:nvPr>
        </p:nvSpPr>
        <p:spPr>
          <a:xfrm>
            <a:off x="449653" y="4825234"/>
            <a:ext cx="11510949" cy="1458258"/>
          </a:xfrm>
        </p:spPr>
        <p:txBody>
          <a:bodyPr vert="horz" lIns="91440" tIns="45720" rIns="91440" bIns="45720" rtlCol="0" anchor="ctr">
            <a:noAutofit/>
          </a:bodyPr>
          <a:lstStyle/>
          <a:p>
            <a:r>
              <a:rPr lang="en-US" sz="3600" kern="1200" dirty="0">
                <a:solidFill>
                  <a:schemeClr val="tx1"/>
                </a:solidFill>
                <a:latin typeface="+mn-lt"/>
                <a:ea typeface="+mn-ea"/>
                <a:cs typeface="+mn-cs"/>
              </a:rPr>
              <a:t>Mother </a:t>
            </a:r>
            <a:r>
              <a:rPr lang="en-US" sz="3600" dirty="0">
                <a:solidFill>
                  <a:schemeClr val="tx1"/>
                </a:solidFill>
              </a:rPr>
              <a:t>presents to the ED and complains</a:t>
            </a:r>
            <a:r>
              <a:rPr lang="en-US" sz="3600" kern="1200" dirty="0">
                <a:solidFill>
                  <a:schemeClr val="tx1"/>
                </a:solidFill>
                <a:latin typeface="+mn-lt"/>
                <a:ea typeface="+mn-ea"/>
                <a:cs typeface="+mn-cs"/>
              </a:rPr>
              <a:t> of significant drainage </a:t>
            </a:r>
            <a:r>
              <a:rPr lang="en-US" sz="3600" dirty="0">
                <a:solidFill>
                  <a:schemeClr val="tx1"/>
                </a:solidFill>
              </a:rPr>
              <a:t>coming from</a:t>
            </a:r>
            <a:r>
              <a:rPr lang="en-US" sz="3600" kern="1200" dirty="0">
                <a:solidFill>
                  <a:schemeClr val="tx1"/>
                </a:solidFill>
                <a:latin typeface="+mn-lt"/>
                <a:ea typeface="+mn-ea"/>
                <a:cs typeface="+mn-cs"/>
              </a:rPr>
              <a:t> </a:t>
            </a:r>
            <a:r>
              <a:rPr lang="en-US" sz="3600" dirty="0">
                <a:solidFill>
                  <a:schemeClr val="tx1"/>
                </a:solidFill>
              </a:rPr>
              <a:t>her child's </a:t>
            </a:r>
            <a:r>
              <a:rPr lang="en-US" sz="3600" kern="1200" dirty="0">
                <a:solidFill>
                  <a:schemeClr val="tx1"/>
                </a:solidFill>
                <a:latin typeface="+mn-lt"/>
                <a:ea typeface="+mn-ea"/>
                <a:cs typeface="+mn-cs"/>
              </a:rPr>
              <a:t>GT for the past 6 months</a:t>
            </a:r>
            <a:r>
              <a:rPr lang="en-US" sz="3600" dirty="0">
                <a:solidFill>
                  <a:schemeClr val="tx1"/>
                </a:solidFill>
              </a:rPr>
              <a:t>,</a:t>
            </a:r>
            <a:r>
              <a:rPr lang="en-US" sz="3600" kern="1200" dirty="0">
                <a:solidFill>
                  <a:schemeClr val="tx1"/>
                </a:solidFill>
                <a:latin typeface="+mn-lt"/>
                <a:ea typeface="+mn-ea"/>
                <a:cs typeface="+mn-cs"/>
              </a:rPr>
              <a:t> and </a:t>
            </a:r>
            <a:r>
              <a:rPr lang="en-US" sz="3600" dirty="0">
                <a:solidFill>
                  <a:schemeClr val="tx1"/>
                </a:solidFill>
              </a:rPr>
              <a:t>she noticed</a:t>
            </a:r>
            <a:r>
              <a:rPr lang="en-US" sz="3600" kern="1200" dirty="0">
                <a:solidFill>
                  <a:schemeClr val="tx1"/>
                </a:solidFill>
                <a:latin typeface="+mn-lt"/>
                <a:ea typeface="+mn-ea"/>
                <a:cs typeface="+mn-cs"/>
              </a:rPr>
              <a:t> some skin breakdown around </a:t>
            </a:r>
            <a:r>
              <a:rPr lang="en-US" sz="3600" dirty="0">
                <a:solidFill>
                  <a:schemeClr val="tx1"/>
                </a:solidFill>
              </a:rPr>
              <a:t>it</a:t>
            </a:r>
            <a:r>
              <a:rPr lang="en-US" sz="3600" kern="1200" dirty="0">
                <a:solidFill>
                  <a:schemeClr val="tx1"/>
                </a:solidFill>
                <a:latin typeface="+mn-lt"/>
                <a:ea typeface="+mn-ea"/>
                <a:cs typeface="+mn-cs"/>
              </a:rPr>
              <a:t>. </a:t>
            </a:r>
            <a:endParaRPr lang="en-US" sz="3600" kern="1200" dirty="0">
              <a:solidFill>
                <a:schemeClr val="tx1"/>
              </a:solidFill>
              <a:latin typeface="+mn-lt"/>
            </a:endParaRPr>
          </a:p>
        </p:txBody>
      </p:sp>
    </p:spTree>
    <p:extLst>
      <p:ext uri="{BB962C8B-B14F-4D97-AF65-F5344CB8AC3E}">
        <p14:creationId xmlns:p14="http://schemas.microsoft.com/office/powerpoint/2010/main" val="1117081788"/>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B724AC0-21F1-4947-B039-8B916AD90503}"/>
              </a:ext>
            </a:extLst>
          </p:cNvPr>
          <p:cNvSpPr>
            <a:spLocks noGrp="1"/>
          </p:cNvSpPr>
          <p:nvPr>
            <p:ph type="title"/>
          </p:nvPr>
        </p:nvSpPr>
        <p:spPr>
          <a:xfrm>
            <a:off x="4200273" y="120770"/>
            <a:ext cx="4253248" cy="1336295"/>
          </a:xfrm>
        </p:spPr>
        <p:txBody>
          <a:bodyPr>
            <a:normAutofit/>
          </a:bodyPr>
          <a:lstStyle/>
          <a:p>
            <a:pPr algn="ctr"/>
            <a:r>
              <a:rPr lang="en-US" sz="2800" dirty="0"/>
              <a:t>Avanos MIC-KEY Gastrostomy Tube </a:t>
            </a:r>
            <a:endParaRPr lang="en-US"/>
          </a:p>
        </p:txBody>
      </p:sp>
      <p:sp>
        <p:nvSpPr>
          <p:cNvPr id="5" name="TextBox 4">
            <a:extLst>
              <a:ext uri="{FF2B5EF4-FFF2-40B4-BE49-F238E27FC236}">
                <a16:creationId xmlns:a16="http://schemas.microsoft.com/office/drawing/2014/main" id="{9F58DC41-9621-4087-B8B6-EE4695F2E993}"/>
              </a:ext>
            </a:extLst>
          </p:cNvPr>
          <p:cNvSpPr txBox="1"/>
          <p:nvPr/>
        </p:nvSpPr>
        <p:spPr>
          <a:xfrm>
            <a:off x="4340299" y="4907050"/>
            <a:ext cx="4338774" cy="369332"/>
          </a:xfrm>
          <a:prstGeom prst="rect">
            <a:avLst/>
          </a:prstGeom>
          <a:noFill/>
        </p:spPr>
        <p:txBody>
          <a:bodyPr wrap="square" rtlCol="0">
            <a:spAutoFit/>
          </a:bodyPr>
          <a:lstStyle/>
          <a:p>
            <a:r>
              <a:rPr lang="en-US" dirty="0"/>
              <a:t>  Balloon inflated with 5 ml sterile water</a:t>
            </a:r>
          </a:p>
        </p:txBody>
      </p:sp>
      <p:sp>
        <p:nvSpPr>
          <p:cNvPr id="7" name="Title 1">
            <a:extLst>
              <a:ext uri="{FF2B5EF4-FFF2-40B4-BE49-F238E27FC236}">
                <a16:creationId xmlns:a16="http://schemas.microsoft.com/office/drawing/2014/main" id="{9D47461E-0BB7-AAC9-5DA2-D49CDDA91C13}"/>
              </a:ext>
            </a:extLst>
          </p:cNvPr>
          <p:cNvSpPr txBox="1">
            <a:spLocks/>
          </p:cNvSpPr>
          <p:nvPr/>
        </p:nvSpPr>
        <p:spPr>
          <a:xfrm>
            <a:off x="232292" y="218307"/>
            <a:ext cx="3727361" cy="1336295"/>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2800" dirty="0"/>
              <a:t>AMT </a:t>
            </a:r>
            <a:r>
              <a:rPr lang="en-US" sz="2800" err="1"/>
              <a:t>MiniONE</a:t>
            </a:r>
            <a:r>
              <a:rPr lang="en-US" sz="2800" dirty="0"/>
              <a:t> Gastrostomy Tube </a:t>
            </a:r>
            <a:endParaRPr lang="en-US"/>
          </a:p>
        </p:txBody>
      </p:sp>
      <p:sp>
        <p:nvSpPr>
          <p:cNvPr id="12" name="TextBox 11">
            <a:extLst>
              <a:ext uri="{FF2B5EF4-FFF2-40B4-BE49-F238E27FC236}">
                <a16:creationId xmlns:a16="http://schemas.microsoft.com/office/drawing/2014/main" id="{782AAF26-D644-5F01-EDCE-1FD6496CC9B0}"/>
              </a:ext>
            </a:extLst>
          </p:cNvPr>
          <p:cNvSpPr txBox="1"/>
          <p:nvPr/>
        </p:nvSpPr>
        <p:spPr>
          <a:xfrm>
            <a:off x="848" y="4907050"/>
            <a:ext cx="4338774" cy="369332"/>
          </a:xfrm>
          <a:prstGeom prst="rect">
            <a:avLst/>
          </a:prstGeom>
          <a:noFill/>
        </p:spPr>
        <p:txBody>
          <a:bodyPr wrap="square" lIns="91440" tIns="45720" rIns="91440" bIns="45720" rtlCol="0" anchor="t">
            <a:spAutoFit/>
          </a:bodyPr>
          <a:lstStyle/>
          <a:p>
            <a:r>
              <a:rPr lang="en-US" dirty="0"/>
              <a:t>  Balloon inflated with 4 ml sterile water</a:t>
            </a:r>
          </a:p>
        </p:txBody>
      </p:sp>
      <p:sp>
        <p:nvSpPr>
          <p:cNvPr id="14" name="Title 1">
            <a:extLst>
              <a:ext uri="{FF2B5EF4-FFF2-40B4-BE49-F238E27FC236}">
                <a16:creationId xmlns:a16="http://schemas.microsoft.com/office/drawing/2014/main" id="{EE865E3E-5B67-AF73-D7E3-344A997681D8}"/>
              </a:ext>
            </a:extLst>
          </p:cNvPr>
          <p:cNvSpPr txBox="1">
            <a:spLocks/>
          </p:cNvSpPr>
          <p:nvPr/>
        </p:nvSpPr>
        <p:spPr>
          <a:xfrm>
            <a:off x="8345510" y="218306"/>
            <a:ext cx="3846472" cy="1338588"/>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ctr"/>
            <a:r>
              <a:rPr lang="en-US" sz="2800" dirty="0"/>
              <a:t>Avanos MIC* Gastrostomy Tube </a:t>
            </a:r>
            <a:endParaRPr lang="en-US"/>
          </a:p>
        </p:txBody>
      </p:sp>
      <p:pic>
        <p:nvPicPr>
          <p:cNvPr id="16" name="Picture 2" descr="A close-up of a medical device&#10;&#10;Description automatically generated">
            <a:extLst>
              <a:ext uri="{FF2B5EF4-FFF2-40B4-BE49-F238E27FC236}">
                <a16:creationId xmlns:a16="http://schemas.microsoft.com/office/drawing/2014/main" id="{52B19BB3-93DE-EACA-F901-197D9A1D6DA5}"/>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8453057" y="1610763"/>
            <a:ext cx="3631574" cy="3631574"/>
          </a:xfrm>
          <a:prstGeom prst="rect">
            <a:avLst/>
          </a:prstGeom>
          <a:noFill/>
          <a:extLst>
            <a:ext uri="{909E8E84-426E-40DD-AFC4-6F175D3DCCD1}">
              <a14:hiddenFill xmlns:a14="http://schemas.microsoft.com/office/drawing/2010/main">
                <a:solidFill>
                  <a:srgbClr val="FFFFFF"/>
                </a:solidFill>
              </a14:hiddenFill>
            </a:ext>
          </a:extLst>
        </p:spPr>
      </p:pic>
      <p:pic>
        <p:nvPicPr>
          <p:cNvPr id="17" name="Picture 16" descr="A close-up of a plastic tube&#10;&#10;Description automatically generated">
            <a:extLst>
              <a:ext uri="{FF2B5EF4-FFF2-40B4-BE49-F238E27FC236}">
                <a16:creationId xmlns:a16="http://schemas.microsoft.com/office/drawing/2014/main" id="{F472A4CB-E883-4C2B-81DA-6562322C25FA}"/>
              </a:ext>
            </a:extLst>
          </p:cNvPr>
          <p:cNvPicPr>
            <a:picLocks noChangeAspect="1"/>
          </p:cNvPicPr>
          <p:nvPr/>
        </p:nvPicPr>
        <p:blipFill>
          <a:blip r:embed="rId4"/>
          <a:stretch>
            <a:fillRect/>
          </a:stretch>
        </p:blipFill>
        <p:spPr>
          <a:xfrm>
            <a:off x="4976860" y="1376441"/>
            <a:ext cx="2599924" cy="3352800"/>
          </a:xfrm>
          <a:prstGeom prst="rect">
            <a:avLst/>
          </a:prstGeom>
        </p:spPr>
      </p:pic>
      <p:pic>
        <p:nvPicPr>
          <p:cNvPr id="18" name="Picture 17" descr="AMT MiniONE® Gastrostomy Tube Balloon Button Kit, with ENFit® Adapter,">
            <a:extLst>
              <a:ext uri="{FF2B5EF4-FFF2-40B4-BE49-F238E27FC236}">
                <a16:creationId xmlns:a16="http://schemas.microsoft.com/office/drawing/2014/main" id="{710D269B-2DED-A3C6-53D4-BDDE8ACC3173}"/>
              </a:ext>
            </a:extLst>
          </p:cNvPr>
          <p:cNvPicPr>
            <a:picLocks noChangeAspect="1"/>
          </p:cNvPicPr>
          <p:nvPr/>
        </p:nvPicPr>
        <p:blipFill>
          <a:blip r:embed="rId5"/>
          <a:stretch>
            <a:fillRect/>
          </a:stretch>
        </p:blipFill>
        <p:spPr>
          <a:xfrm>
            <a:off x="587533" y="1608142"/>
            <a:ext cx="3016876" cy="2995411"/>
          </a:xfrm>
          <a:prstGeom prst="rect">
            <a:avLst/>
          </a:prstGeom>
        </p:spPr>
      </p:pic>
    </p:spTree>
    <p:extLst>
      <p:ext uri="{BB962C8B-B14F-4D97-AF65-F5344CB8AC3E}">
        <p14:creationId xmlns:p14="http://schemas.microsoft.com/office/powerpoint/2010/main" val="1585369059"/>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Content Placeholder 3" descr="A diagram of a balloon button&#10;&#10;Description automatically generated">
            <a:extLst>
              <a:ext uri="{FF2B5EF4-FFF2-40B4-BE49-F238E27FC236}">
                <a16:creationId xmlns:a16="http://schemas.microsoft.com/office/drawing/2014/main" id="{15754B00-BE5C-ACB5-D817-0B03BBCC147B}"/>
              </a:ext>
            </a:extLst>
          </p:cNvPr>
          <p:cNvPicPr>
            <a:picLocks noGrp="1" noChangeAspect="1"/>
          </p:cNvPicPr>
          <p:nvPr>
            <p:ph idx="1"/>
          </p:nvPr>
        </p:nvPicPr>
        <p:blipFill>
          <a:blip r:embed="rId2"/>
          <a:stretch>
            <a:fillRect/>
          </a:stretch>
        </p:blipFill>
        <p:spPr>
          <a:xfrm>
            <a:off x="1122590" y="301599"/>
            <a:ext cx="9790338" cy="6174748"/>
          </a:xfrm>
        </p:spPr>
      </p:pic>
    </p:spTree>
    <p:extLst>
      <p:ext uri="{BB962C8B-B14F-4D97-AF65-F5344CB8AC3E}">
        <p14:creationId xmlns:p14="http://schemas.microsoft.com/office/powerpoint/2010/main" val="3594639168"/>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Diagram 3">
            <a:extLst>
              <a:ext uri="{FF2B5EF4-FFF2-40B4-BE49-F238E27FC236}">
                <a16:creationId xmlns:a16="http://schemas.microsoft.com/office/drawing/2014/main" id="{05D739F9-2718-402C-89C7-6EA977CB517F}"/>
              </a:ext>
            </a:extLst>
          </p:cNvPr>
          <p:cNvGraphicFramePr/>
          <p:nvPr>
            <p:extLst>
              <p:ext uri="{D42A27DB-BD31-4B8C-83A1-F6EECF244321}">
                <p14:modId xmlns:p14="http://schemas.microsoft.com/office/powerpoint/2010/main" val="3798019454"/>
              </p:ext>
            </p:extLst>
          </p:nvPr>
        </p:nvGraphicFramePr>
        <p:xfrm>
          <a:off x="-119321" y="87953"/>
          <a:ext cx="11936540" cy="4456119"/>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6" name="TextBox 5">
            <a:extLst>
              <a:ext uri="{FF2B5EF4-FFF2-40B4-BE49-F238E27FC236}">
                <a16:creationId xmlns:a16="http://schemas.microsoft.com/office/drawing/2014/main" id="{ED9C0DF9-D82E-4405-8519-FC4A50EDC839}"/>
              </a:ext>
            </a:extLst>
          </p:cNvPr>
          <p:cNvSpPr txBox="1"/>
          <p:nvPr/>
        </p:nvSpPr>
        <p:spPr>
          <a:xfrm>
            <a:off x="693990" y="4623415"/>
            <a:ext cx="9599149" cy="2246769"/>
          </a:xfrm>
          <a:prstGeom prst="rect">
            <a:avLst/>
          </a:prstGeom>
          <a:noFill/>
          <a:ln>
            <a:solidFill>
              <a:schemeClr val="tx1"/>
            </a:solidFill>
          </a:ln>
        </p:spPr>
        <p:txBody>
          <a:bodyPr wrap="square" lIns="91440" tIns="45720" rIns="91440" bIns="45720" rtlCol="0" anchor="t">
            <a:spAutoFit/>
          </a:bodyPr>
          <a:lstStyle/>
          <a:p>
            <a:r>
              <a:rPr lang="en-US" sz="1400" dirty="0">
                <a:solidFill>
                  <a:srgbClr val="FF0000"/>
                </a:solidFill>
              </a:rPr>
              <a:t>Leaking may </a:t>
            </a:r>
            <a:r>
              <a:rPr lang="en-US" sz="1400" b="1" u="sng" dirty="0">
                <a:solidFill>
                  <a:srgbClr val="FF0000"/>
                </a:solidFill>
              </a:rPr>
              <a:t>increase</a:t>
            </a:r>
            <a:r>
              <a:rPr lang="en-US" sz="1400" dirty="0">
                <a:solidFill>
                  <a:srgbClr val="FF0000"/>
                </a:solidFill>
              </a:rPr>
              <a:t> at certain times of illness and require more frequent cleaning and skin care; it doesn’t necessarily mean it need to be changed.</a:t>
            </a:r>
          </a:p>
          <a:p>
            <a:pPr marL="742950" lvl="1" indent="-285750">
              <a:buFont typeface="Arial" panose="020B0604020202020204" pitchFamily="34" charset="0"/>
              <a:buChar char="•"/>
            </a:pPr>
            <a:r>
              <a:rPr lang="en-US" sz="1400" u="sng" dirty="0"/>
              <a:t>Coughing, vomiting, diarrhea</a:t>
            </a:r>
            <a:r>
              <a:rPr lang="en-US" sz="1400" dirty="0"/>
              <a:t>: this may increase intra-abdominal pressure and increase leaking</a:t>
            </a:r>
          </a:p>
          <a:p>
            <a:pPr marL="742950" lvl="1" indent="-285750">
              <a:buFont typeface="Arial" panose="020B0604020202020204" pitchFamily="34" charset="0"/>
              <a:buChar char="•"/>
            </a:pPr>
            <a:r>
              <a:rPr lang="en-US" sz="1400" u="sng" dirty="0">
                <a:sym typeface="Wingdings" panose="05000000000000000000" pitchFamily="2" charset="2"/>
              </a:rPr>
              <a:t>Viral/bacterial illness</a:t>
            </a:r>
            <a:r>
              <a:rPr lang="en-US" sz="1400" dirty="0">
                <a:sym typeface="Wingdings" panose="05000000000000000000" pitchFamily="2" charset="2"/>
              </a:rPr>
              <a:t>: i.e. Pharyngitis, sinusitis, or any diagnosis which slow down the GI tract and/or motility </a:t>
            </a:r>
            <a:endParaRPr lang="en-US" sz="1400" dirty="0"/>
          </a:p>
          <a:p>
            <a:pPr marL="742950" lvl="1" indent="-285750">
              <a:buFont typeface="Arial" panose="020B0604020202020204" pitchFamily="34" charset="0"/>
              <a:buChar char="•"/>
            </a:pPr>
            <a:r>
              <a:rPr lang="en-US" sz="1400" u="sng" dirty="0">
                <a:sym typeface="Wingdings" panose="05000000000000000000" pitchFamily="2" charset="2"/>
              </a:rPr>
              <a:t>Increased secretions</a:t>
            </a:r>
            <a:r>
              <a:rPr lang="en-US" sz="1400" dirty="0">
                <a:sym typeface="Wingdings" panose="05000000000000000000" pitchFamily="2" charset="2"/>
              </a:rPr>
              <a:t>: this goes along with URI symptoms, intra-abdominal pressure increases</a:t>
            </a:r>
            <a:endParaRPr lang="en-US" sz="1400" dirty="0"/>
          </a:p>
          <a:p>
            <a:pPr marL="742950" lvl="1" indent="-285750">
              <a:buFont typeface="Arial" panose="020B0604020202020204" pitchFamily="34" charset="0"/>
              <a:buChar char="•"/>
            </a:pPr>
            <a:r>
              <a:rPr lang="en-US" sz="1400" u="sng" dirty="0">
                <a:sym typeface="Wingdings" panose="05000000000000000000" pitchFamily="2" charset="2"/>
              </a:rPr>
              <a:t>Constipation</a:t>
            </a:r>
            <a:r>
              <a:rPr lang="en-US" sz="1400" dirty="0">
                <a:sym typeface="Wingdings" panose="05000000000000000000" pitchFamily="2" charset="2"/>
              </a:rPr>
              <a:t>: when the patient does not have a BM for an atypical amount of time, intra-abdominal pressure will increase leakage</a:t>
            </a:r>
            <a:endParaRPr lang="en-US" sz="1400" dirty="0"/>
          </a:p>
          <a:p>
            <a:pPr marL="742950" lvl="1" indent="-285750">
              <a:buFont typeface="Arial" panose="020B0604020202020204" pitchFamily="34" charset="0"/>
              <a:buChar char="•"/>
            </a:pPr>
            <a:r>
              <a:rPr lang="en-US" sz="1400" u="sng" dirty="0">
                <a:sym typeface="Wingdings" panose="05000000000000000000" pitchFamily="2" charset="2"/>
              </a:rPr>
              <a:t>Ventilated patients: </a:t>
            </a:r>
            <a:r>
              <a:rPr lang="en-US" sz="1400" dirty="0">
                <a:sym typeface="Wingdings" panose="05000000000000000000" pitchFamily="2" charset="2"/>
              </a:rPr>
              <a:t>HIGH likelihood for leakage   skin care is key</a:t>
            </a:r>
            <a:endParaRPr lang="en-US" sz="1400" dirty="0"/>
          </a:p>
          <a:p>
            <a:pPr marL="742950" lvl="1" indent="-285750">
              <a:buFont typeface="Arial" panose="020B0604020202020204" pitchFamily="34" charset="0"/>
              <a:buChar char="•"/>
            </a:pPr>
            <a:r>
              <a:rPr lang="en-US" sz="1400" u="sng" dirty="0">
                <a:sym typeface="Wingdings" panose="05000000000000000000" pitchFamily="2" charset="2"/>
              </a:rPr>
              <a:t>Post-Op (first 8-12 weeks): </a:t>
            </a:r>
            <a:r>
              <a:rPr lang="en-US" sz="1400" dirty="0">
                <a:sym typeface="Wingdings" panose="05000000000000000000" pitchFamily="2" charset="2"/>
              </a:rPr>
              <a:t>tubes cannot be changed until the first 8-12 week follow up. If GT leakage is present, or tube is too tight, skin care is essential</a:t>
            </a:r>
            <a:endParaRPr lang="en-US" sz="1400" dirty="0"/>
          </a:p>
        </p:txBody>
      </p:sp>
      <p:sp>
        <p:nvSpPr>
          <p:cNvPr id="7" name="Rectangle 6">
            <a:extLst>
              <a:ext uri="{FF2B5EF4-FFF2-40B4-BE49-F238E27FC236}">
                <a16:creationId xmlns:a16="http://schemas.microsoft.com/office/drawing/2014/main" id="{CC73BC73-64B2-4D2C-B3B9-65B62A0C36AC}"/>
              </a:ext>
            </a:extLst>
          </p:cNvPr>
          <p:cNvSpPr/>
          <p:nvPr/>
        </p:nvSpPr>
        <p:spPr>
          <a:xfrm rot="19403747">
            <a:off x="7659607" y="878744"/>
            <a:ext cx="738231" cy="234893"/>
          </a:xfrm>
          <a:prstGeom prst="rect">
            <a:avLst/>
          </a:prstGeom>
          <a:solidFill>
            <a:schemeClr val="accent2">
              <a:lumMod val="75000"/>
            </a:schemeClr>
          </a:solidFill>
          <a:ln>
            <a:solidFill>
              <a:schemeClr val="accent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Yes</a:t>
            </a:r>
          </a:p>
        </p:txBody>
      </p:sp>
      <p:sp>
        <p:nvSpPr>
          <p:cNvPr id="8" name="Rectangle 7">
            <a:extLst>
              <a:ext uri="{FF2B5EF4-FFF2-40B4-BE49-F238E27FC236}">
                <a16:creationId xmlns:a16="http://schemas.microsoft.com/office/drawing/2014/main" id="{C9D0F1D3-DEF7-497A-854F-09D32EBF083C}"/>
              </a:ext>
            </a:extLst>
          </p:cNvPr>
          <p:cNvSpPr/>
          <p:nvPr/>
        </p:nvSpPr>
        <p:spPr>
          <a:xfrm rot="2212357">
            <a:off x="7662295" y="1989151"/>
            <a:ext cx="738231" cy="245828"/>
          </a:xfrm>
          <a:prstGeom prst="rect">
            <a:avLst/>
          </a:prstGeom>
          <a:solidFill>
            <a:srgbClr val="0070C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No</a:t>
            </a:r>
          </a:p>
        </p:txBody>
      </p:sp>
    </p:spTree>
    <p:extLst>
      <p:ext uri="{BB962C8B-B14F-4D97-AF65-F5344CB8AC3E}">
        <p14:creationId xmlns:p14="http://schemas.microsoft.com/office/powerpoint/2010/main" val="357535284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4" grpId="0">
        <p:bldAsOne/>
      </p:bldGraphic>
      <p:bldP spid="6" grpId="0" animBg="1"/>
    </p:bldLst>
  </p:timing>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264DE756-E4BD-CE65-DF99-0597DCD47AA5}"/>
              </a:ext>
            </a:extLst>
          </p:cNvPr>
          <p:cNvSpPr txBox="1"/>
          <p:nvPr/>
        </p:nvSpPr>
        <p:spPr>
          <a:xfrm>
            <a:off x="16282" y="641513"/>
            <a:ext cx="4132384" cy="1077218"/>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3200" dirty="0"/>
              <a:t>GT moisture from leakage:</a:t>
            </a:r>
            <a:endParaRPr lang="en-US"/>
          </a:p>
        </p:txBody>
      </p:sp>
      <p:pic>
        <p:nvPicPr>
          <p:cNvPr id="5" name="Content Placeholder 6" descr="A person&amp;#39;s hand holding a tube attached to a wound&#10;&#10;Description automatically generated">
            <a:extLst>
              <a:ext uri="{FF2B5EF4-FFF2-40B4-BE49-F238E27FC236}">
                <a16:creationId xmlns:a16="http://schemas.microsoft.com/office/drawing/2014/main" id="{5E1BA499-E711-9FE7-0FBC-EC5EF72903E5}"/>
              </a:ext>
            </a:extLst>
          </p:cNvPr>
          <p:cNvPicPr>
            <a:picLocks noChangeAspect="1"/>
          </p:cNvPicPr>
          <p:nvPr/>
        </p:nvPicPr>
        <p:blipFill>
          <a:blip r:embed="rId3"/>
          <a:stretch>
            <a:fillRect/>
          </a:stretch>
        </p:blipFill>
        <p:spPr>
          <a:xfrm>
            <a:off x="447571" y="1851676"/>
            <a:ext cx="3266550" cy="4351338"/>
          </a:xfrm>
          <a:prstGeom prst="rect">
            <a:avLst/>
          </a:prstGeom>
        </p:spPr>
      </p:pic>
      <p:sp>
        <p:nvSpPr>
          <p:cNvPr id="2" name="TextBox 1">
            <a:extLst>
              <a:ext uri="{FF2B5EF4-FFF2-40B4-BE49-F238E27FC236}">
                <a16:creationId xmlns:a16="http://schemas.microsoft.com/office/drawing/2014/main" id="{EFD2B7A6-04ED-F6EA-4A80-A8A55A074112}"/>
              </a:ext>
            </a:extLst>
          </p:cNvPr>
          <p:cNvSpPr txBox="1"/>
          <p:nvPr/>
        </p:nvSpPr>
        <p:spPr>
          <a:xfrm>
            <a:off x="7184188" y="1026918"/>
            <a:ext cx="4298461" cy="46166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2400" dirty="0"/>
              <a:t>Barrier creams with Zinc:</a:t>
            </a:r>
          </a:p>
        </p:txBody>
      </p:sp>
      <p:pic>
        <p:nvPicPr>
          <p:cNvPr id="4" name="Picture 3" descr="Calmoseptine Ointment">
            <a:extLst>
              <a:ext uri="{FF2B5EF4-FFF2-40B4-BE49-F238E27FC236}">
                <a16:creationId xmlns:a16="http://schemas.microsoft.com/office/drawing/2014/main" id="{23E5559A-91FB-189D-C2C3-43EF5910F9A1}"/>
              </a:ext>
            </a:extLst>
          </p:cNvPr>
          <p:cNvPicPr>
            <a:picLocks noChangeAspect="1"/>
          </p:cNvPicPr>
          <p:nvPr/>
        </p:nvPicPr>
        <p:blipFill>
          <a:blip r:embed="rId4"/>
          <a:stretch>
            <a:fillRect/>
          </a:stretch>
        </p:blipFill>
        <p:spPr>
          <a:xfrm>
            <a:off x="6892812" y="3427206"/>
            <a:ext cx="2743200" cy="2743200"/>
          </a:xfrm>
          <a:prstGeom prst="rect">
            <a:avLst/>
          </a:prstGeom>
        </p:spPr>
      </p:pic>
      <p:pic>
        <p:nvPicPr>
          <p:cNvPr id="7" name="Picture 6" descr="DESITIN Maximum Strength Original Paste 16 oz (Pack of 4)">
            <a:extLst>
              <a:ext uri="{FF2B5EF4-FFF2-40B4-BE49-F238E27FC236}">
                <a16:creationId xmlns:a16="http://schemas.microsoft.com/office/drawing/2014/main" id="{2B92E915-A43B-6795-FC93-BEA6249C106B}"/>
              </a:ext>
            </a:extLst>
          </p:cNvPr>
          <p:cNvPicPr>
            <a:picLocks noChangeAspect="1"/>
          </p:cNvPicPr>
          <p:nvPr/>
        </p:nvPicPr>
        <p:blipFill>
          <a:blip r:embed="rId5"/>
          <a:stretch>
            <a:fillRect/>
          </a:stretch>
        </p:blipFill>
        <p:spPr>
          <a:xfrm>
            <a:off x="4880882" y="1849747"/>
            <a:ext cx="2130878" cy="2199201"/>
          </a:xfrm>
          <a:prstGeom prst="rect">
            <a:avLst/>
          </a:prstGeom>
        </p:spPr>
      </p:pic>
      <p:pic>
        <p:nvPicPr>
          <p:cNvPr id="8" name="Picture 7" descr="Critic-Aid Skin Protectant 6 oz. 1947, 1 Ct">
            <a:extLst>
              <a:ext uri="{FF2B5EF4-FFF2-40B4-BE49-F238E27FC236}">
                <a16:creationId xmlns:a16="http://schemas.microsoft.com/office/drawing/2014/main" id="{43C49ADC-0AC6-29EF-2562-4A52BA117222}"/>
              </a:ext>
            </a:extLst>
          </p:cNvPr>
          <p:cNvPicPr>
            <a:picLocks noChangeAspect="1"/>
          </p:cNvPicPr>
          <p:nvPr/>
        </p:nvPicPr>
        <p:blipFill>
          <a:blip r:embed="rId6"/>
          <a:stretch>
            <a:fillRect/>
          </a:stretch>
        </p:blipFill>
        <p:spPr>
          <a:xfrm>
            <a:off x="10055928" y="2541815"/>
            <a:ext cx="1822856" cy="4114799"/>
          </a:xfrm>
          <a:prstGeom prst="rect">
            <a:avLst/>
          </a:prstGeom>
        </p:spPr>
      </p:pic>
      <p:cxnSp>
        <p:nvCxnSpPr>
          <p:cNvPr id="10" name="Straight Arrow Connector 9">
            <a:extLst>
              <a:ext uri="{FF2B5EF4-FFF2-40B4-BE49-F238E27FC236}">
                <a16:creationId xmlns:a16="http://schemas.microsoft.com/office/drawing/2014/main" id="{CDF0C96B-FFED-F26D-9152-38C3A53E2FAF}"/>
              </a:ext>
            </a:extLst>
          </p:cNvPr>
          <p:cNvCxnSpPr/>
          <p:nvPr/>
        </p:nvCxnSpPr>
        <p:spPr>
          <a:xfrm>
            <a:off x="3819356" y="4389169"/>
            <a:ext cx="1056009" cy="4046"/>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199010309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0"/>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2"/>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7"/>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4"/>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8"/>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1925F4E-5E30-00A5-9B04-38C836E65924}"/>
              </a:ext>
            </a:extLst>
          </p:cNvPr>
          <p:cNvSpPr>
            <a:spLocks noGrp="1"/>
          </p:cNvSpPr>
          <p:nvPr>
            <p:ph type="title"/>
          </p:nvPr>
        </p:nvSpPr>
        <p:spPr>
          <a:xfrm>
            <a:off x="838200" y="182674"/>
            <a:ext cx="10515600" cy="1325563"/>
          </a:xfrm>
        </p:spPr>
        <p:txBody>
          <a:bodyPr/>
          <a:lstStyle/>
          <a:p>
            <a:r>
              <a:rPr lang="en-US" dirty="0"/>
              <a:t>SBS categories based on anatomy: </a:t>
            </a:r>
          </a:p>
        </p:txBody>
      </p:sp>
      <p:pic>
        <p:nvPicPr>
          <p:cNvPr id="4" name="Picture 3" descr="A diagram of the internal organs&#10;&#10;Description automatically generated">
            <a:extLst>
              <a:ext uri="{FF2B5EF4-FFF2-40B4-BE49-F238E27FC236}">
                <a16:creationId xmlns:a16="http://schemas.microsoft.com/office/drawing/2014/main" id="{095C874A-45CB-3C70-46DB-FAC03429737C}"/>
              </a:ext>
            </a:extLst>
          </p:cNvPr>
          <p:cNvPicPr>
            <a:picLocks noChangeAspect="1"/>
          </p:cNvPicPr>
          <p:nvPr/>
        </p:nvPicPr>
        <p:blipFill>
          <a:blip r:embed="rId3"/>
          <a:stretch>
            <a:fillRect/>
          </a:stretch>
        </p:blipFill>
        <p:spPr>
          <a:xfrm>
            <a:off x="633438" y="1576760"/>
            <a:ext cx="10308464" cy="5282051"/>
          </a:xfrm>
          <a:prstGeom prst="rect">
            <a:avLst/>
          </a:prstGeom>
        </p:spPr>
      </p:pic>
    </p:spTree>
    <p:extLst>
      <p:ext uri="{BB962C8B-B14F-4D97-AF65-F5344CB8AC3E}">
        <p14:creationId xmlns:p14="http://schemas.microsoft.com/office/powerpoint/2010/main" val="4125576382"/>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7" name="Rectangle 6">
            <a:extLst>
              <a:ext uri="{FF2B5EF4-FFF2-40B4-BE49-F238E27FC236}">
                <a16:creationId xmlns:a16="http://schemas.microsoft.com/office/drawing/2014/main" id="{43C48B49-6135-48B6-AC0F-97E5D8D1F03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w="12700" cap="flat" cmpd="sng" algn="ctr">
            <a:noFill/>
            <a:prstDash val="solid"/>
            <a:miter lim="800000"/>
          </a:ln>
          <a:effectLst/>
          <a:extLst>
            <a:ext uri="{91240B29-F687-4F45-9708-019B960494DF}">
              <a14:hiddenLine xmlns:a14="http://schemas.microsoft.com/office/drawing/2010/main" w="12700" cap="flat" cmpd="sng" algn="ctr">
                <a:solidFill>
                  <a:schemeClr val="accent1">
                    <a:shade val="50000"/>
                  </a:schemeClr>
                </a:solidFill>
                <a:prstDash val="solid"/>
                <a:miter lim="800000"/>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1E63AA7C-D8CC-24E2-1927-C63C14BF6FAB}"/>
              </a:ext>
            </a:extLst>
          </p:cNvPr>
          <p:cNvSpPr>
            <a:spLocks noGrp="1"/>
          </p:cNvSpPr>
          <p:nvPr>
            <p:ph type="title"/>
          </p:nvPr>
        </p:nvSpPr>
        <p:spPr>
          <a:xfrm>
            <a:off x="1329766" y="1146412"/>
            <a:ext cx="9014348" cy="2402006"/>
          </a:xfrm>
        </p:spPr>
        <p:txBody>
          <a:bodyPr vert="horz" lIns="91440" tIns="45720" rIns="91440" bIns="45720" rtlCol="0" anchor="b">
            <a:normAutofit/>
          </a:bodyPr>
          <a:lstStyle/>
          <a:p>
            <a:r>
              <a:rPr lang="en-US" sz="4800" kern="1200">
                <a:solidFill>
                  <a:schemeClr val="tx1"/>
                </a:solidFill>
                <a:latin typeface="+mj-lt"/>
                <a:ea typeface="+mj-ea"/>
                <a:cs typeface="+mj-cs"/>
              </a:rPr>
              <a:t>Other GT/GJ complications:</a:t>
            </a:r>
          </a:p>
        </p:txBody>
      </p:sp>
      <p:sp>
        <p:nvSpPr>
          <p:cNvPr id="9" name="Rectangle 8">
            <a:extLst>
              <a:ext uri="{FF2B5EF4-FFF2-40B4-BE49-F238E27FC236}">
                <a16:creationId xmlns:a16="http://schemas.microsoft.com/office/drawing/2014/main" id="{9715DAF0-AE1B-46C9-8A6B-DB2AA05AB91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0800000">
            <a:off x="-8" y="4374554"/>
            <a:ext cx="12192007" cy="2483444"/>
          </a:xfrm>
          <a:prstGeom prst="rect">
            <a:avLst/>
          </a:prstGeom>
          <a:gradFill>
            <a:gsLst>
              <a:gs pos="0">
                <a:schemeClr val="accent1">
                  <a:lumMod val="75000"/>
                </a:schemeClr>
              </a:gs>
              <a:gs pos="100000">
                <a:srgbClr val="000000"/>
              </a:gs>
            </a:gsLst>
            <a:lin ang="156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a:extLst>
              <a:ext uri="{FF2B5EF4-FFF2-40B4-BE49-F238E27FC236}">
                <a16:creationId xmlns:a16="http://schemas.microsoft.com/office/drawing/2014/main" id="{DC631C0B-6DA6-4E57-8231-CE32B3434A7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0800000" flipH="1">
            <a:off x="8140655" y="4374554"/>
            <a:ext cx="4051344" cy="2483446"/>
          </a:xfrm>
          <a:prstGeom prst="rect">
            <a:avLst/>
          </a:prstGeom>
          <a:gradFill>
            <a:gsLst>
              <a:gs pos="4000">
                <a:schemeClr val="accent1">
                  <a:alpha val="21000"/>
                </a:schemeClr>
              </a:gs>
              <a:gs pos="83000">
                <a:schemeClr val="accent1">
                  <a:lumMod val="50000"/>
                  <a:alpha val="61000"/>
                </a:schemeClr>
              </a:gs>
            </a:gsLst>
            <a:lin ang="18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a:extLst>
              <a:ext uri="{FF2B5EF4-FFF2-40B4-BE49-F238E27FC236}">
                <a16:creationId xmlns:a16="http://schemas.microsoft.com/office/drawing/2014/main" id="{F256AC18-FB41-4977-8B0C-F5082335AB7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0800000">
            <a:off x="0" y="4379429"/>
            <a:ext cx="12191984" cy="1953928"/>
          </a:xfrm>
          <a:prstGeom prst="rect">
            <a:avLst/>
          </a:prstGeom>
          <a:gradFill>
            <a:gsLst>
              <a:gs pos="32000">
                <a:schemeClr val="accent1">
                  <a:lumMod val="50000"/>
                  <a:alpha val="0"/>
                </a:schemeClr>
              </a:gs>
              <a:gs pos="100000">
                <a:schemeClr val="accent1">
                  <a:alpha val="55000"/>
                </a:schemeClr>
              </a:gs>
            </a:gsLst>
            <a:lin ang="66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ectangle 14">
            <a:extLst>
              <a:ext uri="{FF2B5EF4-FFF2-40B4-BE49-F238E27FC236}">
                <a16:creationId xmlns:a16="http://schemas.microsoft.com/office/drawing/2014/main" id="{AFF4A713-7B75-4B21-90D7-5AB19547C72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 y="4380927"/>
            <a:ext cx="12192000" cy="2019443"/>
          </a:xfrm>
          <a:prstGeom prst="rect">
            <a:avLst/>
          </a:prstGeom>
          <a:gradFill>
            <a:gsLst>
              <a:gs pos="32000">
                <a:schemeClr val="accent1">
                  <a:lumMod val="50000"/>
                  <a:alpha val="0"/>
                </a:schemeClr>
              </a:gs>
              <a:gs pos="100000">
                <a:srgbClr val="000000">
                  <a:alpha val="45000"/>
                </a:srgbClr>
              </a:gs>
            </a:gsLst>
            <a:lin ang="7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807703115"/>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Content Placeholder 3" descr="A close-up of a wound&#10;&#10;Description automatically generated">
            <a:extLst>
              <a:ext uri="{FF2B5EF4-FFF2-40B4-BE49-F238E27FC236}">
                <a16:creationId xmlns:a16="http://schemas.microsoft.com/office/drawing/2014/main" id="{4348ED40-ECCD-02CF-DC54-D4A548C8952E}"/>
              </a:ext>
            </a:extLst>
          </p:cNvPr>
          <p:cNvPicPr>
            <a:picLocks noGrp="1" noChangeAspect="1"/>
          </p:cNvPicPr>
          <p:nvPr>
            <p:ph idx="1"/>
          </p:nvPr>
        </p:nvPicPr>
        <p:blipFill>
          <a:blip r:embed="rId2"/>
          <a:stretch>
            <a:fillRect/>
          </a:stretch>
        </p:blipFill>
        <p:spPr>
          <a:xfrm>
            <a:off x="437896" y="1712838"/>
            <a:ext cx="4127781" cy="3017149"/>
          </a:xfrm>
        </p:spPr>
      </p:pic>
      <p:sp>
        <p:nvSpPr>
          <p:cNvPr id="6" name="TextBox 5">
            <a:extLst>
              <a:ext uri="{FF2B5EF4-FFF2-40B4-BE49-F238E27FC236}">
                <a16:creationId xmlns:a16="http://schemas.microsoft.com/office/drawing/2014/main" id="{765F1A7F-A9C9-0257-81D2-1906954EC116}"/>
              </a:ext>
            </a:extLst>
          </p:cNvPr>
          <p:cNvSpPr txBox="1"/>
          <p:nvPr/>
        </p:nvSpPr>
        <p:spPr>
          <a:xfrm>
            <a:off x="272530" y="648256"/>
            <a:ext cx="4132384" cy="58477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3200" dirty="0"/>
              <a:t>GT stoma infection:</a:t>
            </a:r>
            <a:endParaRPr lang="en-US" dirty="0"/>
          </a:p>
        </p:txBody>
      </p:sp>
      <p:sp>
        <p:nvSpPr>
          <p:cNvPr id="7" name="TextBox 6">
            <a:extLst>
              <a:ext uri="{FF2B5EF4-FFF2-40B4-BE49-F238E27FC236}">
                <a16:creationId xmlns:a16="http://schemas.microsoft.com/office/drawing/2014/main" id="{CDAC4230-0784-FAED-EEAC-40D97D39373D}"/>
              </a:ext>
            </a:extLst>
          </p:cNvPr>
          <p:cNvSpPr txBox="1"/>
          <p:nvPr/>
        </p:nvSpPr>
        <p:spPr>
          <a:xfrm>
            <a:off x="674240" y="5059453"/>
            <a:ext cx="3650521" cy="190821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marL="285750" indent="-285750">
              <a:buFont typeface="Arial"/>
              <a:buChar char="•"/>
            </a:pPr>
            <a:r>
              <a:rPr lang="en-US" sz="2000" dirty="0"/>
              <a:t>Redness spreads</a:t>
            </a:r>
          </a:p>
          <a:p>
            <a:pPr marL="285750" indent="-285750">
              <a:buFont typeface="Arial"/>
              <a:buChar char="•"/>
            </a:pPr>
            <a:r>
              <a:rPr lang="en-US" sz="2000" dirty="0">
                <a:ea typeface="+mn-lt"/>
                <a:cs typeface="+mn-lt"/>
              </a:rPr>
              <a:t>Tender, warm, swollen</a:t>
            </a:r>
          </a:p>
          <a:p>
            <a:pPr marL="285750" indent="-285750">
              <a:buFont typeface="Arial"/>
              <a:buChar char="•"/>
            </a:pPr>
            <a:r>
              <a:rPr lang="en-US" sz="2000" dirty="0"/>
              <a:t>Thick drainage, foul smelling discharge </a:t>
            </a:r>
          </a:p>
          <a:p>
            <a:pPr marL="285750" indent="-285750">
              <a:buFont typeface="Arial"/>
              <a:buChar char="•"/>
            </a:pPr>
            <a:r>
              <a:rPr lang="en-US" sz="2000" dirty="0"/>
              <a:t>Fever</a:t>
            </a:r>
          </a:p>
          <a:p>
            <a:endParaRPr lang="en-US" dirty="0"/>
          </a:p>
        </p:txBody>
      </p:sp>
      <p:cxnSp>
        <p:nvCxnSpPr>
          <p:cNvPr id="9" name="Straight Arrow Connector 8">
            <a:extLst>
              <a:ext uri="{FF2B5EF4-FFF2-40B4-BE49-F238E27FC236}">
                <a16:creationId xmlns:a16="http://schemas.microsoft.com/office/drawing/2014/main" id="{12B2A1A5-93D9-1D67-D518-B0FBF1E4A067}"/>
              </a:ext>
            </a:extLst>
          </p:cNvPr>
          <p:cNvCxnSpPr/>
          <p:nvPr/>
        </p:nvCxnSpPr>
        <p:spPr>
          <a:xfrm>
            <a:off x="4932011" y="3465328"/>
            <a:ext cx="1056009" cy="4046"/>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sp>
        <p:nvSpPr>
          <p:cNvPr id="10" name="TextBox 9">
            <a:extLst>
              <a:ext uri="{FF2B5EF4-FFF2-40B4-BE49-F238E27FC236}">
                <a16:creationId xmlns:a16="http://schemas.microsoft.com/office/drawing/2014/main" id="{0B6E8676-D265-34C8-6143-A3C67029C003}"/>
              </a:ext>
            </a:extLst>
          </p:cNvPr>
          <p:cNvSpPr txBox="1"/>
          <p:nvPr/>
        </p:nvSpPr>
        <p:spPr>
          <a:xfrm>
            <a:off x="6606637" y="3013756"/>
            <a:ext cx="4671857" cy="830997"/>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2400" dirty="0"/>
              <a:t>Mild: Topical Abx </a:t>
            </a:r>
          </a:p>
          <a:p>
            <a:r>
              <a:rPr lang="en-US" sz="2400" dirty="0"/>
              <a:t>Severe: consider IV Abx</a:t>
            </a:r>
          </a:p>
        </p:txBody>
      </p:sp>
    </p:spTree>
    <p:extLst>
      <p:ext uri="{BB962C8B-B14F-4D97-AF65-F5344CB8AC3E}">
        <p14:creationId xmlns:p14="http://schemas.microsoft.com/office/powerpoint/2010/main" val="322283395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9"/>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 grpId="0"/>
    </p:bldLst>
  </p:timing>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group of creams and containers&#10;&#10;Description automatically generated">
            <a:extLst>
              <a:ext uri="{FF2B5EF4-FFF2-40B4-BE49-F238E27FC236}">
                <a16:creationId xmlns:a16="http://schemas.microsoft.com/office/drawing/2014/main" id="{DA2A71F0-6417-A7F9-E493-739108DE3A4E}"/>
              </a:ext>
            </a:extLst>
          </p:cNvPr>
          <p:cNvPicPr>
            <a:picLocks noChangeAspect="1"/>
          </p:cNvPicPr>
          <p:nvPr/>
        </p:nvPicPr>
        <p:blipFill>
          <a:blip r:embed="rId3"/>
          <a:stretch>
            <a:fillRect/>
          </a:stretch>
        </p:blipFill>
        <p:spPr>
          <a:xfrm>
            <a:off x="6364123" y="625009"/>
            <a:ext cx="3090785" cy="3495675"/>
          </a:xfrm>
          <a:prstGeom prst="rect">
            <a:avLst/>
          </a:prstGeom>
        </p:spPr>
      </p:pic>
      <p:pic>
        <p:nvPicPr>
          <p:cNvPr id="4" name="Picture 3" descr="nystatin 100,000 UNT-GM Topical Powder">
            <a:extLst>
              <a:ext uri="{FF2B5EF4-FFF2-40B4-BE49-F238E27FC236}">
                <a16:creationId xmlns:a16="http://schemas.microsoft.com/office/drawing/2014/main" id="{87600A3E-4DE0-EED9-7AFD-89317515726A}"/>
              </a:ext>
            </a:extLst>
          </p:cNvPr>
          <p:cNvPicPr>
            <a:picLocks noChangeAspect="1"/>
          </p:cNvPicPr>
          <p:nvPr/>
        </p:nvPicPr>
        <p:blipFill>
          <a:blip r:embed="rId4"/>
          <a:stretch>
            <a:fillRect/>
          </a:stretch>
        </p:blipFill>
        <p:spPr>
          <a:xfrm>
            <a:off x="6276471" y="4388978"/>
            <a:ext cx="3178628" cy="2383971"/>
          </a:xfrm>
          <a:prstGeom prst="rect">
            <a:avLst/>
          </a:prstGeom>
        </p:spPr>
      </p:pic>
      <p:pic>
        <p:nvPicPr>
          <p:cNvPr id="5" name="Picture 4" descr="Buy ConvaTec FoamLite Dressing at Medical Monks!">
            <a:extLst>
              <a:ext uri="{FF2B5EF4-FFF2-40B4-BE49-F238E27FC236}">
                <a16:creationId xmlns:a16="http://schemas.microsoft.com/office/drawing/2014/main" id="{A5D062DA-85D1-4F86-95D5-6388AB67CA96}"/>
              </a:ext>
            </a:extLst>
          </p:cNvPr>
          <p:cNvPicPr>
            <a:picLocks noChangeAspect="1"/>
          </p:cNvPicPr>
          <p:nvPr/>
        </p:nvPicPr>
        <p:blipFill>
          <a:blip r:embed="rId5"/>
          <a:stretch>
            <a:fillRect/>
          </a:stretch>
        </p:blipFill>
        <p:spPr>
          <a:xfrm>
            <a:off x="9450895" y="2458810"/>
            <a:ext cx="2743200" cy="2743200"/>
          </a:xfrm>
          <a:prstGeom prst="rect">
            <a:avLst/>
          </a:prstGeom>
        </p:spPr>
      </p:pic>
      <p:sp>
        <p:nvSpPr>
          <p:cNvPr id="6" name="TextBox 5">
            <a:extLst>
              <a:ext uri="{FF2B5EF4-FFF2-40B4-BE49-F238E27FC236}">
                <a16:creationId xmlns:a16="http://schemas.microsoft.com/office/drawing/2014/main" id="{1C507F15-900F-8029-EB18-200808C829EE}"/>
              </a:ext>
            </a:extLst>
          </p:cNvPr>
          <p:cNvSpPr txBox="1"/>
          <p:nvPr/>
        </p:nvSpPr>
        <p:spPr>
          <a:xfrm>
            <a:off x="9877876" y="5393312"/>
            <a:ext cx="3440164"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dirty="0"/>
              <a:t>Protects the wound</a:t>
            </a:r>
          </a:p>
        </p:txBody>
      </p:sp>
      <p:pic>
        <p:nvPicPr>
          <p:cNvPr id="8" name="Picture 2" descr="Image preview">
            <a:extLst>
              <a:ext uri="{FF2B5EF4-FFF2-40B4-BE49-F238E27FC236}">
                <a16:creationId xmlns:a16="http://schemas.microsoft.com/office/drawing/2014/main" id="{0D7723B9-EEFD-E885-4CCB-D0781E15D12F}"/>
              </a:ext>
            </a:extLst>
          </p:cNvPr>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162670" y="1653270"/>
            <a:ext cx="5381113" cy="3625504"/>
          </a:xfrm>
          <a:prstGeom prst="rect">
            <a:avLst/>
          </a:prstGeom>
          <a:noFill/>
          <a:extLst>
            <a:ext uri="{909E8E84-426E-40DD-AFC4-6F175D3DCCD1}">
              <a14:hiddenFill xmlns:a14="http://schemas.microsoft.com/office/drawing/2010/main">
                <a:solidFill>
                  <a:srgbClr val="FFFFFF"/>
                </a:solidFill>
              </a14:hiddenFill>
            </a:ext>
          </a:extLst>
        </p:spPr>
      </p:pic>
      <p:sp>
        <p:nvSpPr>
          <p:cNvPr id="9" name="TextBox 8">
            <a:extLst>
              <a:ext uri="{FF2B5EF4-FFF2-40B4-BE49-F238E27FC236}">
                <a16:creationId xmlns:a16="http://schemas.microsoft.com/office/drawing/2014/main" id="{AD8C5142-AE2B-D2E6-6500-8B460B6BA993}"/>
              </a:ext>
            </a:extLst>
          </p:cNvPr>
          <p:cNvSpPr txBox="1"/>
          <p:nvPr/>
        </p:nvSpPr>
        <p:spPr>
          <a:xfrm>
            <a:off x="784795" y="726180"/>
            <a:ext cx="4132384" cy="58477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3200" dirty="0"/>
              <a:t>GT Pressure Injury:</a:t>
            </a:r>
          </a:p>
        </p:txBody>
      </p:sp>
      <p:cxnSp>
        <p:nvCxnSpPr>
          <p:cNvPr id="7" name="Straight Arrow Connector 6">
            <a:extLst>
              <a:ext uri="{FF2B5EF4-FFF2-40B4-BE49-F238E27FC236}">
                <a16:creationId xmlns:a16="http://schemas.microsoft.com/office/drawing/2014/main" id="{B6A4A913-B49D-FAAC-0CC7-78EE24A30037}"/>
              </a:ext>
            </a:extLst>
          </p:cNvPr>
          <p:cNvCxnSpPr/>
          <p:nvPr/>
        </p:nvCxnSpPr>
        <p:spPr>
          <a:xfrm>
            <a:off x="5687268" y="3998054"/>
            <a:ext cx="819991" cy="4046"/>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317954979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4"/>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nodeType="clickEffect">
                                  <p:stCondLst>
                                    <p:cond delay="0"/>
                                  </p:stCondLst>
                                  <p:childTnLst>
                                    <p:set>
                                      <p:cBhvr>
                                        <p:cTn id="16" dur="1" fill="hold">
                                          <p:stCondLst>
                                            <p:cond delay="0"/>
                                          </p:stCondLst>
                                        </p:cTn>
                                        <p:tgtEl>
                                          <p:spTgt spid="5"/>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p:bldLst>
  </p:timing>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Content Placeholder 3">
            <a:extLst>
              <a:ext uri="{FF2B5EF4-FFF2-40B4-BE49-F238E27FC236}">
                <a16:creationId xmlns:a16="http://schemas.microsoft.com/office/drawing/2014/main" id="{8D6C8133-998B-F8FB-11E1-1C9829935611}"/>
              </a:ext>
            </a:extLst>
          </p:cNvPr>
          <p:cNvPicPr>
            <a:picLocks noGrp="1" noChangeAspect="1"/>
          </p:cNvPicPr>
          <p:nvPr>
            <p:ph idx="1"/>
          </p:nvPr>
        </p:nvPicPr>
        <p:blipFill>
          <a:blip r:embed="rId3"/>
          <a:stretch>
            <a:fillRect/>
          </a:stretch>
        </p:blipFill>
        <p:spPr>
          <a:xfrm>
            <a:off x="542045" y="2044973"/>
            <a:ext cx="4000500" cy="2533650"/>
          </a:xfrm>
        </p:spPr>
      </p:pic>
      <p:sp>
        <p:nvSpPr>
          <p:cNvPr id="3" name="TextBox 2">
            <a:extLst>
              <a:ext uri="{FF2B5EF4-FFF2-40B4-BE49-F238E27FC236}">
                <a16:creationId xmlns:a16="http://schemas.microsoft.com/office/drawing/2014/main" id="{BCF6060F-1BCA-851E-0406-1CB6ECDB46F1}"/>
              </a:ext>
            </a:extLst>
          </p:cNvPr>
          <p:cNvSpPr txBox="1"/>
          <p:nvPr/>
        </p:nvSpPr>
        <p:spPr>
          <a:xfrm>
            <a:off x="784795" y="726180"/>
            <a:ext cx="4132384" cy="1077218"/>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3200" dirty="0"/>
              <a:t>GT Granulation Tissue:</a:t>
            </a:r>
          </a:p>
        </p:txBody>
      </p:sp>
      <p:pic>
        <p:nvPicPr>
          <p:cNvPr id="6" name="Picture 5" descr="Triamcinolone Acetonide Cream 0.1% Jar 454 grams — Mountainside Medical  Equipment">
            <a:extLst>
              <a:ext uri="{FF2B5EF4-FFF2-40B4-BE49-F238E27FC236}">
                <a16:creationId xmlns:a16="http://schemas.microsoft.com/office/drawing/2014/main" id="{F5FED341-E4B4-5B24-CA37-0E733557F2D7}"/>
              </a:ext>
            </a:extLst>
          </p:cNvPr>
          <p:cNvPicPr>
            <a:picLocks noChangeAspect="1"/>
          </p:cNvPicPr>
          <p:nvPr/>
        </p:nvPicPr>
        <p:blipFill>
          <a:blip r:embed="rId4"/>
          <a:stretch>
            <a:fillRect/>
          </a:stretch>
        </p:blipFill>
        <p:spPr>
          <a:xfrm>
            <a:off x="5617294" y="1832882"/>
            <a:ext cx="2743200" cy="2743200"/>
          </a:xfrm>
          <a:prstGeom prst="rect">
            <a:avLst/>
          </a:prstGeom>
        </p:spPr>
      </p:pic>
      <p:cxnSp>
        <p:nvCxnSpPr>
          <p:cNvPr id="8" name="Straight Arrow Connector 7">
            <a:extLst>
              <a:ext uri="{FF2B5EF4-FFF2-40B4-BE49-F238E27FC236}">
                <a16:creationId xmlns:a16="http://schemas.microsoft.com/office/drawing/2014/main" id="{842FFB86-F8E8-256F-486E-664F2F319835}"/>
              </a:ext>
            </a:extLst>
          </p:cNvPr>
          <p:cNvCxnSpPr/>
          <p:nvPr/>
        </p:nvCxnSpPr>
        <p:spPr>
          <a:xfrm>
            <a:off x="4642047" y="3465328"/>
            <a:ext cx="1056009" cy="4046"/>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sp>
        <p:nvSpPr>
          <p:cNvPr id="9" name="TextBox 8">
            <a:extLst>
              <a:ext uri="{FF2B5EF4-FFF2-40B4-BE49-F238E27FC236}">
                <a16:creationId xmlns:a16="http://schemas.microsoft.com/office/drawing/2014/main" id="{6E492868-0D7A-BE71-60BA-5CD8384D4BD3}"/>
              </a:ext>
            </a:extLst>
          </p:cNvPr>
          <p:cNvSpPr txBox="1"/>
          <p:nvPr/>
        </p:nvSpPr>
        <p:spPr>
          <a:xfrm>
            <a:off x="5817894" y="4793204"/>
            <a:ext cx="2346041"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a:t>2-week</a:t>
            </a:r>
            <a:r>
              <a:rPr lang="en-US" dirty="0"/>
              <a:t> trial </a:t>
            </a:r>
            <a:endParaRPr lang="en-US"/>
          </a:p>
        </p:txBody>
      </p:sp>
      <p:pic>
        <p:nvPicPr>
          <p:cNvPr id="11" name="Picture 10" descr="Applicator Silver Nitrate - USL Medical">
            <a:extLst>
              <a:ext uri="{FF2B5EF4-FFF2-40B4-BE49-F238E27FC236}">
                <a16:creationId xmlns:a16="http://schemas.microsoft.com/office/drawing/2014/main" id="{065FC989-3AE5-B6C0-2ED1-B129D70B5BBE}"/>
              </a:ext>
            </a:extLst>
          </p:cNvPr>
          <p:cNvPicPr>
            <a:picLocks noChangeAspect="1"/>
          </p:cNvPicPr>
          <p:nvPr/>
        </p:nvPicPr>
        <p:blipFill>
          <a:blip r:embed="rId5"/>
          <a:stretch>
            <a:fillRect/>
          </a:stretch>
        </p:blipFill>
        <p:spPr>
          <a:xfrm>
            <a:off x="9357090" y="2514263"/>
            <a:ext cx="2743200" cy="1600200"/>
          </a:xfrm>
          <a:prstGeom prst="rect">
            <a:avLst/>
          </a:prstGeom>
        </p:spPr>
      </p:pic>
      <p:cxnSp>
        <p:nvCxnSpPr>
          <p:cNvPr id="12" name="Straight Arrow Connector 11">
            <a:extLst>
              <a:ext uri="{FF2B5EF4-FFF2-40B4-BE49-F238E27FC236}">
                <a16:creationId xmlns:a16="http://schemas.microsoft.com/office/drawing/2014/main" id="{50E549DF-4254-6CC4-71B0-EEB5C726A482}"/>
              </a:ext>
            </a:extLst>
          </p:cNvPr>
          <p:cNvCxnSpPr>
            <a:cxnSpLocks/>
          </p:cNvCxnSpPr>
          <p:nvPr/>
        </p:nvCxnSpPr>
        <p:spPr>
          <a:xfrm flipV="1">
            <a:off x="8364382" y="3462631"/>
            <a:ext cx="880681" cy="9440"/>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sp>
        <p:nvSpPr>
          <p:cNvPr id="13" name="TextBox 12">
            <a:extLst>
              <a:ext uri="{FF2B5EF4-FFF2-40B4-BE49-F238E27FC236}">
                <a16:creationId xmlns:a16="http://schemas.microsoft.com/office/drawing/2014/main" id="{C7150244-FC12-D4F4-40CF-B6C441D3D7F1}"/>
              </a:ext>
            </a:extLst>
          </p:cNvPr>
          <p:cNvSpPr txBox="1"/>
          <p:nvPr/>
        </p:nvSpPr>
        <p:spPr>
          <a:xfrm>
            <a:off x="8103892" y="3019699"/>
            <a:ext cx="1408714"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dirty="0"/>
              <a:t>If fails</a:t>
            </a:r>
          </a:p>
        </p:txBody>
      </p:sp>
      <p:sp>
        <p:nvSpPr>
          <p:cNvPr id="14" name="TextBox 13">
            <a:extLst>
              <a:ext uri="{FF2B5EF4-FFF2-40B4-BE49-F238E27FC236}">
                <a16:creationId xmlns:a16="http://schemas.microsoft.com/office/drawing/2014/main" id="{35C15FFC-6CEB-2F98-52A9-42581F2BEE14}"/>
              </a:ext>
            </a:extLst>
          </p:cNvPr>
          <p:cNvSpPr txBox="1"/>
          <p:nvPr/>
        </p:nvSpPr>
        <p:spPr>
          <a:xfrm>
            <a:off x="9358275" y="1947505"/>
            <a:ext cx="2474164"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dirty="0"/>
              <a:t>Silver Nitrate Cautery</a:t>
            </a:r>
          </a:p>
        </p:txBody>
      </p:sp>
    </p:spTree>
    <p:extLst>
      <p:ext uri="{BB962C8B-B14F-4D97-AF65-F5344CB8AC3E}">
        <p14:creationId xmlns:p14="http://schemas.microsoft.com/office/powerpoint/2010/main" val="147126216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8"/>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6"/>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9"/>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13"/>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12"/>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14"/>
                                        </p:tgtEl>
                                        <p:attrNameLst>
                                          <p:attrName>style.visibility</p:attrName>
                                        </p:attrNameLst>
                                      </p:cBhvr>
                                      <p:to>
                                        <p:strVal val="visible"/>
                                      </p:to>
                                    </p:set>
                                  </p:childTnLst>
                                </p:cTn>
                              </p:par>
                              <p:par>
                                <p:cTn id="23" presetID="1" presetClass="entr" presetSubtype="0" fill="hold" nodeType="withEffect">
                                  <p:stCondLst>
                                    <p:cond delay="0"/>
                                  </p:stCondLst>
                                  <p:childTnLst>
                                    <p:set>
                                      <p:cBhvr>
                                        <p:cTn id="24" dur="1" fill="hold">
                                          <p:stCondLst>
                                            <p:cond delay="0"/>
                                          </p:stCondLst>
                                        </p:cTn>
                                        <p:tgtEl>
                                          <p:spTgt spid="11"/>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9" grpId="0"/>
      <p:bldP spid="13" grpId="0"/>
      <p:bldP spid="14" grpId="0"/>
    </p:bldLst>
  </p:timing>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5DD31F45-CA27-23E9-95FA-EBCBA8AB9498}"/>
              </a:ext>
            </a:extLst>
          </p:cNvPr>
          <p:cNvSpPr txBox="1"/>
          <p:nvPr/>
        </p:nvSpPr>
        <p:spPr>
          <a:xfrm>
            <a:off x="845485" y="874534"/>
            <a:ext cx="4132384" cy="58477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3200" dirty="0"/>
              <a:t>Gastric Prolapse:</a:t>
            </a:r>
          </a:p>
        </p:txBody>
      </p:sp>
      <p:cxnSp>
        <p:nvCxnSpPr>
          <p:cNvPr id="8" name="Straight Arrow Connector 7">
            <a:extLst>
              <a:ext uri="{FF2B5EF4-FFF2-40B4-BE49-F238E27FC236}">
                <a16:creationId xmlns:a16="http://schemas.microsoft.com/office/drawing/2014/main" id="{EAA7AACC-D540-CB9D-262B-3F3B8FF060A4}"/>
              </a:ext>
            </a:extLst>
          </p:cNvPr>
          <p:cNvCxnSpPr/>
          <p:nvPr/>
        </p:nvCxnSpPr>
        <p:spPr>
          <a:xfrm flipV="1">
            <a:off x="5357873" y="3685161"/>
            <a:ext cx="739070" cy="9441"/>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pic>
        <p:nvPicPr>
          <p:cNvPr id="9" name="Picture 8" descr="Aquaphor Healing Ointment® (1.75oz.) / Clinically proven to restore smooth,  healthy skin">
            <a:extLst>
              <a:ext uri="{FF2B5EF4-FFF2-40B4-BE49-F238E27FC236}">
                <a16:creationId xmlns:a16="http://schemas.microsoft.com/office/drawing/2014/main" id="{C383A974-CCF3-0F5E-CF08-436CEEBB9E70}"/>
              </a:ext>
            </a:extLst>
          </p:cNvPr>
          <p:cNvPicPr>
            <a:picLocks noChangeAspect="1"/>
          </p:cNvPicPr>
          <p:nvPr/>
        </p:nvPicPr>
        <p:blipFill>
          <a:blip r:embed="rId2"/>
          <a:stretch>
            <a:fillRect/>
          </a:stretch>
        </p:blipFill>
        <p:spPr>
          <a:xfrm>
            <a:off x="6983428" y="1268427"/>
            <a:ext cx="3876084" cy="3876084"/>
          </a:xfrm>
          <a:prstGeom prst="rect">
            <a:avLst/>
          </a:prstGeom>
        </p:spPr>
      </p:pic>
      <p:pic>
        <p:nvPicPr>
          <p:cNvPr id="11" name="Picture 10" descr="Critic-Aid Skin Protectant 6 oz. 1947, 1 Ct">
            <a:extLst>
              <a:ext uri="{FF2B5EF4-FFF2-40B4-BE49-F238E27FC236}">
                <a16:creationId xmlns:a16="http://schemas.microsoft.com/office/drawing/2014/main" id="{EC7810C9-0AD5-7CC1-30FC-2B740F75AB85}"/>
              </a:ext>
            </a:extLst>
          </p:cNvPr>
          <p:cNvPicPr>
            <a:picLocks noChangeAspect="1"/>
          </p:cNvPicPr>
          <p:nvPr/>
        </p:nvPicPr>
        <p:blipFill>
          <a:blip r:embed="rId3"/>
          <a:stretch>
            <a:fillRect/>
          </a:stretch>
        </p:blipFill>
        <p:spPr>
          <a:xfrm>
            <a:off x="10406582" y="1456133"/>
            <a:ext cx="1458715" cy="3339313"/>
          </a:xfrm>
          <a:prstGeom prst="rect">
            <a:avLst/>
          </a:prstGeom>
        </p:spPr>
      </p:pic>
      <p:sp>
        <p:nvSpPr>
          <p:cNvPr id="12" name="TextBox 11">
            <a:extLst>
              <a:ext uri="{FF2B5EF4-FFF2-40B4-BE49-F238E27FC236}">
                <a16:creationId xmlns:a16="http://schemas.microsoft.com/office/drawing/2014/main" id="{E3CA9471-186A-F2D9-ED01-284CA0C66021}"/>
              </a:ext>
            </a:extLst>
          </p:cNvPr>
          <p:cNvSpPr txBox="1"/>
          <p:nvPr/>
        </p:nvSpPr>
        <p:spPr>
          <a:xfrm>
            <a:off x="10196552" y="5143753"/>
            <a:ext cx="1884374"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dirty="0"/>
              <a:t>If has leaking too</a:t>
            </a:r>
          </a:p>
        </p:txBody>
      </p:sp>
      <p:sp>
        <p:nvSpPr>
          <p:cNvPr id="13" name="TextBox 12">
            <a:extLst>
              <a:ext uri="{FF2B5EF4-FFF2-40B4-BE49-F238E27FC236}">
                <a16:creationId xmlns:a16="http://schemas.microsoft.com/office/drawing/2014/main" id="{A04924F5-6DEA-C352-C915-BDD3F8F0E116}"/>
              </a:ext>
            </a:extLst>
          </p:cNvPr>
          <p:cNvSpPr txBox="1"/>
          <p:nvPr/>
        </p:nvSpPr>
        <p:spPr>
          <a:xfrm>
            <a:off x="6278658" y="3269097"/>
            <a:ext cx="1560693" cy="92333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dirty="0"/>
              <a:t>Consider Surgical Consult</a:t>
            </a:r>
            <a:endParaRPr lang="en-US"/>
          </a:p>
        </p:txBody>
      </p:sp>
      <p:sp>
        <p:nvSpPr>
          <p:cNvPr id="14" name="Plus Sign 13">
            <a:extLst>
              <a:ext uri="{FF2B5EF4-FFF2-40B4-BE49-F238E27FC236}">
                <a16:creationId xmlns:a16="http://schemas.microsoft.com/office/drawing/2014/main" id="{DB0E8D10-0009-0D13-8B59-E42B4EA49004}"/>
              </a:ext>
            </a:extLst>
          </p:cNvPr>
          <p:cNvSpPr/>
          <p:nvPr/>
        </p:nvSpPr>
        <p:spPr>
          <a:xfrm>
            <a:off x="7736120" y="3525072"/>
            <a:ext cx="444938" cy="414602"/>
          </a:xfrm>
          <a:prstGeom prst="mathPlus">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Plus Sign 16">
            <a:extLst>
              <a:ext uri="{FF2B5EF4-FFF2-40B4-BE49-F238E27FC236}">
                <a16:creationId xmlns:a16="http://schemas.microsoft.com/office/drawing/2014/main" id="{C89BA6D0-66B5-3F46-8208-6E3995C7BD5A}"/>
              </a:ext>
            </a:extLst>
          </p:cNvPr>
          <p:cNvSpPr/>
          <p:nvPr/>
        </p:nvSpPr>
        <p:spPr>
          <a:xfrm>
            <a:off x="9849725" y="3515138"/>
            <a:ext cx="428083" cy="414585"/>
          </a:xfrm>
          <a:prstGeom prst="mathPlus">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2" name="Picture 1" descr="Close-up of a person&amp;#39;s tongue&#10;&#10;Description automatically generated">
            <a:extLst>
              <a:ext uri="{FF2B5EF4-FFF2-40B4-BE49-F238E27FC236}">
                <a16:creationId xmlns:a16="http://schemas.microsoft.com/office/drawing/2014/main" id="{BDF0E3A3-B93B-6105-6BE4-19F4454DDFB6}"/>
              </a:ext>
            </a:extLst>
          </p:cNvPr>
          <p:cNvPicPr>
            <a:picLocks noChangeAspect="1"/>
          </p:cNvPicPr>
          <p:nvPr/>
        </p:nvPicPr>
        <p:blipFill>
          <a:blip r:embed="rId4"/>
          <a:stretch>
            <a:fillRect/>
          </a:stretch>
        </p:blipFill>
        <p:spPr>
          <a:xfrm>
            <a:off x="361627" y="2202130"/>
            <a:ext cx="4817391" cy="2899314"/>
          </a:xfrm>
          <a:prstGeom prst="rect">
            <a:avLst/>
          </a:prstGeom>
        </p:spPr>
      </p:pic>
    </p:spTree>
    <p:extLst>
      <p:ext uri="{BB962C8B-B14F-4D97-AF65-F5344CB8AC3E}">
        <p14:creationId xmlns:p14="http://schemas.microsoft.com/office/powerpoint/2010/main" val="24977489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8"/>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3"/>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14"/>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9"/>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17"/>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11"/>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1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2" grpId="0"/>
      <p:bldP spid="13" grpId="0"/>
      <p:bldP spid="14" grpId="0" animBg="1"/>
      <p:bldP spid="17" grpId="0" animBg="1"/>
    </p:bldLst>
  </p:timing>
</p:sld>
</file>

<file path=ppt/slides/slide4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6F5A5072-7B47-4D32-B52A-4EBBF590B8A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w="12700" cap="flat" cmpd="sng" algn="ctr">
            <a:noFill/>
            <a:prstDash val="solid"/>
            <a:miter lim="800000"/>
          </a:ln>
          <a:effectLst/>
          <a:extLst>
            <a:ext uri="{91240B29-F687-4F45-9708-019B960494DF}">
              <a14:hiddenLine xmlns:a14="http://schemas.microsoft.com/office/drawing/2010/main" w="12700" cap="flat" cmpd="sng" algn="ctr">
                <a:solidFill>
                  <a:schemeClr val="accent1">
                    <a:shade val="50000"/>
                  </a:schemeClr>
                </a:solidFill>
                <a:prstDash val="solid"/>
                <a:miter lim="800000"/>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a:extLst>
              <a:ext uri="{FF2B5EF4-FFF2-40B4-BE49-F238E27FC236}">
                <a16:creationId xmlns:a16="http://schemas.microsoft.com/office/drawing/2014/main" id="{9715DAF0-AE1B-46C9-8A6B-DB2AA05AB91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0800000">
            <a:off x="-2" y="-22693"/>
            <a:ext cx="12191999" cy="4374129"/>
          </a:xfrm>
          <a:prstGeom prst="rect">
            <a:avLst/>
          </a:prstGeom>
          <a:gradFill>
            <a:gsLst>
              <a:gs pos="0">
                <a:schemeClr val="accent1">
                  <a:lumMod val="75000"/>
                </a:schemeClr>
              </a:gs>
              <a:gs pos="100000">
                <a:srgbClr val="000000"/>
              </a:gs>
            </a:gsLst>
            <a:lin ang="15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6016219D-510E-4184-9090-6D5578A87BD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3908719" y="-3931841"/>
            <a:ext cx="4374557" cy="12192000"/>
          </a:xfrm>
          <a:prstGeom prst="rect">
            <a:avLst/>
          </a:prstGeom>
          <a:gradFill>
            <a:gsLst>
              <a:gs pos="40000">
                <a:schemeClr val="accent1">
                  <a:alpha val="0"/>
                </a:schemeClr>
              </a:gs>
              <a:gs pos="100000">
                <a:schemeClr val="accent1">
                  <a:lumMod val="75000"/>
                  <a:alpha val="52000"/>
                </a:schemeClr>
              </a:gs>
            </a:gsLst>
            <a:lin ang="24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13">
            <a:extLst>
              <a:ext uri="{FF2B5EF4-FFF2-40B4-BE49-F238E27FC236}">
                <a16:creationId xmlns:a16="http://schemas.microsoft.com/office/drawing/2014/main" id="{AFF4A713-7B75-4B21-90D7-5AB19547C72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5400000">
            <a:off x="4136696" y="-3703868"/>
            <a:ext cx="4374128" cy="11736479"/>
          </a:xfrm>
          <a:prstGeom prst="rect">
            <a:avLst/>
          </a:prstGeom>
          <a:gradFill>
            <a:gsLst>
              <a:gs pos="17000">
                <a:schemeClr val="accent1">
                  <a:alpha val="0"/>
                </a:schemeClr>
              </a:gs>
              <a:gs pos="100000">
                <a:srgbClr val="000000">
                  <a:alpha val="37000"/>
                </a:srgbClr>
              </a:gs>
            </a:gsLst>
            <a:lin ang="7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ectangle 15">
            <a:extLst>
              <a:ext uri="{FF2B5EF4-FFF2-40B4-BE49-F238E27FC236}">
                <a16:creationId xmlns:a16="http://schemas.microsoft.com/office/drawing/2014/main" id="{DC631C0B-6DA6-4E57-8231-CE32B3434A7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 y="-22690"/>
            <a:ext cx="8542485" cy="4374126"/>
          </a:xfrm>
          <a:prstGeom prst="rect">
            <a:avLst/>
          </a:prstGeom>
          <a:gradFill>
            <a:gsLst>
              <a:gs pos="0">
                <a:schemeClr val="accent1">
                  <a:lumMod val="50000"/>
                  <a:alpha val="0"/>
                </a:schemeClr>
              </a:gs>
              <a:gs pos="100000">
                <a:srgbClr val="000000">
                  <a:alpha val="25000"/>
                </a:srgbClr>
              </a:gs>
            </a:gsLst>
            <a:lin ang="186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Freeform: Shape 17">
            <a:extLst>
              <a:ext uri="{FF2B5EF4-FFF2-40B4-BE49-F238E27FC236}">
                <a16:creationId xmlns:a16="http://schemas.microsoft.com/office/drawing/2014/main" id="{C29501E6-A978-4A61-9689-9085AF97A53A}"/>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2508972">
            <a:off x="5945431" y="-1032053"/>
            <a:ext cx="4990147" cy="4439131"/>
          </a:xfrm>
          <a:custGeom>
            <a:avLst/>
            <a:gdLst>
              <a:gd name="connsiteX0" fmla="*/ 4990147 w 4990147"/>
              <a:gd name="connsiteY0" fmla="*/ 2229378 h 4439131"/>
              <a:gd name="connsiteX1" fmla="*/ 917384 w 4990147"/>
              <a:gd name="connsiteY1" fmla="*/ 4439131 h 4439131"/>
              <a:gd name="connsiteX2" fmla="*/ 910814 w 4990147"/>
              <a:gd name="connsiteY2" fmla="*/ 4434219 h 4439131"/>
              <a:gd name="connsiteX3" fmla="*/ 0 w 4990147"/>
              <a:gd name="connsiteY3" fmla="*/ 2502877 h 4439131"/>
              <a:gd name="connsiteX4" fmla="*/ 2502877 w 4990147"/>
              <a:gd name="connsiteY4" fmla="*/ 0 h 4439131"/>
              <a:gd name="connsiteX5" fmla="*/ 4954904 w 4990147"/>
              <a:gd name="connsiteY5" fmla="*/ 1998460 h 443913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4990147" h="4439131">
                <a:moveTo>
                  <a:pt x="4990147" y="2229378"/>
                </a:moveTo>
                <a:lnTo>
                  <a:pt x="917384" y="4439131"/>
                </a:lnTo>
                <a:lnTo>
                  <a:pt x="910814" y="4434219"/>
                </a:lnTo>
                <a:cubicBezTo>
                  <a:pt x="354557" y="3975154"/>
                  <a:pt x="0" y="3280421"/>
                  <a:pt x="0" y="2502877"/>
                </a:cubicBezTo>
                <a:cubicBezTo>
                  <a:pt x="0" y="1120576"/>
                  <a:pt x="1120576" y="0"/>
                  <a:pt x="2502877" y="0"/>
                </a:cubicBezTo>
                <a:cubicBezTo>
                  <a:pt x="3712390" y="0"/>
                  <a:pt x="4721520" y="857941"/>
                  <a:pt x="4954904" y="1998460"/>
                </a:cubicBezTo>
                <a:close/>
              </a:path>
            </a:pathLst>
          </a:custGeom>
          <a:gradFill>
            <a:gsLst>
              <a:gs pos="0">
                <a:schemeClr val="accent1">
                  <a:alpha val="22000"/>
                </a:schemeClr>
              </a:gs>
              <a:gs pos="87000">
                <a:schemeClr val="accent1">
                  <a:lumMod val="60000"/>
                  <a:lumOff val="40000"/>
                  <a:alpha val="2000"/>
                </a:schemeClr>
              </a:gs>
            </a:gsLst>
            <a:lin ang="84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p>
        </p:txBody>
      </p:sp>
      <p:sp>
        <p:nvSpPr>
          <p:cNvPr id="2" name="Title 1">
            <a:extLst>
              <a:ext uri="{FF2B5EF4-FFF2-40B4-BE49-F238E27FC236}">
                <a16:creationId xmlns:a16="http://schemas.microsoft.com/office/drawing/2014/main" id="{1E63AA7C-D8CC-24E2-1927-C63C14BF6FAB}"/>
              </a:ext>
            </a:extLst>
          </p:cNvPr>
          <p:cNvSpPr>
            <a:spLocks noGrp="1"/>
          </p:cNvSpPr>
          <p:nvPr>
            <p:ph type="title"/>
          </p:nvPr>
        </p:nvSpPr>
        <p:spPr>
          <a:xfrm>
            <a:off x="1314824" y="735106"/>
            <a:ext cx="10053763" cy="2928470"/>
          </a:xfrm>
        </p:spPr>
        <p:txBody>
          <a:bodyPr vert="horz" lIns="91440" tIns="45720" rIns="91440" bIns="45720" rtlCol="0" anchor="b">
            <a:normAutofit/>
          </a:bodyPr>
          <a:lstStyle/>
          <a:p>
            <a:r>
              <a:rPr lang="en-US" sz="4800" kern="1200">
                <a:solidFill>
                  <a:srgbClr val="FFFFFF"/>
                </a:solidFill>
                <a:latin typeface="+mj-lt"/>
                <a:ea typeface="+mj-ea"/>
                <a:cs typeface="+mj-cs"/>
              </a:rPr>
              <a:t>Case 5:</a:t>
            </a:r>
          </a:p>
        </p:txBody>
      </p:sp>
      <p:sp>
        <p:nvSpPr>
          <p:cNvPr id="3" name="Text Placeholder 2">
            <a:extLst>
              <a:ext uri="{FF2B5EF4-FFF2-40B4-BE49-F238E27FC236}">
                <a16:creationId xmlns:a16="http://schemas.microsoft.com/office/drawing/2014/main" id="{6B57145F-A3D4-5C8F-5BBE-CC4E7BC1E90B}"/>
              </a:ext>
            </a:extLst>
          </p:cNvPr>
          <p:cNvSpPr>
            <a:spLocks noGrp="1"/>
          </p:cNvSpPr>
          <p:nvPr>
            <p:ph type="body" idx="1"/>
          </p:nvPr>
        </p:nvSpPr>
        <p:spPr>
          <a:xfrm>
            <a:off x="450138" y="4952692"/>
            <a:ext cx="11813337" cy="1458258"/>
          </a:xfrm>
        </p:spPr>
        <p:txBody>
          <a:bodyPr vert="horz" lIns="91440" tIns="45720" rIns="91440" bIns="45720" rtlCol="0" anchor="ctr">
            <a:noAutofit/>
          </a:bodyPr>
          <a:lstStyle/>
          <a:p>
            <a:r>
              <a:rPr lang="en-US" sz="3600" kern="1200" dirty="0">
                <a:solidFill>
                  <a:schemeClr val="tx1"/>
                </a:solidFill>
                <a:latin typeface="+mn-lt"/>
                <a:ea typeface="+mn-ea"/>
                <a:cs typeface="+mn-cs"/>
              </a:rPr>
              <a:t>A 2-year-old boy with </a:t>
            </a:r>
            <a:r>
              <a:rPr lang="en-US" sz="3600" kern="1200" dirty="0" err="1">
                <a:solidFill>
                  <a:schemeClr val="tx1"/>
                </a:solidFill>
                <a:latin typeface="+mn-lt"/>
                <a:ea typeface="+mn-ea"/>
                <a:cs typeface="+mn-cs"/>
              </a:rPr>
              <a:t>hx</a:t>
            </a:r>
            <a:r>
              <a:rPr lang="en-US" sz="3600" kern="1200" dirty="0">
                <a:solidFill>
                  <a:schemeClr val="tx1"/>
                </a:solidFill>
                <a:latin typeface="+mn-lt"/>
                <a:ea typeface="+mn-ea"/>
                <a:cs typeface="+mn-cs"/>
              </a:rPr>
              <a:t> of volvulus, s/p jejunostomy </a:t>
            </a:r>
            <a:r>
              <a:rPr lang="en-US" sz="3600" dirty="0">
                <a:solidFill>
                  <a:schemeClr val="tx1"/>
                </a:solidFill>
              </a:rPr>
              <a:t>two </a:t>
            </a:r>
            <a:r>
              <a:rPr lang="en-US" sz="3600" kern="1200" dirty="0">
                <a:solidFill>
                  <a:schemeClr val="tx1"/>
                </a:solidFill>
                <a:latin typeface="+mn-lt"/>
                <a:ea typeface="+mn-ea"/>
                <a:cs typeface="+mn-cs"/>
              </a:rPr>
              <a:t>months ago, presents to the ED with darker looking stoma for the past 3 days. Slightly tachycardic but afebrile. He endorses some peristomal tenderness on exam. </a:t>
            </a:r>
            <a:endParaRPr lang="en-US" sz="3600" dirty="0">
              <a:solidFill>
                <a:schemeClr val="tx1"/>
              </a:solidFill>
            </a:endParaRPr>
          </a:p>
        </p:txBody>
      </p:sp>
    </p:spTree>
    <p:extLst>
      <p:ext uri="{BB962C8B-B14F-4D97-AF65-F5344CB8AC3E}">
        <p14:creationId xmlns:p14="http://schemas.microsoft.com/office/powerpoint/2010/main" val="3743057861"/>
      </p:ext>
    </p:extLst>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descr="Diagram of mucus fistula and a diagram&#10;&#10;Description automatically generated">
            <a:extLst>
              <a:ext uri="{FF2B5EF4-FFF2-40B4-BE49-F238E27FC236}">
                <a16:creationId xmlns:a16="http://schemas.microsoft.com/office/drawing/2014/main" id="{B8357494-6C64-CE7D-8E84-E3B3B91ABADD}"/>
              </a:ext>
            </a:extLst>
          </p:cNvPr>
          <p:cNvPicPr>
            <a:picLocks noChangeAspect="1"/>
          </p:cNvPicPr>
          <p:nvPr/>
        </p:nvPicPr>
        <p:blipFill>
          <a:blip r:embed="rId2"/>
          <a:stretch>
            <a:fillRect/>
          </a:stretch>
        </p:blipFill>
        <p:spPr>
          <a:xfrm>
            <a:off x="8550858" y="1713044"/>
            <a:ext cx="3390737" cy="2926080"/>
          </a:xfrm>
          <a:prstGeom prst="rect">
            <a:avLst/>
          </a:prstGeom>
        </p:spPr>
      </p:pic>
      <p:pic>
        <p:nvPicPr>
          <p:cNvPr id="9" name="Picture 8" descr="Diagram of a diagram showing the structure of a person&amp;#39;s body&#10;&#10;Description automatically generated">
            <a:extLst>
              <a:ext uri="{FF2B5EF4-FFF2-40B4-BE49-F238E27FC236}">
                <a16:creationId xmlns:a16="http://schemas.microsoft.com/office/drawing/2014/main" id="{13463B0C-DAA6-13D2-5E88-65F9A5A5EB85}"/>
              </a:ext>
            </a:extLst>
          </p:cNvPr>
          <p:cNvPicPr>
            <a:picLocks noChangeAspect="1"/>
          </p:cNvPicPr>
          <p:nvPr/>
        </p:nvPicPr>
        <p:blipFill>
          <a:blip r:embed="rId3"/>
          <a:stretch>
            <a:fillRect/>
          </a:stretch>
        </p:blipFill>
        <p:spPr>
          <a:xfrm>
            <a:off x="5739101" y="3663950"/>
            <a:ext cx="3186742" cy="3194304"/>
          </a:xfrm>
          <a:prstGeom prst="rect">
            <a:avLst/>
          </a:prstGeom>
        </p:spPr>
      </p:pic>
      <p:pic>
        <p:nvPicPr>
          <p:cNvPr id="10" name="Picture 9" descr="A diagram of a end ostomy&#10;&#10;Description automatically generated">
            <a:extLst>
              <a:ext uri="{FF2B5EF4-FFF2-40B4-BE49-F238E27FC236}">
                <a16:creationId xmlns:a16="http://schemas.microsoft.com/office/drawing/2014/main" id="{ACE7D549-9C0A-A131-8EAE-B15299B16394}"/>
              </a:ext>
            </a:extLst>
          </p:cNvPr>
          <p:cNvPicPr>
            <a:picLocks noChangeAspect="1"/>
          </p:cNvPicPr>
          <p:nvPr/>
        </p:nvPicPr>
        <p:blipFill>
          <a:blip r:embed="rId4"/>
          <a:stretch>
            <a:fillRect/>
          </a:stretch>
        </p:blipFill>
        <p:spPr>
          <a:xfrm>
            <a:off x="-118767" y="3566160"/>
            <a:ext cx="3169709" cy="3371088"/>
          </a:xfrm>
          <a:prstGeom prst="rect">
            <a:avLst/>
          </a:prstGeom>
        </p:spPr>
      </p:pic>
      <p:pic>
        <p:nvPicPr>
          <p:cNvPr id="13" name="Picture 12" descr="A close-up of a red object&#10;&#10;Description automatically generated">
            <a:extLst>
              <a:ext uri="{FF2B5EF4-FFF2-40B4-BE49-F238E27FC236}">
                <a16:creationId xmlns:a16="http://schemas.microsoft.com/office/drawing/2014/main" id="{C2A62F2F-8F2F-7799-EDB8-C935640D7E08}"/>
              </a:ext>
            </a:extLst>
          </p:cNvPr>
          <p:cNvPicPr>
            <a:picLocks noChangeAspect="1"/>
          </p:cNvPicPr>
          <p:nvPr/>
        </p:nvPicPr>
        <p:blipFill>
          <a:blip r:embed="rId5"/>
          <a:stretch>
            <a:fillRect/>
          </a:stretch>
        </p:blipFill>
        <p:spPr>
          <a:xfrm>
            <a:off x="141603" y="-109728"/>
            <a:ext cx="2155194" cy="3889248"/>
          </a:xfrm>
          <a:prstGeom prst="rect">
            <a:avLst/>
          </a:prstGeom>
        </p:spPr>
      </p:pic>
      <p:pic>
        <p:nvPicPr>
          <p:cNvPr id="14" name="Picture 13" descr="Close-up of a person&amp;#39;s tongue&#10;&#10;Description automatically generated">
            <a:extLst>
              <a:ext uri="{FF2B5EF4-FFF2-40B4-BE49-F238E27FC236}">
                <a16:creationId xmlns:a16="http://schemas.microsoft.com/office/drawing/2014/main" id="{77AD7A6E-0764-9CE9-4EFF-C82A47BD9C03}"/>
              </a:ext>
            </a:extLst>
          </p:cNvPr>
          <p:cNvPicPr>
            <a:picLocks noChangeAspect="1"/>
          </p:cNvPicPr>
          <p:nvPr/>
        </p:nvPicPr>
        <p:blipFill>
          <a:blip r:embed="rId6"/>
          <a:stretch>
            <a:fillRect/>
          </a:stretch>
        </p:blipFill>
        <p:spPr>
          <a:xfrm>
            <a:off x="5747326" y="-100584"/>
            <a:ext cx="2300597" cy="3883152"/>
          </a:xfrm>
          <a:prstGeom prst="rect">
            <a:avLst/>
          </a:prstGeom>
        </p:spPr>
      </p:pic>
      <p:pic>
        <p:nvPicPr>
          <p:cNvPr id="15" name="Picture 14" descr="A collage of images of a person&amp;#39;s skin&#10;&#10;Description automatically generated">
            <a:extLst>
              <a:ext uri="{FF2B5EF4-FFF2-40B4-BE49-F238E27FC236}">
                <a16:creationId xmlns:a16="http://schemas.microsoft.com/office/drawing/2014/main" id="{06D007B3-259C-BF03-EABF-DFD1022FA9DB}"/>
              </a:ext>
            </a:extLst>
          </p:cNvPr>
          <p:cNvPicPr>
            <a:picLocks noChangeAspect="1"/>
          </p:cNvPicPr>
          <p:nvPr/>
        </p:nvPicPr>
        <p:blipFill>
          <a:blip r:embed="rId7"/>
          <a:stretch>
            <a:fillRect/>
          </a:stretch>
        </p:blipFill>
        <p:spPr>
          <a:xfrm>
            <a:off x="3049195" y="-107696"/>
            <a:ext cx="2458363" cy="4114800"/>
          </a:xfrm>
          <a:prstGeom prst="rect">
            <a:avLst/>
          </a:prstGeom>
        </p:spPr>
      </p:pic>
      <p:sp>
        <p:nvSpPr>
          <p:cNvPr id="3" name="TextBox 2">
            <a:extLst>
              <a:ext uri="{FF2B5EF4-FFF2-40B4-BE49-F238E27FC236}">
                <a16:creationId xmlns:a16="http://schemas.microsoft.com/office/drawing/2014/main" id="{2E80BF24-3645-F4BA-2DCB-BA0265440DC0}"/>
              </a:ext>
            </a:extLst>
          </p:cNvPr>
          <p:cNvSpPr txBox="1"/>
          <p:nvPr/>
        </p:nvSpPr>
        <p:spPr>
          <a:xfrm>
            <a:off x="8179415" y="452504"/>
            <a:ext cx="4132384" cy="58477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3200" dirty="0"/>
              <a:t>Stoma Types:</a:t>
            </a:r>
            <a:endParaRPr lang="en-US" dirty="0"/>
          </a:p>
        </p:txBody>
      </p:sp>
      <p:pic>
        <p:nvPicPr>
          <p:cNvPr id="4" name="Picture 3" descr="Colostomy | PPT">
            <a:extLst>
              <a:ext uri="{FF2B5EF4-FFF2-40B4-BE49-F238E27FC236}">
                <a16:creationId xmlns:a16="http://schemas.microsoft.com/office/drawing/2014/main" id="{9EB6F262-CDE8-389A-6F7E-056379301B5F}"/>
              </a:ext>
            </a:extLst>
          </p:cNvPr>
          <p:cNvPicPr>
            <a:picLocks noChangeAspect="1"/>
          </p:cNvPicPr>
          <p:nvPr/>
        </p:nvPicPr>
        <p:blipFill>
          <a:blip r:embed="rId8"/>
          <a:stretch>
            <a:fillRect/>
          </a:stretch>
        </p:blipFill>
        <p:spPr>
          <a:xfrm>
            <a:off x="3149600" y="4140200"/>
            <a:ext cx="2692400" cy="2019300"/>
          </a:xfrm>
          <a:prstGeom prst="rect">
            <a:avLst/>
          </a:prstGeom>
        </p:spPr>
      </p:pic>
    </p:spTree>
    <p:extLst>
      <p:ext uri="{BB962C8B-B14F-4D97-AF65-F5344CB8AC3E}">
        <p14:creationId xmlns:p14="http://schemas.microsoft.com/office/powerpoint/2010/main" val="230188796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3"/>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10"/>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nodeType="clickEffect">
                                  <p:stCondLst>
                                    <p:cond delay="0"/>
                                  </p:stCondLst>
                                  <p:childTnLst>
                                    <p:set>
                                      <p:cBhvr>
                                        <p:cTn id="12" dur="1" fill="hold">
                                          <p:stCondLst>
                                            <p:cond delay="0"/>
                                          </p:stCondLst>
                                        </p:cTn>
                                        <p:tgtEl>
                                          <p:spTgt spid="15"/>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4"/>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14"/>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9"/>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nodeType="clickEffect">
                                  <p:stCondLst>
                                    <p:cond delay="0"/>
                                  </p:stCondLst>
                                  <p:childTnLst>
                                    <p:set>
                                      <p:cBhvr>
                                        <p:cTn id="24" dur="1" fill="hold">
                                          <p:stCondLst>
                                            <p:cond delay="0"/>
                                          </p:stCondLst>
                                        </p:cTn>
                                        <p:tgtEl>
                                          <p:spTgt spid="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15E40A9-1ADA-D72F-B394-AE4EAAF52A32}"/>
              </a:ext>
            </a:extLst>
          </p:cNvPr>
          <p:cNvSpPr>
            <a:spLocks noGrp="1"/>
          </p:cNvSpPr>
          <p:nvPr>
            <p:ph type="title"/>
          </p:nvPr>
        </p:nvSpPr>
        <p:spPr/>
        <p:txBody>
          <a:bodyPr/>
          <a:lstStyle/>
          <a:p>
            <a:r>
              <a:rPr lang="en-US" dirty="0"/>
              <a:t>Typical Stoma Care</a:t>
            </a:r>
          </a:p>
        </p:txBody>
      </p:sp>
      <p:sp>
        <p:nvSpPr>
          <p:cNvPr id="3" name="Content Placeholder 2">
            <a:extLst>
              <a:ext uri="{FF2B5EF4-FFF2-40B4-BE49-F238E27FC236}">
                <a16:creationId xmlns:a16="http://schemas.microsoft.com/office/drawing/2014/main" id="{19813B5D-F53D-0C33-97ED-29C6246EA762}"/>
              </a:ext>
            </a:extLst>
          </p:cNvPr>
          <p:cNvSpPr>
            <a:spLocks noGrp="1"/>
          </p:cNvSpPr>
          <p:nvPr>
            <p:ph idx="1"/>
          </p:nvPr>
        </p:nvSpPr>
        <p:spPr>
          <a:xfrm>
            <a:off x="474763" y="1708543"/>
            <a:ext cx="11229303" cy="4329874"/>
          </a:xfrm>
        </p:spPr>
        <p:txBody>
          <a:bodyPr vert="horz" lIns="91440" tIns="45720" rIns="91440" bIns="45720" rtlCol="0" anchor="t">
            <a:normAutofit/>
          </a:bodyPr>
          <a:lstStyle/>
          <a:p>
            <a:r>
              <a:rPr lang="en-US" dirty="0"/>
              <a:t>Empty when bag 1/3 or ½ full</a:t>
            </a:r>
          </a:p>
          <a:p>
            <a:r>
              <a:rPr lang="en-US" dirty="0"/>
              <a:t>Change pouching system every 3-4 days (1-3 days for infants )</a:t>
            </a:r>
          </a:p>
          <a:p>
            <a:r>
              <a:rPr lang="en-US" dirty="0"/>
              <a:t>Measure stoma size weekly for the first 6-8 weeks post-stoma creation </a:t>
            </a:r>
          </a:p>
        </p:txBody>
      </p:sp>
      <p:pic>
        <p:nvPicPr>
          <p:cNvPr id="4" name="Picture 3" descr="Close-up of skin diseases and skin diseases&#10;&#10;Description automatically generated">
            <a:extLst>
              <a:ext uri="{FF2B5EF4-FFF2-40B4-BE49-F238E27FC236}">
                <a16:creationId xmlns:a16="http://schemas.microsoft.com/office/drawing/2014/main" id="{120EBD25-4502-E6F9-A99F-9AC13470C37E}"/>
              </a:ext>
            </a:extLst>
          </p:cNvPr>
          <p:cNvPicPr>
            <a:picLocks noChangeAspect="1"/>
          </p:cNvPicPr>
          <p:nvPr/>
        </p:nvPicPr>
        <p:blipFill>
          <a:blip r:embed="rId3"/>
          <a:stretch>
            <a:fillRect/>
          </a:stretch>
        </p:blipFill>
        <p:spPr>
          <a:xfrm>
            <a:off x="5458036" y="3284982"/>
            <a:ext cx="6736080" cy="3573780"/>
          </a:xfrm>
          <a:prstGeom prst="rect">
            <a:avLst/>
          </a:prstGeom>
        </p:spPr>
      </p:pic>
      <p:pic>
        <p:nvPicPr>
          <p:cNvPr id="5" name="Picture 4" descr="Colostomy pouch and a colostomy pouch&#10;&#10;Description automatically generated">
            <a:extLst>
              <a:ext uri="{FF2B5EF4-FFF2-40B4-BE49-F238E27FC236}">
                <a16:creationId xmlns:a16="http://schemas.microsoft.com/office/drawing/2014/main" id="{42271115-8C23-EBF5-D216-7762795949E7}"/>
              </a:ext>
            </a:extLst>
          </p:cNvPr>
          <p:cNvPicPr>
            <a:picLocks noChangeAspect="1"/>
          </p:cNvPicPr>
          <p:nvPr/>
        </p:nvPicPr>
        <p:blipFill>
          <a:blip r:embed="rId4"/>
          <a:stretch>
            <a:fillRect/>
          </a:stretch>
        </p:blipFill>
        <p:spPr>
          <a:xfrm>
            <a:off x="430100" y="3171847"/>
            <a:ext cx="4965753" cy="3573214"/>
          </a:xfrm>
          <a:prstGeom prst="rect">
            <a:avLst/>
          </a:prstGeom>
        </p:spPr>
      </p:pic>
    </p:spTree>
    <p:extLst>
      <p:ext uri="{BB962C8B-B14F-4D97-AF65-F5344CB8AC3E}">
        <p14:creationId xmlns:p14="http://schemas.microsoft.com/office/powerpoint/2010/main" val="334253880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593412EE-9CD8-3360-D073-C451344448E2}"/>
              </a:ext>
            </a:extLst>
          </p:cNvPr>
          <p:cNvPicPr>
            <a:picLocks noChangeAspect="1"/>
          </p:cNvPicPr>
          <p:nvPr/>
        </p:nvPicPr>
        <p:blipFill>
          <a:blip r:embed="rId2"/>
          <a:stretch>
            <a:fillRect/>
          </a:stretch>
        </p:blipFill>
        <p:spPr>
          <a:xfrm>
            <a:off x="2128159" y="178346"/>
            <a:ext cx="3524849" cy="3163875"/>
          </a:xfrm>
          <a:prstGeom prst="rect">
            <a:avLst/>
          </a:prstGeom>
        </p:spPr>
      </p:pic>
      <p:pic>
        <p:nvPicPr>
          <p:cNvPr id="7" name="Picture 6">
            <a:extLst>
              <a:ext uri="{FF2B5EF4-FFF2-40B4-BE49-F238E27FC236}">
                <a16:creationId xmlns:a16="http://schemas.microsoft.com/office/drawing/2014/main" id="{782871B7-678D-029C-488B-DCB318204F6A}"/>
              </a:ext>
            </a:extLst>
          </p:cNvPr>
          <p:cNvPicPr>
            <a:picLocks noChangeAspect="1"/>
          </p:cNvPicPr>
          <p:nvPr/>
        </p:nvPicPr>
        <p:blipFill>
          <a:blip r:embed="rId3"/>
          <a:stretch>
            <a:fillRect/>
          </a:stretch>
        </p:blipFill>
        <p:spPr>
          <a:xfrm>
            <a:off x="6361547" y="178220"/>
            <a:ext cx="4670656" cy="3163875"/>
          </a:xfrm>
          <a:prstGeom prst="rect">
            <a:avLst/>
          </a:prstGeom>
        </p:spPr>
      </p:pic>
      <p:pic>
        <p:nvPicPr>
          <p:cNvPr id="9" name="Picture 8" descr="A close up of a wound&#10;&#10;Description automatically generated">
            <a:extLst>
              <a:ext uri="{FF2B5EF4-FFF2-40B4-BE49-F238E27FC236}">
                <a16:creationId xmlns:a16="http://schemas.microsoft.com/office/drawing/2014/main" id="{90739691-6DF8-5C8C-CD43-A7C190DB7236}"/>
              </a:ext>
            </a:extLst>
          </p:cNvPr>
          <p:cNvPicPr>
            <a:picLocks noChangeAspect="1"/>
          </p:cNvPicPr>
          <p:nvPr/>
        </p:nvPicPr>
        <p:blipFill>
          <a:blip r:embed="rId4"/>
          <a:stretch>
            <a:fillRect/>
          </a:stretch>
        </p:blipFill>
        <p:spPr>
          <a:xfrm>
            <a:off x="4671029" y="3424592"/>
            <a:ext cx="3630835" cy="3434668"/>
          </a:xfrm>
          <a:prstGeom prst="rect">
            <a:avLst/>
          </a:prstGeom>
        </p:spPr>
      </p:pic>
      <p:sp>
        <p:nvSpPr>
          <p:cNvPr id="12" name="TextBox 11">
            <a:extLst>
              <a:ext uri="{FF2B5EF4-FFF2-40B4-BE49-F238E27FC236}">
                <a16:creationId xmlns:a16="http://schemas.microsoft.com/office/drawing/2014/main" id="{DA97FB52-3166-017D-EFEC-4F703F1E1CDA}"/>
              </a:ext>
            </a:extLst>
          </p:cNvPr>
          <p:cNvSpPr txBox="1"/>
          <p:nvPr/>
        </p:nvSpPr>
        <p:spPr>
          <a:xfrm>
            <a:off x="124494" y="1176815"/>
            <a:ext cx="1998784" cy="156966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3200" dirty="0"/>
              <a:t>Ischemic/Necrotic Stoma:</a:t>
            </a:r>
            <a:endParaRPr lang="en-US"/>
          </a:p>
        </p:txBody>
      </p:sp>
      <p:sp>
        <p:nvSpPr>
          <p:cNvPr id="14" name="TextBox 13">
            <a:extLst>
              <a:ext uri="{FF2B5EF4-FFF2-40B4-BE49-F238E27FC236}">
                <a16:creationId xmlns:a16="http://schemas.microsoft.com/office/drawing/2014/main" id="{0A85DAAE-964A-2DDE-DCC6-4F339D7AE66A}"/>
              </a:ext>
            </a:extLst>
          </p:cNvPr>
          <p:cNvSpPr txBox="1"/>
          <p:nvPr/>
        </p:nvSpPr>
        <p:spPr>
          <a:xfrm>
            <a:off x="857677" y="4849126"/>
            <a:ext cx="4132384" cy="58477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3200" dirty="0"/>
              <a:t>Stomal Prolapse:</a:t>
            </a:r>
          </a:p>
        </p:txBody>
      </p:sp>
      <p:sp>
        <p:nvSpPr>
          <p:cNvPr id="15" name="TextBox 14">
            <a:extLst>
              <a:ext uri="{FF2B5EF4-FFF2-40B4-BE49-F238E27FC236}">
                <a16:creationId xmlns:a16="http://schemas.microsoft.com/office/drawing/2014/main" id="{422DB743-F04E-F7B1-FA94-CB3C55FB7E32}"/>
              </a:ext>
            </a:extLst>
          </p:cNvPr>
          <p:cNvSpPr txBox="1"/>
          <p:nvPr/>
        </p:nvSpPr>
        <p:spPr>
          <a:xfrm>
            <a:off x="9032874" y="4908550"/>
            <a:ext cx="2676525" cy="46166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2400" dirty="0">
                <a:solidFill>
                  <a:srgbClr val="FF0000"/>
                </a:solidFill>
              </a:rPr>
              <a:t>Consult Ped Surg! </a:t>
            </a:r>
          </a:p>
        </p:txBody>
      </p:sp>
    </p:spTree>
    <p:extLst>
      <p:ext uri="{BB962C8B-B14F-4D97-AF65-F5344CB8AC3E}">
        <p14:creationId xmlns:p14="http://schemas.microsoft.com/office/powerpoint/2010/main" val="3397044096"/>
      </p:ext>
    </p:extLst>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Content Placeholder 3" descr="A close-up of several medical products&#10;&#10;Description automatically generated">
            <a:extLst>
              <a:ext uri="{FF2B5EF4-FFF2-40B4-BE49-F238E27FC236}">
                <a16:creationId xmlns:a16="http://schemas.microsoft.com/office/drawing/2014/main" id="{A7939DCD-F150-35BD-8615-6C389F88659C}"/>
              </a:ext>
            </a:extLst>
          </p:cNvPr>
          <p:cNvPicPr>
            <a:picLocks noGrp="1" noChangeAspect="1"/>
          </p:cNvPicPr>
          <p:nvPr>
            <p:ph idx="1"/>
          </p:nvPr>
        </p:nvPicPr>
        <p:blipFill>
          <a:blip r:embed="rId3"/>
          <a:stretch>
            <a:fillRect/>
          </a:stretch>
        </p:blipFill>
        <p:spPr>
          <a:xfrm>
            <a:off x="5070257" y="1479405"/>
            <a:ext cx="5200650" cy="3409950"/>
          </a:xfrm>
        </p:spPr>
      </p:pic>
      <p:pic>
        <p:nvPicPr>
          <p:cNvPr id="3" name="Picture 2" descr="A close-up of a skin cancer&#10;&#10;Description automatically generated">
            <a:extLst>
              <a:ext uri="{FF2B5EF4-FFF2-40B4-BE49-F238E27FC236}">
                <a16:creationId xmlns:a16="http://schemas.microsoft.com/office/drawing/2014/main" id="{CEC32265-2615-476F-2D7F-C458C8B570E7}"/>
              </a:ext>
            </a:extLst>
          </p:cNvPr>
          <p:cNvPicPr>
            <a:picLocks noChangeAspect="1"/>
          </p:cNvPicPr>
          <p:nvPr/>
        </p:nvPicPr>
        <p:blipFill>
          <a:blip r:embed="rId4"/>
          <a:stretch>
            <a:fillRect/>
          </a:stretch>
        </p:blipFill>
        <p:spPr>
          <a:xfrm>
            <a:off x="121037" y="1840391"/>
            <a:ext cx="4276725" cy="3181350"/>
          </a:xfrm>
          <a:prstGeom prst="rect">
            <a:avLst/>
          </a:prstGeom>
        </p:spPr>
      </p:pic>
      <p:sp>
        <p:nvSpPr>
          <p:cNvPr id="6" name="TextBox 5">
            <a:extLst>
              <a:ext uri="{FF2B5EF4-FFF2-40B4-BE49-F238E27FC236}">
                <a16:creationId xmlns:a16="http://schemas.microsoft.com/office/drawing/2014/main" id="{4B2D22B1-BB60-1512-D5CC-EB14CD805FE6}"/>
              </a:ext>
            </a:extLst>
          </p:cNvPr>
          <p:cNvSpPr txBox="1"/>
          <p:nvPr/>
        </p:nvSpPr>
        <p:spPr>
          <a:xfrm>
            <a:off x="120061" y="636790"/>
            <a:ext cx="4644448" cy="1077218"/>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3200" dirty="0"/>
              <a:t>Peristomal Skin Breakdown:</a:t>
            </a:r>
            <a:endParaRPr lang="en-US"/>
          </a:p>
        </p:txBody>
      </p:sp>
      <p:cxnSp>
        <p:nvCxnSpPr>
          <p:cNvPr id="8" name="Straight Arrow Connector 7">
            <a:extLst>
              <a:ext uri="{FF2B5EF4-FFF2-40B4-BE49-F238E27FC236}">
                <a16:creationId xmlns:a16="http://schemas.microsoft.com/office/drawing/2014/main" id="{C4F96CAB-3BF6-DE6A-B601-E8566B0AB755}"/>
              </a:ext>
            </a:extLst>
          </p:cNvPr>
          <p:cNvCxnSpPr/>
          <p:nvPr/>
        </p:nvCxnSpPr>
        <p:spPr>
          <a:xfrm flipV="1">
            <a:off x="4553201" y="3429129"/>
            <a:ext cx="739070" cy="9441"/>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sp>
        <p:nvSpPr>
          <p:cNvPr id="10" name="Plus Sign 9">
            <a:extLst>
              <a:ext uri="{FF2B5EF4-FFF2-40B4-BE49-F238E27FC236}">
                <a16:creationId xmlns:a16="http://schemas.microsoft.com/office/drawing/2014/main" id="{CAFA1CF3-93E8-EBFC-9FE0-53D2DA7BCADF}"/>
              </a:ext>
            </a:extLst>
          </p:cNvPr>
          <p:cNvSpPr/>
          <p:nvPr/>
        </p:nvSpPr>
        <p:spPr>
          <a:xfrm>
            <a:off x="6894872" y="3189792"/>
            <a:ext cx="444938" cy="414602"/>
          </a:xfrm>
          <a:prstGeom prst="mathPlus">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Plus Sign 10">
            <a:extLst>
              <a:ext uri="{FF2B5EF4-FFF2-40B4-BE49-F238E27FC236}">
                <a16:creationId xmlns:a16="http://schemas.microsoft.com/office/drawing/2014/main" id="{E12C9442-365B-61B2-36EC-CF1E36DBA105}"/>
              </a:ext>
            </a:extLst>
          </p:cNvPr>
          <p:cNvSpPr/>
          <p:nvPr/>
        </p:nvSpPr>
        <p:spPr>
          <a:xfrm>
            <a:off x="10129308" y="3190045"/>
            <a:ext cx="444938" cy="414602"/>
          </a:xfrm>
          <a:prstGeom prst="mathPlus">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3" name="Picture 12" descr="Critic-Aid Skin Protectant 6 oz. 1947, 1 Ct">
            <a:extLst>
              <a:ext uri="{FF2B5EF4-FFF2-40B4-BE49-F238E27FC236}">
                <a16:creationId xmlns:a16="http://schemas.microsoft.com/office/drawing/2014/main" id="{C9DD50D9-0DCE-DF9E-FAC6-219E32F956A8}"/>
              </a:ext>
            </a:extLst>
          </p:cNvPr>
          <p:cNvPicPr>
            <a:picLocks noChangeAspect="1"/>
          </p:cNvPicPr>
          <p:nvPr/>
        </p:nvPicPr>
        <p:blipFill>
          <a:blip r:embed="rId5"/>
          <a:stretch>
            <a:fillRect/>
          </a:stretch>
        </p:blipFill>
        <p:spPr>
          <a:xfrm>
            <a:off x="10582978" y="1360715"/>
            <a:ext cx="1460906" cy="3270249"/>
          </a:xfrm>
          <a:prstGeom prst="rect">
            <a:avLst/>
          </a:prstGeom>
        </p:spPr>
      </p:pic>
      <p:sp>
        <p:nvSpPr>
          <p:cNvPr id="16" name="TextBox 15">
            <a:extLst>
              <a:ext uri="{FF2B5EF4-FFF2-40B4-BE49-F238E27FC236}">
                <a16:creationId xmlns:a16="http://schemas.microsoft.com/office/drawing/2014/main" id="{F3EE0729-B91D-E8C5-7CC6-B2FBBB7481B2}"/>
              </a:ext>
            </a:extLst>
          </p:cNvPr>
          <p:cNvSpPr txBox="1"/>
          <p:nvPr/>
        </p:nvSpPr>
        <p:spPr>
          <a:xfrm>
            <a:off x="6378574" y="762000"/>
            <a:ext cx="3971925" cy="830997"/>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2400" dirty="0"/>
              <a:t>Consult Ostomy/Wound Care Nurse</a:t>
            </a:r>
            <a:endParaRPr lang="en-US"/>
          </a:p>
        </p:txBody>
      </p:sp>
      <p:sp>
        <p:nvSpPr>
          <p:cNvPr id="17" name="TextBox 16">
            <a:extLst>
              <a:ext uri="{FF2B5EF4-FFF2-40B4-BE49-F238E27FC236}">
                <a16:creationId xmlns:a16="http://schemas.microsoft.com/office/drawing/2014/main" id="{58251154-73FB-6AD6-17B9-8611A5847FD1}"/>
              </a:ext>
            </a:extLst>
          </p:cNvPr>
          <p:cNvSpPr txBox="1"/>
          <p:nvPr/>
        </p:nvSpPr>
        <p:spPr>
          <a:xfrm>
            <a:off x="5067300" y="5013325"/>
            <a:ext cx="1885950"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dirty="0"/>
              <a:t>Ostomy Powder </a:t>
            </a:r>
          </a:p>
        </p:txBody>
      </p:sp>
      <p:sp>
        <p:nvSpPr>
          <p:cNvPr id="18" name="TextBox 17">
            <a:extLst>
              <a:ext uri="{FF2B5EF4-FFF2-40B4-BE49-F238E27FC236}">
                <a16:creationId xmlns:a16="http://schemas.microsoft.com/office/drawing/2014/main" id="{5D8BE32C-7C82-C770-0011-5ECD0EF2465D}"/>
              </a:ext>
            </a:extLst>
          </p:cNvPr>
          <p:cNvSpPr txBox="1"/>
          <p:nvPr/>
        </p:nvSpPr>
        <p:spPr>
          <a:xfrm>
            <a:off x="806450" y="5286374"/>
            <a:ext cx="2908300" cy="92333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dirty="0"/>
              <a:t>Moisture/Leakage</a:t>
            </a:r>
          </a:p>
          <a:p>
            <a:pPr algn="ctr"/>
            <a:r>
              <a:rPr lang="en-US" dirty="0"/>
              <a:t>Allergic Reaction</a:t>
            </a:r>
          </a:p>
          <a:p>
            <a:pPr algn="ctr"/>
            <a:r>
              <a:rPr lang="en-US" dirty="0"/>
              <a:t>Yeast Infection</a:t>
            </a:r>
          </a:p>
        </p:txBody>
      </p:sp>
      <p:sp>
        <p:nvSpPr>
          <p:cNvPr id="19" name="TextBox 18">
            <a:extLst>
              <a:ext uri="{FF2B5EF4-FFF2-40B4-BE49-F238E27FC236}">
                <a16:creationId xmlns:a16="http://schemas.microsoft.com/office/drawing/2014/main" id="{0043638C-45D5-60A2-2BD3-922AF314EA72}"/>
              </a:ext>
            </a:extLst>
          </p:cNvPr>
          <p:cNvSpPr txBox="1"/>
          <p:nvPr/>
        </p:nvSpPr>
        <p:spPr>
          <a:xfrm>
            <a:off x="7670799" y="5019675"/>
            <a:ext cx="2286000"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dirty="0"/>
              <a:t>No Sting Barrier Film</a:t>
            </a:r>
          </a:p>
        </p:txBody>
      </p:sp>
      <p:sp>
        <p:nvSpPr>
          <p:cNvPr id="20" name="TextBox 19">
            <a:extLst>
              <a:ext uri="{FF2B5EF4-FFF2-40B4-BE49-F238E27FC236}">
                <a16:creationId xmlns:a16="http://schemas.microsoft.com/office/drawing/2014/main" id="{54F9B086-14EA-1CB9-B537-BE83DDEBDC33}"/>
              </a:ext>
            </a:extLst>
          </p:cNvPr>
          <p:cNvSpPr txBox="1"/>
          <p:nvPr/>
        </p:nvSpPr>
        <p:spPr>
          <a:xfrm>
            <a:off x="10350499" y="4886325"/>
            <a:ext cx="1885950" cy="64633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dirty="0"/>
              <a:t>Zinc-Based Barrier Cream</a:t>
            </a:r>
          </a:p>
        </p:txBody>
      </p:sp>
    </p:spTree>
    <p:extLst>
      <p:ext uri="{BB962C8B-B14F-4D97-AF65-F5344CB8AC3E}">
        <p14:creationId xmlns:p14="http://schemas.microsoft.com/office/powerpoint/2010/main" val="20088234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8"/>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6"/>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4"/>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10"/>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17"/>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19"/>
                                        </p:tgtEl>
                                        <p:attrNameLst>
                                          <p:attrName>style.visibility</p:attrName>
                                        </p:attrNameLst>
                                      </p:cBhvr>
                                      <p:to>
                                        <p:strVal val="visible"/>
                                      </p:to>
                                    </p:set>
                                  </p:childTnLst>
                                </p:cTn>
                              </p:par>
                            </p:childTnLst>
                          </p:cTn>
                        </p:par>
                      </p:childTnLst>
                    </p:cTn>
                  </p:par>
                  <p:par>
                    <p:cTn id="21" fill="hold">
                      <p:stCondLst>
                        <p:cond delay="indefinite"/>
                      </p:stCondLst>
                      <p:childTnLst>
                        <p:par>
                          <p:cTn id="22" fill="hold">
                            <p:stCondLst>
                              <p:cond delay="0"/>
                            </p:stCondLst>
                            <p:childTnLst>
                              <p:par>
                                <p:cTn id="23" presetID="1" presetClass="entr" presetSubtype="0" fill="hold" grpId="0" nodeType="clickEffect">
                                  <p:stCondLst>
                                    <p:cond delay="0"/>
                                  </p:stCondLst>
                                  <p:childTnLst>
                                    <p:set>
                                      <p:cBhvr>
                                        <p:cTn id="24" dur="1" fill="hold">
                                          <p:stCondLst>
                                            <p:cond delay="0"/>
                                          </p:stCondLst>
                                        </p:cTn>
                                        <p:tgtEl>
                                          <p:spTgt spid="11"/>
                                        </p:tgtEl>
                                        <p:attrNameLst>
                                          <p:attrName>style.visibility</p:attrName>
                                        </p:attrNameLst>
                                      </p:cBhvr>
                                      <p:to>
                                        <p:strVal val="visible"/>
                                      </p:to>
                                    </p:set>
                                  </p:childTnLst>
                                </p:cTn>
                              </p:par>
                              <p:par>
                                <p:cTn id="25" presetID="1" presetClass="entr" presetSubtype="0" fill="hold" nodeType="withEffect">
                                  <p:stCondLst>
                                    <p:cond delay="0"/>
                                  </p:stCondLst>
                                  <p:childTnLst>
                                    <p:set>
                                      <p:cBhvr>
                                        <p:cTn id="26" dur="1" fill="hold">
                                          <p:stCondLst>
                                            <p:cond delay="0"/>
                                          </p:stCondLst>
                                        </p:cTn>
                                        <p:tgtEl>
                                          <p:spTgt spid="13"/>
                                        </p:tgtEl>
                                        <p:attrNameLst>
                                          <p:attrName>style.visibility</p:attrName>
                                        </p:attrNameLst>
                                      </p:cBhvr>
                                      <p:to>
                                        <p:strVal val="visible"/>
                                      </p:to>
                                    </p:set>
                                  </p:childTnLst>
                                </p:cTn>
                              </p:par>
                              <p:par>
                                <p:cTn id="27" presetID="1" presetClass="entr" presetSubtype="0" fill="hold" grpId="0" nodeType="withEffect">
                                  <p:stCondLst>
                                    <p:cond delay="0"/>
                                  </p:stCondLst>
                                  <p:childTnLst>
                                    <p:set>
                                      <p:cBhvr>
                                        <p:cTn id="28" dur="1" fill="hold">
                                          <p:stCondLst>
                                            <p:cond delay="0"/>
                                          </p:stCondLst>
                                        </p:cTn>
                                        <p:tgtEl>
                                          <p:spTgt spid="2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 grpId="0" animBg="1"/>
      <p:bldP spid="11" grpId="0" animBg="1"/>
      <p:bldP spid="16" grpId="0"/>
      <p:bldP spid="17" grpId="0"/>
      <p:bldP spid="19" grpId="0"/>
      <p:bldP spid="20" grpId="0"/>
    </p:bldLst>
  </p:timing>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pic>
        <p:nvPicPr>
          <p:cNvPr id="2" name="Picture 1" descr="A diagram of a complex of vitamins&#10;&#10;Description automatically generated">
            <a:extLst>
              <a:ext uri="{FF2B5EF4-FFF2-40B4-BE49-F238E27FC236}">
                <a16:creationId xmlns:a16="http://schemas.microsoft.com/office/drawing/2014/main" id="{A39918D0-1548-2AC8-502B-16B34FC8317D}"/>
              </a:ext>
            </a:extLst>
          </p:cNvPr>
          <p:cNvPicPr>
            <a:picLocks noChangeAspect="1"/>
          </p:cNvPicPr>
          <p:nvPr/>
        </p:nvPicPr>
        <p:blipFill>
          <a:blip r:embed="rId3"/>
          <a:stretch>
            <a:fillRect/>
          </a:stretch>
        </p:blipFill>
        <p:spPr>
          <a:xfrm>
            <a:off x="1435610" y="53184"/>
            <a:ext cx="9191989" cy="6805292"/>
          </a:xfrm>
          <a:prstGeom prst="rect">
            <a:avLst/>
          </a:prstGeom>
        </p:spPr>
      </p:pic>
      <p:sp>
        <p:nvSpPr>
          <p:cNvPr id="4" name="Oval 3">
            <a:extLst>
              <a:ext uri="{FF2B5EF4-FFF2-40B4-BE49-F238E27FC236}">
                <a16:creationId xmlns:a16="http://schemas.microsoft.com/office/drawing/2014/main" id="{5EAD482C-EFF1-44CF-B54A-758B79606F3D}"/>
              </a:ext>
            </a:extLst>
          </p:cNvPr>
          <p:cNvSpPr/>
          <p:nvPr/>
        </p:nvSpPr>
        <p:spPr>
          <a:xfrm>
            <a:off x="4913516" y="850548"/>
            <a:ext cx="3594022" cy="2842155"/>
          </a:xfrm>
          <a:prstGeom prst="ellipse">
            <a:avLst/>
          </a:prstGeom>
          <a:noFill/>
          <a:ln w="28575">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Oval 4">
            <a:extLst>
              <a:ext uri="{FF2B5EF4-FFF2-40B4-BE49-F238E27FC236}">
                <a16:creationId xmlns:a16="http://schemas.microsoft.com/office/drawing/2014/main" id="{8D4F7496-950C-05BB-173A-4A3A5F9FA2C7}"/>
              </a:ext>
            </a:extLst>
          </p:cNvPr>
          <p:cNvSpPr/>
          <p:nvPr/>
        </p:nvSpPr>
        <p:spPr>
          <a:xfrm>
            <a:off x="6432152" y="3689265"/>
            <a:ext cx="4978497" cy="3180223"/>
          </a:xfrm>
          <a:prstGeom prst="ellipse">
            <a:avLst/>
          </a:prstGeom>
          <a:noFill/>
          <a:ln w="28575">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Oval 5">
            <a:extLst>
              <a:ext uri="{FF2B5EF4-FFF2-40B4-BE49-F238E27FC236}">
                <a16:creationId xmlns:a16="http://schemas.microsoft.com/office/drawing/2014/main" id="{5057A5BE-BD8B-C01A-153D-C0F08300E901}"/>
              </a:ext>
            </a:extLst>
          </p:cNvPr>
          <p:cNvSpPr/>
          <p:nvPr/>
        </p:nvSpPr>
        <p:spPr>
          <a:xfrm>
            <a:off x="1581108" y="2970194"/>
            <a:ext cx="4661893" cy="3582688"/>
          </a:xfrm>
          <a:prstGeom prst="ellipse">
            <a:avLst/>
          </a:prstGeom>
          <a:noFill/>
          <a:ln w="28575">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Oval 6">
            <a:extLst>
              <a:ext uri="{FF2B5EF4-FFF2-40B4-BE49-F238E27FC236}">
                <a16:creationId xmlns:a16="http://schemas.microsoft.com/office/drawing/2014/main" id="{26615FD8-CA50-94EA-8204-2318FD048A44}"/>
              </a:ext>
            </a:extLst>
          </p:cNvPr>
          <p:cNvSpPr/>
          <p:nvPr/>
        </p:nvSpPr>
        <p:spPr>
          <a:xfrm>
            <a:off x="776178" y="8053"/>
            <a:ext cx="3862330" cy="3083631"/>
          </a:xfrm>
          <a:prstGeom prst="ellipse">
            <a:avLst/>
          </a:prstGeom>
          <a:noFill/>
          <a:ln w="28575">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a:extLst>
              <a:ext uri="{FF2B5EF4-FFF2-40B4-BE49-F238E27FC236}">
                <a16:creationId xmlns:a16="http://schemas.microsoft.com/office/drawing/2014/main" id="{3F10592F-F6BB-225D-4660-61DB248C111B}"/>
              </a:ext>
            </a:extLst>
          </p:cNvPr>
          <p:cNvSpPr/>
          <p:nvPr/>
        </p:nvSpPr>
        <p:spPr>
          <a:xfrm>
            <a:off x="1583631" y="4759388"/>
            <a:ext cx="1182058" cy="339115"/>
          </a:xfrm>
          <a:prstGeom prst="rect">
            <a:avLst/>
          </a:prstGeom>
          <a:noFill/>
          <a:ln w="28575">
            <a:solidFill>
              <a:srgbClr val="FF0000"/>
            </a:solidFill>
            <a:prstDash val="dash"/>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Rectangle 2">
            <a:extLst>
              <a:ext uri="{FF2B5EF4-FFF2-40B4-BE49-F238E27FC236}">
                <a16:creationId xmlns:a16="http://schemas.microsoft.com/office/drawing/2014/main" id="{413D458D-0166-F4A0-0D32-6DC38DB896D9}"/>
              </a:ext>
            </a:extLst>
          </p:cNvPr>
          <p:cNvSpPr/>
          <p:nvPr/>
        </p:nvSpPr>
        <p:spPr>
          <a:xfrm>
            <a:off x="1612604" y="4772838"/>
            <a:ext cx="1128231" cy="307161"/>
          </a:xfrm>
          <a:prstGeom prst="rect">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sz="1600" dirty="0"/>
              <a:t>Ileal Brake</a:t>
            </a:r>
            <a:endParaRPr lang="en-US"/>
          </a:p>
        </p:txBody>
      </p:sp>
    </p:spTree>
    <p:extLst>
      <p:ext uri="{BB962C8B-B14F-4D97-AF65-F5344CB8AC3E}">
        <p14:creationId xmlns:p14="http://schemas.microsoft.com/office/powerpoint/2010/main" val="396965478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5"/>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6"/>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P spid="5" grpId="0" animBg="1"/>
      <p:bldP spid="6" grpId="0" animBg="1"/>
      <p:bldP spid="7" grpId="0" animBg="1"/>
    </p:bldLst>
  </p:timing>
</p:sld>
</file>

<file path=ppt/slides/slide5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8" name="Rectangle 7">
            <a:extLst>
              <a:ext uri="{FF2B5EF4-FFF2-40B4-BE49-F238E27FC236}">
                <a16:creationId xmlns:a16="http://schemas.microsoft.com/office/drawing/2014/main" id="{43C48B49-6135-48B6-AC0F-97E5D8D1F03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w="12700" cap="flat" cmpd="sng" algn="ctr">
            <a:noFill/>
            <a:prstDash val="solid"/>
            <a:miter lim="800000"/>
          </a:ln>
          <a:effectLst/>
          <a:extLst>
            <a:ext uri="{91240B29-F687-4F45-9708-019B960494DF}">
              <a14:hiddenLine xmlns:a14="http://schemas.microsoft.com/office/drawing/2010/main" w="12700" cap="flat" cmpd="sng" algn="ctr">
                <a:solidFill>
                  <a:schemeClr val="accent1">
                    <a:shade val="50000"/>
                  </a:schemeClr>
                </a:solidFill>
                <a:prstDash val="solid"/>
                <a:miter lim="800000"/>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16195E82-86AE-AB44-06FF-1A93F02750DC}"/>
              </a:ext>
            </a:extLst>
          </p:cNvPr>
          <p:cNvSpPr>
            <a:spLocks noGrp="1"/>
          </p:cNvSpPr>
          <p:nvPr>
            <p:ph type="ctrTitle"/>
          </p:nvPr>
        </p:nvSpPr>
        <p:spPr>
          <a:xfrm>
            <a:off x="1329766" y="1146412"/>
            <a:ext cx="9014348" cy="2402006"/>
          </a:xfrm>
        </p:spPr>
        <p:txBody>
          <a:bodyPr anchor="b">
            <a:normAutofit fontScale="90000"/>
          </a:bodyPr>
          <a:lstStyle/>
          <a:p>
            <a:r>
              <a:rPr lang="en-US" sz="4800" dirty="0"/>
              <a:t>Thanks to ICARE team!! </a:t>
            </a:r>
            <a:br>
              <a:rPr lang="en-US" sz="4800" dirty="0"/>
            </a:br>
            <a:r>
              <a:rPr lang="en-US" sz="4800" dirty="0"/>
              <a:t>Special thanks to Dr Raghu, </a:t>
            </a:r>
            <a:br>
              <a:rPr lang="en-US" sz="4800" dirty="0"/>
            </a:br>
            <a:r>
              <a:rPr lang="en-US" sz="4800" dirty="0"/>
              <a:t>Dr Alissa, Kim Ackerman, Tracey </a:t>
            </a:r>
            <a:r>
              <a:rPr lang="en-US" sz="4800" dirty="0" err="1"/>
              <a:t>Presel</a:t>
            </a:r>
            <a:r>
              <a:rPr lang="en-US" sz="4800" dirty="0"/>
              <a:t>, Sarah Fox.</a:t>
            </a:r>
          </a:p>
        </p:txBody>
      </p:sp>
      <p:sp>
        <p:nvSpPr>
          <p:cNvPr id="10" name="Rectangle 9">
            <a:extLst>
              <a:ext uri="{FF2B5EF4-FFF2-40B4-BE49-F238E27FC236}">
                <a16:creationId xmlns:a16="http://schemas.microsoft.com/office/drawing/2014/main" id="{9715DAF0-AE1B-46C9-8A6B-DB2AA05AB91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0800000">
            <a:off x="-8" y="4374554"/>
            <a:ext cx="12192007" cy="2483444"/>
          </a:xfrm>
          <a:prstGeom prst="rect">
            <a:avLst/>
          </a:prstGeom>
          <a:gradFill>
            <a:gsLst>
              <a:gs pos="0">
                <a:schemeClr val="accent1">
                  <a:lumMod val="75000"/>
                </a:schemeClr>
              </a:gs>
              <a:gs pos="100000">
                <a:srgbClr val="000000"/>
              </a:gs>
            </a:gsLst>
            <a:lin ang="156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DC631C0B-6DA6-4E57-8231-CE32B3434A7E}"/>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0800000" flipH="1">
            <a:off x="8140655" y="4374554"/>
            <a:ext cx="4051344" cy="2483446"/>
          </a:xfrm>
          <a:prstGeom prst="rect">
            <a:avLst/>
          </a:prstGeom>
          <a:gradFill>
            <a:gsLst>
              <a:gs pos="4000">
                <a:schemeClr val="accent1">
                  <a:alpha val="21000"/>
                </a:schemeClr>
              </a:gs>
              <a:gs pos="83000">
                <a:schemeClr val="accent1">
                  <a:lumMod val="50000"/>
                  <a:alpha val="61000"/>
                </a:schemeClr>
              </a:gs>
            </a:gsLst>
            <a:lin ang="180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13">
            <a:extLst>
              <a:ext uri="{FF2B5EF4-FFF2-40B4-BE49-F238E27FC236}">
                <a16:creationId xmlns:a16="http://schemas.microsoft.com/office/drawing/2014/main" id="{F256AC18-FB41-4977-8B0C-F5082335AB7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rot="10800000">
            <a:off x="0" y="4379429"/>
            <a:ext cx="12191984" cy="1953928"/>
          </a:xfrm>
          <a:prstGeom prst="rect">
            <a:avLst/>
          </a:prstGeom>
          <a:gradFill>
            <a:gsLst>
              <a:gs pos="32000">
                <a:schemeClr val="accent1">
                  <a:lumMod val="50000"/>
                  <a:alpha val="0"/>
                </a:schemeClr>
              </a:gs>
              <a:gs pos="100000">
                <a:schemeClr val="accent1">
                  <a:alpha val="55000"/>
                </a:schemeClr>
              </a:gs>
            </a:gsLst>
            <a:lin ang="66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ectangle 15">
            <a:extLst>
              <a:ext uri="{FF2B5EF4-FFF2-40B4-BE49-F238E27FC236}">
                <a16:creationId xmlns:a16="http://schemas.microsoft.com/office/drawing/2014/main" id="{AFF4A713-7B75-4B21-90D7-5AB19547C72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 y="4380927"/>
            <a:ext cx="12192000" cy="2019443"/>
          </a:xfrm>
          <a:prstGeom prst="rect">
            <a:avLst/>
          </a:prstGeom>
          <a:gradFill>
            <a:gsLst>
              <a:gs pos="32000">
                <a:schemeClr val="accent1">
                  <a:lumMod val="50000"/>
                  <a:alpha val="0"/>
                </a:schemeClr>
              </a:gs>
              <a:gs pos="100000">
                <a:srgbClr val="000000">
                  <a:alpha val="45000"/>
                </a:srgbClr>
              </a:gs>
            </a:gsLst>
            <a:lin ang="78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Subtitle 2">
            <a:extLst>
              <a:ext uri="{FF2B5EF4-FFF2-40B4-BE49-F238E27FC236}">
                <a16:creationId xmlns:a16="http://schemas.microsoft.com/office/drawing/2014/main" id="{0DD947CF-FC6B-318D-FE2A-A5727C629A3D}"/>
              </a:ext>
            </a:extLst>
          </p:cNvPr>
          <p:cNvSpPr>
            <a:spLocks noGrp="1"/>
          </p:cNvSpPr>
          <p:nvPr>
            <p:ph type="subTitle" idx="1"/>
          </p:nvPr>
        </p:nvSpPr>
        <p:spPr>
          <a:xfrm>
            <a:off x="1329765" y="4892722"/>
            <a:ext cx="6387155" cy="1078173"/>
          </a:xfrm>
        </p:spPr>
        <p:txBody>
          <a:bodyPr vert="horz" lIns="91440" tIns="45720" rIns="91440" bIns="45720" rtlCol="0" anchor="ctr">
            <a:normAutofit/>
          </a:bodyPr>
          <a:lstStyle/>
          <a:p>
            <a:pPr algn="l"/>
            <a:r>
              <a:rPr lang="en-US">
                <a:solidFill>
                  <a:srgbClr val="FFFFFF"/>
                </a:solidFill>
              </a:rPr>
              <a:t>Questions?</a:t>
            </a:r>
          </a:p>
        </p:txBody>
      </p:sp>
    </p:spTree>
    <p:extLst>
      <p:ext uri="{BB962C8B-B14F-4D97-AF65-F5344CB8AC3E}">
        <p14:creationId xmlns:p14="http://schemas.microsoft.com/office/powerpoint/2010/main" val="3434993078"/>
      </p:ext>
    </p:extLst>
  </p:cSld>
  <p:clrMapOvr>
    <a:masterClrMapping/>
  </p:clrMapOvr>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33500BA-240B-4E4F-1936-2100A23516CA}"/>
              </a:ext>
            </a:extLst>
          </p:cNvPr>
          <p:cNvSpPr>
            <a:spLocks noGrp="1"/>
          </p:cNvSpPr>
          <p:nvPr>
            <p:ph type="title"/>
          </p:nvPr>
        </p:nvSpPr>
        <p:spPr/>
        <p:txBody>
          <a:bodyPr/>
          <a:lstStyle/>
          <a:p>
            <a:r>
              <a:rPr lang="en-US" dirty="0"/>
              <a:t>References:</a:t>
            </a:r>
          </a:p>
        </p:txBody>
      </p:sp>
      <p:sp>
        <p:nvSpPr>
          <p:cNvPr id="3" name="Content Placeholder 2">
            <a:extLst>
              <a:ext uri="{FF2B5EF4-FFF2-40B4-BE49-F238E27FC236}">
                <a16:creationId xmlns:a16="http://schemas.microsoft.com/office/drawing/2014/main" id="{4A01C084-E4E4-6950-077A-5C215D5C06BE}"/>
              </a:ext>
            </a:extLst>
          </p:cNvPr>
          <p:cNvSpPr>
            <a:spLocks noGrp="1"/>
          </p:cNvSpPr>
          <p:nvPr>
            <p:ph idx="1"/>
          </p:nvPr>
        </p:nvSpPr>
        <p:spPr>
          <a:xfrm>
            <a:off x="838200" y="1690158"/>
            <a:ext cx="10515600" cy="4351338"/>
          </a:xfrm>
        </p:spPr>
        <p:txBody>
          <a:bodyPr vert="horz" lIns="91440" tIns="45720" rIns="91440" bIns="45720" rtlCol="0" anchor="t">
            <a:normAutofit lnSpcReduction="10000"/>
          </a:bodyPr>
          <a:lstStyle/>
          <a:p>
            <a:r>
              <a:rPr lang="en-US" sz="1200" dirty="0">
                <a:solidFill>
                  <a:srgbClr val="212121"/>
                </a:solidFill>
                <a:latin typeface="system-ui"/>
                <a:ea typeface="+mn-lt"/>
                <a:cs typeface="+mn-lt"/>
              </a:rPr>
              <a:t>Wendel, D., </a:t>
            </a:r>
            <a:r>
              <a:rPr lang="en-US" sz="1200" dirty="0" err="1">
                <a:solidFill>
                  <a:srgbClr val="212121"/>
                </a:solidFill>
                <a:latin typeface="system-ui"/>
                <a:ea typeface="+mn-lt"/>
                <a:cs typeface="+mn-lt"/>
              </a:rPr>
              <a:t>Mezoff</a:t>
            </a:r>
            <a:r>
              <a:rPr lang="en-US" sz="1200" dirty="0">
                <a:solidFill>
                  <a:srgbClr val="212121"/>
                </a:solidFill>
                <a:latin typeface="system-ui"/>
                <a:ea typeface="+mn-lt"/>
                <a:cs typeface="+mn-lt"/>
              </a:rPr>
              <a:t>, E. A., Raghu, V. K., Kinberg, S., Soden, J., Avitzur, Y., Rudolph, J. A., Gniadek, M., Cohran, V. C., </a:t>
            </a:r>
            <a:r>
              <a:rPr lang="en-US" sz="1200" dirty="0" err="1">
                <a:solidFill>
                  <a:srgbClr val="212121"/>
                </a:solidFill>
                <a:latin typeface="system-ui"/>
                <a:ea typeface="+mn-lt"/>
                <a:cs typeface="+mn-lt"/>
              </a:rPr>
              <a:t>Venick</a:t>
            </a:r>
            <a:r>
              <a:rPr lang="en-US" sz="1200" dirty="0">
                <a:solidFill>
                  <a:srgbClr val="212121"/>
                </a:solidFill>
                <a:latin typeface="system-ui"/>
                <a:ea typeface="+mn-lt"/>
                <a:cs typeface="+mn-lt"/>
              </a:rPr>
              <a:t>, R. S., &amp; Cole, C. R. (2021). Management of Central Venous Access in Children With Intestinal Failure: A Position Paper From the NASPGHAN Intestinal Rehabilitation Special Interest Group. </a:t>
            </a:r>
            <a:r>
              <a:rPr lang="en-US" sz="1200" i="1" dirty="0">
                <a:solidFill>
                  <a:srgbClr val="212121"/>
                </a:solidFill>
                <a:latin typeface="system-ui"/>
                <a:ea typeface="+mn-lt"/>
                <a:cs typeface="+mn-lt"/>
              </a:rPr>
              <a:t>Journal of pediatric gastroenterology and nutrition</a:t>
            </a:r>
            <a:r>
              <a:rPr lang="en-US" sz="1200" dirty="0">
                <a:solidFill>
                  <a:srgbClr val="212121"/>
                </a:solidFill>
                <a:latin typeface="system-ui"/>
                <a:ea typeface="+mn-lt"/>
                <a:cs typeface="+mn-lt"/>
              </a:rPr>
              <a:t>, </a:t>
            </a:r>
            <a:r>
              <a:rPr lang="en-US" sz="1200" i="1" dirty="0">
                <a:solidFill>
                  <a:srgbClr val="212121"/>
                </a:solidFill>
                <a:latin typeface="system-ui"/>
                <a:ea typeface="+mn-lt"/>
                <a:cs typeface="+mn-lt"/>
              </a:rPr>
              <a:t>72</a:t>
            </a:r>
            <a:r>
              <a:rPr lang="en-US" sz="1200" dirty="0">
                <a:solidFill>
                  <a:srgbClr val="212121"/>
                </a:solidFill>
                <a:latin typeface="system-ui"/>
                <a:ea typeface="+mn-lt"/>
                <a:cs typeface="+mn-lt"/>
              </a:rPr>
              <a:t>(3), 474–486. </a:t>
            </a:r>
            <a:r>
              <a:rPr lang="en-US" sz="1200" dirty="0">
                <a:solidFill>
                  <a:srgbClr val="212121"/>
                </a:solidFill>
                <a:latin typeface="system-ui"/>
                <a:ea typeface="+mn-lt"/>
                <a:cs typeface="+mn-lt"/>
                <a:hlinkClick r:id="rId2"/>
              </a:rPr>
              <a:t>https://doi.org/10.1097/MPG.0000000000003036</a:t>
            </a:r>
            <a:endParaRPr lang="en-US" sz="1200" dirty="0">
              <a:solidFill>
                <a:srgbClr val="1B1B1B"/>
              </a:solidFill>
              <a:ea typeface="+mn-lt"/>
              <a:cs typeface="+mn-lt"/>
            </a:endParaRPr>
          </a:p>
          <a:p>
            <a:r>
              <a:rPr lang="en-US" sz="1200" dirty="0" err="1">
                <a:solidFill>
                  <a:srgbClr val="212121"/>
                </a:solidFill>
                <a:latin typeface="system-ui"/>
                <a:ea typeface="+mn-lt"/>
                <a:cs typeface="+mn-lt"/>
              </a:rPr>
              <a:t>Pironi</a:t>
            </a:r>
            <a:r>
              <a:rPr lang="en-US" sz="1200" dirty="0">
                <a:solidFill>
                  <a:srgbClr val="212121"/>
                </a:solidFill>
                <a:latin typeface="system-ui"/>
                <a:ea typeface="+mn-lt"/>
                <a:cs typeface="+mn-lt"/>
              </a:rPr>
              <a:t> L. (2016). Definitions of intestinal failure and the short bowel syndrome. </a:t>
            </a:r>
            <a:r>
              <a:rPr lang="en-US" sz="1200" i="1" dirty="0">
                <a:solidFill>
                  <a:srgbClr val="212121"/>
                </a:solidFill>
                <a:latin typeface="system-ui"/>
                <a:ea typeface="+mn-lt"/>
                <a:cs typeface="+mn-lt"/>
              </a:rPr>
              <a:t>Best practice &amp; research. Clinical gastroenterology</a:t>
            </a:r>
            <a:r>
              <a:rPr lang="en-US" sz="1200" dirty="0">
                <a:solidFill>
                  <a:srgbClr val="212121"/>
                </a:solidFill>
                <a:latin typeface="system-ui"/>
                <a:ea typeface="+mn-lt"/>
                <a:cs typeface="+mn-lt"/>
              </a:rPr>
              <a:t>, </a:t>
            </a:r>
            <a:r>
              <a:rPr lang="en-US" sz="1200" i="1" dirty="0">
                <a:solidFill>
                  <a:srgbClr val="212121"/>
                </a:solidFill>
                <a:latin typeface="system-ui"/>
                <a:ea typeface="+mn-lt"/>
                <a:cs typeface="+mn-lt"/>
              </a:rPr>
              <a:t>30</a:t>
            </a:r>
            <a:r>
              <a:rPr lang="en-US" sz="1200" dirty="0">
                <a:solidFill>
                  <a:srgbClr val="212121"/>
                </a:solidFill>
                <a:latin typeface="system-ui"/>
                <a:ea typeface="+mn-lt"/>
                <a:cs typeface="+mn-lt"/>
              </a:rPr>
              <a:t>(2), 173–185. </a:t>
            </a:r>
            <a:r>
              <a:rPr lang="en-US" sz="1200" dirty="0">
                <a:solidFill>
                  <a:srgbClr val="212121"/>
                </a:solidFill>
                <a:latin typeface="system-ui"/>
                <a:ea typeface="+mn-lt"/>
                <a:cs typeface="+mn-lt"/>
                <a:hlinkClick r:id="rId3"/>
              </a:rPr>
              <a:t>https://doi.org/10.1016/j.bpg.2016.02.011</a:t>
            </a:r>
          </a:p>
          <a:p>
            <a:r>
              <a:rPr lang="en-US" sz="1200" dirty="0">
                <a:solidFill>
                  <a:srgbClr val="212121"/>
                </a:solidFill>
                <a:latin typeface="system-ui"/>
                <a:ea typeface="+mn-lt"/>
                <a:cs typeface="+mn-lt"/>
              </a:rPr>
              <a:t>Grant D. (1999). Intestinal transplantation: 1997 report of the international registry. Intestinal Transplant Registry. </a:t>
            </a:r>
            <a:r>
              <a:rPr lang="en-US" sz="1200" i="1" dirty="0">
                <a:solidFill>
                  <a:srgbClr val="212121"/>
                </a:solidFill>
                <a:latin typeface="system-ui"/>
                <a:ea typeface="+mn-lt"/>
                <a:cs typeface="+mn-lt"/>
              </a:rPr>
              <a:t>Transplantation</a:t>
            </a:r>
            <a:r>
              <a:rPr lang="en-US" sz="1200" dirty="0">
                <a:solidFill>
                  <a:srgbClr val="212121"/>
                </a:solidFill>
                <a:latin typeface="system-ui"/>
                <a:ea typeface="+mn-lt"/>
                <a:cs typeface="+mn-lt"/>
              </a:rPr>
              <a:t>, </a:t>
            </a:r>
            <a:r>
              <a:rPr lang="en-US" sz="1200" i="1" dirty="0">
                <a:solidFill>
                  <a:srgbClr val="212121"/>
                </a:solidFill>
                <a:latin typeface="system-ui"/>
                <a:ea typeface="+mn-lt"/>
                <a:cs typeface="+mn-lt"/>
              </a:rPr>
              <a:t>67</a:t>
            </a:r>
            <a:r>
              <a:rPr lang="en-US" sz="1200" dirty="0">
                <a:solidFill>
                  <a:srgbClr val="212121"/>
                </a:solidFill>
                <a:latin typeface="system-ui"/>
                <a:ea typeface="+mn-lt"/>
                <a:cs typeface="+mn-lt"/>
              </a:rPr>
              <a:t>(7), 1061–1064. </a:t>
            </a:r>
            <a:r>
              <a:rPr lang="en-US" sz="1200" dirty="0">
                <a:solidFill>
                  <a:srgbClr val="212121"/>
                </a:solidFill>
                <a:latin typeface="system-ui"/>
                <a:ea typeface="+mn-lt"/>
                <a:cs typeface="+mn-lt"/>
                <a:hlinkClick r:id="rId4"/>
              </a:rPr>
              <a:t>https://doi.org/10.1097/00007890-199904150-00021</a:t>
            </a:r>
          </a:p>
          <a:p>
            <a:r>
              <a:rPr lang="en-US" sz="1300" dirty="0">
                <a:solidFill>
                  <a:srgbClr val="1B1B1B"/>
                </a:solidFill>
                <a:ea typeface="+mn-lt"/>
                <a:cs typeface="+mn-lt"/>
              </a:rPr>
              <a:t>Gosselin, K. B., &amp; Duggan, C. (2014). Enteral nutrition in the management of pediatric intestinal failure. </a:t>
            </a:r>
            <a:r>
              <a:rPr lang="en-US" sz="1300" i="1" dirty="0">
                <a:solidFill>
                  <a:srgbClr val="1B1B1B"/>
                </a:solidFill>
                <a:ea typeface="+mn-lt"/>
                <a:cs typeface="+mn-lt"/>
              </a:rPr>
              <a:t>The Journal of pediatrics</a:t>
            </a:r>
            <a:r>
              <a:rPr lang="en-US" sz="1300" dirty="0">
                <a:solidFill>
                  <a:srgbClr val="1B1B1B"/>
                </a:solidFill>
                <a:ea typeface="+mn-lt"/>
                <a:cs typeface="+mn-lt"/>
              </a:rPr>
              <a:t>, </a:t>
            </a:r>
            <a:r>
              <a:rPr lang="en-US" sz="1300" i="1" dirty="0">
                <a:solidFill>
                  <a:srgbClr val="1B1B1B"/>
                </a:solidFill>
                <a:ea typeface="+mn-lt"/>
                <a:cs typeface="+mn-lt"/>
              </a:rPr>
              <a:t>165</a:t>
            </a:r>
            <a:r>
              <a:rPr lang="en-US" sz="1300" dirty="0">
                <a:solidFill>
                  <a:srgbClr val="1B1B1B"/>
                </a:solidFill>
                <a:ea typeface="+mn-lt"/>
                <a:cs typeface="+mn-lt"/>
              </a:rPr>
              <a:t>(6), 1085–1090. https://doi.org/10.1016/j.jpeds.2014.08.012</a:t>
            </a:r>
            <a:endParaRPr lang="en-US" sz="1200" dirty="0">
              <a:solidFill>
                <a:srgbClr val="212121"/>
              </a:solidFill>
              <a:latin typeface="system-ui"/>
              <a:ea typeface="+mn-lt"/>
              <a:cs typeface="+mn-lt"/>
            </a:endParaRPr>
          </a:p>
          <a:p>
            <a:r>
              <a:rPr lang="en-US" sz="1200" dirty="0">
                <a:solidFill>
                  <a:srgbClr val="212121"/>
                </a:solidFill>
                <a:latin typeface="system-ui"/>
                <a:ea typeface="+mn-lt"/>
                <a:cs typeface="+mn-lt"/>
              </a:rPr>
              <a:t>Duggan, C. P., &amp; Jaksic, T. (2017). Pediatric Intestinal Failure. </a:t>
            </a:r>
            <a:r>
              <a:rPr lang="en-US" sz="1200" i="1" dirty="0">
                <a:solidFill>
                  <a:srgbClr val="212121"/>
                </a:solidFill>
                <a:latin typeface="system-ui"/>
                <a:ea typeface="+mn-lt"/>
                <a:cs typeface="+mn-lt"/>
              </a:rPr>
              <a:t>The New England journal of medicine</a:t>
            </a:r>
            <a:r>
              <a:rPr lang="en-US" sz="1200" dirty="0">
                <a:solidFill>
                  <a:srgbClr val="212121"/>
                </a:solidFill>
                <a:latin typeface="system-ui"/>
                <a:ea typeface="+mn-lt"/>
                <a:cs typeface="+mn-lt"/>
              </a:rPr>
              <a:t>, </a:t>
            </a:r>
            <a:r>
              <a:rPr lang="en-US" sz="1200" i="1" dirty="0">
                <a:solidFill>
                  <a:srgbClr val="212121"/>
                </a:solidFill>
                <a:latin typeface="system-ui"/>
                <a:ea typeface="+mn-lt"/>
                <a:cs typeface="+mn-lt"/>
              </a:rPr>
              <a:t>377</a:t>
            </a:r>
            <a:r>
              <a:rPr lang="en-US" sz="1200" dirty="0">
                <a:solidFill>
                  <a:srgbClr val="212121"/>
                </a:solidFill>
                <a:latin typeface="system-ui"/>
                <a:ea typeface="+mn-lt"/>
                <a:cs typeface="+mn-lt"/>
              </a:rPr>
              <a:t>(7), 666–675. https://doi.org/10.1056/NEJMra1602650</a:t>
            </a:r>
          </a:p>
          <a:p>
            <a:r>
              <a:rPr lang="en-US" sz="1200" dirty="0" err="1">
                <a:solidFill>
                  <a:srgbClr val="212121"/>
                </a:solidFill>
                <a:latin typeface="system-ui"/>
                <a:ea typeface="+mn-lt"/>
                <a:cs typeface="+mn-lt"/>
              </a:rPr>
              <a:t>Blotte</a:t>
            </a:r>
            <a:r>
              <a:rPr lang="en-US" sz="1200" dirty="0">
                <a:solidFill>
                  <a:srgbClr val="212121"/>
                </a:solidFill>
                <a:latin typeface="system-ui"/>
                <a:ea typeface="+mn-lt"/>
                <a:cs typeface="+mn-lt"/>
              </a:rPr>
              <a:t>, C., Styers, J., Zhu, H., </a:t>
            </a:r>
            <a:r>
              <a:rPr lang="en-US" sz="1200" dirty="0" err="1">
                <a:solidFill>
                  <a:srgbClr val="212121"/>
                </a:solidFill>
                <a:latin typeface="system-ui"/>
                <a:ea typeface="+mn-lt"/>
                <a:cs typeface="+mn-lt"/>
              </a:rPr>
              <a:t>Channabasappa</a:t>
            </a:r>
            <a:r>
              <a:rPr lang="en-US" sz="1200" dirty="0">
                <a:solidFill>
                  <a:srgbClr val="212121"/>
                </a:solidFill>
                <a:latin typeface="system-ui"/>
                <a:ea typeface="+mn-lt"/>
                <a:cs typeface="+mn-lt"/>
              </a:rPr>
              <a:t>, N., &amp; Piper, H. G. (2017). A comparison of Broviac</a:t>
            </a:r>
            <a:r>
              <a:rPr lang="en-US" sz="900" baseline="30000" dirty="0">
                <a:solidFill>
                  <a:srgbClr val="212121"/>
                </a:solidFill>
                <a:latin typeface="system-ui"/>
                <a:ea typeface="+mn-lt"/>
                <a:cs typeface="+mn-lt"/>
              </a:rPr>
              <a:t>®</a:t>
            </a:r>
            <a:r>
              <a:rPr lang="en-US" sz="1200" dirty="0">
                <a:solidFill>
                  <a:srgbClr val="212121"/>
                </a:solidFill>
                <a:latin typeface="system-ui"/>
                <a:ea typeface="+mn-lt"/>
                <a:cs typeface="+mn-lt"/>
              </a:rPr>
              <a:t> and peripherally inserted central catheters in children with intestinal failure. </a:t>
            </a:r>
            <a:r>
              <a:rPr lang="en-US" sz="1200" i="1" dirty="0">
                <a:solidFill>
                  <a:srgbClr val="212121"/>
                </a:solidFill>
                <a:latin typeface="system-ui"/>
                <a:ea typeface="+mn-lt"/>
                <a:cs typeface="+mn-lt"/>
              </a:rPr>
              <a:t>Journal of pediatric surgery</a:t>
            </a:r>
            <a:r>
              <a:rPr lang="en-US" sz="1200" dirty="0">
                <a:solidFill>
                  <a:srgbClr val="212121"/>
                </a:solidFill>
                <a:latin typeface="system-ui"/>
                <a:ea typeface="+mn-lt"/>
                <a:cs typeface="+mn-lt"/>
              </a:rPr>
              <a:t>, </a:t>
            </a:r>
            <a:r>
              <a:rPr lang="en-US" sz="1200" i="1" dirty="0">
                <a:solidFill>
                  <a:srgbClr val="212121"/>
                </a:solidFill>
                <a:latin typeface="system-ui"/>
                <a:ea typeface="+mn-lt"/>
                <a:cs typeface="+mn-lt"/>
              </a:rPr>
              <a:t>52</a:t>
            </a:r>
            <a:r>
              <a:rPr lang="en-US" sz="1200" dirty="0">
                <a:solidFill>
                  <a:srgbClr val="212121"/>
                </a:solidFill>
                <a:latin typeface="system-ui"/>
                <a:ea typeface="+mn-lt"/>
                <a:cs typeface="+mn-lt"/>
              </a:rPr>
              <a:t>(5), 768–771. https://doi.org/10.1016/j.jpedsurg.2017.01.036</a:t>
            </a:r>
            <a:endParaRPr lang="en-US" sz="1200" dirty="0">
              <a:solidFill>
                <a:srgbClr val="1B1B1B"/>
              </a:solidFill>
              <a:ea typeface="+mn-lt"/>
              <a:cs typeface="+mn-lt"/>
            </a:endParaRPr>
          </a:p>
          <a:p>
            <a:r>
              <a:rPr lang="en-US" sz="1200" dirty="0">
                <a:solidFill>
                  <a:srgbClr val="1B1B1B"/>
                </a:solidFill>
                <a:ea typeface="+mn-lt"/>
                <a:cs typeface="+mn-lt"/>
              </a:rPr>
              <a:t>Wall, C., Moore, J., &amp; Thachil, J. (2016). Catheter-related thrombosis: A practical approach. </a:t>
            </a:r>
            <a:r>
              <a:rPr lang="en-US" sz="1200" i="1" dirty="0">
                <a:solidFill>
                  <a:srgbClr val="1B1B1B"/>
                </a:solidFill>
                <a:ea typeface="+mn-lt"/>
                <a:cs typeface="+mn-lt"/>
              </a:rPr>
              <a:t>Journal of the Intensive Care Society</a:t>
            </a:r>
            <a:r>
              <a:rPr lang="en-US" sz="1200" dirty="0">
                <a:solidFill>
                  <a:srgbClr val="1B1B1B"/>
                </a:solidFill>
                <a:ea typeface="+mn-lt"/>
                <a:cs typeface="+mn-lt"/>
              </a:rPr>
              <a:t>, </a:t>
            </a:r>
            <a:r>
              <a:rPr lang="en-US" sz="1200" i="1" dirty="0">
                <a:solidFill>
                  <a:srgbClr val="1B1B1B"/>
                </a:solidFill>
                <a:ea typeface="+mn-lt"/>
                <a:cs typeface="+mn-lt"/>
              </a:rPr>
              <a:t>17</a:t>
            </a:r>
            <a:r>
              <a:rPr lang="en-US" sz="1200" dirty="0">
                <a:solidFill>
                  <a:srgbClr val="1B1B1B"/>
                </a:solidFill>
                <a:ea typeface="+mn-lt"/>
                <a:cs typeface="+mn-lt"/>
              </a:rPr>
              <a:t>(2), 160–167. </a:t>
            </a:r>
            <a:r>
              <a:rPr lang="en-US" sz="1200" dirty="0">
                <a:solidFill>
                  <a:srgbClr val="1B1B1B"/>
                </a:solidFill>
                <a:ea typeface="+mn-lt"/>
                <a:cs typeface="+mn-lt"/>
                <a:hlinkClick r:id="rId5"/>
              </a:rPr>
              <a:t>https://doi.org/10.1177/1751143715618683</a:t>
            </a:r>
            <a:endParaRPr lang="en-US">
              <a:solidFill>
                <a:srgbClr val="000000"/>
              </a:solidFill>
              <a:ea typeface="+mn-lt"/>
              <a:cs typeface="+mn-lt"/>
            </a:endParaRPr>
          </a:p>
          <a:p>
            <a:r>
              <a:rPr lang="en-US" sz="1200" dirty="0">
                <a:solidFill>
                  <a:srgbClr val="212121"/>
                </a:solidFill>
                <a:latin typeface="system-ui"/>
              </a:rPr>
              <a:t>Touré, A., Duchamp, A., </a:t>
            </a:r>
            <a:r>
              <a:rPr lang="en-US" sz="1200" dirty="0" err="1">
                <a:solidFill>
                  <a:srgbClr val="212121"/>
                </a:solidFill>
                <a:latin typeface="system-ui"/>
              </a:rPr>
              <a:t>Peraldi</a:t>
            </a:r>
            <a:r>
              <a:rPr lang="en-US" sz="1200" dirty="0">
                <a:solidFill>
                  <a:srgbClr val="212121"/>
                </a:solidFill>
                <a:latin typeface="system-ui"/>
              </a:rPr>
              <a:t>, C., </a:t>
            </a:r>
            <a:r>
              <a:rPr lang="en-US" sz="1200" dirty="0" err="1">
                <a:solidFill>
                  <a:srgbClr val="212121"/>
                </a:solidFill>
                <a:latin typeface="system-ui"/>
              </a:rPr>
              <a:t>Barnoud</a:t>
            </a:r>
            <a:r>
              <a:rPr lang="en-US" sz="1200" dirty="0">
                <a:solidFill>
                  <a:srgbClr val="212121"/>
                </a:solidFill>
                <a:latin typeface="system-ui"/>
              </a:rPr>
              <a:t>, D., </a:t>
            </a:r>
            <a:r>
              <a:rPr lang="en-US" sz="1200" dirty="0" err="1">
                <a:solidFill>
                  <a:srgbClr val="212121"/>
                </a:solidFill>
                <a:latin typeface="system-ui"/>
              </a:rPr>
              <a:t>Lauverjat</a:t>
            </a:r>
            <a:r>
              <a:rPr lang="en-US" sz="1200" dirty="0">
                <a:solidFill>
                  <a:srgbClr val="212121"/>
                </a:solidFill>
                <a:latin typeface="system-ui"/>
              </a:rPr>
              <a:t>, M., Gelas, P., &amp; </a:t>
            </a:r>
            <a:r>
              <a:rPr lang="en-US" sz="1200" dirty="0" err="1">
                <a:solidFill>
                  <a:srgbClr val="212121"/>
                </a:solidFill>
                <a:latin typeface="system-ui"/>
              </a:rPr>
              <a:t>Chambrier</a:t>
            </a:r>
            <a:r>
              <a:rPr lang="en-US" sz="1200" dirty="0">
                <a:solidFill>
                  <a:srgbClr val="212121"/>
                </a:solidFill>
                <a:latin typeface="system-ui"/>
              </a:rPr>
              <a:t>, C. (2015). A comparative study of peripherally-inserted and Broviac catheter complications in home parenteral nutrition patients. </a:t>
            </a:r>
            <a:r>
              <a:rPr lang="en-US" sz="1200" i="1" dirty="0">
                <a:solidFill>
                  <a:srgbClr val="212121"/>
                </a:solidFill>
                <a:latin typeface="system-ui"/>
              </a:rPr>
              <a:t>Clinical nutrition (Edinburgh, Scotland)</a:t>
            </a:r>
            <a:r>
              <a:rPr lang="en-US" sz="1200" dirty="0">
                <a:solidFill>
                  <a:srgbClr val="212121"/>
                </a:solidFill>
                <a:latin typeface="system-ui"/>
              </a:rPr>
              <a:t>, </a:t>
            </a:r>
            <a:r>
              <a:rPr lang="en-US" sz="1200" i="1" dirty="0">
                <a:solidFill>
                  <a:srgbClr val="212121"/>
                </a:solidFill>
                <a:latin typeface="system-ui"/>
              </a:rPr>
              <a:t>34</a:t>
            </a:r>
            <a:r>
              <a:rPr lang="en-US" sz="1200" dirty="0">
                <a:solidFill>
                  <a:srgbClr val="212121"/>
                </a:solidFill>
                <a:latin typeface="system-ui"/>
              </a:rPr>
              <a:t>(1), 49–52. </a:t>
            </a:r>
            <a:r>
              <a:rPr lang="en-US" sz="1200" dirty="0">
                <a:solidFill>
                  <a:srgbClr val="212121"/>
                </a:solidFill>
                <a:latin typeface="system-ui"/>
                <a:hlinkClick r:id="rId6"/>
              </a:rPr>
              <a:t>https://doi.org/10.1016/j.clnu.2013.12.017</a:t>
            </a:r>
            <a:endParaRPr lang="en-US" sz="1200" dirty="0">
              <a:solidFill>
                <a:srgbClr val="1B1B1B"/>
              </a:solidFill>
            </a:endParaRPr>
          </a:p>
          <a:p>
            <a:r>
              <a:rPr lang="en-US" sz="1200" dirty="0" err="1">
                <a:solidFill>
                  <a:srgbClr val="333333"/>
                </a:solidFill>
                <a:latin typeface="Open Sans"/>
                <a:ea typeface="Open Sans"/>
                <a:cs typeface="Open Sans"/>
              </a:rPr>
              <a:t>Schears</a:t>
            </a:r>
            <a:r>
              <a:rPr lang="en-US" sz="1200" dirty="0">
                <a:solidFill>
                  <a:srgbClr val="333333"/>
                </a:solidFill>
                <a:latin typeface="Open Sans"/>
                <a:ea typeface="Open Sans"/>
                <a:cs typeface="Open Sans"/>
              </a:rPr>
              <a:t> GJ, Ferko N, Syed I, Arpino J-M, Alsbrooks K. Peripherally inserted central catheters inserted with current best practices have low deep vein thrombosis and central line–associated bloodstream infection risk compared with centrally inserted central catheters: A contemporary meta-analysis. </a:t>
            </a:r>
            <a:r>
              <a:rPr lang="en-US" sz="1200" i="1" dirty="0">
                <a:solidFill>
                  <a:srgbClr val="333333"/>
                </a:solidFill>
                <a:latin typeface="Open Sans"/>
                <a:ea typeface="Open Sans"/>
                <a:cs typeface="Open Sans"/>
              </a:rPr>
              <a:t>The Journal of Vascular Access</a:t>
            </a:r>
            <a:r>
              <a:rPr lang="en-US" sz="1200" dirty="0">
                <a:solidFill>
                  <a:srgbClr val="333333"/>
                </a:solidFill>
                <a:latin typeface="Open Sans"/>
                <a:ea typeface="Open Sans"/>
                <a:cs typeface="Open Sans"/>
              </a:rPr>
              <a:t>. 2021;22(1):9-25. </a:t>
            </a:r>
            <a:r>
              <a:rPr lang="en-US" sz="1200" dirty="0" err="1">
                <a:solidFill>
                  <a:srgbClr val="333333"/>
                </a:solidFill>
                <a:latin typeface="Open Sans"/>
                <a:ea typeface="Open Sans"/>
                <a:cs typeface="Open Sans"/>
              </a:rPr>
              <a:t>doi</a:t>
            </a:r>
            <a:r>
              <a:rPr lang="en-US" sz="1200" dirty="0">
                <a:solidFill>
                  <a:srgbClr val="333333"/>
                </a:solidFill>
                <a:latin typeface="Open Sans"/>
                <a:ea typeface="Open Sans"/>
                <a:cs typeface="Open Sans"/>
              </a:rPr>
              <a:t>:</a:t>
            </a:r>
            <a:r>
              <a:rPr lang="en-US" sz="1200" u="sng" dirty="0">
                <a:solidFill>
                  <a:srgbClr val="046FF8"/>
                </a:solidFill>
                <a:latin typeface="Open Sans"/>
                <a:ea typeface="Open Sans"/>
                <a:cs typeface="Open Sans"/>
                <a:hlinkClick r:id="rId7"/>
              </a:rPr>
              <a:t>10.1177/1129729820916113</a:t>
            </a:r>
            <a:endParaRPr lang="en-US" sz="1200" dirty="0">
              <a:solidFill>
                <a:srgbClr val="212121"/>
              </a:solidFill>
              <a:latin typeface="system-ui"/>
            </a:endParaRPr>
          </a:p>
          <a:p>
            <a:r>
              <a:rPr lang="en-US" sz="1200" dirty="0">
                <a:solidFill>
                  <a:srgbClr val="333333"/>
                </a:solidFill>
                <a:ea typeface="+mn-lt"/>
                <a:cs typeface="+mn-lt"/>
              </a:rPr>
              <a:t>Zhang, P., Lei, JH., Su, XJ. </a:t>
            </a:r>
            <a:r>
              <a:rPr lang="en-US" sz="1200" i="1" dirty="0">
                <a:solidFill>
                  <a:srgbClr val="333333"/>
                </a:solidFill>
                <a:ea typeface="+mn-lt"/>
                <a:cs typeface="+mn-lt"/>
              </a:rPr>
              <a:t>et al.</a:t>
            </a:r>
            <a:r>
              <a:rPr lang="en-US" sz="1200" dirty="0">
                <a:solidFill>
                  <a:srgbClr val="333333"/>
                </a:solidFill>
                <a:ea typeface="+mn-lt"/>
                <a:cs typeface="+mn-lt"/>
              </a:rPr>
              <a:t> Ethanol locks for the prevention of catheter-related bloodstream infection: a meta-analysis of randomized control trials. </a:t>
            </a:r>
            <a:r>
              <a:rPr lang="en-US" sz="1200" i="1" dirty="0">
                <a:solidFill>
                  <a:srgbClr val="333333"/>
                </a:solidFill>
                <a:ea typeface="+mn-lt"/>
                <a:cs typeface="+mn-lt"/>
              </a:rPr>
              <a:t>BMC </a:t>
            </a:r>
            <a:r>
              <a:rPr lang="en-US" sz="1200" i="1" dirty="0" err="1">
                <a:solidFill>
                  <a:srgbClr val="333333"/>
                </a:solidFill>
                <a:ea typeface="+mn-lt"/>
                <a:cs typeface="+mn-lt"/>
              </a:rPr>
              <a:t>Anesthesiol</a:t>
            </a:r>
            <a:r>
              <a:rPr lang="en-US" sz="1200" dirty="0">
                <a:solidFill>
                  <a:srgbClr val="333333"/>
                </a:solidFill>
                <a:ea typeface="+mn-lt"/>
                <a:cs typeface="+mn-lt"/>
              </a:rPr>
              <a:t> </a:t>
            </a:r>
            <a:r>
              <a:rPr lang="en-US" sz="1200" b="1" dirty="0">
                <a:solidFill>
                  <a:srgbClr val="333333"/>
                </a:solidFill>
                <a:ea typeface="+mn-lt"/>
                <a:cs typeface="+mn-lt"/>
              </a:rPr>
              <a:t>18</a:t>
            </a:r>
            <a:r>
              <a:rPr lang="en-US" sz="1200" dirty="0">
                <a:solidFill>
                  <a:srgbClr val="333333"/>
                </a:solidFill>
                <a:ea typeface="+mn-lt"/>
                <a:cs typeface="+mn-lt"/>
              </a:rPr>
              <a:t>, 93 (2018). </a:t>
            </a:r>
            <a:r>
              <a:rPr lang="en-US" sz="1200" dirty="0">
                <a:solidFill>
                  <a:srgbClr val="333333"/>
                </a:solidFill>
                <a:ea typeface="+mn-lt"/>
                <a:cs typeface="+mn-lt"/>
                <a:hlinkClick r:id="rId8"/>
              </a:rPr>
              <a:t>https://doi.org/10.1186/s12871-018-0548-y</a:t>
            </a:r>
            <a:endParaRPr lang="en-US" sz="1200" u="sng" dirty="0">
              <a:solidFill>
                <a:srgbClr val="046FF8"/>
              </a:solidFill>
              <a:latin typeface="Open Sans"/>
              <a:ea typeface="Open Sans"/>
              <a:cs typeface="Open Sans"/>
            </a:endParaRPr>
          </a:p>
          <a:p>
            <a:endParaRPr lang="en-US" sz="1200" dirty="0">
              <a:solidFill>
                <a:srgbClr val="333333"/>
              </a:solidFill>
            </a:endParaRPr>
          </a:p>
          <a:p>
            <a:endParaRPr lang="en-US" sz="1200" dirty="0">
              <a:solidFill>
                <a:srgbClr val="1B1B1B"/>
              </a:solidFill>
            </a:endParaRPr>
          </a:p>
          <a:p>
            <a:endParaRPr lang="en-US" sz="1200" dirty="0">
              <a:solidFill>
                <a:srgbClr val="1B1B1B"/>
              </a:solidFill>
            </a:endParaRPr>
          </a:p>
        </p:txBody>
      </p:sp>
    </p:spTree>
    <p:extLst>
      <p:ext uri="{BB962C8B-B14F-4D97-AF65-F5344CB8AC3E}">
        <p14:creationId xmlns:p14="http://schemas.microsoft.com/office/powerpoint/2010/main" val="173171401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pic>
        <p:nvPicPr>
          <p:cNvPr id="2" name="Picture 1" descr="A diagram of a baby&amp;#39;s internal organs&#10;&#10;Description automatically generated">
            <a:extLst>
              <a:ext uri="{FF2B5EF4-FFF2-40B4-BE49-F238E27FC236}">
                <a16:creationId xmlns:a16="http://schemas.microsoft.com/office/drawing/2014/main" id="{877DECD5-9B38-55E8-C4CA-3DA907C0CDCB}"/>
              </a:ext>
            </a:extLst>
          </p:cNvPr>
          <p:cNvPicPr>
            <a:picLocks noChangeAspect="1"/>
          </p:cNvPicPr>
          <p:nvPr/>
        </p:nvPicPr>
        <p:blipFill>
          <a:blip r:embed="rId2"/>
          <a:stretch>
            <a:fillRect/>
          </a:stretch>
        </p:blipFill>
        <p:spPr>
          <a:xfrm>
            <a:off x="3050507" y="4161"/>
            <a:ext cx="6439697" cy="6856134"/>
          </a:xfrm>
          <a:prstGeom prst="rect">
            <a:avLst/>
          </a:prstGeom>
        </p:spPr>
      </p:pic>
      <p:sp>
        <p:nvSpPr>
          <p:cNvPr id="3" name="Rectangle 2">
            <a:extLst>
              <a:ext uri="{FF2B5EF4-FFF2-40B4-BE49-F238E27FC236}">
                <a16:creationId xmlns:a16="http://schemas.microsoft.com/office/drawing/2014/main" id="{4DC55ADC-1479-2E5C-058A-BAFDD97A0881}"/>
              </a:ext>
            </a:extLst>
          </p:cNvPr>
          <p:cNvSpPr/>
          <p:nvPr/>
        </p:nvSpPr>
        <p:spPr>
          <a:xfrm>
            <a:off x="3297498" y="3268410"/>
            <a:ext cx="1220825" cy="542573"/>
          </a:xfrm>
          <a:prstGeom prst="rect">
            <a:avLst/>
          </a:prstGeom>
          <a:noFill/>
          <a:ln w="57150">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Rectangle 3">
            <a:extLst>
              <a:ext uri="{FF2B5EF4-FFF2-40B4-BE49-F238E27FC236}">
                <a16:creationId xmlns:a16="http://schemas.microsoft.com/office/drawing/2014/main" id="{9A0FB527-D21C-7270-2B49-D54936E79F4C}"/>
              </a:ext>
            </a:extLst>
          </p:cNvPr>
          <p:cNvSpPr/>
          <p:nvPr/>
        </p:nvSpPr>
        <p:spPr>
          <a:xfrm>
            <a:off x="4873158" y="5528578"/>
            <a:ext cx="1530791" cy="1156047"/>
          </a:xfrm>
          <a:prstGeom prst="rect">
            <a:avLst/>
          </a:prstGeom>
          <a:noFill/>
          <a:ln w="57150">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447BDD9D-1C0A-27C1-3C5E-632E14C64BD1}"/>
              </a:ext>
            </a:extLst>
          </p:cNvPr>
          <p:cNvSpPr/>
          <p:nvPr/>
        </p:nvSpPr>
        <p:spPr>
          <a:xfrm>
            <a:off x="7243106" y="5380052"/>
            <a:ext cx="1543706" cy="1388521"/>
          </a:xfrm>
          <a:prstGeom prst="rect">
            <a:avLst/>
          </a:prstGeom>
          <a:noFill/>
          <a:ln w="57150">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ectangle 5">
            <a:extLst>
              <a:ext uri="{FF2B5EF4-FFF2-40B4-BE49-F238E27FC236}">
                <a16:creationId xmlns:a16="http://schemas.microsoft.com/office/drawing/2014/main" id="{80FD8CA4-8927-C765-1A84-CD94410A8ABF}"/>
              </a:ext>
            </a:extLst>
          </p:cNvPr>
          <p:cNvSpPr/>
          <p:nvPr/>
        </p:nvSpPr>
        <p:spPr>
          <a:xfrm>
            <a:off x="8101972" y="4521189"/>
            <a:ext cx="1220825" cy="716928"/>
          </a:xfrm>
          <a:prstGeom prst="rect">
            <a:avLst/>
          </a:prstGeom>
          <a:noFill/>
          <a:ln w="57150">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37246414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6E2AEE0-4A9B-F0FC-0EC4-7B9EB29E7B34}"/>
              </a:ext>
            </a:extLst>
          </p:cNvPr>
          <p:cNvSpPr>
            <a:spLocks noGrp="1"/>
          </p:cNvSpPr>
          <p:nvPr>
            <p:ph type="title"/>
          </p:nvPr>
        </p:nvSpPr>
        <p:spPr/>
        <p:txBody>
          <a:bodyPr/>
          <a:lstStyle/>
          <a:p>
            <a:r>
              <a:rPr lang="en-US"/>
              <a:t>CVC </a:t>
            </a:r>
          </a:p>
        </p:txBody>
      </p:sp>
      <p:sp>
        <p:nvSpPr>
          <p:cNvPr id="3" name="Content Placeholder 2">
            <a:extLst>
              <a:ext uri="{FF2B5EF4-FFF2-40B4-BE49-F238E27FC236}">
                <a16:creationId xmlns:a16="http://schemas.microsoft.com/office/drawing/2014/main" id="{283F0732-6ED3-A107-57EE-B45417AADBF0}"/>
              </a:ext>
            </a:extLst>
          </p:cNvPr>
          <p:cNvSpPr>
            <a:spLocks noGrp="1"/>
          </p:cNvSpPr>
          <p:nvPr>
            <p:ph idx="1"/>
          </p:nvPr>
        </p:nvSpPr>
        <p:spPr/>
        <p:txBody>
          <a:bodyPr vert="horz" lIns="91440" tIns="45720" rIns="91440" bIns="45720" rtlCol="0" anchor="t">
            <a:normAutofit/>
          </a:bodyPr>
          <a:lstStyle/>
          <a:p>
            <a:r>
              <a:rPr lang="en-US">
                <a:ea typeface="+mn-lt"/>
                <a:cs typeface="+mn-lt"/>
              </a:rPr>
              <a:t>Need central venous catheter (CVC) to provide Parenteral Nutrition (PN) and </a:t>
            </a:r>
            <a:r>
              <a:rPr lang="en-US" dirty="0">
                <a:ea typeface="+mn-lt"/>
                <a:cs typeface="+mn-lt"/>
              </a:rPr>
              <a:t>medications while working towards goal of enteral autonomy.</a:t>
            </a:r>
            <a:endParaRPr lang="en-US"/>
          </a:p>
          <a:p>
            <a:pPr marL="0" indent="0">
              <a:buNone/>
            </a:pPr>
            <a:endParaRPr lang="en-US" dirty="0"/>
          </a:p>
          <a:p>
            <a:endParaRPr lang="en-US"/>
          </a:p>
          <a:p>
            <a:endParaRPr lang="en-US"/>
          </a:p>
        </p:txBody>
      </p:sp>
    </p:spTree>
    <p:extLst>
      <p:ext uri="{BB962C8B-B14F-4D97-AF65-F5344CB8AC3E}">
        <p14:creationId xmlns:p14="http://schemas.microsoft.com/office/powerpoint/2010/main" val="149115607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6B1AE23-4599-CB1C-CDE6-F87BBDEA55D1}"/>
              </a:ext>
            </a:extLst>
          </p:cNvPr>
          <p:cNvSpPr>
            <a:spLocks noGrp="1"/>
          </p:cNvSpPr>
          <p:nvPr>
            <p:ph type="title"/>
          </p:nvPr>
        </p:nvSpPr>
        <p:spPr>
          <a:xfrm>
            <a:off x="482260" y="233733"/>
            <a:ext cx="10173010" cy="1554480"/>
          </a:xfrm>
        </p:spPr>
        <p:txBody>
          <a:bodyPr anchor="ctr">
            <a:normAutofit/>
          </a:bodyPr>
          <a:lstStyle/>
          <a:p>
            <a:r>
              <a:rPr lang="en-US" sz="4800"/>
              <a:t>Types of Central Lines </a:t>
            </a:r>
          </a:p>
        </p:txBody>
      </p:sp>
      <p:graphicFrame>
        <p:nvGraphicFramePr>
          <p:cNvPr id="5" name="Content Placeholder 2">
            <a:extLst>
              <a:ext uri="{FF2B5EF4-FFF2-40B4-BE49-F238E27FC236}">
                <a16:creationId xmlns:a16="http://schemas.microsoft.com/office/drawing/2014/main" id="{23AF7966-5238-A790-88D7-3E2B2D408459}"/>
              </a:ext>
            </a:extLst>
          </p:cNvPr>
          <p:cNvGraphicFramePr>
            <a:graphicFrameLocks noGrp="1"/>
          </p:cNvGraphicFramePr>
          <p:nvPr>
            <p:ph idx="1"/>
            <p:extLst>
              <p:ext uri="{D42A27DB-BD31-4B8C-83A1-F6EECF244321}">
                <p14:modId xmlns:p14="http://schemas.microsoft.com/office/powerpoint/2010/main" val="747836843"/>
              </p:ext>
            </p:extLst>
          </p:nvPr>
        </p:nvGraphicFramePr>
        <p:xfrm>
          <a:off x="1430584" y="2322741"/>
          <a:ext cx="9326476" cy="270415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20461359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Pro-Picc">
            <a:extLst>
              <a:ext uri="{FF2B5EF4-FFF2-40B4-BE49-F238E27FC236}">
                <a16:creationId xmlns:a16="http://schemas.microsoft.com/office/drawing/2014/main" id="{FAEB5427-0668-C432-7EB1-63D66F80DE54}"/>
              </a:ext>
            </a:extLst>
          </p:cNvPr>
          <p:cNvPicPr>
            <a:picLocks noChangeAspect="1"/>
          </p:cNvPicPr>
          <p:nvPr/>
        </p:nvPicPr>
        <p:blipFill>
          <a:blip r:embed="rId3"/>
          <a:stretch>
            <a:fillRect/>
          </a:stretch>
        </p:blipFill>
        <p:spPr>
          <a:xfrm>
            <a:off x="509798" y="172618"/>
            <a:ext cx="4112102" cy="4874126"/>
          </a:xfrm>
          <a:prstGeom prst="rect">
            <a:avLst/>
          </a:prstGeom>
        </p:spPr>
      </p:pic>
      <p:pic>
        <p:nvPicPr>
          <p:cNvPr id="3" name="Picture 2" descr="Hickman catheter (Hickman Line) - LA Vascular">
            <a:extLst>
              <a:ext uri="{FF2B5EF4-FFF2-40B4-BE49-F238E27FC236}">
                <a16:creationId xmlns:a16="http://schemas.microsoft.com/office/drawing/2014/main" id="{4492925C-A5A5-A3F6-B6B9-9CD544E53238}"/>
              </a:ext>
            </a:extLst>
          </p:cNvPr>
          <p:cNvPicPr>
            <a:picLocks noChangeAspect="1"/>
          </p:cNvPicPr>
          <p:nvPr/>
        </p:nvPicPr>
        <p:blipFill>
          <a:blip r:embed="rId4"/>
          <a:stretch>
            <a:fillRect/>
          </a:stretch>
        </p:blipFill>
        <p:spPr>
          <a:xfrm>
            <a:off x="5142489" y="1448475"/>
            <a:ext cx="6627376" cy="3266483"/>
          </a:xfrm>
          <a:prstGeom prst="rect">
            <a:avLst/>
          </a:prstGeom>
        </p:spPr>
      </p:pic>
      <p:sp>
        <p:nvSpPr>
          <p:cNvPr id="4" name="TextBox 3">
            <a:extLst>
              <a:ext uri="{FF2B5EF4-FFF2-40B4-BE49-F238E27FC236}">
                <a16:creationId xmlns:a16="http://schemas.microsoft.com/office/drawing/2014/main" id="{4D596B5E-5157-3C7E-BFB0-A26CF590A99E}"/>
              </a:ext>
            </a:extLst>
          </p:cNvPr>
          <p:cNvSpPr txBox="1"/>
          <p:nvPr/>
        </p:nvSpPr>
        <p:spPr>
          <a:xfrm>
            <a:off x="1021470" y="5443707"/>
            <a:ext cx="3842653"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dirty="0"/>
              <a:t>Polyurethane catheters</a:t>
            </a:r>
          </a:p>
        </p:txBody>
      </p:sp>
      <p:sp>
        <p:nvSpPr>
          <p:cNvPr id="5" name="TextBox 4">
            <a:extLst>
              <a:ext uri="{FF2B5EF4-FFF2-40B4-BE49-F238E27FC236}">
                <a16:creationId xmlns:a16="http://schemas.microsoft.com/office/drawing/2014/main" id="{87E8A27D-4779-14D8-7486-8B184D703BBB}"/>
              </a:ext>
            </a:extLst>
          </p:cNvPr>
          <p:cNvSpPr txBox="1"/>
          <p:nvPr/>
        </p:nvSpPr>
        <p:spPr>
          <a:xfrm>
            <a:off x="7326514" y="5173971"/>
            <a:ext cx="3842653"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dirty="0"/>
              <a:t>Silicon catheters</a:t>
            </a:r>
          </a:p>
        </p:txBody>
      </p:sp>
      <p:sp>
        <p:nvSpPr>
          <p:cNvPr id="6" name="Oval 5">
            <a:extLst>
              <a:ext uri="{FF2B5EF4-FFF2-40B4-BE49-F238E27FC236}">
                <a16:creationId xmlns:a16="http://schemas.microsoft.com/office/drawing/2014/main" id="{45F1A969-F05C-EBC3-E804-917C968F09CB}"/>
              </a:ext>
            </a:extLst>
          </p:cNvPr>
          <p:cNvSpPr/>
          <p:nvPr/>
        </p:nvSpPr>
        <p:spPr>
          <a:xfrm>
            <a:off x="7851108" y="2610444"/>
            <a:ext cx="600898" cy="531942"/>
          </a:xfrm>
          <a:prstGeom prst="ellipse">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03764962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ptos" panose="020B000402020202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Application>Microsoft Office PowerPoint</Application>
  <PresentationFormat>Widescreen</PresentationFormat>
  <Slides>51</Slides>
  <Notes>30</Notes>
  <HiddenSlides>0</HiddenSlides>
  <ScaleCrop>false</ScaleCrop>
  <HeadingPairs>
    <vt:vector size="4" baseType="variant">
      <vt:variant>
        <vt:lpstr>Theme</vt:lpstr>
      </vt:variant>
      <vt:variant>
        <vt:i4>1</vt:i4>
      </vt:variant>
      <vt:variant>
        <vt:lpstr>Slide Titles</vt:lpstr>
      </vt:variant>
      <vt:variant>
        <vt:i4>51</vt:i4>
      </vt:variant>
    </vt:vector>
  </HeadingPairs>
  <TitlesOfParts>
    <vt:vector size="52" baseType="lpstr">
      <vt:lpstr>office theme</vt:lpstr>
      <vt:lpstr>Intestinal Rehab  Residency Curriculum</vt:lpstr>
      <vt:lpstr>Purpose </vt:lpstr>
      <vt:lpstr>Introduction</vt:lpstr>
      <vt:lpstr>SBS categories based on anatomy: </vt:lpstr>
      <vt:lpstr>PowerPoint Presentation</vt:lpstr>
      <vt:lpstr>PowerPoint Presentation</vt:lpstr>
      <vt:lpstr>CVC </vt:lpstr>
      <vt:lpstr>Types of Central Lines </vt:lpstr>
      <vt:lpstr>PowerPoint Presentation</vt:lpstr>
      <vt:lpstr>PowerPoint Presentation</vt:lpstr>
      <vt:lpstr>PowerPoint Presentation</vt:lpstr>
      <vt:lpstr>PowerPoint Presentation</vt:lpstr>
      <vt:lpstr>PowerPoint Presentation</vt:lpstr>
      <vt:lpstr>CVC complications: </vt:lpstr>
      <vt:lpstr>Local Infection</vt:lpstr>
      <vt:lpstr>Local Infection Prevention</vt:lpstr>
      <vt:lpstr>Case 1:</vt:lpstr>
      <vt:lpstr>CLABSI</vt:lpstr>
      <vt:lpstr>CLABSI cont.</vt:lpstr>
      <vt:lpstr>CLABSI Prevention</vt:lpstr>
      <vt:lpstr>Case 2:</vt:lpstr>
      <vt:lpstr>Malposition/Dislodgement </vt:lpstr>
      <vt:lpstr>PowerPoint Presentation</vt:lpstr>
      <vt:lpstr>PowerPoint Presentation</vt:lpstr>
      <vt:lpstr>Treatment </vt:lpstr>
      <vt:lpstr>Line Dysfunction (breakage) </vt:lpstr>
      <vt:lpstr>PowerPoint Presentation</vt:lpstr>
      <vt:lpstr>Line Dysfunction (occlusion) </vt:lpstr>
      <vt:lpstr>Etiologies: </vt:lpstr>
      <vt:lpstr>Thrombosis </vt:lpstr>
      <vt:lpstr>Case 3:</vt:lpstr>
      <vt:lpstr>Line Occlusion Management </vt:lpstr>
      <vt:lpstr>Occlusion prevention</vt:lpstr>
      <vt:lpstr>When To Remove CVC?</vt:lpstr>
      <vt:lpstr>Case 4:</vt:lpstr>
      <vt:lpstr>Avanos MIC-KEY Gastrostomy Tube </vt:lpstr>
      <vt:lpstr>PowerPoint Presentation</vt:lpstr>
      <vt:lpstr>PowerPoint Presentation</vt:lpstr>
      <vt:lpstr>PowerPoint Presentation</vt:lpstr>
      <vt:lpstr>Other GT/GJ complications:</vt:lpstr>
      <vt:lpstr>PowerPoint Presentation</vt:lpstr>
      <vt:lpstr>PowerPoint Presentation</vt:lpstr>
      <vt:lpstr>PowerPoint Presentation</vt:lpstr>
      <vt:lpstr>PowerPoint Presentation</vt:lpstr>
      <vt:lpstr>Case 5:</vt:lpstr>
      <vt:lpstr>PowerPoint Presentation</vt:lpstr>
      <vt:lpstr>Typical Stoma Care</vt:lpstr>
      <vt:lpstr>PowerPoint Presentation</vt:lpstr>
      <vt:lpstr>PowerPoint Presentation</vt:lpstr>
      <vt:lpstr>Thanks to ICARE team!!  Special thanks to Dr Raghu,  Dr Alissa, Kim Ackerman, Tracey Presel, Sarah Fox.</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
  <cp:revision>3122</cp:revision>
  <dcterms:created xsi:type="dcterms:W3CDTF">2013-07-15T20:26:40Z</dcterms:created>
  <dcterms:modified xsi:type="dcterms:W3CDTF">2025-04-24T15:33:5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MSIP_Label_5e4b1be8-281e-475d-98b0-21c3457e5a46_Enabled">
    <vt:lpwstr>true</vt:lpwstr>
  </property>
  <property fmtid="{D5CDD505-2E9C-101B-9397-08002B2CF9AE}" pid="3" name="MSIP_Label_5e4b1be8-281e-475d-98b0-21c3457e5a46_SetDate">
    <vt:lpwstr>2024-12-03T19:24:00Z</vt:lpwstr>
  </property>
  <property fmtid="{D5CDD505-2E9C-101B-9397-08002B2CF9AE}" pid="4" name="MSIP_Label_5e4b1be8-281e-475d-98b0-21c3457e5a46_Method">
    <vt:lpwstr>Standard</vt:lpwstr>
  </property>
  <property fmtid="{D5CDD505-2E9C-101B-9397-08002B2CF9AE}" pid="5" name="MSIP_Label_5e4b1be8-281e-475d-98b0-21c3457e5a46_Name">
    <vt:lpwstr>Public</vt:lpwstr>
  </property>
  <property fmtid="{D5CDD505-2E9C-101B-9397-08002B2CF9AE}" pid="6" name="MSIP_Label_5e4b1be8-281e-475d-98b0-21c3457e5a46_SiteId">
    <vt:lpwstr>8b3dd73e-4e72-4679-b191-56da1588712b</vt:lpwstr>
  </property>
  <property fmtid="{D5CDD505-2E9C-101B-9397-08002B2CF9AE}" pid="7" name="MSIP_Label_5e4b1be8-281e-475d-98b0-21c3457e5a46_ActionId">
    <vt:lpwstr>7e6fd707-9c2e-4bd3-a38b-36b856b9030a</vt:lpwstr>
  </property>
  <property fmtid="{D5CDD505-2E9C-101B-9397-08002B2CF9AE}" pid="8" name="MSIP_Label_5e4b1be8-281e-475d-98b0-21c3457e5a46_ContentBits">
    <vt:lpwstr>0</vt:lpwstr>
  </property>
</Properties>
</file>